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16459200" cy="9144000"/>
  <p:notesSz cx="16459200" cy="91440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234440" y="2834640"/>
            <a:ext cx="1399032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2468880" y="5120640"/>
            <a:ext cx="1152144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822960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8476488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488695" y="3583304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488695" y="2766060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488695" y="1948688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563880"/>
                </a:moveTo>
                <a:lnTo>
                  <a:pt x="15900908" y="563880"/>
                </a:lnTo>
              </a:path>
              <a:path w="15901035" h="3416935">
                <a:moveTo>
                  <a:pt x="2168271" y="3416427"/>
                </a:moveTo>
                <a:lnTo>
                  <a:pt x="2168271" y="0"/>
                </a:lnTo>
              </a:path>
              <a:path w="15901035" h="3416935">
                <a:moveTo>
                  <a:pt x="5059426" y="3416427"/>
                </a:moveTo>
                <a:lnTo>
                  <a:pt x="5059426" y="0"/>
                </a:lnTo>
              </a:path>
              <a:path w="15901035" h="3416935">
                <a:moveTo>
                  <a:pt x="7950454" y="3416427"/>
                </a:moveTo>
                <a:lnTo>
                  <a:pt x="7950454" y="0"/>
                </a:lnTo>
              </a:path>
              <a:path w="15901035" h="3416935">
                <a:moveTo>
                  <a:pt x="10841482" y="3416427"/>
                </a:moveTo>
                <a:lnTo>
                  <a:pt x="10841482" y="0"/>
                </a:lnTo>
              </a:path>
              <a:path w="15901035" h="3416935">
                <a:moveTo>
                  <a:pt x="13732637" y="3416427"/>
                </a:moveTo>
                <a:lnTo>
                  <a:pt x="13732637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" name="bg object 20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2607310"/>
                </a:moveTo>
                <a:lnTo>
                  <a:pt x="15900908" y="2607310"/>
                </a:lnTo>
              </a:path>
              <a:path w="15901035" h="3416935">
                <a:moveTo>
                  <a:pt x="0" y="1789938"/>
                </a:moveTo>
                <a:lnTo>
                  <a:pt x="15900908" y="1789938"/>
                </a:lnTo>
              </a:path>
              <a:path w="15901035" h="3416935">
                <a:moveTo>
                  <a:pt x="0" y="972566"/>
                </a:moveTo>
                <a:lnTo>
                  <a:pt x="15900908" y="972566"/>
                </a:lnTo>
              </a:path>
              <a:path w="15901035" h="3416935">
                <a:moveTo>
                  <a:pt x="0" y="155321"/>
                </a:moveTo>
                <a:lnTo>
                  <a:pt x="15900908" y="155321"/>
                </a:lnTo>
              </a:path>
              <a:path w="15901035" h="3416935">
                <a:moveTo>
                  <a:pt x="722757" y="3416427"/>
                </a:moveTo>
                <a:lnTo>
                  <a:pt x="722757" y="0"/>
                </a:lnTo>
              </a:path>
              <a:path w="15901035" h="3416935">
                <a:moveTo>
                  <a:pt x="3613912" y="3416427"/>
                </a:moveTo>
                <a:lnTo>
                  <a:pt x="3613912" y="0"/>
                </a:lnTo>
              </a:path>
              <a:path w="15901035" h="3416935">
                <a:moveTo>
                  <a:pt x="6504939" y="3416427"/>
                </a:moveTo>
                <a:lnTo>
                  <a:pt x="6504939" y="0"/>
                </a:lnTo>
              </a:path>
              <a:path w="15901035" h="3416935">
                <a:moveTo>
                  <a:pt x="9395968" y="3416427"/>
                </a:moveTo>
                <a:lnTo>
                  <a:pt x="9395968" y="0"/>
                </a:lnTo>
              </a:path>
              <a:path w="15901035" h="3416935">
                <a:moveTo>
                  <a:pt x="12287123" y="3416427"/>
                </a:moveTo>
                <a:lnTo>
                  <a:pt x="12287123" y="0"/>
                </a:lnTo>
              </a:path>
              <a:path w="15901035" h="3416935">
                <a:moveTo>
                  <a:pt x="15178150" y="3416427"/>
                </a:moveTo>
                <a:lnTo>
                  <a:pt x="15178150" y="0"/>
                </a:lnTo>
              </a:path>
            </a:pathLst>
          </a:custGeom>
          <a:ln w="13589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" name="bg object 21"/>
          <p:cNvSpPr/>
          <p:nvPr/>
        </p:nvSpPr>
        <p:spPr>
          <a:xfrm>
            <a:off x="1211452" y="722757"/>
            <a:ext cx="14340205" cy="11430"/>
          </a:xfrm>
          <a:custGeom>
            <a:avLst/>
            <a:gdLst/>
            <a:ahLst/>
            <a:cxnLst/>
            <a:rect l="l" t="t" r="r" b="b"/>
            <a:pathLst>
              <a:path w="14340205" h="11429">
                <a:moveTo>
                  <a:pt x="0" y="0"/>
                </a:moveTo>
                <a:lnTo>
                  <a:pt x="0" y="0"/>
                </a:lnTo>
                <a:lnTo>
                  <a:pt x="404749" y="0"/>
                </a:lnTo>
                <a:lnTo>
                  <a:pt x="520446" y="0"/>
                </a:lnTo>
                <a:lnTo>
                  <a:pt x="578230" y="0"/>
                </a:lnTo>
                <a:lnTo>
                  <a:pt x="636016" y="0"/>
                </a:lnTo>
                <a:lnTo>
                  <a:pt x="693928" y="0"/>
                </a:lnTo>
                <a:lnTo>
                  <a:pt x="751713" y="0"/>
                </a:lnTo>
                <a:lnTo>
                  <a:pt x="809497" y="0"/>
                </a:lnTo>
                <a:lnTo>
                  <a:pt x="867283" y="0"/>
                </a:lnTo>
                <a:lnTo>
                  <a:pt x="925195" y="0"/>
                </a:lnTo>
                <a:lnTo>
                  <a:pt x="982979" y="0"/>
                </a:lnTo>
                <a:lnTo>
                  <a:pt x="1040765" y="0"/>
                </a:lnTo>
                <a:lnTo>
                  <a:pt x="1098677" y="0"/>
                </a:lnTo>
                <a:lnTo>
                  <a:pt x="1156461" y="0"/>
                </a:lnTo>
                <a:lnTo>
                  <a:pt x="1214247" y="0"/>
                </a:lnTo>
                <a:lnTo>
                  <a:pt x="1272032" y="0"/>
                </a:lnTo>
                <a:lnTo>
                  <a:pt x="1329944" y="0"/>
                </a:lnTo>
                <a:lnTo>
                  <a:pt x="1387729" y="0"/>
                </a:lnTo>
                <a:lnTo>
                  <a:pt x="1445514" y="0"/>
                </a:lnTo>
                <a:lnTo>
                  <a:pt x="1503426" y="0"/>
                </a:lnTo>
                <a:lnTo>
                  <a:pt x="1503426" y="1524"/>
                </a:lnTo>
                <a:lnTo>
                  <a:pt x="1561211" y="1524"/>
                </a:lnTo>
                <a:lnTo>
                  <a:pt x="1618996" y="1524"/>
                </a:lnTo>
                <a:lnTo>
                  <a:pt x="1676780" y="1524"/>
                </a:lnTo>
                <a:lnTo>
                  <a:pt x="1734692" y="1524"/>
                </a:lnTo>
                <a:lnTo>
                  <a:pt x="1792477" y="1524"/>
                </a:lnTo>
                <a:lnTo>
                  <a:pt x="1850263" y="1524"/>
                </a:lnTo>
                <a:lnTo>
                  <a:pt x="1908175" y="1524"/>
                </a:lnTo>
                <a:lnTo>
                  <a:pt x="1965960" y="1524"/>
                </a:lnTo>
                <a:lnTo>
                  <a:pt x="2023745" y="1524"/>
                </a:lnTo>
                <a:lnTo>
                  <a:pt x="2081530" y="1524"/>
                </a:lnTo>
                <a:lnTo>
                  <a:pt x="2139442" y="1524"/>
                </a:lnTo>
                <a:lnTo>
                  <a:pt x="2197227" y="1524"/>
                </a:lnTo>
                <a:lnTo>
                  <a:pt x="2255012" y="1524"/>
                </a:lnTo>
                <a:lnTo>
                  <a:pt x="2312924" y="1524"/>
                </a:lnTo>
                <a:lnTo>
                  <a:pt x="2370709" y="1524"/>
                </a:lnTo>
                <a:lnTo>
                  <a:pt x="2428494" y="1524"/>
                </a:lnTo>
                <a:lnTo>
                  <a:pt x="2486406" y="1524"/>
                </a:lnTo>
                <a:lnTo>
                  <a:pt x="2544191" y="1524"/>
                </a:lnTo>
                <a:lnTo>
                  <a:pt x="2601976" y="1524"/>
                </a:lnTo>
                <a:lnTo>
                  <a:pt x="2659761" y="1524"/>
                </a:lnTo>
                <a:lnTo>
                  <a:pt x="2717673" y="1524"/>
                </a:lnTo>
                <a:lnTo>
                  <a:pt x="2775458" y="1524"/>
                </a:lnTo>
                <a:lnTo>
                  <a:pt x="2833243" y="1524"/>
                </a:lnTo>
                <a:lnTo>
                  <a:pt x="2891155" y="1524"/>
                </a:lnTo>
                <a:lnTo>
                  <a:pt x="2948940" y="1524"/>
                </a:lnTo>
                <a:lnTo>
                  <a:pt x="3006725" y="1524"/>
                </a:lnTo>
                <a:lnTo>
                  <a:pt x="3064510" y="1524"/>
                </a:lnTo>
                <a:lnTo>
                  <a:pt x="3122422" y="1524"/>
                </a:lnTo>
                <a:lnTo>
                  <a:pt x="3180207" y="1524"/>
                </a:lnTo>
                <a:lnTo>
                  <a:pt x="3237992" y="1524"/>
                </a:lnTo>
                <a:lnTo>
                  <a:pt x="3295904" y="1524"/>
                </a:lnTo>
                <a:lnTo>
                  <a:pt x="3353689" y="1524"/>
                </a:lnTo>
                <a:lnTo>
                  <a:pt x="3411474" y="1524"/>
                </a:lnTo>
                <a:lnTo>
                  <a:pt x="3469259" y="1524"/>
                </a:lnTo>
                <a:lnTo>
                  <a:pt x="3527171" y="1524"/>
                </a:lnTo>
                <a:lnTo>
                  <a:pt x="3584956" y="1524"/>
                </a:lnTo>
                <a:lnTo>
                  <a:pt x="3642741" y="1524"/>
                </a:lnTo>
                <a:lnTo>
                  <a:pt x="3700653" y="1524"/>
                </a:lnTo>
                <a:lnTo>
                  <a:pt x="3758438" y="1524"/>
                </a:lnTo>
                <a:lnTo>
                  <a:pt x="3816223" y="1524"/>
                </a:lnTo>
                <a:lnTo>
                  <a:pt x="3874008" y="1524"/>
                </a:lnTo>
                <a:lnTo>
                  <a:pt x="3931920" y="1524"/>
                </a:lnTo>
                <a:lnTo>
                  <a:pt x="3989705" y="1524"/>
                </a:lnTo>
                <a:lnTo>
                  <a:pt x="4047490" y="1524"/>
                </a:lnTo>
                <a:lnTo>
                  <a:pt x="4105402" y="1524"/>
                </a:lnTo>
                <a:lnTo>
                  <a:pt x="4163187" y="1524"/>
                </a:lnTo>
                <a:lnTo>
                  <a:pt x="4220972" y="1524"/>
                </a:lnTo>
                <a:lnTo>
                  <a:pt x="4278757" y="1524"/>
                </a:lnTo>
                <a:lnTo>
                  <a:pt x="4336669" y="1524"/>
                </a:lnTo>
                <a:lnTo>
                  <a:pt x="4394454" y="1524"/>
                </a:lnTo>
                <a:lnTo>
                  <a:pt x="4452239" y="1524"/>
                </a:lnTo>
                <a:lnTo>
                  <a:pt x="4510151" y="1524"/>
                </a:lnTo>
                <a:lnTo>
                  <a:pt x="4567936" y="1524"/>
                </a:lnTo>
                <a:lnTo>
                  <a:pt x="4625721" y="1524"/>
                </a:lnTo>
                <a:lnTo>
                  <a:pt x="4683506" y="1524"/>
                </a:lnTo>
                <a:lnTo>
                  <a:pt x="4741418" y="1524"/>
                </a:lnTo>
                <a:lnTo>
                  <a:pt x="4799203" y="1524"/>
                </a:lnTo>
                <a:lnTo>
                  <a:pt x="4856988" y="1524"/>
                </a:lnTo>
                <a:lnTo>
                  <a:pt x="4914900" y="1524"/>
                </a:lnTo>
                <a:lnTo>
                  <a:pt x="4972685" y="1524"/>
                </a:lnTo>
                <a:lnTo>
                  <a:pt x="5030470" y="1524"/>
                </a:lnTo>
                <a:lnTo>
                  <a:pt x="5088255" y="1524"/>
                </a:lnTo>
                <a:lnTo>
                  <a:pt x="5146167" y="1524"/>
                </a:lnTo>
                <a:lnTo>
                  <a:pt x="5203952" y="1524"/>
                </a:lnTo>
                <a:lnTo>
                  <a:pt x="5261737" y="1524"/>
                </a:lnTo>
                <a:lnTo>
                  <a:pt x="5319649" y="1524"/>
                </a:lnTo>
                <a:lnTo>
                  <a:pt x="5377433" y="1524"/>
                </a:lnTo>
                <a:lnTo>
                  <a:pt x="5435219" y="1524"/>
                </a:lnTo>
                <a:lnTo>
                  <a:pt x="5493004" y="1524"/>
                </a:lnTo>
                <a:lnTo>
                  <a:pt x="5550916" y="1524"/>
                </a:lnTo>
                <a:lnTo>
                  <a:pt x="5608701" y="1524"/>
                </a:lnTo>
                <a:lnTo>
                  <a:pt x="5666486" y="1524"/>
                </a:lnTo>
                <a:lnTo>
                  <a:pt x="5724398" y="1524"/>
                </a:lnTo>
                <a:lnTo>
                  <a:pt x="5782183" y="1524"/>
                </a:lnTo>
                <a:lnTo>
                  <a:pt x="5839968" y="1524"/>
                </a:lnTo>
                <a:lnTo>
                  <a:pt x="5897753" y="1524"/>
                </a:lnTo>
                <a:lnTo>
                  <a:pt x="5955665" y="1524"/>
                </a:lnTo>
                <a:lnTo>
                  <a:pt x="6013450" y="1524"/>
                </a:lnTo>
                <a:lnTo>
                  <a:pt x="6071235" y="1524"/>
                </a:lnTo>
                <a:lnTo>
                  <a:pt x="6129147" y="1524"/>
                </a:lnTo>
                <a:lnTo>
                  <a:pt x="6186932" y="1524"/>
                </a:lnTo>
                <a:lnTo>
                  <a:pt x="6244717" y="1524"/>
                </a:lnTo>
                <a:lnTo>
                  <a:pt x="6244717" y="4191"/>
                </a:lnTo>
                <a:lnTo>
                  <a:pt x="6302502" y="4191"/>
                </a:lnTo>
                <a:lnTo>
                  <a:pt x="6360414" y="4191"/>
                </a:lnTo>
                <a:lnTo>
                  <a:pt x="6418199" y="4191"/>
                </a:lnTo>
                <a:lnTo>
                  <a:pt x="6475983" y="4191"/>
                </a:lnTo>
                <a:lnTo>
                  <a:pt x="6533896" y="4191"/>
                </a:lnTo>
                <a:lnTo>
                  <a:pt x="6591681" y="4191"/>
                </a:lnTo>
                <a:lnTo>
                  <a:pt x="6649466" y="4191"/>
                </a:lnTo>
                <a:lnTo>
                  <a:pt x="6707251" y="4191"/>
                </a:lnTo>
                <a:lnTo>
                  <a:pt x="6765163" y="4191"/>
                </a:lnTo>
                <a:lnTo>
                  <a:pt x="6822948" y="4191"/>
                </a:lnTo>
                <a:lnTo>
                  <a:pt x="6880733" y="4191"/>
                </a:lnTo>
                <a:lnTo>
                  <a:pt x="6938645" y="4191"/>
                </a:lnTo>
                <a:lnTo>
                  <a:pt x="6996430" y="4191"/>
                </a:lnTo>
                <a:lnTo>
                  <a:pt x="7054215" y="4191"/>
                </a:lnTo>
                <a:lnTo>
                  <a:pt x="7112000" y="4191"/>
                </a:lnTo>
                <a:lnTo>
                  <a:pt x="7169912" y="4191"/>
                </a:lnTo>
                <a:lnTo>
                  <a:pt x="7227697" y="4191"/>
                </a:lnTo>
                <a:lnTo>
                  <a:pt x="7285482" y="4191"/>
                </a:lnTo>
                <a:lnTo>
                  <a:pt x="7285482" y="7239"/>
                </a:lnTo>
                <a:lnTo>
                  <a:pt x="7343394" y="7239"/>
                </a:lnTo>
                <a:lnTo>
                  <a:pt x="7401179" y="7239"/>
                </a:lnTo>
                <a:lnTo>
                  <a:pt x="7458964" y="7239"/>
                </a:lnTo>
                <a:lnTo>
                  <a:pt x="7516749" y="7239"/>
                </a:lnTo>
                <a:lnTo>
                  <a:pt x="7574661" y="7239"/>
                </a:lnTo>
                <a:lnTo>
                  <a:pt x="7632446" y="7239"/>
                </a:lnTo>
                <a:lnTo>
                  <a:pt x="7690231" y="7239"/>
                </a:lnTo>
                <a:lnTo>
                  <a:pt x="7748143" y="7239"/>
                </a:lnTo>
                <a:lnTo>
                  <a:pt x="7805928" y="7239"/>
                </a:lnTo>
                <a:lnTo>
                  <a:pt x="7863713" y="7239"/>
                </a:lnTo>
                <a:lnTo>
                  <a:pt x="7921625" y="7239"/>
                </a:lnTo>
                <a:lnTo>
                  <a:pt x="7979410" y="7239"/>
                </a:lnTo>
                <a:lnTo>
                  <a:pt x="8037195" y="7239"/>
                </a:lnTo>
                <a:lnTo>
                  <a:pt x="8094980" y="7239"/>
                </a:lnTo>
                <a:lnTo>
                  <a:pt x="8152892" y="7239"/>
                </a:lnTo>
                <a:lnTo>
                  <a:pt x="8210677" y="7239"/>
                </a:lnTo>
                <a:lnTo>
                  <a:pt x="8268462" y="7239"/>
                </a:lnTo>
                <a:lnTo>
                  <a:pt x="8326374" y="7239"/>
                </a:lnTo>
                <a:lnTo>
                  <a:pt x="8384158" y="7239"/>
                </a:lnTo>
                <a:lnTo>
                  <a:pt x="8441944" y="7239"/>
                </a:lnTo>
                <a:lnTo>
                  <a:pt x="8441944" y="10922"/>
                </a:lnTo>
                <a:lnTo>
                  <a:pt x="8499729" y="10922"/>
                </a:lnTo>
                <a:lnTo>
                  <a:pt x="8557641" y="10922"/>
                </a:lnTo>
                <a:lnTo>
                  <a:pt x="8615426" y="10922"/>
                </a:lnTo>
                <a:lnTo>
                  <a:pt x="8673211" y="10922"/>
                </a:lnTo>
                <a:lnTo>
                  <a:pt x="8731123" y="10922"/>
                </a:lnTo>
                <a:lnTo>
                  <a:pt x="8788908" y="10922"/>
                </a:lnTo>
                <a:lnTo>
                  <a:pt x="8846693" y="10922"/>
                </a:lnTo>
                <a:lnTo>
                  <a:pt x="8904478" y="10922"/>
                </a:lnTo>
                <a:lnTo>
                  <a:pt x="8962390" y="10922"/>
                </a:lnTo>
                <a:lnTo>
                  <a:pt x="9020175" y="10922"/>
                </a:lnTo>
                <a:lnTo>
                  <a:pt x="9077960" y="10922"/>
                </a:lnTo>
                <a:lnTo>
                  <a:pt x="9135872" y="10922"/>
                </a:lnTo>
                <a:lnTo>
                  <a:pt x="9193657" y="10922"/>
                </a:lnTo>
                <a:lnTo>
                  <a:pt x="9251442" y="10922"/>
                </a:lnTo>
                <a:lnTo>
                  <a:pt x="9309227" y="10922"/>
                </a:lnTo>
                <a:lnTo>
                  <a:pt x="9367139" y="10922"/>
                </a:lnTo>
                <a:lnTo>
                  <a:pt x="9424924" y="10922"/>
                </a:lnTo>
                <a:lnTo>
                  <a:pt x="9482709" y="10922"/>
                </a:lnTo>
                <a:lnTo>
                  <a:pt x="9540621" y="10922"/>
                </a:lnTo>
                <a:lnTo>
                  <a:pt x="9598406" y="10922"/>
                </a:lnTo>
                <a:lnTo>
                  <a:pt x="9656191" y="10922"/>
                </a:lnTo>
                <a:lnTo>
                  <a:pt x="9713976" y="10922"/>
                </a:lnTo>
                <a:lnTo>
                  <a:pt x="9771888" y="10922"/>
                </a:lnTo>
                <a:lnTo>
                  <a:pt x="9829673" y="10922"/>
                </a:lnTo>
                <a:lnTo>
                  <a:pt x="9887458" y="10922"/>
                </a:lnTo>
                <a:lnTo>
                  <a:pt x="9945370" y="10922"/>
                </a:lnTo>
                <a:lnTo>
                  <a:pt x="10003155" y="10922"/>
                </a:lnTo>
                <a:lnTo>
                  <a:pt x="10060940" y="10922"/>
                </a:lnTo>
                <a:lnTo>
                  <a:pt x="10118725" y="10922"/>
                </a:lnTo>
                <a:lnTo>
                  <a:pt x="10176637" y="10922"/>
                </a:lnTo>
                <a:lnTo>
                  <a:pt x="10234422" y="10922"/>
                </a:lnTo>
                <a:lnTo>
                  <a:pt x="10292207" y="10922"/>
                </a:lnTo>
                <a:lnTo>
                  <a:pt x="10350119" y="10922"/>
                </a:lnTo>
                <a:lnTo>
                  <a:pt x="10407904" y="10922"/>
                </a:lnTo>
                <a:lnTo>
                  <a:pt x="10465689" y="10922"/>
                </a:lnTo>
                <a:lnTo>
                  <a:pt x="10523474" y="10922"/>
                </a:lnTo>
                <a:lnTo>
                  <a:pt x="10581386" y="10922"/>
                </a:lnTo>
                <a:lnTo>
                  <a:pt x="10639171" y="10922"/>
                </a:lnTo>
                <a:lnTo>
                  <a:pt x="10696956" y="10922"/>
                </a:lnTo>
                <a:lnTo>
                  <a:pt x="10754868" y="10922"/>
                </a:lnTo>
                <a:lnTo>
                  <a:pt x="10812653" y="10922"/>
                </a:lnTo>
                <a:lnTo>
                  <a:pt x="10870438" y="10922"/>
                </a:lnTo>
                <a:lnTo>
                  <a:pt x="10928223" y="10922"/>
                </a:lnTo>
                <a:lnTo>
                  <a:pt x="10986135" y="10922"/>
                </a:lnTo>
                <a:lnTo>
                  <a:pt x="11043920" y="10922"/>
                </a:lnTo>
                <a:lnTo>
                  <a:pt x="11101705" y="10922"/>
                </a:lnTo>
                <a:lnTo>
                  <a:pt x="11159617" y="10922"/>
                </a:lnTo>
                <a:lnTo>
                  <a:pt x="11217402" y="10922"/>
                </a:lnTo>
                <a:lnTo>
                  <a:pt x="11275187" y="10922"/>
                </a:lnTo>
                <a:lnTo>
                  <a:pt x="11332972" y="10922"/>
                </a:lnTo>
                <a:lnTo>
                  <a:pt x="11390884" y="10922"/>
                </a:lnTo>
                <a:lnTo>
                  <a:pt x="11448669" y="10922"/>
                </a:lnTo>
                <a:lnTo>
                  <a:pt x="11506454" y="10922"/>
                </a:lnTo>
                <a:lnTo>
                  <a:pt x="11564366" y="10922"/>
                </a:lnTo>
                <a:lnTo>
                  <a:pt x="11622151" y="10922"/>
                </a:lnTo>
                <a:lnTo>
                  <a:pt x="11679936" y="10922"/>
                </a:lnTo>
                <a:lnTo>
                  <a:pt x="11737721" y="10922"/>
                </a:lnTo>
                <a:lnTo>
                  <a:pt x="11795633" y="10922"/>
                </a:lnTo>
                <a:lnTo>
                  <a:pt x="11853418" y="10922"/>
                </a:lnTo>
                <a:lnTo>
                  <a:pt x="11911203" y="10922"/>
                </a:lnTo>
                <a:lnTo>
                  <a:pt x="11969115" y="10922"/>
                </a:lnTo>
                <a:lnTo>
                  <a:pt x="12026900" y="10922"/>
                </a:lnTo>
                <a:lnTo>
                  <a:pt x="12084685" y="10922"/>
                </a:lnTo>
                <a:lnTo>
                  <a:pt x="12142470" y="10922"/>
                </a:lnTo>
                <a:lnTo>
                  <a:pt x="12200382" y="10922"/>
                </a:lnTo>
                <a:lnTo>
                  <a:pt x="12258166" y="10922"/>
                </a:lnTo>
                <a:lnTo>
                  <a:pt x="12315952" y="10922"/>
                </a:lnTo>
                <a:lnTo>
                  <a:pt x="12373864" y="10922"/>
                </a:lnTo>
                <a:lnTo>
                  <a:pt x="12431649" y="10922"/>
                </a:lnTo>
                <a:lnTo>
                  <a:pt x="12489434" y="10922"/>
                </a:lnTo>
                <a:lnTo>
                  <a:pt x="12547218" y="10922"/>
                </a:lnTo>
                <a:lnTo>
                  <a:pt x="12605131" y="10922"/>
                </a:lnTo>
                <a:lnTo>
                  <a:pt x="12662916" y="10922"/>
                </a:lnTo>
                <a:lnTo>
                  <a:pt x="12720701" y="10922"/>
                </a:lnTo>
                <a:lnTo>
                  <a:pt x="12778613" y="10922"/>
                </a:lnTo>
                <a:lnTo>
                  <a:pt x="12836398" y="10922"/>
                </a:lnTo>
                <a:lnTo>
                  <a:pt x="12894183" y="10922"/>
                </a:lnTo>
                <a:lnTo>
                  <a:pt x="12951968" y="10922"/>
                </a:lnTo>
                <a:lnTo>
                  <a:pt x="13009879" y="10922"/>
                </a:lnTo>
                <a:lnTo>
                  <a:pt x="13067664" y="10922"/>
                </a:lnTo>
                <a:lnTo>
                  <a:pt x="13125450" y="10922"/>
                </a:lnTo>
                <a:lnTo>
                  <a:pt x="13183362" y="10922"/>
                </a:lnTo>
                <a:lnTo>
                  <a:pt x="13241146" y="10922"/>
                </a:lnTo>
                <a:lnTo>
                  <a:pt x="13298931" y="10922"/>
                </a:lnTo>
                <a:lnTo>
                  <a:pt x="13356843" y="10922"/>
                </a:lnTo>
                <a:lnTo>
                  <a:pt x="13414629" y="10922"/>
                </a:lnTo>
                <a:lnTo>
                  <a:pt x="13472414" y="10922"/>
                </a:lnTo>
                <a:lnTo>
                  <a:pt x="13530198" y="10922"/>
                </a:lnTo>
                <a:lnTo>
                  <a:pt x="13588110" y="10922"/>
                </a:lnTo>
                <a:lnTo>
                  <a:pt x="13645895" y="10922"/>
                </a:lnTo>
                <a:lnTo>
                  <a:pt x="13703681" y="10922"/>
                </a:lnTo>
                <a:lnTo>
                  <a:pt x="13761592" y="10922"/>
                </a:lnTo>
                <a:lnTo>
                  <a:pt x="13819377" y="10922"/>
                </a:lnTo>
                <a:lnTo>
                  <a:pt x="13877162" y="10922"/>
                </a:lnTo>
                <a:lnTo>
                  <a:pt x="13934948" y="10922"/>
                </a:lnTo>
                <a:lnTo>
                  <a:pt x="13992860" y="10922"/>
                </a:lnTo>
                <a:lnTo>
                  <a:pt x="14050644" y="10922"/>
                </a:lnTo>
                <a:lnTo>
                  <a:pt x="14108429" y="10922"/>
                </a:lnTo>
                <a:lnTo>
                  <a:pt x="14166341" y="10922"/>
                </a:lnTo>
                <a:lnTo>
                  <a:pt x="14224127" y="10922"/>
                </a:lnTo>
                <a:lnTo>
                  <a:pt x="14281912" y="10922"/>
                </a:lnTo>
                <a:lnTo>
                  <a:pt x="14339696" y="10922"/>
                </a:lnTo>
              </a:path>
            </a:pathLst>
          </a:custGeom>
          <a:ln w="27051">
            <a:solidFill>
              <a:srgbClr val="E95359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" name="bg object 22"/>
          <p:cNvSpPr/>
          <p:nvPr/>
        </p:nvSpPr>
        <p:spPr>
          <a:xfrm>
            <a:off x="1211452" y="722757"/>
            <a:ext cx="14397990" cy="62865"/>
          </a:xfrm>
          <a:custGeom>
            <a:avLst/>
            <a:gdLst/>
            <a:ahLst/>
            <a:cxnLst/>
            <a:rect l="l" t="t" r="r" b="b"/>
            <a:pathLst>
              <a:path w="14397990" h="62865">
                <a:moveTo>
                  <a:pt x="0" y="0"/>
                </a:moveTo>
                <a:lnTo>
                  <a:pt x="0" y="0"/>
                </a:lnTo>
                <a:lnTo>
                  <a:pt x="57784" y="0"/>
                </a:lnTo>
                <a:lnTo>
                  <a:pt x="115697" y="0"/>
                </a:lnTo>
                <a:lnTo>
                  <a:pt x="173481" y="0"/>
                </a:lnTo>
                <a:lnTo>
                  <a:pt x="173481" y="635"/>
                </a:lnTo>
                <a:lnTo>
                  <a:pt x="231266" y="635"/>
                </a:lnTo>
                <a:lnTo>
                  <a:pt x="289178" y="635"/>
                </a:lnTo>
                <a:lnTo>
                  <a:pt x="346963" y="635"/>
                </a:lnTo>
                <a:lnTo>
                  <a:pt x="404749" y="635"/>
                </a:lnTo>
                <a:lnTo>
                  <a:pt x="462534" y="635"/>
                </a:lnTo>
                <a:lnTo>
                  <a:pt x="520446" y="635"/>
                </a:lnTo>
                <a:lnTo>
                  <a:pt x="578230" y="635"/>
                </a:lnTo>
                <a:lnTo>
                  <a:pt x="636016" y="635"/>
                </a:lnTo>
                <a:lnTo>
                  <a:pt x="693928" y="635"/>
                </a:lnTo>
                <a:lnTo>
                  <a:pt x="751713" y="635"/>
                </a:lnTo>
                <a:lnTo>
                  <a:pt x="751713" y="1270"/>
                </a:lnTo>
                <a:lnTo>
                  <a:pt x="809497" y="1270"/>
                </a:lnTo>
                <a:lnTo>
                  <a:pt x="867283" y="1270"/>
                </a:lnTo>
                <a:lnTo>
                  <a:pt x="925195" y="1270"/>
                </a:lnTo>
                <a:lnTo>
                  <a:pt x="982979" y="1270"/>
                </a:lnTo>
                <a:lnTo>
                  <a:pt x="1040765" y="1270"/>
                </a:lnTo>
                <a:lnTo>
                  <a:pt x="1040765" y="1904"/>
                </a:lnTo>
                <a:lnTo>
                  <a:pt x="1098677" y="1904"/>
                </a:lnTo>
                <a:lnTo>
                  <a:pt x="1156461" y="1904"/>
                </a:lnTo>
                <a:lnTo>
                  <a:pt x="1214247" y="1904"/>
                </a:lnTo>
                <a:lnTo>
                  <a:pt x="1272032" y="1904"/>
                </a:lnTo>
                <a:lnTo>
                  <a:pt x="1329944" y="1904"/>
                </a:lnTo>
                <a:lnTo>
                  <a:pt x="1387729" y="1904"/>
                </a:lnTo>
                <a:lnTo>
                  <a:pt x="1387729" y="2667"/>
                </a:lnTo>
                <a:lnTo>
                  <a:pt x="1445514" y="2667"/>
                </a:lnTo>
                <a:lnTo>
                  <a:pt x="1445514" y="3428"/>
                </a:lnTo>
                <a:lnTo>
                  <a:pt x="1503426" y="3428"/>
                </a:lnTo>
                <a:lnTo>
                  <a:pt x="1561211" y="3428"/>
                </a:lnTo>
                <a:lnTo>
                  <a:pt x="1618996" y="3428"/>
                </a:lnTo>
                <a:lnTo>
                  <a:pt x="1676780" y="3428"/>
                </a:lnTo>
                <a:lnTo>
                  <a:pt x="1734692" y="3428"/>
                </a:lnTo>
                <a:lnTo>
                  <a:pt x="1792477" y="3428"/>
                </a:lnTo>
                <a:lnTo>
                  <a:pt x="1850263" y="3428"/>
                </a:lnTo>
                <a:lnTo>
                  <a:pt x="1908175" y="3428"/>
                </a:lnTo>
                <a:lnTo>
                  <a:pt x="1965960" y="3428"/>
                </a:lnTo>
                <a:lnTo>
                  <a:pt x="1965960" y="4191"/>
                </a:lnTo>
                <a:lnTo>
                  <a:pt x="2023745" y="4191"/>
                </a:lnTo>
                <a:lnTo>
                  <a:pt x="2081530" y="4191"/>
                </a:lnTo>
                <a:lnTo>
                  <a:pt x="2139442" y="4191"/>
                </a:lnTo>
                <a:lnTo>
                  <a:pt x="2197227" y="4191"/>
                </a:lnTo>
                <a:lnTo>
                  <a:pt x="2255012" y="4191"/>
                </a:lnTo>
                <a:lnTo>
                  <a:pt x="2312924" y="4191"/>
                </a:lnTo>
                <a:lnTo>
                  <a:pt x="2370709" y="4191"/>
                </a:lnTo>
                <a:lnTo>
                  <a:pt x="2428494" y="4191"/>
                </a:lnTo>
                <a:lnTo>
                  <a:pt x="2486406" y="4191"/>
                </a:lnTo>
                <a:lnTo>
                  <a:pt x="2544191" y="4191"/>
                </a:lnTo>
                <a:lnTo>
                  <a:pt x="2601976" y="4191"/>
                </a:lnTo>
                <a:lnTo>
                  <a:pt x="2659761" y="4191"/>
                </a:lnTo>
                <a:lnTo>
                  <a:pt x="2717673" y="4191"/>
                </a:lnTo>
                <a:lnTo>
                  <a:pt x="2775458" y="4191"/>
                </a:lnTo>
                <a:lnTo>
                  <a:pt x="2775458" y="4952"/>
                </a:lnTo>
                <a:lnTo>
                  <a:pt x="2833243" y="4952"/>
                </a:lnTo>
                <a:lnTo>
                  <a:pt x="2891155" y="4952"/>
                </a:lnTo>
                <a:lnTo>
                  <a:pt x="2948940" y="4952"/>
                </a:lnTo>
                <a:lnTo>
                  <a:pt x="2948940" y="5842"/>
                </a:lnTo>
                <a:lnTo>
                  <a:pt x="3006725" y="5842"/>
                </a:lnTo>
                <a:lnTo>
                  <a:pt x="3064510" y="5842"/>
                </a:lnTo>
                <a:lnTo>
                  <a:pt x="3122422" y="5842"/>
                </a:lnTo>
                <a:lnTo>
                  <a:pt x="3122422" y="6731"/>
                </a:lnTo>
                <a:lnTo>
                  <a:pt x="3180207" y="6731"/>
                </a:lnTo>
                <a:lnTo>
                  <a:pt x="3237992" y="6731"/>
                </a:lnTo>
                <a:lnTo>
                  <a:pt x="3295904" y="6731"/>
                </a:lnTo>
                <a:lnTo>
                  <a:pt x="3353689" y="6731"/>
                </a:lnTo>
                <a:lnTo>
                  <a:pt x="3353689" y="7747"/>
                </a:lnTo>
                <a:lnTo>
                  <a:pt x="3411474" y="7747"/>
                </a:lnTo>
                <a:lnTo>
                  <a:pt x="3469259" y="7747"/>
                </a:lnTo>
                <a:lnTo>
                  <a:pt x="3469259" y="8636"/>
                </a:lnTo>
                <a:lnTo>
                  <a:pt x="3527171" y="8636"/>
                </a:lnTo>
                <a:lnTo>
                  <a:pt x="3584956" y="8636"/>
                </a:lnTo>
                <a:lnTo>
                  <a:pt x="3642741" y="8636"/>
                </a:lnTo>
                <a:lnTo>
                  <a:pt x="3642741" y="9651"/>
                </a:lnTo>
                <a:lnTo>
                  <a:pt x="3700653" y="9651"/>
                </a:lnTo>
                <a:lnTo>
                  <a:pt x="3758438" y="9651"/>
                </a:lnTo>
                <a:lnTo>
                  <a:pt x="3816223" y="9651"/>
                </a:lnTo>
                <a:lnTo>
                  <a:pt x="3874008" y="9651"/>
                </a:lnTo>
                <a:lnTo>
                  <a:pt x="3931920" y="9651"/>
                </a:lnTo>
                <a:lnTo>
                  <a:pt x="3989705" y="9651"/>
                </a:lnTo>
                <a:lnTo>
                  <a:pt x="4047490" y="9651"/>
                </a:lnTo>
                <a:lnTo>
                  <a:pt x="4105402" y="9651"/>
                </a:lnTo>
                <a:lnTo>
                  <a:pt x="4163187" y="9651"/>
                </a:lnTo>
                <a:lnTo>
                  <a:pt x="4220972" y="9651"/>
                </a:lnTo>
                <a:lnTo>
                  <a:pt x="4278757" y="9651"/>
                </a:lnTo>
                <a:lnTo>
                  <a:pt x="4336669" y="9651"/>
                </a:lnTo>
                <a:lnTo>
                  <a:pt x="4394454" y="9651"/>
                </a:lnTo>
                <a:lnTo>
                  <a:pt x="4452239" y="9651"/>
                </a:lnTo>
                <a:lnTo>
                  <a:pt x="4510151" y="9651"/>
                </a:lnTo>
                <a:lnTo>
                  <a:pt x="4567936" y="9651"/>
                </a:lnTo>
                <a:lnTo>
                  <a:pt x="4625721" y="9651"/>
                </a:lnTo>
                <a:lnTo>
                  <a:pt x="4683506" y="9651"/>
                </a:lnTo>
                <a:lnTo>
                  <a:pt x="4741418" y="9651"/>
                </a:lnTo>
                <a:lnTo>
                  <a:pt x="4799203" y="9651"/>
                </a:lnTo>
                <a:lnTo>
                  <a:pt x="4799203" y="10795"/>
                </a:lnTo>
                <a:lnTo>
                  <a:pt x="4856988" y="10795"/>
                </a:lnTo>
                <a:lnTo>
                  <a:pt x="4914900" y="10795"/>
                </a:lnTo>
                <a:lnTo>
                  <a:pt x="4972685" y="10795"/>
                </a:lnTo>
                <a:lnTo>
                  <a:pt x="5030470" y="10795"/>
                </a:lnTo>
                <a:lnTo>
                  <a:pt x="5088255" y="10795"/>
                </a:lnTo>
                <a:lnTo>
                  <a:pt x="5146167" y="10795"/>
                </a:lnTo>
                <a:lnTo>
                  <a:pt x="5203952" y="10795"/>
                </a:lnTo>
                <a:lnTo>
                  <a:pt x="5261737" y="10795"/>
                </a:lnTo>
                <a:lnTo>
                  <a:pt x="5319649" y="10795"/>
                </a:lnTo>
                <a:lnTo>
                  <a:pt x="5377433" y="10795"/>
                </a:lnTo>
                <a:lnTo>
                  <a:pt x="5435219" y="10795"/>
                </a:lnTo>
                <a:lnTo>
                  <a:pt x="5493004" y="10795"/>
                </a:lnTo>
                <a:lnTo>
                  <a:pt x="5550916" y="10795"/>
                </a:lnTo>
                <a:lnTo>
                  <a:pt x="5608701" y="10795"/>
                </a:lnTo>
                <a:lnTo>
                  <a:pt x="5608701" y="12065"/>
                </a:lnTo>
                <a:lnTo>
                  <a:pt x="5666486" y="12065"/>
                </a:lnTo>
                <a:lnTo>
                  <a:pt x="5724398" y="12065"/>
                </a:lnTo>
                <a:lnTo>
                  <a:pt x="5782183" y="12065"/>
                </a:lnTo>
                <a:lnTo>
                  <a:pt x="5839968" y="12065"/>
                </a:lnTo>
                <a:lnTo>
                  <a:pt x="5897753" y="12065"/>
                </a:lnTo>
                <a:lnTo>
                  <a:pt x="5955665" y="12065"/>
                </a:lnTo>
                <a:lnTo>
                  <a:pt x="6013450" y="12065"/>
                </a:lnTo>
                <a:lnTo>
                  <a:pt x="6071235" y="12065"/>
                </a:lnTo>
                <a:lnTo>
                  <a:pt x="6129147" y="12065"/>
                </a:lnTo>
                <a:lnTo>
                  <a:pt x="6186932" y="12065"/>
                </a:lnTo>
                <a:lnTo>
                  <a:pt x="6186932" y="13589"/>
                </a:lnTo>
                <a:lnTo>
                  <a:pt x="6244717" y="13589"/>
                </a:lnTo>
                <a:lnTo>
                  <a:pt x="6302502" y="13589"/>
                </a:lnTo>
                <a:lnTo>
                  <a:pt x="6360414" y="13589"/>
                </a:lnTo>
                <a:lnTo>
                  <a:pt x="6418199" y="13589"/>
                </a:lnTo>
                <a:lnTo>
                  <a:pt x="6475983" y="13589"/>
                </a:lnTo>
                <a:lnTo>
                  <a:pt x="6533896" y="13589"/>
                </a:lnTo>
                <a:lnTo>
                  <a:pt x="6591681" y="13589"/>
                </a:lnTo>
                <a:lnTo>
                  <a:pt x="6649466" y="13589"/>
                </a:lnTo>
                <a:lnTo>
                  <a:pt x="6707251" y="13589"/>
                </a:lnTo>
                <a:lnTo>
                  <a:pt x="6765163" y="13589"/>
                </a:lnTo>
                <a:lnTo>
                  <a:pt x="6765163" y="15240"/>
                </a:lnTo>
                <a:lnTo>
                  <a:pt x="6822948" y="15240"/>
                </a:lnTo>
                <a:lnTo>
                  <a:pt x="6880733" y="15240"/>
                </a:lnTo>
                <a:lnTo>
                  <a:pt x="6938645" y="15240"/>
                </a:lnTo>
                <a:lnTo>
                  <a:pt x="6996430" y="15240"/>
                </a:lnTo>
                <a:lnTo>
                  <a:pt x="7054215" y="15240"/>
                </a:lnTo>
                <a:lnTo>
                  <a:pt x="7112000" y="15240"/>
                </a:lnTo>
                <a:lnTo>
                  <a:pt x="7112000" y="17018"/>
                </a:lnTo>
                <a:lnTo>
                  <a:pt x="7169912" y="17018"/>
                </a:lnTo>
                <a:lnTo>
                  <a:pt x="7169912" y="18796"/>
                </a:lnTo>
                <a:lnTo>
                  <a:pt x="7227697" y="18796"/>
                </a:lnTo>
                <a:lnTo>
                  <a:pt x="7285482" y="18796"/>
                </a:lnTo>
                <a:lnTo>
                  <a:pt x="7343394" y="18796"/>
                </a:lnTo>
                <a:lnTo>
                  <a:pt x="7343394" y="20574"/>
                </a:lnTo>
                <a:lnTo>
                  <a:pt x="7401179" y="20574"/>
                </a:lnTo>
                <a:lnTo>
                  <a:pt x="7458964" y="20574"/>
                </a:lnTo>
                <a:lnTo>
                  <a:pt x="7516749" y="20574"/>
                </a:lnTo>
                <a:lnTo>
                  <a:pt x="7516749" y="22478"/>
                </a:lnTo>
                <a:lnTo>
                  <a:pt x="7574661" y="22478"/>
                </a:lnTo>
                <a:lnTo>
                  <a:pt x="7632446" y="22478"/>
                </a:lnTo>
                <a:lnTo>
                  <a:pt x="7690231" y="22478"/>
                </a:lnTo>
                <a:lnTo>
                  <a:pt x="7748143" y="22478"/>
                </a:lnTo>
                <a:lnTo>
                  <a:pt x="7805928" y="22478"/>
                </a:lnTo>
                <a:lnTo>
                  <a:pt x="7863713" y="22478"/>
                </a:lnTo>
                <a:lnTo>
                  <a:pt x="7921625" y="22478"/>
                </a:lnTo>
                <a:lnTo>
                  <a:pt x="7921625" y="24638"/>
                </a:lnTo>
                <a:lnTo>
                  <a:pt x="7979410" y="24638"/>
                </a:lnTo>
                <a:lnTo>
                  <a:pt x="8037195" y="24638"/>
                </a:lnTo>
                <a:lnTo>
                  <a:pt x="8094980" y="24638"/>
                </a:lnTo>
                <a:lnTo>
                  <a:pt x="8152892" y="24638"/>
                </a:lnTo>
                <a:lnTo>
                  <a:pt x="8210677" y="24638"/>
                </a:lnTo>
                <a:lnTo>
                  <a:pt x="8268462" y="24638"/>
                </a:lnTo>
                <a:lnTo>
                  <a:pt x="8326374" y="24638"/>
                </a:lnTo>
                <a:lnTo>
                  <a:pt x="8384158" y="24638"/>
                </a:lnTo>
                <a:lnTo>
                  <a:pt x="8441944" y="24638"/>
                </a:lnTo>
                <a:lnTo>
                  <a:pt x="8499729" y="24638"/>
                </a:lnTo>
                <a:lnTo>
                  <a:pt x="8557641" y="24638"/>
                </a:lnTo>
                <a:lnTo>
                  <a:pt x="8615426" y="24638"/>
                </a:lnTo>
                <a:lnTo>
                  <a:pt x="8673211" y="24638"/>
                </a:lnTo>
                <a:lnTo>
                  <a:pt x="8731123" y="24638"/>
                </a:lnTo>
                <a:lnTo>
                  <a:pt x="8788908" y="24638"/>
                </a:lnTo>
                <a:lnTo>
                  <a:pt x="8846693" y="24638"/>
                </a:lnTo>
                <a:lnTo>
                  <a:pt x="8904478" y="24638"/>
                </a:lnTo>
                <a:lnTo>
                  <a:pt x="8904478" y="27432"/>
                </a:lnTo>
                <a:lnTo>
                  <a:pt x="8962390" y="27432"/>
                </a:lnTo>
                <a:lnTo>
                  <a:pt x="8962390" y="30099"/>
                </a:lnTo>
                <a:lnTo>
                  <a:pt x="9020175" y="30099"/>
                </a:lnTo>
                <a:lnTo>
                  <a:pt x="9077960" y="30099"/>
                </a:lnTo>
                <a:lnTo>
                  <a:pt x="9135872" y="30099"/>
                </a:lnTo>
                <a:lnTo>
                  <a:pt x="9193657" y="30099"/>
                </a:lnTo>
                <a:lnTo>
                  <a:pt x="9251442" y="30099"/>
                </a:lnTo>
                <a:lnTo>
                  <a:pt x="9309227" y="30099"/>
                </a:lnTo>
                <a:lnTo>
                  <a:pt x="9367139" y="30099"/>
                </a:lnTo>
                <a:lnTo>
                  <a:pt x="9424924" y="30099"/>
                </a:lnTo>
                <a:lnTo>
                  <a:pt x="9482709" y="30099"/>
                </a:lnTo>
                <a:lnTo>
                  <a:pt x="9540621" y="30099"/>
                </a:lnTo>
                <a:lnTo>
                  <a:pt x="9598406" y="30099"/>
                </a:lnTo>
                <a:lnTo>
                  <a:pt x="9656191" y="30099"/>
                </a:lnTo>
                <a:lnTo>
                  <a:pt x="9713976" y="30099"/>
                </a:lnTo>
                <a:lnTo>
                  <a:pt x="9771888" y="30099"/>
                </a:lnTo>
                <a:lnTo>
                  <a:pt x="9829673" y="30099"/>
                </a:lnTo>
                <a:lnTo>
                  <a:pt x="9887458" y="30099"/>
                </a:lnTo>
                <a:lnTo>
                  <a:pt x="9945370" y="30099"/>
                </a:lnTo>
                <a:lnTo>
                  <a:pt x="10003155" y="30099"/>
                </a:lnTo>
                <a:lnTo>
                  <a:pt x="10003155" y="33909"/>
                </a:lnTo>
                <a:lnTo>
                  <a:pt x="10060940" y="33909"/>
                </a:lnTo>
                <a:lnTo>
                  <a:pt x="10118725" y="33909"/>
                </a:lnTo>
                <a:lnTo>
                  <a:pt x="10176637" y="33909"/>
                </a:lnTo>
                <a:lnTo>
                  <a:pt x="10234422" y="33909"/>
                </a:lnTo>
                <a:lnTo>
                  <a:pt x="10292207" y="33909"/>
                </a:lnTo>
                <a:lnTo>
                  <a:pt x="10350119" y="33909"/>
                </a:lnTo>
                <a:lnTo>
                  <a:pt x="10407904" y="33909"/>
                </a:lnTo>
                <a:lnTo>
                  <a:pt x="10465689" y="33909"/>
                </a:lnTo>
                <a:lnTo>
                  <a:pt x="10523474" y="33909"/>
                </a:lnTo>
                <a:lnTo>
                  <a:pt x="10581386" y="33909"/>
                </a:lnTo>
                <a:lnTo>
                  <a:pt x="10639171" y="33909"/>
                </a:lnTo>
                <a:lnTo>
                  <a:pt x="10696956" y="33909"/>
                </a:lnTo>
                <a:lnTo>
                  <a:pt x="10754868" y="33909"/>
                </a:lnTo>
                <a:lnTo>
                  <a:pt x="10812653" y="33909"/>
                </a:lnTo>
                <a:lnTo>
                  <a:pt x="10870438" y="33909"/>
                </a:lnTo>
                <a:lnTo>
                  <a:pt x="10928223" y="33909"/>
                </a:lnTo>
                <a:lnTo>
                  <a:pt x="10986135" y="33909"/>
                </a:lnTo>
                <a:lnTo>
                  <a:pt x="11043920" y="33909"/>
                </a:lnTo>
                <a:lnTo>
                  <a:pt x="11101705" y="33909"/>
                </a:lnTo>
                <a:lnTo>
                  <a:pt x="11159617" y="33909"/>
                </a:lnTo>
                <a:lnTo>
                  <a:pt x="11217402" y="33909"/>
                </a:lnTo>
                <a:lnTo>
                  <a:pt x="11275187" y="33909"/>
                </a:lnTo>
                <a:lnTo>
                  <a:pt x="11275187" y="39877"/>
                </a:lnTo>
                <a:lnTo>
                  <a:pt x="11332972" y="39877"/>
                </a:lnTo>
                <a:lnTo>
                  <a:pt x="11332972" y="46100"/>
                </a:lnTo>
                <a:lnTo>
                  <a:pt x="11390884" y="46100"/>
                </a:lnTo>
                <a:lnTo>
                  <a:pt x="11448669" y="46100"/>
                </a:lnTo>
                <a:lnTo>
                  <a:pt x="11506454" y="46100"/>
                </a:lnTo>
                <a:lnTo>
                  <a:pt x="11564366" y="46100"/>
                </a:lnTo>
                <a:lnTo>
                  <a:pt x="11622151" y="46100"/>
                </a:lnTo>
                <a:lnTo>
                  <a:pt x="11679936" y="46100"/>
                </a:lnTo>
                <a:lnTo>
                  <a:pt x="11737721" y="46100"/>
                </a:lnTo>
                <a:lnTo>
                  <a:pt x="11795633" y="46100"/>
                </a:lnTo>
                <a:lnTo>
                  <a:pt x="11853418" y="46100"/>
                </a:lnTo>
                <a:lnTo>
                  <a:pt x="11911203" y="46100"/>
                </a:lnTo>
                <a:lnTo>
                  <a:pt x="11969115" y="46100"/>
                </a:lnTo>
                <a:lnTo>
                  <a:pt x="12026900" y="46100"/>
                </a:lnTo>
                <a:lnTo>
                  <a:pt x="12084685" y="46100"/>
                </a:lnTo>
                <a:lnTo>
                  <a:pt x="12142470" y="46100"/>
                </a:lnTo>
                <a:lnTo>
                  <a:pt x="12200382" y="46100"/>
                </a:lnTo>
                <a:lnTo>
                  <a:pt x="12258166" y="46100"/>
                </a:lnTo>
                <a:lnTo>
                  <a:pt x="12315952" y="46100"/>
                </a:lnTo>
                <a:lnTo>
                  <a:pt x="12373864" y="46100"/>
                </a:lnTo>
                <a:lnTo>
                  <a:pt x="12431649" y="46100"/>
                </a:lnTo>
                <a:lnTo>
                  <a:pt x="12489434" y="46100"/>
                </a:lnTo>
                <a:lnTo>
                  <a:pt x="12547218" y="46100"/>
                </a:lnTo>
                <a:lnTo>
                  <a:pt x="12605131" y="46100"/>
                </a:lnTo>
                <a:lnTo>
                  <a:pt x="12662916" y="46100"/>
                </a:lnTo>
                <a:lnTo>
                  <a:pt x="12720701" y="46100"/>
                </a:lnTo>
                <a:lnTo>
                  <a:pt x="12778613" y="46100"/>
                </a:lnTo>
                <a:lnTo>
                  <a:pt x="12836398" y="46100"/>
                </a:lnTo>
                <a:lnTo>
                  <a:pt x="12894183" y="46100"/>
                </a:lnTo>
                <a:lnTo>
                  <a:pt x="12951968" y="46100"/>
                </a:lnTo>
                <a:lnTo>
                  <a:pt x="13009879" y="46100"/>
                </a:lnTo>
                <a:lnTo>
                  <a:pt x="13009879" y="62865"/>
                </a:lnTo>
                <a:lnTo>
                  <a:pt x="13067664" y="62865"/>
                </a:lnTo>
                <a:lnTo>
                  <a:pt x="13125450" y="62865"/>
                </a:lnTo>
                <a:lnTo>
                  <a:pt x="13183362" y="62865"/>
                </a:lnTo>
                <a:lnTo>
                  <a:pt x="13241146" y="62865"/>
                </a:lnTo>
                <a:lnTo>
                  <a:pt x="13298931" y="62865"/>
                </a:lnTo>
                <a:lnTo>
                  <a:pt x="13356843" y="62865"/>
                </a:lnTo>
                <a:lnTo>
                  <a:pt x="13414629" y="62865"/>
                </a:lnTo>
                <a:lnTo>
                  <a:pt x="13472414" y="62865"/>
                </a:lnTo>
                <a:lnTo>
                  <a:pt x="13530198" y="62865"/>
                </a:lnTo>
                <a:lnTo>
                  <a:pt x="13588110" y="62865"/>
                </a:lnTo>
                <a:lnTo>
                  <a:pt x="13645895" y="62865"/>
                </a:lnTo>
                <a:lnTo>
                  <a:pt x="13703681" y="62865"/>
                </a:lnTo>
                <a:lnTo>
                  <a:pt x="13761592" y="62865"/>
                </a:lnTo>
                <a:lnTo>
                  <a:pt x="13819377" y="62865"/>
                </a:lnTo>
                <a:lnTo>
                  <a:pt x="13877162" y="62865"/>
                </a:lnTo>
                <a:lnTo>
                  <a:pt x="13934948" y="62865"/>
                </a:lnTo>
                <a:lnTo>
                  <a:pt x="13992860" y="62865"/>
                </a:lnTo>
                <a:lnTo>
                  <a:pt x="14050644" y="62865"/>
                </a:lnTo>
                <a:lnTo>
                  <a:pt x="14108429" y="62865"/>
                </a:lnTo>
                <a:lnTo>
                  <a:pt x="14166341" y="62865"/>
                </a:lnTo>
                <a:lnTo>
                  <a:pt x="14224127" y="62865"/>
                </a:lnTo>
                <a:lnTo>
                  <a:pt x="14281912" y="62865"/>
                </a:lnTo>
                <a:lnTo>
                  <a:pt x="14339696" y="62865"/>
                </a:lnTo>
                <a:lnTo>
                  <a:pt x="14397608" y="62865"/>
                </a:lnTo>
              </a:path>
            </a:pathLst>
          </a:custGeom>
          <a:ln w="27051">
            <a:solidFill>
              <a:srgbClr val="41A3FF"/>
            </a:solidFill>
            <a:prstDash val="dash"/>
          </a:ln>
        </p:spPr>
        <p:txBody>
          <a:bodyPr wrap="square" lIns="0" tIns="0" rIns="0" bIns="0" rtlCol="0"/>
          <a:lstStyle/>
          <a:p/>
        </p:txBody>
      </p:sp>
      <p:sp>
        <p:nvSpPr>
          <p:cNvPr id="23" name="bg object 23"/>
          <p:cNvSpPr/>
          <p:nvPr/>
        </p:nvSpPr>
        <p:spPr>
          <a:xfrm>
            <a:off x="1211452" y="722757"/>
            <a:ext cx="14397990" cy="106045"/>
          </a:xfrm>
          <a:custGeom>
            <a:avLst/>
            <a:gdLst/>
            <a:ahLst/>
            <a:cxnLst/>
            <a:rect l="l" t="t" r="r" b="b"/>
            <a:pathLst>
              <a:path w="14397990" h="106044">
                <a:moveTo>
                  <a:pt x="0" y="0"/>
                </a:moveTo>
                <a:lnTo>
                  <a:pt x="57784" y="0"/>
                </a:lnTo>
                <a:lnTo>
                  <a:pt x="115697" y="0"/>
                </a:lnTo>
                <a:lnTo>
                  <a:pt x="115697" y="1397"/>
                </a:lnTo>
                <a:lnTo>
                  <a:pt x="173481" y="1397"/>
                </a:lnTo>
                <a:lnTo>
                  <a:pt x="231266" y="1397"/>
                </a:lnTo>
                <a:lnTo>
                  <a:pt x="289178" y="1397"/>
                </a:lnTo>
                <a:lnTo>
                  <a:pt x="346963" y="1397"/>
                </a:lnTo>
                <a:lnTo>
                  <a:pt x="404749" y="1397"/>
                </a:lnTo>
                <a:lnTo>
                  <a:pt x="462534" y="1397"/>
                </a:lnTo>
                <a:lnTo>
                  <a:pt x="520446" y="1397"/>
                </a:lnTo>
                <a:lnTo>
                  <a:pt x="578230" y="1397"/>
                </a:lnTo>
                <a:lnTo>
                  <a:pt x="636016" y="1397"/>
                </a:lnTo>
                <a:lnTo>
                  <a:pt x="693928" y="1397"/>
                </a:lnTo>
                <a:lnTo>
                  <a:pt x="751713" y="1397"/>
                </a:lnTo>
                <a:lnTo>
                  <a:pt x="809497" y="1397"/>
                </a:lnTo>
                <a:lnTo>
                  <a:pt x="867283" y="1397"/>
                </a:lnTo>
                <a:lnTo>
                  <a:pt x="925195" y="1397"/>
                </a:lnTo>
                <a:lnTo>
                  <a:pt x="982979" y="1397"/>
                </a:lnTo>
                <a:lnTo>
                  <a:pt x="1040765" y="1397"/>
                </a:lnTo>
                <a:lnTo>
                  <a:pt x="1098677" y="1397"/>
                </a:lnTo>
                <a:lnTo>
                  <a:pt x="1156461" y="1397"/>
                </a:lnTo>
                <a:lnTo>
                  <a:pt x="1214247" y="1397"/>
                </a:lnTo>
                <a:lnTo>
                  <a:pt x="1214247" y="3048"/>
                </a:lnTo>
                <a:lnTo>
                  <a:pt x="1272032" y="3048"/>
                </a:lnTo>
                <a:lnTo>
                  <a:pt x="1272032" y="4572"/>
                </a:lnTo>
                <a:lnTo>
                  <a:pt x="1329944" y="4572"/>
                </a:lnTo>
                <a:lnTo>
                  <a:pt x="1387729" y="4572"/>
                </a:lnTo>
                <a:lnTo>
                  <a:pt x="1387729" y="6223"/>
                </a:lnTo>
                <a:lnTo>
                  <a:pt x="1445514" y="6223"/>
                </a:lnTo>
                <a:lnTo>
                  <a:pt x="1503426" y="6223"/>
                </a:lnTo>
                <a:lnTo>
                  <a:pt x="1503426" y="7874"/>
                </a:lnTo>
                <a:lnTo>
                  <a:pt x="1561211" y="7874"/>
                </a:lnTo>
                <a:lnTo>
                  <a:pt x="1561211" y="9651"/>
                </a:lnTo>
                <a:lnTo>
                  <a:pt x="1618996" y="9651"/>
                </a:lnTo>
                <a:lnTo>
                  <a:pt x="1676780" y="9651"/>
                </a:lnTo>
                <a:lnTo>
                  <a:pt x="1734692" y="9651"/>
                </a:lnTo>
                <a:lnTo>
                  <a:pt x="1792477" y="9651"/>
                </a:lnTo>
                <a:lnTo>
                  <a:pt x="1850263" y="9651"/>
                </a:lnTo>
                <a:lnTo>
                  <a:pt x="1908175" y="9651"/>
                </a:lnTo>
                <a:lnTo>
                  <a:pt x="1965960" y="9651"/>
                </a:lnTo>
                <a:lnTo>
                  <a:pt x="2023745" y="9651"/>
                </a:lnTo>
                <a:lnTo>
                  <a:pt x="2023745" y="11429"/>
                </a:lnTo>
                <a:lnTo>
                  <a:pt x="2081530" y="11429"/>
                </a:lnTo>
                <a:lnTo>
                  <a:pt x="2081530" y="13208"/>
                </a:lnTo>
                <a:lnTo>
                  <a:pt x="2139442" y="13208"/>
                </a:lnTo>
                <a:lnTo>
                  <a:pt x="2197227" y="13208"/>
                </a:lnTo>
                <a:lnTo>
                  <a:pt x="2197227" y="14986"/>
                </a:lnTo>
                <a:lnTo>
                  <a:pt x="2255012" y="14986"/>
                </a:lnTo>
                <a:lnTo>
                  <a:pt x="2312924" y="14986"/>
                </a:lnTo>
                <a:lnTo>
                  <a:pt x="2370709" y="14986"/>
                </a:lnTo>
                <a:lnTo>
                  <a:pt x="2428494" y="14986"/>
                </a:lnTo>
                <a:lnTo>
                  <a:pt x="2486406" y="14986"/>
                </a:lnTo>
                <a:lnTo>
                  <a:pt x="2486406" y="16891"/>
                </a:lnTo>
                <a:lnTo>
                  <a:pt x="2544191" y="16891"/>
                </a:lnTo>
                <a:lnTo>
                  <a:pt x="2601976" y="16891"/>
                </a:lnTo>
                <a:lnTo>
                  <a:pt x="2601976" y="18923"/>
                </a:lnTo>
                <a:lnTo>
                  <a:pt x="2659761" y="18923"/>
                </a:lnTo>
                <a:lnTo>
                  <a:pt x="2717673" y="18923"/>
                </a:lnTo>
                <a:lnTo>
                  <a:pt x="2775458" y="18923"/>
                </a:lnTo>
                <a:lnTo>
                  <a:pt x="2833243" y="18923"/>
                </a:lnTo>
                <a:lnTo>
                  <a:pt x="2891155" y="18923"/>
                </a:lnTo>
                <a:lnTo>
                  <a:pt x="2948940" y="18923"/>
                </a:lnTo>
                <a:lnTo>
                  <a:pt x="3006725" y="18923"/>
                </a:lnTo>
                <a:lnTo>
                  <a:pt x="3064510" y="18923"/>
                </a:lnTo>
                <a:lnTo>
                  <a:pt x="3122422" y="18923"/>
                </a:lnTo>
                <a:lnTo>
                  <a:pt x="3180207" y="18923"/>
                </a:lnTo>
                <a:lnTo>
                  <a:pt x="3237992" y="18923"/>
                </a:lnTo>
                <a:lnTo>
                  <a:pt x="3295904" y="18923"/>
                </a:lnTo>
                <a:lnTo>
                  <a:pt x="3353689" y="18923"/>
                </a:lnTo>
                <a:lnTo>
                  <a:pt x="3411474" y="18923"/>
                </a:lnTo>
                <a:lnTo>
                  <a:pt x="3469259" y="18923"/>
                </a:lnTo>
                <a:lnTo>
                  <a:pt x="3527171" y="18923"/>
                </a:lnTo>
                <a:lnTo>
                  <a:pt x="3584956" y="18923"/>
                </a:lnTo>
                <a:lnTo>
                  <a:pt x="3642741" y="18923"/>
                </a:lnTo>
                <a:lnTo>
                  <a:pt x="3642741" y="21209"/>
                </a:lnTo>
                <a:lnTo>
                  <a:pt x="3700653" y="21209"/>
                </a:lnTo>
                <a:lnTo>
                  <a:pt x="3758438" y="21209"/>
                </a:lnTo>
                <a:lnTo>
                  <a:pt x="3816223" y="21209"/>
                </a:lnTo>
                <a:lnTo>
                  <a:pt x="3816223" y="23622"/>
                </a:lnTo>
                <a:lnTo>
                  <a:pt x="3874008" y="23622"/>
                </a:lnTo>
                <a:lnTo>
                  <a:pt x="3931920" y="23622"/>
                </a:lnTo>
                <a:lnTo>
                  <a:pt x="3989705" y="23622"/>
                </a:lnTo>
                <a:lnTo>
                  <a:pt x="4047490" y="23622"/>
                </a:lnTo>
                <a:lnTo>
                  <a:pt x="4047490" y="26035"/>
                </a:lnTo>
                <a:lnTo>
                  <a:pt x="4105402" y="26035"/>
                </a:lnTo>
                <a:lnTo>
                  <a:pt x="4163187" y="26035"/>
                </a:lnTo>
                <a:lnTo>
                  <a:pt x="4220972" y="26035"/>
                </a:lnTo>
                <a:lnTo>
                  <a:pt x="4278757" y="26035"/>
                </a:lnTo>
                <a:lnTo>
                  <a:pt x="4336669" y="26035"/>
                </a:lnTo>
                <a:lnTo>
                  <a:pt x="4394454" y="26035"/>
                </a:lnTo>
                <a:lnTo>
                  <a:pt x="4452239" y="26035"/>
                </a:lnTo>
                <a:lnTo>
                  <a:pt x="4510151" y="26035"/>
                </a:lnTo>
                <a:lnTo>
                  <a:pt x="4567936" y="26035"/>
                </a:lnTo>
                <a:lnTo>
                  <a:pt x="4625721" y="26035"/>
                </a:lnTo>
                <a:lnTo>
                  <a:pt x="4683506" y="26035"/>
                </a:lnTo>
                <a:lnTo>
                  <a:pt x="4741418" y="26035"/>
                </a:lnTo>
                <a:lnTo>
                  <a:pt x="4799203" y="26035"/>
                </a:lnTo>
                <a:lnTo>
                  <a:pt x="4856988" y="26035"/>
                </a:lnTo>
                <a:lnTo>
                  <a:pt x="4914900" y="26035"/>
                </a:lnTo>
                <a:lnTo>
                  <a:pt x="4972685" y="26035"/>
                </a:lnTo>
                <a:lnTo>
                  <a:pt x="5030470" y="26035"/>
                </a:lnTo>
                <a:lnTo>
                  <a:pt x="5088255" y="26035"/>
                </a:lnTo>
                <a:lnTo>
                  <a:pt x="5146167" y="26035"/>
                </a:lnTo>
                <a:lnTo>
                  <a:pt x="5203952" y="26035"/>
                </a:lnTo>
                <a:lnTo>
                  <a:pt x="5203952" y="29210"/>
                </a:lnTo>
                <a:lnTo>
                  <a:pt x="5261737" y="29210"/>
                </a:lnTo>
                <a:lnTo>
                  <a:pt x="5319649" y="29210"/>
                </a:lnTo>
                <a:lnTo>
                  <a:pt x="5377433" y="29210"/>
                </a:lnTo>
                <a:lnTo>
                  <a:pt x="5377433" y="32385"/>
                </a:lnTo>
                <a:lnTo>
                  <a:pt x="5435219" y="32385"/>
                </a:lnTo>
                <a:lnTo>
                  <a:pt x="5493004" y="32385"/>
                </a:lnTo>
                <a:lnTo>
                  <a:pt x="5493004" y="35687"/>
                </a:lnTo>
                <a:lnTo>
                  <a:pt x="5550916" y="35687"/>
                </a:lnTo>
                <a:lnTo>
                  <a:pt x="5608701" y="35687"/>
                </a:lnTo>
                <a:lnTo>
                  <a:pt x="5608701" y="39116"/>
                </a:lnTo>
                <a:lnTo>
                  <a:pt x="5666486" y="39116"/>
                </a:lnTo>
                <a:lnTo>
                  <a:pt x="5724398" y="39116"/>
                </a:lnTo>
                <a:lnTo>
                  <a:pt x="5724398" y="42545"/>
                </a:lnTo>
                <a:lnTo>
                  <a:pt x="5782183" y="42545"/>
                </a:lnTo>
                <a:lnTo>
                  <a:pt x="5839968" y="42545"/>
                </a:lnTo>
                <a:lnTo>
                  <a:pt x="5897753" y="42545"/>
                </a:lnTo>
                <a:lnTo>
                  <a:pt x="5955665" y="42545"/>
                </a:lnTo>
                <a:lnTo>
                  <a:pt x="6013450" y="42545"/>
                </a:lnTo>
                <a:lnTo>
                  <a:pt x="6071235" y="42545"/>
                </a:lnTo>
                <a:lnTo>
                  <a:pt x="6129147" y="42545"/>
                </a:lnTo>
                <a:lnTo>
                  <a:pt x="6186932" y="42545"/>
                </a:lnTo>
                <a:lnTo>
                  <a:pt x="6244717" y="42545"/>
                </a:lnTo>
                <a:lnTo>
                  <a:pt x="6302502" y="42545"/>
                </a:lnTo>
                <a:lnTo>
                  <a:pt x="6360414" y="42545"/>
                </a:lnTo>
                <a:lnTo>
                  <a:pt x="6418199" y="42545"/>
                </a:lnTo>
                <a:lnTo>
                  <a:pt x="6475983" y="42545"/>
                </a:lnTo>
                <a:lnTo>
                  <a:pt x="6533896" y="42545"/>
                </a:lnTo>
                <a:lnTo>
                  <a:pt x="6591681" y="42545"/>
                </a:lnTo>
                <a:lnTo>
                  <a:pt x="6649466" y="42545"/>
                </a:lnTo>
                <a:lnTo>
                  <a:pt x="6707251" y="42545"/>
                </a:lnTo>
                <a:lnTo>
                  <a:pt x="6765163" y="42545"/>
                </a:lnTo>
                <a:lnTo>
                  <a:pt x="6822948" y="42545"/>
                </a:lnTo>
                <a:lnTo>
                  <a:pt x="6880733" y="42545"/>
                </a:lnTo>
                <a:lnTo>
                  <a:pt x="6938645" y="42545"/>
                </a:lnTo>
                <a:lnTo>
                  <a:pt x="6996430" y="42545"/>
                </a:lnTo>
                <a:lnTo>
                  <a:pt x="7054215" y="42545"/>
                </a:lnTo>
                <a:lnTo>
                  <a:pt x="7112000" y="42545"/>
                </a:lnTo>
                <a:lnTo>
                  <a:pt x="7169912" y="42545"/>
                </a:lnTo>
                <a:lnTo>
                  <a:pt x="7227697" y="42545"/>
                </a:lnTo>
                <a:lnTo>
                  <a:pt x="7285482" y="42545"/>
                </a:lnTo>
                <a:lnTo>
                  <a:pt x="7343394" y="42545"/>
                </a:lnTo>
                <a:lnTo>
                  <a:pt x="7401179" y="42545"/>
                </a:lnTo>
                <a:lnTo>
                  <a:pt x="7458964" y="42545"/>
                </a:lnTo>
                <a:lnTo>
                  <a:pt x="7516749" y="42545"/>
                </a:lnTo>
                <a:lnTo>
                  <a:pt x="7574661" y="42545"/>
                </a:lnTo>
                <a:lnTo>
                  <a:pt x="7632446" y="42545"/>
                </a:lnTo>
                <a:lnTo>
                  <a:pt x="7690231" y="42545"/>
                </a:lnTo>
                <a:lnTo>
                  <a:pt x="7748143" y="42545"/>
                </a:lnTo>
                <a:lnTo>
                  <a:pt x="7805928" y="42545"/>
                </a:lnTo>
                <a:lnTo>
                  <a:pt x="7863713" y="42545"/>
                </a:lnTo>
                <a:lnTo>
                  <a:pt x="7921625" y="42545"/>
                </a:lnTo>
                <a:lnTo>
                  <a:pt x="7979410" y="42545"/>
                </a:lnTo>
                <a:lnTo>
                  <a:pt x="8037195" y="42545"/>
                </a:lnTo>
                <a:lnTo>
                  <a:pt x="8094980" y="42545"/>
                </a:lnTo>
                <a:lnTo>
                  <a:pt x="8152892" y="42545"/>
                </a:lnTo>
                <a:lnTo>
                  <a:pt x="8210677" y="42545"/>
                </a:lnTo>
                <a:lnTo>
                  <a:pt x="8268462" y="42545"/>
                </a:lnTo>
                <a:lnTo>
                  <a:pt x="8326374" y="42545"/>
                </a:lnTo>
                <a:lnTo>
                  <a:pt x="8384158" y="42545"/>
                </a:lnTo>
                <a:lnTo>
                  <a:pt x="8441944" y="42545"/>
                </a:lnTo>
                <a:lnTo>
                  <a:pt x="8499729" y="42545"/>
                </a:lnTo>
                <a:lnTo>
                  <a:pt x="8557641" y="42545"/>
                </a:lnTo>
                <a:lnTo>
                  <a:pt x="8615426" y="42545"/>
                </a:lnTo>
                <a:lnTo>
                  <a:pt x="8673211" y="42545"/>
                </a:lnTo>
                <a:lnTo>
                  <a:pt x="8731123" y="42545"/>
                </a:lnTo>
                <a:lnTo>
                  <a:pt x="8788908" y="42545"/>
                </a:lnTo>
                <a:lnTo>
                  <a:pt x="8788908" y="50038"/>
                </a:lnTo>
                <a:lnTo>
                  <a:pt x="8846693" y="50038"/>
                </a:lnTo>
                <a:lnTo>
                  <a:pt x="8904478" y="50038"/>
                </a:lnTo>
                <a:lnTo>
                  <a:pt x="8962390" y="50038"/>
                </a:lnTo>
                <a:lnTo>
                  <a:pt x="9020175" y="50038"/>
                </a:lnTo>
                <a:lnTo>
                  <a:pt x="9077960" y="50038"/>
                </a:lnTo>
                <a:lnTo>
                  <a:pt x="9135872" y="50038"/>
                </a:lnTo>
                <a:lnTo>
                  <a:pt x="9193657" y="50038"/>
                </a:lnTo>
                <a:lnTo>
                  <a:pt x="9251442" y="50038"/>
                </a:lnTo>
                <a:lnTo>
                  <a:pt x="9309227" y="50038"/>
                </a:lnTo>
                <a:lnTo>
                  <a:pt x="9367139" y="50038"/>
                </a:lnTo>
                <a:lnTo>
                  <a:pt x="9424924" y="50038"/>
                </a:lnTo>
                <a:lnTo>
                  <a:pt x="9482709" y="50038"/>
                </a:lnTo>
                <a:lnTo>
                  <a:pt x="9540621" y="50038"/>
                </a:lnTo>
                <a:lnTo>
                  <a:pt x="9598406" y="50038"/>
                </a:lnTo>
                <a:lnTo>
                  <a:pt x="9656191" y="50038"/>
                </a:lnTo>
                <a:lnTo>
                  <a:pt x="9713976" y="50038"/>
                </a:lnTo>
                <a:lnTo>
                  <a:pt x="9771888" y="50038"/>
                </a:lnTo>
                <a:lnTo>
                  <a:pt x="9829673" y="50038"/>
                </a:lnTo>
                <a:lnTo>
                  <a:pt x="9887458" y="50038"/>
                </a:lnTo>
                <a:lnTo>
                  <a:pt x="9945370" y="50038"/>
                </a:lnTo>
                <a:lnTo>
                  <a:pt x="10003155" y="50038"/>
                </a:lnTo>
                <a:lnTo>
                  <a:pt x="10060940" y="50038"/>
                </a:lnTo>
                <a:lnTo>
                  <a:pt x="10118725" y="50038"/>
                </a:lnTo>
                <a:lnTo>
                  <a:pt x="10176637" y="50038"/>
                </a:lnTo>
                <a:lnTo>
                  <a:pt x="10234422" y="50038"/>
                </a:lnTo>
                <a:lnTo>
                  <a:pt x="10292207" y="50038"/>
                </a:lnTo>
                <a:lnTo>
                  <a:pt x="10350119" y="50038"/>
                </a:lnTo>
                <a:lnTo>
                  <a:pt x="10407904" y="50038"/>
                </a:lnTo>
                <a:lnTo>
                  <a:pt x="10465689" y="50038"/>
                </a:lnTo>
                <a:lnTo>
                  <a:pt x="10523474" y="50038"/>
                </a:lnTo>
                <a:lnTo>
                  <a:pt x="10581386" y="50038"/>
                </a:lnTo>
                <a:lnTo>
                  <a:pt x="10639171" y="50038"/>
                </a:lnTo>
                <a:lnTo>
                  <a:pt x="10639171" y="64389"/>
                </a:lnTo>
                <a:lnTo>
                  <a:pt x="10696956" y="64389"/>
                </a:lnTo>
                <a:lnTo>
                  <a:pt x="10754868" y="64389"/>
                </a:lnTo>
                <a:lnTo>
                  <a:pt x="10754868" y="79628"/>
                </a:lnTo>
                <a:lnTo>
                  <a:pt x="10812653" y="79628"/>
                </a:lnTo>
                <a:lnTo>
                  <a:pt x="10870438" y="79628"/>
                </a:lnTo>
                <a:lnTo>
                  <a:pt x="10928223" y="79628"/>
                </a:lnTo>
                <a:lnTo>
                  <a:pt x="10986135" y="79628"/>
                </a:lnTo>
                <a:lnTo>
                  <a:pt x="11043920" y="79628"/>
                </a:lnTo>
                <a:lnTo>
                  <a:pt x="11101705" y="79628"/>
                </a:lnTo>
                <a:lnTo>
                  <a:pt x="11159617" y="79628"/>
                </a:lnTo>
                <a:lnTo>
                  <a:pt x="11217402" y="79628"/>
                </a:lnTo>
                <a:lnTo>
                  <a:pt x="11275187" y="79628"/>
                </a:lnTo>
                <a:lnTo>
                  <a:pt x="11332972" y="79628"/>
                </a:lnTo>
                <a:lnTo>
                  <a:pt x="11390884" y="79628"/>
                </a:lnTo>
                <a:lnTo>
                  <a:pt x="11448669" y="79628"/>
                </a:lnTo>
                <a:lnTo>
                  <a:pt x="11506454" y="79628"/>
                </a:lnTo>
                <a:lnTo>
                  <a:pt x="11564366" y="79628"/>
                </a:lnTo>
                <a:lnTo>
                  <a:pt x="11622151" y="79628"/>
                </a:lnTo>
                <a:lnTo>
                  <a:pt x="11679936" y="79628"/>
                </a:lnTo>
                <a:lnTo>
                  <a:pt x="11737721" y="79628"/>
                </a:lnTo>
                <a:lnTo>
                  <a:pt x="11795633" y="79628"/>
                </a:lnTo>
                <a:lnTo>
                  <a:pt x="11795633" y="105791"/>
                </a:lnTo>
                <a:lnTo>
                  <a:pt x="11853418" y="105791"/>
                </a:lnTo>
                <a:lnTo>
                  <a:pt x="11911203" y="105791"/>
                </a:lnTo>
                <a:lnTo>
                  <a:pt x="11969115" y="105791"/>
                </a:lnTo>
                <a:lnTo>
                  <a:pt x="12026900" y="105791"/>
                </a:lnTo>
                <a:lnTo>
                  <a:pt x="12142470" y="105791"/>
                </a:lnTo>
                <a:lnTo>
                  <a:pt x="12200382" y="105791"/>
                </a:lnTo>
                <a:lnTo>
                  <a:pt x="12258166" y="105791"/>
                </a:lnTo>
                <a:lnTo>
                  <a:pt x="12315952" y="105791"/>
                </a:lnTo>
                <a:lnTo>
                  <a:pt x="12373864" y="105791"/>
                </a:lnTo>
                <a:lnTo>
                  <a:pt x="12431649" y="105791"/>
                </a:lnTo>
                <a:lnTo>
                  <a:pt x="12547218" y="105791"/>
                </a:lnTo>
                <a:lnTo>
                  <a:pt x="12605131" y="105791"/>
                </a:lnTo>
                <a:lnTo>
                  <a:pt x="12662916" y="105791"/>
                </a:lnTo>
                <a:lnTo>
                  <a:pt x="12720701" y="105791"/>
                </a:lnTo>
                <a:lnTo>
                  <a:pt x="12778613" y="105791"/>
                </a:lnTo>
                <a:lnTo>
                  <a:pt x="12836398" y="105791"/>
                </a:lnTo>
                <a:lnTo>
                  <a:pt x="12894183" y="105791"/>
                </a:lnTo>
                <a:lnTo>
                  <a:pt x="12951968" y="105791"/>
                </a:lnTo>
                <a:lnTo>
                  <a:pt x="13009879" y="105791"/>
                </a:lnTo>
                <a:lnTo>
                  <a:pt x="13067664" y="105791"/>
                </a:lnTo>
                <a:lnTo>
                  <a:pt x="13125450" y="105791"/>
                </a:lnTo>
                <a:lnTo>
                  <a:pt x="13241146" y="105791"/>
                </a:lnTo>
                <a:lnTo>
                  <a:pt x="13298931" y="105791"/>
                </a:lnTo>
                <a:lnTo>
                  <a:pt x="13356843" y="105791"/>
                </a:lnTo>
                <a:lnTo>
                  <a:pt x="13414629" y="105791"/>
                </a:lnTo>
                <a:lnTo>
                  <a:pt x="13472414" y="105791"/>
                </a:lnTo>
                <a:lnTo>
                  <a:pt x="13530198" y="105791"/>
                </a:lnTo>
                <a:lnTo>
                  <a:pt x="13588110" y="105791"/>
                </a:lnTo>
                <a:lnTo>
                  <a:pt x="13645895" y="105791"/>
                </a:lnTo>
                <a:lnTo>
                  <a:pt x="13703681" y="105791"/>
                </a:lnTo>
                <a:lnTo>
                  <a:pt x="13761592" y="105791"/>
                </a:lnTo>
                <a:lnTo>
                  <a:pt x="13819377" y="105791"/>
                </a:lnTo>
                <a:lnTo>
                  <a:pt x="13934948" y="105791"/>
                </a:lnTo>
                <a:lnTo>
                  <a:pt x="13992860" y="105791"/>
                </a:lnTo>
                <a:lnTo>
                  <a:pt x="14108429" y="105791"/>
                </a:lnTo>
                <a:lnTo>
                  <a:pt x="14166341" y="105791"/>
                </a:lnTo>
                <a:lnTo>
                  <a:pt x="14224127" y="105791"/>
                </a:lnTo>
                <a:lnTo>
                  <a:pt x="14397608" y="105791"/>
                </a:lnTo>
              </a:path>
            </a:pathLst>
          </a:custGeom>
          <a:ln w="27051">
            <a:solidFill>
              <a:srgbClr val="DFD625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4" name="bg object 24"/>
          <p:cNvSpPr/>
          <p:nvPr/>
        </p:nvSpPr>
        <p:spPr>
          <a:xfrm>
            <a:off x="1211452" y="722757"/>
            <a:ext cx="14166850" cy="302895"/>
          </a:xfrm>
          <a:custGeom>
            <a:avLst/>
            <a:gdLst/>
            <a:ahLst/>
            <a:cxnLst/>
            <a:rect l="l" t="t" r="r" b="b"/>
            <a:pathLst>
              <a:path w="14166850" h="302894">
                <a:moveTo>
                  <a:pt x="0" y="0"/>
                </a:moveTo>
                <a:lnTo>
                  <a:pt x="0" y="0"/>
                </a:lnTo>
                <a:lnTo>
                  <a:pt x="57784" y="0"/>
                </a:lnTo>
                <a:lnTo>
                  <a:pt x="115697" y="0"/>
                </a:lnTo>
                <a:lnTo>
                  <a:pt x="173481" y="0"/>
                </a:lnTo>
                <a:lnTo>
                  <a:pt x="231266" y="0"/>
                </a:lnTo>
                <a:lnTo>
                  <a:pt x="289178" y="0"/>
                </a:lnTo>
                <a:lnTo>
                  <a:pt x="346963" y="0"/>
                </a:lnTo>
                <a:lnTo>
                  <a:pt x="404749" y="0"/>
                </a:lnTo>
                <a:lnTo>
                  <a:pt x="462534" y="0"/>
                </a:lnTo>
                <a:lnTo>
                  <a:pt x="520446" y="0"/>
                </a:lnTo>
                <a:lnTo>
                  <a:pt x="520446" y="3048"/>
                </a:lnTo>
                <a:lnTo>
                  <a:pt x="578230" y="3048"/>
                </a:lnTo>
                <a:lnTo>
                  <a:pt x="636016" y="3048"/>
                </a:lnTo>
                <a:lnTo>
                  <a:pt x="693928" y="3048"/>
                </a:lnTo>
                <a:lnTo>
                  <a:pt x="751713" y="3048"/>
                </a:lnTo>
                <a:lnTo>
                  <a:pt x="809497" y="3048"/>
                </a:lnTo>
                <a:lnTo>
                  <a:pt x="867283" y="3048"/>
                </a:lnTo>
                <a:lnTo>
                  <a:pt x="925195" y="3048"/>
                </a:lnTo>
                <a:lnTo>
                  <a:pt x="982979" y="3048"/>
                </a:lnTo>
                <a:lnTo>
                  <a:pt x="1040765" y="3048"/>
                </a:lnTo>
                <a:lnTo>
                  <a:pt x="1098677" y="3048"/>
                </a:lnTo>
                <a:lnTo>
                  <a:pt x="1156461" y="3048"/>
                </a:lnTo>
                <a:lnTo>
                  <a:pt x="1156461" y="6350"/>
                </a:lnTo>
                <a:lnTo>
                  <a:pt x="1214247" y="6350"/>
                </a:lnTo>
                <a:lnTo>
                  <a:pt x="1272032" y="6350"/>
                </a:lnTo>
                <a:lnTo>
                  <a:pt x="1329944" y="6350"/>
                </a:lnTo>
                <a:lnTo>
                  <a:pt x="1329944" y="9778"/>
                </a:lnTo>
                <a:lnTo>
                  <a:pt x="1387729" y="9778"/>
                </a:lnTo>
                <a:lnTo>
                  <a:pt x="1445514" y="9778"/>
                </a:lnTo>
                <a:lnTo>
                  <a:pt x="1503426" y="9778"/>
                </a:lnTo>
                <a:lnTo>
                  <a:pt x="1561211" y="9778"/>
                </a:lnTo>
                <a:lnTo>
                  <a:pt x="1618996" y="9778"/>
                </a:lnTo>
                <a:lnTo>
                  <a:pt x="1676780" y="9778"/>
                </a:lnTo>
                <a:lnTo>
                  <a:pt x="1734692" y="9778"/>
                </a:lnTo>
                <a:lnTo>
                  <a:pt x="1792477" y="9778"/>
                </a:lnTo>
                <a:lnTo>
                  <a:pt x="1850263" y="9778"/>
                </a:lnTo>
                <a:lnTo>
                  <a:pt x="1908175" y="9778"/>
                </a:lnTo>
                <a:lnTo>
                  <a:pt x="1965960" y="9778"/>
                </a:lnTo>
                <a:lnTo>
                  <a:pt x="2023745" y="9778"/>
                </a:lnTo>
                <a:lnTo>
                  <a:pt x="2023745" y="13716"/>
                </a:lnTo>
                <a:lnTo>
                  <a:pt x="2081530" y="13716"/>
                </a:lnTo>
                <a:lnTo>
                  <a:pt x="2081530" y="17652"/>
                </a:lnTo>
                <a:lnTo>
                  <a:pt x="2139442" y="17652"/>
                </a:lnTo>
                <a:lnTo>
                  <a:pt x="2197227" y="17652"/>
                </a:lnTo>
                <a:lnTo>
                  <a:pt x="2255012" y="17652"/>
                </a:lnTo>
                <a:lnTo>
                  <a:pt x="2312924" y="17652"/>
                </a:lnTo>
                <a:lnTo>
                  <a:pt x="2370709" y="17652"/>
                </a:lnTo>
                <a:lnTo>
                  <a:pt x="2428494" y="17652"/>
                </a:lnTo>
                <a:lnTo>
                  <a:pt x="2486406" y="17652"/>
                </a:lnTo>
                <a:lnTo>
                  <a:pt x="2544191" y="17652"/>
                </a:lnTo>
                <a:lnTo>
                  <a:pt x="2601976" y="17652"/>
                </a:lnTo>
                <a:lnTo>
                  <a:pt x="2659761" y="17652"/>
                </a:lnTo>
                <a:lnTo>
                  <a:pt x="2717673" y="17652"/>
                </a:lnTo>
                <a:lnTo>
                  <a:pt x="2775458" y="17652"/>
                </a:lnTo>
                <a:lnTo>
                  <a:pt x="2833243" y="17652"/>
                </a:lnTo>
                <a:lnTo>
                  <a:pt x="2891155" y="17652"/>
                </a:lnTo>
                <a:lnTo>
                  <a:pt x="2948940" y="17652"/>
                </a:lnTo>
                <a:lnTo>
                  <a:pt x="3006725" y="17652"/>
                </a:lnTo>
                <a:lnTo>
                  <a:pt x="3064510" y="17652"/>
                </a:lnTo>
                <a:lnTo>
                  <a:pt x="3122422" y="17652"/>
                </a:lnTo>
                <a:lnTo>
                  <a:pt x="3180207" y="17652"/>
                </a:lnTo>
                <a:lnTo>
                  <a:pt x="3237992" y="17652"/>
                </a:lnTo>
                <a:lnTo>
                  <a:pt x="3295904" y="17652"/>
                </a:lnTo>
                <a:lnTo>
                  <a:pt x="3353689" y="17652"/>
                </a:lnTo>
                <a:lnTo>
                  <a:pt x="3411474" y="17652"/>
                </a:lnTo>
                <a:lnTo>
                  <a:pt x="3469259" y="17652"/>
                </a:lnTo>
                <a:lnTo>
                  <a:pt x="3527171" y="17652"/>
                </a:lnTo>
                <a:lnTo>
                  <a:pt x="3527171" y="22733"/>
                </a:lnTo>
                <a:lnTo>
                  <a:pt x="3584956" y="22733"/>
                </a:lnTo>
                <a:lnTo>
                  <a:pt x="3642741" y="22733"/>
                </a:lnTo>
                <a:lnTo>
                  <a:pt x="3700653" y="22733"/>
                </a:lnTo>
                <a:lnTo>
                  <a:pt x="3758438" y="22733"/>
                </a:lnTo>
                <a:lnTo>
                  <a:pt x="3758438" y="33147"/>
                </a:lnTo>
                <a:lnTo>
                  <a:pt x="3816223" y="33147"/>
                </a:lnTo>
                <a:lnTo>
                  <a:pt x="3874008" y="33147"/>
                </a:lnTo>
                <a:lnTo>
                  <a:pt x="3931920" y="33147"/>
                </a:lnTo>
                <a:lnTo>
                  <a:pt x="3989705" y="33147"/>
                </a:lnTo>
                <a:lnTo>
                  <a:pt x="4047490" y="33147"/>
                </a:lnTo>
                <a:lnTo>
                  <a:pt x="4105402" y="33147"/>
                </a:lnTo>
                <a:lnTo>
                  <a:pt x="4163187" y="33147"/>
                </a:lnTo>
                <a:lnTo>
                  <a:pt x="4220972" y="33147"/>
                </a:lnTo>
                <a:lnTo>
                  <a:pt x="4278757" y="33147"/>
                </a:lnTo>
                <a:lnTo>
                  <a:pt x="4336669" y="33147"/>
                </a:lnTo>
                <a:lnTo>
                  <a:pt x="4394454" y="33147"/>
                </a:lnTo>
                <a:lnTo>
                  <a:pt x="4452239" y="33147"/>
                </a:lnTo>
                <a:lnTo>
                  <a:pt x="4510151" y="33147"/>
                </a:lnTo>
                <a:lnTo>
                  <a:pt x="4567936" y="33147"/>
                </a:lnTo>
                <a:lnTo>
                  <a:pt x="4625721" y="33147"/>
                </a:lnTo>
                <a:lnTo>
                  <a:pt x="4683506" y="33147"/>
                </a:lnTo>
                <a:lnTo>
                  <a:pt x="4741418" y="33147"/>
                </a:lnTo>
                <a:lnTo>
                  <a:pt x="4799203" y="33147"/>
                </a:lnTo>
                <a:lnTo>
                  <a:pt x="4856988" y="33147"/>
                </a:lnTo>
                <a:lnTo>
                  <a:pt x="4914900" y="33147"/>
                </a:lnTo>
                <a:lnTo>
                  <a:pt x="4972685" y="33147"/>
                </a:lnTo>
                <a:lnTo>
                  <a:pt x="5030470" y="33147"/>
                </a:lnTo>
                <a:lnTo>
                  <a:pt x="5088255" y="33147"/>
                </a:lnTo>
                <a:lnTo>
                  <a:pt x="5088255" y="46990"/>
                </a:lnTo>
                <a:lnTo>
                  <a:pt x="5146167" y="46990"/>
                </a:lnTo>
                <a:lnTo>
                  <a:pt x="5203952" y="46990"/>
                </a:lnTo>
                <a:lnTo>
                  <a:pt x="5203952" y="53848"/>
                </a:lnTo>
                <a:lnTo>
                  <a:pt x="5261737" y="53848"/>
                </a:lnTo>
                <a:lnTo>
                  <a:pt x="5319649" y="53848"/>
                </a:lnTo>
                <a:lnTo>
                  <a:pt x="5377433" y="53848"/>
                </a:lnTo>
                <a:lnTo>
                  <a:pt x="5435219" y="53848"/>
                </a:lnTo>
                <a:lnTo>
                  <a:pt x="5493004" y="53848"/>
                </a:lnTo>
                <a:lnTo>
                  <a:pt x="5550916" y="53848"/>
                </a:lnTo>
                <a:lnTo>
                  <a:pt x="5608701" y="53848"/>
                </a:lnTo>
                <a:lnTo>
                  <a:pt x="5666486" y="53848"/>
                </a:lnTo>
                <a:lnTo>
                  <a:pt x="5724398" y="53848"/>
                </a:lnTo>
                <a:lnTo>
                  <a:pt x="5782183" y="53848"/>
                </a:lnTo>
                <a:lnTo>
                  <a:pt x="5839968" y="53848"/>
                </a:lnTo>
                <a:lnTo>
                  <a:pt x="5897753" y="53848"/>
                </a:lnTo>
                <a:lnTo>
                  <a:pt x="5955665" y="53848"/>
                </a:lnTo>
                <a:lnTo>
                  <a:pt x="6013450" y="53848"/>
                </a:lnTo>
                <a:lnTo>
                  <a:pt x="6071235" y="53848"/>
                </a:lnTo>
                <a:lnTo>
                  <a:pt x="6129147" y="53848"/>
                </a:lnTo>
                <a:lnTo>
                  <a:pt x="6186932" y="53848"/>
                </a:lnTo>
                <a:lnTo>
                  <a:pt x="6244717" y="53848"/>
                </a:lnTo>
                <a:lnTo>
                  <a:pt x="6302502" y="53848"/>
                </a:lnTo>
                <a:lnTo>
                  <a:pt x="6360414" y="53848"/>
                </a:lnTo>
                <a:lnTo>
                  <a:pt x="6418199" y="53848"/>
                </a:lnTo>
                <a:lnTo>
                  <a:pt x="6418199" y="63373"/>
                </a:lnTo>
                <a:lnTo>
                  <a:pt x="6475983" y="63373"/>
                </a:lnTo>
                <a:lnTo>
                  <a:pt x="6533896" y="63373"/>
                </a:lnTo>
                <a:lnTo>
                  <a:pt x="6591681" y="63373"/>
                </a:lnTo>
                <a:lnTo>
                  <a:pt x="6649466" y="63373"/>
                </a:lnTo>
                <a:lnTo>
                  <a:pt x="6707251" y="63373"/>
                </a:lnTo>
                <a:lnTo>
                  <a:pt x="6765163" y="63373"/>
                </a:lnTo>
                <a:lnTo>
                  <a:pt x="6822948" y="63373"/>
                </a:lnTo>
                <a:lnTo>
                  <a:pt x="6938645" y="63373"/>
                </a:lnTo>
                <a:lnTo>
                  <a:pt x="6996430" y="63373"/>
                </a:lnTo>
                <a:lnTo>
                  <a:pt x="7054215" y="63373"/>
                </a:lnTo>
                <a:lnTo>
                  <a:pt x="7054215" y="74549"/>
                </a:lnTo>
                <a:lnTo>
                  <a:pt x="7112000" y="74549"/>
                </a:lnTo>
                <a:lnTo>
                  <a:pt x="7169912" y="74549"/>
                </a:lnTo>
                <a:lnTo>
                  <a:pt x="7227697" y="74549"/>
                </a:lnTo>
                <a:lnTo>
                  <a:pt x="7285482" y="74549"/>
                </a:lnTo>
                <a:lnTo>
                  <a:pt x="7343394" y="74549"/>
                </a:lnTo>
                <a:lnTo>
                  <a:pt x="7401179" y="74549"/>
                </a:lnTo>
                <a:lnTo>
                  <a:pt x="7458964" y="74549"/>
                </a:lnTo>
                <a:lnTo>
                  <a:pt x="7516749" y="74549"/>
                </a:lnTo>
                <a:lnTo>
                  <a:pt x="7516749" y="87249"/>
                </a:lnTo>
                <a:lnTo>
                  <a:pt x="7574661" y="87249"/>
                </a:lnTo>
                <a:lnTo>
                  <a:pt x="7632446" y="87249"/>
                </a:lnTo>
                <a:lnTo>
                  <a:pt x="7690231" y="87249"/>
                </a:lnTo>
                <a:lnTo>
                  <a:pt x="7748143" y="87249"/>
                </a:lnTo>
                <a:lnTo>
                  <a:pt x="7805928" y="87249"/>
                </a:lnTo>
                <a:lnTo>
                  <a:pt x="7863713" y="87249"/>
                </a:lnTo>
                <a:lnTo>
                  <a:pt x="7921625" y="87249"/>
                </a:lnTo>
                <a:lnTo>
                  <a:pt x="7979410" y="87249"/>
                </a:lnTo>
                <a:lnTo>
                  <a:pt x="8037195" y="87249"/>
                </a:lnTo>
                <a:lnTo>
                  <a:pt x="8094980" y="87249"/>
                </a:lnTo>
                <a:lnTo>
                  <a:pt x="8152892" y="87249"/>
                </a:lnTo>
                <a:lnTo>
                  <a:pt x="8210677" y="87249"/>
                </a:lnTo>
                <a:lnTo>
                  <a:pt x="8268462" y="87249"/>
                </a:lnTo>
                <a:lnTo>
                  <a:pt x="8326374" y="87249"/>
                </a:lnTo>
                <a:lnTo>
                  <a:pt x="8384158" y="87249"/>
                </a:lnTo>
                <a:lnTo>
                  <a:pt x="8441944" y="87249"/>
                </a:lnTo>
                <a:lnTo>
                  <a:pt x="8499729" y="87249"/>
                </a:lnTo>
                <a:lnTo>
                  <a:pt x="8557641" y="87249"/>
                </a:lnTo>
                <a:lnTo>
                  <a:pt x="8615426" y="87249"/>
                </a:lnTo>
                <a:lnTo>
                  <a:pt x="8673211" y="87249"/>
                </a:lnTo>
                <a:lnTo>
                  <a:pt x="8731123" y="87249"/>
                </a:lnTo>
                <a:lnTo>
                  <a:pt x="8788908" y="87249"/>
                </a:lnTo>
                <a:lnTo>
                  <a:pt x="8846693" y="87249"/>
                </a:lnTo>
                <a:lnTo>
                  <a:pt x="8904478" y="87249"/>
                </a:lnTo>
                <a:lnTo>
                  <a:pt x="8962390" y="87249"/>
                </a:lnTo>
                <a:lnTo>
                  <a:pt x="9020175" y="87249"/>
                </a:lnTo>
                <a:lnTo>
                  <a:pt x="9077960" y="87249"/>
                </a:lnTo>
                <a:lnTo>
                  <a:pt x="9135872" y="87249"/>
                </a:lnTo>
                <a:lnTo>
                  <a:pt x="9193657" y="87249"/>
                </a:lnTo>
                <a:lnTo>
                  <a:pt x="9251442" y="87249"/>
                </a:lnTo>
                <a:lnTo>
                  <a:pt x="9309227" y="87249"/>
                </a:lnTo>
                <a:lnTo>
                  <a:pt x="9424924" y="87249"/>
                </a:lnTo>
                <a:lnTo>
                  <a:pt x="9482709" y="87249"/>
                </a:lnTo>
                <a:lnTo>
                  <a:pt x="9540621" y="87249"/>
                </a:lnTo>
                <a:lnTo>
                  <a:pt x="9598406" y="87249"/>
                </a:lnTo>
                <a:lnTo>
                  <a:pt x="9656191" y="87249"/>
                </a:lnTo>
                <a:lnTo>
                  <a:pt x="9713976" y="87249"/>
                </a:lnTo>
                <a:lnTo>
                  <a:pt x="9771888" y="87249"/>
                </a:lnTo>
                <a:lnTo>
                  <a:pt x="9829673" y="87249"/>
                </a:lnTo>
                <a:lnTo>
                  <a:pt x="9829673" y="113792"/>
                </a:lnTo>
                <a:lnTo>
                  <a:pt x="9887458" y="113792"/>
                </a:lnTo>
                <a:lnTo>
                  <a:pt x="10003155" y="113792"/>
                </a:lnTo>
                <a:lnTo>
                  <a:pt x="10060940" y="113792"/>
                </a:lnTo>
                <a:lnTo>
                  <a:pt x="10118725" y="113792"/>
                </a:lnTo>
                <a:lnTo>
                  <a:pt x="10176637" y="113792"/>
                </a:lnTo>
                <a:lnTo>
                  <a:pt x="10234422" y="113792"/>
                </a:lnTo>
                <a:lnTo>
                  <a:pt x="10234422" y="146558"/>
                </a:lnTo>
                <a:lnTo>
                  <a:pt x="10292207" y="146558"/>
                </a:lnTo>
                <a:lnTo>
                  <a:pt x="10350119" y="146558"/>
                </a:lnTo>
                <a:lnTo>
                  <a:pt x="10407904" y="146558"/>
                </a:lnTo>
                <a:lnTo>
                  <a:pt x="10465689" y="146558"/>
                </a:lnTo>
                <a:lnTo>
                  <a:pt x="10581386" y="146558"/>
                </a:lnTo>
                <a:lnTo>
                  <a:pt x="10639171" y="146558"/>
                </a:lnTo>
                <a:lnTo>
                  <a:pt x="10754868" y="146558"/>
                </a:lnTo>
                <a:lnTo>
                  <a:pt x="10812653" y="146558"/>
                </a:lnTo>
                <a:lnTo>
                  <a:pt x="10870438" y="146558"/>
                </a:lnTo>
                <a:lnTo>
                  <a:pt x="10986135" y="146558"/>
                </a:lnTo>
                <a:lnTo>
                  <a:pt x="11043920" y="146558"/>
                </a:lnTo>
                <a:lnTo>
                  <a:pt x="11101705" y="146558"/>
                </a:lnTo>
                <a:lnTo>
                  <a:pt x="11159617" y="146558"/>
                </a:lnTo>
                <a:lnTo>
                  <a:pt x="11217402" y="146558"/>
                </a:lnTo>
                <a:lnTo>
                  <a:pt x="11275187" y="146558"/>
                </a:lnTo>
                <a:lnTo>
                  <a:pt x="11332972" y="146558"/>
                </a:lnTo>
                <a:lnTo>
                  <a:pt x="11506454" y="146558"/>
                </a:lnTo>
                <a:lnTo>
                  <a:pt x="11564366" y="146558"/>
                </a:lnTo>
                <a:lnTo>
                  <a:pt x="11622151" y="146558"/>
                </a:lnTo>
                <a:lnTo>
                  <a:pt x="11679936" y="146558"/>
                </a:lnTo>
                <a:lnTo>
                  <a:pt x="11737721" y="146558"/>
                </a:lnTo>
                <a:lnTo>
                  <a:pt x="11795633" y="146558"/>
                </a:lnTo>
                <a:lnTo>
                  <a:pt x="11853418" y="146558"/>
                </a:lnTo>
                <a:lnTo>
                  <a:pt x="11969115" y="146558"/>
                </a:lnTo>
                <a:lnTo>
                  <a:pt x="12026900" y="146558"/>
                </a:lnTo>
                <a:lnTo>
                  <a:pt x="12084685" y="146558"/>
                </a:lnTo>
                <a:lnTo>
                  <a:pt x="12200382" y="146558"/>
                </a:lnTo>
                <a:lnTo>
                  <a:pt x="12258166" y="146558"/>
                </a:lnTo>
                <a:lnTo>
                  <a:pt x="12315952" y="146558"/>
                </a:lnTo>
                <a:lnTo>
                  <a:pt x="12373864" y="146558"/>
                </a:lnTo>
                <a:lnTo>
                  <a:pt x="12489434" y="146558"/>
                </a:lnTo>
                <a:lnTo>
                  <a:pt x="12605131" y="146558"/>
                </a:lnTo>
                <a:lnTo>
                  <a:pt x="12662916" y="146558"/>
                </a:lnTo>
                <a:lnTo>
                  <a:pt x="12720701" y="146558"/>
                </a:lnTo>
                <a:lnTo>
                  <a:pt x="12778613" y="146558"/>
                </a:lnTo>
                <a:lnTo>
                  <a:pt x="12836398" y="146558"/>
                </a:lnTo>
                <a:lnTo>
                  <a:pt x="12894183" y="146558"/>
                </a:lnTo>
                <a:lnTo>
                  <a:pt x="12951968" y="146558"/>
                </a:lnTo>
                <a:lnTo>
                  <a:pt x="13009879" y="146558"/>
                </a:lnTo>
                <a:lnTo>
                  <a:pt x="13067664" y="146558"/>
                </a:lnTo>
                <a:lnTo>
                  <a:pt x="13125450" y="146558"/>
                </a:lnTo>
                <a:lnTo>
                  <a:pt x="13125450" y="302768"/>
                </a:lnTo>
                <a:lnTo>
                  <a:pt x="13241146" y="302768"/>
                </a:lnTo>
                <a:lnTo>
                  <a:pt x="13298931" y="302768"/>
                </a:lnTo>
                <a:lnTo>
                  <a:pt x="13356843" y="302768"/>
                </a:lnTo>
                <a:lnTo>
                  <a:pt x="13530198" y="302768"/>
                </a:lnTo>
                <a:lnTo>
                  <a:pt x="13588110" y="302768"/>
                </a:lnTo>
                <a:lnTo>
                  <a:pt x="13645895" y="302768"/>
                </a:lnTo>
                <a:lnTo>
                  <a:pt x="13761592" y="302768"/>
                </a:lnTo>
                <a:lnTo>
                  <a:pt x="13819377" y="302768"/>
                </a:lnTo>
                <a:lnTo>
                  <a:pt x="13877162" y="302768"/>
                </a:lnTo>
                <a:lnTo>
                  <a:pt x="13934948" y="302768"/>
                </a:lnTo>
                <a:lnTo>
                  <a:pt x="13992860" y="302768"/>
                </a:lnTo>
                <a:lnTo>
                  <a:pt x="14108429" y="302768"/>
                </a:lnTo>
                <a:lnTo>
                  <a:pt x="14166341" y="302768"/>
                </a:lnTo>
              </a:path>
            </a:pathLst>
          </a:custGeom>
          <a:ln w="27051">
            <a:solidFill>
              <a:srgbClr val="4DCE6B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5" name="bg object 25"/>
          <p:cNvSpPr/>
          <p:nvPr/>
        </p:nvSpPr>
        <p:spPr>
          <a:xfrm>
            <a:off x="1211452" y="722757"/>
            <a:ext cx="14340205" cy="132080"/>
          </a:xfrm>
          <a:custGeom>
            <a:avLst/>
            <a:gdLst/>
            <a:ahLst/>
            <a:cxnLst/>
            <a:rect l="l" t="t" r="r" b="b"/>
            <a:pathLst>
              <a:path w="14340205" h="132080">
                <a:moveTo>
                  <a:pt x="0" y="0"/>
                </a:moveTo>
                <a:lnTo>
                  <a:pt x="0" y="0"/>
                </a:lnTo>
                <a:lnTo>
                  <a:pt x="57784" y="0"/>
                </a:lnTo>
                <a:lnTo>
                  <a:pt x="115697" y="0"/>
                </a:lnTo>
                <a:lnTo>
                  <a:pt x="173481" y="0"/>
                </a:lnTo>
                <a:lnTo>
                  <a:pt x="231266" y="0"/>
                </a:lnTo>
                <a:lnTo>
                  <a:pt x="289178" y="0"/>
                </a:lnTo>
                <a:lnTo>
                  <a:pt x="346963" y="0"/>
                </a:lnTo>
                <a:lnTo>
                  <a:pt x="404749" y="0"/>
                </a:lnTo>
                <a:lnTo>
                  <a:pt x="462534" y="0"/>
                </a:lnTo>
                <a:lnTo>
                  <a:pt x="520446" y="0"/>
                </a:lnTo>
                <a:lnTo>
                  <a:pt x="578230" y="0"/>
                </a:lnTo>
                <a:lnTo>
                  <a:pt x="636016" y="0"/>
                </a:lnTo>
                <a:lnTo>
                  <a:pt x="636016" y="1650"/>
                </a:lnTo>
                <a:lnTo>
                  <a:pt x="693928" y="1650"/>
                </a:lnTo>
                <a:lnTo>
                  <a:pt x="693928" y="3301"/>
                </a:lnTo>
                <a:lnTo>
                  <a:pt x="751713" y="3301"/>
                </a:lnTo>
                <a:lnTo>
                  <a:pt x="809497" y="3301"/>
                </a:lnTo>
                <a:lnTo>
                  <a:pt x="867283" y="3301"/>
                </a:lnTo>
                <a:lnTo>
                  <a:pt x="925195" y="3301"/>
                </a:lnTo>
                <a:lnTo>
                  <a:pt x="982979" y="3301"/>
                </a:lnTo>
                <a:lnTo>
                  <a:pt x="1040765" y="3301"/>
                </a:lnTo>
                <a:lnTo>
                  <a:pt x="1098677" y="3301"/>
                </a:lnTo>
                <a:lnTo>
                  <a:pt x="1156461" y="3301"/>
                </a:lnTo>
                <a:lnTo>
                  <a:pt x="1214247" y="3301"/>
                </a:lnTo>
                <a:lnTo>
                  <a:pt x="1214247" y="5079"/>
                </a:lnTo>
                <a:lnTo>
                  <a:pt x="1272032" y="5079"/>
                </a:lnTo>
                <a:lnTo>
                  <a:pt x="1272032" y="6858"/>
                </a:lnTo>
                <a:lnTo>
                  <a:pt x="1329944" y="6858"/>
                </a:lnTo>
                <a:lnTo>
                  <a:pt x="1387729" y="6858"/>
                </a:lnTo>
                <a:lnTo>
                  <a:pt x="1445514" y="6858"/>
                </a:lnTo>
                <a:lnTo>
                  <a:pt x="1503426" y="6858"/>
                </a:lnTo>
                <a:lnTo>
                  <a:pt x="1561211" y="6858"/>
                </a:lnTo>
                <a:lnTo>
                  <a:pt x="1561211" y="8890"/>
                </a:lnTo>
                <a:lnTo>
                  <a:pt x="1618996" y="8890"/>
                </a:lnTo>
                <a:lnTo>
                  <a:pt x="1676780" y="8890"/>
                </a:lnTo>
                <a:lnTo>
                  <a:pt x="1734692" y="8890"/>
                </a:lnTo>
                <a:lnTo>
                  <a:pt x="1792477" y="8890"/>
                </a:lnTo>
                <a:lnTo>
                  <a:pt x="1850263" y="8890"/>
                </a:lnTo>
                <a:lnTo>
                  <a:pt x="1908175" y="8890"/>
                </a:lnTo>
                <a:lnTo>
                  <a:pt x="1908175" y="10922"/>
                </a:lnTo>
                <a:lnTo>
                  <a:pt x="1965960" y="10922"/>
                </a:lnTo>
                <a:lnTo>
                  <a:pt x="2023745" y="10922"/>
                </a:lnTo>
                <a:lnTo>
                  <a:pt x="2081530" y="10922"/>
                </a:lnTo>
                <a:lnTo>
                  <a:pt x="2081530" y="15113"/>
                </a:lnTo>
                <a:lnTo>
                  <a:pt x="2139442" y="15113"/>
                </a:lnTo>
                <a:lnTo>
                  <a:pt x="2139442" y="17272"/>
                </a:lnTo>
                <a:lnTo>
                  <a:pt x="2197227" y="17272"/>
                </a:lnTo>
                <a:lnTo>
                  <a:pt x="2255012" y="17272"/>
                </a:lnTo>
                <a:lnTo>
                  <a:pt x="2312924" y="17272"/>
                </a:lnTo>
                <a:lnTo>
                  <a:pt x="2370709" y="17272"/>
                </a:lnTo>
                <a:lnTo>
                  <a:pt x="2428494" y="17272"/>
                </a:lnTo>
                <a:lnTo>
                  <a:pt x="2486406" y="17272"/>
                </a:lnTo>
                <a:lnTo>
                  <a:pt x="2544191" y="17272"/>
                </a:lnTo>
                <a:lnTo>
                  <a:pt x="2601976" y="17272"/>
                </a:lnTo>
                <a:lnTo>
                  <a:pt x="2659761" y="17272"/>
                </a:lnTo>
                <a:lnTo>
                  <a:pt x="2717673" y="17272"/>
                </a:lnTo>
                <a:lnTo>
                  <a:pt x="2775458" y="17272"/>
                </a:lnTo>
                <a:lnTo>
                  <a:pt x="2775458" y="21971"/>
                </a:lnTo>
                <a:lnTo>
                  <a:pt x="2833243" y="21971"/>
                </a:lnTo>
                <a:lnTo>
                  <a:pt x="2891155" y="21971"/>
                </a:lnTo>
                <a:lnTo>
                  <a:pt x="2948940" y="21971"/>
                </a:lnTo>
                <a:lnTo>
                  <a:pt x="3006725" y="21971"/>
                </a:lnTo>
                <a:lnTo>
                  <a:pt x="3064510" y="21971"/>
                </a:lnTo>
                <a:lnTo>
                  <a:pt x="3122422" y="21971"/>
                </a:lnTo>
                <a:lnTo>
                  <a:pt x="3180207" y="21971"/>
                </a:lnTo>
                <a:lnTo>
                  <a:pt x="3237992" y="21971"/>
                </a:lnTo>
                <a:lnTo>
                  <a:pt x="3295904" y="21971"/>
                </a:lnTo>
                <a:lnTo>
                  <a:pt x="3353689" y="21971"/>
                </a:lnTo>
                <a:lnTo>
                  <a:pt x="3411474" y="21971"/>
                </a:lnTo>
                <a:lnTo>
                  <a:pt x="3469259" y="21971"/>
                </a:lnTo>
                <a:lnTo>
                  <a:pt x="3527171" y="21971"/>
                </a:lnTo>
                <a:lnTo>
                  <a:pt x="3584956" y="21971"/>
                </a:lnTo>
                <a:lnTo>
                  <a:pt x="3642741" y="21971"/>
                </a:lnTo>
                <a:lnTo>
                  <a:pt x="3642741" y="24765"/>
                </a:lnTo>
                <a:lnTo>
                  <a:pt x="3700653" y="24765"/>
                </a:lnTo>
                <a:lnTo>
                  <a:pt x="3758438" y="24765"/>
                </a:lnTo>
                <a:lnTo>
                  <a:pt x="3816223" y="24765"/>
                </a:lnTo>
                <a:lnTo>
                  <a:pt x="3816223" y="27686"/>
                </a:lnTo>
                <a:lnTo>
                  <a:pt x="3874008" y="27686"/>
                </a:lnTo>
                <a:lnTo>
                  <a:pt x="3931920" y="27686"/>
                </a:lnTo>
                <a:lnTo>
                  <a:pt x="3989705" y="27686"/>
                </a:lnTo>
                <a:lnTo>
                  <a:pt x="4047490" y="27686"/>
                </a:lnTo>
                <a:lnTo>
                  <a:pt x="4105402" y="27686"/>
                </a:lnTo>
                <a:lnTo>
                  <a:pt x="4105402" y="30734"/>
                </a:lnTo>
                <a:lnTo>
                  <a:pt x="4163187" y="30734"/>
                </a:lnTo>
                <a:lnTo>
                  <a:pt x="4163187" y="33782"/>
                </a:lnTo>
                <a:lnTo>
                  <a:pt x="4220972" y="33782"/>
                </a:lnTo>
                <a:lnTo>
                  <a:pt x="4278757" y="33782"/>
                </a:lnTo>
                <a:lnTo>
                  <a:pt x="4336669" y="33782"/>
                </a:lnTo>
                <a:lnTo>
                  <a:pt x="4394454" y="33782"/>
                </a:lnTo>
                <a:lnTo>
                  <a:pt x="4452239" y="33782"/>
                </a:lnTo>
                <a:lnTo>
                  <a:pt x="4452239" y="37084"/>
                </a:lnTo>
                <a:lnTo>
                  <a:pt x="4510151" y="37084"/>
                </a:lnTo>
                <a:lnTo>
                  <a:pt x="4567936" y="37084"/>
                </a:lnTo>
                <a:lnTo>
                  <a:pt x="4625721" y="37084"/>
                </a:lnTo>
                <a:lnTo>
                  <a:pt x="4625721" y="40513"/>
                </a:lnTo>
                <a:lnTo>
                  <a:pt x="4683506" y="40513"/>
                </a:lnTo>
                <a:lnTo>
                  <a:pt x="4741418" y="40513"/>
                </a:lnTo>
                <a:lnTo>
                  <a:pt x="4799203" y="40513"/>
                </a:lnTo>
                <a:lnTo>
                  <a:pt x="4856988" y="40513"/>
                </a:lnTo>
                <a:lnTo>
                  <a:pt x="4914900" y="40513"/>
                </a:lnTo>
                <a:lnTo>
                  <a:pt x="4972685" y="40513"/>
                </a:lnTo>
                <a:lnTo>
                  <a:pt x="4972685" y="48133"/>
                </a:lnTo>
                <a:lnTo>
                  <a:pt x="5030470" y="48133"/>
                </a:lnTo>
                <a:lnTo>
                  <a:pt x="5088255" y="48133"/>
                </a:lnTo>
                <a:lnTo>
                  <a:pt x="5146167" y="48133"/>
                </a:lnTo>
                <a:lnTo>
                  <a:pt x="5146167" y="52070"/>
                </a:lnTo>
                <a:lnTo>
                  <a:pt x="5203952" y="52070"/>
                </a:lnTo>
                <a:lnTo>
                  <a:pt x="5203952" y="56007"/>
                </a:lnTo>
                <a:lnTo>
                  <a:pt x="5261737" y="56007"/>
                </a:lnTo>
                <a:lnTo>
                  <a:pt x="5319649" y="56007"/>
                </a:lnTo>
                <a:lnTo>
                  <a:pt x="5377433" y="56007"/>
                </a:lnTo>
                <a:lnTo>
                  <a:pt x="5435219" y="56007"/>
                </a:lnTo>
                <a:lnTo>
                  <a:pt x="5493004" y="56007"/>
                </a:lnTo>
                <a:lnTo>
                  <a:pt x="5550916" y="56007"/>
                </a:lnTo>
                <a:lnTo>
                  <a:pt x="5608701" y="56007"/>
                </a:lnTo>
                <a:lnTo>
                  <a:pt x="5666486" y="56007"/>
                </a:lnTo>
                <a:lnTo>
                  <a:pt x="5724398" y="56007"/>
                </a:lnTo>
                <a:lnTo>
                  <a:pt x="5782183" y="56007"/>
                </a:lnTo>
                <a:lnTo>
                  <a:pt x="5839968" y="56007"/>
                </a:lnTo>
                <a:lnTo>
                  <a:pt x="5897753" y="56007"/>
                </a:lnTo>
                <a:lnTo>
                  <a:pt x="5955665" y="56007"/>
                </a:lnTo>
                <a:lnTo>
                  <a:pt x="6013450" y="56007"/>
                </a:lnTo>
                <a:lnTo>
                  <a:pt x="6071235" y="56007"/>
                </a:lnTo>
                <a:lnTo>
                  <a:pt x="6129147" y="56007"/>
                </a:lnTo>
                <a:lnTo>
                  <a:pt x="6129147" y="61214"/>
                </a:lnTo>
                <a:lnTo>
                  <a:pt x="6186932" y="61214"/>
                </a:lnTo>
                <a:lnTo>
                  <a:pt x="6186932" y="66421"/>
                </a:lnTo>
                <a:lnTo>
                  <a:pt x="6244717" y="66421"/>
                </a:lnTo>
                <a:lnTo>
                  <a:pt x="6302502" y="66421"/>
                </a:lnTo>
                <a:lnTo>
                  <a:pt x="6360414" y="66421"/>
                </a:lnTo>
                <a:lnTo>
                  <a:pt x="6418199" y="66421"/>
                </a:lnTo>
                <a:lnTo>
                  <a:pt x="6475983" y="66421"/>
                </a:lnTo>
                <a:lnTo>
                  <a:pt x="6533896" y="66421"/>
                </a:lnTo>
                <a:lnTo>
                  <a:pt x="6591681" y="66421"/>
                </a:lnTo>
                <a:lnTo>
                  <a:pt x="6649466" y="66421"/>
                </a:lnTo>
                <a:lnTo>
                  <a:pt x="6707251" y="66421"/>
                </a:lnTo>
                <a:lnTo>
                  <a:pt x="6707251" y="72263"/>
                </a:lnTo>
                <a:lnTo>
                  <a:pt x="6765163" y="72263"/>
                </a:lnTo>
                <a:lnTo>
                  <a:pt x="6822948" y="72263"/>
                </a:lnTo>
                <a:lnTo>
                  <a:pt x="6880733" y="72263"/>
                </a:lnTo>
                <a:lnTo>
                  <a:pt x="6938645" y="72263"/>
                </a:lnTo>
                <a:lnTo>
                  <a:pt x="6996430" y="72263"/>
                </a:lnTo>
                <a:lnTo>
                  <a:pt x="7054215" y="72263"/>
                </a:lnTo>
                <a:lnTo>
                  <a:pt x="7112000" y="72263"/>
                </a:lnTo>
                <a:lnTo>
                  <a:pt x="7169912" y="72263"/>
                </a:lnTo>
                <a:lnTo>
                  <a:pt x="7227697" y="72263"/>
                </a:lnTo>
                <a:lnTo>
                  <a:pt x="7285482" y="72263"/>
                </a:lnTo>
                <a:lnTo>
                  <a:pt x="7343394" y="72263"/>
                </a:lnTo>
                <a:lnTo>
                  <a:pt x="7401179" y="72263"/>
                </a:lnTo>
                <a:lnTo>
                  <a:pt x="7458964" y="72263"/>
                </a:lnTo>
                <a:lnTo>
                  <a:pt x="7516749" y="72263"/>
                </a:lnTo>
                <a:lnTo>
                  <a:pt x="7574661" y="72263"/>
                </a:lnTo>
                <a:lnTo>
                  <a:pt x="7632446" y="72263"/>
                </a:lnTo>
                <a:lnTo>
                  <a:pt x="7632446" y="79883"/>
                </a:lnTo>
                <a:lnTo>
                  <a:pt x="7690231" y="79883"/>
                </a:lnTo>
                <a:lnTo>
                  <a:pt x="7690231" y="87502"/>
                </a:lnTo>
                <a:lnTo>
                  <a:pt x="7748143" y="87502"/>
                </a:lnTo>
                <a:lnTo>
                  <a:pt x="7805928" y="87502"/>
                </a:lnTo>
                <a:lnTo>
                  <a:pt x="7863713" y="87502"/>
                </a:lnTo>
                <a:lnTo>
                  <a:pt x="7863713" y="95631"/>
                </a:lnTo>
                <a:lnTo>
                  <a:pt x="7921625" y="95631"/>
                </a:lnTo>
                <a:lnTo>
                  <a:pt x="7979410" y="95631"/>
                </a:lnTo>
                <a:lnTo>
                  <a:pt x="8037195" y="95631"/>
                </a:lnTo>
                <a:lnTo>
                  <a:pt x="8094980" y="95631"/>
                </a:lnTo>
                <a:lnTo>
                  <a:pt x="8152892" y="95631"/>
                </a:lnTo>
                <a:lnTo>
                  <a:pt x="8210677" y="95631"/>
                </a:lnTo>
                <a:lnTo>
                  <a:pt x="8268462" y="95631"/>
                </a:lnTo>
                <a:lnTo>
                  <a:pt x="8326374" y="95631"/>
                </a:lnTo>
                <a:lnTo>
                  <a:pt x="8326374" y="105537"/>
                </a:lnTo>
                <a:lnTo>
                  <a:pt x="8384158" y="105537"/>
                </a:lnTo>
                <a:lnTo>
                  <a:pt x="8441944" y="105537"/>
                </a:lnTo>
                <a:lnTo>
                  <a:pt x="8499729" y="105537"/>
                </a:lnTo>
                <a:lnTo>
                  <a:pt x="8557641" y="105537"/>
                </a:lnTo>
                <a:lnTo>
                  <a:pt x="8615426" y="105537"/>
                </a:lnTo>
                <a:lnTo>
                  <a:pt x="8673211" y="105537"/>
                </a:lnTo>
                <a:lnTo>
                  <a:pt x="8731123" y="105537"/>
                </a:lnTo>
                <a:lnTo>
                  <a:pt x="8788908" y="105537"/>
                </a:lnTo>
                <a:lnTo>
                  <a:pt x="8788908" y="117094"/>
                </a:lnTo>
                <a:lnTo>
                  <a:pt x="8846693" y="117094"/>
                </a:lnTo>
                <a:lnTo>
                  <a:pt x="8962390" y="117094"/>
                </a:lnTo>
                <a:lnTo>
                  <a:pt x="9020175" y="117094"/>
                </a:lnTo>
                <a:lnTo>
                  <a:pt x="9077960" y="117094"/>
                </a:lnTo>
                <a:lnTo>
                  <a:pt x="9135872" y="117094"/>
                </a:lnTo>
                <a:lnTo>
                  <a:pt x="9193657" y="117094"/>
                </a:lnTo>
                <a:lnTo>
                  <a:pt x="9251442" y="117094"/>
                </a:lnTo>
                <a:lnTo>
                  <a:pt x="9309227" y="117094"/>
                </a:lnTo>
                <a:lnTo>
                  <a:pt x="9367139" y="117094"/>
                </a:lnTo>
                <a:lnTo>
                  <a:pt x="9424924" y="117094"/>
                </a:lnTo>
                <a:lnTo>
                  <a:pt x="9424924" y="131825"/>
                </a:lnTo>
                <a:lnTo>
                  <a:pt x="9482709" y="131825"/>
                </a:lnTo>
                <a:lnTo>
                  <a:pt x="9540621" y="131825"/>
                </a:lnTo>
                <a:lnTo>
                  <a:pt x="9598406" y="131825"/>
                </a:lnTo>
                <a:lnTo>
                  <a:pt x="9656191" y="131825"/>
                </a:lnTo>
                <a:lnTo>
                  <a:pt x="9713976" y="131825"/>
                </a:lnTo>
                <a:lnTo>
                  <a:pt x="9771888" y="131825"/>
                </a:lnTo>
                <a:lnTo>
                  <a:pt x="9829673" y="131825"/>
                </a:lnTo>
                <a:lnTo>
                  <a:pt x="9887458" y="131825"/>
                </a:lnTo>
                <a:lnTo>
                  <a:pt x="9945370" y="131825"/>
                </a:lnTo>
                <a:lnTo>
                  <a:pt x="10003155" y="131825"/>
                </a:lnTo>
                <a:lnTo>
                  <a:pt x="10060940" y="131825"/>
                </a:lnTo>
                <a:lnTo>
                  <a:pt x="10118725" y="131825"/>
                </a:lnTo>
                <a:lnTo>
                  <a:pt x="10176637" y="131825"/>
                </a:lnTo>
                <a:lnTo>
                  <a:pt x="10234422" y="131825"/>
                </a:lnTo>
                <a:lnTo>
                  <a:pt x="10292207" y="131825"/>
                </a:lnTo>
                <a:lnTo>
                  <a:pt x="10350119" y="131825"/>
                </a:lnTo>
                <a:lnTo>
                  <a:pt x="10407904" y="131825"/>
                </a:lnTo>
                <a:lnTo>
                  <a:pt x="10465689" y="131825"/>
                </a:lnTo>
                <a:lnTo>
                  <a:pt x="10523474" y="131825"/>
                </a:lnTo>
                <a:lnTo>
                  <a:pt x="10581386" y="131825"/>
                </a:lnTo>
                <a:lnTo>
                  <a:pt x="10639171" y="131825"/>
                </a:lnTo>
                <a:lnTo>
                  <a:pt x="10696956" y="131825"/>
                </a:lnTo>
                <a:lnTo>
                  <a:pt x="10754868" y="131825"/>
                </a:lnTo>
                <a:lnTo>
                  <a:pt x="10812653" y="131825"/>
                </a:lnTo>
                <a:lnTo>
                  <a:pt x="10870438" y="131825"/>
                </a:lnTo>
                <a:lnTo>
                  <a:pt x="10928223" y="131825"/>
                </a:lnTo>
                <a:lnTo>
                  <a:pt x="10986135" y="131825"/>
                </a:lnTo>
                <a:lnTo>
                  <a:pt x="11043920" y="131825"/>
                </a:lnTo>
                <a:lnTo>
                  <a:pt x="11101705" y="131825"/>
                </a:lnTo>
                <a:lnTo>
                  <a:pt x="11159617" y="131825"/>
                </a:lnTo>
                <a:lnTo>
                  <a:pt x="11217402" y="131825"/>
                </a:lnTo>
                <a:lnTo>
                  <a:pt x="11275187" y="131825"/>
                </a:lnTo>
                <a:lnTo>
                  <a:pt x="11332972" y="131825"/>
                </a:lnTo>
                <a:lnTo>
                  <a:pt x="11390884" y="131825"/>
                </a:lnTo>
                <a:lnTo>
                  <a:pt x="11448669" y="131825"/>
                </a:lnTo>
                <a:lnTo>
                  <a:pt x="11506454" y="131825"/>
                </a:lnTo>
                <a:lnTo>
                  <a:pt x="11564366" y="131825"/>
                </a:lnTo>
                <a:lnTo>
                  <a:pt x="11622151" y="131825"/>
                </a:lnTo>
                <a:lnTo>
                  <a:pt x="11679936" y="131825"/>
                </a:lnTo>
                <a:lnTo>
                  <a:pt x="11737721" y="131825"/>
                </a:lnTo>
                <a:lnTo>
                  <a:pt x="11795633" y="131825"/>
                </a:lnTo>
                <a:lnTo>
                  <a:pt x="11853418" y="131825"/>
                </a:lnTo>
                <a:lnTo>
                  <a:pt x="11911203" y="131825"/>
                </a:lnTo>
                <a:lnTo>
                  <a:pt x="11969115" y="131825"/>
                </a:lnTo>
                <a:lnTo>
                  <a:pt x="12142470" y="131825"/>
                </a:lnTo>
                <a:lnTo>
                  <a:pt x="12200382" y="131825"/>
                </a:lnTo>
                <a:lnTo>
                  <a:pt x="12258166" y="131825"/>
                </a:lnTo>
                <a:lnTo>
                  <a:pt x="12431649" y="131825"/>
                </a:lnTo>
                <a:lnTo>
                  <a:pt x="12489434" y="131825"/>
                </a:lnTo>
                <a:lnTo>
                  <a:pt x="12547218" y="131825"/>
                </a:lnTo>
                <a:lnTo>
                  <a:pt x="12662916" y="131825"/>
                </a:lnTo>
                <a:lnTo>
                  <a:pt x="12720701" y="131825"/>
                </a:lnTo>
                <a:lnTo>
                  <a:pt x="12778613" y="131825"/>
                </a:lnTo>
                <a:lnTo>
                  <a:pt x="12836398" y="131825"/>
                </a:lnTo>
                <a:lnTo>
                  <a:pt x="12894183" y="131825"/>
                </a:lnTo>
                <a:lnTo>
                  <a:pt x="12951968" y="131825"/>
                </a:lnTo>
                <a:lnTo>
                  <a:pt x="13009879" y="131825"/>
                </a:lnTo>
                <a:lnTo>
                  <a:pt x="13067664" y="131825"/>
                </a:lnTo>
                <a:lnTo>
                  <a:pt x="13183362" y="131825"/>
                </a:lnTo>
                <a:lnTo>
                  <a:pt x="13298931" y="131825"/>
                </a:lnTo>
                <a:lnTo>
                  <a:pt x="13356843" y="131825"/>
                </a:lnTo>
                <a:lnTo>
                  <a:pt x="13472414" y="131825"/>
                </a:lnTo>
                <a:lnTo>
                  <a:pt x="13530198" y="131825"/>
                </a:lnTo>
                <a:lnTo>
                  <a:pt x="13645895" y="131825"/>
                </a:lnTo>
                <a:lnTo>
                  <a:pt x="14281912" y="131825"/>
                </a:lnTo>
                <a:lnTo>
                  <a:pt x="14339696" y="131825"/>
                </a:lnTo>
              </a:path>
            </a:pathLst>
          </a:custGeom>
          <a:ln w="27051">
            <a:solidFill>
              <a:srgbClr val="BCA7E8"/>
            </a:solidFill>
            <a:prstDash val="sysDash"/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bg object 26"/>
          <p:cNvSpPr/>
          <p:nvPr/>
        </p:nvSpPr>
        <p:spPr>
          <a:xfrm>
            <a:off x="2714879" y="722629"/>
            <a:ext cx="12836525" cy="22860"/>
          </a:xfrm>
          <a:custGeom>
            <a:avLst/>
            <a:gdLst/>
            <a:ahLst/>
            <a:cxnLst/>
            <a:rect l="l" t="t" r="r" b="b"/>
            <a:pathLst>
              <a:path w="12836525" h="22859">
                <a:moveTo>
                  <a:pt x="12836271" y="0"/>
                </a:moveTo>
                <a:lnTo>
                  <a:pt x="0" y="0"/>
                </a:lnTo>
                <a:lnTo>
                  <a:pt x="0" y="5080"/>
                </a:lnTo>
                <a:lnTo>
                  <a:pt x="4741291" y="5080"/>
                </a:lnTo>
                <a:lnTo>
                  <a:pt x="4741291" y="10160"/>
                </a:lnTo>
                <a:lnTo>
                  <a:pt x="5782056" y="10160"/>
                </a:lnTo>
                <a:lnTo>
                  <a:pt x="5782056" y="15240"/>
                </a:lnTo>
                <a:lnTo>
                  <a:pt x="6938518" y="15240"/>
                </a:lnTo>
                <a:lnTo>
                  <a:pt x="6938518" y="22860"/>
                </a:lnTo>
                <a:lnTo>
                  <a:pt x="12836271" y="22860"/>
                </a:lnTo>
                <a:lnTo>
                  <a:pt x="12836271" y="15240"/>
                </a:lnTo>
                <a:lnTo>
                  <a:pt x="12836271" y="10160"/>
                </a:lnTo>
                <a:lnTo>
                  <a:pt x="12836271" y="5080"/>
                </a:lnTo>
                <a:lnTo>
                  <a:pt x="12836271" y="0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7" name="bg object 27"/>
          <p:cNvSpPr/>
          <p:nvPr/>
        </p:nvSpPr>
        <p:spPr>
          <a:xfrm>
            <a:off x="1384935" y="722629"/>
            <a:ext cx="14224635" cy="102870"/>
          </a:xfrm>
          <a:custGeom>
            <a:avLst/>
            <a:gdLst/>
            <a:ahLst/>
            <a:cxnLst/>
            <a:rect l="l" t="t" r="r" b="b"/>
            <a:pathLst>
              <a:path w="14224635" h="102869">
                <a:moveTo>
                  <a:pt x="2775458" y="1270"/>
                </a:moveTo>
                <a:lnTo>
                  <a:pt x="1792478" y="1270"/>
                </a:lnTo>
                <a:lnTo>
                  <a:pt x="1792478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578231" y="2540"/>
                </a:lnTo>
                <a:lnTo>
                  <a:pt x="578231" y="3810"/>
                </a:lnTo>
                <a:lnTo>
                  <a:pt x="867283" y="3810"/>
                </a:lnTo>
                <a:lnTo>
                  <a:pt x="867283" y="2540"/>
                </a:lnTo>
                <a:lnTo>
                  <a:pt x="2775458" y="2540"/>
                </a:lnTo>
                <a:lnTo>
                  <a:pt x="2775458" y="1270"/>
                </a:lnTo>
                <a:close/>
              </a:path>
              <a:path w="14224635" h="102869">
                <a:moveTo>
                  <a:pt x="14224127" y="22733"/>
                </a:moveTo>
                <a:lnTo>
                  <a:pt x="12836398" y="22733"/>
                </a:lnTo>
                <a:lnTo>
                  <a:pt x="12836398" y="22860"/>
                </a:lnTo>
                <a:lnTo>
                  <a:pt x="11159490" y="22860"/>
                </a:lnTo>
                <a:lnTo>
                  <a:pt x="11159490" y="20320"/>
                </a:lnTo>
                <a:lnTo>
                  <a:pt x="11101705" y="20320"/>
                </a:lnTo>
                <a:lnTo>
                  <a:pt x="11101705" y="19050"/>
                </a:lnTo>
                <a:lnTo>
                  <a:pt x="9829673" y="19050"/>
                </a:lnTo>
                <a:lnTo>
                  <a:pt x="9829673" y="16510"/>
                </a:lnTo>
                <a:lnTo>
                  <a:pt x="8788908" y="16510"/>
                </a:lnTo>
                <a:lnTo>
                  <a:pt x="8788908" y="15240"/>
                </a:lnTo>
                <a:lnTo>
                  <a:pt x="8730996" y="15240"/>
                </a:lnTo>
                <a:lnTo>
                  <a:pt x="8730996" y="13970"/>
                </a:lnTo>
                <a:lnTo>
                  <a:pt x="7748143" y="13970"/>
                </a:lnTo>
                <a:lnTo>
                  <a:pt x="7748143" y="12700"/>
                </a:lnTo>
                <a:lnTo>
                  <a:pt x="7343267" y="12700"/>
                </a:lnTo>
                <a:lnTo>
                  <a:pt x="7343267" y="11430"/>
                </a:lnTo>
                <a:lnTo>
                  <a:pt x="7169912" y="11430"/>
                </a:lnTo>
                <a:lnTo>
                  <a:pt x="7169912" y="10160"/>
                </a:lnTo>
                <a:lnTo>
                  <a:pt x="6996430" y="10160"/>
                </a:lnTo>
                <a:lnTo>
                  <a:pt x="6996430" y="8890"/>
                </a:lnTo>
                <a:lnTo>
                  <a:pt x="6938518" y="8890"/>
                </a:lnTo>
                <a:lnTo>
                  <a:pt x="6938518" y="7620"/>
                </a:lnTo>
                <a:lnTo>
                  <a:pt x="6591681" y="7620"/>
                </a:lnTo>
                <a:lnTo>
                  <a:pt x="6591681" y="6350"/>
                </a:lnTo>
                <a:lnTo>
                  <a:pt x="5435219" y="6350"/>
                </a:lnTo>
                <a:lnTo>
                  <a:pt x="5435219" y="5080"/>
                </a:lnTo>
                <a:lnTo>
                  <a:pt x="4625721" y="5080"/>
                </a:lnTo>
                <a:lnTo>
                  <a:pt x="4625721" y="3810"/>
                </a:lnTo>
                <a:lnTo>
                  <a:pt x="1214247" y="3810"/>
                </a:lnTo>
                <a:lnTo>
                  <a:pt x="1214247" y="5080"/>
                </a:lnTo>
                <a:lnTo>
                  <a:pt x="1272032" y="5080"/>
                </a:lnTo>
                <a:lnTo>
                  <a:pt x="1272032" y="6350"/>
                </a:lnTo>
                <a:lnTo>
                  <a:pt x="1792478" y="6350"/>
                </a:lnTo>
                <a:lnTo>
                  <a:pt x="1792478" y="7620"/>
                </a:lnTo>
                <a:lnTo>
                  <a:pt x="2601976" y="7620"/>
                </a:lnTo>
                <a:lnTo>
                  <a:pt x="2601976" y="8890"/>
                </a:lnTo>
                <a:lnTo>
                  <a:pt x="2775458" y="8890"/>
                </a:lnTo>
                <a:lnTo>
                  <a:pt x="2775458" y="10160"/>
                </a:lnTo>
                <a:lnTo>
                  <a:pt x="2948940" y="10160"/>
                </a:lnTo>
                <a:lnTo>
                  <a:pt x="2948940" y="11430"/>
                </a:lnTo>
                <a:lnTo>
                  <a:pt x="3180207" y="11430"/>
                </a:lnTo>
                <a:lnTo>
                  <a:pt x="3180207" y="12700"/>
                </a:lnTo>
                <a:lnTo>
                  <a:pt x="3295777" y="12700"/>
                </a:lnTo>
                <a:lnTo>
                  <a:pt x="3295777" y="13970"/>
                </a:lnTo>
                <a:lnTo>
                  <a:pt x="3469259" y="13970"/>
                </a:lnTo>
                <a:lnTo>
                  <a:pt x="3469259" y="15240"/>
                </a:lnTo>
                <a:lnTo>
                  <a:pt x="4625721" y="15240"/>
                </a:lnTo>
                <a:lnTo>
                  <a:pt x="4625721" y="16510"/>
                </a:lnTo>
                <a:lnTo>
                  <a:pt x="5435219" y="16510"/>
                </a:lnTo>
                <a:lnTo>
                  <a:pt x="5435219" y="19050"/>
                </a:lnTo>
                <a:lnTo>
                  <a:pt x="6013450" y="19050"/>
                </a:lnTo>
                <a:lnTo>
                  <a:pt x="6013450" y="20320"/>
                </a:lnTo>
                <a:lnTo>
                  <a:pt x="6591681" y="20320"/>
                </a:lnTo>
                <a:lnTo>
                  <a:pt x="6591681" y="22860"/>
                </a:lnTo>
                <a:lnTo>
                  <a:pt x="6938518" y="22860"/>
                </a:lnTo>
                <a:lnTo>
                  <a:pt x="6938518" y="25400"/>
                </a:lnTo>
                <a:lnTo>
                  <a:pt x="6996430" y="25400"/>
                </a:lnTo>
                <a:lnTo>
                  <a:pt x="6996430" y="27940"/>
                </a:lnTo>
                <a:lnTo>
                  <a:pt x="7169912" y="27940"/>
                </a:lnTo>
                <a:lnTo>
                  <a:pt x="7169912" y="30480"/>
                </a:lnTo>
                <a:lnTo>
                  <a:pt x="7343267" y="30480"/>
                </a:lnTo>
                <a:lnTo>
                  <a:pt x="7343267" y="33020"/>
                </a:lnTo>
                <a:lnTo>
                  <a:pt x="7748143" y="33020"/>
                </a:lnTo>
                <a:lnTo>
                  <a:pt x="7748143" y="35560"/>
                </a:lnTo>
                <a:lnTo>
                  <a:pt x="8730996" y="35560"/>
                </a:lnTo>
                <a:lnTo>
                  <a:pt x="8730996" y="40640"/>
                </a:lnTo>
                <a:lnTo>
                  <a:pt x="8788908" y="40640"/>
                </a:lnTo>
                <a:lnTo>
                  <a:pt x="8788908" y="44450"/>
                </a:lnTo>
                <a:lnTo>
                  <a:pt x="9829673" y="44450"/>
                </a:lnTo>
                <a:lnTo>
                  <a:pt x="9829673" y="49530"/>
                </a:lnTo>
                <a:lnTo>
                  <a:pt x="11101705" y="49530"/>
                </a:lnTo>
                <a:lnTo>
                  <a:pt x="11101705" y="59690"/>
                </a:lnTo>
                <a:lnTo>
                  <a:pt x="11159490" y="59690"/>
                </a:lnTo>
                <a:lnTo>
                  <a:pt x="11159490" y="68580"/>
                </a:lnTo>
                <a:lnTo>
                  <a:pt x="12836398" y="68580"/>
                </a:lnTo>
                <a:lnTo>
                  <a:pt x="12836398" y="102870"/>
                </a:lnTo>
                <a:lnTo>
                  <a:pt x="14224127" y="102870"/>
                </a:lnTo>
                <a:lnTo>
                  <a:pt x="14224127" y="22860"/>
                </a:lnTo>
                <a:lnTo>
                  <a:pt x="14224127" y="22733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8" name="bg object 28"/>
          <p:cNvSpPr/>
          <p:nvPr/>
        </p:nvSpPr>
        <p:spPr>
          <a:xfrm>
            <a:off x="1327150" y="722629"/>
            <a:ext cx="14282419" cy="175260"/>
          </a:xfrm>
          <a:custGeom>
            <a:avLst/>
            <a:gdLst/>
            <a:ahLst/>
            <a:cxnLst/>
            <a:rect l="l" t="t" r="r" b="b"/>
            <a:pathLst>
              <a:path w="14282419" h="175259">
                <a:moveTo>
                  <a:pt x="14281912" y="35560"/>
                </a:moveTo>
                <a:lnTo>
                  <a:pt x="11679936" y="35560"/>
                </a:lnTo>
                <a:lnTo>
                  <a:pt x="11679936" y="33020"/>
                </a:lnTo>
                <a:lnTo>
                  <a:pt x="11679936" y="31750"/>
                </a:lnTo>
                <a:lnTo>
                  <a:pt x="10639171" y="31750"/>
                </a:lnTo>
                <a:lnTo>
                  <a:pt x="10639171" y="30480"/>
                </a:lnTo>
                <a:lnTo>
                  <a:pt x="10639171" y="27940"/>
                </a:lnTo>
                <a:lnTo>
                  <a:pt x="10639171" y="26670"/>
                </a:lnTo>
                <a:lnTo>
                  <a:pt x="10523474" y="26670"/>
                </a:lnTo>
                <a:lnTo>
                  <a:pt x="10523474" y="25400"/>
                </a:lnTo>
                <a:lnTo>
                  <a:pt x="8673211" y="25400"/>
                </a:lnTo>
                <a:lnTo>
                  <a:pt x="8673211" y="22860"/>
                </a:lnTo>
                <a:lnTo>
                  <a:pt x="5608701" y="22860"/>
                </a:lnTo>
                <a:lnTo>
                  <a:pt x="5608701" y="20320"/>
                </a:lnTo>
                <a:lnTo>
                  <a:pt x="5493004" y="20320"/>
                </a:lnTo>
                <a:lnTo>
                  <a:pt x="5493004" y="17780"/>
                </a:lnTo>
                <a:lnTo>
                  <a:pt x="5377307" y="17780"/>
                </a:lnTo>
                <a:lnTo>
                  <a:pt x="5377307" y="16510"/>
                </a:lnTo>
                <a:lnTo>
                  <a:pt x="5261724" y="16510"/>
                </a:lnTo>
                <a:lnTo>
                  <a:pt x="5261724" y="15240"/>
                </a:lnTo>
                <a:lnTo>
                  <a:pt x="5261724" y="13970"/>
                </a:lnTo>
                <a:lnTo>
                  <a:pt x="5088255" y="13970"/>
                </a:lnTo>
                <a:lnTo>
                  <a:pt x="5088255" y="12700"/>
                </a:lnTo>
                <a:lnTo>
                  <a:pt x="3931793" y="12700"/>
                </a:lnTo>
                <a:lnTo>
                  <a:pt x="3931793" y="11430"/>
                </a:lnTo>
                <a:lnTo>
                  <a:pt x="3700526" y="11430"/>
                </a:lnTo>
                <a:lnTo>
                  <a:pt x="3700526" y="10160"/>
                </a:lnTo>
                <a:lnTo>
                  <a:pt x="3700526" y="8890"/>
                </a:lnTo>
                <a:lnTo>
                  <a:pt x="3527044" y="8890"/>
                </a:lnTo>
                <a:lnTo>
                  <a:pt x="3527044" y="7620"/>
                </a:lnTo>
                <a:lnTo>
                  <a:pt x="2486279" y="7620"/>
                </a:lnTo>
                <a:lnTo>
                  <a:pt x="2486279" y="6350"/>
                </a:lnTo>
                <a:lnTo>
                  <a:pt x="2370709" y="6350"/>
                </a:lnTo>
                <a:lnTo>
                  <a:pt x="2370709" y="5080"/>
                </a:lnTo>
                <a:lnTo>
                  <a:pt x="2081530" y="5080"/>
                </a:lnTo>
                <a:lnTo>
                  <a:pt x="2081530" y="3810"/>
                </a:lnTo>
                <a:lnTo>
                  <a:pt x="1965833" y="3810"/>
                </a:lnTo>
                <a:lnTo>
                  <a:pt x="1965833" y="2540"/>
                </a:lnTo>
                <a:lnTo>
                  <a:pt x="1445514" y="2540"/>
                </a:lnTo>
                <a:lnTo>
                  <a:pt x="1445514" y="1270"/>
                </a:lnTo>
                <a:lnTo>
                  <a:pt x="1387729" y="1270"/>
                </a:lnTo>
                <a:lnTo>
                  <a:pt x="1387729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0" y="3810"/>
                </a:lnTo>
                <a:lnTo>
                  <a:pt x="1098550" y="3810"/>
                </a:lnTo>
                <a:lnTo>
                  <a:pt x="1098550" y="5080"/>
                </a:lnTo>
                <a:lnTo>
                  <a:pt x="1098550" y="6350"/>
                </a:lnTo>
                <a:lnTo>
                  <a:pt x="1098550" y="7620"/>
                </a:lnTo>
                <a:lnTo>
                  <a:pt x="1156335" y="7620"/>
                </a:lnTo>
                <a:lnTo>
                  <a:pt x="1156335" y="8890"/>
                </a:lnTo>
                <a:lnTo>
                  <a:pt x="1156335" y="10160"/>
                </a:lnTo>
                <a:lnTo>
                  <a:pt x="1272032" y="10160"/>
                </a:lnTo>
                <a:lnTo>
                  <a:pt x="1272032" y="11430"/>
                </a:lnTo>
                <a:lnTo>
                  <a:pt x="1272032" y="12700"/>
                </a:lnTo>
                <a:lnTo>
                  <a:pt x="1387729" y="12700"/>
                </a:lnTo>
                <a:lnTo>
                  <a:pt x="1387729" y="13970"/>
                </a:lnTo>
                <a:lnTo>
                  <a:pt x="1387729" y="15240"/>
                </a:lnTo>
                <a:lnTo>
                  <a:pt x="1445514" y="15240"/>
                </a:lnTo>
                <a:lnTo>
                  <a:pt x="1445514" y="16510"/>
                </a:lnTo>
                <a:lnTo>
                  <a:pt x="1445514" y="17780"/>
                </a:lnTo>
                <a:lnTo>
                  <a:pt x="1908048" y="17780"/>
                </a:lnTo>
                <a:lnTo>
                  <a:pt x="1908048" y="20320"/>
                </a:lnTo>
                <a:lnTo>
                  <a:pt x="1965833" y="20320"/>
                </a:lnTo>
                <a:lnTo>
                  <a:pt x="1965833" y="22860"/>
                </a:lnTo>
                <a:lnTo>
                  <a:pt x="2081530" y="22860"/>
                </a:lnTo>
                <a:lnTo>
                  <a:pt x="2081530" y="25400"/>
                </a:lnTo>
                <a:lnTo>
                  <a:pt x="2370709" y="25400"/>
                </a:lnTo>
                <a:lnTo>
                  <a:pt x="2370709" y="26670"/>
                </a:lnTo>
                <a:lnTo>
                  <a:pt x="2370709" y="27940"/>
                </a:lnTo>
                <a:lnTo>
                  <a:pt x="2486279" y="27940"/>
                </a:lnTo>
                <a:lnTo>
                  <a:pt x="2486279" y="30480"/>
                </a:lnTo>
                <a:lnTo>
                  <a:pt x="3527044" y="30480"/>
                </a:lnTo>
                <a:lnTo>
                  <a:pt x="3527044" y="31750"/>
                </a:lnTo>
                <a:lnTo>
                  <a:pt x="3527044" y="33020"/>
                </a:lnTo>
                <a:lnTo>
                  <a:pt x="3700526" y="33020"/>
                </a:lnTo>
                <a:lnTo>
                  <a:pt x="3700526" y="35560"/>
                </a:lnTo>
                <a:lnTo>
                  <a:pt x="3700526" y="36830"/>
                </a:lnTo>
                <a:lnTo>
                  <a:pt x="3931793" y="36830"/>
                </a:lnTo>
                <a:lnTo>
                  <a:pt x="3931793" y="40640"/>
                </a:lnTo>
                <a:lnTo>
                  <a:pt x="5088255" y="40640"/>
                </a:lnTo>
                <a:lnTo>
                  <a:pt x="5088255" y="44450"/>
                </a:lnTo>
                <a:lnTo>
                  <a:pt x="5261724" y="44450"/>
                </a:lnTo>
                <a:lnTo>
                  <a:pt x="5261724" y="49530"/>
                </a:lnTo>
                <a:lnTo>
                  <a:pt x="5377307" y="49530"/>
                </a:lnTo>
                <a:lnTo>
                  <a:pt x="5377307" y="53340"/>
                </a:lnTo>
                <a:lnTo>
                  <a:pt x="5493004" y="53340"/>
                </a:lnTo>
                <a:lnTo>
                  <a:pt x="5493004" y="58420"/>
                </a:lnTo>
                <a:lnTo>
                  <a:pt x="5608701" y="58420"/>
                </a:lnTo>
                <a:lnTo>
                  <a:pt x="5608701" y="62230"/>
                </a:lnTo>
                <a:lnTo>
                  <a:pt x="8673211" y="62230"/>
                </a:lnTo>
                <a:lnTo>
                  <a:pt x="8673211" y="74930"/>
                </a:lnTo>
                <a:lnTo>
                  <a:pt x="10523474" y="74930"/>
                </a:lnTo>
                <a:lnTo>
                  <a:pt x="10523474" y="101600"/>
                </a:lnTo>
                <a:lnTo>
                  <a:pt x="10639171" y="101600"/>
                </a:lnTo>
                <a:lnTo>
                  <a:pt x="10639171" y="127000"/>
                </a:lnTo>
                <a:lnTo>
                  <a:pt x="11679936" y="127000"/>
                </a:lnTo>
                <a:lnTo>
                  <a:pt x="11679936" y="175260"/>
                </a:lnTo>
                <a:lnTo>
                  <a:pt x="14281912" y="175260"/>
                </a:lnTo>
                <a:lnTo>
                  <a:pt x="14281912" y="127000"/>
                </a:lnTo>
                <a:lnTo>
                  <a:pt x="14281912" y="101600"/>
                </a:lnTo>
                <a:lnTo>
                  <a:pt x="14281912" y="36830"/>
                </a:lnTo>
                <a:lnTo>
                  <a:pt x="14281912" y="3556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9" name="bg object 29"/>
          <p:cNvSpPr/>
          <p:nvPr/>
        </p:nvSpPr>
        <p:spPr>
          <a:xfrm>
            <a:off x="1731899" y="722629"/>
            <a:ext cx="13646150" cy="599440"/>
          </a:xfrm>
          <a:custGeom>
            <a:avLst/>
            <a:gdLst/>
            <a:ahLst/>
            <a:cxnLst/>
            <a:rect l="l" t="t" r="r" b="b"/>
            <a:pathLst>
              <a:path w="13646150" h="599440">
                <a:moveTo>
                  <a:pt x="13645896" y="127"/>
                </a:moveTo>
                <a:lnTo>
                  <a:pt x="12605004" y="127"/>
                </a:lnTo>
                <a:lnTo>
                  <a:pt x="12605004" y="49530"/>
                </a:lnTo>
                <a:lnTo>
                  <a:pt x="9713976" y="49530"/>
                </a:lnTo>
                <a:lnTo>
                  <a:pt x="9713976" y="41910"/>
                </a:lnTo>
                <a:lnTo>
                  <a:pt x="9309227" y="41910"/>
                </a:lnTo>
                <a:lnTo>
                  <a:pt x="9309227" y="40640"/>
                </a:lnTo>
                <a:lnTo>
                  <a:pt x="9309227" y="36830"/>
                </a:lnTo>
                <a:lnTo>
                  <a:pt x="6996303" y="36830"/>
                </a:lnTo>
                <a:lnTo>
                  <a:pt x="6996303" y="33020"/>
                </a:lnTo>
                <a:lnTo>
                  <a:pt x="6996303" y="30480"/>
                </a:lnTo>
                <a:lnTo>
                  <a:pt x="6533769" y="30480"/>
                </a:lnTo>
                <a:lnTo>
                  <a:pt x="6533769" y="27940"/>
                </a:lnTo>
                <a:lnTo>
                  <a:pt x="6533769" y="25400"/>
                </a:lnTo>
                <a:lnTo>
                  <a:pt x="5897753" y="25400"/>
                </a:lnTo>
                <a:lnTo>
                  <a:pt x="5897753" y="21590"/>
                </a:lnTo>
                <a:lnTo>
                  <a:pt x="4683506" y="21590"/>
                </a:lnTo>
                <a:lnTo>
                  <a:pt x="4683506" y="16510"/>
                </a:lnTo>
                <a:lnTo>
                  <a:pt x="4567809" y="16510"/>
                </a:lnTo>
                <a:lnTo>
                  <a:pt x="4567809" y="15240"/>
                </a:lnTo>
                <a:lnTo>
                  <a:pt x="4567809" y="10160"/>
                </a:lnTo>
                <a:lnTo>
                  <a:pt x="3237992" y="10160"/>
                </a:lnTo>
                <a:lnTo>
                  <a:pt x="3237992" y="8890"/>
                </a:lnTo>
                <a:lnTo>
                  <a:pt x="3237992" y="3810"/>
                </a:lnTo>
                <a:lnTo>
                  <a:pt x="3006725" y="3810"/>
                </a:lnTo>
                <a:lnTo>
                  <a:pt x="3006725" y="2540"/>
                </a:lnTo>
                <a:lnTo>
                  <a:pt x="1561084" y="2540"/>
                </a:lnTo>
                <a:lnTo>
                  <a:pt x="1561084" y="0"/>
                </a:lnTo>
                <a:lnTo>
                  <a:pt x="0" y="0"/>
                </a:lnTo>
                <a:lnTo>
                  <a:pt x="0" y="2540"/>
                </a:lnTo>
                <a:lnTo>
                  <a:pt x="0" y="3810"/>
                </a:lnTo>
                <a:lnTo>
                  <a:pt x="0" y="8890"/>
                </a:lnTo>
                <a:lnTo>
                  <a:pt x="636016" y="8890"/>
                </a:lnTo>
                <a:lnTo>
                  <a:pt x="636016" y="10160"/>
                </a:lnTo>
                <a:lnTo>
                  <a:pt x="636016" y="15240"/>
                </a:lnTo>
                <a:lnTo>
                  <a:pt x="809498" y="15240"/>
                </a:lnTo>
                <a:lnTo>
                  <a:pt x="809498" y="16510"/>
                </a:lnTo>
                <a:lnTo>
                  <a:pt x="809498" y="21590"/>
                </a:lnTo>
                <a:lnTo>
                  <a:pt x="1503299" y="21590"/>
                </a:lnTo>
                <a:lnTo>
                  <a:pt x="1503299" y="25400"/>
                </a:lnTo>
                <a:lnTo>
                  <a:pt x="1503299" y="27940"/>
                </a:lnTo>
                <a:lnTo>
                  <a:pt x="1561084" y="27940"/>
                </a:lnTo>
                <a:lnTo>
                  <a:pt x="1561084" y="30480"/>
                </a:lnTo>
                <a:lnTo>
                  <a:pt x="1561084" y="33020"/>
                </a:lnTo>
                <a:lnTo>
                  <a:pt x="3006725" y="33020"/>
                </a:lnTo>
                <a:lnTo>
                  <a:pt x="3006725" y="36830"/>
                </a:lnTo>
                <a:lnTo>
                  <a:pt x="3006725" y="40640"/>
                </a:lnTo>
                <a:lnTo>
                  <a:pt x="3237992" y="40640"/>
                </a:lnTo>
                <a:lnTo>
                  <a:pt x="3237992" y="41910"/>
                </a:lnTo>
                <a:lnTo>
                  <a:pt x="3237992" y="49530"/>
                </a:lnTo>
                <a:lnTo>
                  <a:pt x="3237992" y="57150"/>
                </a:lnTo>
                <a:lnTo>
                  <a:pt x="4567809" y="57150"/>
                </a:lnTo>
                <a:lnTo>
                  <a:pt x="4567809" y="77470"/>
                </a:lnTo>
                <a:lnTo>
                  <a:pt x="4683506" y="77470"/>
                </a:lnTo>
                <a:lnTo>
                  <a:pt x="4683506" y="86360"/>
                </a:lnTo>
                <a:lnTo>
                  <a:pt x="5897753" y="86360"/>
                </a:lnTo>
                <a:lnTo>
                  <a:pt x="5897753" y="101600"/>
                </a:lnTo>
                <a:lnTo>
                  <a:pt x="6533769" y="101600"/>
                </a:lnTo>
                <a:lnTo>
                  <a:pt x="6533769" y="118110"/>
                </a:lnTo>
                <a:lnTo>
                  <a:pt x="6996303" y="118110"/>
                </a:lnTo>
                <a:lnTo>
                  <a:pt x="6996303" y="137160"/>
                </a:lnTo>
                <a:lnTo>
                  <a:pt x="9309227" y="137160"/>
                </a:lnTo>
                <a:lnTo>
                  <a:pt x="9309227" y="184150"/>
                </a:lnTo>
                <a:lnTo>
                  <a:pt x="9713976" y="184150"/>
                </a:lnTo>
                <a:lnTo>
                  <a:pt x="9713976" y="241300"/>
                </a:lnTo>
                <a:lnTo>
                  <a:pt x="12605004" y="241300"/>
                </a:lnTo>
                <a:lnTo>
                  <a:pt x="12605004" y="599440"/>
                </a:lnTo>
                <a:lnTo>
                  <a:pt x="13645896" y="599440"/>
                </a:lnTo>
                <a:lnTo>
                  <a:pt x="13645896" y="241300"/>
                </a:lnTo>
                <a:lnTo>
                  <a:pt x="13645896" y="184150"/>
                </a:lnTo>
                <a:lnTo>
                  <a:pt x="13645896" y="49530"/>
                </a:lnTo>
                <a:lnTo>
                  <a:pt x="13645896" y="127"/>
                </a:lnTo>
                <a:close/>
              </a:path>
            </a:pathLst>
          </a:custGeom>
          <a:solidFill>
            <a:srgbClr val="4DCE6B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bg object 30"/>
          <p:cNvSpPr/>
          <p:nvPr/>
        </p:nvSpPr>
        <p:spPr>
          <a:xfrm>
            <a:off x="1847469" y="722629"/>
            <a:ext cx="13703935" cy="189230"/>
          </a:xfrm>
          <a:custGeom>
            <a:avLst/>
            <a:gdLst/>
            <a:ahLst/>
            <a:cxnLst/>
            <a:rect l="l" t="t" r="r" b="b"/>
            <a:pathLst>
              <a:path w="13703935" h="189230">
                <a:moveTo>
                  <a:pt x="13703681" y="73660"/>
                </a:moveTo>
                <a:lnTo>
                  <a:pt x="8788908" y="73660"/>
                </a:lnTo>
                <a:lnTo>
                  <a:pt x="8788908" y="71120"/>
                </a:lnTo>
                <a:lnTo>
                  <a:pt x="8788908" y="67310"/>
                </a:lnTo>
                <a:lnTo>
                  <a:pt x="8152892" y="67310"/>
                </a:lnTo>
                <a:lnTo>
                  <a:pt x="8152892" y="60960"/>
                </a:lnTo>
                <a:lnTo>
                  <a:pt x="7690358" y="60960"/>
                </a:lnTo>
                <a:lnTo>
                  <a:pt x="7690358" y="55880"/>
                </a:lnTo>
                <a:lnTo>
                  <a:pt x="7690358" y="54610"/>
                </a:lnTo>
                <a:lnTo>
                  <a:pt x="7227697" y="54610"/>
                </a:lnTo>
                <a:lnTo>
                  <a:pt x="7227697" y="50800"/>
                </a:lnTo>
                <a:lnTo>
                  <a:pt x="7054215" y="50800"/>
                </a:lnTo>
                <a:lnTo>
                  <a:pt x="7054215" y="46990"/>
                </a:lnTo>
                <a:lnTo>
                  <a:pt x="7054215" y="45720"/>
                </a:lnTo>
                <a:lnTo>
                  <a:pt x="6996430" y="45720"/>
                </a:lnTo>
                <a:lnTo>
                  <a:pt x="6996430" y="43180"/>
                </a:lnTo>
                <a:lnTo>
                  <a:pt x="6996430" y="41910"/>
                </a:lnTo>
                <a:lnTo>
                  <a:pt x="6071235" y="41910"/>
                </a:lnTo>
                <a:lnTo>
                  <a:pt x="6071235" y="39370"/>
                </a:lnTo>
                <a:lnTo>
                  <a:pt x="6071235" y="38100"/>
                </a:lnTo>
                <a:lnTo>
                  <a:pt x="5550916" y="38100"/>
                </a:lnTo>
                <a:lnTo>
                  <a:pt x="5550916" y="35560"/>
                </a:lnTo>
                <a:lnTo>
                  <a:pt x="5550916" y="34290"/>
                </a:lnTo>
                <a:lnTo>
                  <a:pt x="5493131" y="34290"/>
                </a:lnTo>
                <a:lnTo>
                  <a:pt x="5493131" y="31750"/>
                </a:lnTo>
                <a:lnTo>
                  <a:pt x="4567936" y="31750"/>
                </a:lnTo>
                <a:lnTo>
                  <a:pt x="4567936" y="29210"/>
                </a:lnTo>
                <a:lnTo>
                  <a:pt x="4567936" y="27940"/>
                </a:lnTo>
                <a:lnTo>
                  <a:pt x="4510151" y="27940"/>
                </a:lnTo>
                <a:lnTo>
                  <a:pt x="4510151" y="25400"/>
                </a:lnTo>
                <a:lnTo>
                  <a:pt x="4336669" y="25400"/>
                </a:lnTo>
                <a:lnTo>
                  <a:pt x="4336669" y="20320"/>
                </a:lnTo>
                <a:lnTo>
                  <a:pt x="3989705" y="20320"/>
                </a:lnTo>
                <a:lnTo>
                  <a:pt x="3989705" y="19050"/>
                </a:lnTo>
                <a:lnTo>
                  <a:pt x="3816223" y="19050"/>
                </a:lnTo>
                <a:lnTo>
                  <a:pt x="3816223" y="16510"/>
                </a:lnTo>
                <a:lnTo>
                  <a:pt x="3527171" y="16510"/>
                </a:lnTo>
                <a:lnTo>
                  <a:pt x="3527171" y="13970"/>
                </a:lnTo>
                <a:lnTo>
                  <a:pt x="3469386" y="13970"/>
                </a:lnTo>
                <a:lnTo>
                  <a:pt x="3469386" y="12700"/>
                </a:lnTo>
                <a:lnTo>
                  <a:pt x="3180207" y="12700"/>
                </a:lnTo>
                <a:lnTo>
                  <a:pt x="3180207" y="11430"/>
                </a:lnTo>
                <a:lnTo>
                  <a:pt x="3180207" y="10160"/>
                </a:lnTo>
                <a:lnTo>
                  <a:pt x="3006725" y="10160"/>
                </a:lnTo>
                <a:lnTo>
                  <a:pt x="3006725" y="8890"/>
                </a:lnTo>
                <a:lnTo>
                  <a:pt x="2139442" y="8890"/>
                </a:lnTo>
                <a:lnTo>
                  <a:pt x="2139442" y="7620"/>
                </a:lnTo>
                <a:lnTo>
                  <a:pt x="2139442" y="6350"/>
                </a:lnTo>
                <a:lnTo>
                  <a:pt x="1503426" y="6350"/>
                </a:lnTo>
                <a:lnTo>
                  <a:pt x="1503426" y="5080"/>
                </a:lnTo>
                <a:lnTo>
                  <a:pt x="1445514" y="5080"/>
                </a:lnTo>
                <a:lnTo>
                  <a:pt x="1445514" y="2540"/>
                </a:lnTo>
                <a:lnTo>
                  <a:pt x="1272159" y="2540"/>
                </a:lnTo>
                <a:lnTo>
                  <a:pt x="1272159" y="1270"/>
                </a:lnTo>
                <a:lnTo>
                  <a:pt x="925195" y="1270"/>
                </a:lnTo>
                <a:lnTo>
                  <a:pt x="925195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0" y="5080"/>
                </a:lnTo>
                <a:lnTo>
                  <a:pt x="57912" y="5080"/>
                </a:lnTo>
                <a:lnTo>
                  <a:pt x="57912" y="6350"/>
                </a:lnTo>
                <a:lnTo>
                  <a:pt x="57912" y="7620"/>
                </a:lnTo>
                <a:lnTo>
                  <a:pt x="578231" y="7620"/>
                </a:lnTo>
                <a:lnTo>
                  <a:pt x="578231" y="8890"/>
                </a:lnTo>
                <a:lnTo>
                  <a:pt x="578231" y="10160"/>
                </a:lnTo>
                <a:lnTo>
                  <a:pt x="578231" y="11430"/>
                </a:lnTo>
                <a:lnTo>
                  <a:pt x="636016" y="11430"/>
                </a:lnTo>
                <a:lnTo>
                  <a:pt x="636016" y="12700"/>
                </a:lnTo>
                <a:lnTo>
                  <a:pt x="636016" y="13970"/>
                </a:lnTo>
                <a:lnTo>
                  <a:pt x="925195" y="13970"/>
                </a:lnTo>
                <a:lnTo>
                  <a:pt x="925195" y="16510"/>
                </a:lnTo>
                <a:lnTo>
                  <a:pt x="1272159" y="16510"/>
                </a:lnTo>
                <a:lnTo>
                  <a:pt x="1272159" y="19050"/>
                </a:lnTo>
                <a:lnTo>
                  <a:pt x="1272159" y="20320"/>
                </a:lnTo>
                <a:lnTo>
                  <a:pt x="1445514" y="20320"/>
                </a:lnTo>
                <a:lnTo>
                  <a:pt x="1445514" y="25400"/>
                </a:lnTo>
                <a:lnTo>
                  <a:pt x="1503426" y="25400"/>
                </a:lnTo>
                <a:lnTo>
                  <a:pt x="1503426" y="27940"/>
                </a:lnTo>
                <a:lnTo>
                  <a:pt x="1503426" y="29210"/>
                </a:lnTo>
                <a:lnTo>
                  <a:pt x="2139442" y="29210"/>
                </a:lnTo>
                <a:lnTo>
                  <a:pt x="2139442" y="31750"/>
                </a:lnTo>
                <a:lnTo>
                  <a:pt x="2139442" y="34290"/>
                </a:lnTo>
                <a:lnTo>
                  <a:pt x="2139442" y="35560"/>
                </a:lnTo>
                <a:lnTo>
                  <a:pt x="3006725" y="35560"/>
                </a:lnTo>
                <a:lnTo>
                  <a:pt x="3006725" y="38100"/>
                </a:lnTo>
                <a:lnTo>
                  <a:pt x="3006725" y="39370"/>
                </a:lnTo>
                <a:lnTo>
                  <a:pt x="3180207" y="39370"/>
                </a:lnTo>
                <a:lnTo>
                  <a:pt x="3180207" y="41910"/>
                </a:lnTo>
                <a:lnTo>
                  <a:pt x="3180207" y="43180"/>
                </a:lnTo>
                <a:lnTo>
                  <a:pt x="3469386" y="43180"/>
                </a:lnTo>
                <a:lnTo>
                  <a:pt x="3469386" y="45720"/>
                </a:lnTo>
                <a:lnTo>
                  <a:pt x="3469386" y="46990"/>
                </a:lnTo>
                <a:lnTo>
                  <a:pt x="3527171" y="46990"/>
                </a:lnTo>
                <a:lnTo>
                  <a:pt x="3527171" y="50800"/>
                </a:lnTo>
                <a:lnTo>
                  <a:pt x="3816223" y="50800"/>
                </a:lnTo>
                <a:lnTo>
                  <a:pt x="3816223" y="54610"/>
                </a:lnTo>
                <a:lnTo>
                  <a:pt x="3816223" y="55880"/>
                </a:lnTo>
                <a:lnTo>
                  <a:pt x="3989705" y="55880"/>
                </a:lnTo>
                <a:lnTo>
                  <a:pt x="3989705" y="60960"/>
                </a:lnTo>
                <a:lnTo>
                  <a:pt x="4336669" y="60960"/>
                </a:lnTo>
                <a:lnTo>
                  <a:pt x="4336669" y="67310"/>
                </a:lnTo>
                <a:lnTo>
                  <a:pt x="4336669" y="71120"/>
                </a:lnTo>
                <a:lnTo>
                  <a:pt x="4510151" y="71120"/>
                </a:lnTo>
                <a:lnTo>
                  <a:pt x="4510151" y="73660"/>
                </a:lnTo>
                <a:lnTo>
                  <a:pt x="4510151" y="76200"/>
                </a:lnTo>
                <a:lnTo>
                  <a:pt x="4567936" y="76200"/>
                </a:lnTo>
                <a:lnTo>
                  <a:pt x="4567936" y="81280"/>
                </a:lnTo>
                <a:lnTo>
                  <a:pt x="5493131" y="81280"/>
                </a:lnTo>
                <a:lnTo>
                  <a:pt x="5493131" y="87630"/>
                </a:lnTo>
                <a:lnTo>
                  <a:pt x="5550916" y="87630"/>
                </a:lnTo>
                <a:lnTo>
                  <a:pt x="5550916" y="95250"/>
                </a:lnTo>
                <a:lnTo>
                  <a:pt x="6071235" y="95250"/>
                </a:lnTo>
                <a:lnTo>
                  <a:pt x="6071235" y="102870"/>
                </a:lnTo>
                <a:lnTo>
                  <a:pt x="6996430" y="102870"/>
                </a:lnTo>
                <a:lnTo>
                  <a:pt x="6996430" y="114300"/>
                </a:lnTo>
                <a:lnTo>
                  <a:pt x="7054215" y="114300"/>
                </a:lnTo>
                <a:lnTo>
                  <a:pt x="7054215" y="124460"/>
                </a:lnTo>
                <a:lnTo>
                  <a:pt x="7227697" y="124460"/>
                </a:lnTo>
                <a:lnTo>
                  <a:pt x="7227697" y="135890"/>
                </a:lnTo>
                <a:lnTo>
                  <a:pt x="7690358" y="135890"/>
                </a:lnTo>
                <a:lnTo>
                  <a:pt x="7690358" y="149860"/>
                </a:lnTo>
                <a:lnTo>
                  <a:pt x="8152892" y="149860"/>
                </a:lnTo>
                <a:lnTo>
                  <a:pt x="8152892" y="166370"/>
                </a:lnTo>
                <a:lnTo>
                  <a:pt x="8788908" y="166370"/>
                </a:lnTo>
                <a:lnTo>
                  <a:pt x="8788908" y="189230"/>
                </a:lnTo>
                <a:lnTo>
                  <a:pt x="13703681" y="189230"/>
                </a:lnTo>
                <a:lnTo>
                  <a:pt x="13703681" y="166370"/>
                </a:lnTo>
                <a:lnTo>
                  <a:pt x="13703681" y="149860"/>
                </a:lnTo>
                <a:lnTo>
                  <a:pt x="13703681" y="76200"/>
                </a:lnTo>
                <a:lnTo>
                  <a:pt x="13703681" y="7366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822960" y="365760"/>
            <a:ext cx="1481328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822960" y="2103120"/>
            <a:ext cx="1481328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5596128" y="8503920"/>
            <a:ext cx="5266944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822960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11850624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 descr=""/>
          <p:cNvSpPr txBox="1"/>
          <p:nvPr/>
        </p:nvSpPr>
        <p:spPr>
          <a:xfrm>
            <a:off x="13231494" y="723772"/>
            <a:ext cx="1168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365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 descr=""/>
          <p:cNvSpPr txBox="1"/>
          <p:nvPr/>
        </p:nvSpPr>
        <p:spPr>
          <a:xfrm>
            <a:off x="14387957" y="879856"/>
            <a:ext cx="105473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240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sz="1400" spc="14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1400" spc="-235">
                <a:solidFill>
                  <a:srgbClr val="4DCE6B"/>
                </a:solidFill>
                <a:latin typeface="Arial"/>
                <a:cs typeface="Arial"/>
              </a:rPr>
              <a:t>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4" name="object 4" descr=""/>
          <p:cNvSpPr txBox="1"/>
          <p:nvPr/>
        </p:nvSpPr>
        <p:spPr>
          <a:xfrm>
            <a:off x="1121410" y="708914"/>
            <a:ext cx="14577694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41666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41666" sz="2100" spc="-562">
                <a:solidFill>
                  <a:srgbClr val="BCA7E8"/>
                </a:solidFill>
                <a:latin typeface="Arial"/>
                <a:cs typeface="Arial"/>
              </a:rPr>
              <a:t>+++++++++</a:t>
            </a:r>
            <a:r>
              <a:rPr dirty="0" baseline="39682" sz="2100" spc="-562">
                <a:solidFill>
                  <a:srgbClr val="BCA7E8"/>
                </a:solidFill>
                <a:latin typeface="Arial"/>
                <a:cs typeface="Arial"/>
              </a:rPr>
              <a:t>++++++++++++++++</a:t>
            </a:r>
            <a:r>
              <a:rPr dirty="0" baseline="37698" sz="2100" spc="-562">
                <a:solidFill>
                  <a:srgbClr val="BCA7E8"/>
                </a:solidFill>
                <a:latin typeface="Arial"/>
                <a:cs typeface="Arial"/>
              </a:rPr>
              <a:t>+++++++++</a:t>
            </a:r>
            <a:r>
              <a:rPr dirty="0" baseline="35714" sz="2100" spc="-562">
                <a:solidFill>
                  <a:srgbClr val="BCA7E8"/>
                </a:solidFill>
                <a:latin typeface="Arial"/>
                <a:cs typeface="Arial"/>
              </a:rPr>
              <a:t>++++++++++++</a:t>
            </a:r>
            <a:r>
              <a:rPr dirty="0" baseline="33730" sz="2100" spc="-562">
                <a:solidFill>
                  <a:srgbClr val="BCA7E8"/>
                </a:solidFill>
                <a:latin typeface="Arial"/>
                <a:cs typeface="Arial"/>
              </a:rPr>
              <a:t>++++++++++++++++++</a:t>
            </a:r>
            <a:r>
              <a:rPr dirty="0" baseline="31746" sz="2100" spc="-562">
                <a:solidFill>
                  <a:srgbClr val="BCA7E8"/>
                </a:solidFill>
                <a:latin typeface="Arial"/>
                <a:cs typeface="Arial"/>
              </a:rPr>
              <a:t>++++++</a:t>
            </a:r>
            <a:r>
              <a:rPr dirty="0" baseline="29761" sz="2100" spc="-562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baseline="27777" sz="2100" spc="-562">
                <a:solidFill>
                  <a:srgbClr val="BCA7E8"/>
                </a:solidFill>
                <a:latin typeface="Arial"/>
                <a:cs typeface="Arial"/>
              </a:rPr>
              <a:t>++++++</a:t>
            </a:r>
            <a:r>
              <a:rPr dirty="0" baseline="25793" sz="2100" spc="-56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23809" sz="2100" spc="-562">
                <a:solidFill>
                  <a:srgbClr val="BCA7E8"/>
                </a:solidFill>
                <a:latin typeface="Arial"/>
                <a:cs typeface="Arial"/>
              </a:rPr>
              <a:t>++++++++++++++++</a:t>
            </a:r>
            <a:r>
              <a:rPr dirty="0" baseline="21825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1" sz="2100" spc="-562">
                <a:solidFill>
                  <a:srgbClr val="BCA7E8"/>
                </a:solidFill>
                <a:latin typeface="Arial"/>
                <a:cs typeface="Arial"/>
              </a:rPr>
              <a:t>+++++++++</a:t>
            </a:r>
            <a:r>
              <a:rPr dirty="0" baseline="17857" sz="2100" spc="-562">
                <a:solidFill>
                  <a:srgbClr val="BCA7E8"/>
                </a:solidFill>
                <a:latin typeface="Arial"/>
                <a:cs typeface="Arial"/>
              </a:rPr>
              <a:t>++++++++++++++++</a:t>
            </a:r>
            <a:r>
              <a:rPr dirty="0" baseline="15873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1904" sz="2100" spc="-562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baseline="7936" sz="2100" spc="-562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baseline="3968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388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3968" sz="2100" spc="-562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+++++++++++++++++++++++++++++++++++++++++++</a:t>
            </a:r>
            <a:r>
              <a:rPr dirty="0" baseline="-396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25793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3968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396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21825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21825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baseline="7936" sz="2100">
              <a:latin typeface="Arial"/>
              <a:cs typeface="Arial"/>
            </a:endParaRPr>
          </a:p>
        </p:txBody>
      </p:sp>
      <p:sp>
        <p:nvSpPr>
          <p:cNvPr id="5" name="object 5" descr=""/>
          <p:cNvSpPr txBox="1"/>
          <p:nvPr/>
        </p:nvSpPr>
        <p:spPr>
          <a:xfrm>
            <a:off x="1776983" y="3374897"/>
            <a:ext cx="87121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latin typeface="Arial"/>
                <a:cs typeface="Arial"/>
              </a:rPr>
              <a:t>p &lt; </a:t>
            </a:r>
            <a:r>
              <a:rPr dirty="0" sz="1400" spc="-10">
                <a:latin typeface="Arial"/>
                <a:cs typeface="Arial"/>
              </a:rPr>
              <a:t>0.0001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 descr=""/>
          <p:cNvSpPr txBox="1"/>
          <p:nvPr/>
        </p:nvSpPr>
        <p:spPr>
          <a:xfrm>
            <a:off x="1776983" y="3048000"/>
            <a:ext cx="7702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">
                <a:latin typeface="Arial"/>
                <a:cs typeface="Arial"/>
              </a:rPr>
              <a:t>Log−rank</a:t>
            </a:r>
            <a:endParaRPr sz="1400">
              <a:latin typeface="Arial"/>
              <a:cs typeface="Arial"/>
            </a:endParaRPr>
          </a:p>
        </p:txBody>
      </p:sp>
      <p:sp>
        <p:nvSpPr>
          <p:cNvPr id="7" name="object 7" descr=""/>
          <p:cNvSpPr txBox="1"/>
          <p:nvPr/>
        </p:nvSpPr>
        <p:spPr>
          <a:xfrm>
            <a:off x="286258" y="3088766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</a:t>
            </a:r>
            <a:endParaRPr sz="900">
              <a:latin typeface="Arial"/>
              <a:cs typeface="Arial"/>
            </a:endParaRPr>
          </a:p>
        </p:txBody>
      </p:sp>
      <p:sp>
        <p:nvSpPr>
          <p:cNvPr id="8" name="object 8" descr=""/>
          <p:cNvSpPr txBox="1"/>
          <p:nvPr/>
        </p:nvSpPr>
        <p:spPr>
          <a:xfrm>
            <a:off x="286258" y="2271394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" name="object 9" descr=""/>
          <p:cNvSpPr txBox="1"/>
          <p:nvPr/>
        </p:nvSpPr>
        <p:spPr>
          <a:xfrm>
            <a:off x="286258" y="1454022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75</a:t>
            </a:r>
            <a:endParaRPr sz="900">
              <a:latin typeface="Arial"/>
              <a:cs typeface="Arial"/>
            </a:endParaRPr>
          </a:p>
        </p:txBody>
      </p:sp>
      <p:sp>
        <p:nvSpPr>
          <p:cNvPr id="10" name="object 10" descr=""/>
          <p:cNvSpPr txBox="1"/>
          <p:nvPr/>
        </p:nvSpPr>
        <p:spPr>
          <a:xfrm>
            <a:off x="222758" y="636778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1" name="object 11" descr=""/>
          <p:cNvSpPr/>
          <p:nvPr/>
        </p:nvSpPr>
        <p:spPr>
          <a:xfrm>
            <a:off x="453898" y="722756"/>
            <a:ext cx="15213330" cy="3296285"/>
          </a:xfrm>
          <a:custGeom>
            <a:avLst/>
            <a:gdLst/>
            <a:ahLst/>
            <a:cxnLst/>
            <a:rect l="l" t="t" r="r" b="b"/>
            <a:pathLst>
              <a:path w="15213330" h="3296285">
                <a:moveTo>
                  <a:pt x="0" y="2451989"/>
                </a:moveTo>
                <a:lnTo>
                  <a:pt x="34797" y="2451989"/>
                </a:lnTo>
              </a:path>
              <a:path w="15213330" h="3296285">
                <a:moveTo>
                  <a:pt x="0" y="1634617"/>
                </a:moveTo>
                <a:lnTo>
                  <a:pt x="34797" y="1634617"/>
                </a:lnTo>
              </a:path>
              <a:path w="15213330" h="3296285">
                <a:moveTo>
                  <a:pt x="0" y="817245"/>
                </a:moveTo>
                <a:lnTo>
                  <a:pt x="34797" y="817245"/>
                </a:lnTo>
              </a:path>
              <a:path w="15213330" h="3296285">
                <a:moveTo>
                  <a:pt x="0" y="0"/>
                </a:moveTo>
                <a:lnTo>
                  <a:pt x="34797" y="0"/>
                </a:lnTo>
              </a:path>
              <a:path w="15213330" h="3296285">
                <a:moveTo>
                  <a:pt x="757555" y="3295904"/>
                </a:moveTo>
                <a:lnTo>
                  <a:pt x="757555" y="3261106"/>
                </a:lnTo>
              </a:path>
              <a:path w="15213330" h="3296285">
                <a:moveTo>
                  <a:pt x="3648710" y="3295904"/>
                </a:moveTo>
                <a:lnTo>
                  <a:pt x="3648710" y="3261106"/>
                </a:lnTo>
              </a:path>
              <a:path w="15213330" h="3296285">
                <a:moveTo>
                  <a:pt x="6539737" y="3295904"/>
                </a:moveTo>
                <a:lnTo>
                  <a:pt x="6539737" y="3261106"/>
                </a:lnTo>
              </a:path>
              <a:path w="15213330" h="3296285">
                <a:moveTo>
                  <a:pt x="9430766" y="3295904"/>
                </a:moveTo>
                <a:lnTo>
                  <a:pt x="9430766" y="3261106"/>
                </a:lnTo>
              </a:path>
              <a:path w="15213330" h="3296285">
                <a:moveTo>
                  <a:pt x="12321921" y="3295904"/>
                </a:moveTo>
                <a:lnTo>
                  <a:pt x="12321921" y="3261106"/>
                </a:lnTo>
              </a:path>
              <a:path w="15213330" h="3296285">
                <a:moveTo>
                  <a:pt x="15212948" y="3295904"/>
                </a:moveTo>
                <a:lnTo>
                  <a:pt x="15212948" y="3261106"/>
                </a:lnTo>
              </a:path>
            </a:pathLst>
          </a:custGeom>
          <a:ln w="13589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" name="object 12" descr=""/>
          <p:cNvSpPr txBox="1"/>
          <p:nvPr/>
        </p:nvSpPr>
        <p:spPr>
          <a:xfrm>
            <a:off x="1167002" y="400151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" name="object 13" descr=""/>
          <p:cNvSpPr txBox="1"/>
          <p:nvPr/>
        </p:nvSpPr>
        <p:spPr>
          <a:xfrm>
            <a:off x="4026280" y="400151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" name="object 14" descr=""/>
          <p:cNvSpPr txBox="1"/>
          <p:nvPr/>
        </p:nvSpPr>
        <p:spPr>
          <a:xfrm>
            <a:off x="6885558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5" name="object 15" descr=""/>
          <p:cNvSpPr txBox="1"/>
          <p:nvPr/>
        </p:nvSpPr>
        <p:spPr>
          <a:xfrm>
            <a:off x="9776714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6" name="object 16" descr=""/>
          <p:cNvSpPr txBox="1"/>
          <p:nvPr/>
        </p:nvSpPr>
        <p:spPr>
          <a:xfrm>
            <a:off x="12667742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7" name="object 17" descr=""/>
          <p:cNvSpPr txBox="1"/>
          <p:nvPr/>
        </p:nvSpPr>
        <p:spPr>
          <a:xfrm>
            <a:off x="15558769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8" name="object 18" descr=""/>
          <p:cNvSpPr txBox="1"/>
          <p:nvPr/>
        </p:nvSpPr>
        <p:spPr>
          <a:xfrm>
            <a:off x="8271256" y="413639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9" name="object 19" descr=""/>
          <p:cNvSpPr txBox="1"/>
          <p:nvPr/>
        </p:nvSpPr>
        <p:spPr>
          <a:xfrm>
            <a:off x="30759" y="1548175"/>
            <a:ext cx="181610" cy="145478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>
                <a:latin typeface="Arial"/>
                <a:cs typeface="Arial"/>
              </a:rPr>
              <a:t>Survival probability </a:t>
            </a:r>
            <a:r>
              <a:rPr dirty="0" sz="1100" spc="-25">
                <a:latin typeface="Arial"/>
                <a:cs typeface="Arial"/>
              </a:rPr>
              <a:t>(%)</a:t>
            </a:r>
            <a:endParaRPr sz="1100">
              <a:latin typeface="Arial"/>
              <a:cs typeface="Arial"/>
            </a:endParaRPr>
          </a:p>
        </p:txBody>
      </p:sp>
      <p:sp>
        <p:nvSpPr>
          <p:cNvPr id="20" name="object 20" descr=""/>
          <p:cNvSpPr/>
          <p:nvPr/>
        </p:nvSpPr>
        <p:spPr>
          <a:xfrm>
            <a:off x="6085459" y="148209"/>
            <a:ext cx="201930" cy="201930"/>
          </a:xfrm>
          <a:custGeom>
            <a:avLst/>
            <a:gdLst/>
            <a:ahLst/>
            <a:cxnLst/>
            <a:rect l="l" t="t" r="r" b="b"/>
            <a:pathLst>
              <a:path w="201929" h="201929">
                <a:moveTo>
                  <a:pt x="201422" y="0"/>
                </a:moveTo>
                <a:lnTo>
                  <a:pt x="0" y="0"/>
                </a:lnTo>
                <a:lnTo>
                  <a:pt x="0" y="201422"/>
                </a:lnTo>
                <a:lnTo>
                  <a:pt x="201422" y="201422"/>
                </a:lnTo>
                <a:lnTo>
                  <a:pt x="201422" y="0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1" name="object 21" descr=""/>
          <p:cNvSpPr txBox="1"/>
          <p:nvPr/>
        </p:nvSpPr>
        <p:spPr>
          <a:xfrm>
            <a:off x="5242178" y="108584"/>
            <a:ext cx="10090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eeth </a:t>
            </a:r>
            <a:r>
              <a:rPr dirty="0" sz="1100">
                <a:latin typeface="Arial"/>
                <a:cs typeface="Arial"/>
              </a:rPr>
              <a:t>status</a:t>
            </a:r>
            <a:r>
              <a:rPr dirty="0" sz="1100" spc="395">
                <a:latin typeface="Arial"/>
                <a:cs typeface="Arial"/>
              </a:rPr>
              <a:t> </a:t>
            </a:r>
            <a:r>
              <a:rPr dirty="0" baseline="1984" sz="2100" spc="-165" strike="sngStrike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baseline="1984" sz="2100" spc="-75" strike="sngStrike">
                <a:solidFill>
                  <a:srgbClr val="E95359"/>
                </a:solidFill>
                <a:latin typeface="Arial"/>
                <a:cs typeface="Arial"/>
              </a:rPr>
              <a:t>+</a:t>
            </a:r>
            <a:endParaRPr baseline="1984" sz="2100">
              <a:latin typeface="Arial"/>
              <a:cs typeface="Arial"/>
            </a:endParaRPr>
          </a:p>
        </p:txBody>
      </p:sp>
      <p:grpSp>
        <p:nvGrpSpPr>
          <p:cNvPr id="22" name="object 22" descr=""/>
          <p:cNvGrpSpPr/>
          <p:nvPr/>
        </p:nvGrpSpPr>
        <p:grpSpPr>
          <a:xfrm>
            <a:off x="7396988" y="148209"/>
            <a:ext cx="201930" cy="201930"/>
            <a:chOff x="7396988" y="148209"/>
            <a:chExt cx="201930" cy="201930"/>
          </a:xfrm>
        </p:grpSpPr>
        <p:sp>
          <p:nvSpPr>
            <p:cNvPr id="23" name="object 23" descr=""/>
            <p:cNvSpPr/>
            <p:nvPr/>
          </p:nvSpPr>
          <p:spPr>
            <a:xfrm>
              <a:off x="740994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41A3FF"/>
              </a:solidFill>
              <a:prstDash val="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" name="object 24" descr=""/>
            <p:cNvSpPr/>
            <p:nvPr/>
          </p:nvSpPr>
          <p:spPr>
            <a:xfrm>
              <a:off x="739698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1A3FF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5" name="object 25" descr=""/>
          <p:cNvSpPr txBox="1"/>
          <p:nvPr/>
        </p:nvSpPr>
        <p:spPr>
          <a:xfrm>
            <a:off x="7433056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41A3FF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26" name="object 26" descr=""/>
          <p:cNvGrpSpPr/>
          <p:nvPr/>
        </p:nvGrpSpPr>
        <p:grpSpPr>
          <a:xfrm>
            <a:off x="8269223" y="148209"/>
            <a:ext cx="201930" cy="201930"/>
            <a:chOff x="8269223" y="148209"/>
            <a:chExt cx="201930" cy="201930"/>
          </a:xfrm>
        </p:grpSpPr>
        <p:sp>
          <p:nvSpPr>
            <p:cNvPr id="27" name="object 27" descr=""/>
            <p:cNvSpPr/>
            <p:nvPr/>
          </p:nvSpPr>
          <p:spPr>
            <a:xfrm>
              <a:off x="828217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DFD625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" name="object 28" descr=""/>
            <p:cNvSpPr/>
            <p:nvPr/>
          </p:nvSpPr>
          <p:spPr>
            <a:xfrm>
              <a:off x="826922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DFD625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9" name="object 29" descr=""/>
          <p:cNvSpPr txBox="1"/>
          <p:nvPr/>
        </p:nvSpPr>
        <p:spPr>
          <a:xfrm>
            <a:off x="8305292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30" name="object 30" descr=""/>
          <p:cNvGrpSpPr/>
          <p:nvPr/>
        </p:nvGrpSpPr>
        <p:grpSpPr>
          <a:xfrm>
            <a:off x="9542653" y="148209"/>
            <a:ext cx="201930" cy="201930"/>
            <a:chOff x="9542653" y="148209"/>
            <a:chExt cx="201930" cy="201930"/>
          </a:xfrm>
        </p:grpSpPr>
        <p:sp>
          <p:nvSpPr>
            <p:cNvPr id="31" name="object 31" descr=""/>
            <p:cNvSpPr/>
            <p:nvPr/>
          </p:nvSpPr>
          <p:spPr>
            <a:xfrm>
              <a:off x="955560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4DCE6B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" name="object 32" descr=""/>
            <p:cNvSpPr/>
            <p:nvPr/>
          </p:nvSpPr>
          <p:spPr>
            <a:xfrm>
              <a:off x="954265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DCE6B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33" name="object 33" descr=""/>
          <p:cNvSpPr txBox="1"/>
          <p:nvPr/>
        </p:nvSpPr>
        <p:spPr>
          <a:xfrm>
            <a:off x="9578720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34" name="object 34" descr=""/>
          <p:cNvGrpSpPr/>
          <p:nvPr/>
        </p:nvGrpSpPr>
        <p:grpSpPr>
          <a:xfrm>
            <a:off x="10778108" y="148209"/>
            <a:ext cx="201930" cy="201930"/>
            <a:chOff x="10778108" y="148209"/>
            <a:chExt cx="201930" cy="201930"/>
          </a:xfrm>
        </p:grpSpPr>
        <p:sp>
          <p:nvSpPr>
            <p:cNvPr id="35" name="object 35" descr=""/>
            <p:cNvSpPr/>
            <p:nvPr/>
          </p:nvSpPr>
          <p:spPr>
            <a:xfrm>
              <a:off x="1079106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BCA7E8"/>
              </a:solidFill>
              <a:prstDash val="sys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6" name="object 36" descr=""/>
            <p:cNvSpPr/>
            <p:nvPr/>
          </p:nvSpPr>
          <p:spPr>
            <a:xfrm>
              <a:off x="1077810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BCA7E8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37" name="object 37" descr=""/>
          <p:cNvSpPr txBox="1"/>
          <p:nvPr/>
        </p:nvSpPr>
        <p:spPr>
          <a:xfrm>
            <a:off x="10814177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BCA7E8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38" name="object 38" descr=""/>
          <p:cNvSpPr txBox="1"/>
          <p:nvPr/>
        </p:nvSpPr>
        <p:spPr>
          <a:xfrm>
            <a:off x="6352794" y="162941"/>
            <a:ext cx="978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Complete </a:t>
            </a:r>
            <a:r>
              <a:rPr dirty="0" sz="900" spc="-10">
                <a:latin typeface="Arial"/>
                <a:cs typeface="Arial"/>
              </a:rPr>
              <a:t>denti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39" name="object 39" descr=""/>
          <p:cNvSpPr txBox="1"/>
          <p:nvPr/>
        </p:nvSpPr>
        <p:spPr>
          <a:xfrm>
            <a:off x="7664322" y="162941"/>
            <a:ext cx="53911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0">
                <a:latin typeface="Arial"/>
                <a:cs typeface="Arial"/>
              </a:rPr>
              <a:t>Tooth</a:t>
            </a:r>
            <a:r>
              <a:rPr dirty="0" sz="900" spc="-10">
                <a:latin typeface="Arial"/>
                <a:cs typeface="Arial"/>
              </a:rPr>
              <a:t> </a:t>
            </a:r>
            <a:r>
              <a:rPr dirty="0" sz="900" spc="-20"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40" name="object 40" descr=""/>
          <p:cNvSpPr txBox="1"/>
          <p:nvPr/>
        </p:nvSpPr>
        <p:spPr>
          <a:xfrm>
            <a:off x="8536558" y="162941"/>
            <a:ext cx="9404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Lacking </a:t>
            </a:r>
            <a:r>
              <a:rPr dirty="0" sz="900" spc="-10">
                <a:latin typeface="Arial"/>
                <a:cs typeface="Arial"/>
              </a:rPr>
              <a:t>functional</a:t>
            </a:r>
            <a:endParaRPr sz="900">
              <a:latin typeface="Arial"/>
              <a:cs typeface="Arial"/>
            </a:endParaRPr>
          </a:p>
        </p:txBody>
      </p:sp>
      <p:sp>
        <p:nvSpPr>
          <p:cNvPr id="41" name="object 41" descr=""/>
          <p:cNvSpPr txBox="1"/>
          <p:nvPr/>
        </p:nvSpPr>
        <p:spPr>
          <a:xfrm>
            <a:off x="9809988" y="162941"/>
            <a:ext cx="902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Severe</a:t>
            </a:r>
            <a:r>
              <a:rPr dirty="0" sz="900" spc="-30">
                <a:latin typeface="Arial"/>
                <a:cs typeface="Arial"/>
              </a:rPr>
              <a:t> </a:t>
            </a:r>
            <a:r>
              <a:rPr dirty="0" sz="900">
                <a:latin typeface="Arial"/>
                <a:cs typeface="Arial"/>
              </a:rPr>
              <a:t>tooth</a:t>
            </a:r>
            <a:r>
              <a:rPr dirty="0" sz="900" spc="-25">
                <a:latin typeface="Arial"/>
                <a:cs typeface="Arial"/>
              </a:rPr>
              <a:t> </a:t>
            </a:r>
            <a:r>
              <a:rPr dirty="0" sz="900" spc="-20"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42" name="object 42" descr=""/>
          <p:cNvSpPr txBox="1"/>
          <p:nvPr/>
        </p:nvSpPr>
        <p:spPr>
          <a:xfrm>
            <a:off x="11045443" y="162941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43" name="object 43" descr=""/>
          <p:cNvGrpSpPr/>
          <p:nvPr/>
        </p:nvGrpSpPr>
        <p:grpSpPr>
          <a:xfrm>
            <a:off x="1250950" y="4683125"/>
            <a:ext cx="15139035" cy="1678305"/>
            <a:chOff x="1250950" y="4683125"/>
            <a:chExt cx="15139035" cy="1678305"/>
          </a:xfrm>
        </p:grpSpPr>
        <p:sp>
          <p:nvSpPr>
            <p:cNvPr id="44" name="object 44" descr=""/>
            <p:cNvSpPr/>
            <p:nvPr/>
          </p:nvSpPr>
          <p:spPr>
            <a:xfrm>
              <a:off x="3315335" y="4683125"/>
              <a:ext cx="11010265" cy="1678305"/>
            </a:xfrm>
            <a:custGeom>
              <a:avLst/>
              <a:gdLst/>
              <a:ahLst/>
              <a:cxnLst/>
              <a:rect l="l" t="t" r="r" b="b"/>
              <a:pathLst>
                <a:path w="11010265" h="1678304">
                  <a:moveTo>
                    <a:pt x="0" y="1678177"/>
                  </a:moveTo>
                  <a:lnTo>
                    <a:pt x="0" y="0"/>
                  </a:lnTo>
                </a:path>
                <a:path w="11010265" h="1678304">
                  <a:moveTo>
                    <a:pt x="2752470" y="1678177"/>
                  </a:moveTo>
                  <a:lnTo>
                    <a:pt x="2752470" y="0"/>
                  </a:lnTo>
                </a:path>
                <a:path w="11010265" h="1678304">
                  <a:moveTo>
                    <a:pt x="5504942" y="1678177"/>
                  </a:moveTo>
                  <a:lnTo>
                    <a:pt x="5504942" y="0"/>
                  </a:lnTo>
                </a:path>
                <a:path w="11010265" h="1678304">
                  <a:moveTo>
                    <a:pt x="8257413" y="1678177"/>
                  </a:moveTo>
                  <a:lnTo>
                    <a:pt x="8257413" y="0"/>
                  </a:lnTo>
                </a:path>
                <a:path w="11010265" h="1678304">
                  <a:moveTo>
                    <a:pt x="11009884" y="1678177"/>
                  </a:moveTo>
                  <a:lnTo>
                    <a:pt x="11009884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5" name="object 45" descr=""/>
            <p:cNvSpPr/>
            <p:nvPr/>
          </p:nvSpPr>
          <p:spPr>
            <a:xfrm>
              <a:off x="1250950" y="4683125"/>
              <a:ext cx="15139035" cy="1678305"/>
            </a:xfrm>
            <a:custGeom>
              <a:avLst/>
              <a:gdLst/>
              <a:ahLst/>
              <a:cxnLst/>
              <a:rect l="l" t="t" r="r" b="b"/>
              <a:pathLst>
                <a:path w="15139035" h="1678304">
                  <a:moveTo>
                    <a:pt x="0" y="1484502"/>
                  </a:moveTo>
                  <a:lnTo>
                    <a:pt x="15138654" y="1484502"/>
                  </a:lnTo>
                </a:path>
                <a:path w="15139035" h="1678304">
                  <a:moveTo>
                    <a:pt x="0" y="1161796"/>
                  </a:moveTo>
                  <a:lnTo>
                    <a:pt x="15138654" y="1161796"/>
                  </a:lnTo>
                </a:path>
                <a:path w="15139035" h="1678304">
                  <a:moveTo>
                    <a:pt x="0" y="839088"/>
                  </a:moveTo>
                  <a:lnTo>
                    <a:pt x="15138654" y="839088"/>
                  </a:lnTo>
                </a:path>
                <a:path w="15139035" h="1678304">
                  <a:moveTo>
                    <a:pt x="0" y="516382"/>
                  </a:moveTo>
                  <a:lnTo>
                    <a:pt x="15138654" y="516382"/>
                  </a:lnTo>
                </a:path>
                <a:path w="15139035" h="1678304">
                  <a:moveTo>
                    <a:pt x="0" y="193675"/>
                  </a:moveTo>
                  <a:lnTo>
                    <a:pt x="15138654" y="193675"/>
                  </a:lnTo>
                </a:path>
                <a:path w="15139035" h="1678304">
                  <a:moveTo>
                    <a:pt x="688086" y="1678177"/>
                  </a:moveTo>
                  <a:lnTo>
                    <a:pt x="688086" y="0"/>
                  </a:lnTo>
                </a:path>
                <a:path w="15139035" h="1678304">
                  <a:moveTo>
                    <a:pt x="3440684" y="1678177"/>
                  </a:moveTo>
                  <a:lnTo>
                    <a:pt x="3440684" y="0"/>
                  </a:lnTo>
                </a:path>
                <a:path w="15139035" h="1678304">
                  <a:moveTo>
                    <a:pt x="6193155" y="1678177"/>
                  </a:moveTo>
                  <a:lnTo>
                    <a:pt x="6193155" y="0"/>
                  </a:lnTo>
                </a:path>
                <a:path w="15139035" h="1678304">
                  <a:moveTo>
                    <a:pt x="8945626" y="1678177"/>
                  </a:moveTo>
                  <a:lnTo>
                    <a:pt x="8945626" y="0"/>
                  </a:lnTo>
                </a:path>
                <a:path w="15139035" h="1678304">
                  <a:moveTo>
                    <a:pt x="11698097" y="1678177"/>
                  </a:moveTo>
                  <a:lnTo>
                    <a:pt x="11698097" y="0"/>
                  </a:lnTo>
                </a:path>
                <a:path w="15139035" h="1678304">
                  <a:moveTo>
                    <a:pt x="14450567" y="1678177"/>
                  </a:moveTo>
                  <a:lnTo>
                    <a:pt x="14450567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46" name="object 46" descr=""/>
          <p:cNvSpPr txBox="1"/>
          <p:nvPr/>
        </p:nvSpPr>
        <p:spPr>
          <a:xfrm>
            <a:off x="1619250" y="4782692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2245 </a:t>
            </a:r>
            <a:r>
              <a:rPr dirty="0" sz="1000" spc="-10">
                <a:solidFill>
                  <a:srgbClr val="E95359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47" name="object 47" descr=""/>
          <p:cNvSpPr txBox="1"/>
          <p:nvPr/>
        </p:nvSpPr>
        <p:spPr>
          <a:xfrm>
            <a:off x="4407153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838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82)</a:t>
            </a:r>
            <a:endParaRPr sz="1000">
              <a:latin typeface="Arial"/>
              <a:cs typeface="Arial"/>
            </a:endParaRPr>
          </a:p>
        </p:txBody>
      </p:sp>
      <p:sp>
        <p:nvSpPr>
          <p:cNvPr id="48" name="object 48" descr=""/>
          <p:cNvSpPr txBox="1"/>
          <p:nvPr/>
        </p:nvSpPr>
        <p:spPr>
          <a:xfrm>
            <a:off x="7159625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31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58)</a:t>
            </a:r>
            <a:endParaRPr sz="1000">
              <a:latin typeface="Arial"/>
              <a:cs typeface="Arial"/>
            </a:endParaRPr>
          </a:p>
        </p:txBody>
      </p:sp>
      <p:sp>
        <p:nvSpPr>
          <p:cNvPr id="49" name="object 49" descr=""/>
          <p:cNvSpPr txBox="1"/>
          <p:nvPr/>
        </p:nvSpPr>
        <p:spPr>
          <a:xfrm>
            <a:off x="994740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82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0" name="object 50" descr=""/>
          <p:cNvSpPr txBox="1"/>
          <p:nvPr/>
        </p:nvSpPr>
        <p:spPr>
          <a:xfrm>
            <a:off x="1269987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333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1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1" name="object 51" descr=""/>
          <p:cNvSpPr txBox="1"/>
          <p:nvPr/>
        </p:nvSpPr>
        <p:spPr>
          <a:xfrm>
            <a:off x="15558262" y="4782692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E95359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2" name="object 52" descr=""/>
          <p:cNvSpPr txBox="1"/>
          <p:nvPr/>
        </p:nvSpPr>
        <p:spPr>
          <a:xfrm>
            <a:off x="1619250" y="510540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5029 </a:t>
            </a:r>
            <a:r>
              <a:rPr dirty="0" sz="1000" spc="-10">
                <a:solidFill>
                  <a:srgbClr val="41A3FF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3" name="object 53" descr=""/>
          <p:cNvSpPr txBox="1"/>
          <p:nvPr/>
        </p:nvSpPr>
        <p:spPr>
          <a:xfrm>
            <a:off x="4407153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3760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7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4" name="object 54" descr=""/>
          <p:cNvSpPr txBox="1"/>
          <p:nvPr/>
        </p:nvSpPr>
        <p:spPr>
          <a:xfrm>
            <a:off x="715962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2369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4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5" name="object 55" descr=""/>
          <p:cNvSpPr txBox="1"/>
          <p:nvPr/>
        </p:nvSpPr>
        <p:spPr>
          <a:xfrm>
            <a:off x="991209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1254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2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6" name="object 56" descr=""/>
          <p:cNvSpPr txBox="1"/>
          <p:nvPr/>
        </p:nvSpPr>
        <p:spPr>
          <a:xfrm>
            <a:off x="12735179" y="5105400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474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9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7" name="object 57" descr=""/>
          <p:cNvSpPr txBox="1"/>
          <p:nvPr/>
        </p:nvSpPr>
        <p:spPr>
          <a:xfrm>
            <a:off x="15558262" y="510540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8" name="object 58" descr=""/>
          <p:cNvSpPr txBox="1"/>
          <p:nvPr/>
        </p:nvSpPr>
        <p:spPr>
          <a:xfrm>
            <a:off x="1619250" y="5428107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2246 </a:t>
            </a:r>
            <a:r>
              <a:rPr dirty="0" sz="1000" spc="-10">
                <a:solidFill>
                  <a:srgbClr val="DFD625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9" name="object 59" descr=""/>
          <p:cNvSpPr txBox="1"/>
          <p:nvPr/>
        </p:nvSpPr>
        <p:spPr>
          <a:xfrm>
            <a:off x="4407153" y="5428107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59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7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0" name="object 60" descr=""/>
          <p:cNvSpPr txBox="1"/>
          <p:nvPr/>
        </p:nvSpPr>
        <p:spPr>
          <a:xfrm>
            <a:off x="7194931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922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4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1" name="object 61" descr=""/>
          <p:cNvSpPr txBox="1"/>
          <p:nvPr/>
        </p:nvSpPr>
        <p:spPr>
          <a:xfrm>
            <a:off x="9947402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44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2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2" name="object 62" descr=""/>
          <p:cNvSpPr txBox="1"/>
          <p:nvPr/>
        </p:nvSpPr>
        <p:spPr>
          <a:xfrm>
            <a:off x="12735179" y="5428107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39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3" name="object 63" descr=""/>
          <p:cNvSpPr txBox="1"/>
          <p:nvPr/>
        </p:nvSpPr>
        <p:spPr>
          <a:xfrm>
            <a:off x="15558262" y="5428107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4" name="object 64" descr=""/>
          <p:cNvSpPr txBox="1"/>
          <p:nvPr/>
        </p:nvSpPr>
        <p:spPr>
          <a:xfrm>
            <a:off x="1619250" y="5750814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073 </a:t>
            </a:r>
            <a:r>
              <a:rPr dirty="0" sz="1000" spc="-10">
                <a:solidFill>
                  <a:srgbClr val="4DCE6B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5" name="object 65" descr=""/>
          <p:cNvSpPr txBox="1"/>
          <p:nvPr/>
        </p:nvSpPr>
        <p:spPr>
          <a:xfrm>
            <a:off x="4442459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718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6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6" name="object 66" descr=""/>
          <p:cNvSpPr txBox="1"/>
          <p:nvPr/>
        </p:nvSpPr>
        <p:spPr>
          <a:xfrm>
            <a:off x="7194931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397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7" name="object 67" descr=""/>
          <p:cNvSpPr txBox="1"/>
          <p:nvPr/>
        </p:nvSpPr>
        <p:spPr>
          <a:xfrm>
            <a:off x="9947402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75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1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8" name="object 68" descr=""/>
          <p:cNvSpPr txBox="1"/>
          <p:nvPr/>
        </p:nvSpPr>
        <p:spPr>
          <a:xfrm>
            <a:off x="12770484" y="5750814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49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9" name="object 69" descr=""/>
          <p:cNvSpPr txBox="1"/>
          <p:nvPr/>
        </p:nvSpPr>
        <p:spPr>
          <a:xfrm>
            <a:off x="15558262" y="5750814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0" name="object 70" descr=""/>
          <p:cNvSpPr txBox="1"/>
          <p:nvPr/>
        </p:nvSpPr>
        <p:spPr>
          <a:xfrm>
            <a:off x="1619250" y="607352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046 </a:t>
            </a:r>
            <a:r>
              <a:rPr dirty="0" sz="1000" spc="-10">
                <a:solidFill>
                  <a:srgbClr val="BCA7E8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1" name="object 71" descr=""/>
          <p:cNvSpPr txBox="1"/>
          <p:nvPr/>
        </p:nvSpPr>
        <p:spPr>
          <a:xfrm>
            <a:off x="4407153" y="607352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1349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6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2" name="object 72" descr=""/>
          <p:cNvSpPr txBox="1"/>
          <p:nvPr/>
        </p:nvSpPr>
        <p:spPr>
          <a:xfrm>
            <a:off x="7194931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691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3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3" name="object 73" descr=""/>
          <p:cNvSpPr txBox="1"/>
          <p:nvPr/>
        </p:nvSpPr>
        <p:spPr>
          <a:xfrm>
            <a:off x="9947402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83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1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4" name="object 74" descr=""/>
          <p:cNvSpPr txBox="1"/>
          <p:nvPr/>
        </p:nvSpPr>
        <p:spPr>
          <a:xfrm>
            <a:off x="12770484" y="6073520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76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5" name="object 75" descr=""/>
          <p:cNvSpPr txBox="1"/>
          <p:nvPr/>
        </p:nvSpPr>
        <p:spPr>
          <a:xfrm>
            <a:off x="15558262" y="607352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6" name="object 76" descr=""/>
          <p:cNvSpPr txBox="1"/>
          <p:nvPr/>
        </p:nvSpPr>
        <p:spPr>
          <a:xfrm>
            <a:off x="610362" y="6069076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solidFill>
                  <a:srgbClr val="BCA7E8"/>
                </a:solidFill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sp>
        <p:nvSpPr>
          <p:cNvPr id="77" name="object 77" descr=""/>
          <p:cNvSpPr txBox="1"/>
          <p:nvPr/>
        </p:nvSpPr>
        <p:spPr>
          <a:xfrm>
            <a:off x="298831" y="5746369"/>
            <a:ext cx="902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Severe</a:t>
            </a:r>
            <a:r>
              <a:rPr dirty="0" sz="900" spc="-3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tooth</a:t>
            </a:r>
            <a:r>
              <a:rPr dirty="0" sz="900" spc="-2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DCE6B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78" name="object 78" descr=""/>
          <p:cNvSpPr txBox="1"/>
          <p:nvPr/>
        </p:nvSpPr>
        <p:spPr>
          <a:xfrm>
            <a:off x="260731" y="5423661"/>
            <a:ext cx="9404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DFD625"/>
                </a:solidFill>
                <a:latin typeface="Arial"/>
                <a:cs typeface="Arial"/>
              </a:rPr>
              <a:t>Lacking</a:t>
            </a:r>
            <a:r>
              <a:rPr dirty="0" sz="900" spc="-5">
                <a:solidFill>
                  <a:srgbClr val="DFD625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DFD625"/>
                </a:solidFill>
                <a:latin typeface="Arial"/>
                <a:cs typeface="Arial"/>
              </a:rPr>
              <a:t>functional</a:t>
            </a:r>
            <a:endParaRPr sz="900">
              <a:latin typeface="Arial"/>
              <a:cs typeface="Arial"/>
            </a:endParaRPr>
          </a:p>
        </p:txBody>
      </p:sp>
      <p:sp>
        <p:nvSpPr>
          <p:cNvPr id="79" name="object 79" descr=""/>
          <p:cNvSpPr txBox="1"/>
          <p:nvPr/>
        </p:nvSpPr>
        <p:spPr>
          <a:xfrm>
            <a:off x="662051" y="5100954"/>
            <a:ext cx="53911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Tooth</a:t>
            </a:r>
            <a:r>
              <a:rPr dirty="0" sz="900" spc="-10">
                <a:solidFill>
                  <a:srgbClr val="41A3FF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80" name="object 80" descr=""/>
          <p:cNvSpPr txBox="1"/>
          <p:nvPr/>
        </p:nvSpPr>
        <p:spPr>
          <a:xfrm>
            <a:off x="222758" y="4778247"/>
            <a:ext cx="978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E95359"/>
                </a:solidFill>
                <a:latin typeface="Arial"/>
                <a:cs typeface="Arial"/>
              </a:rPr>
              <a:t>Complete</a:t>
            </a:r>
            <a:r>
              <a:rPr dirty="0" sz="900" spc="-5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E95359"/>
                </a:solidFill>
                <a:latin typeface="Arial"/>
                <a:cs typeface="Arial"/>
              </a:rPr>
              <a:t>denti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81" name="object 81" descr=""/>
          <p:cNvSpPr txBox="1"/>
          <p:nvPr/>
        </p:nvSpPr>
        <p:spPr>
          <a:xfrm>
            <a:off x="1894585" y="637895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82" name="object 82" descr=""/>
          <p:cNvSpPr txBox="1"/>
          <p:nvPr/>
        </p:nvSpPr>
        <p:spPr>
          <a:xfrm>
            <a:off x="4615307" y="637895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83" name="object 83" descr=""/>
          <p:cNvSpPr txBox="1"/>
          <p:nvPr/>
        </p:nvSpPr>
        <p:spPr>
          <a:xfrm>
            <a:off x="733602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84" name="object 84" descr=""/>
          <p:cNvSpPr txBox="1"/>
          <p:nvPr/>
        </p:nvSpPr>
        <p:spPr>
          <a:xfrm>
            <a:off x="1008849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85" name="object 85" descr=""/>
          <p:cNvSpPr txBox="1"/>
          <p:nvPr/>
        </p:nvSpPr>
        <p:spPr>
          <a:xfrm>
            <a:off x="12840969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86" name="object 86" descr=""/>
          <p:cNvSpPr txBox="1"/>
          <p:nvPr/>
        </p:nvSpPr>
        <p:spPr>
          <a:xfrm>
            <a:off x="15593440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87" name="object 87" descr=""/>
          <p:cNvSpPr txBox="1"/>
          <p:nvPr/>
        </p:nvSpPr>
        <p:spPr>
          <a:xfrm>
            <a:off x="8652382" y="651383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88" name="object 88" descr=""/>
          <p:cNvSpPr txBox="1"/>
          <p:nvPr/>
        </p:nvSpPr>
        <p:spPr>
          <a:xfrm>
            <a:off x="30759" y="5133565"/>
            <a:ext cx="181610" cy="77787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20">
                <a:latin typeface="Arial"/>
                <a:cs typeface="Arial"/>
              </a:rPr>
              <a:t>Teeth</a:t>
            </a:r>
            <a:r>
              <a:rPr dirty="0" sz="1100" spc="-35">
                <a:latin typeface="Arial"/>
                <a:cs typeface="Arial"/>
              </a:rPr>
              <a:t> </a:t>
            </a:r>
            <a:r>
              <a:rPr dirty="0" sz="1100" spc="-10">
                <a:latin typeface="Arial"/>
                <a:cs typeface="Arial"/>
              </a:rPr>
              <a:t>status</a:t>
            </a:r>
            <a:endParaRPr sz="1100">
              <a:latin typeface="Arial"/>
              <a:cs typeface="Arial"/>
            </a:endParaRPr>
          </a:p>
        </p:txBody>
      </p:sp>
      <p:sp>
        <p:nvSpPr>
          <p:cNvPr id="89" name="object 89" descr=""/>
          <p:cNvSpPr txBox="1"/>
          <p:nvPr/>
        </p:nvSpPr>
        <p:spPr>
          <a:xfrm>
            <a:off x="1238250" y="4399407"/>
            <a:ext cx="1587500" cy="22352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300">
                <a:latin typeface="Arial"/>
                <a:cs typeface="Arial"/>
              </a:rPr>
              <a:t>Number at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risk: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n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 spc="-25">
                <a:latin typeface="Arial"/>
                <a:cs typeface="Arial"/>
              </a:rPr>
              <a:t>(%)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90" name="object 90" descr=""/>
          <p:cNvGrpSpPr/>
          <p:nvPr/>
        </p:nvGrpSpPr>
        <p:grpSpPr>
          <a:xfrm>
            <a:off x="425195" y="7060565"/>
            <a:ext cx="15964535" cy="1678305"/>
            <a:chOff x="425195" y="7060565"/>
            <a:chExt cx="15964535" cy="1678305"/>
          </a:xfrm>
        </p:grpSpPr>
        <p:sp>
          <p:nvSpPr>
            <p:cNvPr id="91" name="object 91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31822"/>
                  </a:moveTo>
                  <a:lnTo>
                    <a:pt x="15964408" y="1631822"/>
                  </a:lnTo>
                </a:path>
                <a:path w="15964535" h="1678304">
                  <a:moveTo>
                    <a:pt x="0" y="1616836"/>
                  </a:moveTo>
                  <a:lnTo>
                    <a:pt x="15964408" y="1616836"/>
                  </a:lnTo>
                </a:path>
                <a:path w="15964535" h="1678304">
                  <a:moveTo>
                    <a:pt x="0" y="1586991"/>
                  </a:moveTo>
                  <a:lnTo>
                    <a:pt x="15964408" y="1586991"/>
                  </a:lnTo>
                </a:path>
                <a:path w="15964535" h="1678304">
                  <a:moveTo>
                    <a:pt x="0" y="1557019"/>
                  </a:moveTo>
                  <a:lnTo>
                    <a:pt x="15964408" y="1557019"/>
                  </a:lnTo>
                </a:path>
                <a:path w="15964535" h="1678304">
                  <a:moveTo>
                    <a:pt x="0" y="1527047"/>
                  </a:moveTo>
                  <a:lnTo>
                    <a:pt x="15964408" y="1527047"/>
                  </a:lnTo>
                </a:path>
                <a:path w="15964535" h="1678304">
                  <a:moveTo>
                    <a:pt x="0" y="1497202"/>
                  </a:moveTo>
                  <a:lnTo>
                    <a:pt x="15964408" y="1497202"/>
                  </a:lnTo>
                </a:path>
                <a:path w="15964535" h="1678304">
                  <a:moveTo>
                    <a:pt x="0" y="1467230"/>
                  </a:moveTo>
                  <a:lnTo>
                    <a:pt x="15964408" y="1467230"/>
                  </a:lnTo>
                </a:path>
                <a:path w="15964535" h="1678304">
                  <a:moveTo>
                    <a:pt x="0" y="1437385"/>
                  </a:moveTo>
                  <a:lnTo>
                    <a:pt x="15964408" y="1437385"/>
                  </a:lnTo>
                </a:path>
                <a:path w="15964535" h="1678304">
                  <a:moveTo>
                    <a:pt x="0" y="1407413"/>
                  </a:moveTo>
                  <a:lnTo>
                    <a:pt x="15964408" y="1407413"/>
                  </a:lnTo>
                </a:path>
                <a:path w="15964535" h="1678304">
                  <a:moveTo>
                    <a:pt x="0" y="1377568"/>
                  </a:moveTo>
                  <a:lnTo>
                    <a:pt x="15964408" y="1377568"/>
                  </a:lnTo>
                </a:path>
                <a:path w="15964535" h="1678304">
                  <a:moveTo>
                    <a:pt x="0" y="1347596"/>
                  </a:moveTo>
                  <a:lnTo>
                    <a:pt x="15964408" y="1347596"/>
                  </a:lnTo>
                </a:path>
                <a:path w="15964535" h="1678304">
                  <a:moveTo>
                    <a:pt x="0" y="1317751"/>
                  </a:moveTo>
                  <a:lnTo>
                    <a:pt x="15964408" y="1317751"/>
                  </a:lnTo>
                </a:path>
                <a:path w="15964535" h="1678304">
                  <a:moveTo>
                    <a:pt x="0" y="1287779"/>
                  </a:moveTo>
                  <a:lnTo>
                    <a:pt x="15964408" y="1287779"/>
                  </a:lnTo>
                </a:path>
                <a:path w="15964535" h="1678304">
                  <a:moveTo>
                    <a:pt x="0" y="1257934"/>
                  </a:moveTo>
                  <a:lnTo>
                    <a:pt x="15964408" y="1257934"/>
                  </a:lnTo>
                </a:path>
                <a:path w="15964535" h="1678304">
                  <a:moveTo>
                    <a:pt x="0" y="1227962"/>
                  </a:moveTo>
                  <a:lnTo>
                    <a:pt x="15964408" y="1227962"/>
                  </a:lnTo>
                </a:path>
                <a:path w="15964535" h="1678304">
                  <a:moveTo>
                    <a:pt x="0" y="1198117"/>
                  </a:moveTo>
                  <a:lnTo>
                    <a:pt x="15964408" y="1198117"/>
                  </a:lnTo>
                </a:path>
                <a:path w="15964535" h="1678304">
                  <a:moveTo>
                    <a:pt x="0" y="1168145"/>
                  </a:moveTo>
                  <a:lnTo>
                    <a:pt x="15964408" y="1168145"/>
                  </a:lnTo>
                </a:path>
                <a:path w="15964535" h="1678304">
                  <a:moveTo>
                    <a:pt x="0" y="1138173"/>
                  </a:moveTo>
                  <a:lnTo>
                    <a:pt x="15964408" y="1138173"/>
                  </a:lnTo>
                </a:path>
                <a:path w="15964535" h="1678304">
                  <a:moveTo>
                    <a:pt x="0" y="1108328"/>
                  </a:moveTo>
                  <a:lnTo>
                    <a:pt x="15964408" y="1108328"/>
                  </a:lnTo>
                </a:path>
                <a:path w="15964535" h="1678304">
                  <a:moveTo>
                    <a:pt x="0" y="1078356"/>
                  </a:moveTo>
                  <a:lnTo>
                    <a:pt x="15964408" y="1078356"/>
                  </a:lnTo>
                </a:path>
                <a:path w="15964535" h="1678304">
                  <a:moveTo>
                    <a:pt x="0" y="1048511"/>
                  </a:moveTo>
                  <a:lnTo>
                    <a:pt x="15964408" y="1048511"/>
                  </a:lnTo>
                </a:path>
                <a:path w="15964535" h="1678304">
                  <a:moveTo>
                    <a:pt x="0" y="1018539"/>
                  </a:moveTo>
                  <a:lnTo>
                    <a:pt x="15964408" y="1018539"/>
                  </a:lnTo>
                </a:path>
                <a:path w="15964535" h="1678304">
                  <a:moveTo>
                    <a:pt x="0" y="988694"/>
                  </a:moveTo>
                  <a:lnTo>
                    <a:pt x="15964408" y="988694"/>
                  </a:lnTo>
                </a:path>
                <a:path w="15964535" h="1678304">
                  <a:moveTo>
                    <a:pt x="0" y="958722"/>
                  </a:moveTo>
                  <a:lnTo>
                    <a:pt x="15964408" y="958722"/>
                  </a:lnTo>
                </a:path>
                <a:path w="15964535" h="1678304">
                  <a:moveTo>
                    <a:pt x="0" y="928877"/>
                  </a:moveTo>
                  <a:lnTo>
                    <a:pt x="15964408" y="928877"/>
                  </a:lnTo>
                </a:path>
                <a:path w="15964535" h="1678304">
                  <a:moveTo>
                    <a:pt x="0" y="898905"/>
                  </a:moveTo>
                  <a:lnTo>
                    <a:pt x="15964408" y="898905"/>
                  </a:lnTo>
                </a:path>
                <a:path w="15964535" h="1678304">
                  <a:moveTo>
                    <a:pt x="0" y="869060"/>
                  </a:moveTo>
                  <a:lnTo>
                    <a:pt x="15964408" y="869060"/>
                  </a:lnTo>
                </a:path>
                <a:path w="15964535" h="1678304">
                  <a:moveTo>
                    <a:pt x="0" y="839088"/>
                  </a:moveTo>
                  <a:lnTo>
                    <a:pt x="15964408" y="839088"/>
                  </a:lnTo>
                </a:path>
                <a:path w="15964535" h="1678304">
                  <a:moveTo>
                    <a:pt x="0" y="809243"/>
                  </a:moveTo>
                  <a:lnTo>
                    <a:pt x="15964408" y="809243"/>
                  </a:lnTo>
                </a:path>
                <a:path w="15964535" h="1678304">
                  <a:moveTo>
                    <a:pt x="0" y="779271"/>
                  </a:moveTo>
                  <a:lnTo>
                    <a:pt x="15964408" y="779271"/>
                  </a:lnTo>
                </a:path>
                <a:path w="15964535" h="1678304">
                  <a:moveTo>
                    <a:pt x="0" y="749299"/>
                  </a:moveTo>
                  <a:lnTo>
                    <a:pt x="15964408" y="749299"/>
                  </a:lnTo>
                </a:path>
                <a:path w="15964535" h="1678304">
                  <a:moveTo>
                    <a:pt x="0" y="719454"/>
                  </a:moveTo>
                  <a:lnTo>
                    <a:pt x="15964408" y="719454"/>
                  </a:lnTo>
                </a:path>
                <a:path w="15964535" h="1678304">
                  <a:moveTo>
                    <a:pt x="0" y="689482"/>
                  </a:moveTo>
                  <a:lnTo>
                    <a:pt x="15964408" y="689482"/>
                  </a:lnTo>
                </a:path>
                <a:path w="15964535" h="1678304">
                  <a:moveTo>
                    <a:pt x="0" y="659637"/>
                  </a:moveTo>
                  <a:lnTo>
                    <a:pt x="15964408" y="659637"/>
                  </a:lnTo>
                </a:path>
                <a:path w="15964535" h="1678304">
                  <a:moveTo>
                    <a:pt x="0" y="629665"/>
                  </a:moveTo>
                  <a:lnTo>
                    <a:pt x="15964408" y="629665"/>
                  </a:lnTo>
                </a:path>
                <a:path w="15964535" h="1678304">
                  <a:moveTo>
                    <a:pt x="0" y="599820"/>
                  </a:moveTo>
                  <a:lnTo>
                    <a:pt x="15964408" y="599820"/>
                  </a:lnTo>
                </a:path>
                <a:path w="15964535" h="1678304">
                  <a:moveTo>
                    <a:pt x="0" y="569848"/>
                  </a:moveTo>
                  <a:lnTo>
                    <a:pt x="15964408" y="569848"/>
                  </a:lnTo>
                </a:path>
                <a:path w="15964535" h="1678304">
                  <a:moveTo>
                    <a:pt x="0" y="540003"/>
                  </a:moveTo>
                  <a:lnTo>
                    <a:pt x="15964408" y="540003"/>
                  </a:lnTo>
                </a:path>
                <a:path w="15964535" h="1678304">
                  <a:moveTo>
                    <a:pt x="0" y="510031"/>
                  </a:moveTo>
                  <a:lnTo>
                    <a:pt x="15964408" y="510031"/>
                  </a:lnTo>
                </a:path>
                <a:path w="15964535" h="1678304">
                  <a:moveTo>
                    <a:pt x="0" y="480186"/>
                  </a:moveTo>
                  <a:lnTo>
                    <a:pt x="15964408" y="480186"/>
                  </a:lnTo>
                </a:path>
                <a:path w="15964535" h="1678304">
                  <a:moveTo>
                    <a:pt x="0" y="450214"/>
                  </a:moveTo>
                  <a:lnTo>
                    <a:pt x="15964408" y="450214"/>
                  </a:lnTo>
                </a:path>
                <a:path w="15964535" h="1678304">
                  <a:moveTo>
                    <a:pt x="0" y="390397"/>
                  </a:moveTo>
                  <a:lnTo>
                    <a:pt x="15964408" y="390397"/>
                  </a:lnTo>
                </a:path>
                <a:path w="15964535" h="1678304">
                  <a:moveTo>
                    <a:pt x="0" y="330580"/>
                  </a:moveTo>
                  <a:lnTo>
                    <a:pt x="15964408" y="330580"/>
                  </a:lnTo>
                </a:path>
                <a:path w="15964535" h="1678304">
                  <a:moveTo>
                    <a:pt x="0" y="300608"/>
                  </a:moveTo>
                  <a:lnTo>
                    <a:pt x="15964408" y="300608"/>
                  </a:lnTo>
                </a:path>
                <a:path w="15964535" h="1678304">
                  <a:moveTo>
                    <a:pt x="0" y="180974"/>
                  </a:moveTo>
                  <a:lnTo>
                    <a:pt x="15964408" y="180974"/>
                  </a:lnTo>
                </a:path>
                <a:path w="15964535" h="1678304">
                  <a:moveTo>
                    <a:pt x="0" y="61340"/>
                  </a:moveTo>
                  <a:lnTo>
                    <a:pt x="15964408" y="61340"/>
                  </a:lnTo>
                </a:path>
                <a:path w="15964535" h="1678304">
                  <a:moveTo>
                    <a:pt x="0" y="46354"/>
                  </a:moveTo>
                  <a:lnTo>
                    <a:pt x="15964408" y="46354"/>
                  </a:lnTo>
                </a:path>
                <a:path w="15964535" h="1678304">
                  <a:moveTo>
                    <a:pt x="2176907" y="1678177"/>
                  </a:moveTo>
                  <a:lnTo>
                    <a:pt x="2176907" y="0"/>
                  </a:lnTo>
                </a:path>
                <a:path w="15964535" h="1678304">
                  <a:moveTo>
                    <a:pt x="5079619" y="1678177"/>
                  </a:moveTo>
                  <a:lnTo>
                    <a:pt x="5079619" y="0"/>
                  </a:lnTo>
                </a:path>
                <a:path w="15964535" h="1678304">
                  <a:moveTo>
                    <a:pt x="7982204" y="1678177"/>
                  </a:moveTo>
                  <a:lnTo>
                    <a:pt x="7982204" y="0"/>
                  </a:lnTo>
                </a:path>
                <a:path w="15964535" h="1678304">
                  <a:moveTo>
                    <a:pt x="10884789" y="1678177"/>
                  </a:moveTo>
                  <a:lnTo>
                    <a:pt x="10884789" y="0"/>
                  </a:lnTo>
                </a:path>
                <a:path w="15964535" h="1678304">
                  <a:moveTo>
                    <a:pt x="13787500" y="1678177"/>
                  </a:moveTo>
                  <a:lnTo>
                    <a:pt x="13787500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2" name="object 92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01850"/>
                  </a:moveTo>
                  <a:lnTo>
                    <a:pt x="15964408" y="1601850"/>
                  </a:lnTo>
                </a:path>
                <a:path w="15964535" h="1678304">
                  <a:moveTo>
                    <a:pt x="0" y="1572005"/>
                  </a:moveTo>
                  <a:lnTo>
                    <a:pt x="15964408" y="1572005"/>
                  </a:lnTo>
                </a:path>
                <a:path w="15964535" h="1678304">
                  <a:moveTo>
                    <a:pt x="0" y="1542033"/>
                  </a:moveTo>
                  <a:lnTo>
                    <a:pt x="15964408" y="1542033"/>
                  </a:lnTo>
                </a:path>
                <a:path w="15964535" h="1678304">
                  <a:moveTo>
                    <a:pt x="0" y="1512188"/>
                  </a:moveTo>
                  <a:lnTo>
                    <a:pt x="15964408" y="1512188"/>
                  </a:lnTo>
                </a:path>
                <a:path w="15964535" h="1678304">
                  <a:moveTo>
                    <a:pt x="0" y="1482216"/>
                  </a:moveTo>
                  <a:lnTo>
                    <a:pt x="15964408" y="1482216"/>
                  </a:lnTo>
                </a:path>
                <a:path w="15964535" h="1678304">
                  <a:moveTo>
                    <a:pt x="0" y="1452371"/>
                  </a:moveTo>
                  <a:lnTo>
                    <a:pt x="15964408" y="1452371"/>
                  </a:lnTo>
                </a:path>
                <a:path w="15964535" h="1678304">
                  <a:moveTo>
                    <a:pt x="0" y="1422399"/>
                  </a:moveTo>
                  <a:lnTo>
                    <a:pt x="15964408" y="1422399"/>
                  </a:lnTo>
                </a:path>
                <a:path w="15964535" h="1678304">
                  <a:moveTo>
                    <a:pt x="0" y="1392554"/>
                  </a:moveTo>
                  <a:lnTo>
                    <a:pt x="15964408" y="1392554"/>
                  </a:lnTo>
                </a:path>
                <a:path w="15964535" h="1678304">
                  <a:moveTo>
                    <a:pt x="0" y="1362582"/>
                  </a:moveTo>
                  <a:lnTo>
                    <a:pt x="15964408" y="1362582"/>
                  </a:lnTo>
                </a:path>
                <a:path w="15964535" h="1678304">
                  <a:moveTo>
                    <a:pt x="0" y="1332610"/>
                  </a:moveTo>
                  <a:lnTo>
                    <a:pt x="15964408" y="1332610"/>
                  </a:lnTo>
                </a:path>
                <a:path w="15964535" h="1678304">
                  <a:moveTo>
                    <a:pt x="0" y="1302765"/>
                  </a:moveTo>
                  <a:lnTo>
                    <a:pt x="15964408" y="1302765"/>
                  </a:lnTo>
                </a:path>
                <a:path w="15964535" h="1678304">
                  <a:moveTo>
                    <a:pt x="0" y="1272793"/>
                  </a:moveTo>
                  <a:lnTo>
                    <a:pt x="15964408" y="1272793"/>
                  </a:lnTo>
                </a:path>
                <a:path w="15964535" h="1678304">
                  <a:moveTo>
                    <a:pt x="0" y="1242948"/>
                  </a:moveTo>
                  <a:lnTo>
                    <a:pt x="15964408" y="1242948"/>
                  </a:lnTo>
                </a:path>
                <a:path w="15964535" h="1678304">
                  <a:moveTo>
                    <a:pt x="0" y="1212976"/>
                  </a:moveTo>
                  <a:lnTo>
                    <a:pt x="15964408" y="1212976"/>
                  </a:lnTo>
                </a:path>
                <a:path w="15964535" h="1678304">
                  <a:moveTo>
                    <a:pt x="0" y="1183131"/>
                  </a:moveTo>
                  <a:lnTo>
                    <a:pt x="15964408" y="1183131"/>
                  </a:lnTo>
                </a:path>
                <a:path w="15964535" h="1678304">
                  <a:moveTo>
                    <a:pt x="0" y="1153159"/>
                  </a:moveTo>
                  <a:lnTo>
                    <a:pt x="15964408" y="1153159"/>
                  </a:lnTo>
                </a:path>
                <a:path w="15964535" h="1678304">
                  <a:moveTo>
                    <a:pt x="0" y="1123314"/>
                  </a:moveTo>
                  <a:lnTo>
                    <a:pt x="15964408" y="1123314"/>
                  </a:lnTo>
                </a:path>
                <a:path w="15964535" h="1678304">
                  <a:moveTo>
                    <a:pt x="0" y="1093342"/>
                  </a:moveTo>
                  <a:lnTo>
                    <a:pt x="15964408" y="1093342"/>
                  </a:lnTo>
                </a:path>
                <a:path w="15964535" h="1678304">
                  <a:moveTo>
                    <a:pt x="0" y="1063497"/>
                  </a:moveTo>
                  <a:lnTo>
                    <a:pt x="15964408" y="1063497"/>
                  </a:lnTo>
                </a:path>
                <a:path w="15964535" h="1678304">
                  <a:moveTo>
                    <a:pt x="0" y="1033525"/>
                  </a:moveTo>
                  <a:lnTo>
                    <a:pt x="15964408" y="1033525"/>
                  </a:lnTo>
                </a:path>
                <a:path w="15964535" h="1678304">
                  <a:moveTo>
                    <a:pt x="0" y="1003680"/>
                  </a:moveTo>
                  <a:lnTo>
                    <a:pt x="15964408" y="1003680"/>
                  </a:lnTo>
                </a:path>
                <a:path w="15964535" h="1678304">
                  <a:moveTo>
                    <a:pt x="0" y="973708"/>
                  </a:moveTo>
                  <a:lnTo>
                    <a:pt x="15964408" y="973708"/>
                  </a:lnTo>
                </a:path>
                <a:path w="15964535" h="1678304">
                  <a:moveTo>
                    <a:pt x="0" y="943736"/>
                  </a:moveTo>
                  <a:lnTo>
                    <a:pt x="15964408" y="943736"/>
                  </a:lnTo>
                </a:path>
                <a:path w="15964535" h="1678304">
                  <a:moveTo>
                    <a:pt x="0" y="913891"/>
                  </a:moveTo>
                  <a:lnTo>
                    <a:pt x="15964408" y="913891"/>
                  </a:lnTo>
                </a:path>
                <a:path w="15964535" h="1678304">
                  <a:moveTo>
                    <a:pt x="0" y="883919"/>
                  </a:moveTo>
                  <a:lnTo>
                    <a:pt x="15964408" y="883919"/>
                  </a:lnTo>
                </a:path>
                <a:path w="15964535" h="1678304">
                  <a:moveTo>
                    <a:pt x="0" y="854074"/>
                  </a:moveTo>
                  <a:lnTo>
                    <a:pt x="15964408" y="854074"/>
                  </a:lnTo>
                </a:path>
                <a:path w="15964535" h="1678304">
                  <a:moveTo>
                    <a:pt x="0" y="824102"/>
                  </a:moveTo>
                  <a:lnTo>
                    <a:pt x="15964408" y="824102"/>
                  </a:lnTo>
                </a:path>
                <a:path w="15964535" h="1678304">
                  <a:moveTo>
                    <a:pt x="0" y="794257"/>
                  </a:moveTo>
                  <a:lnTo>
                    <a:pt x="15964408" y="794257"/>
                  </a:lnTo>
                </a:path>
                <a:path w="15964535" h="1678304">
                  <a:moveTo>
                    <a:pt x="0" y="764285"/>
                  </a:moveTo>
                  <a:lnTo>
                    <a:pt x="15964408" y="764285"/>
                  </a:lnTo>
                </a:path>
                <a:path w="15964535" h="1678304">
                  <a:moveTo>
                    <a:pt x="0" y="734440"/>
                  </a:moveTo>
                  <a:lnTo>
                    <a:pt x="15964408" y="734440"/>
                  </a:lnTo>
                </a:path>
                <a:path w="15964535" h="1678304">
                  <a:moveTo>
                    <a:pt x="0" y="704468"/>
                  </a:moveTo>
                  <a:lnTo>
                    <a:pt x="15964408" y="704468"/>
                  </a:lnTo>
                </a:path>
                <a:path w="15964535" h="1678304">
                  <a:moveTo>
                    <a:pt x="0" y="674623"/>
                  </a:moveTo>
                  <a:lnTo>
                    <a:pt x="15964408" y="674623"/>
                  </a:lnTo>
                </a:path>
                <a:path w="15964535" h="1678304">
                  <a:moveTo>
                    <a:pt x="0" y="644651"/>
                  </a:moveTo>
                  <a:lnTo>
                    <a:pt x="15964408" y="644651"/>
                  </a:lnTo>
                </a:path>
                <a:path w="15964535" h="1678304">
                  <a:moveTo>
                    <a:pt x="0" y="614806"/>
                  </a:moveTo>
                  <a:lnTo>
                    <a:pt x="15964408" y="614806"/>
                  </a:lnTo>
                </a:path>
                <a:path w="15964535" h="1678304">
                  <a:moveTo>
                    <a:pt x="0" y="584834"/>
                  </a:moveTo>
                  <a:lnTo>
                    <a:pt x="15964408" y="584834"/>
                  </a:lnTo>
                </a:path>
                <a:path w="15964535" h="1678304">
                  <a:moveTo>
                    <a:pt x="0" y="554989"/>
                  </a:moveTo>
                  <a:lnTo>
                    <a:pt x="15964408" y="554989"/>
                  </a:lnTo>
                </a:path>
                <a:path w="15964535" h="1678304">
                  <a:moveTo>
                    <a:pt x="0" y="525017"/>
                  </a:moveTo>
                  <a:lnTo>
                    <a:pt x="15964408" y="525017"/>
                  </a:lnTo>
                </a:path>
                <a:path w="15964535" h="1678304">
                  <a:moveTo>
                    <a:pt x="0" y="495045"/>
                  </a:moveTo>
                  <a:lnTo>
                    <a:pt x="15964408" y="495045"/>
                  </a:lnTo>
                </a:path>
                <a:path w="15964535" h="1678304">
                  <a:moveTo>
                    <a:pt x="0" y="465200"/>
                  </a:moveTo>
                  <a:lnTo>
                    <a:pt x="15964408" y="465200"/>
                  </a:lnTo>
                </a:path>
                <a:path w="15964535" h="1678304">
                  <a:moveTo>
                    <a:pt x="0" y="435228"/>
                  </a:moveTo>
                  <a:lnTo>
                    <a:pt x="15964408" y="435228"/>
                  </a:lnTo>
                </a:path>
                <a:path w="15964535" h="1678304">
                  <a:moveTo>
                    <a:pt x="0" y="345566"/>
                  </a:moveTo>
                  <a:lnTo>
                    <a:pt x="15964408" y="345566"/>
                  </a:lnTo>
                </a:path>
                <a:path w="15964535" h="1678304">
                  <a:moveTo>
                    <a:pt x="0" y="315594"/>
                  </a:moveTo>
                  <a:lnTo>
                    <a:pt x="15964408" y="315594"/>
                  </a:lnTo>
                </a:path>
                <a:path w="15964535" h="1678304">
                  <a:moveTo>
                    <a:pt x="0" y="285749"/>
                  </a:moveTo>
                  <a:lnTo>
                    <a:pt x="15964408" y="285749"/>
                  </a:lnTo>
                </a:path>
                <a:path w="15964535" h="1678304">
                  <a:moveTo>
                    <a:pt x="0" y="76326"/>
                  </a:moveTo>
                  <a:lnTo>
                    <a:pt x="15964408" y="76326"/>
                  </a:lnTo>
                </a:path>
                <a:path w="15964535" h="1678304">
                  <a:moveTo>
                    <a:pt x="725678" y="1678177"/>
                  </a:moveTo>
                  <a:lnTo>
                    <a:pt x="725678" y="0"/>
                  </a:lnTo>
                </a:path>
                <a:path w="15964535" h="1678304">
                  <a:moveTo>
                    <a:pt x="3628263" y="1678177"/>
                  </a:moveTo>
                  <a:lnTo>
                    <a:pt x="3628263" y="0"/>
                  </a:lnTo>
                </a:path>
                <a:path w="15964535" h="1678304">
                  <a:moveTo>
                    <a:pt x="6530848" y="1678177"/>
                  </a:moveTo>
                  <a:lnTo>
                    <a:pt x="6530848" y="0"/>
                  </a:lnTo>
                </a:path>
                <a:path w="15964535" h="1678304">
                  <a:moveTo>
                    <a:pt x="9433560" y="1678177"/>
                  </a:moveTo>
                  <a:lnTo>
                    <a:pt x="9433560" y="0"/>
                  </a:lnTo>
                </a:path>
                <a:path w="15964535" h="1678304">
                  <a:moveTo>
                    <a:pt x="12336145" y="1678177"/>
                  </a:moveTo>
                  <a:lnTo>
                    <a:pt x="12336145" y="0"/>
                  </a:lnTo>
                </a:path>
                <a:path w="15964535" h="1678304">
                  <a:moveTo>
                    <a:pt x="15238730" y="1678177"/>
                  </a:moveTo>
                  <a:lnTo>
                    <a:pt x="15238730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3" name="object 93" descr=""/>
            <p:cNvSpPr/>
            <p:nvPr/>
          </p:nvSpPr>
          <p:spPr>
            <a:xfrm>
              <a:off x="1531112" y="7884668"/>
              <a:ext cx="4132579" cy="777875"/>
            </a:xfrm>
            <a:custGeom>
              <a:avLst/>
              <a:gdLst/>
              <a:ahLst/>
              <a:cxnLst/>
              <a:rect l="l" t="t" r="r" b="b"/>
              <a:pathLst>
                <a:path w="4132579" h="777875">
                  <a:moveTo>
                    <a:pt x="10414" y="747776"/>
                  </a:moveTo>
                  <a:lnTo>
                    <a:pt x="0" y="747776"/>
                  </a:lnTo>
                  <a:lnTo>
                    <a:pt x="0" y="777748"/>
                  </a:lnTo>
                  <a:lnTo>
                    <a:pt x="10414" y="777748"/>
                  </a:lnTo>
                  <a:lnTo>
                    <a:pt x="10414" y="747776"/>
                  </a:lnTo>
                  <a:close/>
                </a:path>
                <a:path w="4132579" h="777875">
                  <a:moveTo>
                    <a:pt x="126479" y="747776"/>
                  </a:moveTo>
                  <a:lnTo>
                    <a:pt x="116065" y="747776"/>
                  </a:lnTo>
                  <a:lnTo>
                    <a:pt x="116065" y="777748"/>
                  </a:lnTo>
                  <a:lnTo>
                    <a:pt x="126479" y="777748"/>
                  </a:lnTo>
                  <a:lnTo>
                    <a:pt x="126479" y="747776"/>
                  </a:lnTo>
                  <a:close/>
                </a:path>
                <a:path w="4132579" h="777875">
                  <a:moveTo>
                    <a:pt x="184531" y="717931"/>
                  </a:moveTo>
                  <a:lnTo>
                    <a:pt x="174117" y="717931"/>
                  </a:lnTo>
                  <a:lnTo>
                    <a:pt x="174117" y="777748"/>
                  </a:lnTo>
                  <a:lnTo>
                    <a:pt x="184531" y="777748"/>
                  </a:lnTo>
                  <a:lnTo>
                    <a:pt x="184531" y="717931"/>
                  </a:lnTo>
                  <a:close/>
                </a:path>
                <a:path w="4132579" h="777875">
                  <a:moveTo>
                    <a:pt x="242570" y="747776"/>
                  </a:moveTo>
                  <a:lnTo>
                    <a:pt x="232156" y="747776"/>
                  </a:lnTo>
                  <a:lnTo>
                    <a:pt x="232156" y="777748"/>
                  </a:lnTo>
                  <a:lnTo>
                    <a:pt x="242570" y="777748"/>
                  </a:lnTo>
                  <a:lnTo>
                    <a:pt x="242570" y="747776"/>
                  </a:lnTo>
                  <a:close/>
                </a:path>
                <a:path w="4132579" h="777875">
                  <a:moveTo>
                    <a:pt x="300609" y="508508"/>
                  </a:moveTo>
                  <a:lnTo>
                    <a:pt x="290195" y="508508"/>
                  </a:lnTo>
                  <a:lnTo>
                    <a:pt x="290195" y="777748"/>
                  </a:lnTo>
                  <a:lnTo>
                    <a:pt x="300609" y="777748"/>
                  </a:lnTo>
                  <a:lnTo>
                    <a:pt x="300609" y="508508"/>
                  </a:lnTo>
                  <a:close/>
                </a:path>
                <a:path w="4132579" h="777875">
                  <a:moveTo>
                    <a:pt x="358635" y="478663"/>
                  </a:moveTo>
                  <a:lnTo>
                    <a:pt x="348234" y="478663"/>
                  </a:lnTo>
                  <a:lnTo>
                    <a:pt x="348234" y="777748"/>
                  </a:lnTo>
                  <a:lnTo>
                    <a:pt x="358635" y="777748"/>
                  </a:lnTo>
                  <a:lnTo>
                    <a:pt x="358635" y="478663"/>
                  </a:lnTo>
                  <a:close/>
                </a:path>
                <a:path w="4132579" h="777875">
                  <a:moveTo>
                    <a:pt x="416687" y="448691"/>
                  </a:moveTo>
                  <a:lnTo>
                    <a:pt x="406273" y="448691"/>
                  </a:lnTo>
                  <a:lnTo>
                    <a:pt x="406273" y="777748"/>
                  </a:lnTo>
                  <a:lnTo>
                    <a:pt x="416687" y="777748"/>
                  </a:lnTo>
                  <a:lnTo>
                    <a:pt x="416687" y="448691"/>
                  </a:lnTo>
                  <a:close/>
                </a:path>
                <a:path w="4132579" h="777875">
                  <a:moveTo>
                    <a:pt x="474726" y="209423"/>
                  </a:moveTo>
                  <a:lnTo>
                    <a:pt x="464312" y="209423"/>
                  </a:lnTo>
                  <a:lnTo>
                    <a:pt x="464312" y="777748"/>
                  </a:lnTo>
                  <a:lnTo>
                    <a:pt x="474726" y="777748"/>
                  </a:lnTo>
                  <a:lnTo>
                    <a:pt x="474726" y="209423"/>
                  </a:lnTo>
                  <a:close/>
                </a:path>
                <a:path w="4132579" h="777875">
                  <a:moveTo>
                    <a:pt x="532879" y="448691"/>
                  </a:moveTo>
                  <a:lnTo>
                    <a:pt x="522478" y="448691"/>
                  </a:lnTo>
                  <a:lnTo>
                    <a:pt x="522478" y="777748"/>
                  </a:lnTo>
                  <a:lnTo>
                    <a:pt x="532879" y="777748"/>
                  </a:lnTo>
                  <a:lnTo>
                    <a:pt x="532879" y="448691"/>
                  </a:lnTo>
                  <a:close/>
                </a:path>
                <a:path w="4132579" h="777875">
                  <a:moveTo>
                    <a:pt x="590931" y="538480"/>
                  </a:moveTo>
                  <a:lnTo>
                    <a:pt x="580517" y="538480"/>
                  </a:lnTo>
                  <a:lnTo>
                    <a:pt x="580517" y="777748"/>
                  </a:lnTo>
                  <a:lnTo>
                    <a:pt x="590931" y="777748"/>
                  </a:lnTo>
                  <a:lnTo>
                    <a:pt x="590931" y="538480"/>
                  </a:lnTo>
                  <a:close/>
                </a:path>
                <a:path w="4132579" h="777875">
                  <a:moveTo>
                    <a:pt x="648970" y="299085"/>
                  </a:moveTo>
                  <a:lnTo>
                    <a:pt x="638556" y="299085"/>
                  </a:lnTo>
                  <a:lnTo>
                    <a:pt x="638556" y="777748"/>
                  </a:lnTo>
                  <a:lnTo>
                    <a:pt x="648970" y="777748"/>
                  </a:lnTo>
                  <a:lnTo>
                    <a:pt x="648970" y="299085"/>
                  </a:lnTo>
                  <a:close/>
                </a:path>
                <a:path w="4132579" h="777875">
                  <a:moveTo>
                    <a:pt x="707009" y="568325"/>
                  </a:moveTo>
                  <a:lnTo>
                    <a:pt x="696595" y="568325"/>
                  </a:lnTo>
                  <a:lnTo>
                    <a:pt x="696595" y="777748"/>
                  </a:lnTo>
                  <a:lnTo>
                    <a:pt x="707009" y="777748"/>
                  </a:lnTo>
                  <a:lnTo>
                    <a:pt x="707009" y="568325"/>
                  </a:lnTo>
                  <a:close/>
                </a:path>
                <a:path w="4132579" h="777875">
                  <a:moveTo>
                    <a:pt x="765035" y="299085"/>
                  </a:moveTo>
                  <a:lnTo>
                    <a:pt x="754634" y="299085"/>
                  </a:lnTo>
                  <a:lnTo>
                    <a:pt x="754634" y="777748"/>
                  </a:lnTo>
                  <a:lnTo>
                    <a:pt x="765035" y="777748"/>
                  </a:lnTo>
                  <a:lnTo>
                    <a:pt x="765035" y="299085"/>
                  </a:lnTo>
                  <a:close/>
                </a:path>
                <a:path w="4132579" h="777875">
                  <a:moveTo>
                    <a:pt x="823087" y="628142"/>
                  </a:moveTo>
                  <a:lnTo>
                    <a:pt x="812673" y="628142"/>
                  </a:lnTo>
                  <a:lnTo>
                    <a:pt x="812673" y="777748"/>
                  </a:lnTo>
                  <a:lnTo>
                    <a:pt x="823087" y="777748"/>
                  </a:lnTo>
                  <a:lnTo>
                    <a:pt x="823087" y="628142"/>
                  </a:lnTo>
                  <a:close/>
                </a:path>
                <a:path w="4132579" h="777875">
                  <a:moveTo>
                    <a:pt x="881126" y="538480"/>
                  </a:moveTo>
                  <a:lnTo>
                    <a:pt x="870712" y="538480"/>
                  </a:lnTo>
                  <a:lnTo>
                    <a:pt x="870712" y="777748"/>
                  </a:lnTo>
                  <a:lnTo>
                    <a:pt x="881126" y="777748"/>
                  </a:lnTo>
                  <a:lnTo>
                    <a:pt x="881126" y="538480"/>
                  </a:lnTo>
                  <a:close/>
                </a:path>
                <a:path w="4132579" h="777875">
                  <a:moveTo>
                    <a:pt x="939165" y="508508"/>
                  </a:moveTo>
                  <a:lnTo>
                    <a:pt x="928751" y="508508"/>
                  </a:lnTo>
                  <a:lnTo>
                    <a:pt x="928751" y="777748"/>
                  </a:lnTo>
                  <a:lnTo>
                    <a:pt x="939165" y="777748"/>
                  </a:lnTo>
                  <a:lnTo>
                    <a:pt x="939165" y="508508"/>
                  </a:lnTo>
                  <a:close/>
                </a:path>
                <a:path w="4132579" h="777875">
                  <a:moveTo>
                    <a:pt x="997191" y="478663"/>
                  </a:moveTo>
                  <a:lnTo>
                    <a:pt x="986790" y="478663"/>
                  </a:lnTo>
                  <a:lnTo>
                    <a:pt x="986790" y="777748"/>
                  </a:lnTo>
                  <a:lnTo>
                    <a:pt x="997191" y="777748"/>
                  </a:lnTo>
                  <a:lnTo>
                    <a:pt x="997191" y="478663"/>
                  </a:lnTo>
                  <a:close/>
                </a:path>
                <a:path w="4132579" h="777875">
                  <a:moveTo>
                    <a:pt x="1055243" y="418846"/>
                  </a:moveTo>
                  <a:lnTo>
                    <a:pt x="1044829" y="418846"/>
                  </a:lnTo>
                  <a:lnTo>
                    <a:pt x="1044829" y="777748"/>
                  </a:lnTo>
                  <a:lnTo>
                    <a:pt x="1055243" y="777748"/>
                  </a:lnTo>
                  <a:lnTo>
                    <a:pt x="1055243" y="418846"/>
                  </a:lnTo>
                  <a:close/>
                </a:path>
                <a:path w="4132579" h="777875">
                  <a:moveTo>
                    <a:pt x="1113409" y="448691"/>
                  </a:moveTo>
                  <a:lnTo>
                    <a:pt x="1102995" y="448691"/>
                  </a:lnTo>
                  <a:lnTo>
                    <a:pt x="1102995" y="777748"/>
                  </a:lnTo>
                  <a:lnTo>
                    <a:pt x="1113409" y="777748"/>
                  </a:lnTo>
                  <a:lnTo>
                    <a:pt x="1113409" y="448691"/>
                  </a:lnTo>
                  <a:close/>
                </a:path>
                <a:path w="4132579" h="777875">
                  <a:moveTo>
                    <a:pt x="1171435" y="538480"/>
                  </a:moveTo>
                  <a:lnTo>
                    <a:pt x="1161034" y="538480"/>
                  </a:lnTo>
                  <a:lnTo>
                    <a:pt x="1161034" y="777748"/>
                  </a:lnTo>
                  <a:lnTo>
                    <a:pt x="1171435" y="777748"/>
                  </a:lnTo>
                  <a:lnTo>
                    <a:pt x="1171435" y="538480"/>
                  </a:lnTo>
                  <a:close/>
                </a:path>
                <a:path w="4132579" h="777875">
                  <a:moveTo>
                    <a:pt x="1229487" y="418846"/>
                  </a:moveTo>
                  <a:lnTo>
                    <a:pt x="1219073" y="418846"/>
                  </a:lnTo>
                  <a:lnTo>
                    <a:pt x="1219073" y="777748"/>
                  </a:lnTo>
                  <a:lnTo>
                    <a:pt x="1229487" y="777748"/>
                  </a:lnTo>
                  <a:lnTo>
                    <a:pt x="1229487" y="418846"/>
                  </a:lnTo>
                  <a:close/>
                </a:path>
                <a:path w="4132579" h="777875">
                  <a:moveTo>
                    <a:pt x="1287526" y="478663"/>
                  </a:moveTo>
                  <a:lnTo>
                    <a:pt x="1277112" y="478663"/>
                  </a:lnTo>
                  <a:lnTo>
                    <a:pt x="1277112" y="777748"/>
                  </a:lnTo>
                  <a:lnTo>
                    <a:pt x="1287526" y="777748"/>
                  </a:lnTo>
                  <a:lnTo>
                    <a:pt x="1287526" y="478663"/>
                  </a:lnTo>
                  <a:close/>
                </a:path>
                <a:path w="4132579" h="777875">
                  <a:moveTo>
                    <a:pt x="1345565" y="538480"/>
                  </a:moveTo>
                  <a:lnTo>
                    <a:pt x="1335151" y="538480"/>
                  </a:lnTo>
                  <a:lnTo>
                    <a:pt x="1335151" y="777748"/>
                  </a:lnTo>
                  <a:lnTo>
                    <a:pt x="1345565" y="777748"/>
                  </a:lnTo>
                  <a:lnTo>
                    <a:pt x="1345565" y="538480"/>
                  </a:lnTo>
                  <a:close/>
                </a:path>
                <a:path w="4132579" h="777875">
                  <a:moveTo>
                    <a:pt x="1403591" y="508508"/>
                  </a:moveTo>
                  <a:lnTo>
                    <a:pt x="1393190" y="508508"/>
                  </a:lnTo>
                  <a:lnTo>
                    <a:pt x="1393190" y="777748"/>
                  </a:lnTo>
                  <a:lnTo>
                    <a:pt x="1403591" y="777748"/>
                  </a:lnTo>
                  <a:lnTo>
                    <a:pt x="1403591" y="508508"/>
                  </a:lnTo>
                  <a:close/>
                </a:path>
                <a:path w="4132579" h="777875">
                  <a:moveTo>
                    <a:pt x="1461643" y="89789"/>
                  </a:moveTo>
                  <a:lnTo>
                    <a:pt x="1451229" y="89789"/>
                  </a:lnTo>
                  <a:lnTo>
                    <a:pt x="1451229" y="777748"/>
                  </a:lnTo>
                  <a:lnTo>
                    <a:pt x="1461643" y="777748"/>
                  </a:lnTo>
                  <a:lnTo>
                    <a:pt x="1461643" y="89789"/>
                  </a:lnTo>
                  <a:close/>
                </a:path>
                <a:path w="4132579" h="777875">
                  <a:moveTo>
                    <a:pt x="1519682" y="418846"/>
                  </a:moveTo>
                  <a:lnTo>
                    <a:pt x="1509268" y="418846"/>
                  </a:lnTo>
                  <a:lnTo>
                    <a:pt x="1509268" y="777748"/>
                  </a:lnTo>
                  <a:lnTo>
                    <a:pt x="1519682" y="777748"/>
                  </a:lnTo>
                  <a:lnTo>
                    <a:pt x="1519682" y="418846"/>
                  </a:lnTo>
                  <a:close/>
                </a:path>
                <a:path w="4132579" h="777875">
                  <a:moveTo>
                    <a:pt x="1577721" y="388874"/>
                  </a:moveTo>
                  <a:lnTo>
                    <a:pt x="1567307" y="388874"/>
                  </a:lnTo>
                  <a:lnTo>
                    <a:pt x="1567307" y="777748"/>
                  </a:lnTo>
                  <a:lnTo>
                    <a:pt x="1577721" y="777748"/>
                  </a:lnTo>
                  <a:lnTo>
                    <a:pt x="1577721" y="388874"/>
                  </a:lnTo>
                  <a:close/>
                </a:path>
                <a:path w="4132579" h="777875">
                  <a:moveTo>
                    <a:pt x="1635887" y="598297"/>
                  </a:moveTo>
                  <a:lnTo>
                    <a:pt x="1625473" y="598297"/>
                  </a:lnTo>
                  <a:lnTo>
                    <a:pt x="1625473" y="777748"/>
                  </a:lnTo>
                  <a:lnTo>
                    <a:pt x="1635887" y="777748"/>
                  </a:lnTo>
                  <a:lnTo>
                    <a:pt x="1635887" y="598297"/>
                  </a:lnTo>
                  <a:close/>
                </a:path>
                <a:path w="4132579" h="777875">
                  <a:moveTo>
                    <a:pt x="1693926" y="568325"/>
                  </a:moveTo>
                  <a:lnTo>
                    <a:pt x="1683512" y="568325"/>
                  </a:lnTo>
                  <a:lnTo>
                    <a:pt x="1683512" y="777748"/>
                  </a:lnTo>
                  <a:lnTo>
                    <a:pt x="1693926" y="777748"/>
                  </a:lnTo>
                  <a:lnTo>
                    <a:pt x="1693926" y="568325"/>
                  </a:lnTo>
                  <a:close/>
                </a:path>
                <a:path w="4132579" h="777875">
                  <a:moveTo>
                    <a:pt x="1751965" y="418846"/>
                  </a:moveTo>
                  <a:lnTo>
                    <a:pt x="1741551" y="418846"/>
                  </a:lnTo>
                  <a:lnTo>
                    <a:pt x="1741551" y="777748"/>
                  </a:lnTo>
                  <a:lnTo>
                    <a:pt x="1751965" y="777748"/>
                  </a:lnTo>
                  <a:lnTo>
                    <a:pt x="1751965" y="418846"/>
                  </a:lnTo>
                  <a:close/>
                </a:path>
                <a:path w="4132579" h="777875">
                  <a:moveTo>
                    <a:pt x="1810004" y="358902"/>
                  </a:moveTo>
                  <a:lnTo>
                    <a:pt x="1799590" y="358902"/>
                  </a:lnTo>
                  <a:lnTo>
                    <a:pt x="1799590" y="777748"/>
                  </a:lnTo>
                  <a:lnTo>
                    <a:pt x="1810004" y="777748"/>
                  </a:lnTo>
                  <a:lnTo>
                    <a:pt x="1810004" y="358902"/>
                  </a:lnTo>
                  <a:close/>
                </a:path>
                <a:path w="4132579" h="777875">
                  <a:moveTo>
                    <a:pt x="1868043" y="388874"/>
                  </a:moveTo>
                  <a:lnTo>
                    <a:pt x="1857629" y="388874"/>
                  </a:lnTo>
                  <a:lnTo>
                    <a:pt x="1857629" y="777748"/>
                  </a:lnTo>
                  <a:lnTo>
                    <a:pt x="1868043" y="777748"/>
                  </a:lnTo>
                  <a:lnTo>
                    <a:pt x="1868043" y="388874"/>
                  </a:lnTo>
                  <a:close/>
                </a:path>
                <a:path w="4132579" h="777875">
                  <a:moveTo>
                    <a:pt x="1926069" y="508508"/>
                  </a:moveTo>
                  <a:lnTo>
                    <a:pt x="1915668" y="508508"/>
                  </a:lnTo>
                  <a:lnTo>
                    <a:pt x="1915668" y="777748"/>
                  </a:lnTo>
                  <a:lnTo>
                    <a:pt x="1926069" y="777748"/>
                  </a:lnTo>
                  <a:lnTo>
                    <a:pt x="1926069" y="508508"/>
                  </a:lnTo>
                  <a:close/>
                </a:path>
                <a:path w="4132579" h="777875">
                  <a:moveTo>
                    <a:pt x="1984121" y="658114"/>
                  </a:moveTo>
                  <a:lnTo>
                    <a:pt x="1973707" y="658114"/>
                  </a:lnTo>
                  <a:lnTo>
                    <a:pt x="1973707" y="777748"/>
                  </a:lnTo>
                  <a:lnTo>
                    <a:pt x="1984121" y="777748"/>
                  </a:lnTo>
                  <a:lnTo>
                    <a:pt x="1984121" y="658114"/>
                  </a:lnTo>
                  <a:close/>
                </a:path>
                <a:path w="4132579" h="777875">
                  <a:moveTo>
                    <a:pt x="2042160" y="568325"/>
                  </a:moveTo>
                  <a:lnTo>
                    <a:pt x="2031746" y="568325"/>
                  </a:lnTo>
                  <a:lnTo>
                    <a:pt x="2031746" y="777748"/>
                  </a:lnTo>
                  <a:lnTo>
                    <a:pt x="2042160" y="777748"/>
                  </a:lnTo>
                  <a:lnTo>
                    <a:pt x="2042160" y="568325"/>
                  </a:lnTo>
                  <a:close/>
                </a:path>
                <a:path w="4132579" h="777875">
                  <a:moveTo>
                    <a:pt x="2100199" y="299085"/>
                  </a:moveTo>
                  <a:lnTo>
                    <a:pt x="2089785" y="299085"/>
                  </a:lnTo>
                  <a:lnTo>
                    <a:pt x="2089785" y="777748"/>
                  </a:lnTo>
                  <a:lnTo>
                    <a:pt x="2100199" y="777748"/>
                  </a:lnTo>
                  <a:lnTo>
                    <a:pt x="2100199" y="299085"/>
                  </a:lnTo>
                  <a:close/>
                </a:path>
                <a:path w="4132579" h="777875">
                  <a:moveTo>
                    <a:pt x="2158365" y="418846"/>
                  </a:moveTo>
                  <a:lnTo>
                    <a:pt x="2147951" y="418846"/>
                  </a:lnTo>
                  <a:lnTo>
                    <a:pt x="2147951" y="777748"/>
                  </a:lnTo>
                  <a:lnTo>
                    <a:pt x="2158365" y="777748"/>
                  </a:lnTo>
                  <a:lnTo>
                    <a:pt x="2158365" y="418846"/>
                  </a:lnTo>
                  <a:close/>
                </a:path>
                <a:path w="4132579" h="777875">
                  <a:moveTo>
                    <a:pt x="2216404" y="538480"/>
                  </a:moveTo>
                  <a:lnTo>
                    <a:pt x="2205990" y="538480"/>
                  </a:lnTo>
                  <a:lnTo>
                    <a:pt x="2205990" y="777748"/>
                  </a:lnTo>
                  <a:lnTo>
                    <a:pt x="2216404" y="777748"/>
                  </a:lnTo>
                  <a:lnTo>
                    <a:pt x="2216404" y="538480"/>
                  </a:lnTo>
                  <a:close/>
                </a:path>
                <a:path w="4132579" h="777875">
                  <a:moveTo>
                    <a:pt x="2274443" y="568325"/>
                  </a:moveTo>
                  <a:lnTo>
                    <a:pt x="2264029" y="568325"/>
                  </a:lnTo>
                  <a:lnTo>
                    <a:pt x="2264029" y="777748"/>
                  </a:lnTo>
                  <a:lnTo>
                    <a:pt x="2274443" y="777748"/>
                  </a:lnTo>
                  <a:lnTo>
                    <a:pt x="2274443" y="568325"/>
                  </a:lnTo>
                  <a:close/>
                </a:path>
                <a:path w="4132579" h="777875">
                  <a:moveTo>
                    <a:pt x="2332469" y="568325"/>
                  </a:moveTo>
                  <a:lnTo>
                    <a:pt x="2322068" y="568325"/>
                  </a:lnTo>
                  <a:lnTo>
                    <a:pt x="2322068" y="777748"/>
                  </a:lnTo>
                  <a:lnTo>
                    <a:pt x="2332469" y="777748"/>
                  </a:lnTo>
                  <a:lnTo>
                    <a:pt x="2332469" y="568325"/>
                  </a:lnTo>
                  <a:close/>
                </a:path>
                <a:path w="4132579" h="777875">
                  <a:moveTo>
                    <a:pt x="2390521" y="418846"/>
                  </a:moveTo>
                  <a:lnTo>
                    <a:pt x="2380107" y="418846"/>
                  </a:lnTo>
                  <a:lnTo>
                    <a:pt x="2380107" y="777748"/>
                  </a:lnTo>
                  <a:lnTo>
                    <a:pt x="2390521" y="777748"/>
                  </a:lnTo>
                  <a:lnTo>
                    <a:pt x="2390521" y="418846"/>
                  </a:lnTo>
                  <a:close/>
                </a:path>
                <a:path w="4132579" h="777875">
                  <a:moveTo>
                    <a:pt x="2448560" y="478663"/>
                  </a:moveTo>
                  <a:lnTo>
                    <a:pt x="2438146" y="478663"/>
                  </a:lnTo>
                  <a:lnTo>
                    <a:pt x="2438146" y="777748"/>
                  </a:lnTo>
                  <a:lnTo>
                    <a:pt x="2448560" y="777748"/>
                  </a:lnTo>
                  <a:lnTo>
                    <a:pt x="2448560" y="478663"/>
                  </a:lnTo>
                  <a:close/>
                </a:path>
                <a:path w="4132579" h="777875">
                  <a:moveTo>
                    <a:pt x="2506599" y="478663"/>
                  </a:moveTo>
                  <a:lnTo>
                    <a:pt x="2496185" y="478663"/>
                  </a:lnTo>
                  <a:lnTo>
                    <a:pt x="2496185" y="777748"/>
                  </a:lnTo>
                  <a:lnTo>
                    <a:pt x="2506599" y="777748"/>
                  </a:lnTo>
                  <a:lnTo>
                    <a:pt x="2506599" y="478663"/>
                  </a:lnTo>
                  <a:close/>
                </a:path>
                <a:path w="4132579" h="777875">
                  <a:moveTo>
                    <a:pt x="2564638" y="508508"/>
                  </a:moveTo>
                  <a:lnTo>
                    <a:pt x="2554224" y="508508"/>
                  </a:lnTo>
                  <a:lnTo>
                    <a:pt x="2554224" y="777748"/>
                  </a:lnTo>
                  <a:lnTo>
                    <a:pt x="2564638" y="777748"/>
                  </a:lnTo>
                  <a:lnTo>
                    <a:pt x="2564638" y="508508"/>
                  </a:lnTo>
                  <a:close/>
                </a:path>
                <a:path w="4132579" h="777875">
                  <a:moveTo>
                    <a:pt x="2622677" y="598297"/>
                  </a:moveTo>
                  <a:lnTo>
                    <a:pt x="2612263" y="598297"/>
                  </a:lnTo>
                  <a:lnTo>
                    <a:pt x="2612263" y="777748"/>
                  </a:lnTo>
                  <a:lnTo>
                    <a:pt x="2622677" y="777748"/>
                  </a:lnTo>
                  <a:lnTo>
                    <a:pt x="2622677" y="598297"/>
                  </a:lnTo>
                  <a:close/>
                </a:path>
                <a:path w="4132579" h="777875">
                  <a:moveTo>
                    <a:pt x="2680716" y="448691"/>
                  </a:moveTo>
                  <a:lnTo>
                    <a:pt x="2670302" y="448691"/>
                  </a:lnTo>
                  <a:lnTo>
                    <a:pt x="2670302" y="777748"/>
                  </a:lnTo>
                  <a:lnTo>
                    <a:pt x="2680716" y="777748"/>
                  </a:lnTo>
                  <a:lnTo>
                    <a:pt x="2680716" y="448691"/>
                  </a:lnTo>
                  <a:close/>
                </a:path>
                <a:path w="4132579" h="777875">
                  <a:moveTo>
                    <a:pt x="2738869" y="418846"/>
                  </a:moveTo>
                  <a:lnTo>
                    <a:pt x="2728468" y="418846"/>
                  </a:lnTo>
                  <a:lnTo>
                    <a:pt x="2728468" y="777748"/>
                  </a:lnTo>
                  <a:lnTo>
                    <a:pt x="2738869" y="777748"/>
                  </a:lnTo>
                  <a:lnTo>
                    <a:pt x="2738869" y="418846"/>
                  </a:lnTo>
                  <a:close/>
                </a:path>
                <a:path w="4132579" h="777875">
                  <a:moveTo>
                    <a:pt x="2796921" y="508508"/>
                  </a:moveTo>
                  <a:lnTo>
                    <a:pt x="2786507" y="508508"/>
                  </a:lnTo>
                  <a:lnTo>
                    <a:pt x="2786507" y="777748"/>
                  </a:lnTo>
                  <a:lnTo>
                    <a:pt x="2796921" y="777748"/>
                  </a:lnTo>
                  <a:lnTo>
                    <a:pt x="2796921" y="508508"/>
                  </a:lnTo>
                  <a:close/>
                </a:path>
                <a:path w="4132579" h="777875">
                  <a:moveTo>
                    <a:pt x="2854960" y="299085"/>
                  </a:moveTo>
                  <a:lnTo>
                    <a:pt x="2844546" y="299085"/>
                  </a:lnTo>
                  <a:lnTo>
                    <a:pt x="2844546" y="777748"/>
                  </a:lnTo>
                  <a:lnTo>
                    <a:pt x="2854960" y="777748"/>
                  </a:lnTo>
                  <a:lnTo>
                    <a:pt x="2854960" y="299085"/>
                  </a:lnTo>
                  <a:close/>
                </a:path>
                <a:path w="4132579" h="777875">
                  <a:moveTo>
                    <a:pt x="2912999" y="538480"/>
                  </a:moveTo>
                  <a:lnTo>
                    <a:pt x="2902585" y="538480"/>
                  </a:lnTo>
                  <a:lnTo>
                    <a:pt x="2902585" y="777748"/>
                  </a:lnTo>
                  <a:lnTo>
                    <a:pt x="2912999" y="777748"/>
                  </a:lnTo>
                  <a:lnTo>
                    <a:pt x="2912999" y="538480"/>
                  </a:lnTo>
                  <a:close/>
                </a:path>
                <a:path w="4132579" h="777875">
                  <a:moveTo>
                    <a:pt x="2971038" y="538480"/>
                  </a:moveTo>
                  <a:lnTo>
                    <a:pt x="2960624" y="538480"/>
                  </a:lnTo>
                  <a:lnTo>
                    <a:pt x="2960624" y="777748"/>
                  </a:lnTo>
                  <a:lnTo>
                    <a:pt x="2971038" y="777748"/>
                  </a:lnTo>
                  <a:lnTo>
                    <a:pt x="2971038" y="538480"/>
                  </a:lnTo>
                  <a:close/>
                </a:path>
                <a:path w="4132579" h="777875">
                  <a:moveTo>
                    <a:pt x="3029077" y="538480"/>
                  </a:moveTo>
                  <a:lnTo>
                    <a:pt x="3018663" y="538480"/>
                  </a:lnTo>
                  <a:lnTo>
                    <a:pt x="3018663" y="777748"/>
                  </a:lnTo>
                  <a:lnTo>
                    <a:pt x="3029077" y="777748"/>
                  </a:lnTo>
                  <a:lnTo>
                    <a:pt x="3029077" y="538480"/>
                  </a:lnTo>
                  <a:close/>
                </a:path>
                <a:path w="4132579" h="777875">
                  <a:moveTo>
                    <a:pt x="3087116" y="508508"/>
                  </a:moveTo>
                  <a:lnTo>
                    <a:pt x="3076702" y="508508"/>
                  </a:lnTo>
                  <a:lnTo>
                    <a:pt x="3076702" y="777748"/>
                  </a:lnTo>
                  <a:lnTo>
                    <a:pt x="3087116" y="777748"/>
                  </a:lnTo>
                  <a:lnTo>
                    <a:pt x="3087116" y="508508"/>
                  </a:lnTo>
                  <a:close/>
                </a:path>
                <a:path w="4132579" h="777875">
                  <a:moveTo>
                    <a:pt x="3145155" y="299085"/>
                  </a:moveTo>
                  <a:lnTo>
                    <a:pt x="3134741" y="299085"/>
                  </a:lnTo>
                  <a:lnTo>
                    <a:pt x="3134741" y="777748"/>
                  </a:lnTo>
                  <a:lnTo>
                    <a:pt x="3145155" y="777748"/>
                  </a:lnTo>
                  <a:lnTo>
                    <a:pt x="3145155" y="299085"/>
                  </a:lnTo>
                  <a:close/>
                </a:path>
                <a:path w="4132579" h="777875">
                  <a:moveTo>
                    <a:pt x="3203194" y="628142"/>
                  </a:moveTo>
                  <a:lnTo>
                    <a:pt x="3192780" y="628142"/>
                  </a:lnTo>
                  <a:lnTo>
                    <a:pt x="3192780" y="777748"/>
                  </a:lnTo>
                  <a:lnTo>
                    <a:pt x="3203194" y="777748"/>
                  </a:lnTo>
                  <a:lnTo>
                    <a:pt x="3203194" y="628142"/>
                  </a:lnTo>
                  <a:close/>
                </a:path>
                <a:path w="4132579" h="777875">
                  <a:moveTo>
                    <a:pt x="3261360" y="358902"/>
                  </a:moveTo>
                  <a:lnTo>
                    <a:pt x="3250946" y="358902"/>
                  </a:lnTo>
                  <a:lnTo>
                    <a:pt x="3250946" y="777748"/>
                  </a:lnTo>
                  <a:lnTo>
                    <a:pt x="3261360" y="777748"/>
                  </a:lnTo>
                  <a:lnTo>
                    <a:pt x="3261360" y="358902"/>
                  </a:lnTo>
                  <a:close/>
                </a:path>
                <a:path w="4132579" h="777875">
                  <a:moveTo>
                    <a:pt x="3319399" y="568325"/>
                  </a:moveTo>
                  <a:lnTo>
                    <a:pt x="3308985" y="568325"/>
                  </a:lnTo>
                  <a:lnTo>
                    <a:pt x="3308985" y="777748"/>
                  </a:lnTo>
                  <a:lnTo>
                    <a:pt x="3319399" y="777748"/>
                  </a:lnTo>
                  <a:lnTo>
                    <a:pt x="3319399" y="568325"/>
                  </a:lnTo>
                  <a:close/>
                </a:path>
                <a:path w="4132579" h="777875">
                  <a:moveTo>
                    <a:pt x="3377438" y="628142"/>
                  </a:moveTo>
                  <a:lnTo>
                    <a:pt x="3367024" y="628142"/>
                  </a:lnTo>
                  <a:lnTo>
                    <a:pt x="3367024" y="777748"/>
                  </a:lnTo>
                  <a:lnTo>
                    <a:pt x="3377438" y="777748"/>
                  </a:lnTo>
                  <a:lnTo>
                    <a:pt x="3377438" y="628142"/>
                  </a:lnTo>
                  <a:close/>
                </a:path>
                <a:path w="4132579" h="777875">
                  <a:moveTo>
                    <a:pt x="3435477" y="508508"/>
                  </a:moveTo>
                  <a:lnTo>
                    <a:pt x="3425063" y="508508"/>
                  </a:lnTo>
                  <a:lnTo>
                    <a:pt x="3425063" y="777748"/>
                  </a:lnTo>
                  <a:lnTo>
                    <a:pt x="3435477" y="777748"/>
                  </a:lnTo>
                  <a:lnTo>
                    <a:pt x="3435477" y="508508"/>
                  </a:lnTo>
                  <a:close/>
                </a:path>
                <a:path w="4132579" h="777875">
                  <a:moveTo>
                    <a:pt x="3493516" y="388874"/>
                  </a:moveTo>
                  <a:lnTo>
                    <a:pt x="3483102" y="388874"/>
                  </a:lnTo>
                  <a:lnTo>
                    <a:pt x="3483102" y="777748"/>
                  </a:lnTo>
                  <a:lnTo>
                    <a:pt x="3493516" y="777748"/>
                  </a:lnTo>
                  <a:lnTo>
                    <a:pt x="3493516" y="388874"/>
                  </a:lnTo>
                  <a:close/>
                </a:path>
                <a:path w="4132579" h="777875">
                  <a:moveTo>
                    <a:pt x="3551555" y="299085"/>
                  </a:moveTo>
                  <a:lnTo>
                    <a:pt x="3541141" y="299085"/>
                  </a:lnTo>
                  <a:lnTo>
                    <a:pt x="3541141" y="777748"/>
                  </a:lnTo>
                  <a:lnTo>
                    <a:pt x="3551555" y="777748"/>
                  </a:lnTo>
                  <a:lnTo>
                    <a:pt x="3551555" y="299085"/>
                  </a:lnTo>
                  <a:close/>
                </a:path>
                <a:path w="4132579" h="777875">
                  <a:moveTo>
                    <a:pt x="3609594" y="598297"/>
                  </a:moveTo>
                  <a:lnTo>
                    <a:pt x="3599180" y="598297"/>
                  </a:lnTo>
                  <a:lnTo>
                    <a:pt x="3599180" y="777748"/>
                  </a:lnTo>
                  <a:lnTo>
                    <a:pt x="3609594" y="777748"/>
                  </a:lnTo>
                  <a:lnTo>
                    <a:pt x="3609594" y="598297"/>
                  </a:lnTo>
                  <a:close/>
                </a:path>
                <a:path w="4132579" h="777875">
                  <a:moveTo>
                    <a:pt x="3667620" y="239268"/>
                  </a:moveTo>
                  <a:lnTo>
                    <a:pt x="3657219" y="239268"/>
                  </a:lnTo>
                  <a:lnTo>
                    <a:pt x="3657219" y="777748"/>
                  </a:lnTo>
                  <a:lnTo>
                    <a:pt x="3667620" y="777748"/>
                  </a:lnTo>
                  <a:lnTo>
                    <a:pt x="3667620" y="239268"/>
                  </a:lnTo>
                  <a:close/>
                </a:path>
                <a:path w="4132579" h="777875">
                  <a:moveTo>
                    <a:pt x="3725672" y="478663"/>
                  </a:moveTo>
                  <a:lnTo>
                    <a:pt x="3715258" y="478663"/>
                  </a:lnTo>
                  <a:lnTo>
                    <a:pt x="3715258" y="777748"/>
                  </a:lnTo>
                  <a:lnTo>
                    <a:pt x="3725672" y="777748"/>
                  </a:lnTo>
                  <a:lnTo>
                    <a:pt x="3725672" y="478663"/>
                  </a:lnTo>
                  <a:close/>
                </a:path>
                <a:path w="4132579" h="777875">
                  <a:moveTo>
                    <a:pt x="3783838" y="508508"/>
                  </a:moveTo>
                  <a:lnTo>
                    <a:pt x="3773424" y="508508"/>
                  </a:lnTo>
                  <a:lnTo>
                    <a:pt x="3773424" y="777748"/>
                  </a:lnTo>
                  <a:lnTo>
                    <a:pt x="3783838" y="777748"/>
                  </a:lnTo>
                  <a:lnTo>
                    <a:pt x="3783838" y="508508"/>
                  </a:lnTo>
                  <a:close/>
                </a:path>
                <a:path w="4132579" h="777875">
                  <a:moveTo>
                    <a:pt x="3841877" y="209423"/>
                  </a:moveTo>
                  <a:lnTo>
                    <a:pt x="3831463" y="209423"/>
                  </a:lnTo>
                  <a:lnTo>
                    <a:pt x="3831463" y="777748"/>
                  </a:lnTo>
                  <a:lnTo>
                    <a:pt x="3841877" y="777748"/>
                  </a:lnTo>
                  <a:lnTo>
                    <a:pt x="3841877" y="209423"/>
                  </a:lnTo>
                  <a:close/>
                </a:path>
                <a:path w="4132579" h="777875">
                  <a:moveTo>
                    <a:pt x="3899916" y="448691"/>
                  </a:moveTo>
                  <a:lnTo>
                    <a:pt x="3889502" y="448691"/>
                  </a:lnTo>
                  <a:lnTo>
                    <a:pt x="3889502" y="777748"/>
                  </a:lnTo>
                  <a:lnTo>
                    <a:pt x="3899916" y="777748"/>
                  </a:lnTo>
                  <a:lnTo>
                    <a:pt x="3899916" y="448691"/>
                  </a:lnTo>
                  <a:close/>
                </a:path>
                <a:path w="4132579" h="777875">
                  <a:moveTo>
                    <a:pt x="3957955" y="329057"/>
                  </a:moveTo>
                  <a:lnTo>
                    <a:pt x="3947541" y="329057"/>
                  </a:lnTo>
                  <a:lnTo>
                    <a:pt x="3947541" y="777748"/>
                  </a:lnTo>
                  <a:lnTo>
                    <a:pt x="3957955" y="777748"/>
                  </a:lnTo>
                  <a:lnTo>
                    <a:pt x="3957955" y="329057"/>
                  </a:lnTo>
                  <a:close/>
                </a:path>
                <a:path w="4132579" h="777875">
                  <a:moveTo>
                    <a:pt x="4015994" y="0"/>
                  </a:moveTo>
                  <a:lnTo>
                    <a:pt x="4005580" y="0"/>
                  </a:lnTo>
                  <a:lnTo>
                    <a:pt x="4005580" y="777748"/>
                  </a:lnTo>
                  <a:lnTo>
                    <a:pt x="4015994" y="777748"/>
                  </a:lnTo>
                  <a:lnTo>
                    <a:pt x="4015994" y="0"/>
                  </a:lnTo>
                  <a:close/>
                </a:path>
                <a:path w="4132579" h="777875">
                  <a:moveTo>
                    <a:pt x="4074020" y="538480"/>
                  </a:moveTo>
                  <a:lnTo>
                    <a:pt x="4063619" y="538480"/>
                  </a:lnTo>
                  <a:lnTo>
                    <a:pt x="4063619" y="777748"/>
                  </a:lnTo>
                  <a:lnTo>
                    <a:pt x="4074020" y="777748"/>
                  </a:lnTo>
                  <a:lnTo>
                    <a:pt x="4074020" y="538480"/>
                  </a:lnTo>
                  <a:close/>
                </a:path>
                <a:path w="4132579" h="777875">
                  <a:moveTo>
                    <a:pt x="4132072" y="478663"/>
                  </a:moveTo>
                  <a:lnTo>
                    <a:pt x="4121658" y="478663"/>
                  </a:lnTo>
                  <a:lnTo>
                    <a:pt x="4121658" y="777748"/>
                  </a:lnTo>
                  <a:lnTo>
                    <a:pt x="4132072" y="777748"/>
                  </a:lnTo>
                  <a:lnTo>
                    <a:pt x="4132072" y="478663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4" name="object 94" descr=""/>
            <p:cNvSpPr/>
            <p:nvPr/>
          </p:nvSpPr>
          <p:spPr>
            <a:xfrm>
              <a:off x="5652770" y="8064119"/>
              <a:ext cx="4074160" cy="598805"/>
            </a:xfrm>
            <a:custGeom>
              <a:avLst/>
              <a:gdLst/>
              <a:ahLst/>
              <a:cxnLst/>
              <a:rect l="l" t="t" r="r" b="b"/>
              <a:pathLst>
                <a:path w="4074159" h="598804">
                  <a:moveTo>
                    <a:pt x="10414" y="299212"/>
                  </a:moveTo>
                  <a:lnTo>
                    <a:pt x="0" y="299212"/>
                  </a:lnTo>
                  <a:lnTo>
                    <a:pt x="0" y="598297"/>
                  </a:lnTo>
                  <a:lnTo>
                    <a:pt x="10414" y="598297"/>
                  </a:lnTo>
                  <a:lnTo>
                    <a:pt x="10414" y="299212"/>
                  </a:lnTo>
                  <a:close/>
                </a:path>
                <a:path w="4074159" h="598804">
                  <a:moveTo>
                    <a:pt x="68453" y="209423"/>
                  </a:moveTo>
                  <a:lnTo>
                    <a:pt x="58039" y="209423"/>
                  </a:lnTo>
                  <a:lnTo>
                    <a:pt x="58039" y="598297"/>
                  </a:lnTo>
                  <a:lnTo>
                    <a:pt x="68453" y="598297"/>
                  </a:lnTo>
                  <a:lnTo>
                    <a:pt x="68453" y="209423"/>
                  </a:lnTo>
                  <a:close/>
                </a:path>
                <a:path w="4074159" h="598804">
                  <a:moveTo>
                    <a:pt x="126492" y="299212"/>
                  </a:moveTo>
                  <a:lnTo>
                    <a:pt x="116078" y="299212"/>
                  </a:lnTo>
                  <a:lnTo>
                    <a:pt x="116078" y="598297"/>
                  </a:lnTo>
                  <a:lnTo>
                    <a:pt x="126492" y="598297"/>
                  </a:lnTo>
                  <a:lnTo>
                    <a:pt x="126492" y="299212"/>
                  </a:lnTo>
                  <a:close/>
                </a:path>
                <a:path w="4074159" h="598804">
                  <a:moveTo>
                    <a:pt x="184531" y="329057"/>
                  </a:moveTo>
                  <a:lnTo>
                    <a:pt x="174117" y="329057"/>
                  </a:lnTo>
                  <a:lnTo>
                    <a:pt x="174117" y="598297"/>
                  </a:lnTo>
                  <a:lnTo>
                    <a:pt x="184531" y="598297"/>
                  </a:lnTo>
                  <a:lnTo>
                    <a:pt x="184531" y="329057"/>
                  </a:lnTo>
                  <a:close/>
                </a:path>
                <a:path w="4074159" h="598804">
                  <a:moveTo>
                    <a:pt x="242697" y="239395"/>
                  </a:moveTo>
                  <a:lnTo>
                    <a:pt x="232283" y="239395"/>
                  </a:lnTo>
                  <a:lnTo>
                    <a:pt x="232283" y="598297"/>
                  </a:lnTo>
                  <a:lnTo>
                    <a:pt x="242697" y="598297"/>
                  </a:lnTo>
                  <a:lnTo>
                    <a:pt x="242697" y="239395"/>
                  </a:lnTo>
                  <a:close/>
                </a:path>
                <a:path w="4074159" h="598804">
                  <a:moveTo>
                    <a:pt x="300736" y="448691"/>
                  </a:moveTo>
                  <a:lnTo>
                    <a:pt x="290322" y="448691"/>
                  </a:lnTo>
                  <a:lnTo>
                    <a:pt x="290322" y="598297"/>
                  </a:lnTo>
                  <a:lnTo>
                    <a:pt x="300736" y="598297"/>
                  </a:lnTo>
                  <a:lnTo>
                    <a:pt x="300736" y="448691"/>
                  </a:lnTo>
                  <a:close/>
                </a:path>
                <a:path w="4074159" h="598804">
                  <a:moveTo>
                    <a:pt x="358762" y="119634"/>
                  </a:moveTo>
                  <a:lnTo>
                    <a:pt x="348361" y="119634"/>
                  </a:lnTo>
                  <a:lnTo>
                    <a:pt x="348361" y="598297"/>
                  </a:lnTo>
                  <a:lnTo>
                    <a:pt x="358762" y="598297"/>
                  </a:lnTo>
                  <a:lnTo>
                    <a:pt x="358762" y="119634"/>
                  </a:lnTo>
                  <a:close/>
                </a:path>
                <a:path w="4074159" h="598804">
                  <a:moveTo>
                    <a:pt x="416814" y="508508"/>
                  </a:moveTo>
                  <a:lnTo>
                    <a:pt x="406400" y="508508"/>
                  </a:lnTo>
                  <a:lnTo>
                    <a:pt x="406400" y="598297"/>
                  </a:lnTo>
                  <a:lnTo>
                    <a:pt x="416814" y="598297"/>
                  </a:lnTo>
                  <a:lnTo>
                    <a:pt x="416814" y="508508"/>
                  </a:lnTo>
                  <a:close/>
                </a:path>
                <a:path w="4074159" h="598804">
                  <a:moveTo>
                    <a:pt x="474853" y="269240"/>
                  </a:moveTo>
                  <a:lnTo>
                    <a:pt x="464439" y="269240"/>
                  </a:lnTo>
                  <a:lnTo>
                    <a:pt x="464439" y="598297"/>
                  </a:lnTo>
                  <a:lnTo>
                    <a:pt x="474853" y="598297"/>
                  </a:lnTo>
                  <a:lnTo>
                    <a:pt x="474853" y="269240"/>
                  </a:lnTo>
                  <a:close/>
                </a:path>
                <a:path w="4074159" h="598804">
                  <a:moveTo>
                    <a:pt x="532892" y="329057"/>
                  </a:moveTo>
                  <a:lnTo>
                    <a:pt x="522478" y="329057"/>
                  </a:lnTo>
                  <a:lnTo>
                    <a:pt x="522478" y="598297"/>
                  </a:lnTo>
                  <a:lnTo>
                    <a:pt x="532892" y="598297"/>
                  </a:lnTo>
                  <a:lnTo>
                    <a:pt x="532892" y="329057"/>
                  </a:lnTo>
                  <a:close/>
                </a:path>
                <a:path w="4074159" h="598804">
                  <a:moveTo>
                    <a:pt x="590931" y="359029"/>
                  </a:moveTo>
                  <a:lnTo>
                    <a:pt x="580517" y="359029"/>
                  </a:lnTo>
                  <a:lnTo>
                    <a:pt x="580517" y="598297"/>
                  </a:lnTo>
                  <a:lnTo>
                    <a:pt x="590931" y="598297"/>
                  </a:lnTo>
                  <a:lnTo>
                    <a:pt x="590931" y="359029"/>
                  </a:lnTo>
                  <a:close/>
                </a:path>
                <a:path w="4074159" h="598804">
                  <a:moveTo>
                    <a:pt x="648970" y="359029"/>
                  </a:moveTo>
                  <a:lnTo>
                    <a:pt x="638556" y="359029"/>
                  </a:lnTo>
                  <a:lnTo>
                    <a:pt x="638556" y="598297"/>
                  </a:lnTo>
                  <a:lnTo>
                    <a:pt x="648970" y="598297"/>
                  </a:lnTo>
                  <a:lnTo>
                    <a:pt x="648970" y="359029"/>
                  </a:lnTo>
                  <a:close/>
                </a:path>
                <a:path w="4074159" h="598804">
                  <a:moveTo>
                    <a:pt x="707009" y="478663"/>
                  </a:moveTo>
                  <a:lnTo>
                    <a:pt x="696595" y="478663"/>
                  </a:lnTo>
                  <a:lnTo>
                    <a:pt x="696595" y="598297"/>
                  </a:lnTo>
                  <a:lnTo>
                    <a:pt x="707009" y="598297"/>
                  </a:lnTo>
                  <a:lnTo>
                    <a:pt x="707009" y="478663"/>
                  </a:lnTo>
                  <a:close/>
                </a:path>
                <a:path w="4074159" h="598804">
                  <a:moveTo>
                    <a:pt x="765162" y="359029"/>
                  </a:moveTo>
                  <a:lnTo>
                    <a:pt x="754761" y="359029"/>
                  </a:lnTo>
                  <a:lnTo>
                    <a:pt x="754761" y="598297"/>
                  </a:lnTo>
                  <a:lnTo>
                    <a:pt x="765162" y="598297"/>
                  </a:lnTo>
                  <a:lnTo>
                    <a:pt x="765162" y="359029"/>
                  </a:lnTo>
                  <a:close/>
                </a:path>
                <a:path w="4074159" h="598804">
                  <a:moveTo>
                    <a:pt x="823214" y="478663"/>
                  </a:moveTo>
                  <a:lnTo>
                    <a:pt x="812800" y="478663"/>
                  </a:lnTo>
                  <a:lnTo>
                    <a:pt x="812800" y="598297"/>
                  </a:lnTo>
                  <a:lnTo>
                    <a:pt x="823214" y="598297"/>
                  </a:lnTo>
                  <a:lnTo>
                    <a:pt x="823214" y="478663"/>
                  </a:lnTo>
                  <a:close/>
                </a:path>
                <a:path w="4074159" h="598804">
                  <a:moveTo>
                    <a:pt x="881253" y="179451"/>
                  </a:moveTo>
                  <a:lnTo>
                    <a:pt x="870826" y="179451"/>
                  </a:lnTo>
                  <a:lnTo>
                    <a:pt x="870826" y="598297"/>
                  </a:lnTo>
                  <a:lnTo>
                    <a:pt x="881253" y="598297"/>
                  </a:lnTo>
                  <a:lnTo>
                    <a:pt x="881253" y="179451"/>
                  </a:lnTo>
                  <a:close/>
                </a:path>
                <a:path w="4074159" h="598804">
                  <a:moveTo>
                    <a:pt x="939292" y="179451"/>
                  </a:moveTo>
                  <a:lnTo>
                    <a:pt x="928878" y="179451"/>
                  </a:lnTo>
                  <a:lnTo>
                    <a:pt x="928878" y="598297"/>
                  </a:lnTo>
                  <a:lnTo>
                    <a:pt x="939292" y="598297"/>
                  </a:lnTo>
                  <a:lnTo>
                    <a:pt x="939292" y="179451"/>
                  </a:lnTo>
                  <a:close/>
                </a:path>
                <a:path w="4074159" h="598804">
                  <a:moveTo>
                    <a:pt x="997331" y="269240"/>
                  </a:moveTo>
                  <a:lnTo>
                    <a:pt x="986904" y="269240"/>
                  </a:lnTo>
                  <a:lnTo>
                    <a:pt x="986904" y="598297"/>
                  </a:lnTo>
                  <a:lnTo>
                    <a:pt x="997331" y="598297"/>
                  </a:lnTo>
                  <a:lnTo>
                    <a:pt x="997331" y="269240"/>
                  </a:lnTo>
                  <a:close/>
                </a:path>
                <a:path w="4074159" h="598804">
                  <a:moveTo>
                    <a:pt x="1055370" y="418846"/>
                  </a:moveTo>
                  <a:lnTo>
                    <a:pt x="1044956" y="418846"/>
                  </a:lnTo>
                  <a:lnTo>
                    <a:pt x="1044956" y="598297"/>
                  </a:lnTo>
                  <a:lnTo>
                    <a:pt x="1055370" y="598297"/>
                  </a:lnTo>
                  <a:lnTo>
                    <a:pt x="1055370" y="418846"/>
                  </a:lnTo>
                  <a:close/>
                </a:path>
                <a:path w="4074159" h="598804">
                  <a:moveTo>
                    <a:pt x="1113409" y="149606"/>
                  </a:moveTo>
                  <a:lnTo>
                    <a:pt x="1102995" y="149606"/>
                  </a:lnTo>
                  <a:lnTo>
                    <a:pt x="1102995" y="598297"/>
                  </a:lnTo>
                  <a:lnTo>
                    <a:pt x="1113409" y="598297"/>
                  </a:lnTo>
                  <a:lnTo>
                    <a:pt x="1113409" y="149606"/>
                  </a:lnTo>
                  <a:close/>
                </a:path>
                <a:path w="4074159" h="598804">
                  <a:moveTo>
                    <a:pt x="1171448" y="329057"/>
                  </a:moveTo>
                  <a:lnTo>
                    <a:pt x="1161034" y="329057"/>
                  </a:lnTo>
                  <a:lnTo>
                    <a:pt x="1161034" y="598297"/>
                  </a:lnTo>
                  <a:lnTo>
                    <a:pt x="1171448" y="598297"/>
                  </a:lnTo>
                  <a:lnTo>
                    <a:pt x="1171448" y="329057"/>
                  </a:lnTo>
                  <a:close/>
                </a:path>
                <a:path w="4074159" h="598804">
                  <a:moveTo>
                    <a:pt x="1229487" y="149606"/>
                  </a:moveTo>
                  <a:lnTo>
                    <a:pt x="1219073" y="149606"/>
                  </a:lnTo>
                  <a:lnTo>
                    <a:pt x="1219073" y="598297"/>
                  </a:lnTo>
                  <a:lnTo>
                    <a:pt x="1229487" y="598297"/>
                  </a:lnTo>
                  <a:lnTo>
                    <a:pt x="1229487" y="149606"/>
                  </a:lnTo>
                  <a:close/>
                </a:path>
                <a:path w="4074159" h="598804">
                  <a:moveTo>
                    <a:pt x="1287526" y="359029"/>
                  </a:moveTo>
                  <a:lnTo>
                    <a:pt x="1277112" y="359029"/>
                  </a:lnTo>
                  <a:lnTo>
                    <a:pt x="1277112" y="598297"/>
                  </a:lnTo>
                  <a:lnTo>
                    <a:pt x="1287526" y="598297"/>
                  </a:lnTo>
                  <a:lnTo>
                    <a:pt x="1287526" y="359029"/>
                  </a:lnTo>
                  <a:close/>
                </a:path>
                <a:path w="4074159" h="598804">
                  <a:moveTo>
                    <a:pt x="1345692" y="269240"/>
                  </a:moveTo>
                  <a:lnTo>
                    <a:pt x="1335278" y="269240"/>
                  </a:lnTo>
                  <a:lnTo>
                    <a:pt x="1335278" y="598297"/>
                  </a:lnTo>
                  <a:lnTo>
                    <a:pt x="1345692" y="598297"/>
                  </a:lnTo>
                  <a:lnTo>
                    <a:pt x="1345692" y="269240"/>
                  </a:lnTo>
                  <a:close/>
                </a:path>
                <a:path w="4074159" h="598804">
                  <a:moveTo>
                    <a:pt x="1403731" y="269240"/>
                  </a:moveTo>
                  <a:lnTo>
                    <a:pt x="1393317" y="269240"/>
                  </a:lnTo>
                  <a:lnTo>
                    <a:pt x="1393317" y="598297"/>
                  </a:lnTo>
                  <a:lnTo>
                    <a:pt x="1403731" y="598297"/>
                  </a:lnTo>
                  <a:lnTo>
                    <a:pt x="1403731" y="269240"/>
                  </a:lnTo>
                  <a:close/>
                </a:path>
                <a:path w="4074159" h="598804">
                  <a:moveTo>
                    <a:pt x="1461770" y="269240"/>
                  </a:moveTo>
                  <a:lnTo>
                    <a:pt x="1451356" y="269240"/>
                  </a:lnTo>
                  <a:lnTo>
                    <a:pt x="1451356" y="598297"/>
                  </a:lnTo>
                  <a:lnTo>
                    <a:pt x="1461770" y="598297"/>
                  </a:lnTo>
                  <a:lnTo>
                    <a:pt x="1461770" y="269240"/>
                  </a:lnTo>
                  <a:close/>
                </a:path>
                <a:path w="4074159" h="598804">
                  <a:moveTo>
                    <a:pt x="1519809" y="329057"/>
                  </a:moveTo>
                  <a:lnTo>
                    <a:pt x="1509395" y="329057"/>
                  </a:lnTo>
                  <a:lnTo>
                    <a:pt x="1509395" y="598297"/>
                  </a:lnTo>
                  <a:lnTo>
                    <a:pt x="1519809" y="598297"/>
                  </a:lnTo>
                  <a:lnTo>
                    <a:pt x="1519809" y="329057"/>
                  </a:lnTo>
                  <a:close/>
                </a:path>
                <a:path w="4074159" h="598804">
                  <a:moveTo>
                    <a:pt x="1577848" y="179451"/>
                  </a:moveTo>
                  <a:lnTo>
                    <a:pt x="1567434" y="179451"/>
                  </a:lnTo>
                  <a:lnTo>
                    <a:pt x="1567434" y="598297"/>
                  </a:lnTo>
                  <a:lnTo>
                    <a:pt x="1577848" y="598297"/>
                  </a:lnTo>
                  <a:lnTo>
                    <a:pt x="1577848" y="179451"/>
                  </a:lnTo>
                  <a:close/>
                </a:path>
                <a:path w="4074159" h="598804">
                  <a:moveTo>
                    <a:pt x="1635887" y="299212"/>
                  </a:moveTo>
                  <a:lnTo>
                    <a:pt x="1625473" y="299212"/>
                  </a:lnTo>
                  <a:lnTo>
                    <a:pt x="1625473" y="598297"/>
                  </a:lnTo>
                  <a:lnTo>
                    <a:pt x="1635887" y="598297"/>
                  </a:lnTo>
                  <a:lnTo>
                    <a:pt x="1635887" y="299212"/>
                  </a:lnTo>
                  <a:close/>
                </a:path>
                <a:path w="4074159" h="598804">
                  <a:moveTo>
                    <a:pt x="1693926" y="388874"/>
                  </a:moveTo>
                  <a:lnTo>
                    <a:pt x="1683512" y="388874"/>
                  </a:lnTo>
                  <a:lnTo>
                    <a:pt x="1683512" y="598297"/>
                  </a:lnTo>
                  <a:lnTo>
                    <a:pt x="1693926" y="598297"/>
                  </a:lnTo>
                  <a:lnTo>
                    <a:pt x="1693926" y="388874"/>
                  </a:lnTo>
                  <a:close/>
                </a:path>
                <a:path w="4074159" h="598804">
                  <a:moveTo>
                    <a:pt x="1751965" y="269240"/>
                  </a:moveTo>
                  <a:lnTo>
                    <a:pt x="1741551" y="269240"/>
                  </a:lnTo>
                  <a:lnTo>
                    <a:pt x="1741551" y="598297"/>
                  </a:lnTo>
                  <a:lnTo>
                    <a:pt x="1751965" y="598297"/>
                  </a:lnTo>
                  <a:lnTo>
                    <a:pt x="1751965" y="269240"/>
                  </a:lnTo>
                  <a:close/>
                </a:path>
                <a:path w="4074159" h="598804">
                  <a:moveTo>
                    <a:pt x="1810004" y="359029"/>
                  </a:moveTo>
                  <a:lnTo>
                    <a:pt x="1799590" y="359029"/>
                  </a:lnTo>
                  <a:lnTo>
                    <a:pt x="1799590" y="598297"/>
                  </a:lnTo>
                  <a:lnTo>
                    <a:pt x="1810004" y="598297"/>
                  </a:lnTo>
                  <a:lnTo>
                    <a:pt x="1810004" y="359029"/>
                  </a:lnTo>
                  <a:close/>
                </a:path>
                <a:path w="4074159" h="598804">
                  <a:moveTo>
                    <a:pt x="1868170" y="239395"/>
                  </a:moveTo>
                  <a:lnTo>
                    <a:pt x="1857756" y="239395"/>
                  </a:lnTo>
                  <a:lnTo>
                    <a:pt x="1857756" y="598297"/>
                  </a:lnTo>
                  <a:lnTo>
                    <a:pt x="1868170" y="598297"/>
                  </a:lnTo>
                  <a:lnTo>
                    <a:pt x="1868170" y="239395"/>
                  </a:lnTo>
                  <a:close/>
                </a:path>
                <a:path w="4074159" h="598804">
                  <a:moveTo>
                    <a:pt x="1926209" y="418846"/>
                  </a:moveTo>
                  <a:lnTo>
                    <a:pt x="1915795" y="418846"/>
                  </a:lnTo>
                  <a:lnTo>
                    <a:pt x="1915795" y="598297"/>
                  </a:lnTo>
                  <a:lnTo>
                    <a:pt x="1926209" y="598297"/>
                  </a:lnTo>
                  <a:lnTo>
                    <a:pt x="1926209" y="418846"/>
                  </a:lnTo>
                  <a:close/>
                </a:path>
                <a:path w="4074159" h="598804">
                  <a:moveTo>
                    <a:pt x="1984248" y="508508"/>
                  </a:moveTo>
                  <a:lnTo>
                    <a:pt x="1973834" y="508508"/>
                  </a:lnTo>
                  <a:lnTo>
                    <a:pt x="1973834" y="598297"/>
                  </a:lnTo>
                  <a:lnTo>
                    <a:pt x="1984248" y="598297"/>
                  </a:lnTo>
                  <a:lnTo>
                    <a:pt x="1984248" y="508508"/>
                  </a:lnTo>
                  <a:close/>
                </a:path>
                <a:path w="4074159" h="598804">
                  <a:moveTo>
                    <a:pt x="2042287" y="508508"/>
                  </a:moveTo>
                  <a:lnTo>
                    <a:pt x="2031873" y="508508"/>
                  </a:lnTo>
                  <a:lnTo>
                    <a:pt x="2031873" y="598297"/>
                  </a:lnTo>
                  <a:lnTo>
                    <a:pt x="2042287" y="598297"/>
                  </a:lnTo>
                  <a:lnTo>
                    <a:pt x="2042287" y="508508"/>
                  </a:lnTo>
                  <a:close/>
                </a:path>
                <a:path w="4074159" h="598804">
                  <a:moveTo>
                    <a:pt x="2100326" y="359029"/>
                  </a:moveTo>
                  <a:lnTo>
                    <a:pt x="2089912" y="359029"/>
                  </a:lnTo>
                  <a:lnTo>
                    <a:pt x="2089912" y="598297"/>
                  </a:lnTo>
                  <a:lnTo>
                    <a:pt x="2100326" y="598297"/>
                  </a:lnTo>
                  <a:lnTo>
                    <a:pt x="2100326" y="359029"/>
                  </a:lnTo>
                  <a:close/>
                </a:path>
                <a:path w="4074159" h="598804">
                  <a:moveTo>
                    <a:pt x="2158365" y="299212"/>
                  </a:moveTo>
                  <a:lnTo>
                    <a:pt x="2147951" y="299212"/>
                  </a:lnTo>
                  <a:lnTo>
                    <a:pt x="2147951" y="598297"/>
                  </a:lnTo>
                  <a:lnTo>
                    <a:pt x="2158365" y="598297"/>
                  </a:lnTo>
                  <a:lnTo>
                    <a:pt x="2158365" y="299212"/>
                  </a:lnTo>
                  <a:close/>
                </a:path>
                <a:path w="4074159" h="598804">
                  <a:moveTo>
                    <a:pt x="2216404" y="418846"/>
                  </a:moveTo>
                  <a:lnTo>
                    <a:pt x="2205990" y="418846"/>
                  </a:lnTo>
                  <a:lnTo>
                    <a:pt x="2205990" y="598297"/>
                  </a:lnTo>
                  <a:lnTo>
                    <a:pt x="2216404" y="598297"/>
                  </a:lnTo>
                  <a:lnTo>
                    <a:pt x="2216404" y="418846"/>
                  </a:lnTo>
                  <a:close/>
                </a:path>
                <a:path w="4074159" h="598804">
                  <a:moveTo>
                    <a:pt x="2274443" y="299212"/>
                  </a:moveTo>
                  <a:lnTo>
                    <a:pt x="2264029" y="299212"/>
                  </a:lnTo>
                  <a:lnTo>
                    <a:pt x="2264029" y="598297"/>
                  </a:lnTo>
                  <a:lnTo>
                    <a:pt x="2274443" y="598297"/>
                  </a:lnTo>
                  <a:lnTo>
                    <a:pt x="2274443" y="299212"/>
                  </a:lnTo>
                  <a:close/>
                </a:path>
                <a:path w="4074159" h="598804">
                  <a:moveTo>
                    <a:pt x="2332482" y="209423"/>
                  </a:moveTo>
                  <a:lnTo>
                    <a:pt x="2322068" y="209423"/>
                  </a:lnTo>
                  <a:lnTo>
                    <a:pt x="2322068" y="598297"/>
                  </a:lnTo>
                  <a:lnTo>
                    <a:pt x="2332482" y="598297"/>
                  </a:lnTo>
                  <a:lnTo>
                    <a:pt x="2332482" y="209423"/>
                  </a:lnTo>
                  <a:close/>
                </a:path>
                <a:path w="4074159" h="598804">
                  <a:moveTo>
                    <a:pt x="2393315" y="329057"/>
                  </a:moveTo>
                  <a:lnTo>
                    <a:pt x="2380234" y="329057"/>
                  </a:lnTo>
                  <a:lnTo>
                    <a:pt x="2380234" y="598297"/>
                  </a:lnTo>
                  <a:lnTo>
                    <a:pt x="2393315" y="598297"/>
                  </a:lnTo>
                  <a:lnTo>
                    <a:pt x="2393315" y="329057"/>
                  </a:lnTo>
                  <a:close/>
                </a:path>
                <a:path w="4074159" h="598804">
                  <a:moveTo>
                    <a:pt x="2448687" y="239395"/>
                  </a:moveTo>
                  <a:lnTo>
                    <a:pt x="2438273" y="239395"/>
                  </a:lnTo>
                  <a:lnTo>
                    <a:pt x="2438273" y="598297"/>
                  </a:lnTo>
                  <a:lnTo>
                    <a:pt x="2448687" y="598297"/>
                  </a:lnTo>
                  <a:lnTo>
                    <a:pt x="2448687" y="239395"/>
                  </a:lnTo>
                  <a:close/>
                </a:path>
                <a:path w="4074159" h="598804">
                  <a:moveTo>
                    <a:pt x="2506726" y="239395"/>
                  </a:moveTo>
                  <a:lnTo>
                    <a:pt x="2496312" y="239395"/>
                  </a:lnTo>
                  <a:lnTo>
                    <a:pt x="2496312" y="598297"/>
                  </a:lnTo>
                  <a:lnTo>
                    <a:pt x="2506726" y="598297"/>
                  </a:lnTo>
                  <a:lnTo>
                    <a:pt x="2506726" y="239395"/>
                  </a:lnTo>
                  <a:close/>
                </a:path>
                <a:path w="4074159" h="598804">
                  <a:moveTo>
                    <a:pt x="2564765" y="359029"/>
                  </a:moveTo>
                  <a:lnTo>
                    <a:pt x="2554351" y="359029"/>
                  </a:lnTo>
                  <a:lnTo>
                    <a:pt x="2554351" y="598297"/>
                  </a:lnTo>
                  <a:lnTo>
                    <a:pt x="2564765" y="598297"/>
                  </a:lnTo>
                  <a:lnTo>
                    <a:pt x="2564765" y="359029"/>
                  </a:lnTo>
                  <a:close/>
                </a:path>
                <a:path w="4074159" h="598804">
                  <a:moveTo>
                    <a:pt x="2622804" y="209423"/>
                  </a:moveTo>
                  <a:lnTo>
                    <a:pt x="2612390" y="209423"/>
                  </a:lnTo>
                  <a:lnTo>
                    <a:pt x="2612390" y="598297"/>
                  </a:lnTo>
                  <a:lnTo>
                    <a:pt x="2622804" y="598297"/>
                  </a:lnTo>
                  <a:lnTo>
                    <a:pt x="2622804" y="209423"/>
                  </a:lnTo>
                  <a:close/>
                </a:path>
                <a:path w="4074159" h="598804">
                  <a:moveTo>
                    <a:pt x="2680843" y="359029"/>
                  </a:moveTo>
                  <a:lnTo>
                    <a:pt x="2670429" y="359029"/>
                  </a:lnTo>
                  <a:lnTo>
                    <a:pt x="2670429" y="598297"/>
                  </a:lnTo>
                  <a:lnTo>
                    <a:pt x="2680843" y="598297"/>
                  </a:lnTo>
                  <a:lnTo>
                    <a:pt x="2680843" y="359029"/>
                  </a:lnTo>
                  <a:close/>
                </a:path>
                <a:path w="4074159" h="598804">
                  <a:moveTo>
                    <a:pt x="2738882" y="478663"/>
                  </a:moveTo>
                  <a:lnTo>
                    <a:pt x="2728468" y="478663"/>
                  </a:lnTo>
                  <a:lnTo>
                    <a:pt x="2728468" y="598297"/>
                  </a:lnTo>
                  <a:lnTo>
                    <a:pt x="2738882" y="598297"/>
                  </a:lnTo>
                  <a:lnTo>
                    <a:pt x="2738882" y="478663"/>
                  </a:lnTo>
                  <a:close/>
                </a:path>
                <a:path w="4074159" h="598804">
                  <a:moveTo>
                    <a:pt x="2796921" y="508508"/>
                  </a:moveTo>
                  <a:lnTo>
                    <a:pt x="2786507" y="508508"/>
                  </a:lnTo>
                  <a:lnTo>
                    <a:pt x="2786507" y="598297"/>
                  </a:lnTo>
                  <a:lnTo>
                    <a:pt x="2796921" y="598297"/>
                  </a:lnTo>
                  <a:lnTo>
                    <a:pt x="2796921" y="508508"/>
                  </a:lnTo>
                  <a:close/>
                </a:path>
                <a:path w="4074159" h="598804">
                  <a:moveTo>
                    <a:pt x="2854960" y="239395"/>
                  </a:moveTo>
                  <a:lnTo>
                    <a:pt x="2844546" y="239395"/>
                  </a:lnTo>
                  <a:lnTo>
                    <a:pt x="2844546" y="598297"/>
                  </a:lnTo>
                  <a:lnTo>
                    <a:pt x="2854960" y="598297"/>
                  </a:lnTo>
                  <a:lnTo>
                    <a:pt x="2854960" y="239395"/>
                  </a:lnTo>
                  <a:close/>
                </a:path>
                <a:path w="4074159" h="598804">
                  <a:moveTo>
                    <a:pt x="2912999" y="359029"/>
                  </a:moveTo>
                  <a:lnTo>
                    <a:pt x="2902585" y="359029"/>
                  </a:lnTo>
                  <a:lnTo>
                    <a:pt x="2902585" y="598297"/>
                  </a:lnTo>
                  <a:lnTo>
                    <a:pt x="2912999" y="598297"/>
                  </a:lnTo>
                  <a:lnTo>
                    <a:pt x="2912999" y="359029"/>
                  </a:lnTo>
                  <a:close/>
                </a:path>
                <a:path w="4074159" h="598804">
                  <a:moveTo>
                    <a:pt x="2971165" y="418846"/>
                  </a:moveTo>
                  <a:lnTo>
                    <a:pt x="2960751" y="418846"/>
                  </a:lnTo>
                  <a:lnTo>
                    <a:pt x="2960751" y="598297"/>
                  </a:lnTo>
                  <a:lnTo>
                    <a:pt x="2971165" y="598297"/>
                  </a:lnTo>
                  <a:lnTo>
                    <a:pt x="2971165" y="418846"/>
                  </a:lnTo>
                  <a:close/>
                </a:path>
                <a:path w="4074159" h="598804">
                  <a:moveTo>
                    <a:pt x="3029204" y="209423"/>
                  </a:moveTo>
                  <a:lnTo>
                    <a:pt x="3018790" y="209423"/>
                  </a:lnTo>
                  <a:lnTo>
                    <a:pt x="3018790" y="598297"/>
                  </a:lnTo>
                  <a:lnTo>
                    <a:pt x="3029204" y="598297"/>
                  </a:lnTo>
                  <a:lnTo>
                    <a:pt x="3029204" y="209423"/>
                  </a:lnTo>
                  <a:close/>
                </a:path>
                <a:path w="4074159" h="598804">
                  <a:moveTo>
                    <a:pt x="3087243" y="478663"/>
                  </a:moveTo>
                  <a:lnTo>
                    <a:pt x="3076829" y="478663"/>
                  </a:lnTo>
                  <a:lnTo>
                    <a:pt x="3076829" y="598297"/>
                  </a:lnTo>
                  <a:lnTo>
                    <a:pt x="3087243" y="598297"/>
                  </a:lnTo>
                  <a:lnTo>
                    <a:pt x="3087243" y="478663"/>
                  </a:lnTo>
                  <a:close/>
                </a:path>
                <a:path w="4074159" h="598804">
                  <a:moveTo>
                    <a:pt x="3145282" y="329057"/>
                  </a:moveTo>
                  <a:lnTo>
                    <a:pt x="3134868" y="329057"/>
                  </a:lnTo>
                  <a:lnTo>
                    <a:pt x="3134868" y="598297"/>
                  </a:lnTo>
                  <a:lnTo>
                    <a:pt x="3145282" y="598297"/>
                  </a:lnTo>
                  <a:lnTo>
                    <a:pt x="3145282" y="329057"/>
                  </a:lnTo>
                  <a:close/>
                </a:path>
                <a:path w="4074159" h="598804">
                  <a:moveTo>
                    <a:pt x="3203321" y="329057"/>
                  </a:moveTo>
                  <a:lnTo>
                    <a:pt x="3192907" y="329057"/>
                  </a:lnTo>
                  <a:lnTo>
                    <a:pt x="3192907" y="598297"/>
                  </a:lnTo>
                  <a:lnTo>
                    <a:pt x="3203321" y="598297"/>
                  </a:lnTo>
                  <a:lnTo>
                    <a:pt x="3203321" y="329057"/>
                  </a:lnTo>
                  <a:close/>
                </a:path>
                <a:path w="4074159" h="598804">
                  <a:moveTo>
                    <a:pt x="3261360" y="89789"/>
                  </a:moveTo>
                  <a:lnTo>
                    <a:pt x="3250946" y="89789"/>
                  </a:lnTo>
                  <a:lnTo>
                    <a:pt x="3250946" y="598297"/>
                  </a:lnTo>
                  <a:lnTo>
                    <a:pt x="3261360" y="598297"/>
                  </a:lnTo>
                  <a:lnTo>
                    <a:pt x="3261360" y="89789"/>
                  </a:lnTo>
                  <a:close/>
                </a:path>
                <a:path w="4074159" h="598804">
                  <a:moveTo>
                    <a:pt x="3319399" y="239395"/>
                  </a:moveTo>
                  <a:lnTo>
                    <a:pt x="3308985" y="239395"/>
                  </a:lnTo>
                  <a:lnTo>
                    <a:pt x="3308985" y="598297"/>
                  </a:lnTo>
                  <a:lnTo>
                    <a:pt x="3319399" y="598297"/>
                  </a:lnTo>
                  <a:lnTo>
                    <a:pt x="3319399" y="239395"/>
                  </a:lnTo>
                  <a:close/>
                </a:path>
                <a:path w="4074159" h="598804">
                  <a:moveTo>
                    <a:pt x="3377438" y="209423"/>
                  </a:moveTo>
                  <a:lnTo>
                    <a:pt x="3367024" y="209423"/>
                  </a:lnTo>
                  <a:lnTo>
                    <a:pt x="3367024" y="598297"/>
                  </a:lnTo>
                  <a:lnTo>
                    <a:pt x="3377438" y="598297"/>
                  </a:lnTo>
                  <a:lnTo>
                    <a:pt x="3377438" y="209423"/>
                  </a:lnTo>
                  <a:close/>
                </a:path>
                <a:path w="4074159" h="598804">
                  <a:moveTo>
                    <a:pt x="3435477" y="89789"/>
                  </a:moveTo>
                  <a:lnTo>
                    <a:pt x="3425063" y="89789"/>
                  </a:lnTo>
                  <a:lnTo>
                    <a:pt x="3425063" y="598297"/>
                  </a:lnTo>
                  <a:lnTo>
                    <a:pt x="3435477" y="598297"/>
                  </a:lnTo>
                  <a:lnTo>
                    <a:pt x="3435477" y="89789"/>
                  </a:lnTo>
                  <a:close/>
                </a:path>
                <a:path w="4074159" h="598804">
                  <a:moveTo>
                    <a:pt x="3493643" y="329057"/>
                  </a:moveTo>
                  <a:lnTo>
                    <a:pt x="3483229" y="329057"/>
                  </a:lnTo>
                  <a:lnTo>
                    <a:pt x="3483229" y="598297"/>
                  </a:lnTo>
                  <a:lnTo>
                    <a:pt x="3493643" y="598297"/>
                  </a:lnTo>
                  <a:lnTo>
                    <a:pt x="3493643" y="329057"/>
                  </a:lnTo>
                  <a:close/>
                </a:path>
                <a:path w="4074159" h="598804">
                  <a:moveTo>
                    <a:pt x="3551682" y="179451"/>
                  </a:moveTo>
                  <a:lnTo>
                    <a:pt x="3541268" y="179451"/>
                  </a:lnTo>
                  <a:lnTo>
                    <a:pt x="3541268" y="598297"/>
                  </a:lnTo>
                  <a:lnTo>
                    <a:pt x="3551682" y="598297"/>
                  </a:lnTo>
                  <a:lnTo>
                    <a:pt x="3551682" y="179451"/>
                  </a:lnTo>
                  <a:close/>
                </a:path>
                <a:path w="4074159" h="598804">
                  <a:moveTo>
                    <a:pt x="3609721" y="388874"/>
                  </a:moveTo>
                  <a:lnTo>
                    <a:pt x="3599307" y="388874"/>
                  </a:lnTo>
                  <a:lnTo>
                    <a:pt x="3599307" y="598297"/>
                  </a:lnTo>
                  <a:lnTo>
                    <a:pt x="3609721" y="598297"/>
                  </a:lnTo>
                  <a:lnTo>
                    <a:pt x="3609721" y="388874"/>
                  </a:lnTo>
                  <a:close/>
                </a:path>
                <a:path w="4074159" h="598804">
                  <a:moveTo>
                    <a:pt x="3667760" y="448691"/>
                  </a:moveTo>
                  <a:lnTo>
                    <a:pt x="3657346" y="448691"/>
                  </a:lnTo>
                  <a:lnTo>
                    <a:pt x="3657346" y="598297"/>
                  </a:lnTo>
                  <a:lnTo>
                    <a:pt x="3667760" y="598297"/>
                  </a:lnTo>
                  <a:lnTo>
                    <a:pt x="3667760" y="448691"/>
                  </a:lnTo>
                  <a:close/>
                </a:path>
                <a:path w="4074159" h="598804">
                  <a:moveTo>
                    <a:pt x="3725799" y="388874"/>
                  </a:moveTo>
                  <a:lnTo>
                    <a:pt x="3715385" y="388874"/>
                  </a:lnTo>
                  <a:lnTo>
                    <a:pt x="3715385" y="598297"/>
                  </a:lnTo>
                  <a:lnTo>
                    <a:pt x="3725799" y="598297"/>
                  </a:lnTo>
                  <a:lnTo>
                    <a:pt x="3725799" y="388874"/>
                  </a:lnTo>
                  <a:close/>
                </a:path>
                <a:path w="4074159" h="598804">
                  <a:moveTo>
                    <a:pt x="3783838" y="179451"/>
                  </a:moveTo>
                  <a:lnTo>
                    <a:pt x="3773424" y="179451"/>
                  </a:lnTo>
                  <a:lnTo>
                    <a:pt x="3773424" y="598297"/>
                  </a:lnTo>
                  <a:lnTo>
                    <a:pt x="3783838" y="598297"/>
                  </a:lnTo>
                  <a:lnTo>
                    <a:pt x="3783838" y="179451"/>
                  </a:lnTo>
                  <a:close/>
                </a:path>
                <a:path w="4074159" h="598804">
                  <a:moveTo>
                    <a:pt x="3841877" y="269240"/>
                  </a:moveTo>
                  <a:lnTo>
                    <a:pt x="3831463" y="269240"/>
                  </a:lnTo>
                  <a:lnTo>
                    <a:pt x="3831463" y="598297"/>
                  </a:lnTo>
                  <a:lnTo>
                    <a:pt x="3841877" y="598297"/>
                  </a:lnTo>
                  <a:lnTo>
                    <a:pt x="3841877" y="269240"/>
                  </a:lnTo>
                  <a:close/>
                </a:path>
                <a:path w="4074159" h="598804">
                  <a:moveTo>
                    <a:pt x="3899916" y="359029"/>
                  </a:moveTo>
                  <a:lnTo>
                    <a:pt x="3889502" y="359029"/>
                  </a:lnTo>
                  <a:lnTo>
                    <a:pt x="3889502" y="598297"/>
                  </a:lnTo>
                  <a:lnTo>
                    <a:pt x="3899916" y="598297"/>
                  </a:lnTo>
                  <a:lnTo>
                    <a:pt x="3899916" y="359029"/>
                  </a:lnTo>
                  <a:close/>
                </a:path>
                <a:path w="4074159" h="598804">
                  <a:moveTo>
                    <a:pt x="3957955" y="119634"/>
                  </a:moveTo>
                  <a:lnTo>
                    <a:pt x="3947541" y="119634"/>
                  </a:lnTo>
                  <a:lnTo>
                    <a:pt x="3947541" y="598297"/>
                  </a:lnTo>
                  <a:lnTo>
                    <a:pt x="3957955" y="598297"/>
                  </a:lnTo>
                  <a:lnTo>
                    <a:pt x="3957955" y="119634"/>
                  </a:lnTo>
                  <a:close/>
                </a:path>
                <a:path w="4074159" h="598804">
                  <a:moveTo>
                    <a:pt x="4016121" y="0"/>
                  </a:moveTo>
                  <a:lnTo>
                    <a:pt x="4005707" y="0"/>
                  </a:lnTo>
                  <a:lnTo>
                    <a:pt x="4005707" y="598297"/>
                  </a:lnTo>
                  <a:lnTo>
                    <a:pt x="4016121" y="598297"/>
                  </a:lnTo>
                  <a:lnTo>
                    <a:pt x="4016121" y="0"/>
                  </a:lnTo>
                  <a:close/>
                </a:path>
                <a:path w="4074159" h="598804">
                  <a:moveTo>
                    <a:pt x="4074160" y="359029"/>
                  </a:moveTo>
                  <a:lnTo>
                    <a:pt x="4063746" y="359029"/>
                  </a:lnTo>
                  <a:lnTo>
                    <a:pt x="4063746" y="598297"/>
                  </a:lnTo>
                  <a:lnTo>
                    <a:pt x="4074160" y="598297"/>
                  </a:lnTo>
                  <a:lnTo>
                    <a:pt x="4074160" y="359029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5" name="object 95" descr=""/>
            <p:cNvSpPr/>
            <p:nvPr/>
          </p:nvSpPr>
          <p:spPr>
            <a:xfrm>
              <a:off x="9716516" y="7914640"/>
              <a:ext cx="4076700" cy="748030"/>
            </a:xfrm>
            <a:custGeom>
              <a:avLst/>
              <a:gdLst/>
              <a:ahLst/>
              <a:cxnLst/>
              <a:rect l="l" t="t" r="r" b="b"/>
              <a:pathLst>
                <a:path w="4076700" h="748029">
                  <a:moveTo>
                    <a:pt x="10414" y="508508"/>
                  </a:moveTo>
                  <a:lnTo>
                    <a:pt x="0" y="508508"/>
                  </a:lnTo>
                  <a:lnTo>
                    <a:pt x="0" y="747776"/>
                  </a:lnTo>
                  <a:lnTo>
                    <a:pt x="10414" y="747776"/>
                  </a:lnTo>
                  <a:lnTo>
                    <a:pt x="10414" y="508508"/>
                  </a:lnTo>
                  <a:close/>
                </a:path>
                <a:path w="4076700" h="748029">
                  <a:moveTo>
                    <a:pt x="68453" y="508508"/>
                  </a:moveTo>
                  <a:lnTo>
                    <a:pt x="58039" y="508508"/>
                  </a:lnTo>
                  <a:lnTo>
                    <a:pt x="58039" y="747776"/>
                  </a:lnTo>
                  <a:lnTo>
                    <a:pt x="68453" y="747776"/>
                  </a:lnTo>
                  <a:lnTo>
                    <a:pt x="68453" y="508508"/>
                  </a:lnTo>
                  <a:close/>
                </a:path>
                <a:path w="4076700" h="748029">
                  <a:moveTo>
                    <a:pt x="126492" y="628142"/>
                  </a:moveTo>
                  <a:lnTo>
                    <a:pt x="116078" y="628142"/>
                  </a:lnTo>
                  <a:lnTo>
                    <a:pt x="116078" y="747776"/>
                  </a:lnTo>
                  <a:lnTo>
                    <a:pt x="126492" y="747776"/>
                  </a:lnTo>
                  <a:lnTo>
                    <a:pt x="126492" y="628142"/>
                  </a:lnTo>
                  <a:close/>
                </a:path>
                <a:path w="4076700" h="748029">
                  <a:moveTo>
                    <a:pt x="184531" y="538353"/>
                  </a:moveTo>
                  <a:lnTo>
                    <a:pt x="174117" y="538353"/>
                  </a:lnTo>
                  <a:lnTo>
                    <a:pt x="174117" y="747776"/>
                  </a:lnTo>
                  <a:lnTo>
                    <a:pt x="184531" y="747776"/>
                  </a:lnTo>
                  <a:lnTo>
                    <a:pt x="184531" y="538353"/>
                  </a:lnTo>
                  <a:close/>
                </a:path>
                <a:path w="4076700" h="748029">
                  <a:moveTo>
                    <a:pt x="242570" y="628142"/>
                  </a:moveTo>
                  <a:lnTo>
                    <a:pt x="232156" y="628142"/>
                  </a:lnTo>
                  <a:lnTo>
                    <a:pt x="232156" y="747776"/>
                  </a:lnTo>
                  <a:lnTo>
                    <a:pt x="242570" y="747776"/>
                  </a:lnTo>
                  <a:lnTo>
                    <a:pt x="242570" y="628142"/>
                  </a:lnTo>
                  <a:close/>
                </a:path>
                <a:path w="4076700" h="748029">
                  <a:moveTo>
                    <a:pt x="300609" y="388874"/>
                  </a:moveTo>
                  <a:lnTo>
                    <a:pt x="290195" y="388874"/>
                  </a:lnTo>
                  <a:lnTo>
                    <a:pt x="290195" y="747776"/>
                  </a:lnTo>
                  <a:lnTo>
                    <a:pt x="300609" y="747776"/>
                  </a:lnTo>
                  <a:lnTo>
                    <a:pt x="300609" y="388874"/>
                  </a:lnTo>
                  <a:close/>
                </a:path>
                <a:path w="4076700" h="748029">
                  <a:moveTo>
                    <a:pt x="361315" y="478536"/>
                  </a:moveTo>
                  <a:lnTo>
                    <a:pt x="348234" y="478536"/>
                  </a:lnTo>
                  <a:lnTo>
                    <a:pt x="348234" y="747776"/>
                  </a:lnTo>
                  <a:lnTo>
                    <a:pt x="361315" y="747776"/>
                  </a:lnTo>
                  <a:lnTo>
                    <a:pt x="361315" y="478536"/>
                  </a:lnTo>
                  <a:close/>
                </a:path>
                <a:path w="4076700" h="748029">
                  <a:moveTo>
                    <a:pt x="416687" y="538353"/>
                  </a:moveTo>
                  <a:lnTo>
                    <a:pt x="406273" y="538353"/>
                  </a:lnTo>
                  <a:lnTo>
                    <a:pt x="406273" y="747776"/>
                  </a:lnTo>
                  <a:lnTo>
                    <a:pt x="416687" y="747776"/>
                  </a:lnTo>
                  <a:lnTo>
                    <a:pt x="416687" y="538353"/>
                  </a:lnTo>
                  <a:close/>
                </a:path>
                <a:path w="4076700" h="748029">
                  <a:moveTo>
                    <a:pt x="474726" y="358902"/>
                  </a:moveTo>
                  <a:lnTo>
                    <a:pt x="464312" y="358902"/>
                  </a:lnTo>
                  <a:lnTo>
                    <a:pt x="464312" y="747776"/>
                  </a:lnTo>
                  <a:lnTo>
                    <a:pt x="474726" y="747776"/>
                  </a:lnTo>
                  <a:lnTo>
                    <a:pt x="474726" y="358902"/>
                  </a:lnTo>
                  <a:close/>
                </a:path>
                <a:path w="4076700" h="748029">
                  <a:moveTo>
                    <a:pt x="532892" y="478536"/>
                  </a:moveTo>
                  <a:lnTo>
                    <a:pt x="522478" y="478536"/>
                  </a:lnTo>
                  <a:lnTo>
                    <a:pt x="522478" y="747776"/>
                  </a:lnTo>
                  <a:lnTo>
                    <a:pt x="532892" y="747776"/>
                  </a:lnTo>
                  <a:lnTo>
                    <a:pt x="532892" y="478536"/>
                  </a:lnTo>
                  <a:close/>
                </a:path>
                <a:path w="4076700" h="748029">
                  <a:moveTo>
                    <a:pt x="590931" y="269113"/>
                  </a:moveTo>
                  <a:lnTo>
                    <a:pt x="580517" y="269113"/>
                  </a:lnTo>
                  <a:lnTo>
                    <a:pt x="580517" y="747776"/>
                  </a:lnTo>
                  <a:lnTo>
                    <a:pt x="590931" y="747776"/>
                  </a:lnTo>
                  <a:lnTo>
                    <a:pt x="590931" y="269113"/>
                  </a:lnTo>
                  <a:close/>
                </a:path>
                <a:path w="4076700" h="748029">
                  <a:moveTo>
                    <a:pt x="648970" y="448691"/>
                  </a:moveTo>
                  <a:lnTo>
                    <a:pt x="638556" y="448691"/>
                  </a:lnTo>
                  <a:lnTo>
                    <a:pt x="638556" y="747776"/>
                  </a:lnTo>
                  <a:lnTo>
                    <a:pt x="648970" y="747776"/>
                  </a:lnTo>
                  <a:lnTo>
                    <a:pt x="648970" y="448691"/>
                  </a:lnTo>
                  <a:close/>
                </a:path>
                <a:path w="4076700" h="748029">
                  <a:moveTo>
                    <a:pt x="707009" y="448691"/>
                  </a:moveTo>
                  <a:lnTo>
                    <a:pt x="696595" y="448691"/>
                  </a:lnTo>
                  <a:lnTo>
                    <a:pt x="696595" y="747776"/>
                  </a:lnTo>
                  <a:lnTo>
                    <a:pt x="707009" y="747776"/>
                  </a:lnTo>
                  <a:lnTo>
                    <a:pt x="707009" y="448691"/>
                  </a:lnTo>
                  <a:close/>
                </a:path>
                <a:path w="4076700" h="748029">
                  <a:moveTo>
                    <a:pt x="765048" y="538353"/>
                  </a:moveTo>
                  <a:lnTo>
                    <a:pt x="754634" y="538353"/>
                  </a:lnTo>
                  <a:lnTo>
                    <a:pt x="754634" y="747776"/>
                  </a:lnTo>
                  <a:lnTo>
                    <a:pt x="765048" y="747776"/>
                  </a:lnTo>
                  <a:lnTo>
                    <a:pt x="765048" y="538353"/>
                  </a:lnTo>
                  <a:close/>
                </a:path>
                <a:path w="4076700" h="748029">
                  <a:moveTo>
                    <a:pt x="825754" y="388874"/>
                  </a:moveTo>
                  <a:lnTo>
                    <a:pt x="812673" y="388874"/>
                  </a:lnTo>
                  <a:lnTo>
                    <a:pt x="812673" y="747776"/>
                  </a:lnTo>
                  <a:lnTo>
                    <a:pt x="825754" y="747776"/>
                  </a:lnTo>
                  <a:lnTo>
                    <a:pt x="825754" y="388874"/>
                  </a:lnTo>
                  <a:close/>
                </a:path>
                <a:path w="4076700" h="748029">
                  <a:moveTo>
                    <a:pt x="881126" y="0"/>
                  </a:moveTo>
                  <a:lnTo>
                    <a:pt x="870712" y="0"/>
                  </a:lnTo>
                  <a:lnTo>
                    <a:pt x="870712" y="747776"/>
                  </a:lnTo>
                  <a:lnTo>
                    <a:pt x="881126" y="747776"/>
                  </a:lnTo>
                  <a:lnTo>
                    <a:pt x="881126" y="0"/>
                  </a:lnTo>
                  <a:close/>
                </a:path>
                <a:path w="4076700" h="748029">
                  <a:moveTo>
                    <a:pt x="939165" y="239268"/>
                  </a:moveTo>
                  <a:lnTo>
                    <a:pt x="928751" y="239268"/>
                  </a:lnTo>
                  <a:lnTo>
                    <a:pt x="928751" y="747776"/>
                  </a:lnTo>
                  <a:lnTo>
                    <a:pt x="939165" y="747776"/>
                  </a:lnTo>
                  <a:lnTo>
                    <a:pt x="939165" y="239268"/>
                  </a:lnTo>
                  <a:close/>
                </a:path>
                <a:path w="4076700" h="748029">
                  <a:moveTo>
                    <a:pt x="997204" y="358902"/>
                  </a:moveTo>
                  <a:lnTo>
                    <a:pt x="986790" y="358902"/>
                  </a:lnTo>
                  <a:lnTo>
                    <a:pt x="986790" y="747776"/>
                  </a:lnTo>
                  <a:lnTo>
                    <a:pt x="997204" y="747776"/>
                  </a:lnTo>
                  <a:lnTo>
                    <a:pt x="997204" y="358902"/>
                  </a:lnTo>
                  <a:close/>
                </a:path>
                <a:path w="4076700" h="748029">
                  <a:moveTo>
                    <a:pt x="1055370" y="358902"/>
                  </a:moveTo>
                  <a:lnTo>
                    <a:pt x="1044956" y="358902"/>
                  </a:lnTo>
                  <a:lnTo>
                    <a:pt x="1044956" y="747776"/>
                  </a:lnTo>
                  <a:lnTo>
                    <a:pt x="1055370" y="747776"/>
                  </a:lnTo>
                  <a:lnTo>
                    <a:pt x="1055370" y="358902"/>
                  </a:lnTo>
                  <a:close/>
                </a:path>
                <a:path w="4076700" h="748029">
                  <a:moveTo>
                    <a:pt x="1113409" y="358902"/>
                  </a:moveTo>
                  <a:lnTo>
                    <a:pt x="1102995" y="358902"/>
                  </a:lnTo>
                  <a:lnTo>
                    <a:pt x="1102995" y="747776"/>
                  </a:lnTo>
                  <a:lnTo>
                    <a:pt x="1113409" y="747776"/>
                  </a:lnTo>
                  <a:lnTo>
                    <a:pt x="1113409" y="358902"/>
                  </a:lnTo>
                  <a:close/>
                </a:path>
                <a:path w="4076700" h="748029">
                  <a:moveTo>
                    <a:pt x="1171448" y="388874"/>
                  </a:moveTo>
                  <a:lnTo>
                    <a:pt x="1161034" y="388874"/>
                  </a:lnTo>
                  <a:lnTo>
                    <a:pt x="1161034" y="747776"/>
                  </a:lnTo>
                  <a:lnTo>
                    <a:pt x="1171448" y="747776"/>
                  </a:lnTo>
                  <a:lnTo>
                    <a:pt x="1171448" y="388874"/>
                  </a:lnTo>
                  <a:close/>
                </a:path>
                <a:path w="4076700" h="748029">
                  <a:moveTo>
                    <a:pt x="1229487" y="299085"/>
                  </a:moveTo>
                  <a:lnTo>
                    <a:pt x="1219073" y="299085"/>
                  </a:lnTo>
                  <a:lnTo>
                    <a:pt x="1219073" y="747776"/>
                  </a:lnTo>
                  <a:lnTo>
                    <a:pt x="1229487" y="747776"/>
                  </a:lnTo>
                  <a:lnTo>
                    <a:pt x="1229487" y="299085"/>
                  </a:lnTo>
                  <a:close/>
                </a:path>
                <a:path w="4076700" h="748029">
                  <a:moveTo>
                    <a:pt x="1287526" y="328930"/>
                  </a:moveTo>
                  <a:lnTo>
                    <a:pt x="1277112" y="328930"/>
                  </a:lnTo>
                  <a:lnTo>
                    <a:pt x="1277112" y="747776"/>
                  </a:lnTo>
                  <a:lnTo>
                    <a:pt x="1287526" y="747776"/>
                  </a:lnTo>
                  <a:lnTo>
                    <a:pt x="1287526" y="328930"/>
                  </a:lnTo>
                  <a:close/>
                </a:path>
                <a:path w="4076700" h="748029">
                  <a:moveTo>
                    <a:pt x="1345565" y="269113"/>
                  </a:moveTo>
                  <a:lnTo>
                    <a:pt x="1335151" y="269113"/>
                  </a:lnTo>
                  <a:lnTo>
                    <a:pt x="1335151" y="747776"/>
                  </a:lnTo>
                  <a:lnTo>
                    <a:pt x="1345565" y="747776"/>
                  </a:lnTo>
                  <a:lnTo>
                    <a:pt x="1345565" y="269113"/>
                  </a:lnTo>
                  <a:close/>
                </a:path>
                <a:path w="4076700" h="748029">
                  <a:moveTo>
                    <a:pt x="1406271" y="358902"/>
                  </a:moveTo>
                  <a:lnTo>
                    <a:pt x="1393190" y="358902"/>
                  </a:lnTo>
                  <a:lnTo>
                    <a:pt x="1393190" y="747776"/>
                  </a:lnTo>
                  <a:lnTo>
                    <a:pt x="1406271" y="747776"/>
                  </a:lnTo>
                  <a:lnTo>
                    <a:pt x="1406271" y="358902"/>
                  </a:lnTo>
                  <a:close/>
                </a:path>
                <a:path w="4076700" h="748029">
                  <a:moveTo>
                    <a:pt x="1461643" y="568325"/>
                  </a:moveTo>
                  <a:lnTo>
                    <a:pt x="1451229" y="568325"/>
                  </a:lnTo>
                  <a:lnTo>
                    <a:pt x="1451229" y="747776"/>
                  </a:lnTo>
                  <a:lnTo>
                    <a:pt x="1461643" y="747776"/>
                  </a:lnTo>
                  <a:lnTo>
                    <a:pt x="1461643" y="568325"/>
                  </a:lnTo>
                  <a:close/>
                </a:path>
                <a:path w="4076700" h="748029">
                  <a:moveTo>
                    <a:pt x="1519682" y="478536"/>
                  </a:moveTo>
                  <a:lnTo>
                    <a:pt x="1509268" y="478536"/>
                  </a:lnTo>
                  <a:lnTo>
                    <a:pt x="1509268" y="747776"/>
                  </a:lnTo>
                  <a:lnTo>
                    <a:pt x="1519682" y="747776"/>
                  </a:lnTo>
                  <a:lnTo>
                    <a:pt x="1519682" y="478536"/>
                  </a:lnTo>
                  <a:close/>
                </a:path>
                <a:path w="4076700" h="748029">
                  <a:moveTo>
                    <a:pt x="1577848" y="358902"/>
                  </a:moveTo>
                  <a:lnTo>
                    <a:pt x="1567434" y="358902"/>
                  </a:lnTo>
                  <a:lnTo>
                    <a:pt x="1567434" y="747776"/>
                  </a:lnTo>
                  <a:lnTo>
                    <a:pt x="1577848" y="747776"/>
                  </a:lnTo>
                  <a:lnTo>
                    <a:pt x="1577848" y="358902"/>
                  </a:lnTo>
                  <a:close/>
                </a:path>
                <a:path w="4076700" h="748029">
                  <a:moveTo>
                    <a:pt x="1635887" y="538353"/>
                  </a:moveTo>
                  <a:lnTo>
                    <a:pt x="1625473" y="538353"/>
                  </a:lnTo>
                  <a:lnTo>
                    <a:pt x="1625473" y="747776"/>
                  </a:lnTo>
                  <a:lnTo>
                    <a:pt x="1635887" y="747776"/>
                  </a:lnTo>
                  <a:lnTo>
                    <a:pt x="1635887" y="538353"/>
                  </a:lnTo>
                  <a:close/>
                </a:path>
                <a:path w="4076700" h="748029">
                  <a:moveTo>
                    <a:pt x="1693926" y="508508"/>
                  </a:moveTo>
                  <a:lnTo>
                    <a:pt x="1683512" y="508508"/>
                  </a:lnTo>
                  <a:lnTo>
                    <a:pt x="1683512" y="747776"/>
                  </a:lnTo>
                  <a:lnTo>
                    <a:pt x="1693926" y="747776"/>
                  </a:lnTo>
                  <a:lnTo>
                    <a:pt x="1693926" y="508508"/>
                  </a:lnTo>
                  <a:close/>
                </a:path>
                <a:path w="4076700" h="748029">
                  <a:moveTo>
                    <a:pt x="1751965" y="508508"/>
                  </a:moveTo>
                  <a:lnTo>
                    <a:pt x="1741551" y="508508"/>
                  </a:lnTo>
                  <a:lnTo>
                    <a:pt x="1741551" y="747776"/>
                  </a:lnTo>
                  <a:lnTo>
                    <a:pt x="1751965" y="747776"/>
                  </a:lnTo>
                  <a:lnTo>
                    <a:pt x="1751965" y="508508"/>
                  </a:lnTo>
                  <a:close/>
                </a:path>
                <a:path w="4076700" h="748029">
                  <a:moveTo>
                    <a:pt x="1810004" y="388874"/>
                  </a:moveTo>
                  <a:lnTo>
                    <a:pt x="1799590" y="388874"/>
                  </a:lnTo>
                  <a:lnTo>
                    <a:pt x="1799590" y="747776"/>
                  </a:lnTo>
                  <a:lnTo>
                    <a:pt x="1810004" y="747776"/>
                  </a:lnTo>
                  <a:lnTo>
                    <a:pt x="1810004" y="388874"/>
                  </a:lnTo>
                  <a:close/>
                </a:path>
                <a:path w="4076700" h="748029">
                  <a:moveTo>
                    <a:pt x="1868043" y="508508"/>
                  </a:moveTo>
                  <a:lnTo>
                    <a:pt x="1857629" y="508508"/>
                  </a:lnTo>
                  <a:lnTo>
                    <a:pt x="1857629" y="747776"/>
                  </a:lnTo>
                  <a:lnTo>
                    <a:pt x="1868043" y="747776"/>
                  </a:lnTo>
                  <a:lnTo>
                    <a:pt x="1868043" y="508508"/>
                  </a:lnTo>
                  <a:close/>
                </a:path>
                <a:path w="4076700" h="748029">
                  <a:moveTo>
                    <a:pt x="1926082" y="418719"/>
                  </a:moveTo>
                  <a:lnTo>
                    <a:pt x="1915668" y="418719"/>
                  </a:lnTo>
                  <a:lnTo>
                    <a:pt x="1915668" y="747776"/>
                  </a:lnTo>
                  <a:lnTo>
                    <a:pt x="1926082" y="747776"/>
                  </a:lnTo>
                  <a:lnTo>
                    <a:pt x="1926082" y="418719"/>
                  </a:lnTo>
                  <a:close/>
                </a:path>
                <a:path w="4076700" h="748029">
                  <a:moveTo>
                    <a:pt x="1986788" y="508508"/>
                  </a:moveTo>
                  <a:lnTo>
                    <a:pt x="1973707" y="508508"/>
                  </a:lnTo>
                  <a:lnTo>
                    <a:pt x="1973707" y="747776"/>
                  </a:lnTo>
                  <a:lnTo>
                    <a:pt x="1986788" y="747776"/>
                  </a:lnTo>
                  <a:lnTo>
                    <a:pt x="1986788" y="508508"/>
                  </a:lnTo>
                  <a:close/>
                </a:path>
                <a:path w="4076700" h="748029">
                  <a:moveTo>
                    <a:pt x="2042160" y="388874"/>
                  </a:moveTo>
                  <a:lnTo>
                    <a:pt x="2031746" y="388874"/>
                  </a:lnTo>
                  <a:lnTo>
                    <a:pt x="2031746" y="747776"/>
                  </a:lnTo>
                  <a:lnTo>
                    <a:pt x="2042160" y="747776"/>
                  </a:lnTo>
                  <a:lnTo>
                    <a:pt x="2042160" y="388874"/>
                  </a:lnTo>
                  <a:close/>
                </a:path>
                <a:path w="4076700" h="748029">
                  <a:moveTo>
                    <a:pt x="2100199" y="538353"/>
                  </a:moveTo>
                  <a:lnTo>
                    <a:pt x="2089785" y="538353"/>
                  </a:lnTo>
                  <a:lnTo>
                    <a:pt x="2089785" y="747776"/>
                  </a:lnTo>
                  <a:lnTo>
                    <a:pt x="2100199" y="747776"/>
                  </a:lnTo>
                  <a:lnTo>
                    <a:pt x="2100199" y="538353"/>
                  </a:lnTo>
                  <a:close/>
                </a:path>
                <a:path w="4076700" h="748029">
                  <a:moveTo>
                    <a:pt x="2161032" y="598170"/>
                  </a:moveTo>
                  <a:lnTo>
                    <a:pt x="2147951" y="598170"/>
                  </a:lnTo>
                  <a:lnTo>
                    <a:pt x="2147951" y="747776"/>
                  </a:lnTo>
                  <a:lnTo>
                    <a:pt x="2161032" y="747776"/>
                  </a:lnTo>
                  <a:lnTo>
                    <a:pt x="2161032" y="598170"/>
                  </a:lnTo>
                  <a:close/>
                </a:path>
                <a:path w="4076700" h="748029">
                  <a:moveTo>
                    <a:pt x="2216404" y="538353"/>
                  </a:moveTo>
                  <a:lnTo>
                    <a:pt x="2205990" y="538353"/>
                  </a:lnTo>
                  <a:lnTo>
                    <a:pt x="2205990" y="747776"/>
                  </a:lnTo>
                  <a:lnTo>
                    <a:pt x="2216404" y="747776"/>
                  </a:lnTo>
                  <a:lnTo>
                    <a:pt x="2216404" y="538353"/>
                  </a:lnTo>
                  <a:close/>
                </a:path>
                <a:path w="4076700" h="748029">
                  <a:moveTo>
                    <a:pt x="2274443" y="628142"/>
                  </a:moveTo>
                  <a:lnTo>
                    <a:pt x="2264029" y="628142"/>
                  </a:lnTo>
                  <a:lnTo>
                    <a:pt x="2264029" y="747776"/>
                  </a:lnTo>
                  <a:lnTo>
                    <a:pt x="2274443" y="747776"/>
                  </a:lnTo>
                  <a:lnTo>
                    <a:pt x="2274443" y="628142"/>
                  </a:lnTo>
                  <a:close/>
                </a:path>
                <a:path w="4076700" h="748029">
                  <a:moveTo>
                    <a:pt x="2332482" y="538353"/>
                  </a:moveTo>
                  <a:lnTo>
                    <a:pt x="2322068" y="538353"/>
                  </a:lnTo>
                  <a:lnTo>
                    <a:pt x="2322068" y="747776"/>
                  </a:lnTo>
                  <a:lnTo>
                    <a:pt x="2332482" y="747776"/>
                  </a:lnTo>
                  <a:lnTo>
                    <a:pt x="2332482" y="538353"/>
                  </a:lnTo>
                  <a:close/>
                </a:path>
                <a:path w="4076700" h="748029">
                  <a:moveTo>
                    <a:pt x="2393188" y="448691"/>
                  </a:moveTo>
                  <a:lnTo>
                    <a:pt x="2380107" y="448691"/>
                  </a:lnTo>
                  <a:lnTo>
                    <a:pt x="2380107" y="747776"/>
                  </a:lnTo>
                  <a:lnTo>
                    <a:pt x="2393188" y="747776"/>
                  </a:lnTo>
                  <a:lnTo>
                    <a:pt x="2393188" y="448691"/>
                  </a:lnTo>
                  <a:close/>
                </a:path>
                <a:path w="4076700" h="748029">
                  <a:moveTo>
                    <a:pt x="2448560" y="448691"/>
                  </a:moveTo>
                  <a:lnTo>
                    <a:pt x="2438146" y="448691"/>
                  </a:lnTo>
                  <a:lnTo>
                    <a:pt x="2438146" y="747776"/>
                  </a:lnTo>
                  <a:lnTo>
                    <a:pt x="2448560" y="747776"/>
                  </a:lnTo>
                  <a:lnTo>
                    <a:pt x="2448560" y="448691"/>
                  </a:lnTo>
                  <a:close/>
                </a:path>
                <a:path w="4076700" h="748029">
                  <a:moveTo>
                    <a:pt x="2506599" y="508508"/>
                  </a:moveTo>
                  <a:lnTo>
                    <a:pt x="2496185" y="508508"/>
                  </a:lnTo>
                  <a:lnTo>
                    <a:pt x="2496185" y="747776"/>
                  </a:lnTo>
                  <a:lnTo>
                    <a:pt x="2506599" y="747776"/>
                  </a:lnTo>
                  <a:lnTo>
                    <a:pt x="2506599" y="508508"/>
                  </a:lnTo>
                  <a:close/>
                </a:path>
                <a:path w="4076700" h="748029">
                  <a:moveTo>
                    <a:pt x="2564638" y="508508"/>
                  </a:moveTo>
                  <a:lnTo>
                    <a:pt x="2554224" y="508508"/>
                  </a:lnTo>
                  <a:lnTo>
                    <a:pt x="2554224" y="747776"/>
                  </a:lnTo>
                  <a:lnTo>
                    <a:pt x="2564638" y="747776"/>
                  </a:lnTo>
                  <a:lnTo>
                    <a:pt x="2564638" y="508508"/>
                  </a:lnTo>
                  <a:close/>
                </a:path>
                <a:path w="4076700" h="748029">
                  <a:moveTo>
                    <a:pt x="2622677" y="538353"/>
                  </a:moveTo>
                  <a:lnTo>
                    <a:pt x="2612263" y="538353"/>
                  </a:lnTo>
                  <a:lnTo>
                    <a:pt x="2612263" y="747776"/>
                  </a:lnTo>
                  <a:lnTo>
                    <a:pt x="2622677" y="747776"/>
                  </a:lnTo>
                  <a:lnTo>
                    <a:pt x="2622677" y="538353"/>
                  </a:lnTo>
                  <a:close/>
                </a:path>
                <a:path w="4076700" h="748029">
                  <a:moveTo>
                    <a:pt x="2680843" y="598170"/>
                  </a:moveTo>
                  <a:lnTo>
                    <a:pt x="2670429" y="598170"/>
                  </a:lnTo>
                  <a:lnTo>
                    <a:pt x="2670429" y="747776"/>
                  </a:lnTo>
                  <a:lnTo>
                    <a:pt x="2680843" y="747776"/>
                  </a:lnTo>
                  <a:lnTo>
                    <a:pt x="2680843" y="598170"/>
                  </a:lnTo>
                  <a:close/>
                </a:path>
                <a:path w="4076700" h="748029">
                  <a:moveTo>
                    <a:pt x="2738882" y="508508"/>
                  </a:moveTo>
                  <a:lnTo>
                    <a:pt x="2728468" y="508508"/>
                  </a:lnTo>
                  <a:lnTo>
                    <a:pt x="2728468" y="747776"/>
                  </a:lnTo>
                  <a:lnTo>
                    <a:pt x="2738882" y="747776"/>
                  </a:lnTo>
                  <a:lnTo>
                    <a:pt x="2738882" y="508508"/>
                  </a:lnTo>
                  <a:close/>
                </a:path>
                <a:path w="4076700" h="748029">
                  <a:moveTo>
                    <a:pt x="2796921" y="598170"/>
                  </a:moveTo>
                  <a:lnTo>
                    <a:pt x="2786507" y="598170"/>
                  </a:lnTo>
                  <a:lnTo>
                    <a:pt x="2786507" y="747776"/>
                  </a:lnTo>
                  <a:lnTo>
                    <a:pt x="2796921" y="747776"/>
                  </a:lnTo>
                  <a:lnTo>
                    <a:pt x="2796921" y="598170"/>
                  </a:lnTo>
                  <a:close/>
                </a:path>
                <a:path w="4076700" h="748029">
                  <a:moveTo>
                    <a:pt x="2857614" y="628142"/>
                  </a:moveTo>
                  <a:lnTo>
                    <a:pt x="2844546" y="628142"/>
                  </a:lnTo>
                  <a:lnTo>
                    <a:pt x="2844546" y="747776"/>
                  </a:lnTo>
                  <a:lnTo>
                    <a:pt x="2857614" y="747776"/>
                  </a:lnTo>
                  <a:lnTo>
                    <a:pt x="2857614" y="628142"/>
                  </a:lnTo>
                  <a:close/>
                </a:path>
                <a:path w="4076700" h="748029">
                  <a:moveTo>
                    <a:pt x="2915666" y="538353"/>
                  </a:moveTo>
                  <a:lnTo>
                    <a:pt x="2902585" y="538353"/>
                  </a:lnTo>
                  <a:lnTo>
                    <a:pt x="2902585" y="747776"/>
                  </a:lnTo>
                  <a:lnTo>
                    <a:pt x="2915666" y="747776"/>
                  </a:lnTo>
                  <a:lnTo>
                    <a:pt x="2915666" y="538353"/>
                  </a:lnTo>
                  <a:close/>
                </a:path>
                <a:path w="4076700" h="748029">
                  <a:moveTo>
                    <a:pt x="2971038" y="358902"/>
                  </a:moveTo>
                  <a:lnTo>
                    <a:pt x="2960624" y="358902"/>
                  </a:lnTo>
                  <a:lnTo>
                    <a:pt x="2960624" y="747776"/>
                  </a:lnTo>
                  <a:lnTo>
                    <a:pt x="2971038" y="747776"/>
                  </a:lnTo>
                  <a:lnTo>
                    <a:pt x="2971038" y="358902"/>
                  </a:lnTo>
                  <a:close/>
                </a:path>
                <a:path w="4076700" h="748029">
                  <a:moveTo>
                    <a:pt x="3029077" y="568325"/>
                  </a:moveTo>
                  <a:lnTo>
                    <a:pt x="3018663" y="568325"/>
                  </a:lnTo>
                  <a:lnTo>
                    <a:pt x="3018663" y="747776"/>
                  </a:lnTo>
                  <a:lnTo>
                    <a:pt x="3029077" y="747776"/>
                  </a:lnTo>
                  <a:lnTo>
                    <a:pt x="3029077" y="568325"/>
                  </a:lnTo>
                  <a:close/>
                </a:path>
                <a:path w="4076700" h="748029">
                  <a:moveTo>
                    <a:pt x="3087116" y="508508"/>
                  </a:moveTo>
                  <a:lnTo>
                    <a:pt x="3076702" y="508508"/>
                  </a:lnTo>
                  <a:lnTo>
                    <a:pt x="3076702" y="747776"/>
                  </a:lnTo>
                  <a:lnTo>
                    <a:pt x="3087116" y="747776"/>
                  </a:lnTo>
                  <a:lnTo>
                    <a:pt x="3087116" y="508508"/>
                  </a:lnTo>
                  <a:close/>
                </a:path>
                <a:path w="4076700" h="748029">
                  <a:moveTo>
                    <a:pt x="3145155" y="568325"/>
                  </a:moveTo>
                  <a:lnTo>
                    <a:pt x="3134741" y="568325"/>
                  </a:lnTo>
                  <a:lnTo>
                    <a:pt x="3134741" y="747776"/>
                  </a:lnTo>
                  <a:lnTo>
                    <a:pt x="3145155" y="747776"/>
                  </a:lnTo>
                  <a:lnTo>
                    <a:pt x="3145155" y="568325"/>
                  </a:lnTo>
                  <a:close/>
                </a:path>
                <a:path w="4076700" h="748029">
                  <a:moveTo>
                    <a:pt x="3203194" y="687959"/>
                  </a:moveTo>
                  <a:lnTo>
                    <a:pt x="3192780" y="687959"/>
                  </a:lnTo>
                  <a:lnTo>
                    <a:pt x="3192780" y="747776"/>
                  </a:lnTo>
                  <a:lnTo>
                    <a:pt x="3203194" y="747776"/>
                  </a:lnTo>
                  <a:lnTo>
                    <a:pt x="3203194" y="687959"/>
                  </a:lnTo>
                  <a:close/>
                </a:path>
                <a:path w="4076700" h="748029">
                  <a:moveTo>
                    <a:pt x="3261360" y="628142"/>
                  </a:moveTo>
                  <a:lnTo>
                    <a:pt x="3250946" y="628142"/>
                  </a:lnTo>
                  <a:lnTo>
                    <a:pt x="3250946" y="747776"/>
                  </a:lnTo>
                  <a:lnTo>
                    <a:pt x="3261360" y="747776"/>
                  </a:lnTo>
                  <a:lnTo>
                    <a:pt x="3261360" y="628142"/>
                  </a:lnTo>
                  <a:close/>
                </a:path>
                <a:path w="4076700" h="748029">
                  <a:moveTo>
                    <a:pt x="3319399" y="538353"/>
                  </a:moveTo>
                  <a:lnTo>
                    <a:pt x="3308985" y="538353"/>
                  </a:lnTo>
                  <a:lnTo>
                    <a:pt x="3308985" y="747776"/>
                  </a:lnTo>
                  <a:lnTo>
                    <a:pt x="3319399" y="747776"/>
                  </a:lnTo>
                  <a:lnTo>
                    <a:pt x="3319399" y="538353"/>
                  </a:lnTo>
                  <a:close/>
                </a:path>
                <a:path w="4076700" h="748029">
                  <a:moveTo>
                    <a:pt x="3380105" y="508508"/>
                  </a:moveTo>
                  <a:lnTo>
                    <a:pt x="3367024" y="508508"/>
                  </a:lnTo>
                  <a:lnTo>
                    <a:pt x="3367024" y="747776"/>
                  </a:lnTo>
                  <a:lnTo>
                    <a:pt x="3380105" y="747776"/>
                  </a:lnTo>
                  <a:lnTo>
                    <a:pt x="3380105" y="508508"/>
                  </a:lnTo>
                  <a:close/>
                </a:path>
                <a:path w="4076700" h="748029">
                  <a:moveTo>
                    <a:pt x="3435464" y="538353"/>
                  </a:moveTo>
                  <a:lnTo>
                    <a:pt x="3425063" y="538353"/>
                  </a:lnTo>
                  <a:lnTo>
                    <a:pt x="3425063" y="747776"/>
                  </a:lnTo>
                  <a:lnTo>
                    <a:pt x="3435464" y="747776"/>
                  </a:lnTo>
                  <a:lnTo>
                    <a:pt x="3435464" y="538353"/>
                  </a:lnTo>
                  <a:close/>
                </a:path>
                <a:path w="4076700" h="748029">
                  <a:moveTo>
                    <a:pt x="3496170" y="478536"/>
                  </a:moveTo>
                  <a:lnTo>
                    <a:pt x="3483089" y="478536"/>
                  </a:lnTo>
                  <a:lnTo>
                    <a:pt x="3483089" y="747776"/>
                  </a:lnTo>
                  <a:lnTo>
                    <a:pt x="3496170" y="747776"/>
                  </a:lnTo>
                  <a:lnTo>
                    <a:pt x="3496170" y="478536"/>
                  </a:lnTo>
                  <a:close/>
                </a:path>
                <a:path w="4076700" h="748029">
                  <a:moveTo>
                    <a:pt x="3558540" y="538353"/>
                  </a:moveTo>
                  <a:lnTo>
                    <a:pt x="3541141" y="538353"/>
                  </a:lnTo>
                  <a:lnTo>
                    <a:pt x="3541141" y="747776"/>
                  </a:lnTo>
                  <a:lnTo>
                    <a:pt x="3558540" y="747776"/>
                  </a:lnTo>
                  <a:lnTo>
                    <a:pt x="3558540" y="538353"/>
                  </a:lnTo>
                  <a:close/>
                </a:path>
                <a:path w="4076700" h="748029">
                  <a:moveTo>
                    <a:pt x="3612261" y="418719"/>
                  </a:moveTo>
                  <a:lnTo>
                    <a:pt x="3599180" y="418719"/>
                  </a:lnTo>
                  <a:lnTo>
                    <a:pt x="3599180" y="747776"/>
                  </a:lnTo>
                  <a:lnTo>
                    <a:pt x="3612261" y="747776"/>
                  </a:lnTo>
                  <a:lnTo>
                    <a:pt x="3612261" y="418719"/>
                  </a:lnTo>
                  <a:close/>
                </a:path>
                <a:path w="4076700" h="748029">
                  <a:moveTo>
                    <a:pt x="3667633" y="508508"/>
                  </a:moveTo>
                  <a:lnTo>
                    <a:pt x="3657219" y="508508"/>
                  </a:lnTo>
                  <a:lnTo>
                    <a:pt x="3657219" y="747776"/>
                  </a:lnTo>
                  <a:lnTo>
                    <a:pt x="3667633" y="747776"/>
                  </a:lnTo>
                  <a:lnTo>
                    <a:pt x="3667633" y="508508"/>
                  </a:lnTo>
                  <a:close/>
                </a:path>
                <a:path w="4076700" h="748029">
                  <a:moveTo>
                    <a:pt x="3725659" y="418719"/>
                  </a:moveTo>
                  <a:lnTo>
                    <a:pt x="3715258" y="418719"/>
                  </a:lnTo>
                  <a:lnTo>
                    <a:pt x="3715258" y="747776"/>
                  </a:lnTo>
                  <a:lnTo>
                    <a:pt x="3725659" y="747776"/>
                  </a:lnTo>
                  <a:lnTo>
                    <a:pt x="3725659" y="418719"/>
                  </a:lnTo>
                  <a:close/>
                </a:path>
                <a:path w="4076700" h="748029">
                  <a:moveTo>
                    <a:pt x="3786505" y="478536"/>
                  </a:moveTo>
                  <a:lnTo>
                    <a:pt x="3773424" y="478536"/>
                  </a:lnTo>
                  <a:lnTo>
                    <a:pt x="3773424" y="747776"/>
                  </a:lnTo>
                  <a:lnTo>
                    <a:pt x="3786505" y="747776"/>
                  </a:lnTo>
                  <a:lnTo>
                    <a:pt x="3786505" y="478536"/>
                  </a:lnTo>
                  <a:close/>
                </a:path>
                <a:path w="4076700" h="748029">
                  <a:moveTo>
                    <a:pt x="3844544" y="538353"/>
                  </a:moveTo>
                  <a:lnTo>
                    <a:pt x="3831463" y="538353"/>
                  </a:lnTo>
                  <a:lnTo>
                    <a:pt x="3831463" y="747776"/>
                  </a:lnTo>
                  <a:lnTo>
                    <a:pt x="3844544" y="747776"/>
                  </a:lnTo>
                  <a:lnTo>
                    <a:pt x="3844544" y="538353"/>
                  </a:lnTo>
                  <a:close/>
                </a:path>
                <a:path w="4076700" h="748029">
                  <a:moveTo>
                    <a:pt x="3902583" y="628142"/>
                  </a:moveTo>
                  <a:lnTo>
                    <a:pt x="3889502" y="628142"/>
                  </a:lnTo>
                  <a:lnTo>
                    <a:pt x="3889502" y="747776"/>
                  </a:lnTo>
                  <a:lnTo>
                    <a:pt x="3902583" y="747776"/>
                  </a:lnTo>
                  <a:lnTo>
                    <a:pt x="3902583" y="628142"/>
                  </a:lnTo>
                  <a:close/>
                </a:path>
                <a:path w="4076700" h="748029">
                  <a:moveTo>
                    <a:pt x="3960622" y="448691"/>
                  </a:moveTo>
                  <a:lnTo>
                    <a:pt x="3947541" y="448691"/>
                  </a:lnTo>
                  <a:lnTo>
                    <a:pt x="3947541" y="747776"/>
                  </a:lnTo>
                  <a:lnTo>
                    <a:pt x="3960622" y="747776"/>
                  </a:lnTo>
                  <a:lnTo>
                    <a:pt x="3960622" y="448691"/>
                  </a:lnTo>
                  <a:close/>
                </a:path>
                <a:path w="4076700" h="748029">
                  <a:moveTo>
                    <a:pt x="4018661" y="538353"/>
                  </a:moveTo>
                  <a:lnTo>
                    <a:pt x="4005580" y="538353"/>
                  </a:lnTo>
                  <a:lnTo>
                    <a:pt x="4005580" y="747776"/>
                  </a:lnTo>
                  <a:lnTo>
                    <a:pt x="4018661" y="747776"/>
                  </a:lnTo>
                  <a:lnTo>
                    <a:pt x="4018661" y="538353"/>
                  </a:lnTo>
                  <a:close/>
                </a:path>
                <a:path w="4076700" h="748029">
                  <a:moveTo>
                    <a:pt x="4076700" y="448691"/>
                  </a:moveTo>
                  <a:lnTo>
                    <a:pt x="4063619" y="448691"/>
                  </a:lnTo>
                  <a:lnTo>
                    <a:pt x="4063619" y="747776"/>
                  </a:lnTo>
                  <a:lnTo>
                    <a:pt x="4076700" y="747776"/>
                  </a:lnTo>
                  <a:lnTo>
                    <a:pt x="4076700" y="448691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6" name="object 96" descr=""/>
            <p:cNvSpPr/>
            <p:nvPr/>
          </p:nvSpPr>
          <p:spPr>
            <a:xfrm>
              <a:off x="13780135" y="8094091"/>
              <a:ext cx="1758950" cy="568325"/>
            </a:xfrm>
            <a:custGeom>
              <a:avLst/>
              <a:gdLst/>
              <a:ahLst/>
              <a:cxnLst/>
              <a:rect l="l" t="t" r="r" b="b"/>
              <a:pathLst>
                <a:path w="1758950" h="568325">
                  <a:moveTo>
                    <a:pt x="13081" y="269240"/>
                  </a:moveTo>
                  <a:lnTo>
                    <a:pt x="0" y="269240"/>
                  </a:lnTo>
                  <a:lnTo>
                    <a:pt x="0" y="568325"/>
                  </a:lnTo>
                  <a:lnTo>
                    <a:pt x="13081" y="568325"/>
                  </a:lnTo>
                  <a:lnTo>
                    <a:pt x="13081" y="269240"/>
                  </a:lnTo>
                  <a:close/>
                </a:path>
                <a:path w="1758950" h="568325">
                  <a:moveTo>
                    <a:pt x="68440" y="329057"/>
                  </a:moveTo>
                  <a:lnTo>
                    <a:pt x="58039" y="329057"/>
                  </a:lnTo>
                  <a:lnTo>
                    <a:pt x="58039" y="568325"/>
                  </a:lnTo>
                  <a:lnTo>
                    <a:pt x="68440" y="568325"/>
                  </a:lnTo>
                  <a:lnTo>
                    <a:pt x="68440" y="329057"/>
                  </a:lnTo>
                  <a:close/>
                </a:path>
                <a:path w="1758950" h="568325">
                  <a:moveTo>
                    <a:pt x="126492" y="358902"/>
                  </a:moveTo>
                  <a:lnTo>
                    <a:pt x="116078" y="358902"/>
                  </a:lnTo>
                  <a:lnTo>
                    <a:pt x="116078" y="568325"/>
                  </a:lnTo>
                  <a:lnTo>
                    <a:pt x="126492" y="568325"/>
                  </a:lnTo>
                  <a:lnTo>
                    <a:pt x="126492" y="358902"/>
                  </a:lnTo>
                  <a:close/>
                </a:path>
                <a:path w="1758950" h="568325">
                  <a:moveTo>
                    <a:pt x="184531" y="239268"/>
                  </a:moveTo>
                  <a:lnTo>
                    <a:pt x="174117" y="239268"/>
                  </a:lnTo>
                  <a:lnTo>
                    <a:pt x="174117" y="568325"/>
                  </a:lnTo>
                  <a:lnTo>
                    <a:pt x="184531" y="568325"/>
                  </a:lnTo>
                  <a:lnTo>
                    <a:pt x="184531" y="239268"/>
                  </a:lnTo>
                  <a:close/>
                </a:path>
                <a:path w="1758950" h="568325">
                  <a:moveTo>
                    <a:pt x="242684" y="329057"/>
                  </a:moveTo>
                  <a:lnTo>
                    <a:pt x="232283" y="329057"/>
                  </a:lnTo>
                  <a:lnTo>
                    <a:pt x="232283" y="568325"/>
                  </a:lnTo>
                  <a:lnTo>
                    <a:pt x="242684" y="568325"/>
                  </a:lnTo>
                  <a:lnTo>
                    <a:pt x="242684" y="329057"/>
                  </a:lnTo>
                  <a:close/>
                </a:path>
                <a:path w="1758950" h="568325">
                  <a:moveTo>
                    <a:pt x="300736" y="299085"/>
                  </a:moveTo>
                  <a:lnTo>
                    <a:pt x="290322" y="299085"/>
                  </a:lnTo>
                  <a:lnTo>
                    <a:pt x="290322" y="568325"/>
                  </a:lnTo>
                  <a:lnTo>
                    <a:pt x="300736" y="568325"/>
                  </a:lnTo>
                  <a:lnTo>
                    <a:pt x="300736" y="299085"/>
                  </a:lnTo>
                  <a:close/>
                </a:path>
                <a:path w="1758950" h="568325">
                  <a:moveTo>
                    <a:pt x="358775" y="239268"/>
                  </a:moveTo>
                  <a:lnTo>
                    <a:pt x="348361" y="239268"/>
                  </a:lnTo>
                  <a:lnTo>
                    <a:pt x="348361" y="568325"/>
                  </a:lnTo>
                  <a:lnTo>
                    <a:pt x="358775" y="568325"/>
                  </a:lnTo>
                  <a:lnTo>
                    <a:pt x="358775" y="239268"/>
                  </a:lnTo>
                  <a:close/>
                </a:path>
                <a:path w="1758950" h="568325">
                  <a:moveTo>
                    <a:pt x="416814" y="0"/>
                  </a:moveTo>
                  <a:lnTo>
                    <a:pt x="406400" y="0"/>
                  </a:lnTo>
                  <a:lnTo>
                    <a:pt x="406400" y="568325"/>
                  </a:lnTo>
                  <a:lnTo>
                    <a:pt x="416814" y="568325"/>
                  </a:lnTo>
                  <a:lnTo>
                    <a:pt x="416814" y="0"/>
                  </a:lnTo>
                  <a:close/>
                </a:path>
                <a:path w="1758950" h="568325">
                  <a:moveTo>
                    <a:pt x="474840" y="209423"/>
                  </a:moveTo>
                  <a:lnTo>
                    <a:pt x="464439" y="209423"/>
                  </a:lnTo>
                  <a:lnTo>
                    <a:pt x="464439" y="568325"/>
                  </a:lnTo>
                  <a:lnTo>
                    <a:pt x="474840" y="568325"/>
                  </a:lnTo>
                  <a:lnTo>
                    <a:pt x="474840" y="209423"/>
                  </a:lnTo>
                  <a:close/>
                </a:path>
                <a:path w="1758950" h="568325">
                  <a:moveTo>
                    <a:pt x="535559" y="418719"/>
                  </a:moveTo>
                  <a:lnTo>
                    <a:pt x="522478" y="418719"/>
                  </a:lnTo>
                  <a:lnTo>
                    <a:pt x="522478" y="568325"/>
                  </a:lnTo>
                  <a:lnTo>
                    <a:pt x="535559" y="568325"/>
                  </a:lnTo>
                  <a:lnTo>
                    <a:pt x="535559" y="418719"/>
                  </a:lnTo>
                  <a:close/>
                </a:path>
                <a:path w="1758950" h="568325">
                  <a:moveTo>
                    <a:pt x="597903" y="478536"/>
                  </a:moveTo>
                  <a:lnTo>
                    <a:pt x="580517" y="478536"/>
                  </a:lnTo>
                  <a:lnTo>
                    <a:pt x="580517" y="568325"/>
                  </a:lnTo>
                  <a:lnTo>
                    <a:pt x="597903" y="568325"/>
                  </a:lnTo>
                  <a:lnTo>
                    <a:pt x="597903" y="478536"/>
                  </a:lnTo>
                  <a:close/>
                </a:path>
                <a:path w="1758950" h="568325">
                  <a:moveTo>
                    <a:pt x="651637" y="388874"/>
                  </a:moveTo>
                  <a:lnTo>
                    <a:pt x="638556" y="388874"/>
                  </a:lnTo>
                  <a:lnTo>
                    <a:pt x="638556" y="568325"/>
                  </a:lnTo>
                  <a:lnTo>
                    <a:pt x="651637" y="568325"/>
                  </a:lnTo>
                  <a:lnTo>
                    <a:pt x="651637" y="388874"/>
                  </a:lnTo>
                  <a:close/>
                </a:path>
                <a:path w="1758950" h="568325">
                  <a:moveTo>
                    <a:pt x="707009" y="508508"/>
                  </a:moveTo>
                  <a:lnTo>
                    <a:pt x="696595" y="508508"/>
                  </a:lnTo>
                  <a:lnTo>
                    <a:pt x="696595" y="568325"/>
                  </a:lnTo>
                  <a:lnTo>
                    <a:pt x="707009" y="568325"/>
                  </a:lnTo>
                  <a:lnTo>
                    <a:pt x="707009" y="508508"/>
                  </a:lnTo>
                  <a:close/>
                </a:path>
                <a:path w="1758950" h="568325">
                  <a:moveTo>
                    <a:pt x="765048" y="299085"/>
                  </a:moveTo>
                  <a:lnTo>
                    <a:pt x="754634" y="299085"/>
                  </a:lnTo>
                  <a:lnTo>
                    <a:pt x="754634" y="568325"/>
                  </a:lnTo>
                  <a:lnTo>
                    <a:pt x="765048" y="568325"/>
                  </a:lnTo>
                  <a:lnTo>
                    <a:pt x="765048" y="299085"/>
                  </a:lnTo>
                  <a:close/>
                </a:path>
                <a:path w="1758950" h="568325">
                  <a:moveTo>
                    <a:pt x="830186" y="478536"/>
                  </a:moveTo>
                  <a:lnTo>
                    <a:pt x="812800" y="478536"/>
                  </a:lnTo>
                  <a:lnTo>
                    <a:pt x="812800" y="568325"/>
                  </a:lnTo>
                  <a:lnTo>
                    <a:pt x="830186" y="568325"/>
                  </a:lnTo>
                  <a:lnTo>
                    <a:pt x="830186" y="478536"/>
                  </a:lnTo>
                  <a:close/>
                </a:path>
                <a:path w="1758950" h="568325">
                  <a:moveTo>
                    <a:pt x="883907" y="418719"/>
                  </a:moveTo>
                  <a:lnTo>
                    <a:pt x="870839" y="418719"/>
                  </a:lnTo>
                  <a:lnTo>
                    <a:pt x="870839" y="568325"/>
                  </a:lnTo>
                  <a:lnTo>
                    <a:pt x="883907" y="568325"/>
                  </a:lnTo>
                  <a:lnTo>
                    <a:pt x="883907" y="418719"/>
                  </a:lnTo>
                  <a:close/>
                </a:path>
                <a:path w="1758950" h="568325">
                  <a:moveTo>
                    <a:pt x="939292" y="448691"/>
                  </a:moveTo>
                  <a:lnTo>
                    <a:pt x="928878" y="448691"/>
                  </a:lnTo>
                  <a:lnTo>
                    <a:pt x="928878" y="568325"/>
                  </a:lnTo>
                  <a:lnTo>
                    <a:pt x="939292" y="568325"/>
                  </a:lnTo>
                  <a:lnTo>
                    <a:pt x="939292" y="448691"/>
                  </a:lnTo>
                  <a:close/>
                </a:path>
                <a:path w="1758950" h="568325">
                  <a:moveTo>
                    <a:pt x="999998" y="418719"/>
                  </a:moveTo>
                  <a:lnTo>
                    <a:pt x="986917" y="418719"/>
                  </a:lnTo>
                  <a:lnTo>
                    <a:pt x="986917" y="568325"/>
                  </a:lnTo>
                  <a:lnTo>
                    <a:pt x="999998" y="568325"/>
                  </a:lnTo>
                  <a:lnTo>
                    <a:pt x="999998" y="418719"/>
                  </a:lnTo>
                  <a:close/>
                </a:path>
                <a:path w="1758950" h="568325">
                  <a:moveTo>
                    <a:pt x="1055357" y="299085"/>
                  </a:moveTo>
                  <a:lnTo>
                    <a:pt x="1044956" y="299085"/>
                  </a:lnTo>
                  <a:lnTo>
                    <a:pt x="1044956" y="568325"/>
                  </a:lnTo>
                  <a:lnTo>
                    <a:pt x="1055357" y="568325"/>
                  </a:lnTo>
                  <a:lnTo>
                    <a:pt x="1055357" y="299085"/>
                  </a:lnTo>
                  <a:close/>
                </a:path>
                <a:path w="1758950" h="568325">
                  <a:moveTo>
                    <a:pt x="1120394" y="478536"/>
                  </a:moveTo>
                  <a:lnTo>
                    <a:pt x="1102995" y="478536"/>
                  </a:lnTo>
                  <a:lnTo>
                    <a:pt x="1102995" y="568325"/>
                  </a:lnTo>
                  <a:lnTo>
                    <a:pt x="1120394" y="568325"/>
                  </a:lnTo>
                  <a:lnTo>
                    <a:pt x="1120394" y="478536"/>
                  </a:lnTo>
                  <a:close/>
                </a:path>
                <a:path w="1758950" h="568325">
                  <a:moveTo>
                    <a:pt x="1174115" y="478536"/>
                  </a:moveTo>
                  <a:lnTo>
                    <a:pt x="1161034" y="478536"/>
                  </a:lnTo>
                  <a:lnTo>
                    <a:pt x="1161034" y="568325"/>
                  </a:lnTo>
                  <a:lnTo>
                    <a:pt x="1174115" y="568325"/>
                  </a:lnTo>
                  <a:lnTo>
                    <a:pt x="1174115" y="478536"/>
                  </a:lnTo>
                  <a:close/>
                </a:path>
                <a:path w="1758950" h="568325">
                  <a:moveTo>
                    <a:pt x="1232154" y="508508"/>
                  </a:moveTo>
                  <a:lnTo>
                    <a:pt x="1219073" y="508508"/>
                  </a:lnTo>
                  <a:lnTo>
                    <a:pt x="1219073" y="568325"/>
                  </a:lnTo>
                  <a:lnTo>
                    <a:pt x="1232154" y="568325"/>
                  </a:lnTo>
                  <a:lnTo>
                    <a:pt x="1232154" y="508508"/>
                  </a:lnTo>
                  <a:close/>
                </a:path>
                <a:path w="1758950" h="568325">
                  <a:moveTo>
                    <a:pt x="1294498" y="299085"/>
                  </a:moveTo>
                  <a:lnTo>
                    <a:pt x="1277112" y="299085"/>
                  </a:lnTo>
                  <a:lnTo>
                    <a:pt x="1277112" y="568325"/>
                  </a:lnTo>
                  <a:lnTo>
                    <a:pt x="1294498" y="568325"/>
                  </a:lnTo>
                  <a:lnTo>
                    <a:pt x="1294498" y="299085"/>
                  </a:lnTo>
                  <a:close/>
                </a:path>
                <a:path w="1758950" h="568325">
                  <a:moveTo>
                    <a:pt x="1348359" y="388874"/>
                  </a:moveTo>
                  <a:lnTo>
                    <a:pt x="1335278" y="388874"/>
                  </a:lnTo>
                  <a:lnTo>
                    <a:pt x="1335278" y="568325"/>
                  </a:lnTo>
                  <a:lnTo>
                    <a:pt x="1348359" y="568325"/>
                  </a:lnTo>
                  <a:lnTo>
                    <a:pt x="1348359" y="388874"/>
                  </a:lnTo>
                  <a:close/>
                </a:path>
                <a:path w="1758950" h="568325">
                  <a:moveTo>
                    <a:pt x="1406398" y="388874"/>
                  </a:moveTo>
                  <a:lnTo>
                    <a:pt x="1393317" y="388874"/>
                  </a:lnTo>
                  <a:lnTo>
                    <a:pt x="1393317" y="568325"/>
                  </a:lnTo>
                  <a:lnTo>
                    <a:pt x="1406398" y="568325"/>
                  </a:lnTo>
                  <a:lnTo>
                    <a:pt x="1406398" y="388874"/>
                  </a:lnTo>
                  <a:close/>
                </a:path>
                <a:path w="1758950" h="568325">
                  <a:moveTo>
                    <a:pt x="1477505" y="418719"/>
                  </a:moveTo>
                  <a:lnTo>
                    <a:pt x="1451356" y="418719"/>
                  </a:lnTo>
                  <a:lnTo>
                    <a:pt x="1451356" y="568325"/>
                  </a:lnTo>
                  <a:lnTo>
                    <a:pt x="1477505" y="568325"/>
                  </a:lnTo>
                  <a:lnTo>
                    <a:pt x="1477505" y="418719"/>
                  </a:lnTo>
                  <a:close/>
                </a:path>
                <a:path w="1758950" h="568325">
                  <a:moveTo>
                    <a:pt x="1522476" y="418719"/>
                  </a:moveTo>
                  <a:lnTo>
                    <a:pt x="1509395" y="418719"/>
                  </a:lnTo>
                  <a:lnTo>
                    <a:pt x="1509395" y="568325"/>
                  </a:lnTo>
                  <a:lnTo>
                    <a:pt x="1522476" y="568325"/>
                  </a:lnTo>
                  <a:lnTo>
                    <a:pt x="1522476" y="418719"/>
                  </a:lnTo>
                  <a:close/>
                </a:path>
                <a:path w="1758950" h="568325">
                  <a:moveTo>
                    <a:pt x="1580515" y="418719"/>
                  </a:moveTo>
                  <a:lnTo>
                    <a:pt x="1567434" y="418719"/>
                  </a:lnTo>
                  <a:lnTo>
                    <a:pt x="1567434" y="568325"/>
                  </a:lnTo>
                  <a:lnTo>
                    <a:pt x="1580515" y="568325"/>
                  </a:lnTo>
                  <a:lnTo>
                    <a:pt x="1580515" y="418719"/>
                  </a:lnTo>
                  <a:close/>
                </a:path>
                <a:path w="1758950" h="568325">
                  <a:moveTo>
                    <a:pt x="1642859" y="538353"/>
                  </a:moveTo>
                  <a:lnTo>
                    <a:pt x="1625473" y="538353"/>
                  </a:lnTo>
                  <a:lnTo>
                    <a:pt x="1625473" y="568325"/>
                  </a:lnTo>
                  <a:lnTo>
                    <a:pt x="1642859" y="568325"/>
                  </a:lnTo>
                  <a:lnTo>
                    <a:pt x="1642859" y="538353"/>
                  </a:lnTo>
                  <a:close/>
                </a:path>
                <a:path w="1758950" h="568325">
                  <a:moveTo>
                    <a:pt x="1700898" y="329057"/>
                  </a:moveTo>
                  <a:lnTo>
                    <a:pt x="1683512" y="329057"/>
                  </a:lnTo>
                  <a:lnTo>
                    <a:pt x="1683512" y="568325"/>
                  </a:lnTo>
                  <a:lnTo>
                    <a:pt x="1700898" y="568325"/>
                  </a:lnTo>
                  <a:lnTo>
                    <a:pt x="1700898" y="329057"/>
                  </a:lnTo>
                  <a:close/>
                </a:path>
                <a:path w="1758950" h="568325">
                  <a:moveTo>
                    <a:pt x="1758950" y="478536"/>
                  </a:moveTo>
                  <a:lnTo>
                    <a:pt x="1741551" y="478536"/>
                  </a:lnTo>
                  <a:lnTo>
                    <a:pt x="1741551" y="568325"/>
                  </a:lnTo>
                  <a:lnTo>
                    <a:pt x="1758950" y="568325"/>
                  </a:lnTo>
                  <a:lnTo>
                    <a:pt x="1758950" y="478536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7" name="object 97" descr=""/>
            <p:cNvSpPr/>
            <p:nvPr/>
          </p:nvSpPr>
          <p:spPr>
            <a:xfrm>
              <a:off x="1124712" y="7136892"/>
              <a:ext cx="4084954" cy="1525905"/>
            </a:xfrm>
            <a:custGeom>
              <a:avLst/>
              <a:gdLst/>
              <a:ahLst/>
              <a:cxnLst/>
              <a:rect l="l" t="t" r="r" b="b"/>
              <a:pathLst>
                <a:path w="4084954" h="1525904">
                  <a:moveTo>
                    <a:pt x="13081" y="1465707"/>
                  </a:moveTo>
                  <a:lnTo>
                    <a:pt x="0" y="1465707"/>
                  </a:lnTo>
                  <a:lnTo>
                    <a:pt x="0" y="1525524"/>
                  </a:lnTo>
                  <a:lnTo>
                    <a:pt x="13081" y="1525524"/>
                  </a:lnTo>
                  <a:lnTo>
                    <a:pt x="13081" y="1465707"/>
                  </a:lnTo>
                  <a:close/>
                </a:path>
                <a:path w="4084954" h="1525904">
                  <a:moveTo>
                    <a:pt x="71120" y="1435735"/>
                  </a:moveTo>
                  <a:lnTo>
                    <a:pt x="58039" y="1435735"/>
                  </a:lnTo>
                  <a:lnTo>
                    <a:pt x="58039" y="1525524"/>
                  </a:lnTo>
                  <a:lnTo>
                    <a:pt x="71120" y="1525524"/>
                  </a:lnTo>
                  <a:lnTo>
                    <a:pt x="71120" y="1435735"/>
                  </a:lnTo>
                  <a:close/>
                </a:path>
                <a:path w="4084954" h="1525904">
                  <a:moveTo>
                    <a:pt x="129159" y="1286256"/>
                  </a:moveTo>
                  <a:lnTo>
                    <a:pt x="116078" y="1286256"/>
                  </a:lnTo>
                  <a:lnTo>
                    <a:pt x="116078" y="1525524"/>
                  </a:lnTo>
                  <a:lnTo>
                    <a:pt x="129159" y="1525524"/>
                  </a:lnTo>
                  <a:lnTo>
                    <a:pt x="129159" y="1286256"/>
                  </a:lnTo>
                  <a:close/>
                </a:path>
                <a:path w="4084954" h="1525904">
                  <a:moveTo>
                    <a:pt x="187198" y="1465707"/>
                  </a:moveTo>
                  <a:lnTo>
                    <a:pt x="174117" y="1465707"/>
                  </a:lnTo>
                  <a:lnTo>
                    <a:pt x="174117" y="1525524"/>
                  </a:lnTo>
                  <a:lnTo>
                    <a:pt x="187198" y="1525524"/>
                  </a:lnTo>
                  <a:lnTo>
                    <a:pt x="187198" y="1465707"/>
                  </a:lnTo>
                  <a:close/>
                </a:path>
                <a:path w="4084954" h="1525904">
                  <a:moveTo>
                    <a:pt x="245237" y="1316101"/>
                  </a:moveTo>
                  <a:lnTo>
                    <a:pt x="232156" y="1316101"/>
                  </a:lnTo>
                  <a:lnTo>
                    <a:pt x="232156" y="1525524"/>
                  </a:lnTo>
                  <a:lnTo>
                    <a:pt x="245237" y="1525524"/>
                  </a:lnTo>
                  <a:lnTo>
                    <a:pt x="245237" y="1316101"/>
                  </a:lnTo>
                  <a:close/>
                </a:path>
                <a:path w="4084954" h="1525904">
                  <a:moveTo>
                    <a:pt x="303276" y="1465707"/>
                  </a:moveTo>
                  <a:lnTo>
                    <a:pt x="290195" y="1465707"/>
                  </a:lnTo>
                  <a:lnTo>
                    <a:pt x="290195" y="1525524"/>
                  </a:lnTo>
                  <a:lnTo>
                    <a:pt x="303276" y="1525524"/>
                  </a:lnTo>
                  <a:lnTo>
                    <a:pt x="303276" y="1465707"/>
                  </a:lnTo>
                  <a:close/>
                </a:path>
                <a:path w="4084954" h="1525904">
                  <a:moveTo>
                    <a:pt x="361315" y="1316101"/>
                  </a:moveTo>
                  <a:lnTo>
                    <a:pt x="348234" y="1316101"/>
                  </a:lnTo>
                  <a:lnTo>
                    <a:pt x="348234" y="1525524"/>
                  </a:lnTo>
                  <a:lnTo>
                    <a:pt x="361315" y="1525524"/>
                  </a:lnTo>
                  <a:lnTo>
                    <a:pt x="361315" y="1316101"/>
                  </a:lnTo>
                  <a:close/>
                </a:path>
                <a:path w="4084954" h="1525904">
                  <a:moveTo>
                    <a:pt x="427215" y="1316101"/>
                  </a:moveTo>
                  <a:lnTo>
                    <a:pt x="416814" y="1316101"/>
                  </a:lnTo>
                  <a:lnTo>
                    <a:pt x="416814" y="1525524"/>
                  </a:lnTo>
                  <a:lnTo>
                    <a:pt x="427215" y="1525524"/>
                  </a:lnTo>
                  <a:lnTo>
                    <a:pt x="427215" y="1316101"/>
                  </a:lnTo>
                  <a:close/>
                </a:path>
                <a:path w="4084954" h="1525904">
                  <a:moveTo>
                    <a:pt x="477520" y="1405890"/>
                  </a:moveTo>
                  <a:lnTo>
                    <a:pt x="464439" y="1405890"/>
                  </a:lnTo>
                  <a:lnTo>
                    <a:pt x="464439" y="1525524"/>
                  </a:lnTo>
                  <a:lnTo>
                    <a:pt x="477520" y="1525524"/>
                  </a:lnTo>
                  <a:lnTo>
                    <a:pt x="477520" y="1405890"/>
                  </a:lnTo>
                  <a:close/>
                </a:path>
                <a:path w="4084954" h="1525904">
                  <a:moveTo>
                    <a:pt x="543306" y="1286256"/>
                  </a:moveTo>
                  <a:lnTo>
                    <a:pt x="532892" y="1286256"/>
                  </a:lnTo>
                  <a:lnTo>
                    <a:pt x="532892" y="1525524"/>
                  </a:lnTo>
                  <a:lnTo>
                    <a:pt x="543306" y="1525524"/>
                  </a:lnTo>
                  <a:lnTo>
                    <a:pt x="543306" y="1286256"/>
                  </a:lnTo>
                  <a:close/>
                </a:path>
                <a:path w="4084954" h="1525904">
                  <a:moveTo>
                    <a:pt x="601345" y="1346073"/>
                  </a:moveTo>
                  <a:lnTo>
                    <a:pt x="590931" y="1346073"/>
                  </a:lnTo>
                  <a:lnTo>
                    <a:pt x="590931" y="1525524"/>
                  </a:lnTo>
                  <a:lnTo>
                    <a:pt x="601345" y="1525524"/>
                  </a:lnTo>
                  <a:lnTo>
                    <a:pt x="601345" y="1346073"/>
                  </a:lnTo>
                  <a:close/>
                </a:path>
                <a:path w="4084954" h="1525904">
                  <a:moveTo>
                    <a:pt x="659384" y="1136650"/>
                  </a:moveTo>
                  <a:lnTo>
                    <a:pt x="648970" y="1136650"/>
                  </a:lnTo>
                  <a:lnTo>
                    <a:pt x="648970" y="1525524"/>
                  </a:lnTo>
                  <a:lnTo>
                    <a:pt x="659384" y="1525524"/>
                  </a:lnTo>
                  <a:lnTo>
                    <a:pt x="659384" y="1136650"/>
                  </a:lnTo>
                  <a:close/>
                </a:path>
                <a:path w="4084954" h="1525904">
                  <a:moveTo>
                    <a:pt x="717410" y="657987"/>
                  </a:moveTo>
                  <a:lnTo>
                    <a:pt x="707009" y="657987"/>
                  </a:lnTo>
                  <a:lnTo>
                    <a:pt x="707009" y="1525524"/>
                  </a:lnTo>
                  <a:lnTo>
                    <a:pt x="717410" y="1525524"/>
                  </a:lnTo>
                  <a:lnTo>
                    <a:pt x="717410" y="657987"/>
                  </a:lnTo>
                  <a:close/>
                </a:path>
                <a:path w="4084954" h="1525904">
                  <a:moveTo>
                    <a:pt x="775462" y="598170"/>
                  </a:moveTo>
                  <a:lnTo>
                    <a:pt x="765048" y="598170"/>
                  </a:lnTo>
                  <a:lnTo>
                    <a:pt x="765048" y="1525524"/>
                  </a:lnTo>
                  <a:lnTo>
                    <a:pt x="775462" y="1525524"/>
                  </a:lnTo>
                  <a:lnTo>
                    <a:pt x="775462" y="598170"/>
                  </a:lnTo>
                  <a:close/>
                </a:path>
                <a:path w="4084954" h="1525904">
                  <a:moveTo>
                    <a:pt x="833628" y="717804"/>
                  </a:moveTo>
                  <a:lnTo>
                    <a:pt x="823214" y="717804"/>
                  </a:lnTo>
                  <a:lnTo>
                    <a:pt x="823214" y="1525524"/>
                  </a:lnTo>
                  <a:lnTo>
                    <a:pt x="833628" y="1525524"/>
                  </a:lnTo>
                  <a:lnTo>
                    <a:pt x="833628" y="717804"/>
                  </a:lnTo>
                  <a:close/>
                </a:path>
                <a:path w="4084954" h="1525904">
                  <a:moveTo>
                    <a:pt x="891654" y="448691"/>
                  </a:moveTo>
                  <a:lnTo>
                    <a:pt x="881253" y="448691"/>
                  </a:lnTo>
                  <a:lnTo>
                    <a:pt x="881253" y="1525524"/>
                  </a:lnTo>
                  <a:lnTo>
                    <a:pt x="891654" y="1525524"/>
                  </a:lnTo>
                  <a:lnTo>
                    <a:pt x="891654" y="448691"/>
                  </a:lnTo>
                  <a:close/>
                </a:path>
                <a:path w="4084954" h="1525904">
                  <a:moveTo>
                    <a:pt x="949706" y="777748"/>
                  </a:moveTo>
                  <a:lnTo>
                    <a:pt x="939292" y="777748"/>
                  </a:lnTo>
                  <a:lnTo>
                    <a:pt x="939292" y="1525524"/>
                  </a:lnTo>
                  <a:lnTo>
                    <a:pt x="949706" y="1525524"/>
                  </a:lnTo>
                  <a:lnTo>
                    <a:pt x="949706" y="777748"/>
                  </a:lnTo>
                  <a:close/>
                </a:path>
                <a:path w="4084954" h="1525904">
                  <a:moveTo>
                    <a:pt x="1007745" y="418719"/>
                  </a:moveTo>
                  <a:lnTo>
                    <a:pt x="997331" y="418719"/>
                  </a:lnTo>
                  <a:lnTo>
                    <a:pt x="997331" y="1525524"/>
                  </a:lnTo>
                  <a:lnTo>
                    <a:pt x="1007745" y="1525524"/>
                  </a:lnTo>
                  <a:lnTo>
                    <a:pt x="1007745" y="418719"/>
                  </a:lnTo>
                  <a:close/>
                </a:path>
                <a:path w="4084954" h="1525904">
                  <a:moveTo>
                    <a:pt x="1065784" y="717804"/>
                  </a:moveTo>
                  <a:lnTo>
                    <a:pt x="1055370" y="717804"/>
                  </a:lnTo>
                  <a:lnTo>
                    <a:pt x="1055370" y="1525524"/>
                  </a:lnTo>
                  <a:lnTo>
                    <a:pt x="1065784" y="1525524"/>
                  </a:lnTo>
                  <a:lnTo>
                    <a:pt x="1065784" y="717804"/>
                  </a:lnTo>
                  <a:close/>
                </a:path>
                <a:path w="4084954" h="1525904">
                  <a:moveTo>
                    <a:pt x="1123810" y="687959"/>
                  </a:moveTo>
                  <a:lnTo>
                    <a:pt x="1113409" y="687959"/>
                  </a:lnTo>
                  <a:lnTo>
                    <a:pt x="1113409" y="1525524"/>
                  </a:lnTo>
                  <a:lnTo>
                    <a:pt x="1123810" y="1525524"/>
                  </a:lnTo>
                  <a:lnTo>
                    <a:pt x="1123810" y="687959"/>
                  </a:lnTo>
                  <a:close/>
                </a:path>
                <a:path w="4084954" h="1525904">
                  <a:moveTo>
                    <a:pt x="1181862" y="418719"/>
                  </a:moveTo>
                  <a:lnTo>
                    <a:pt x="1171448" y="418719"/>
                  </a:lnTo>
                  <a:lnTo>
                    <a:pt x="1171448" y="1525524"/>
                  </a:lnTo>
                  <a:lnTo>
                    <a:pt x="1181862" y="1525524"/>
                  </a:lnTo>
                  <a:lnTo>
                    <a:pt x="1181862" y="418719"/>
                  </a:lnTo>
                  <a:close/>
                </a:path>
                <a:path w="4084954" h="1525904">
                  <a:moveTo>
                    <a:pt x="1239901" y="657987"/>
                  </a:moveTo>
                  <a:lnTo>
                    <a:pt x="1229487" y="657987"/>
                  </a:lnTo>
                  <a:lnTo>
                    <a:pt x="1229487" y="1525524"/>
                  </a:lnTo>
                  <a:lnTo>
                    <a:pt x="1239901" y="1525524"/>
                  </a:lnTo>
                  <a:lnTo>
                    <a:pt x="1239901" y="657987"/>
                  </a:lnTo>
                  <a:close/>
                </a:path>
                <a:path w="4084954" h="1525904">
                  <a:moveTo>
                    <a:pt x="1297940" y="209296"/>
                  </a:moveTo>
                  <a:lnTo>
                    <a:pt x="1287526" y="209296"/>
                  </a:lnTo>
                  <a:lnTo>
                    <a:pt x="1287526" y="1525524"/>
                  </a:lnTo>
                  <a:lnTo>
                    <a:pt x="1297940" y="1525524"/>
                  </a:lnTo>
                  <a:lnTo>
                    <a:pt x="1297940" y="209296"/>
                  </a:lnTo>
                  <a:close/>
                </a:path>
                <a:path w="4084954" h="1525904">
                  <a:moveTo>
                    <a:pt x="1356106" y="867410"/>
                  </a:moveTo>
                  <a:lnTo>
                    <a:pt x="1345692" y="867410"/>
                  </a:lnTo>
                  <a:lnTo>
                    <a:pt x="1345692" y="1525524"/>
                  </a:lnTo>
                  <a:lnTo>
                    <a:pt x="1356106" y="1525524"/>
                  </a:lnTo>
                  <a:lnTo>
                    <a:pt x="1356106" y="867410"/>
                  </a:lnTo>
                  <a:close/>
                </a:path>
                <a:path w="4084954" h="1525904">
                  <a:moveTo>
                    <a:pt x="1414145" y="717804"/>
                  </a:moveTo>
                  <a:lnTo>
                    <a:pt x="1403731" y="717804"/>
                  </a:lnTo>
                  <a:lnTo>
                    <a:pt x="1403731" y="1525524"/>
                  </a:lnTo>
                  <a:lnTo>
                    <a:pt x="1414145" y="1525524"/>
                  </a:lnTo>
                  <a:lnTo>
                    <a:pt x="1414145" y="717804"/>
                  </a:lnTo>
                  <a:close/>
                </a:path>
                <a:path w="4084954" h="1525904">
                  <a:moveTo>
                    <a:pt x="1472184" y="388874"/>
                  </a:moveTo>
                  <a:lnTo>
                    <a:pt x="1461770" y="388874"/>
                  </a:lnTo>
                  <a:lnTo>
                    <a:pt x="1461770" y="1525524"/>
                  </a:lnTo>
                  <a:lnTo>
                    <a:pt x="1472184" y="1525524"/>
                  </a:lnTo>
                  <a:lnTo>
                    <a:pt x="1472184" y="388874"/>
                  </a:lnTo>
                  <a:close/>
                </a:path>
                <a:path w="4084954" h="1525904">
                  <a:moveTo>
                    <a:pt x="1530210" y="538353"/>
                  </a:moveTo>
                  <a:lnTo>
                    <a:pt x="1519809" y="538353"/>
                  </a:lnTo>
                  <a:lnTo>
                    <a:pt x="1519809" y="1525524"/>
                  </a:lnTo>
                  <a:lnTo>
                    <a:pt x="1530210" y="1525524"/>
                  </a:lnTo>
                  <a:lnTo>
                    <a:pt x="1530210" y="538353"/>
                  </a:lnTo>
                  <a:close/>
                </a:path>
                <a:path w="4084954" h="1525904">
                  <a:moveTo>
                    <a:pt x="1588262" y="418719"/>
                  </a:moveTo>
                  <a:lnTo>
                    <a:pt x="1577848" y="418719"/>
                  </a:lnTo>
                  <a:lnTo>
                    <a:pt x="1577848" y="1525524"/>
                  </a:lnTo>
                  <a:lnTo>
                    <a:pt x="1588262" y="1525524"/>
                  </a:lnTo>
                  <a:lnTo>
                    <a:pt x="1588262" y="418719"/>
                  </a:lnTo>
                  <a:close/>
                </a:path>
                <a:path w="4084954" h="1525904">
                  <a:moveTo>
                    <a:pt x="1646301" y="538353"/>
                  </a:moveTo>
                  <a:lnTo>
                    <a:pt x="1635887" y="538353"/>
                  </a:lnTo>
                  <a:lnTo>
                    <a:pt x="1635887" y="1525524"/>
                  </a:lnTo>
                  <a:lnTo>
                    <a:pt x="1646301" y="1525524"/>
                  </a:lnTo>
                  <a:lnTo>
                    <a:pt x="1646301" y="538353"/>
                  </a:lnTo>
                  <a:close/>
                </a:path>
                <a:path w="4084954" h="1525904">
                  <a:moveTo>
                    <a:pt x="1704340" y="867410"/>
                  </a:moveTo>
                  <a:lnTo>
                    <a:pt x="1693926" y="867410"/>
                  </a:lnTo>
                  <a:lnTo>
                    <a:pt x="1693926" y="1525524"/>
                  </a:lnTo>
                  <a:lnTo>
                    <a:pt x="1704340" y="1525524"/>
                  </a:lnTo>
                  <a:lnTo>
                    <a:pt x="1704340" y="867410"/>
                  </a:lnTo>
                  <a:close/>
                </a:path>
                <a:path w="4084954" h="1525904">
                  <a:moveTo>
                    <a:pt x="1762366" y="598170"/>
                  </a:moveTo>
                  <a:lnTo>
                    <a:pt x="1751965" y="598170"/>
                  </a:lnTo>
                  <a:lnTo>
                    <a:pt x="1751965" y="1525524"/>
                  </a:lnTo>
                  <a:lnTo>
                    <a:pt x="1762366" y="1525524"/>
                  </a:lnTo>
                  <a:lnTo>
                    <a:pt x="1762366" y="598170"/>
                  </a:lnTo>
                  <a:close/>
                </a:path>
                <a:path w="4084954" h="1525904">
                  <a:moveTo>
                    <a:pt x="1820418" y="508508"/>
                  </a:moveTo>
                  <a:lnTo>
                    <a:pt x="1810004" y="508508"/>
                  </a:lnTo>
                  <a:lnTo>
                    <a:pt x="1810004" y="1525524"/>
                  </a:lnTo>
                  <a:lnTo>
                    <a:pt x="1820418" y="1525524"/>
                  </a:lnTo>
                  <a:lnTo>
                    <a:pt x="1820418" y="508508"/>
                  </a:lnTo>
                  <a:close/>
                </a:path>
                <a:path w="4084954" h="1525904">
                  <a:moveTo>
                    <a:pt x="1878584" y="269113"/>
                  </a:moveTo>
                  <a:lnTo>
                    <a:pt x="1868170" y="269113"/>
                  </a:lnTo>
                  <a:lnTo>
                    <a:pt x="1868170" y="1525524"/>
                  </a:lnTo>
                  <a:lnTo>
                    <a:pt x="1878584" y="1525524"/>
                  </a:lnTo>
                  <a:lnTo>
                    <a:pt x="1878584" y="269113"/>
                  </a:lnTo>
                  <a:close/>
                </a:path>
                <a:path w="4084954" h="1525904">
                  <a:moveTo>
                    <a:pt x="1936610" y="269113"/>
                  </a:moveTo>
                  <a:lnTo>
                    <a:pt x="1926209" y="269113"/>
                  </a:lnTo>
                  <a:lnTo>
                    <a:pt x="1926209" y="1525524"/>
                  </a:lnTo>
                  <a:lnTo>
                    <a:pt x="1936610" y="1525524"/>
                  </a:lnTo>
                  <a:lnTo>
                    <a:pt x="1936610" y="269113"/>
                  </a:lnTo>
                  <a:close/>
                </a:path>
                <a:path w="4084954" h="1525904">
                  <a:moveTo>
                    <a:pt x="1994662" y="568325"/>
                  </a:moveTo>
                  <a:lnTo>
                    <a:pt x="1984248" y="568325"/>
                  </a:lnTo>
                  <a:lnTo>
                    <a:pt x="1984248" y="1525524"/>
                  </a:lnTo>
                  <a:lnTo>
                    <a:pt x="1994662" y="1525524"/>
                  </a:lnTo>
                  <a:lnTo>
                    <a:pt x="1994662" y="568325"/>
                  </a:lnTo>
                  <a:close/>
                </a:path>
                <a:path w="4084954" h="1525904">
                  <a:moveTo>
                    <a:pt x="2052701" y="1106678"/>
                  </a:moveTo>
                  <a:lnTo>
                    <a:pt x="2042287" y="1106678"/>
                  </a:lnTo>
                  <a:lnTo>
                    <a:pt x="2042287" y="1525524"/>
                  </a:lnTo>
                  <a:lnTo>
                    <a:pt x="2052701" y="1525524"/>
                  </a:lnTo>
                  <a:lnTo>
                    <a:pt x="2052701" y="1106678"/>
                  </a:lnTo>
                  <a:close/>
                </a:path>
                <a:path w="4084954" h="1525904">
                  <a:moveTo>
                    <a:pt x="2110740" y="867410"/>
                  </a:moveTo>
                  <a:lnTo>
                    <a:pt x="2100326" y="867410"/>
                  </a:lnTo>
                  <a:lnTo>
                    <a:pt x="2100326" y="1525524"/>
                  </a:lnTo>
                  <a:lnTo>
                    <a:pt x="2110740" y="1525524"/>
                  </a:lnTo>
                  <a:lnTo>
                    <a:pt x="2110740" y="867410"/>
                  </a:lnTo>
                  <a:close/>
                </a:path>
                <a:path w="4084954" h="1525904">
                  <a:moveTo>
                    <a:pt x="2168766" y="478536"/>
                  </a:moveTo>
                  <a:lnTo>
                    <a:pt x="2158365" y="478536"/>
                  </a:lnTo>
                  <a:lnTo>
                    <a:pt x="2158365" y="1525524"/>
                  </a:lnTo>
                  <a:lnTo>
                    <a:pt x="2168766" y="1525524"/>
                  </a:lnTo>
                  <a:lnTo>
                    <a:pt x="2168766" y="478536"/>
                  </a:lnTo>
                  <a:close/>
                </a:path>
                <a:path w="4084954" h="1525904">
                  <a:moveTo>
                    <a:pt x="2226818" y="448691"/>
                  </a:moveTo>
                  <a:lnTo>
                    <a:pt x="2216404" y="448691"/>
                  </a:lnTo>
                  <a:lnTo>
                    <a:pt x="2216404" y="1525524"/>
                  </a:lnTo>
                  <a:lnTo>
                    <a:pt x="2226818" y="1525524"/>
                  </a:lnTo>
                  <a:lnTo>
                    <a:pt x="2226818" y="448691"/>
                  </a:lnTo>
                  <a:close/>
                </a:path>
                <a:path w="4084954" h="1525904">
                  <a:moveTo>
                    <a:pt x="2284844" y="239268"/>
                  </a:moveTo>
                  <a:lnTo>
                    <a:pt x="2274443" y="239268"/>
                  </a:lnTo>
                  <a:lnTo>
                    <a:pt x="2274443" y="1525524"/>
                  </a:lnTo>
                  <a:lnTo>
                    <a:pt x="2284844" y="1525524"/>
                  </a:lnTo>
                  <a:lnTo>
                    <a:pt x="2284844" y="239268"/>
                  </a:lnTo>
                  <a:close/>
                </a:path>
                <a:path w="4084954" h="1525904">
                  <a:moveTo>
                    <a:pt x="2342896" y="927227"/>
                  </a:moveTo>
                  <a:lnTo>
                    <a:pt x="2332482" y="927227"/>
                  </a:lnTo>
                  <a:lnTo>
                    <a:pt x="2332482" y="1525524"/>
                  </a:lnTo>
                  <a:lnTo>
                    <a:pt x="2342896" y="1525524"/>
                  </a:lnTo>
                  <a:lnTo>
                    <a:pt x="2342896" y="927227"/>
                  </a:lnTo>
                  <a:close/>
                </a:path>
                <a:path w="4084954" h="1525904">
                  <a:moveTo>
                    <a:pt x="2400935" y="687959"/>
                  </a:moveTo>
                  <a:lnTo>
                    <a:pt x="2390521" y="687959"/>
                  </a:lnTo>
                  <a:lnTo>
                    <a:pt x="2390521" y="1525524"/>
                  </a:lnTo>
                  <a:lnTo>
                    <a:pt x="2400935" y="1525524"/>
                  </a:lnTo>
                  <a:lnTo>
                    <a:pt x="2400935" y="687959"/>
                  </a:lnTo>
                  <a:close/>
                </a:path>
                <a:path w="4084954" h="1525904">
                  <a:moveTo>
                    <a:pt x="2459101" y="987044"/>
                  </a:moveTo>
                  <a:lnTo>
                    <a:pt x="2448687" y="987044"/>
                  </a:lnTo>
                  <a:lnTo>
                    <a:pt x="2448687" y="1525524"/>
                  </a:lnTo>
                  <a:lnTo>
                    <a:pt x="2459101" y="1525524"/>
                  </a:lnTo>
                  <a:lnTo>
                    <a:pt x="2459101" y="987044"/>
                  </a:lnTo>
                  <a:close/>
                </a:path>
                <a:path w="4084954" h="1525904">
                  <a:moveTo>
                    <a:pt x="2517140" y="358902"/>
                  </a:moveTo>
                  <a:lnTo>
                    <a:pt x="2506726" y="358902"/>
                  </a:lnTo>
                  <a:lnTo>
                    <a:pt x="2506726" y="1525524"/>
                  </a:lnTo>
                  <a:lnTo>
                    <a:pt x="2517140" y="1525524"/>
                  </a:lnTo>
                  <a:lnTo>
                    <a:pt x="2517140" y="358902"/>
                  </a:lnTo>
                  <a:close/>
                </a:path>
                <a:path w="4084954" h="1525904">
                  <a:moveTo>
                    <a:pt x="2575179" y="478536"/>
                  </a:moveTo>
                  <a:lnTo>
                    <a:pt x="2564765" y="478536"/>
                  </a:lnTo>
                  <a:lnTo>
                    <a:pt x="2564765" y="1525524"/>
                  </a:lnTo>
                  <a:lnTo>
                    <a:pt x="2575179" y="1525524"/>
                  </a:lnTo>
                  <a:lnTo>
                    <a:pt x="2575179" y="478536"/>
                  </a:lnTo>
                  <a:close/>
                </a:path>
                <a:path w="4084954" h="1525904">
                  <a:moveTo>
                    <a:pt x="2633218" y="388874"/>
                  </a:moveTo>
                  <a:lnTo>
                    <a:pt x="2622804" y="388874"/>
                  </a:lnTo>
                  <a:lnTo>
                    <a:pt x="2622804" y="1525524"/>
                  </a:lnTo>
                  <a:lnTo>
                    <a:pt x="2633218" y="1525524"/>
                  </a:lnTo>
                  <a:lnTo>
                    <a:pt x="2633218" y="388874"/>
                  </a:lnTo>
                  <a:close/>
                </a:path>
                <a:path w="4084954" h="1525904">
                  <a:moveTo>
                    <a:pt x="2691244" y="687959"/>
                  </a:moveTo>
                  <a:lnTo>
                    <a:pt x="2680843" y="687959"/>
                  </a:lnTo>
                  <a:lnTo>
                    <a:pt x="2680843" y="1525524"/>
                  </a:lnTo>
                  <a:lnTo>
                    <a:pt x="2691244" y="1525524"/>
                  </a:lnTo>
                  <a:lnTo>
                    <a:pt x="2691244" y="687959"/>
                  </a:lnTo>
                  <a:close/>
                </a:path>
                <a:path w="4084954" h="1525904">
                  <a:moveTo>
                    <a:pt x="2749296" y="837565"/>
                  </a:moveTo>
                  <a:lnTo>
                    <a:pt x="2738882" y="837565"/>
                  </a:lnTo>
                  <a:lnTo>
                    <a:pt x="2738882" y="1525524"/>
                  </a:lnTo>
                  <a:lnTo>
                    <a:pt x="2749296" y="1525524"/>
                  </a:lnTo>
                  <a:lnTo>
                    <a:pt x="2749296" y="837565"/>
                  </a:lnTo>
                  <a:close/>
                </a:path>
                <a:path w="4084954" h="1525904">
                  <a:moveTo>
                    <a:pt x="2807335" y="568325"/>
                  </a:moveTo>
                  <a:lnTo>
                    <a:pt x="2796921" y="568325"/>
                  </a:lnTo>
                  <a:lnTo>
                    <a:pt x="2796921" y="1525524"/>
                  </a:lnTo>
                  <a:lnTo>
                    <a:pt x="2807335" y="1525524"/>
                  </a:lnTo>
                  <a:lnTo>
                    <a:pt x="2807335" y="568325"/>
                  </a:lnTo>
                  <a:close/>
                </a:path>
                <a:path w="4084954" h="1525904">
                  <a:moveTo>
                    <a:pt x="2865374" y="358902"/>
                  </a:moveTo>
                  <a:lnTo>
                    <a:pt x="2854960" y="358902"/>
                  </a:lnTo>
                  <a:lnTo>
                    <a:pt x="2854960" y="1525524"/>
                  </a:lnTo>
                  <a:lnTo>
                    <a:pt x="2865374" y="1525524"/>
                  </a:lnTo>
                  <a:lnTo>
                    <a:pt x="2865374" y="358902"/>
                  </a:lnTo>
                  <a:close/>
                </a:path>
                <a:path w="4084954" h="1525904">
                  <a:moveTo>
                    <a:pt x="2923413" y="598170"/>
                  </a:moveTo>
                  <a:lnTo>
                    <a:pt x="2912999" y="598170"/>
                  </a:lnTo>
                  <a:lnTo>
                    <a:pt x="2912999" y="1525524"/>
                  </a:lnTo>
                  <a:lnTo>
                    <a:pt x="2923413" y="1525524"/>
                  </a:lnTo>
                  <a:lnTo>
                    <a:pt x="2923413" y="598170"/>
                  </a:lnTo>
                  <a:close/>
                </a:path>
                <a:path w="4084954" h="1525904">
                  <a:moveTo>
                    <a:pt x="2981579" y="657987"/>
                  </a:moveTo>
                  <a:lnTo>
                    <a:pt x="2971165" y="657987"/>
                  </a:lnTo>
                  <a:lnTo>
                    <a:pt x="2971165" y="1525524"/>
                  </a:lnTo>
                  <a:lnTo>
                    <a:pt x="2981579" y="1525524"/>
                  </a:lnTo>
                  <a:lnTo>
                    <a:pt x="2981579" y="657987"/>
                  </a:lnTo>
                  <a:close/>
                </a:path>
                <a:path w="4084954" h="1525904">
                  <a:moveTo>
                    <a:pt x="3039618" y="598170"/>
                  </a:moveTo>
                  <a:lnTo>
                    <a:pt x="3029204" y="598170"/>
                  </a:lnTo>
                  <a:lnTo>
                    <a:pt x="3029204" y="1525524"/>
                  </a:lnTo>
                  <a:lnTo>
                    <a:pt x="3039618" y="1525524"/>
                  </a:lnTo>
                  <a:lnTo>
                    <a:pt x="3039618" y="598170"/>
                  </a:lnTo>
                  <a:close/>
                </a:path>
                <a:path w="4084954" h="1525904">
                  <a:moveTo>
                    <a:pt x="3097644" y="717804"/>
                  </a:moveTo>
                  <a:lnTo>
                    <a:pt x="3087243" y="717804"/>
                  </a:lnTo>
                  <a:lnTo>
                    <a:pt x="3087243" y="1525524"/>
                  </a:lnTo>
                  <a:lnTo>
                    <a:pt x="3097644" y="1525524"/>
                  </a:lnTo>
                  <a:lnTo>
                    <a:pt x="3097644" y="717804"/>
                  </a:lnTo>
                  <a:close/>
                </a:path>
                <a:path w="4084954" h="1525904">
                  <a:moveTo>
                    <a:pt x="3155696" y="657987"/>
                  </a:moveTo>
                  <a:lnTo>
                    <a:pt x="3145282" y="657987"/>
                  </a:lnTo>
                  <a:lnTo>
                    <a:pt x="3145282" y="1525524"/>
                  </a:lnTo>
                  <a:lnTo>
                    <a:pt x="3155696" y="1525524"/>
                  </a:lnTo>
                  <a:lnTo>
                    <a:pt x="3155696" y="657987"/>
                  </a:lnTo>
                  <a:close/>
                </a:path>
                <a:path w="4084954" h="1525904">
                  <a:moveTo>
                    <a:pt x="3213735" y="209296"/>
                  </a:moveTo>
                  <a:lnTo>
                    <a:pt x="3203321" y="209296"/>
                  </a:lnTo>
                  <a:lnTo>
                    <a:pt x="3203321" y="1525524"/>
                  </a:lnTo>
                  <a:lnTo>
                    <a:pt x="3213735" y="1525524"/>
                  </a:lnTo>
                  <a:lnTo>
                    <a:pt x="3213735" y="209296"/>
                  </a:lnTo>
                  <a:close/>
                </a:path>
                <a:path w="4084954" h="1525904">
                  <a:moveTo>
                    <a:pt x="3271774" y="478536"/>
                  </a:moveTo>
                  <a:lnTo>
                    <a:pt x="3261360" y="478536"/>
                  </a:lnTo>
                  <a:lnTo>
                    <a:pt x="3261360" y="1525524"/>
                  </a:lnTo>
                  <a:lnTo>
                    <a:pt x="3271774" y="1525524"/>
                  </a:lnTo>
                  <a:lnTo>
                    <a:pt x="3271774" y="478536"/>
                  </a:lnTo>
                  <a:close/>
                </a:path>
                <a:path w="4084954" h="1525904">
                  <a:moveTo>
                    <a:pt x="3329813" y="987044"/>
                  </a:moveTo>
                  <a:lnTo>
                    <a:pt x="3319399" y="987044"/>
                  </a:lnTo>
                  <a:lnTo>
                    <a:pt x="3319399" y="1525524"/>
                  </a:lnTo>
                  <a:lnTo>
                    <a:pt x="3329813" y="1525524"/>
                  </a:lnTo>
                  <a:lnTo>
                    <a:pt x="3329813" y="987044"/>
                  </a:lnTo>
                  <a:close/>
                </a:path>
                <a:path w="4084954" h="1525904">
                  <a:moveTo>
                    <a:pt x="3387852" y="418719"/>
                  </a:moveTo>
                  <a:lnTo>
                    <a:pt x="3377438" y="418719"/>
                  </a:lnTo>
                  <a:lnTo>
                    <a:pt x="3377438" y="1525524"/>
                  </a:lnTo>
                  <a:lnTo>
                    <a:pt x="3387852" y="1525524"/>
                  </a:lnTo>
                  <a:lnTo>
                    <a:pt x="3387852" y="418719"/>
                  </a:lnTo>
                  <a:close/>
                </a:path>
                <a:path w="4084954" h="1525904">
                  <a:moveTo>
                    <a:pt x="3445891" y="747776"/>
                  </a:moveTo>
                  <a:lnTo>
                    <a:pt x="3435477" y="747776"/>
                  </a:lnTo>
                  <a:lnTo>
                    <a:pt x="3435477" y="1525524"/>
                  </a:lnTo>
                  <a:lnTo>
                    <a:pt x="3445891" y="1525524"/>
                  </a:lnTo>
                  <a:lnTo>
                    <a:pt x="3445891" y="747776"/>
                  </a:lnTo>
                  <a:close/>
                </a:path>
                <a:path w="4084954" h="1525904">
                  <a:moveTo>
                    <a:pt x="3503930" y="897382"/>
                  </a:moveTo>
                  <a:lnTo>
                    <a:pt x="3493516" y="897382"/>
                  </a:lnTo>
                  <a:lnTo>
                    <a:pt x="3493516" y="1525524"/>
                  </a:lnTo>
                  <a:lnTo>
                    <a:pt x="3503930" y="1525524"/>
                  </a:lnTo>
                  <a:lnTo>
                    <a:pt x="3503930" y="897382"/>
                  </a:lnTo>
                  <a:close/>
                </a:path>
                <a:path w="4084954" h="1525904">
                  <a:moveTo>
                    <a:pt x="3562096" y="687959"/>
                  </a:moveTo>
                  <a:lnTo>
                    <a:pt x="3551682" y="687959"/>
                  </a:lnTo>
                  <a:lnTo>
                    <a:pt x="3551682" y="1525524"/>
                  </a:lnTo>
                  <a:lnTo>
                    <a:pt x="3562096" y="1525524"/>
                  </a:lnTo>
                  <a:lnTo>
                    <a:pt x="3562096" y="687959"/>
                  </a:lnTo>
                  <a:close/>
                </a:path>
                <a:path w="4084954" h="1525904">
                  <a:moveTo>
                    <a:pt x="3620135" y="628142"/>
                  </a:moveTo>
                  <a:lnTo>
                    <a:pt x="3609721" y="628142"/>
                  </a:lnTo>
                  <a:lnTo>
                    <a:pt x="3609721" y="1525524"/>
                  </a:lnTo>
                  <a:lnTo>
                    <a:pt x="3620135" y="1525524"/>
                  </a:lnTo>
                  <a:lnTo>
                    <a:pt x="3620135" y="628142"/>
                  </a:lnTo>
                  <a:close/>
                </a:path>
                <a:path w="4084954" h="1525904">
                  <a:moveTo>
                    <a:pt x="3678174" y="987044"/>
                  </a:moveTo>
                  <a:lnTo>
                    <a:pt x="3667760" y="987044"/>
                  </a:lnTo>
                  <a:lnTo>
                    <a:pt x="3667760" y="1525524"/>
                  </a:lnTo>
                  <a:lnTo>
                    <a:pt x="3678174" y="1525524"/>
                  </a:lnTo>
                  <a:lnTo>
                    <a:pt x="3678174" y="987044"/>
                  </a:lnTo>
                  <a:close/>
                </a:path>
                <a:path w="4084954" h="1525904">
                  <a:moveTo>
                    <a:pt x="3736213" y="957199"/>
                  </a:moveTo>
                  <a:lnTo>
                    <a:pt x="3725799" y="957199"/>
                  </a:lnTo>
                  <a:lnTo>
                    <a:pt x="3725799" y="1525524"/>
                  </a:lnTo>
                  <a:lnTo>
                    <a:pt x="3736213" y="1525524"/>
                  </a:lnTo>
                  <a:lnTo>
                    <a:pt x="3736213" y="957199"/>
                  </a:lnTo>
                  <a:close/>
                </a:path>
                <a:path w="4084954" h="1525904">
                  <a:moveTo>
                    <a:pt x="3794252" y="897382"/>
                  </a:moveTo>
                  <a:lnTo>
                    <a:pt x="3783838" y="897382"/>
                  </a:lnTo>
                  <a:lnTo>
                    <a:pt x="3783838" y="1525524"/>
                  </a:lnTo>
                  <a:lnTo>
                    <a:pt x="3794252" y="1525524"/>
                  </a:lnTo>
                  <a:lnTo>
                    <a:pt x="3794252" y="897382"/>
                  </a:lnTo>
                  <a:close/>
                </a:path>
                <a:path w="4084954" h="1525904">
                  <a:moveTo>
                    <a:pt x="3852291" y="1076833"/>
                  </a:moveTo>
                  <a:lnTo>
                    <a:pt x="3841877" y="1076833"/>
                  </a:lnTo>
                  <a:lnTo>
                    <a:pt x="3841877" y="1525524"/>
                  </a:lnTo>
                  <a:lnTo>
                    <a:pt x="3852291" y="1525524"/>
                  </a:lnTo>
                  <a:lnTo>
                    <a:pt x="3852291" y="1076833"/>
                  </a:lnTo>
                  <a:close/>
                </a:path>
                <a:path w="4084954" h="1525904">
                  <a:moveTo>
                    <a:pt x="3910330" y="388874"/>
                  </a:moveTo>
                  <a:lnTo>
                    <a:pt x="3899916" y="388874"/>
                  </a:lnTo>
                  <a:lnTo>
                    <a:pt x="3899916" y="1525524"/>
                  </a:lnTo>
                  <a:lnTo>
                    <a:pt x="3910330" y="1525524"/>
                  </a:lnTo>
                  <a:lnTo>
                    <a:pt x="3910330" y="388874"/>
                  </a:lnTo>
                  <a:close/>
                </a:path>
                <a:path w="4084954" h="1525904">
                  <a:moveTo>
                    <a:pt x="3968369" y="0"/>
                  </a:moveTo>
                  <a:lnTo>
                    <a:pt x="3957955" y="0"/>
                  </a:lnTo>
                  <a:lnTo>
                    <a:pt x="3957955" y="1525524"/>
                  </a:lnTo>
                  <a:lnTo>
                    <a:pt x="3968369" y="1525524"/>
                  </a:lnTo>
                  <a:lnTo>
                    <a:pt x="3968369" y="0"/>
                  </a:lnTo>
                  <a:close/>
                </a:path>
                <a:path w="4084954" h="1525904">
                  <a:moveTo>
                    <a:pt x="4026395" y="747776"/>
                  </a:moveTo>
                  <a:lnTo>
                    <a:pt x="4015994" y="747776"/>
                  </a:lnTo>
                  <a:lnTo>
                    <a:pt x="4015994" y="1525524"/>
                  </a:lnTo>
                  <a:lnTo>
                    <a:pt x="4026395" y="1525524"/>
                  </a:lnTo>
                  <a:lnTo>
                    <a:pt x="4026395" y="747776"/>
                  </a:lnTo>
                  <a:close/>
                </a:path>
                <a:path w="4084954" h="1525904">
                  <a:moveTo>
                    <a:pt x="4084574" y="628142"/>
                  </a:moveTo>
                  <a:lnTo>
                    <a:pt x="4074160" y="628142"/>
                  </a:lnTo>
                  <a:lnTo>
                    <a:pt x="4074160" y="1525524"/>
                  </a:lnTo>
                  <a:lnTo>
                    <a:pt x="4084574" y="1525524"/>
                  </a:lnTo>
                  <a:lnTo>
                    <a:pt x="4084574" y="628142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8" name="object 98" descr=""/>
            <p:cNvSpPr/>
            <p:nvPr/>
          </p:nvSpPr>
          <p:spPr>
            <a:xfrm>
              <a:off x="5198872" y="7525766"/>
              <a:ext cx="4074160" cy="1136650"/>
            </a:xfrm>
            <a:custGeom>
              <a:avLst/>
              <a:gdLst/>
              <a:ahLst/>
              <a:cxnLst/>
              <a:rect l="l" t="t" r="r" b="b"/>
              <a:pathLst>
                <a:path w="4074159" h="1136650">
                  <a:moveTo>
                    <a:pt x="10414" y="239268"/>
                  </a:moveTo>
                  <a:lnTo>
                    <a:pt x="0" y="239268"/>
                  </a:lnTo>
                  <a:lnTo>
                    <a:pt x="0" y="1136650"/>
                  </a:lnTo>
                  <a:lnTo>
                    <a:pt x="10414" y="1136650"/>
                  </a:lnTo>
                  <a:lnTo>
                    <a:pt x="10414" y="239268"/>
                  </a:lnTo>
                  <a:close/>
                </a:path>
                <a:path w="4074159" h="1136650">
                  <a:moveTo>
                    <a:pt x="68453" y="657987"/>
                  </a:moveTo>
                  <a:lnTo>
                    <a:pt x="58039" y="657987"/>
                  </a:lnTo>
                  <a:lnTo>
                    <a:pt x="58039" y="1136650"/>
                  </a:lnTo>
                  <a:lnTo>
                    <a:pt x="68453" y="1136650"/>
                  </a:lnTo>
                  <a:lnTo>
                    <a:pt x="68453" y="657987"/>
                  </a:lnTo>
                  <a:close/>
                </a:path>
                <a:path w="4074159" h="1136650">
                  <a:moveTo>
                    <a:pt x="126492" y="239268"/>
                  </a:moveTo>
                  <a:lnTo>
                    <a:pt x="116078" y="239268"/>
                  </a:lnTo>
                  <a:lnTo>
                    <a:pt x="116078" y="1136650"/>
                  </a:lnTo>
                  <a:lnTo>
                    <a:pt x="126492" y="1136650"/>
                  </a:lnTo>
                  <a:lnTo>
                    <a:pt x="126492" y="239268"/>
                  </a:lnTo>
                  <a:close/>
                </a:path>
                <a:path w="4074159" h="1136650">
                  <a:moveTo>
                    <a:pt x="184531" y="478536"/>
                  </a:moveTo>
                  <a:lnTo>
                    <a:pt x="174117" y="478536"/>
                  </a:lnTo>
                  <a:lnTo>
                    <a:pt x="174117" y="1136650"/>
                  </a:lnTo>
                  <a:lnTo>
                    <a:pt x="184531" y="1136650"/>
                  </a:lnTo>
                  <a:lnTo>
                    <a:pt x="184531" y="478536"/>
                  </a:lnTo>
                  <a:close/>
                </a:path>
                <a:path w="4074159" h="1136650">
                  <a:moveTo>
                    <a:pt x="242570" y="209296"/>
                  </a:moveTo>
                  <a:lnTo>
                    <a:pt x="232156" y="209296"/>
                  </a:lnTo>
                  <a:lnTo>
                    <a:pt x="232156" y="1136650"/>
                  </a:lnTo>
                  <a:lnTo>
                    <a:pt x="242570" y="1136650"/>
                  </a:lnTo>
                  <a:lnTo>
                    <a:pt x="242570" y="209296"/>
                  </a:lnTo>
                  <a:close/>
                </a:path>
                <a:path w="4074159" h="1136650">
                  <a:moveTo>
                    <a:pt x="300609" y="119634"/>
                  </a:moveTo>
                  <a:lnTo>
                    <a:pt x="290195" y="119634"/>
                  </a:lnTo>
                  <a:lnTo>
                    <a:pt x="290195" y="1136650"/>
                  </a:lnTo>
                  <a:lnTo>
                    <a:pt x="300609" y="1136650"/>
                  </a:lnTo>
                  <a:lnTo>
                    <a:pt x="300609" y="119634"/>
                  </a:lnTo>
                  <a:close/>
                </a:path>
                <a:path w="4074159" h="1136650">
                  <a:moveTo>
                    <a:pt x="358635" y="0"/>
                  </a:moveTo>
                  <a:lnTo>
                    <a:pt x="348234" y="0"/>
                  </a:lnTo>
                  <a:lnTo>
                    <a:pt x="348234" y="1136650"/>
                  </a:lnTo>
                  <a:lnTo>
                    <a:pt x="358635" y="1136650"/>
                  </a:lnTo>
                  <a:lnTo>
                    <a:pt x="358635" y="0"/>
                  </a:lnTo>
                  <a:close/>
                </a:path>
                <a:path w="4074159" h="1136650">
                  <a:moveTo>
                    <a:pt x="416687" y="89662"/>
                  </a:moveTo>
                  <a:lnTo>
                    <a:pt x="406273" y="89662"/>
                  </a:lnTo>
                  <a:lnTo>
                    <a:pt x="406273" y="1136650"/>
                  </a:lnTo>
                  <a:lnTo>
                    <a:pt x="416687" y="1136650"/>
                  </a:lnTo>
                  <a:lnTo>
                    <a:pt x="416687" y="89662"/>
                  </a:lnTo>
                  <a:close/>
                </a:path>
                <a:path w="4074159" h="1136650">
                  <a:moveTo>
                    <a:pt x="474726" y="179451"/>
                  </a:moveTo>
                  <a:lnTo>
                    <a:pt x="464312" y="179451"/>
                  </a:lnTo>
                  <a:lnTo>
                    <a:pt x="464312" y="1136650"/>
                  </a:lnTo>
                  <a:lnTo>
                    <a:pt x="474726" y="1136650"/>
                  </a:lnTo>
                  <a:lnTo>
                    <a:pt x="474726" y="179451"/>
                  </a:lnTo>
                  <a:close/>
                </a:path>
                <a:path w="4074159" h="1136650">
                  <a:moveTo>
                    <a:pt x="532892" y="299085"/>
                  </a:moveTo>
                  <a:lnTo>
                    <a:pt x="522478" y="299085"/>
                  </a:lnTo>
                  <a:lnTo>
                    <a:pt x="522478" y="1136650"/>
                  </a:lnTo>
                  <a:lnTo>
                    <a:pt x="532892" y="1136650"/>
                  </a:lnTo>
                  <a:lnTo>
                    <a:pt x="532892" y="299085"/>
                  </a:lnTo>
                  <a:close/>
                </a:path>
                <a:path w="4074159" h="1136650">
                  <a:moveTo>
                    <a:pt x="590931" y="59817"/>
                  </a:moveTo>
                  <a:lnTo>
                    <a:pt x="580517" y="59817"/>
                  </a:lnTo>
                  <a:lnTo>
                    <a:pt x="580517" y="1136650"/>
                  </a:lnTo>
                  <a:lnTo>
                    <a:pt x="590931" y="1136650"/>
                  </a:lnTo>
                  <a:lnTo>
                    <a:pt x="590931" y="59817"/>
                  </a:lnTo>
                  <a:close/>
                </a:path>
                <a:path w="4074159" h="1136650">
                  <a:moveTo>
                    <a:pt x="648970" y="149479"/>
                  </a:moveTo>
                  <a:lnTo>
                    <a:pt x="638556" y="149479"/>
                  </a:lnTo>
                  <a:lnTo>
                    <a:pt x="638556" y="1136650"/>
                  </a:lnTo>
                  <a:lnTo>
                    <a:pt x="648970" y="1136650"/>
                  </a:lnTo>
                  <a:lnTo>
                    <a:pt x="648970" y="149479"/>
                  </a:lnTo>
                  <a:close/>
                </a:path>
                <a:path w="4074159" h="1136650">
                  <a:moveTo>
                    <a:pt x="707009" y="358902"/>
                  </a:moveTo>
                  <a:lnTo>
                    <a:pt x="696595" y="358902"/>
                  </a:lnTo>
                  <a:lnTo>
                    <a:pt x="696595" y="1136650"/>
                  </a:lnTo>
                  <a:lnTo>
                    <a:pt x="707009" y="1136650"/>
                  </a:lnTo>
                  <a:lnTo>
                    <a:pt x="707009" y="358902"/>
                  </a:lnTo>
                  <a:close/>
                </a:path>
                <a:path w="4074159" h="1136650">
                  <a:moveTo>
                    <a:pt x="765035" y="418719"/>
                  </a:moveTo>
                  <a:lnTo>
                    <a:pt x="754634" y="418719"/>
                  </a:lnTo>
                  <a:lnTo>
                    <a:pt x="754634" y="1136650"/>
                  </a:lnTo>
                  <a:lnTo>
                    <a:pt x="765035" y="1136650"/>
                  </a:lnTo>
                  <a:lnTo>
                    <a:pt x="765035" y="418719"/>
                  </a:lnTo>
                  <a:close/>
                </a:path>
                <a:path w="4074159" h="1136650">
                  <a:moveTo>
                    <a:pt x="823087" y="628142"/>
                  </a:moveTo>
                  <a:lnTo>
                    <a:pt x="812673" y="628142"/>
                  </a:lnTo>
                  <a:lnTo>
                    <a:pt x="812673" y="1136650"/>
                  </a:lnTo>
                  <a:lnTo>
                    <a:pt x="823087" y="1136650"/>
                  </a:lnTo>
                  <a:lnTo>
                    <a:pt x="823087" y="628142"/>
                  </a:lnTo>
                  <a:close/>
                </a:path>
                <a:path w="4074159" h="1136650">
                  <a:moveTo>
                    <a:pt x="881126" y="598170"/>
                  </a:moveTo>
                  <a:lnTo>
                    <a:pt x="870712" y="598170"/>
                  </a:lnTo>
                  <a:lnTo>
                    <a:pt x="870712" y="1136650"/>
                  </a:lnTo>
                  <a:lnTo>
                    <a:pt x="881126" y="1136650"/>
                  </a:lnTo>
                  <a:lnTo>
                    <a:pt x="881126" y="598170"/>
                  </a:lnTo>
                  <a:close/>
                </a:path>
                <a:path w="4074159" h="1136650">
                  <a:moveTo>
                    <a:pt x="939165" y="328930"/>
                  </a:moveTo>
                  <a:lnTo>
                    <a:pt x="928751" y="328930"/>
                  </a:lnTo>
                  <a:lnTo>
                    <a:pt x="928751" y="1136650"/>
                  </a:lnTo>
                  <a:lnTo>
                    <a:pt x="939165" y="1136650"/>
                  </a:lnTo>
                  <a:lnTo>
                    <a:pt x="939165" y="328930"/>
                  </a:lnTo>
                  <a:close/>
                </a:path>
                <a:path w="4074159" h="1136650">
                  <a:moveTo>
                    <a:pt x="997204" y="478536"/>
                  </a:moveTo>
                  <a:lnTo>
                    <a:pt x="986790" y="478536"/>
                  </a:lnTo>
                  <a:lnTo>
                    <a:pt x="986790" y="1136650"/>
                  </a:lnTo>
                  <a:lnTo>
                    <a:pt x="997204" y="1136650"/>
                  </a:lnTo>
                  <a:lnTo>
                    <a:pt x="997204" y="478536"/>
                  </a:lnTo>
                  <a:close/>
                </a:path>
                <a:path w="4074159" h="1136650">
                  <a:moveTo>
                    <a:pt x="1055243" y="687959"/>
                  </a:moveTo>
                  <a:lnTo>
                    <a:pt x="1044829" y="687959"/>
                  </a:lnTo>
                  <a:lnTo>
                    <a:pt x="1044829" y="1136650"/>
                  </a:lnTo>
                  <a:lnTo>
                    <a:pt x="1055243" y="1136650"/>
                  </a:lnTo>
                  <a:lnTo>
                    <a:pt x="1055243" y="687959"/>
                  </a:lnTo>
                  <a:close/>
                </a:path>
                <a:path w="4074159" h="1136650">
                  <a:moveTo>
                    <a:pt x="1113409" y="418719"/>
                  </a:moveTo>
                  <a:lnTo>
                    <a:pt x="1102995" y="418719"/>
                  </a:lnTo>
                  <a:lnTo>
                    <a:pt x="1102995" y="1136650"/>
                  </a:lnTo>
                  <a:lnTo>
                    <a:pt x="1113409" y="1136650"/>
                  </a:lnTo>
                  <a:lnTo>
                    <a:pt x="1113409" y="418719"/>
                  </a:lnTo>
                  <a:close/>
                </a:path>
                <a:path w="4074159" h="1136650">
                  <a:moveTo>
                    <a:pt x="1171435" y="388874"/>
                  </a:moveTo>
                  <a:lnTo>
                    <a:pt x="1161034" y="388874"/>
                  </a:lnTo>
                  <a:lnTo>
                    <a:pt x="1161034" y="1136650"/>
                  </a:lnTo>
                  <a:lnTo>
                    <a:pt x="1171435" y="1136650"/>
                  </a:lnTo>
                  <a:lnTo>
                    <a:pt x="1171435" y="388874"/>
                  </a:lnTo>
                  <a:close/>
                </a:path>
                <a:path w="4074159" h="1136650">
                  <a:moveTo>
                    <a:pt x="1229487" y="89662"/>
                  </a:moveTo>
                  <a:lnTo>
                    <a:pt x="1219073" y="89662"/>
                  </a:lnTo>
                  <a:lnTo>
                    <a:pt x="1219073" y="1136650"/>
                  </a:lnTo>
                  <a:lnTo>
                    <a:pt x="1229487" y="1136650"/>
                  </a:lnTo>
                  <a:lnTo>
                    <a:pt x="1229487" y="89662"/>
                  </a:lnTo>
                  <a:close/>
                </a:path>
                <a:path w="4074159" h="1136650">
                  <a:moveTo>
                    <a:pt x="1287526" y="508508"/>
                  </a:moveTo>
                  <a:lnTo>
                    <a:pt x="1277112" y="508508"/>
                  </a:lnTo>
                  <a:lnTo>
                    <a:pt x="1277112" y="1136650"/>
                  </a:lnTo>
                  <a:lnTo>
                    <a:pt x="1287526" y="1136650"/>
                  </a:lnTo>
                  <a:lnTo>
                    <a:pt x="1287526" y="508508"/>
                  </a:lnTo>
                  <a:close/>
                </a:path>
                <a:path w="4074159" h="1136650">
                  <a:moveTo>
                    <a:pt x="1345565" y="269113"/>
                  </a:moveTo>
                  <a:lnTo>
                    <a:pt x="1335151" y="269113"/>
                  </a:lnTo>
                  <a:lnTo>
                    <a:pt x="1335151" y="1136650"/>
                  </a:lnTo>
                  <a:lnTo>
                    <a:pt x="1345565" y="1136650"/>
                  </a:lnTo>
                  <a:lnTo>
                    <a:pt x="1345565" y="269113"/>
                  </a:lnTo>
                  <a:close/>
                </a:path>
                <a:path w="4074159" h="1136650">
                  <a:moveTo>
                    <a:pt x="1403604" y="119634"/>
                  </a:moveTo>
                  <a:lnTo>
                    <a:pt x="1393177" y="119634"/>
                  </a:lnTo>
                  <a:lnTo>
                    <a:pt x="1393177" y="1136650"/>
                  </a:lnTo>
                  <a:lnTo>
                    <a:pt x="1403604" y="1136650"/>
                  </a:lnTo>
                  <a:lnTo>
                    <a:pt x="1403604" y="119634"/>
                  </a:lnTo>
                  <a:close/>
                </a:path>
                <a:path w="4074159" h="1136650">
                  <a:moveTo>
                    <a:pt x="1461643" y="628142"/>
                  </a:moveTo>
                  <a:lnTo>
                    <a:pt x="1451229" y="628142"/>
                  </a:lnTo>
                  <a:lnTo>
                    <a:pt x="1451229" y="1136650"/>
                  </a:lnTo>
                  <a:lnTo>
                    <a:pt x="1461643" y="1136650"/>
                  </a:lnTo>
                  <a:lnTo>
                    <a:pt x="1461643" y="628142"/>
                  </a:lnTo>
                  <a:close/>
                </a:path>
                <a:path w="4074159" h="1136650">
                  <a:moveTo>
                    <a:pt x="1519682" y="179451"/>
                  </a:moveTo>
                  <a:lnTo>
                    <a:pt x="1509268" y="179451"/>
                  </a:lnTo>
                  <a:lnTo>
                    <a:pt x="1509268" y="1136650"/>
                  </a:lnTo>
                  <a:lnTo>
                    <a:pt x="1519682" y="1136650"/>
                  </a:lnTo>
                  <a:lnTo>
                    <a:pt x="1519682" y="179451"/>
                  </a:lnTo>
                  <a:close/>
                </a:path>
                <a:path w="4074159" h="1136650">
                  <a:moveTo>
                    <a:pt x="1577721" y="418719"/>
                  </a:moveTo>
                  <a:lnTo>
                    <a:pt x="1567307" y="418719"/>
                  </a:lnTo>
                  <a:lnTo>
                    <a:pt x="1567307" y="1136650"/>
                  </a:lnTo>
                  <a:lnTo>
                    <a:pt x="1577721" y="1136650"/>
                  </a:lnTo>
                  <a:lnTo>
                    <a:pt x="1577721" y="418719"/>
                  </a:lnTo>
                  <a:close/>
                </a:path>
                <a:path w="4074159" h="1136650">
                  <a:moveTo>
                    <a:pt x="1635887" y="239268"/>
                  </a:moveTo>
                  <a:lnTo>
                    <a:pt x="1625473" y="239268"/>
                  </a:lnTo>
                  <a:lnTo>
                    <a:pt x="1625473" y="1136650"/>
                  </a:lnTo>
                  <a:lnTo>
                    <a:pt x="1635887" y="1136650"/>
                  </a:lnTo>
                  <a:lnTo>
                    <a:pt x="1635887" y="239268"/>
                  </a:lnTo>
                  <a:close/>
                </a:path>
                <a:path w="4074159" h="1136650">
                  <a:moveTo>
                    <a:pt x="1693926" y="388874"/>
                  </a:moveTo>
                  <a:lnTo>
                    <a:pt x="1683512" y="388874"/>
                  </a:lnTo>
                  <a:lnTo>
                    <a:pt x="1683512" y="1136650"/>
                  </a:lnTo>
                  <a:lnTo>
                    <a:pt x="1693926" y="1136650"/>
                  </a:lnTo>
                  <a:lnTo>
                    <a:pt x="1693926" y="388874"/>
                  </a:lnTo>
                  <a:close/>
                </a:path>
                <a:path w="4074159" h="1136650">
                  <a:moveTo>
                    <a:pt x="1751965" y="418719"/>
                  </a:moveTo>
                  <a:lnTo>
                    <a:pt x="1741551" y="418719"/>
                  </a:lnTo>
                  <a:lnTo>
                    <a:pt x="1741551" y="1136650"/>
                  </a:lnTo>
                  <a:lnTo>
                    <a:pt x="1751965" y="1136650"/>
                  </a:lnTo>
                  <a:lnTo>
                    <a:pt x="1751965" y="418719"/>
                  </a:lnTo>
                  <a:close/>
                </a:path>
                <a:path w="4074159" h="1136650">
                  <a:moveTo>
                    <a:pt x="1810004" y="269113"/>
                  </a:moveTo>
                  <a:lnTo>
                    <a:pt x="1799590" y="269113"/>
                  </a:lnTo>
                  <a:lnTo>
                    <a:pt x="1799590" y="1136650"/>
                  </a:lnTo>
                  <a:lnTo>
                    <a:pt x="1810004" y="1136650"/>
                  </a:lnTo>
                  <a:lnTo>
                    <a:pt x="1810004" y="269113"/>
                  </a:lnTo>
                  <a:close/>
                </a:path>
                <a:path w="4074159" h="1136650">
                  <a:moveTo>
                    <a:pt x="1868043" y="508508"/>
                  </a:moveTo>
                  <a:lnTo>
                    <a:pt x="1857629" y="508508"/>
                  </a:lnTo>
                  <a:lnTo>
                    <a:pt x="1857629" y="1136650"/>
                  </a:lnTo>
                  <a:lnTo>
                    <a:pt x="1868043" y="1136650"/>
                  </a:lnTo>
                  <a:lnTo>
                    <a:pt x="1868043" y="508508"/>
                  </a:lnTo>
                  <a:close/>
                </a:path>
                <a:path w="4074159" h="1136650">
                  <a:moveTo>
                    <a:pt x="1926082" y="299085"/>
                  </a:moveTo>
                  <a:lnTo>
                    <a:pt x="1915668" y="299085"/>
                  </a:lnTo>
                  <a:lnTo>
                    <a:pt x="1915668" y="1136650"/>
                  </a:lnTo>
                  <a:lnTo>
                    <a:pt x="1926082" y="1136650"/>
                  </a:lnTo>
                  <a:lnTo>
                    <a:pt x="1926082" y="299085"/>
                  </a:lnTo>
                  <a:close/>
                </a:path>
                <a:path w="4074159" h="1136650">
                  <a:moveTo>
                    <a:pt x="1984121" y="149479"/>
                  </a:moveTo>
                  <a:lnTo>
                    <a:pt x="1973707" y="149479"/>
                  </a:lnTo>
                  <a:lnTo>
                    <a:pt x="1973707" y="1136650"/>
                  </a:lnTo>
                  <a:lnTo>
                    <a:pt x="1984121" y="1136650"/>
                  </a:lnTo>
                  <a:lnTo>
                    <a:pt x="1984121" y="149479"/>
                  </a:lnTo>
                  <a:close/>
                </a:path>
                <a:path w="4074159" h="1136650">
                  <a:moveTo>
                    <a:pt x="2042160" y="538353"/>
                  </a:moveTo>
                  <a:lnTo>
                    <a:pt x="2031746" y="538353"/>
                  </a:lnTo>
                  <a:lnTo>
                    <a:pt x="2031746" y="1136650"/>
                  </a:lnTo>
                  <a:lnTo>
                    <a:pt x="2042160" y="1136650"/>
                  </a:lnTo>
                  <a:lnTo>
                    <a:pt x="2042160" y="538353"/>
                  </a:lnTo>
                  <a:close/>
                </a:path>
                <a:path w="4074159" h="1136650">
                  <a:moveTo>
                    <a:pt x="2100199" y="418719"/>
                  </a:moveTo>
                  <a:lnTo>
                    <a:pt x="2089785" y="418719"/>
                  </a:lnTo>
                  <a:lnTo>
                    <a:pt x="2089785" y="1136650"/>
                  </a:lnTo>
                  <a:lnTo>
                    <a:pt x="2100199" y="1136650"/>
                  </a:lnTo>
                  <a:lnTo>
                    <a:pt x="2100199" y="418719"/>
                  </a:lnTo>
                  <a:close/>
                </a:path>
                <a:path w="4074159" h="1136650">
                  <a:moveTo>
                    <a:pt x="2158365" y="777748"/>
                  </a:moveTo>
                  <a:lnTo>
                    <a:pt x="2147951" y="777748"/>
                  </a:lnTo>
                  <a:lnTo>
                    <a:pt x="2147951" y="1136650"/>
                  </a:lnTo>
                  <a:lnTo>
                    <a:pt x="2158365" y="1136650"/>
                  </a:lnTo>
                  <a:lnTo>
                    <a:pt x="2158365" y="777748"/>
                  </a:lnTo>
                  <a:close/>
                </a:path>
                <a:path w="4074159" h="1136650">
                  <a:moveTo>
                    <a:pt x="2216404" y="448691"/>
                  </a:moveTo>
                  <a:lnTo>
                    <a:pt x="2205990" y="448691"/>
                  </a:lnTo>
                  <a:lnTo>
                    <a:pt x="2205990" y="1136650"/>
                  </a:lnTo>
                  <a:lnTo>
                    <a:pt x="2216404" y="1136650"/>
                  </a:lnTo>
                  <a:lnTo>
                    <a:pt x="2216404" y="448691"/>
                  </a:lnTo>
                  <a:close/>
                </a:path>
                <a:path w="4074159" h="1136650">
                  <a:moveTo>
                    <a:pt x="2274443" y="747776"/>
                  </a:moveTo>
                  <a:lnTo>
                    <a:pt x="2264029" y="747776"/>
                  </a:lnTo>
                  <a:lnTo>
                    <a:pt x="2264029" y="1136650"/>
                  </a:lnTo>
                  <a:lnTo>
                    <a:pt x="2274443" y="1136650"/>
                  </a:lnTo>
                  <a:lnTo>
                    <a:pt x="2274443" y="747776"/>
                  </a:lnTo>
                  <a:close/>
                </a:path>
                <a:path w="4074159" h="1136650">
                  <a:moveTo>
                    <a:pt x="2332482" y="478536"/>
                  </a:moveTo>
                  <a:lnTo>
                    <a:pt x="2322068" y="478536"/>
                  </a:lnTo>
                  <a:lnTo>
                    <a:pt x="2322068" y="1136650"/>
                  </a:lnTo>
                  <a:lnTo>
                    <a:pt x="2332482" y="1136650"/>
                  </a:lnTo>
                  <a:lnTo>
                    <a:pt x="2332482" y="478536"/>
                  </a:lnTo>
                  <a:close/>
                </a:path>
                <a:path w="4074159" h="1136650">
                  <a:moveTo>
                    <a:pt x="2390521" y="508508"/>
                  </a:moveTo>
                  <a:lnTo>
                    <a:pt x="2380107" y="508508"/>
                  </a:lnTo>
                  <a:lnTo>
                    <a:pt x="2380107" y="1136650"/>
                  </a:lnTo>
                  <a:lnTo>
                    <a:pt x="2390521" y="1136650"/>
                  </a:lnTo>
                  <a:lnTo>
                    <a:pt x="2390521" y="508508"/>
                  </a:lnTo>
                  <a:close/>
                </a:path>
                <a:path w="4074159" h="1136650">
                  <a:moveTo>
                    <a:pt x="2448560" y="448691"/>
                  </a:moveTo>
                  <a:lnTo>
                    <a:pt x="2438146" y="448691"/>
                  </a:lnTo>
                  <a:lnTo>
                    <a:pt x="2438146" y="1136650"/>
                  </a:lnTo>
                  <a:lnTo>
                    <a:pt x="2448560" y="1136650"/>
                  </a:lnTo>
                  <a:lnTo>
                    <a:pt x="2448560" y="448691"/>
                  </a:lnTo>
                  <a:close/>
                </a:path>
                <a:path w="4074159" h="1136650">
                  <a:moveTo>
                    <a:pt x="2506599" y="538353"/>
                  </a:moveTo>
                  <a:lnTo>
                    <a:pt x="2496185" y="538353"/>
                  </a:lnTo>
                  <a:lnTo>
                    <a:pt x="2496185" y="1136650"/>
                  </a:lnTo>
                  <a:lnTo>
                    <a:pt x="2506599" y="1136650"/>
                  </a:lnTo>
                  <a:lnTo>
                    <a:pt x="2506599" y="538353"/>
                  </a:lnTo>
                  <a:close/>
                </a:path>
                <a:path w="4074159" h="1136650">
                  <a:moveTo>
                    <a:pt x="2564638" y="568325"/>
                  </a:moveTo>
                  <a:lnTo>
                    <a:pt x="2554224" y="568325"/>
                  </a:lnTo>
                  <a:lnTo>
                    <a:pt x="2554224" y="1136650"/>
                  </a:lnTo>
                  <a:lnTo>
                    <a:pt x="2564638" y="1136650"/>
                  </a:lnTo>
                  <a:lnTo>
                    <a:pt x="2564638" y="568325"/>
                  </a:lnTo>
                  <a:close/>
                </a:path>
                <a:path w="4074159" h="1136650">
                  <a:moveTo>
                    <a:pt x="2622677" y="119634"/>
                  </a:moveTo>
                  <a:lnTo>
                    <a:pt x="2612263" y="119634"/>
                  </a:lnTo>
                  <a:lnTo>
                    <a:pt x="2612263" y="1136650"/>
                  </a:lnTo>
                  <a:lnTo>
                    <a:pt x="2622677" y="1136650"/>
                  </a:lnTo>
                  <a:lnTo>
                    <a:pt x="2622677" y="119634"/>
                  </a:lnTo>
                  <a:close/>
                </a:path>
                <a:path w="4074159" h="1136650">
                  <a:moveTo>
                    <a:pt x="2680716" y="598170"/>
                  </a:moveTo>
                  <a:lnTo>
                    <a:pt x="2670302" y="598170"/>
                  </a:lnTo>
                  <a:lnTo>
                    <a:pt x="2670302" y="1136650"/>
                  </a:lnTo>
                  <a:lnTo>
                    <a:pt x="2680716" y="1136650"/>
                  </a:lnTo>
                  <a:lnTo>
                    <a:pt x="2680716" y="598170"/>
                  </a:lnTo>
                  <a:close/>
                </a:path>
                <a:path w="4074159" h="1136650">
                  <a:moveTo>
                    <a:pt x="2738882" y="538353"/>
                  </a:moveTo>
                  <a:lnTo>
                    <a:pt x="2728468" y="538353"/>
                  </a:lnTo>
                  <a:lnTo>
                    <a:pt x="2728468" y="1136650"/>
                  </a:lnTo>
                  <a:lnTo>
                    <a:pt x="2738882" y="1136650"/>
                  </a:lnTo>
                  <a:lnTo>
                    <a:pt x="2738882" y="538353"/>
                  </a:lnTo>
                  <a:close/>
                </a:path>
                <a:path w="4074159" h="1136650">
                  <a:moveTo>
                    <a:pt x="2796921" y="388874"/>
                  </a:moveTo>
                  <a:lnTo>
                    <a:pt x="2786507" y="388874"/>
                  </a:lnTo>
                  <a:lnTo>
                    <a:pt x="2786507" y="1136650"/>
                  </a:lnTo>
                  <a:lnTo>
                    <a:pt x="2796921" y="1136650"/>
                  </a:lnTo>
                  <a:lnTo>
                    <a:pt x="2796921" y="388874"/>
                  </a:lnTo>
                  <a:close/>
                </a:path>
                <a:path w="4074159" h="1136650">
                  <a:moveTo>
                    <a:pt x="2860154" y="657987"/>
                  </a:moveTo>
                  <a:lnTo>
                    <a:pt x="2847086" y="657987"/>
                  </a:lnTo>
                  <a:lnTo>
                    <a:pt x="2847086" y="1136650"/>
                  </a:lnTo>
                  <a:lnTo>
                    <a:pt x="2860154" y="1136650"/>
                  </a:lnTo>
                  <a:lnTo>
                    <a:pt x="2860154" y="657987"/>
                  </a:lnTo>
                  <a:close/>
                </a:path>
                <a:path w="4074159" h="1136650">
                  <a:moveTo>
                    <a:pt x="2912999" y="568325"/>
                  </a:moveTo>
                  <a:lnTo>
                    <a:pt x="2902585" y="568325"/>
                  </a:lnTo>
                  <a:lnTo>
                    <a:pt x="2902585" y="1136650"/>
                  </a:lnTo>
                  <a:lnTo>
                    <a:pt x="2912999" y="1136650"/>
                  </a:lnTo>
                  <a:lnTo>
                    <a:pt x="2912999" y="568325"/>
                  </a:lnTo>
                  <a:close/>
                </a:path>
                <a:path w="4074159" h="1136650">
                  <a:moveTo>
                    <a:pt x="2971038" y="328930"/>
                  </a:moveTo>
                  <a:lnTo>
                    <a:pt x="2960624" y="328930"/>
                  </a:lnTo>
                  <a:lnTo>
                    <a:pt x="2960624" y="1136650"/>
                  </a:lnTo>
                  <a:lnTo>
                    <a:pt x="2971038" y="1136650"/>
                  </a:lnTo>
                  <a:lnTo>
                    <a:pt x="2971038" y="328930"/>
                  </a:lnTo>
                  <a:close/>
                </a:path>
                <a:path w="4074159" h="1136650">
                  <a:moveTo>
                    <a:pt x="3029077" y="209296"/>
                  </a:moveTo>
                  <a:lnTo>
                    <a:pt x="3018663" y="209296"/>
                  </a:lnTo>
                  <a:lnTo>
                    <a:pt x="3018663" y="1136650"/>
                  </a:lnTo>
                  <a:lnTo>
                    <a:pt x="3029077" y="1136650"/>
                  </a:lnTo>
                  <a:lnTo>
                    <a:pt x="3029077" y="209296"/>
                  </a:lnTo>
                  <a:close/>
                </a:path>
                <a:path w="4074159" h="1136650">
                  <a:moveTo>
                    <a:pt x="3087116" y="538353"/>
                  </a:moveTo>
                  <a:lnTo>
                    <a:pt x="3076702" y="538353"/>
                  </a:lnTo>
                  <a:lnTo>
                    <a:pt x="3076702" y="1136650"/>
                  </a:lnTo>
                  <a:lnTo>
                    <a:pt x="3087116" y="1136650"/>
                  </a:lnTo>
                  <a:lnTo>
                    <a:pt x="3087116" y="538353"/>
                  </a:lnTo>
                  <a:close/>
                </a:path>
                <a:path w="4074159" h="1136650">
                  <a:moveTo>
                    <a:pt x="3145155" y="568325"/>
                  </a:moveTo>
                  <a:lnTo>
                    <a:pt x="3134741" y="568325"/>
                  </a:lnTo>
                  <a:lnTo>
                    <a:pt x="3134741" y="1136650"/>
                  </a:lnTo>
                  <a:lnTo>
                    <a:pt x="3145155" y="1136650"/>
                  </a:lnTo>
                  <a:lnTo>
                    <a:pt x="3145155" y="568325"/>
                  </a:lnTo>
                  <a:close/>
                </a:path>
                <a:path w="4074159" h="1136650">
                  <a:moveTo>
                    <a:pt x="3203194" y="747776"/>
                  </a:moveTo>
                  <a:lnTo>
                    <a:pt x="3192780" y="747776"/>
                  </a:lnTo>
                  <a:lnTo>
                    <a:pt x="3192780" y="1136650"/>
                  </a:lnTo>
                  <a:lnTo>
                    <a:pt x="3203194" y="1136650"/>
                  </a:lnTo>
                  <a:lnTo>
                    <a:pt x="3203194" y="747776"/>
                  </a:lnTo>
                  <a:close/>
                </a:path>
                <a:path w="4074159" h="1136650">
                  <a:moveTo>
                    <a:pt x="3261360" y="358902"/>
                  </a:moveTo>
                  <a:lnTo>
                    <a:pt x="3250946" y="358902"/>
                  </a:lnTo>
                  <a:lnTo>
                    <a:pt x="3250946" y="1136650"/>
                  </a:lnTo>
                  <a:lnTo>
                    <a:pt x="3261360" y="1136650"/>
                  </a:lnTo>
                  <a:lnTo>
                    <a:pt x="3261360" y="358902"/>
                  </a:lnTo>
                  <a:close/>
                </a:path>
                <a:path w="4074159" h="1136650">
                  <a:moveTo>
                    <a:pt x="3319399" y="508508"/>
                  </a:moveTo>
                  <a:lnTo>
                    <a:pt x="3308985" y="508508"/>
                  </a:lnTo>
                  <a:lnTo>
                    <a:pt x="3308985" y="1136650"/>
                  </a:lnTo>
                  <a:lnTo>
                    <a:pt x="3319399" y="1136650"/>
                  </a:lnTo>
                  <a:lnTo>
                    <a:pt x="3319399" y="508508"/>
                  </a:lnTo>
                  <a:close/>
                </a:path>
                <a:path w="4074159" h="1136650">
                  <a:moveTo>
                    <a:pt x="3377438" y="538353"/>
                  </a:moveTo>
                  <a:lnTo>
                    <a:pt x="3367024" y="538353"/>
                  </a:lnTo>
                  <a:lnTo>
                    <a:pt x="3367024" y="1136650"/>
                  </a:lnTo>
                  <a:lnTo>
                    <a:pt x="3377438" y="1136650"/>
                  </a:lnTo>
                  <a:lnTo>
                    <a:pt x="3377438" y="538353"/>
                  </a:lnTo>
                  <a:close/>
                </a:path>
                <a:path w="4074159" h="1136650">
                  <a:moveTo>
                    <a:pt x="3435477" y="388874"/>
                  </a:moveTo>
                  <a:lnTo>
                    <a:pt x="3425063" y="388874"/>
                  </a:lnTo>
                  <a:lnTo>
                    <a:pt x="3425063" y="1136650"/>
                  </a:lnTo>
                  <a:lnTo>
                    <a:pt x="3435477" y="1136650"/>
                  </a:lnTo>
                  <a:lnTo>
                    <a:pt x="3435477" y="388874"/>
                  </a:lnTo>
                  <a:close/>
                </a:path>
                <a:path w="4074159" h="1136650">
                  <a:moveTo>
                    <a:pt x="3493516" y="508508"/>
                  </a:moveTo>
                  <a:lnTo>
                    <a:pt x="3483102" y="508508"/>
                  </a:lnTo>
                  <a:lnTo>
                    <a:pt x="3483102" y="1136650"/>
                  </a:lnTo>
                  <a:lnTo>
                    <a:pt x="3493516" y="1136650"/>
                  </a:lnTo>
                  <a:lnTo>
                    <a:pt x="3493516" y="508508"/>
                  </a:lnTo>
                  <a:close/>
                </a:path>
                <a:path w="4074159" h="1136650">
                  <a:moveTo>
                    <a:pt x="3551555" y="628142"/>
                  </a:moveTo>
                  <a:lnTo>
                    <a:pt x="3541141" y="628142"/>
                  </a:lnTo>
                  <a:lnTo>
                    <a:pt x="3541141" y="1136650"/>
                  </a:lnTo>
                  <a:lnTo>
                    <a:pt x="3551555" y="1136650"/>
                  </a:lnTo>
                  <a:lnTo>
                    <a:pt x="3551555" y="628142"/>
                  </a:lnTo>
                  <a:close/>
                </a:path>
                <a:path w="4074159" h="1136650">
                  <a:moveTo>
                    <a:pt x="3609594" y="418719"/>
                  </a:moveTo>
                  <a:lnTo>
                    <a:pt x="3599180" y="418719"/>
                  </a:lnTo>
                  <a:lnTo>
                    <a:pt x="3599180" y="1136650"/>
                  </a:lnTo>
                  <a:lnTo>
                    <a:pt x="3609594" y="1136650"/>
                  </a:lnTo>
                  <a:lnTo>
                    <a:pt x="3609594" y="418719"/>
                  </a:lnTo>
                  <a:close/>
                </a:path>
                <a:path w="4074159" h="1136650">
                  <a:moveTo>
                    <a:pt x="3667633" y="239268"/>
                  </a:moveTo>
                  <a:lnTo>
                    <a:pt x="3657219" y="239268"/>
                  </a:lnTo>
                  <a:lnTo>
                    <a:pt x="3657219" y="1136650"/>
                  </a:lnTo>
                  <a:lnTo>
                    <a:pt x="3667633" y="1136650"/>
                  </a:lnTo>
                  <a:lnTo>
                    <a:pt x="3667633" y="239268"/>
                  </a:lnTo>
                  <a:close/>
                </a:path>
                <a:path w="4074159" h="1136650">
                  <a:moveTo>
                    <a:pt x="3725672" y="299085"/>
                  </a:moveTo>
                  <a:lnTo>
                    <a:pt x="3715258" y="299085"/>
                  </a:lnTo>
                  <a:lnTo>
                    <a:pt x="3715258" y="1136650"/>
                  </a:lnTo>
                  <a:lnTo>
                    <a:pt x="3725672" y="1136650"/>
                  </a:lnTo>
                  <a:lnTo>
                    <a:pt x="3725672" y="299085"/>
                  </a:lnTo>
                  <a:close/>
                </a:path>
                <a:path w="4074159" h="1136650">
                  <a:moveTo>
                    <a:pt x="3783838" y="538353"/>
                  </a:moveTo>
                  <a:lnTo>
                    <a:pt x="3773424" y="538353"/>
                  </a:lnTo>
                  <a:lnTo>
                    <a:pt x="3773424" y="1136650"/>
                  </a:lnTo>
                  <a:lnTo>
                    <a:pt x="3783838" y="1136650"/>
                  </a:lnTo>
                  <a:lnTo>
                    <a:pt x="3783838" y="538353"/>
                  </a:lnTo>
                  <a:close/>
                </a:path>
                <a:path w="4074159" h="1136650">
                  <a:moveTo>
                    <a:pt x="3841877" y="628142"/>
                  </a:moveTo>
                  <a:lnTo>
                    <a:pt x="3831463" y="628142"/>
                  </a:lnTo>
                  <a:lnTo>
                    <a:pt x="3831463" y="1136650"/>
                  </a:lnTo>
                  <a:lnTo>
                    <a:pt x="3841877" y="1136650"/>
                  </a:lnTo>
                  <a:lnTo>
                    <a:pt x="3841877" y="628142"/>
                  </a:lnTo>
                  <a:close/>
                </a:path>
                <a:path w="4074159" h="1136650">
                  <a:moveTo>
                    <a:pt x="3899916" y="717804"/>
                  </a:moveTo>
                  <a:lnTo>
                    <a:pt x="3889502" y="717804"/>
                  </a:lnTo>
                  <a:lnTo>
                    <a:pt x="3889502" y="1136650"/>
                  </a:lnTo>
                  <a:lnTo>
                    <a:pt x="3899916" y="1136650"/>
                  </a:lnTo>
                  <a:lnTo>
                    <a:pt x="3899916" y="717804"/>
                  </a:lnTo>
                  <a:close/>
                </a:path>
                <a:path w="4074159" h="1136650">
                  <a:moveTo>
                    <a:pt x="3957955" y="687959"/>
                  </a:moveTo>
                  <a:lnTo>
                    <a:pt x="3947541" y="687959"/>
                  </a:lnTo>
                  <a:lnTo>
                    <a:pt x="3947541" y="1136650"/>
                  </a:lnTo>
                  <a:lnTo>
                    <a:pt x="3957955" y="1136650"/>
                  </a:lnTo>
                  <a:lnTo>
                    <a:pt x="3957955" y="687959"/>
                  </a:lnTo>
                  <a:close/>
                </a:path>
                <a:path w="4074159" h="1136650">
                  <a:moveTo>
                    <a:pt x="4015994" y="448691"/>
                  </a:moveTo>
                  <a:lnTo>
                    <a:pt x="4005580" y="448691"/>
                  </a:lnTo>
                  <a:lnTo>
                    <a:pt x="4005580" y="1136650"/>
                  </a:lnTo>
                  <a:lnTo>
                    <a:pt x="4015994" y="1136650"/>
                  </a:lnTo>
                  <a:lnTo>
                    <a:pt x="4015994" y="448691"/>
                  </a:lnTo>
                  <a:close/>
                </a:path>
                <a:path w="4074159" h="1136650">
                  <a:moveTo>
                    <a:pt x="4074033" y="687959"/>
                  </a:moveTo>
                  <a:lnTo>
                    <a:pt x="4063619" y="687959"/>
                  </a:lnTo>
                  <a:lnTo>
                    <a:pt x="4063619" y="1136650"/>
                  </a:lnTo>
                  <a:lnTo>
                    <a:pt x="4074033" y="1136650"/>
                  </a:lnTo>
                  <a:lnTo>
                    <a:pt x="4074033" y="687959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9" name="object 99" descr=""/>
            <p:cNvSpPr/>
            <p:nvPr/>
          </p:nvSpPr>
          <p:spPr>
            <a:xfrm>
              <a:off x="9262491" y="7735062"/>
              <a:ext cx="4079875" cy="927735"/>
            </a:xfrm>
            <a:custGeom>
              <a:avLst/>
              <a:gdLst/>
              <a:ahLst/>
              <a:cxnLst/>
              <a:rect l="l" t="t" r="r" b="b"/>
              <a:pathLst>
                <a:path w="4079875" h="927734">
                  <a:moveTo>
                    <a:pt x="10414" y="478663"/>
                  </a:moveTo>
                  <a:lnTo>
                    <a:pt x="0" y="478663"/>
                  </a:lnTo>
                  <a:lnTo>
                    <a:pt x="0" y="927354"/>
                  </a:lnTo>
                  <a:lnTo>
                    <a:pt x="10414" y="927354"/>
                  </a:lnTo>
                  <a:lnTo>
                    <a:pt x="10414" y="478663"/>
                  </a:lnTo>
                  <a:close/>
                </a:path>
                <a:path w="4079875" h="927734">
                  <a:moveTo>
                    <a:pt x="68453" y="149606"/>
                  </a:moveTo>
                  <a:lnTo>
                    <a:pt x="58039" y="149606"/>
                  </a:lnTo>
                  <a:lnTo>
                    <a:pt x="58039" y="927354"/>
                  </a:lnTo>
                  <a:lnTo>
                    <a:pt x="68453" y="927354"/>
                  </a:lnTo>
                  <a:lnTo>
                    <a:pt x="68453" y="149606"/>
                  </a:lnTo>
                  <a:close/>
                </a:path>
                <a:path w="4079875" h="927734">
                  <a:moveTo>
                    <a:pt x="126492" y="209423"/>
                  </a:moveTo>
                  <a:lnTo>
                    <a:pt x="116078" y="209423"/>
                  </a:lnTo>
                  <a:lnTo>
                    <a:pt x="116078" y="927354"/>
                  </a:lnTo>
                  <a:lnTo>
                    <a:pt x="126492" y="927354"/>
                  </a:lnTo>
                  <a:lnTo>
                    <a:pt x="126492" y="209423"/>
                  </a:lnTo>
                  <a:close/>
                </a:path>
                <a:path w="4079875" h="927734">
                  <a:moveTo>
                    <a:pt x="184531" y="418846"/>
                  </a:moveTo>
                  <a:lnTo>
                    <a:pt x="174117" y="418846"/>
                  </a:lnTo>
                  <a:lnTo>
                    <a:pt x="174117" y="927354"/>
                  </a:lnTo>
                  <a:lnTo>
                    <a:pt x="184531" y="927354"/>
                  </a:lnTo>
                  <a:lnTo>
                    <a:pt x="184531" y="418846"/>
                  </a:lnTo>
                  <a:close/>
                </a:path>
                <a:path w="4079875" h="927734">
                  <a:moveTo>
                    <a:pt x="242570" y="269240"/>
                  </a:moveTo>
                  <a:lnTo>
                    <a:pt x="232156" y="269240"/>
                  </a:lnTo>
                  <a:lnTo>
                    <a:pt x="232156" y="927354"/>
                  </a:lnTo>
                  <a:lnTo>
                    <a:pt x="242570" y="927354"/>
                  </a:lnTo>
                  <a:lnTo>
                    <a:pt x="242570" y="269240"/>
                  </a:lnTo>
                  <a:close/>
                </a:path>
                <a:path w="4079875" h="927734">
                  <a:moveTo>
                    <a:pt x="300736" y="299212"/>
                  </a:moveTo>
                  <a:lnTo>
                    <a:pt x="290322" y="299212"/>
                  </a:lnTo>
                  <a:lnTo>
                    <a:pt x="290322" y="927354"/>
                  </a:lnTo>
                  <a:lnTo>
                    <a:pt x="300736" y="927354"/>
                  </a:lnTo>
                  <a:lnTo>
                    <a:pt x="300736" y="299212"/>
                  </a:lnTo>
                  <a:close/>
                </a:path>
                <a:path w="4079875" h="927734">
                  <a:moveTo>
                    <a:pt x="358775" y="29972"/>
                  </a:moveTo>
                  <a:lnTo>
                    <a:pt x="348361" y="29972"/>
                  </a:lnTo>
                  <a:lnTo>
                    <a:pt x="348361" y="927354"/>
                  </a:lnTo>
                  <a:lnTo>
                    <a:pt x="358775" y="927354"/>
                  </a:lnTo>
                  <a:lnTo>
                    <a:pt x="358775" y="29972"/>
                  </a:lnTo>
                  <a:close/>
                </a:path>
                <a:path w="4079875" h="927734">
                  <a:moveTo>
                    <a:pt x="416814" y="149606"/>
                  </a:moveTo>
                  <a:lnTo>
                    <a:pt x="406400" y="149606"/>
                  </a:lnTo>
                  <a:lnTo>
                    <a:pt x="406400" y="927354"/>
                  </a:lnTo>
                  <a:lnTo>
                    <a:pt x="416814" y="927354"/>
                  </a:lnTo>
                  <a:lnTo>
                    <a:pt x="416814" y="149606"/>
                  </a:lnTo>
                  <a:close/>
                </a:path>
                <a:path w="4079875" h="927734">
                  <a:moveTo>
                    <a:pt x="474853" y="0"/>
                  </a:moveTo>
                  <a:lnTo>
                    <a:pt x="464439" y="0"/>
                  </a:lnTo>
                  <a:lnTo>
                    <a:pt x="464439" y="927354"/>
                  </a:lnTo>
                  <a:lnTo>
                    <a:pt x="474853" y="927354"/>
                  </a:lnTo>
                  <a:lnTo>
                    <a:pt x="474853" y="0"/>
                  </a:lnTo>
                  <a:close/>
                </a:path>
                <a:path w="4079875" h="927734">
                  <a:moveTo>
                    <a:pt x="532892" y="299212"/>
                  </a:moveTo>
                  <a:lnTo>
                    <a:pt x="522478" y="299212"/>
                  </a:lnTo>
                  <a:lnTo>
                    <a:pt x="522478" y="927354"/>
                  </a:lnTo>
                  <a:lnTo>
                    <a:pt x="532892" y="927354"/>
                  </a:lnTo>
                  <a:lnTo>
                    <a:pt x="532892" y="299212"/>
                  </a:lnTo>
                  <a:close/>
                </a:path>
                <a:path w="4079875" h="927734">
                  <a:moveTo>
                    <a:pt x="590931" y="478663"/>
                  </a:moveTo>
                  <a:lnTo>
                    <a:pt x="580517" y="478663"/>
                  </a:lnTo>
                  <a:lnTo>
                    <a:pt x="580517" y="927354"/>
                  </a:lnTo>
                  <a:lnTo>
                    <a:pt x="590931" y="927354"/>
                  </a:lnTo>
                  <a:lnTo>
                    <a:pt x="590931" y="478663"/>
                  </a:lnTo>
                  <a:close/>
                </a:path>
                <a:path w="4079875" h="927734">
                  <a:moveTo>
                    <a:pt x="648970" y="299212"/>
                  </a:moveTo>
                  <a:lnTo>
                    <a:pt x="638556" y="299212"/>
                  </a:lnTo>
                  <a:lnTo>
                    <a:pt x="638556" y="927354"/>
                  </a:lnTo>
                  <a:lnTo>
                    <a:pt x="648970" y="927354"/>
                  </a:lnTo>
                  <a:lnTo>
                    <a:pt x="648970" y="299212"/>
                  </a:lnTo>
                  <a:close/>
                </a:path>
                <a:path w="4079875" h="927734">
                  <a:moveTo>
                    <a:pt x="707009" y="478663"/>
                  </a:moveTo>
                  <a:lnTo>
                    <a:pt x="696595" y="478663"/>
                  </a:lnTo>
                  <a:lnTo>
                    <a:pt x="696595" y="927354"/>
                  </a:lnTo>
                  <a:lnTo>
                    <a:pt x="707009" y="927354"/>
                  </a:lnTo>
                  <a:lnTo>
                    <a:pt x="707009" y="478663"/>
                  </a:lnTo>
                  <a:close/>
                </a:path>
                <a:path w="4079875" h="927734">
                  <a:moveTo>
                    <a:pt x="765048" y="329057"/>
                  </a:moveTo>
                  <a:lnTo>
                    <a:pt x="754634" y="329057"/>
                  </a:lnTo>
                  <a:lnTo>
                    <a:pt x="754634" y="927354"/>
                  </a:lnTo>
                  <a:lnTo>
                    <a:pt x="765048" y="927354"/>
                  </a:lnTo>
                  <a:lnTo>
                    <a:pt x="765048" y="329057"/>
                  </a:lnTo>
                  <a:close/>
                </a:path>
                <a:path w="4079875" h="927734">
                  <a:moveTo>
                    <a:pt x="828421" y="658114"/>
                  </a:moveTo>
                  <a:lnTo>
                    <a:pt x="815340" y="658114"/>
                  </a:lnTo>
                  <a:lnTo>
                    <a:pt x="815340" y="927354"/>
                  </a:lnTo>
                  <a:lnTo>
                    <a:pt x="828421" y="927354"/>
                  </a:lnTo>
                  <a:lnTo>
                    <a:pt x="828421" y="658114"/>
                  </a:lnTo>
                  <a:close/>
                </a:path>
                <a:path w="4079875" h="927734">
                  <a:moveTo>
                    <a:pt x="881253" y="329057"/>
                  </a:moveTo>
                  <a:lnTo>
                    <a:pt x="870839" y="329057"/>
                  </a:lnTo>
                  <a:lnTo>
                    <a:pt x="870839" y="927354"/>
                  </a:lnTo>
                  <a:lnTo>
                    <a:pt x="881253" y="927354"/>
                  </a:lnTo>
                  <a:lnTo>
                    <a:pt x="881253" y="329057"/>
                  </a:lnTo>
                  <a:close/>
                </a:path>
                <a:path w="4079875" h="927734">
                  <a:moveTo>
                    <a:pt x="939292" y="299212"/>
                  </a:moveTo>
                  <a:lnTo>
                    <a:pt x="928878" y="299212"/>
                  </a:lnTo>
                  <a:lnTo>
                    <a:pt x="928878" y="927354"/>
                  </a:lnTo>
                  <a:lnTo>
                    <a:pt x="939292" y="927354"/>
                  </a:lnTo>
                  <a:lnTo>
                    <a:pt x="939292" y="299212"/>
                  </a:lnTo>
                  <a:close/>
                </a:path>
                <a:path w="4079875" h="927734">
                  <a:moveTo>
                    <a:pt x="997331" y="478663"/>
                  </a:moveTo>
                  <a:lnTo>
                    <a:pt x="986917" y="478663"/>
                  </a:lnTo>
                  <a:lnTo>
                    <a:pt x="986917" y="927354"/>
                  </a:lnTo>
                  <a:lnTo>
                    <a:pt x="997331" y="927354"/>
                  </a:lnTo>
                  <a:lnTo>
                    <a:pt x="997331" y="478663"/>
                  </a:lnTo>
                  <a:close/>
                </a:path>
                <a:path w="4079875" h="927734">
                  <a:moveTo>
                    <a:pt x="1055370" y="448691"/>
                  </a:moveTo>
                  <a:lnTo>
                    <a:pt x="1044956" y="448691"/>
                  </a:lnTo>
                  <a:lnTo>
                    <a:pt x="1044956" y="927354"/>
                  </a:lnTo>
                  <a:lnTo>
                    <a:pt x="1055370" y="927354"/>
                  </a:lnTo>
                  <a:lnTo>
                    <a:pt x="1055370" y="448691"/>
                  </a:lnTo>
                  <a:close/>
                </a:path>
                <a:path w="4079875" h="927734">
                  <a:moveTo>
                    <a:pt x="1113409" y="388874"/>
                  </a:moveTo>
                  <a:lnTo>
                    <a:pt x="1102995" y="388874"/>
                  </a:lnTo>
                  <a:lnTo>
                    <a:pt x="1102995" y="927354"/>
                  </a:lnTo>
                  <a:lnTo>
                    <a:pt x="1113409" y="927354"/>
                  </a:lnTo>
                  <a:lnTo>
                    <a:pt x="1113409" y="388874"/>
                  </a:lnTo>
                  <a:close/>
                </a:path>
                <a:path w="4079875" h="927734">
                  <a:moveTo>
                    <a:pt x="1171448" y="179578"/>
                  </a:moveTo>
                  <a:lnTo>
                    <a:pt x="1161034" y="179578"/>
                  </a:lnTo>
                  <a:lnTo>
                    <a:pt x="1161034" y="927354"/>
                  </a:lnTo>
                  <a:lnTo>
                    <a:pt x="1171448" y="927354"/>
                  </a:lnTo>
                  <a:lnTo>
                    <a:pt x="1171448" y="179578"/>
                  </a:lnTo>
                  <a:close/>
                </a:path>
                <a:path w="4079875" h="927734">
                  <a:moveTo>
                    <a:pt x="1229487" y="149606"/>
                  </a:moveTo>
                  <a:lnTo>
                    <a:pt x="1219073" y="149606"/>
                  </a:lnTo>
                  <a:lnTo>
                    <a:pt x="1219073" y="927354"/>
                  </a:lnTo>
                  <a:lnTo>
                    <a:pt x="1229487" y="927354"/>
                  </a:lnTo>
                  <a:lnTo>
                    <a:pt x="1229487" y="149606"/>
                  </a:lnTo>
                  <a:close/>
                </a:path>
                <a:path w="4079875" h="927734">
                  <a:moveTo>
                    <a:pt x="1292860" y="658114"/>
                  </a:moveTo>
                  <a:lnTo>
                    <a:pt x="1279779" y="658114"/>
                  </a:lnTo>
                  <a:lnTo>
                    <a:pt x="1279779" y="927354"/>
                  </a:lnTo>
                  <a:lnTo>
                    <a:pt x="1292860" y="927354"/>
                  </a:lnTo>
                  <a:lnTo>
                    <a:pt x="1292860" y="658114"/>
                  </a:lnTo>
                  <a:close/>
                </a:path>
                <a:path w="4079875" h="927734">
                  <a:moveTo>
                    <a:pt x="1345692" y="388874"/>
                  </a:moveTo>
                  <a:lnTo>
                    <a:pt x="1335278" y="388874"/>
                  </a:lnTo>
                  <a:lnTo>
                    <a:pt x="1335278" y="927354"/>
                  </a:lnTo>
                  <a:lnTo>
                    <a:pt x="1345692" y="927354"/>
                  </a:lnTo>
                  <a:lnTo>
                    <a:pt x="1345692" y="388874"/>
                  </a:lnTo>
                  <a:close/>
                </a:path>
                <a:path w="4079875" h="927734">
                  <a:moveTo>
                    <a:pt x="1403731" y="448691"/>
                  </a:moveTo>
                  <a:lnTo>
                    <a:pt x="1393317" y="448691"/>
                  </a:lnTo>
                  <a:lnTo>
                    <a:pt x="1393317" y="927354"/>
                  </a:lnTo>
                  <a:lnTo>
                    <a:pt x="1403731" y="927354"/>
                  </a:lnTo>
                  <a:lnTo>
                    <a:pt x="1403731" y="448691"/>
                  </a:lnTo>
                  <a:close/>
                </a:path>
                <a:path w="4079875" h="927734">
                  <a:moveTo>
                    <a:pt x="1461770" y="478663"/>
                  </a:moveTo>
                  <a:lnTo>
                    <a:pt x="1451356" y="478663"/>
                  </a:lnTo>
                  <a:lnTo>
                    <a:pt x="1451356" y="927354"/>
                  </a:lnTo>
                  <a:lnTo>
                    <a:pt x="1461770" y="927354"/>
                  </a:lnTo>
                  <a:lnTo>
                    <a:pt x="1461770" y="478663"/>
                  </a:lnTo>
                  <a:close/>
                </a:path>
                <a:path w="4079875" h="927734">
                  <a:moveTo>
                    <a:pt x="1519809" y="329057"/>
                  </a:moveTo>
                  <a:lnTo>
                    <a:pt x="1509395" y="329057"/>
                  </a:lnTo>
                  <a:lnTo>
                    <a:pt x="1509395" y="927354"/>
                  </a:lnTo>
                  <a:lnTo>
                    <a:pt x="1519809" y="927354"/>
                  </a:lnTo>
                  <a:lnTo>
                    <a:pt x="1519809" y="329057"/>
                  </a:lnTo>
                  <a:close/>
                </a:path>
                <a:path w="4079875" h="927734">
                  <a:moveTo>
                    <a:pt x="1577848" y="598297"/>
                  </a:moveTo>
                  <a:lnTo>
                    <a:pt x="1567434" y="598297"/>
                  </a:lnTo>
                  <a:lnTo>
                    <a:pt x="1567434" y="927354"/>
                  </a:lnTo>
                  <a:lnTo>
                    <a:pt x="1577848" y="927354"/>
                  </a:lnTo>
                  <a:lnTo>
                    <a:pt x="1577848" y="598297"/>
                  </a:lnTo>
                  <a:close/>
                </a:path>
                <a:path w="4079875" h="927734">
                  <a:moveTo>
                    <a:pt x="1635887" y="269240"/>
                  </a:moveTo>
                  <a:lnTo>
                    <a:pt x="1625473" y="269240"/>
                  </a:lnTo>
                  <a:lnTo>
                    <a:pt x="1625473" y="927354"/>
                  </a:lnTo>
                  <a:lnTo>
                    <a:pt x="1635887" y="927354"/>
                  </a:lnTo>
                  <a:lnTo>
                    <a:pt x="1635887" y="269240"/>
                  </a:lnTo>
                  <a:close/>
                </a:path>
                <a:path w="4079875" h="927734">
                  <a:moveTo>
                    <a:pt x="1693926" y="299212"/>
                  </a:moveTo>
                  <a:lnTo>
                    <a:pt x="1683512" y="299212"/>
                  </a:lnTo>
                  <a:lnTo>
                    <a:pt x="1683512" y="927354"/>
                  </a:lnTo>
                  <a:lnTo>
                    <a:pt x="1693926" y="927354"/>
                  </a:lnTo>
                  <a:lnTo>
                    <a:pt x="1693926" y="299212"/>
                  </a:lnTo>
                  <a:close/>
                </a:path>
                <a:path w="4079875" h="927734">
                  <a:moveTo>
                    <a:pt x="1751965" y="239395"/>
                  </a:moveTo>
                  <a:lnTo>
                    <a:pt x="1741551" y="239395"/>
                  </a:lnTo>
                  <a:lnTo>
                    <a:pt x="1741551" y="927354"/>
                  </a:lnTo>
                  <a:lnTo>
                    <a:pt x="1751965" y="927354"/>
                  </a:lnTo>
                  <a:lnTo>
                    <a:pt x="1751965" y="239395"/>
                  </a:lnTo>
                  <a:close/>
                </a:path>
                <a:path w="4079875" h="927734">
                  <a:moveTo>
                    <a:pt x="1810004" y="538480"/>
                  </a:moveTo>
                  <a:lnTo>
                    <a:pt x="1799590" y="538480"/>
                  </a:lnTo>
                  <a:lnTo>
                    <a:pt x="1799590" y="927354"/>
                  </a:lnTo>
                  <a:lnTo>
                    <a:pt x="1810004" y="927354"/>
                  </a:lnTo>
                  <a:lnTo>
                    <a:pt x="1810004" y="538480"/>
                  </a:lnTo>
                  <a:close/>
                </a:path>
                <a:path w="4079875" h="927734">
                  <a:moveTo>
                    <a:pt x="1873364" y="478663"/>
                  </a:moveTo>
                  <a:lnTo>
                    <a:pt x="1860296" y="478663"/>
                  </a:lnTo>
                  <a:lnTo>
                    <a:pt x="1860296" y="927354"/>
                  </a:lnTo>
                  <a:lnTo>
                    <a:pt x="1873364" y="927354"/>
                  </a:lnTo>
                  <a:lnTo>
                    <a:pt x="1873364" y="478663"/>
                  </a:lnTo>
                  <a:close/>
                </a:path>
                <a:path w="4079875" h="927734">
                  <a:moveTo>
                    <a:pt x="1926209" y="329057"/>
                  </a:moveTo>
                  <a:lnTo>
                    <a:pt x="1915795" y="329057"/>
                  </a:lnTo>
                  <a:lnTo>
                    <a:pt x="1915795" y="927354"/>
                  </a:lnTo>
                  <a:lnTo>
                    <a:pt x="1926209" y="927354"/>
                  </a:lnTo>
                  <a:lnTo>
                    <a:pt x="1926209" y="329057"/>
                  </a:lnTo>
                  <a:close/>
                </a:path>
                <a:path w="4079875" h="927734">
                  <a:moveTo>
                    <a:pt x="1984248" y="388874"/>
                  </a:moveTo>
                  <a:lnTo>
                    <a:pt x="1973834" y="388874"/>
                  </a:lnTo>
                  <a:lnTo>
                    <a:pt x="1973834" y="927354"/>
                  </a:lnTo>
                  <a:lnTo>
                    <a:pt x="1984248" y="927354"/>
                  </a:lnTo>
                  <a:lnTo>
                    <a:pt x="1984248" y="388874"/>
                  </a:lnTo>
                  <a:close/>
                </a:path>
                <a:path w="4079875" h="927734">
                  <a:moveTo>
                    <a:pt x="2042287" y="329057"/>
                  </a:moveTo>
                  <a:lnTo>
                    <a:pt x="2031873" y="329057"/>
                  </a:lnTo>
                  <a:lnTo>
                    <a:pt x="2031873" y="927354"/>
                  </a:lnTo>
                  <a:lnTo>
                    <a:pt x="2042287" y="927354"/>
                  </a:lnTo>
                  <a:lnTo>
                    <a:pt x="2042287" y="329057"/>
                  </a:lnTo>
                  <a:close/>
                </a:path>
                <a:path w="4079875" h="927734">
                  <a:moveTo>
                    <a:pt x="2100326" y="628269"/>
                  </a:moveTo>
                  <a:lnTo>
                    <a:pt x="2089912" y="628269"/>
                  </a:lnTo>
                  <a:lnTo>
                    <a:pt x="2089912" y="927354"/>
                  </a:lnTo>
                  <a:lnTo>
                    <a:pt x="2100326" y="927354"/>
                  </a:lnTo>
                  <a:lnTo>
                    <a:pt x="2100326" y="628269"/>
                  </a:lnTo>
                  <a:close/>
                </a:path>
                <a:path w="4079875" h="927734">
                  <a:moveTo>
                    <a:pt x="2158365" y="89789"/>
                  </a:moveTo>
                  <a:lnTo>
                    <a:pt x="2147951" y="89789"/>
                  </a:lnTo>
                  <a:lnTo>
                    <a:pt x="2147951" y="927354"/>
                  </a:lnTo>
                  <a:lnTo>
                    <a:pt x="2158365" y="927354"/>
                  </a:lnTo>
                  <a:lnTo>
                    <a:pt x="2158365" y="89789"/>
                  </a:lnTo>
                  <a:close/>
                </a:path>
                <a:path w="4079875" h="927734">
                  <a:moveTo>
                    <a:pt x="2216404" y="388874"/>
                  </a:moveTo>
                  <a:lnTo>
                    <a:pt x="2205990" y="388874"/>
                  </a:lnTo>
                  <a:lnTo>
                    <a:pt x="2205990" y="927354"/>
                  </a:lnTo>
                  <a:lnTo>
                    <a:pt x="2216404" y="927354"/>
                  </a:lnTo>
                  <a:lnTo>
                    <a:pt x="2216404" y="388874"/>
                  </a:lnTo>
                  <a:close/>
                </a:path>
                <a:path w="4079875" h="927734">
                  <a:moveTo>
                    <a:pt x="2274443" y="658114"/>
                  </a:moveTo>
                  <a:lnTo>
                    <a:pt x="2264029" y="658114"/>
                  </a:lnTo>
                  <a:lnTo>
                    <a:pt x="2264029" y="927354"/>
                  </a:lnTo>
                  <a:lnTo>
                    <a:pt x="2274443" y="927354"/>
                  </a:lnTo>
                  <a:lnTo>
                    <a:pt x="2274443" y="658114"/>
                  </a:lnTo>
                  <a:close/>
                </a:path>
                <a:path w="4079875" h="927734">
                  <a:moveTo>
                    <a:pt x="2332482" y="598297"/>
                  </a:moveTo>
                  <a:lnTo>
                    <a:pt x="2322068" y="598297"/>
                  </a:lnTo>
                  <a:lnTo>
                    <a:pt x="2322068" y="927354"/>
                  </a:lnTo>
                  <a:lnTo>
                    <a:pt x="2332482" y="927354"/>
                  </a:lnTo>
                  <a:lnTo>
                    <a:pt x="2332482" y="598297"/>
                  </a:lnTo>
                  <a:close/>
                </a:path>
                <a:path w="4079875" h="927734">
                  <a:moveTo>
                    <a:pt x="2390521" y="418846"/>
                  </a:moveTo>
                  <a:lnTo>
                    <a:pt x="2380107" y="418846"/>
                  </a:lnTo>
                  <a:lnTo>
                    <a:pt x="2380107" y="927354"/>
                  </a:lnTo>
                  <a:lnTo>
                    <a:pt x="2390521" y="927354"/>
                  </a:lnTo>
                  <a:lnTo>
                    <a:pt x="2390521" y="418846"/>
                  </a:lnTo>
                  <a:close/>
                </a:path>
                <a:path w="4079875" h="927734">
                  <a:moveTo>
                    <a:pt x="2453894" y="538480"/>
                  </a:moveTo>
                  <a:lnTo>
                    <a:pt x="2440813" y="538480"/>
                  </a:lnTo>
                  <a:lnTo>
                    <a:pt x="2440813" y="927354"/>
                  </a:lnTo>
                  <a:lnTo>
                    <a:pt x="2453894" y="927354"/>
                  </a:lnTo>
                  <a:lnTo>
                    <a:pt x="2453894" y="538480"/>
                  </a:lnTo>
                  <a:close/>
                </a:path>
                <a:path w="4079875" h="927734">
                  <a:moveTo>
                    <a:pt x="2506726" y="478663"/>
                  </a:moveTo>
                  <a:lnTo>
                    <a:pt x="2496312" y="478663"/>
                  </a:lnTo>
                  <a:lnTo>
                    <a:pt x="2496312" y="927354"/>
                  </a:lnTo>
                  <a:lnTo>
                    <a:pt x="2506726" y="927354"/>
                  </a:lnTo>
                  <a:lnTo>
                    <a:pt x="2506726" y="478663"/>
                  </a:lnTo>
                  <a:close/>
                </a:path>
                <a:path w="4079875" h="927734">
                  <a:moveTo>
                    <a:pt x="2564765" y="508508"/>
                  </a:moveTo>
                  <a:lnTo>
                    <a:pt x="2554351" y="508508"/>
                  </a:lnTo>
                  <a:lnTo>
                    <a:pt x="2554351" y="927354"/>
                  </a:lnTo>
                  <a:lnTo>
                    <a:pt x="2564765" y="927354"/>
                  </a:lnTo>
                  <a:lnTo>
                    <a:pt x="2564765" y="508508"/>
                  </a:lnTo>
                  <a:close/>
                </a:path>
                <a:path w="4079875" h="927734">
                  <a:moveTo>
                    <a:pt x="2628011" y="777748"/>
                  </a:moveTo>
                  <a:lnTo>
                    <a:pt x="2614930" y="777748"/>
                  </a:lnTo>
                  <a:lnTo>
                    <a:pt x="2614930" y="927354"/>
                  </a:lnTo>
                  <a:lnTo>
                    <a:pt x="2628011" y="927354"/>
                  </a:lnTo>
                  <a:lnTo>
                    <a:pt x="2628011" y="777748"/>
                  </a:lnTo>
                  <a:close/>
                </a:path>
                <a:path w="4079875" h="927734">
                  <a:moveTo>
                    <a:pt x="2680843" y="717931"/>
                  </a:moveTo>
                  <a:lnTo>
                    <a:pt x="2670429" y="717931"/>
                  </a:lnTo>
                  <a:lnTo>
                    <a:pt x="2670429" y="927354"/>
                  </a:lnTo>
                  <a:lnTo>
                    <a:pt x="2680843" y="927354"/>
                  </a:lnTo>
                  <a:lnTo>
                    <a:pt x="2680843" y="717931"/>
                  </a:lnTo>
                  <a:close/>
                </a:path>
                <a:path w="4079875" h="927734">
                  <a:moveTo>
                    <a:pt x="2738882" y="658114"/>
                  </a:moveTo>
                  <a:lnTo>
                    <a:pt x="2728468" y="658114"/>
                  </a:lnTo>
                  <a:lnTo>
                    <a:pt x="2728468" y="927354"/>
                  </a:lnTo>
                  <a:lnTo>
                    <a:pt x="2738882" y="927354"/>
                  </a:lnTo>
                  <a:lnTo>
                    <a:pt x="2738882" y="658114"/>
                  </a:lnTo>
                  <a:close/>
                </a:path>
                <a:path w="4079875" h="927734">
                  <a:moveTo>
                    <a:pt x="2796921" y="628269"/>
                  </a:moveTo>
                  <a:lnTo>
                    <a:pt x="2786507" y="628269"/>
                  </a:lnTo>
                  <a:lnTo>
                    <a:pt x="2786507" y="927354"/>
                  </a:lnTo>
                  <a:lnTo>
                    <a:pt x="2796921" y="927354"/>
                  </a:lnTo>
                  <a:lnTo>
                    <a:pt x="2796921" y="628269"/>
                  </a:lnTo>
                  <a:close/>
                </a:path>
                <a:path w="4079875" h="927734">
                  <a:moveTo>
                    <a:pt x="2860294" y="628269"/>
                  </a:moveTo>
                  <a:lnTo>
                    <a:pt x="2847213" y="628269"/>
                  </a:lnTo>
                  <a:lnTo>
                    <a:pt x="2847213" y="927354"/>
                  </a:lnTo>
                  <a:lnTo>
                    <a:pt x="2860294" y="927354"/>
                  </a:lnTo>
                  <a:lnTo>
                    <a:pt x="2860294" y="628269"/>
                  </a:lnTo>
                  <a:close/>
                </a:path>
                <a:path w="4079875" h="927734">
                  <a:moveTo>
                    <a:pt x="2912999" y="658114"/>
                  </a:moveTo>
                  <a:lnTo>
                    <a:pt x="2902585" y="658114"/>
                  </a:lnTo>
                  <a:lnTo>
                    <a:pt x="2902585" y="927354"/>
                  </a:lnTo>
                  <a:lnTo>
                    <a:pt x="2912999" y="927354"/>
                  </a:lnTo>
                  <a:lnTo>
                    <a:pt x="2912999" y="658114"/>
                  </a:lnTo>
                  <a:close/>
                </a:path>
                <a:path w="4079875" h="927734">
                  <a:moveTo>
                    <a:pt x="2971038" y="867537"/>
                  </a:moveTo>
                  <a:lnTo>
                    <a:pt x="2960624" y="867537"/>
                  </a:lnTo>
                  <a:lnTo>
                    <a:pt x="2960624" y="927354"/>
                  </a:lnTo>
                  <a:lnTo>
                    <a:pt x="2971038" y="927354"/>
                  </a:lnTo>
                  <a:lnTo>
                    <a:pt x="2971038" y="867537"/>
                  </a:lnTo>
                  <a:close/>
                </a:path>
                <a:path w="4079875" h="927734">
                  <a:moveTo>
                    <a:pt x="3029204" y="359029"/>
                  </a:moveTo>
                  <a:lnTo>
                    <a:pt x="3018790" y="359029"/>
                  </a:lnTo>
                  <a:lnTo>
                    <a:pt x="3018790" y="927354"/>
                  </a:lnTo>
                  <a:lnTo>
                    <a:pt x="3029204" y="927354"/>
                  </a:lnTo>
                  <a:lnTo>
                    <a:pt x="3029204" y="359029"/>
                  </a:lnTo>
                  <a:close/>
                </a:path>
                <a:path w="4079875" h="927734">
                  <a:moveTo>
                    <a:pt x="3087243" y="388874"/>
                  </a:moveTo>
                  <a:lnTo>
                    <a:pt x="3076829" y="388874"/>
                  </a:lnTo>
                  <a:lnTo>
                    <a:pt x="3076829" y="927354"/>
                  </a:lnTo>
                  <a:lnTo>
                    <a:pt x="3087243" y="927354"/>
                  </a:lnTo>
                  <a:lnTo>
                    <a:pt x="3087243" y="388874"/>
                  </a:lnTo>
                  <a:close/>
                </a:path>
                <a:path w="4079875" h="927734">
                  <a:moveTo>
                    <a:pt x="3145282" y="239395"/>
                  </a:moveTo>
                  <a:lnTo>
                    <a:pt x="3134868" y="239395"/>
                  </a:lnTo>
                  <a:lnTo>
                    <a:pt x="3134868" y="927354"/>
                  </a:lnTo>
                  <a:lnTo>
                    <a:pt x="3145282" y="927354"/>
                  </a:lnTo>
                  <a:lnTo>
                    <a:pt x="3145282" y="239395"/>
                  </a:lnTo>
                  <a:close/>
                </a:path>
                <a:path w="4079875" h="927734">
                  <a:moveTo>
                    <a:pt x="3203321" y="538480"/>
                  </a:moveTo>
                  <a:lnTo>
                    <a:pt x="3192907" y="538480"/>
                  </a:lnTo>
                  <a:lnTo>
                    <a:pt x="3192907" y="927354"/>
                  </a:lnTo>
                  <a:lnTo>
                    <a:pt x="3203321" y="927354"/>
                  </a:lnTo>
                  <a:lnTo>
                    <a:pt x="3203321" y="538480"/>
                  </a:lnTo>
                  <a:close/>
                </a:path>
                <a:path w="4079875" h="927734">
                  <a:moveTo>
                    <a:pt x="3261360" y="717931"/>
                  </a:moveTo>
                  <a:lnTo>
                    <a:pt x="3250946" y="717931"/>
                  </a:lnTo>
                  <a:lnTo>
                    <a:pt x="3250946" y="927354"/>
                  </a:lnTo>
                  <a:lnTo>
                    <a:pt x="3261360" y="927354"/>
                  </a:lnTo>
                  <a:lnTo>
                    <a:pt x="3261360" y="717931"/>
                  </a:lnTo>
                  <a:close/>
                </a:path>
                <a:path w="4079875" h="927734">
                  <a:moveTo>
                    <a:pt x="3324733" y="538480"/>
                  </a:moveTo>
                  <a:lnTo>
                    <a:pt x="3311652" y="538480"/>
                  </a:lnTo>
                  <a:lnTo>
                    <a:pt x="3311652" y="927354"/>
                  </a:lnTo>
                  <a:lnTo>
                    <a:pt x="3324733" y="927354"/>
                  </a:lnTo>
                  <a:lnTo>
                    <a:pt x="3324733" y="538480"/>
                  </a:lnTo>
                  <a:close/>
                </a:path>
                <a:path w="4079875" h="927734">
                  <a:moveTo>
                    <a:pt x="3382759" y="598297"/>
                  </a:moveTo>
                  <a:lnTo>
                    <a:pt x="3369691" y="598297"/>
                  </a:lnTo>
                  <a:lnTo>
                    <a:pt x="3369691" y="927354"/>
                  </a:lnTo>
                  <a:lnTo>
                    <a:pt x="3382759" y="927354"/>
                  </a:lnTo>
                  <a:lnTo>
                    <a:pt x="3382759" y="598297"/>
                  </a:lnTo>
                  <a:close/>
                </a:path>
                <a:path w="4079875" h="927734">
                  <a:moveTo>
                    <a:pt x="3435477" y="269240"/>
                  </a:moveTo>
                  <a:lnTo>
                    <a:pt x="3425063" y="269240"/>
                  </a:lnTo>
                  <a:lnTo>
                    <a:pt x="3425063" y="927354"/>
                  </a:lnTo>
                  <a:lnTo>
                    <a:pt x="3435477" y="927354"/>
                  </a:lnTo>
                  <a:lnTo>
                    <a:pt x="3435477" y="269240"/>
                  </a:lnTo>
                  <a:close/>
                </a:path>
                <a:path w="4079875" h="927734">
                  <a:moveTo>
                    <a:pt x="3493516" y="568452"/>
                  </a:moveTo>
                  <a:lnTo>
                    <a:pt x="3483102" y="568452"/>
                  </a:lnTo>
                  <a:lnTo>
                    <a:pt x="3483102" y="927354"/>
                  </a:lnTo>
                  <a:lnTo>
                    <a:pt x="3493516" y="927354"/>
                  </a:lnTo>
                  <a:lnTo>
                    <a:pt x="3493516" y="568452"/>
                  </a:lnTo>
                  <a:close/>
                </a:path>
                <a:path w="4079875" h="927734">
                  <a:moveTo>
                    <a:pt x="3551682" y="538480"/>
                  </a:moveTo>
                  <a:lnTo>
                    <a:pt x="3541268" y="538480"/>
                  </a:lnTo>
                  <a:lnTo>
                    <a:pt x="3541268" y="927354"/>
                  </a:lnTo>
                  <a:lnTo>
                    <a:pt x="3551682" y="927354"/>
                  </a:lnTo>
                  <a:lnTo>
                    <a:pt x="3551682" y="538480"/>
                  </a:lnTo>
                  <a:close/>
                </a:path>
                <a:path w="4079875" h="927734">
                  <a:moveTo>
                    <a:pt x="3609721" y="688086"/>
                  </a:moveTo>
                  <a:lnTo>
                    <a:pt x="3599307" y="688086"/>
                  </a:lnTo>
                  <a:lnTo>
                    <a:pt x="3599307" y="927354"/>
                  </a:lnTo>
                  <a:lnTo>
                    <a:pt x="3609721" y="927354"/>
                  </a:lnTo>
                  <a:lnTo>
                    <a:pt x="3609721" y="688086"/>
                  </a:lnTo>
                  <a:close/>
                </a:path>
                <a:path w="4079875" h="927734">
                  <a:moveTo>
                    <a:pt x="3667760" y="717931"/>
                  </a:moveTo>
                  <a:lnTo>
                    <a:pt x="3657346" y="717931"/>
                  </a:lnTo>
                  <a:lnTo>
                    <a:pt x="3657346" y="927354"/>
                  </a:lnTo>
                  <a:lnTo>
                    <a:pt x="3667760" y="927354"/>
                  </a:lnTo>
                  <a:lnTo>
                    <a:pt x="3667760" y="717931"/>
                  </a:lnTo>
                  <a:close/>
                </a:path>
                <a:path w="4079875" h="927734">
                  <a:moveTo>
                    <a:pt x="3725799" y="688086"/>
                  </a:moveTo>
                  <a:lnTo>
                    <a:pt x="3715385" y="688086"/>
                  </a:lnTo>
                  <a:lnTo>
                    <a:pt x="3715385" y="927354"/>
                  </a:lnTo>
                  <a:lnTo>
                    <a:pt x="3725799" y="927354"/>
                  </a:lnTo>
                  <a:lnTo>
                    <a:pt x="3725799" y="688086"/>
                  </a:lnTo>
                  <a:close/>
                </a:path>
                <a:path w="4079875" h="927734">
                  <a:moveTo>
                    <a:pt x="3783838" y="598297"/>
                  </a:moveTo>
                  <a:lnTo>
                    <a:pt x="3773424" y="598297"/>
                  </a:lnTo>
                  <a:lnTo>
                    <a:pt x="3773424" y="927354"/>
                  </a:lnTo>
                  <a:lnTo>
                    <a:pt x="3783838" y="927354"/>
                  </a:lnTo>
                  <a:lnTo>
                    <a:pt x="3783838" y="598297"/>
                  </a:lnTo>
                  <a:close/>
                </a:path>
                <a:path w="4079875" h="927734">
                  <a:moveTo>
                    <a:pt x="3847211" y="508508"/>
                  </a:moveTo>
                  <a:lnTo>
                    <a:pt x="3834130" y="508508"/>
                  </a:lnTo>
                  <a:lnTo>
                    <a:pt x="3834130" y="927354"/>
                  </a:lnTo>
                  <a:lnTo>
                    <a:pt x="3847211" y="927354"/>
                  </a:lnTo>
                  <a:lnTo>
                    <a:pt x="3847211" y="508508"/>
                  </a:lnTo>
                  <a:close/>
                </a:path>
                <a:path w="4079875" h="927734">
                  <a:moveTo>
                    <a:pt x="3899903" y="658114"/>
                  </a:moveTo>
                  <a:lnTo>
                    <a:pt x="3889489" y="658114"/>
                  </a:lnTo>
                  <a:lnTo>
                    <a:pt x="3889489" y="927354"/>
                  </a:lnTo>
                  <a:lnTo>
                    <a:pt x="3899903" y="927354"/>
                  </a:lnTo>
                  <a:lnTo>
                    <a:pt x="3899903" y="658114"/>
                  </a:lnTo>
                  <a:close/>
                </a:path>
                <a:path w="4079875" h="927734">
                  <a:moveTo>
                    <a:pt x="3963276" y="807720"/>
                  </a:moveTo>
                  <a:lnTo>
                    <a:pt x="3950195" y="807720"/>
                  </a:lnTo>
                  <a:lnTo>
                    <a:pt x="3950195" y="927354"/>
                  </a:lnTo>
                  <a:lnTo>
                    <a:pt x="3963276" y="927354"/>
                  </a:lnTo>
                  <a:lnTo>
                    <a:pt x="3963276" y="807720"/>
                  </a:lnTo>
                  <a:close/>
                </a:path>
                <a:path w="4079875" h="927734">
                  <a:moveTo>
                    <a:pt x="4029951" y="717931"/>
                  </a:moveTo>
                  <a:lnTo>
                    <a:pt x="4012565" y="717931"/>
                  </a:lnTo>
                  <a:lnTo>
                    <a:pt x="4012565" y="927354"/>
                  </a:lnTo>
                  <a:lnTo>
                    <a:pt x="4029951" y="927354"/>
                  </a:lnTo>
                  <a:lnTo>
                    <a:pt x="4029951" y="717931"/>
                  </a:lnTo>
                  <a:close/>
                </a:path>
                <a:path w="4079875" h="927734">
                  <a:moveTo>
                    <a:pt x="4079367" y="448691"/>
                  </a:moveTo>
                  <a:lnTo>
                    <a:pt x="4066286" y="448691"/>
                  </a:lnTo>
                  <a:lnTo>
                    <a:pt x="4066286" y="927354"/>
                  </a:lnTo>
                  <a:lnTo>
                    <a:pt x="4079367" y="927354"/>
                  </a:lnTo>
                  <a:lnTo>
                    <a:pt x="4079367" y="448691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0" name="object 100" descr=""/>
            <p:cNvSpPr/>
            <p:nvPr/>
          </p:nvSpPr>
          <p:spPr>
            <a:xfrm>
              <a:off x="13328777" y="7944485"/>
              <a:ext cx="2277110" cy="718185"/>
            </a:xfrm>
            <a:custGeom>
              <a:avLst/>
              <a:gdLst/>
              <a:ahLst/>
              <a:cxnLst/>
              <a:rect l="l" t="t" r="r" b="b"/>
              <a:pathLst>
                <a:path w="2277109" h="718184">
                  <a:moveTo>
                    <a:pt x="13081" y="239268"/>
                  </a:moveTo>
                  <a:lnTo>
                    <a:pt x="0" y="239268"/>
                  </a:lnTo>
                  <a:lnTo>
                    <a:pt x="0" y="717931"/>
                  </a:lnTo>
                  <a:lnTo>
                    <a:pt x="13081" y="717931"/>
                  </a:lnTo>
                  <a:lnTo>
                    <a:pt x="13081" y="239268"/>
                  </a:lnTo>
                  <a:close/>
                </a:path>
                <a:path w="2277109" h="718184">
                  <a:moveTo>
                    <a:pt x="65913" y="329057"/>
                  </a:moveTo>
                  <a:lnTo>
                    <a:pt x="55499" y="329057"/>
                  </a:lnTo>
                  <a:lnTo>
                    <a:pt x="55499" y="717931"/>
                  </a:lnTo>
                  <a:lnTo>
                    <a:pt x="65913" y="717931"/>
                  </a:lnTo>
                  <a:lnTo>
                    <a:pt x="65913" y="329057"/>
                  </a:lnTo>
                  <a:close/>
                </a:path>
                <a:path w="2277109" h="718184">
                  <a:moveTo>
                    <a:pt x="123952" y="299085"/>
                  </a:moveTo>
                  <a:lnTo>
                    <a:pt x="113538" y="299085"/>
                  </a:lnTo>
                  <a:lnTo>
                    <a:pt x="113538" y="717931"/>
                  </a:lnTo>
                  <a:lnTo>
                    <a:pt x="123952" y="717931"/>
                  </a:lnTo>
                  <a:lnTo>
                    <a:pt x="123952" y="299085"/>
                  </a:lnTo>
                  <a:close/>
                </a:path>
                <a:path w="2277109" h="718184">
                  <a:moveTo>
                    <a:pt x="187198" y="59817"/>
                  </a:moveTo>
                  <a:lnTo>
                    <a:pt x="174117" y="59817"/>
                  </a:lnTo>
                  <a:lnTo>
                    <a:pt x="174117" y="717931"/>
                  </a:lnTo>
                  <a:lnTo>
                    <a:pt x="187198" y="717931"/>
                  </a:lnTo>
                  <a:lnTo>
                    <a:pt x="187198" y="59817"/>
                  </a:lnTo>
                  <a:close/>
                </a:path>
                <a:path w="2277109" h="718184">
                  <a:moveTo>
                    <a:pt x="245364" y="538480"/>
                  </a:moveTo>
                  <a:lnTo>
                    <a:pt x="232283" y="538480"/>
                  </a:lnTo>
                  <a:lnTo>
                    <a:pt x="232283" y="717931"/>
                  </a:lnTo>
                  <a:lnTo>
                    <a:pt x="245364" y="717931"/>
                  </a:lnTo>
                  <a:lnTo>
                    <a:pt x="245364" y="538480"/>
                  </a:lnTo>
                  <a:close/>
                </a:path>
                <a:path w="2277109" h="718184">
                  <a:moveTo>
                    <a:pt x="303390" y="598297"/>
                  </a:moveTo>
                  <a:lnTo>
                    <a:pt x="290322" y="598297"/>
                  </a:lnTo>
                  <a:lnTo>
                    <a:pt x="290322" y="717931"/>
                  </a:lnTo>
                  <a:lnTo>
                    <a:pt x="303390" y="717931"/>
                  </a:lnTo>
                  <a:lnTo>
                    <a:pt x="303390" y="598297"/>
                  </a:lnTo>
                  <a:close/>
                </a:path>
                <a:path w="2277109" h="718184">
                  <a:moveTo>
                    <a:pt x="361442" y="239268"/>
                  </a:moveTo>
                  <a:lnTo>
                    <a:pt x="348361" y="239268"/>
                  </a:lnTo>
                  <a:lnTo>
                    <a:pt x="348361" y="717931"/>
                  </a:lnTo>
                  <a:lnTo>
                    <a:pt x="361442" y="717931"/>
                  </a:lnTo>
                  <a:lnTo>
                    <a:pt x="361442" y="239268"/>
                  </a:lnTo>
                  <a:close/>
                </a:path>
                <a:path w="2277109" h="718184">
                  <a:moveTo>
                    <a:pt x="419481" y="149606"/>
                  </a:moveTo>
                  <a:lnTo>
                    <a:pt x="406400" y="149606"/>
                  </a:lnTo>
                  <a:lnTo>
                    <a:pt x="406400" y="717931"/>
                  </a:lnTo>
                  <a:lnTo>
                    <a:pt x="419481" y="717931"/>
                  </a:lnTo>
                  <a:lnTo>
                    <a:pt x="419481" y="149606"/>
                  </a:lnTo>
                  <a:close/>
                </a:path>
                <a:path w="2277109" h="718184">
                  <a:moveTo>
                    <a:pt x="477520" y="269240"/>
                  </a:moveTo>
                  <a:lnTo>
                    <a:pt x="464439" y="269240"/>
                  </a:lnTo>
                  <a:lnTo>
                    <a:pt x="464439" y="717931"/>
                  </a:lnTo>
                  <a:lnTo>
                    <a:pt x="477520" y="717931"/>
                  </a:lnTo>
                  <a:lnTo>
                    <a:pt x="477520" y="269240"/>
                  </a:lnTo>
                  <a:close/>
                </a:path>
                <a:path w="2277109" h="718184">
                  <a:moveTo>
                    <a:pt x="530225" y="359029"/>
                  </a:moveTo>
                  <a:lnTo>
                    <a:pt x="519811" y="359029"/>
                  </a:lnTo>
                  <a:lnTo>
                    <a:pt x="519811" y="717931"/>
                  </a:lnTo>
                  <a:lnTo>
                    <a:pt x="530225" y="717931"/>
                  </a:lnTo>
                  <a:lnTo>
                    <a:pt x="530225" y="359029"/>
                  </a:lnTo>
                  <a:close/>
                </a:path>
                <a:path w="2277109" h="718184">
                  <a:moveTo>
                    <a:pt x="588391" y="359029"/>
                  </a:moveTo>
                  <a:lnTo>
                    <a:pt x="577977" y="359029"/>
                  </a:lnTo>
                  <a:lnTo>
                    <a:pt x="577977" y="717931"/>
                  </a:lnTo>
                  <a:lnTo>
                    <a:pt x="588391" y="717931"/>
                  </a:lnTo>
                  <a:lnTo>
                    <a:pt x="588391" y="359029"/>
                  </a:lnTo>
                  <a:close/>
                </a:path>
                <a:path w="2277109" h="718184">
                  <a:moveTo>
                    <a:pt x="646417" y="359029"/>
                  </a:moveTo>
                  <a:lnTo>
                    <a:pt x="636016" y="359029"/>
                  </a:lnTo>
                  <a:lnTo>
                    <a:pt x="636016" y="717931"/>
                  </a:lnTo>
                  <a:lnTo>
                    <a:pt x="646417" y="717931"/>
                  </a:lnTo>
                  <a:lnTo>
                    <a:pt x="646417" y="359029"/>
                  </a:lnTo>
                  <a:close/>
                </a:path>
                <a:path w="2277109" h="718184">
                  <a:moveTo>
                    <a:pt x="704469" y="388874"/>
                  </a:moveTo>
                  <a:lnTo>
                    <a:pt x="694055" y="388874"/>
                  </a:lnTo>
                  <a:lnTo>
                    <a:pt x="694055" y="717931"/>
                  </a:lnTo>
                  <a:lnTo>
                    <a:pt x="704469" y="717931"/>
                  </a:lnTo>
                  <a:lnTo>
                    <a:pt x="704469" y="388874"/>
                  </a:lnTo>
                  <a:close/>
                </a:path>
                <a:path w="2277109" h="718184">
                  <a:moveTo>
                    <a:pt x="762508" y="508508"/>
                  </a:moveTo>
                  <a:lnTo>
                    <a:pt x="752094" y="508508"/>
                  </a:lnTo>
                  <a:lnTo>
                    <a:pt x="752094" y="717931"/>
                  </a:lnTo>
                  <a:lnTo>
                    <a:pt x="762508" y="717931"/>
                  </a:lnTo>
                  <a:lnTo>
                    <a:pt x="762508" y="508508"/>
                  </a:lnTo>
                  <a:close/>
                </a:path>
                <a:path w="2277109" h="718184">
                  <a:moveTo>
                    <a:pt x="820547" y="388874"/>
                  </a:moveTo>
                  <a:lnTo>
                    <a:pt x="810133" y="388874"/>
                  </a:lnTo>
                  <a:lnTo>
                    <a:pt x="810133" y="717931"/>
                  </a:lnTo>
                  <a:lnTo>
                    <a:pt x="820547" y="717931"/>
                  </a:lnTo>
                  <a:lnTo>
                    <a:pt x="820547" y="388874"/>
                  </a:lnTo>
                  <a:close/>
                </a:path>
                <a:path w="2277109" h="718184">
                  <a:moveTo>
                    <a:pt x="878573" y="299085"/>
                  </a:moveTo>
                  <a:lnTo>
                    <a:pt x="868172" y="299085"/>
                  </a:lnTo>
                  <a:lnTo>
                    <a:pt x="868172" y="717931"/>
                  </a:lnTo>
                  <a:lnTo>
                    <a:pt x="878573" y="717931"/>
                  </a:lnTo>
                  <a:lnTo>
                    <a:pt x="878573" y="299085"/>
                  </a:lnTo>
                  <a:close/>
                </a:path>
                <a:path w="2277109" h="718184">
                  <a:moveTo>
                    <a:pt x="936625" y="0"/>
                  </a:moveTo>
                  <a:lnTo>
                    <a:pt x="926211" y="0"/>
                  </a:lnTo>
                  <a:lnTo>
                    <a:pt x="926211" y="717931"/>
                  </a:lnTo>
                  <a:lnTo>
                    <a:pt x="936625" y="717931"/>
                  </a:lnTo>
                  <a:lnTo>
                    <a:pt x="936625" y="0"/>
                  </a:lnTo>
                  <a:close/>
                </a:path>
                <a:path w="2277109" h="718184">
                  <a:moveTo>
                    <a:pt x="999998" y="568325"/>
                  </a:moveTo>
                  <a:lnTo>
                    <a:pt x="986917" y="568325"/>
                  </a:lnTo>
                  <a:lnTo>
                    <a:pt x="986917" y="717931"/>
                  </a:lnTo>
                  <a:lnTo>
                    <a:pt x="999998" y="717931"/>
                  </a:lnTo>
                  <a:lnTo>
                    <a:pt x="999998" y="568325"/>
                  </a:lnTo>
                  <a:close/>
                </a:path>
                <a:path w="2277109" h="718184">
                  <a:moveTo>
                    <a:pt x="1066673" y="448691"/>
                  </a:moveTo>
                  <a:lnTo>
                    <a:pt x="1049274" y="448691"/>
                  </a:lnTo>
                  <a:lnTo>
                    <a:pt x="1049274" y="717931"/>
                  </a:lnTo>
                  <a:lnTo>
                    <a:pt x="1066673" y="717931"/>
                  </a:lnTo>
                  <a:lnTo>
                    <a:pt x="1066673" y="448691"/>
                  </a:lnTo>
                  <a:close/>
                </a:path>
                <a:path w="2277109" h="718184">
                  <a:moveTo>
                    <a:pt x="1116063" y="478663"/>
                  </a:moveTo>
                  <a:lnTo>
                    <a:pt x="1102995" y="478663"/>
                  </a:lnTo>
                  <a:lnTo>
                    <a:pt x="1102995" y="717931"/>
                  </a:lnTo>
                  <a:lnTo>
                    <a:pt x="1116063" y="717931"/>
                  </a:lnTo>
                  <a:lnTo>
                    <a:pt x="1116063" y="478663"/>
                  </a:lnTo>
                  <a:close/>
                </a:path>
                <a:path w="2277109" h="718184">
                  <a:moveTo>
                    <a:pt x="1168908" y="418846"/>
                  </a:moveTo>
                  <a:lnTo>
                    <a:pt x="1158494" y="418846"/>
                  </a:lnTo>
                  <a:lnTo>
                    <a:pt x="1158494" y="717931"/>
                  </a:lnTo>
                  <a:lnTo>
                    <a:pt x="1168908" y="717931"/>
                  </a:lnTo>
                  <a:lnTo>
                    <a:pt x="1168908" y="418846"/>
                  </a:lnTo>
                  <a:close/>
                </a:path>
                <a:path w="2277109" h="718184">
                  <a:moveTo>
                    <a:pt x="1226947" y="329057"/>
                  </a:moveTo>
                  <a:lnTo>
                    <a:pt x="1216533" y="329057"/>
                  </a:lnTo>
                  <a:lnTo>
                    <a:pt x="1216533" y="717931"/>
                  </a:lnTo>
                  <a:lnTo>
                    <a:pt x="1226947" y="717931"/>
                  </a:lnTo>
                  <a:lnTo>
                    <a:pt x="1226947" y="329057"/>
                  </a:lnTo>
                  <a:close/>
                </a:path>
                <a:path w="2277109" h="718184">
                  <a:moveTo>
                    <a:pt x="1298956" y="628142"/>
                  </a:moveTo>
                  <a:lnTo>
                    <a:pt x="1281557" y="628142"/>
                  </a:lnTo>
                  <a:lnTo>
                    <a:pt x="1281557" y="717931"/>
                  </a:lnTo>
                  <a:lnTo>
                    <a:pt x="1298956" y="717931"/>
                  </a:lnTo>
                  <a:lnTo>
                    <a:pt x="1298956" y="628142"/>
                  </a:lnTo>
                  <a:close/>
                </a:path>
                <a:path w="2277109" h="718184">
                  <a:moveTo>
                    <a:pt x="1348359" y="628142"/>
                  </a:moveTo>
                  <a:lnTo>
                    <a:pt x="1335278" y="628142"/>
                  </a:lnTo>
                  <a:lnTo>
                    <a:pt x="1335278" y="717931"/>
                  </a:lnTo>
                  <a:lnTo>
                    <a:pt x="1348359" y="717931"/>
                  </a:lnTo>
                  <a:lnTo>
                    <a:pt x="1348359" y="628142"/>
                  </a:lnTo>
                  <a:close/>
                </a:path>
                <a:path w="2277109" h="718184">
                  <a:moveTo>
                    <a:pt x="1401064" y="568325"/>
                  </a:moveTo>
                  <a:lnTo>
                    <a:pt x="1390650" y="568325"/>
                  </a:lnTo>
                  <a:lnTo>
                    <a:pt x="1390650" y="717931"/>
                  </a:lnTo>
                  <a:lnTo>
                    <a:pt x="1401064" y="717931"/>
                  </a:lnTo>
                  <a:lnTo>
                    <a:pt x="1401064" y="568325"/>
                  </a:lnTo>
                  <a:close/>
                </a:path>
                <a:path w="2277109" h="718184">
                  <a:moveTo>
                    <a:pt x="1464437" y="538480"/>
                  </a:moveTo>
                  <a:lnTo>
                    <a:pt x="1451356" y="538480"/>
                  </a:lnTo>
                  <a:lnTo>
                    <a:pt x="1451356" y="717931"/>
                  </a:lnTo>
                  <a:lnTo>
                    <a:pt x="1464437" y="717931"/>
                  </a:lnTo>
                  <a:lnTo>
                    <a:pt x="1464437" y="538480"/>
                  </a:lnTo>
                  <a:close/>
                </a:path>
                <a:path w="2277109" h="718184">
                  <a:moveTo>
                    <a:pt x="1517142" y="598297"/>
                  </a:moveTo>
                  <a:lnTo>
                    <a:pt x="1506728" y="598297"/>
                  </a:lnTo>
                  <a:lnTo>
                    <a:pt x="1506728" y="717931"/>
                  </a:lnTo>
                  <a:lnTo>
                    <a:pt x="1517142" y="717931"/>
                  </a:lnTo>
                  <a:lnTo>
                    <a:pt x="1517142" y="598297"/>
                  </a:lnTo>
                  <a:close/>
                </a:path>
                <a:path w="2277109" h="718184">
                  <a:moveTo>
                    <a:pt x="1589138" y="448691"/>
                  </a:moveTo>
                  <a:lnTo>
                    <a:pt x="1571752" y="448691"/>
                  </a:lnTo>
                  <a:lnTo>
                    <a:pt x="1571752" y="717931"/>
                  </a:lnTo>
                  <a:lnTo>
                    <a:pt x="1589138" y="717931"/>
                  </a:lnTo>
                  <a:lnTo>
                    <a:pt x="1589138" y="448691"/>
                  </a:lnTo>
                  <a:close/>
                </a:path>
                <a:path w="2277109" h="718184">
                  <a:moveTo>
                    <a:pt x="1638554" y="598297"/>
                  </a:moveTo>
                  <a:lnTo>
                    <a:pt x="1625473" y="598297"/>
                  </a:lnTo>
                  <a:lnTo>
                    <a:pt x="1625473" y="717931"/>
                  </a:lnTo>
                  <a:lnTo>
                    <a:pt x="1638554" y="717931"/>
                  </a:lnTo>
                  <a:lnTo>
                    <a:pt x="1638554" y="598297"/>
                  </a:lnTo>
                  <a:close/>
                </a:path>
                <a:path w="2277109" h="718184">
                  <a:moveTo>
                    <a:pt x="1696593" y="508508"/>
                  </a:moveTo>
                  <a:lnTo>
                    <a:pt x="1683512" y="508508"/>
                  </a:lnTo>
                  <a:lnTo>
                    <a:pt x="1683512" y="717931"/>
                  </a:lnTo>
                  <a:lnTo>
                    <a:pt x="1696593" y="717931"/>
                  </a:lnTo>
                  <a:lnTo>
                    <a:pt x="1696593" y="508508"/>
                  </a:lnTo>
                  <a:close/>
                </a:path>
                <a:path w="2277109" h="718184">
                  <a:moveTo>
                    <a:pt x="1763395" y="568325"/>
                  </a:moveTo>
                  <a:lnTo>
                    <a:pt x="1745996" y="568325"/>
                  </a:lnTo>
                  <a:lnTo>
                    <a:pt x="1745996" y="717931"/>
                  </a:lnTo>
                  <a:lnTo>
                    <a:pt x="1763395" y="717931"/>
                  </a:lnTo>
                  <a:lnTo>
                    <a:pt x="1763395" y="568325"/>
                  </a:lnTo>
                  <a:close/>
                </a:path>
                <a:path w="2277109" h="718184">
                  <a:moveTo>
                    <a:pt x="1812671" y="508508"/>
                  </a:moveTo>
                  <a:lnTo>
                    <a:pt x="1799590" y="508508"/>
                  </a:lnTo>
                  <a:lnTo>
                    <a:pt x="1799590" y="717931"/>
                  </a:lnTo>
                  <a:lnTo>
                    <a:pt x="1812671" y="717931"/>
                  </a:lnTo>
                  <a:lnTo>
                    <a:pt x="1812671" y="508508"/>
                  </a:lnTo>
                  <a:close/>
                </a:path>
                <a:path w="2277109" h="718184">
                  <a:moveTo>
                    <a:pt x="1870837" y="478663"/>
                  </a:moveTo>
                  <a:lnTo>
                    <a:pt x="1857756" y="478663"/>
                  </a:lnTo>
                  <a:lnTo>
                    <a:pt x="1857756" y="717931"/>
                  </a:lnTo>
                  <a:lnTo>
                    <a:pt x="1870837" y="717931"/>
                  </a:lnTo>
                  <a:lnTo>
                    <a:pt x="1870837" y="478663"/>
                  </a:lnTo>
                  <a:close/>
                </a:path>
                <a:path w="2277109" h="718184">
                  <a:moveTo>
                    <a:pt x="1954911" y="508508"/>
                  </a:moveTo>
                  <a:lnTo>
                    <a:pt x="1928749" y="508508"/>
                  </a:lnTo>
                  <a:lnTo>
                    <a:pt x="1928749" y="717931"/>
                  </a:lnTo>
                  <a:lnTo>
                    <a:pt x="1954911" y="717931"/>
                  </a:lnTo>
                  <a:lnTo>
                    <a:pt x="1954911" y="508508"/>
                  </a:lnTo>
                  <a:close/>
                </a:path>
                <a:path w="2277109" h="718184">
                  <a:moveTo>
                    <a:pt x="1986915" y="448691"/>
                  </a:moveTo>
                  <a:lnTo>
                    <a:pt x="1973834" y="448691"/>
                  </a:lnTo>
                  <a:lnTo>
                    <a:pt x="1973834" y="717931"/>
                  </a:lnTo>
                  <a:lnTo>
                    <a:pt x="1986915" y="717931"/>
                  </a:lnTo>
                  <a:lnTo>
                    <a:pt x="1986915" y="448691"/>
                  </a:lnTo>
                  <a:close/>
                </a:path>
                <a:path w="2277109" h="718184">
                  <a:moveTo>
                    <a:pt x="2044954" y="628142"/>
                  </a:moveTo>
                  <a:lnTo>
                    <a:pt x="2031873" y="628142"/>
                  </a:lnTo>
                  <a:lnTo>
                    <a:pt x="2031873" y="717931"/>
                  </a:lnTo>
                  <a:lnTo>
                    <a:pt x="2044954" y="717931"/>
                  </a:lnTo>
                  <a:lnTo>
                    <a:pt x="2044954" y="628142"/>
                  </a:lnTo>
                  <a:close/>
                </a:path>
                <a:path w="2277109" h="718184">
                  <a:moveTo>
                    <a:pt x="2111629" y="329057"/>
                  </a:moveTo>
                  <a:lnTo>
                    <a:pt x="2094230" y="329057"/>
                  </a:lnTo>
                  <a:lnTo>
                    <a:pt x="2094230" y="717931"/>
                  </a:lnTo>
                  <a:lnTo>
                    <a:pt x="2111629" y="717931"/>
                  </a:lnTo>
                  <a:lnTo>
                    <a:pt x="2111629" y="329057"/>
                  </a:lnTo>
                  <a:close/>
                </a:path>
                <a:path w="2277109" h="718184">
                  <a:moveTo>
                    <a:pt x="2169668" y="508508"/>
                  </a:moveTo>
                  <a:lnTo>
                    <a:pt x="2152269" y="508508"/>
                  </a:lnTo>
                  <a:lnTo>
                    <a:pt x="2152269" y="717931"/>
                  </a:lnTo>
                  <a:lnTo>
                    <a:pt x="2169668" y="717931"/>
                  </a:lnTo>
                  <a:lnTo>
                    <a:pt x="2169668" y="508508"/>
                  </a:lnTo>
                  <a:close/>
                </a:path>
                <a:path w="2277109" h="718184">
                  <a:moveTo>
                    <a:pt x="2227694" y="568325"/>
                  </a:moveTo>
                  <a:lnTo>
                    <a:pt x="2210308" y="568325"/>
                  </a:lnTo>
                  <a:lnTo>
                    <a:pt x="2210308" y="717931"/>
                  </a:lnTo>
                  <a:lnTo>
                    <a:pt x="2227694" y="717931"/>
                  </a:lnTo>
                  <a:lnTo>
                    <a:pt x="2227694" y="568325"/>
                  </a:lnTo>
                  <a:close/>
                </a:path>
                <a:path w="2277109" h="718184">
                  <a:moveTo>
                    <a:pt x="2277110" y="658114"/>
                  </a:moveTo>
                  <a:lnTo>
                    <a:pt x="2250948" y="658114"/>
                  </a:lnTo>
                  <a:lnTo>
                    <a:pt x="2250948" y="717931"/>
                  </a:lnTo>
                  <a:lnTo>
                    <a:pt x="2277110" y="717931"/>
                  </a:lnTo>
                  <a:lnTo>
                    <a:pt x="2277110" y="658114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1" name="object 101" descr=""/>
            <p:cNvSpPr/>
            <p:nvPr/>
          </p:nvSpPr>
          <p:spPr>
            <a:xfrm>
              <a:off x="1137793" y="7765034"/>
              <a:ext cx="4082415" cy="897890"/>
            </a:xfrm>
            <a:custGeom>
              <a:avLst/>
              <a:gdLst/>
              <a:ahLst/>
              <a:cxnLst/>
              <a:rect l="l" t="t" r="r" b="b"/>
              <a:pathLst>
                <a:path w="4082415" h="897890">
                  <a:moveTo>
                    <a:pt x="13081" y="867410"/>
                  </a:moveTo>
                  <a:lnTo>
                    <a:pt x="0" y="867410"/>
                  </a:lnTo>
                  <a:lnTo>
                    <a:pt x="0" y="897382"/>
                  </a:lnTo>
                  <a:lnTo>
                    <a:pt x="13081" y="897382"/>
                  </a:lnTo>
                  <a:lnTo>
                    <a:pt x="13081" y="867410"/>
                  </a:lnTo>
                  <a:close/>
                </a:path>
                <a:path w="4082415" h="897890">
                  <a:moveTo>
                    <a:pt x="71120" y="807593"/>
                  </a:moveTo>
                  <a:lnTo>
                    <a:pt x="58039" y="807593"/>
                  </a:lnTo>
                  <a:lnTo>
                    <a:pt x="58039" y="897382"/>
                  </a:lnTo>
                  <a:lnTo>
                    <a:pt x="71120" y="897382"/>
                  </a:lnTo>
                  <a:lnTo>
                    <a:pt x="71120" y="807593"/>
                  </a:lnTo>
                  <a:close/>
                </a:path>
                <a:path w="4082415" h="897890">
                  <a:moveTo>
                    <a:pt x="129159" y="747776"/>
                  </a:moveTo>
                  <a:lnTo>
                    <a:pt x="116078" y="747776"/>
                  </a:lnTo>
                  <a:lnTo>
                    <a:pt x="116078" y="897382"/>
                  </a:lnTo>
                  <a:lnTo>
                    <a:pt x="129159" y="897382"/>
                  </a:lnTo>
                  <a:lnTo>
                    <a:pt x="129159" y="747776"/>
                  </a:lnTo>
                  <a:close/>
                </a:path>
                <a:path w="4082415" h="897890">
                  <a:moveTo>
                    <a:pt x="187198" y="777748"/>
                  </a:moveTo>
                  <a:lnTo>
                    <a:pt x="174117" y="777748"/>
                  </a:lnTo>
                  <a:lnTo>
                    <a:pt x="174117" y="897382"/>
                  </a:lnTo>
                  <a:lnTo>
                    <a:pt x="187198" y="897382"/>
                  </a:lnTo>
                  <a:lnTo>
                    <a:pt x="187198" y="777748"/>
                  </a:lnTo>
                  <a:close/>
                </a:path>
                <a:path w="4082415" h="897890">
                  <a:moveTo>
                    <a:pt x="245237" y="717931"/>
                  </a:moveTo>
                  <a:lnTo>
                    <a:pt x="232156" y="717931"/>
                  </a:lnTo>
                  <a:lnTo>
                    <a:pt x="232156" y="897382"/>
                  </a:lnTo>
                  <a:lnTo>
                    <a:pt x="245237" y="897382"/>
                  </a:lnTo>
                  <a:lnTo>
                    <a:pt x="245237" y="717931"/>
                  </a:lnTo>
                  <a:close/>
                </a:path>
                <a:path w="4082415" h="897890">
                  <a:moveTo>
                    <a:pt x="303276" y="777748"/>
                  </a:moveTo>
                  <a:lnTo>
                    <a:pt x="290195" y="777748"/>
                  </a:lnTo>
                  <a:lnTo>
                    <a:pt x="290195" y="897382"/>
                  </a:lnTo>
                  <a:lnTo>
                    <a:pt x="303276" y="897382"/>
                  </a:lnTo>
                  <a:lnTo>
                    <a:pt x="303276" y="777748"/>
                  </a:lnTo>
                  <a:close/>
                </a:path>
                <a:path w="4082415" h="897890">
                  <a:moveTo>
                    <a:pt x="361315" y="717931"/>
                  </a:moveTo>
                  <a:lnTo>
                    <a:pt x="348234" y="717931"/>
                  </a:lnTo>
                  <a:lnTo>
                    <a:pt x="348234" y="897382"/>
                  </a:lnTo>
                  <a:lnTo>
                    <a:pt x="361315" y="897382"/>
                  </a:lnTo>
                  <a:lnTo>
                    <a:pt x="361315" y="717931"/>
                  </a:lnTo>
                  <a:close/>
                </a:path>
                <a:path w="4082415" h="897890">
                  <a:moveTo>
                    <a:pt x="424561" y="687959"/>
                  </a:moveTo>
                  <a:lnTo>
                    <a:pt x="414147" y="687959"/>
                  </a:lnTo>
                  <a:lnTo>
                    <a:pt x="414147" y="897382"/>
                  </a:lnTo>
                  <a:lnTo>
                    <a:pt x="424561" y="897382"/>
                  </a:lnTo>
                  <a:lnTo>
                    <a:pt x="424561" y="687959"/>
                  </a:lnTo>
                  <a:close/>
                </a:path>
                <a:path w="4082415" h="897890">
                  <a:moveTo>
                    <a:pt x="477520" y="777748"/>
                  </a:moveTo>
                  <a:lnTo>
                    <a:pt x="464439" y="777748"/>
                  </a:lnTo>
                  <a:lnTo>
                    <a:pt x="464439" y="897382"/>
                  </a:lnTo>
                  <a:lnTo>
                    <a:pt x="477520" y="897382"/>
                  </a:lnTo>
                  <a:lnTo>
                    <a:pt x="477520" y="777748"/>
                  </a:lnTo>
                  <a:close/>
                </a:path>
                <a:path w="4082415" h="897890">
                  <a:moveTo>
                    <a:pt x="540639" y="687959"/>
                  </a:moveTo>
                  <a:lnTo>
                    <a:pt x="530225" y="687959"/>
                  </a:lnTo>
                  <a:lnTo>
                    <a:pt x="530225" y="897382"/>
                  </a:lnTo>
                  <a:lnTo>
                    <a:pt x="540639" y="897382"/>
                  </a:lnTo>
                  <a:lnTo>
                    <a:pt x="540639" y="687959"/>
                  </a:lnTo>
                  <a:close/>
                </a:path>
                <a:path w="4082415" h="897890">
                  <a:moveTo>
                    <a:pt x="598678" y="807593"/>
                  </a:moveTo>
                  <a:lnTo>
                    <a:pt x="588264" y="807593"/>
                  </a:lnTo>
                  <a:lnTo>
                    <a:pt x="588264" y="897382"/>
                  </a:lnTo>
                  <a:lnTo>
                    <a:pt x="598678" y="897382"/>
                  </a:lnTo>
                  <a:lnTo>
                    <a:pt x="598678" y="807593"/>
                  </a:lnTo>
                  <a:close/>
                </a:path>
                <a:path w="4082415" h="897890">
                  <a:moveTo>
                    <a:pt x="656844" y="747776"/>
                  </a:moveTo>
                  <a:lnTo>
                    <a:pt x="646430" y="747776"/>
                  </a:lnTo>
                  <a:lnTo>
                    <a:pt x="646430" y="897382"/>
                  </a:lnTo>
                  <a:lnTo>
                    <a:pt x="656844" y="897382"/>
                  </a:lnTo>
                  <a:lnTo>
                    <a:pt x="656844" y="747776"/>
                  </a:lnTo>
                  <a:close/>
                </a:path>
                <a:path w="4082415" h="897890">
                  <a:moveTo>
                    <a:pt x="714883" y="777748"/>
                  </a:moveTo>
                  <a:lnTo>
                    <a:pt x="704469" y="777748"/>
                  </a:lnTo>
                  <a:lnTo>
                    <a:pt x="704469" y="897382"/>
                  </a:lnTo>
                  <a:lnTo>
                    <a:pt x="714883" y="897382"/>
                  </a:lnTo>
                  <a:lnTo>
                    <a:pt x="714883" y="777748"/>
                  </a:lnTo>
                  <a:close/>
                </a:path>
                <a:path w="4082415" h="897890">
                  <a:moveTo>
                    <a:pt x="772922" y="508508"/>
                  </a:moveTo>
                  <a:lnTo>
                    <a:pt x="762508" y="508508"/>
                  </a:lnTo>
                  <a:lnTo>
                    <a:pt x="762508" y="897382"/>
                  </a:lnTo>
                  <a:lnTo>
                    <a:pt x="772922" y="897382"/>
                  </a:lnTo>
                  <a:lnTo>
                    <a:pt x="772922" y="508508"/>
                  </a:lnTo>
                  <a:close/>
                </a:path>
                <a:path w="4082415" h="897890">
                  <a:moveTo>
                    <a:pt x="830948" y="239268"/>
                  </a:moveTo>
                  <a:lnTo>
                    <a:pt x="820547" y="239268"/>
                  </a:lnTo>
                  <a:lnTo>
                    <a:pt x="820547" y="897382"/>
                  </a:lnTo>
                  <a:lnTo>
                    <a:pt x="830948" y="897382"/>
                  </a:lnTo>
                  <a:lnTo>
                    <a:pt x="830948" y="239268"/>
                  </a:lnTo>
                  <a:close/>
                </a:path>
                <a:path w="4082415" h="897890">
                  <a:moveTo>
                    <a:pt x="889000" y="179451"/>
                  </a:moveTo>
                  <a:lnTo>
                    <a:pt x="878586" y="179451"/>
                  </a:lnTo>
                  <a:lnTo>
                    <a:pt x="878586" y="897382"/>
                  </a:lnTo>
                  <a:lnTo>
                    <a:pt x="889000" y="897382"/>
                  </a:lnTo>
                  <a:lnTo>
                    <a:pt x="889000" y="179451"/>
                  </a:lnTo>
                  <a:close/>
                </a:path>
                <a:path w="4082415" h="897890">
                  <a:moveTo>
                    <a:pt x="947039" y="0"/>
                  </a:moveTo>
                  <a:lnTo>
                    <a:pt x="936625" y="0"/>
                  </a:lnTo>
                  <a:lnTo>
                    <a:pt x="936625" y="897382"/>
                  </a:lnTo>
                  <a:lnTo>
                    <a:pt x="947039" y="897382"/>
                  </a:lnTo>
                  <a:lnTo>
                    <a:pt x="947039" y="0"/>
                  </a:lnTo>
                  <a:close/>
                </a:path>
                <a:path w="4082415" h="897890">
                  <a:moveTo>
                    <a:pt x="1005078" y="388874"/>
                  </a:moveTo>
                  <a:lnTo>
                    <a:pt x="994664" y="388874"/>
                  </a:lnTo>
                  <a:lnTo>
                    <a:pt x="994664" y="897382"/>
                  </a:lnTo>
                  <a:lnTo>
                    <a:pt x="1005078" y="897382"/>
                  </a:lnTo>
                  <a:lnTo>
                    <a:pt x="1005078" y="388874"/>
                  </a:lnTo>
                  <a:close/>
                </a:path>
                <a:path w="4082415" h="897890">
                  <a:moveTo>
                    <a:pt x="1063104" y="418719"/>
                  </a:moveTo>
                  <a:lnTo>
                    <a:pt x="1052703" y="418719"/>
                  </a:lnTo>
                  <a:lnTo>
                    <a:pt x="1052703" y="897382"/>
                  </a:lnTo>
                  <a:lnTo>
                    <a:pt x="1063104" y="897382"/>
                  </a:lnTo>
                  <a:lnTo>
                    <a:pt x="1063104" y="418719"/>
                  </a:lnTo>
                  <a:close/>
                </a:path>
                <a:path w="4082415" h="897890">
                  <a:moveTo>
                    <a:pt x="1121156" y="388874"/>
                  </a:moveTo>
                  <a:lnTo>
                    <a:pt x="1110742" y="388874"/>
                  </a:lnTo>
                  <a:lnTo>
                    <a:pt x="1110742" y="897382"/>
                  </a:lnTo>
                  <a:lnTo>
                    <a:pt x="1121156" y="897382"/>
                  </a:lnTo>
                  <a:lnTo>
                    <a:pt x="1121156" y="388874"/>
                  </a:lnTo>
                  <a:close/>
                </a:path>
                <a:path w="4082415" h="897890">
                  <a:moveTo>
                    <a:pt x="1179322" y="448691"/>
                  </a:moveTo>
                  <a:lnTo>
                    <a:pt x="1168908" y="448691"/>
                  </a:lnTo>
                  <a:lnTo>
                    <a:pt x="1168908" y="897382"/>
                  </a:lnTo>
                  <a:lnTo>
                    <a:pt x="1179322" y="897382"/>
                  </a:lnTo>
                  <a:lnTo>
                    <a:pt x="1179322" y="448691"/>
                  </a:lnTo>
                  <a:close/>
                </a:path>
                <a:path w="4082415" h="897890">
                  <a:moveTo>
                    <a:pt x="1237348" y="628142"/>
                  </a:moveTo>
                  <a:lnTo>
                    <a:pt x="1226947" y="628142"/>
                  </a:lnTo>
                  <a:lnTo>
                    <a:pt x="1226947" y="897382"/>
                  </a:lnTo>
                  <a:lnTo>
                    <a:pt x="1237348" y="897382"/>
                  </a:lnTo>
                  <a:lnTo>
                    <a:pt x="1237348" y="628142"/>
                  </a:lnTo>
                  <a:close/>
                </a:path>
                <a:path w="4082415" h="897890">
                  <a:moveTo>
                    <a:pt x="1295400" y="448691"/>
                  </a:moveTo>
                  <a:lnTo>
                    <a:pt x="1284986" y="448691"/>
                  </a:lnTo>
                  <a:lnTo>
                    <a:pt x="1284986" y="897382"/>
                  </a:lnTo>
                  <a:lnTo>
                    <a:pt x="1295400" y="897382"/>
                  </a:lnTo>
                  <a:lnTo>
                    <a:pt x="1295400" y="448691"/>
                  </a:lnTo>
                  <a:close/>
                </a:path>
                <a:path w="4082415" h="897890">
                  <a:moveTo>
                    <a:pt x="1353439" y="508508"/>
                  </a:moveTo>
                  <a:lnTo>
                    <a:pt x="1343025" y="508508"/>
                  </a:lnTo>
                  <a:lnTo>
                    <a:pt x="1343025" y="897382"/>
                  </a:lnTo>
                  <a:lnTo>
                    <a:pt x="1353439" y="897382"/>
                  </a:lnTo>
                  <a:lnTo>
                    <a:pt x="1353439" y="508508"/>
                  </a:lnTo>
                  <a:close/>
                </a:path>
                <a:path w="4082415" h="897890">
                  <a:moveTo>
                    <a:pt x="1411478" y="329057"/>
                  </a:moveTo>
                  <a:lnTo>
                    <a:pt x="1401064" y="329057"/>
                  </a:lnTo>
                  <a:lnTo>
                    <a:pt x="1401064" y="897382"/>
                  </a:lnTo>
                  <a:lnTo>
                    <a:pt x="1411478" y="897382"/>
                  </a:lnTo>
                  <a:lnTo>
                    <a:pt x="1411478" y="329057"/>
                  </a:lnTo>
                  <a:close/>
                </a:path>
                <a:path w="4082415" h="897890">
                  <a:moveTo>
                    <a:pt x="1469504" y="269240"/>
                  </a:moveTo>
                  <a:lnTo>
                    <a:pt x="1459103" y="269240"/>
                  </a:lnTo>
                  <a:lnTo>
                    <a:pt x="1459103" y="897382"/>
                  </a:lnTo>
                  <a:lnTo>
                    <a:pt x="1469504" y="897382"/>
                  </a:lnTo>
                  <a:lnTo>
                    <a:pt x="1469504" y="269240"/>
                  </a:lnTo>
                  <a:close/>
                </a:path>
                <a:path w="4082415" h="897890">
                  <a:moveTo>
                    <a:pt x="1527556" y="418719"/>
                  </a:moveTo>
                  <a:lnTo>
                    <a:pt x="1517142" y="418719"/>
                  </a:lnTo>
                  <a:lnTo>
                    <a:pt x="1517142" y="897382"/>
                  </a:lnTo>
                  <a:lnTo>
                    <a:pt x="1527556" y="897382"/>
                  </a:lnTo>
                  <a:lnTo>
                    <a:pt x="1527556" y="418719"/>
                  </a:lnTo>
                  <a:close/>
                </a:path>
                <a:path w="4082415" h="897890">
                  <a:moveTo>
                    <a:pt x="1585595" y="568325"/>
                  </a:moveTo>
                  <a:lnTo>
                    <a:pt x="1575181" y="568325"/>
                  </a:lnTo>
                  <a:lnTo>
                    <a:pt x="1575181" y="897382"/>
                  </a:lnTo>
                  <a:lnTo>
                    <a:pt x="1585595" y="897382"/>
                  </a:lnTo>
                  <a:lnTo>
                    <a:pt x="1585595" y="568325"/>
                  </a:lnTo>
                  <a:close/>
                </a:path>
                <a:path w="4082415" h="897890">
                  <a:moveTo>
                    <a:pt x="1643634" y="538480"/>
                  </a:moveTo>
                  <a:lnTo>
                    <a:pt x="1633220" y="538480"/>
                  </a:lnTo>
                  <a:lnTo>
                    <a:pt x="1633220" y="897382"/>
                  </a:lnTo>
                  <a:lnTo>
                    <a:pt x="1643634" y="897382"/>
                  </a:lnTo>
                  <a:lnTo>
                    <a:pt x="1643634" y="538480"/>
                  </a:lnTo>
                  <a:close/>
                </a:path>
                <a:path w="4082415" h="897890">
                  <a:moveTo>
                    <a:pt x="1701660" y="478536"/>
                  </a:moveTo>
                  <a:lnTo>
                    <a:pt x="1691259" y="478536"/>
                  </a:lnTo>
                  <a:lnTo>
                    <a:pt x="1691259" y="897382"/>
                  </a:lnTo>
                  <a:lnTo>
                    <a:pt x="1701660" y="897382"/>
                  </a:lnTo>
                  <a:lnTo>
                    <a:pt x="1701660" y="478536"/>
                  </a:lnTo>
                  <a:close/>
                </a:path>
                <a:path w="4082415" h="897890">
                  <a:moveTo>
                    <a:pt x="1759839" y="448691"/>
                  </a:moveTo>
                  <a:lnTo>
                    <a:pt x="1749425" y="448691"/>
                  </a:lnTo>
                  <a:lnTo>
                    <a:pt x="1749425" y="897382"/>
                  </a:lnTo>
                  <a:lnTo>
                    <a:pt x="1759839" y="897382"/>
                  </a:lnTo>
                  <a:lnTo>
                    <a:pt x="1759839" y="448691"/>
                  </a:lnTo>
                  <a:close/>
                </a:path>
                <a:path w="4082415" h="897890">
                  <a:moveTo>
                    <a:pt x="1817878" y="628142"/>
                  </a:moveTo>
                  <a:lnTo>
                    <a:pt x="1807464" y="628142"/>
                  </a:lnTo>
                  <a:lnTo>
                    <a:pt x="1807464" y="897382"/>
                  </a:lnTo>
                  <a:lnTo>
                    <a:pt x="1817878" y="897382"/>
                  </a:lnTo>
                  <a:lnTo>
                    <a:pt x="1817878" y="628142"/>
                  </a:lnTo>
                  <a:close/>
                </a:path>
                <a:path w="4082415" h="897890">
                  <a:moveTo>
                    <a:pt x="1875904" y="358902"/>
                  </a:moveTo>
                  <a:lnTo>
                    <a:pt x="1865503" y="358902"/>
                  </a:lnTo>
                  <a:lnTo>
                    <a:pt x="1865503" y="897382"/>
                  </a:lnTo>
                  <a:lnTo>
                    <a:pt x="1875904" y="897382"/>
                  </a:lnTo>
                  <a:lnTo>
                    <a:pt x="1875904" y="358902"/>
                  </a:lnTo>
                  <a:close/>
                </a:path>
                <a:path w="4082415" h="897890">
                  <a:moveTo>
                    <a:pt x="1933956" y="358902"/>
                  </a:moveTo>
                  <a:lnTo>
                    <a:pt x="1923542" y="358902"/>
                  </a:lnTo>
                  <a:lnTo>
                    <a:pt x="1923542" y="897382"/>
                  </a:lnTo>
                  <a:lnTo>
                    <a:pt x="1933956" y="897382"/>
                  </a:lnTo>
                  <a:lnTo>
                    <a:pt x="1933956" y="358902"/>
                  </a:lnTo>
                  <a:close/>
                </a:path>
                <a:path w="4082415" h="897890">
                  <a:moveTo>
                    <a:pt x="1991995" y="508508"/>
                  </a:moveTo>
                  <a:lnTo>
                    <a:pt x="1981581" y="508508"/>
                  </a:lnTo>
                  <a:lnTo>
                    <a:pt x="1981581" y="897382"/>
                  </a:lnTo>
                  <a:lnTo>
                    <a:pt x="1991995" y="897382"/>
                  </a:lnTo>
                  <a:lnTo>
                    <a:pt x="1991995" y="508508"/>
                  </a:lnTo>
                  <a:close/>
                </a:path>
                <a:path w="4082415" h="897890">
                  <a:moveTo>
                    <a:pt x="2050034" y="568325"/>
                  </a:moveTo>
                  <a:lnTo>
                    <a:pt x="2039620" y="568325"/>
                  </a:lnTo>
                  <a:lnTo>
                    <a:pt x="2039620" y="897382"/>
                  </a:lnTo>
                  <a:lnTo>
                    <a:pt x="2050034" y="897382"/>
                  </a:lnTo>
                  <a:lnTo>
                    <a:pt x="2050034" y="568325"/>
                  </a:lnTo>
                  <a:close/>
                </a:path>
                <a:path w="4082415" h="897890">
                  <a:moveTo>
                    <a:pt x="2108060" y="358902"/>
                  </a:moveTo>
                  <a:lnTo>
                    <a:pt x="2097659" y="358902"/>
                  </a:lnTo>
                  <a:lnTo>
                    <a:pt x="2097659" y="897382"/>
                  </a:lnTo>
                  <a:lnTo>
                    <a:pt x="2108060" y="897382"/>
                  </a:lnTo>
                  <a:lnTo>
                    <a:pt x="2108060" y="358902"/>
                  </a:lnTo>
                  <a:close/>
                </a:path>
                <a:path w="4082415" h="897890">
                  <a:moveTo>
                    <a:pt x="2166099" y="418719"/>
                  </a:moveTo>
                  <a:lnTo>
                    <a:pt x="2155685" y="418719"/>
                  </a:lnTo>
                  <a:lnTo>
                    <a:pt x="2155685" y="897382"/>
                  </a:lnTo>
                  <a:lnTo>
                    <a:pt x="2166099" y="897382"/>
                  </a:lnTo>
                  <a:lnTo>
                    <a:pt x="2166099" y="418719"/>
                  </a:lnTo>
                  <a:close/>
                </a:path>
                <a:path w="4082415" h="897890">
                  <a:moveTo>
                    <a:pt x="2224138" y="388874"/>
                  </a:moveTo>
                  <a:lnTo>
                    <a:pt x="2213737" y="388874"/>
                  </a:lnTo>
                  <a:lnTo>
                    <a:pt x="2213737" y="897382"/>
                  </a:lnTo>
                  <a:lnTo>
                    <a:pt x="2224138" y="897382"/>
                  </a:lnTo>
                  <a:lnTo>
                    <a:pt x="2224138" y="388874"/>
                  </a:lnTo>
                  <a:close/>
                </a:path>
                <a:path w="4082415" h="897890">
                  <a:moveTo>
                    <a:pt x="2282317" y="299085"/>
                  </a:moveTo>
                  <a:lnTo>
                    <a:pt x="2271903" y="299085"/>
                  </a:lnTo>
                  <a:lnTo>
                    <a:pt x="2271903" y="897382"/>
                  </a:lnTo>
                  <a:lnTo>
                    <a:pt x="2282317" y="897382"/>
                  </a:lnTo>
                  <a:lnTo>
                    <a:pt x="2282317" y="299085"/>
                  </a:lnTo>
                  <a:close/>
                </a:path>
                <a:path w="4082415" h="897890">
                  <a:moveTo>
                    <a:pt x="2340356" y="448691"/>
                  </a:moveTo>
                  <a:lnTo>
                    <a:pt x="2329942" y="448691"/>
                  </a:lnTo>
                  <a:lnTo>
                    <a:pt x="2329942" y="897382"/>
                  </a:lnTo>
                  <a:lnTo>
                    <a:pt x="2340356" y="897382"/>
                  </a:lnTo>
                  <a:lnTo>
                    <a:pt x="2340356" y="448691"/>
                  </a:lnTo>
                  <a:close/>
                </a:path>
                <a:path w="4082415" h="897890">
                  <a:moveTo>
                    <a:pt x="2398395" y="538480"/>
                  </a:moveTo>
                  <a:lnTo>
                    <a:pt x="2387981" y="538480"/>
                  </a:lnTo>
                  <a:lnTo>
                    <a:pt x="2387981" y="897382"/>
                  </a:lnTo>
                  <a:lnTo>
                    <a:pt x="2398395" y="897382"/>
                  </a:lnTo>
                  <a:lnTo>
                    <a:pt x="2398395" y="538480"/>
                  </a:lnTo>
                  <a:close/>
                </a:path>
                <a:path w="4082415" h="897890">
                  <a:moveTo>
                    <a:pt x="2456434" y="568325"/>
                  </a:moveTo>
                  <a:lnTo>
                    <a:pt x="2446020" y="568325"/>
                  </a:lnTo>
                  <a:lnTo>
                    <a:pt x="2446020" y="897382"/>
                  </a:lnTo>
                  <a:lnTo>
                    <a:pt x="2456434" y="897382"/>
                  </a:lnTo>
                  <a:lnTo>
                    <a:pt x="2456434" y="568325"/>
                  </a:lnTo>
                  <a:close/>
                </a:path>
                <a:path w="4082415" h="897890">
                  <a:moveTo>
                    <a:pt x="2514473" y="239268"/>
                  </a:moveTo>
                  <a:lnTo>
                    <a:pt x="2504059" y="239268"/>
                  </a:lnTo>
                  <a:lnTo>
                    <a:pt x="2504059" y="897382"/>
                  </a:lnTo>
                  <a:lnTo>
                    <a:pt x="2514473" y="897382"/>
                  </a:lnTo>
                  <a:lnTo>
                    <a:pt x="2514473" y="239268"/>
                  </a:lnTo>
                  <a:close/>
                </a:path>
                <a:path w="4082415" h="897890">
                  <a:moveTo>
                    <a:pt x="2572512" y="478536"/>
                  </a:moveTo>
                  <a:lnTo>
                    <a:pt x="2562098" y="478536"/>
                  </a:lnTo>
                  <a:lnTo>
                    <a:pt x="2562098" y="897382"/>
                  </a:lnTo>
                  <a:lnTo>
                    <a:pt x="2572512" y="897382"/>
                  </a:lnTo>
                  <a:lnTo>
                    <a:pt x="2572512" y="478536"/>
                  </a:lnTo>
                  <a:close/>
                </a:path>
                <a:path w="4082415" h="897890">
                  <a:moveTo>
                    <a:pt x="2630538" y="358902"/>
                  </a:moveTo>
                  <a:lnTo>
                    <a:pt x="2620137" y="358902"/>
                  </a:lnTo>
                  <a:lnTo>
                    <a:pt x="2620137" y="897382"/>
                  </a:lnTo>
                  <a:lnTo>
                    <a:pt x="2630538" y="897382"/>
                  </a:lnTo>
                  <a:lnTo>
                    <a:pt x="2630538" y="358902"/>
                  </a:lnTo>
                  <a:close/>
                </a:path>
                <a:path w="4082415" h="897890">
                  <a:moveTo>
                    <a:pt x="2688590" y="448691"/>
                  </a:moveTo>
                  <a:lnTo>
                    <a:pt x="2678176" y="448691"/>
                  </a:lnTo>
                  <a:lnTo>
                    <a:pt x="2678176" y="897382"/>
                  </a:lnTo>
                  <a:lnTo>
                    <a:pt x="2688590" y="897382"/>
                  </a:lnTo>
                  <a:lnTo>
                    <a:pt x="2688590" y="448691"/>
                  </a:lnTo>
                  <a:close/>
                </a:path>
                <a:path w="4082415" h="897890">
                  <a:moveTo>
                    <a:pt x="2746629" y="628142"/>
                  </a:moveTo>
                  <a:lnTo>
                    <a:pt x="2736215" y="628142"/>
                  </a:lnTo>
                  <a:lnTo>
                    <a:pt x="2736215" y="897382"/>
                  </a:lnTo>
                  <a:lnTo>
                    <a:pt x="2746629" y="897382"/>
                  </a:lnTo>
                  <a:lnTo>
                    <a:pt x="2746629" y="628142"/>
                  </a:lnTo>
                  <a:close/>
                </a:path>
                <a:path w="4082415" h="897890">
                  <a:moveTo>
                    <a:pt x="2804668" y="478536"/>
                  </a:moveTo>
                  <a:lnTo>
                    <a:pt x="2794254" y="478536"/>
                  </a:lnTo>
                  <a:lnTo>
                    <a:pt x="2794254" y="897382"/>
                  </a:lnTo>
                  <a:lnTo>
                    <a:pt x="2804668" y="897382"/>
                  </a:lnTo>
                  <a:lnTo>
                    <a:pt x="2804668" y="478536"/>
                  </a:lnTo>
                  <a:close/>
                </a:path>
                <a:path w="4082415" h="897890">
                  <a:moveTo>
                    <a:pt x="2862834" y="538480"/>
                  </a:moveTo>
                  <a:lnTo>
                    <a:pt x="2852420" y="538480"/>
                  </a:lnTo>
                  <a:lnTo>
                    <a:pt x="2852420" y="897382"/>
                  </a:lnTo>
                  <a:lnTo>
                    <a:pt x="2862834" y="897382"/>
                  </a:lnTo>
                  <a:lnTo>
                    <a:pt x="2862834" y="538480"/>
                  </a:lnTo>
                  <a:close/>
                </a:path>
                <a:path w="4082415" h="897890">
                  <a:moveTo>
                    <a:pt x="2920873" y="478536"/>
                  </a:moveTo>
                  <a:lnTo>
                    <a:pt x="2910459" y="478536"/>
                  </a:lnTo>
                  <a:lnTo>
                    <a:pt x="2910459" y="897382"/>
                  </a:lnTo>
                  <a:lnTo>
                    <a:pt x="2920873" y="897382"/>
                  </a:lnTo>
                  <a:lnTo>
                    <a:pt x="2920873" y="478536"/>
                  </a:lnTo>
                  <a:close/>
                </a:path>
                <a:path w="4082415" h="897890">
                  <a:moveTo>
                    <a:pt x="2978912" y="239268"/>
                  </a:moveTo>
                  <a:lnTo>
                    <a:pt x="2968498" y="239268"/>
                  </a:lnTo>
                  <a:lnTo>
                    <a:pt x="2968498" y="897382"/>
                  </a:lnTo>
                  <a:lnTo>
                    <a:pt x="2978912" y="897382"/>
                  </a:lnTo>
                  <a:lnTo>
                    <a:pt x="2978912" y="239268"/>
                  </a:lnTo>
                  <a:close/>
                </a:path>
                <a:path w="4082415" h="897890">
                  <a:moveTo>
                    <a:pt x="3036938" y="478536"/>
                  </a:moveTo>
                  <a:lnTo>
                    <a:pt x="3026537" y="478536"/>
                  </a:lnTo>
                  <a:lnTo>
                    <a:pt x="3026537" y="897382"/>
                  </a:lnTo>
                  <a:lnTo>
                    <a:pt x="3036938" y="897382"/>
                  </a:lnTo>
                  <a:lnTo>
                    <a:pt x="3036938" y="478536"/>
                  </a:lnTo>
                  <a:close/>
                </a:path>
                <a:path w="4082415" h="897890">
                  <a:moveTo>
                    <a:pt x="3094990" y="478536"/>
                  </a:moveTo>
                  <a:lnTo>
                    <a:pt x="3084576" y="478536"/>
                  </a:lnTo>
                  <a:lnTo>
                    <a:pt x="3084576" y="897382"/>
                  </a:lnTo>
                  <a:lnTo>
                    <a:pt x="3094990" y="897382"/>
                  </a:lnTo>
                  <a:lnTo>
                    <a:pt x="3094990" y="478536"/>
                  </a:lnTo>
                  <a:close/>
                </a:path>
                <a:path w="4082415" h="897890">
                  <a:moveTo>
                    <a:pt x="3153029" y="478536"/>
                  </a:moveTo>
                  <a:lnTo>
                    <a:pt x="3142615" y="478536"/>
                  </a:lnTo>
                  <a:lnTo>
                    <a:pt x="3142615" y="897382"/>
                  </a:lnTo>
                  <a:lnTo>
                    <a:pt x="3153029" y="897382"/>
                  </a:lnTo>
                  <a:lnTo>
                    <a:pt x="3153029" y="478536"/>
                  </a:lnTo>
                  <a:close/>
                </a:path>
                <a:path w="4082415" h="897890">
                  <a:moveTo>
                    <a:pt x="3211068" y="448691"/>
                  </a:moveTo>
                  <a:lnTo>
                    <a:pt x="3200654" y="448691"/>
                  </a:lnTo>
                  <a:lnTo>
                    <a:pt x="3200654" y="897382"/>
                  </a:lnTo>
                  <a:lnTo>
                    <a:pt x="3211068" y="897382"/>
                  </a:lnTo>
                  <a:lnTo>
                    <a:pt x="3211068" y="448691"/>
                  </a:lnTo>
                  <a:close/>
                </a:path>
                <a:path w="4082415" h="897890">
                  <a:moveTo>
                    <a:pt x="3269107" y="329057"/>
                  </a:moveTo>
                  <a:lnTo>
                    <a:pt x="3258693" y="329057"/>
                  </a:lnTo>
                  <a:lnTo>
                    <a:pt x="3258693" y="897382"/>
                  </a:lnTo>
                  <a:lnTo>
                    <a:pt x="3269107" y="897382"/>
                  </a:lnTo>
                  <a:lnTo>
                    <a:pt x="3269107" y="329057"/>
                  </a:lnTo>
                  <a:close/>
                </a:path>
                <a:path w="4082415" h="897890">
                  <a:moveTo>
                    <a:pt x="3327146" y="687959"/>
                  </a:moveTo>
                  <a:lnTo>
                    <a:pt x="3316732" y="687959"/>
                  </a:lnTo>
                  <a:lnTo>
                    <a:pt x="3316732" y="897382"/>
                  </a:lnTo>
                  <a:lnTo>
                    <a:pt x="3327146" y="897382"/>
                  </a:lnTo>
                  <a:lnTo>
                    <a:pt x="3327146" y="687959"/>
                  </a:lnTo>
                  <a:close/>
                </a:path>
                <a:path w="4082415" h="897890">
                  <a:moveTo>
                    <a:pt x="3385312" y="598297"/>
                  </a:moveTo>
                  <a:lnTo>
                    <a:pt x="3374898" y="598297"/>
                  </a:lnTo>
                  <a:lnTo>
                    <a:pt x="3374898" y="897382"/>
                  </a:lnTo>
                  <a:lnTo>
                    <a:pt x="3385312" y="897382"/>
                  </a:lnTo>
                  <a:lnTo>
                    <a:pt x="3385312" y="598297"/>
                  </a:lnTo>
                  <a:close/>
                </a:path>
                <a:path w="4082415" h="897890">
                  <a:moveTo>
                    <a:pt x="3443338" y="598297"/>
                  </a:moveTo>
                  <a:lnTo>
                    <a:pt x="3432937" y="598297"/>
                  </a:lnTo>
                  <a:lnTo>
                    <a:pt x="3432937" y="897382"/>
                  </a:lnTo>
                  <a:lnTo>
                    <a:pt x="3443338" y="897382"/>
                  </a:lnTo>
                  <a:lnTo>
                    <a:pt x="3443338" y="598297"/>
                  </a:lnTo>
                  <a:close/>
                </a:path>
                <a:path w="4082415" h="897890">
                  <a:moveTo>
                    <a:pt x="3501390" y="418719"/>
                  </a:moveTo>
                  <a:lnTo>
                    <a:pt x="3490976" y="418719"/>
                  </a:lnTo>
                  <a:lnTo>
                    <a:pt x="3490976" y="897382"/>
                  </a:lnTo>
                  <a:lnTo>
                    <a:pt x="3501390" y="897382"/>
                  </a:lnTo>
                  <a:lnTo>
                    <a:pt x="3501390" y="418719"/>
                  </a:lnTo>
                  <a:close/>
                </a:path>
                <a:path w="4082415" h="897890">
                  <a:moveTo>
                    <a:pt x="3559429" y="299085"/>
                  </a:moveTo>
                  <a:lnTo>
                    <a:pt x="3549015" y="299085"/>
                  </a:lnTo>
                  <a:lnTo>
                    <a:pt x="3549015" y="897382"/>
                  </a:lnTo>
                  <a:lnTo>
                    <a:pt x="3559429" y="897382"/>
                  </a:lnTo>
                  <a:lnTo>
                    <a:pt x="3559429" y="299085"/>
                  </a:lnTo>
                  <a:close/>
                </a:path>
                <a:path w="4082415" h="897890">
                  <a:moveTo>
                    <a:pt x="3617468" y="418719"/>
                  </a:moveTo>
                  <a:lnTo>
                    <a:pt x="3607054" y="418719"/>
                  </a:lnTo>
                  <a:lnTo>
                    <a:pt x="3607054" y="897382"/>
                  </a:lnTo>
                  <a:lnTo>
                    <a:pt x="3617468" y="897382"/>
                  </a:lnTo>
                  <a:lnTo>
                    <a:pt x="3617468" y="418719"/>
                  </a:lnTo>
                  <a:close/>
                </a:path>
                <a:path w="4082415" h="897890">
                  <a:moveTo>
                    <a:pt x="3675507" y="658114"/>
                  </a:moveTo>
                  <a:lnTo>
                    <a:pt x="3665093" y="658114"/>
                  </a:lnTo>
                  <a:lnTo>
                    <a:pt x="3665093" y="897382"/>
                  </a:lnTo>
                  <a:lnTo>
                    <a:pt x="3675507" y="897382"/>
                  </a:lnTo>
                  <a:lnTo>
                    <a:pt x="3675507" y="658114"/>
                  </a:lnTo>
                  <a:close/>
                </a:path>
                <a:path w="4082415" h="897890">
                  <a:moveTo>
                    <a:pt x="3733546" y="598297"/>
                  </a:moveTo>
                  <a:lnTo>
                    <a:pt x="3723132" y="598297"/>
                  </a:lnTo>
                  <a:lnTo>
                    <a:pt x="3723132" y="897382"/>
                  </a:lnTo>
                  <a:lnTo>
                    <a:pt x="3733546" y="897382"/>
                  </a:lnTo>
                  <a:lnTo>
                    <a:pt x="3733546" y="598297"/>
                  </a:lnTo>
                  <a:close/>
                </a:path>
                <a:path w="4082415" h="897890">
                  <a:moveTo>
                    <a:pt x="3791585" y="388874"/>
                  </a:moveTo>
                  <a:lnTo>
                    <a:pt x="3781171" y="388874"/>
                  </a:lnTo>
                  <a:lnTo>
                    <a:pt x="3781171" y="897382"/>
                  </a:lnTo>
                  <a:lnTo>
                    <a:pt x="3791585" y="897382"/>
                  </a:lnTo>
                  <a:lnTo>
                    <a:pt x="3791585" y="388874"/>
                  </a:lnTo>
                  <a:close/>
                </a:path>
                <a:path w="4082415" h="897890">
                  <a:moveTo>
                    <a:pt x="3849624" y="418719"/>
                  </a:moveTo>
                  <a:lnTo>
                    <a:pt x="3839210" y="418719"/>
                  </a:lnTo>
                  <a:lnTo>
                    <a:pt x="3839210" y="897382"/>
                  </a:lnTo>
                  <a:lnTo>
                    <a:pt x="3849624" y="897382"/>
                  </a:lnTo>
                  <a:lnTo>
                    <a:pt x="3849624" y="418719"/>
                  </a:lnTo>
                  <a:close/>
                </a:path>
                <a:path w="4082415" h="897890">
                  <a:moveTo>
                    <a:pt x="3907790" y="538480"/>
                  </a:moveTo>
                  <a:lnTo>
                    <a:pt x="3897376" y="538480"/>
                  </a:lnTo>
                  <a:lnTo>
                    <a:pt x="3897376" y="897382"/>
                  </a:lnTo>
                  <a:lnTo>
                    <a:pt x="3907790" y="897382"/>
                  </a:lnTo>
                  <a:lnTo>
                    <a:pt x="3907790" y="538480"/>
                  </a:lnTo>
                  <a:close/>
                </a:path>
                <a:path w="4082415" h="897890">
                  <a:moveTo>
                    <a:pt x="3965829" y="269240"/>
                  </a:moveTo>
                  <a:lnTo>
                    <a:pt x="3955415" y="269240"/>
                  </a:lnTo>
                  <a:lnTo>
                    <a:pt x="3955415" y="897382"/>
                  </a:lnTo>
                  <a:lnTo>
                    <a:pt x="3965829" y="897382"/>
                  </a:lnTo>
                  <a:lnTo>
                    <a:pt x="3965829" y="269240"/>
                  </a:lnTo>
                  <a:close/>
                </a:path>
                <a:path w="4082415" h="897890">
                  <a:moveTo>
                    <a:pt x="4023868" y="508508"/>
                  </a:moveTo>
                  <a:lnTo>
                    <a:pt x="4013454" y="508508"/>
                  </a:lnTo>
                  <a:lnTo>
                    <a:pt x="4013454" y="897382"/>
                  </a:lnTo>
                  <a:lnTo>
                    <a:pt x="4023868" y="897382"/>
                  </a:lnTo>
                  <a:lnTo>
                    <a:pt x="4023868" y="508508"/>
                  </a:lnTo>
                  <a:close/>
                </a:path>
                <a:path w="4082415" h="897890">
                  <a:moveTo>
                    <a:pt x="4081907" y="388874"/>
                  </a:moveTo>
                  <a:lnTo>
                    <a:pt x="4071493" y="388874"/>
                  </a:lnTo>
                  <a:lnTo>
                    <a:pt x="4071493" y="897382"/>
                  </a:lnTo>
                  <a:lnTo>
                    <a:pt x="4081907" y="897382"/>
                  </a:lnTo>
                  <a:lnTo>
                    <a:pt x="4081907" y="388874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2" name="object 102" descr=""/>
            <p:cNvSpPr/>
            <p:nvPr/>
          </p:nvSpPr>
          <p:spPr>
            <a:xfrm>
              <a:off x="5209286" y="8004302"/>
              <a:ext cx="4074160" cy="658495"/>
            </a:xfrm>
            <a:custGeom>
              <a:avLst/>
              <a:gdLst/>
              <a:ahLst/>
              <a:cxnLst/>
              <a:rect l="l" t="t" r="r" b="b"/>
              <a:pathLst>
                <a:path w="4074159" h="658495">
                  <a:moveTo>
                    <a:pt x="10414" y="149606"/>
                  </a:moveTo>
                  <a:lnTo>
                    <a:pt x="0" y="149606"/>
                  </a:lnTo>
                  <a:lnTo>
                    <a:pt x="0" y="658114"/>
                  </a:lnTo>
                  <a:lnTo>
                    <a:pt x="10414" y="658114"/>
                  </a:lnTo>
                  <a:lnTo>
                    <a:pt x="10414" y="149606"/>
                  </a:lnTo>
                  <a:close/>
                </a:path>
                <a:path w="4074159" h="658495">
                  <a:moveTo>
                    <a:pt x="68453" y="269240"/>
                  </a:moveTo>
                  <a:lnTo>
                    <a:pt x="58039" y="269240"/>
                  </a:lnTo>
                  <a:lnTo>
                    <a:pt x="58039" y="658114"/>
                  </a:lnTo>
                  <a:lnTo>
                    <a:pt x="68453" y="658114"/>
                  </a:lnTo>
                  <a:lnTo>
                    <a:pt x="68453" y="269240"/>
                  </a:lnTo>
                  <a:close/>
                </a:path>
                <a:path w="4074159" h="658495">
                  <a:moveTo>
                    <a:pt x="126492" y="269240"/>
                  </a:moveTo>
                  <a:lnTo>
                    <a:pt x="116078" y="269240"/>
                  </a:lnTo>
                  <a:lnTo>
                    <a:pt x="116078" y="658114"/>
                  </a:lnTo>
                  <a:lnTo>
                    <a:pt x="126492" y="658114"/>
                  </a:lnTo>
                  <a:lnTo>
                    <a:pt x="126492" y="269240"/>
                  </a:lnTo>
                  <a:close/>
                </a:path>
                <a:path w="4074159" h="658495">
                  <a:moveTo>
                    <a:pt x="184531" y="119634"/>
                  </a:moveTo>
                  <a:lnTo>
                    <a:pt x="174117" y="119634"/>
                  </a:lnTo>
                  <a:lnTo>
                    <a:pt x="174117" y="658114"/>
                  </a:lnTo>
                  <a:lnTo>
                    <a:pt x="184531" y="658114"/>
                  </a:lnTo>
                  <a:lnTo>
                    <a:pt x="184531" y="119634"/>
                  </a:lnTo>
                  <a:close/>
                </a:path>
                <a:path w="4074159" h="658495">
                  <a:moveTo>
                    <a:pt x="242570" y="149606"/>
                  </a:moveTo>
                  <a:lnTo>
                    <a:pt x="232156" y="149606"/>
                  </a:lnTo>
                  <a:lnTo>
                    <a:pt x="232156" y="658114"/>
                  </a:lnTo>
                  <a:lnTo>
                    <a:pt x="242570" y="658114"/>
                  </a:lnTo>
                  <a:lnTo>
                    <a:pt x="242570" y="149606"/>
                  </a:lnTo>
                  <a:close/>
                </a:path>
                <a:path w="4074159" h="658495">
                  <a:moveTo>
                    <a:pt x="300596" y="329057"/>
                  </a:moveTo>
                  <a:lnTo>
                    <a:pt x="290195" y="329057"/>
                  </a:lnTo>
                  <a:lnTo>
                    <a:pt x="290195" y="658114"/>
                  </a:lnTo>
                  <a:lnTo>
                    <a:pt x="300596" y="658114"/>
                  </a:lnTo>
                  <a:lnTo>
                    <a:pt x="300596" y="329057"/>
                  </a:lnTo>
                  <a:close/>
                </a:path>
                <a:path w="4074159" h="658495">
                  <a:moveTo>
                    <a:pt x="358648" y="89789"/>
                  </a:moveTo>
                  <a:lnTo>
                    <a:pt x="348234" y="89789"/>
                  </a:lnTo>
                  <a:lnTo>
                    <a:pt x="348234" y="658114"/>
                  </a:lnTo>
                  <a:lnTo>
                    <a:pt x="358648" y="658114"/>
                  </a:lnTo>
                  <a:lnTo>
                    <a:pt x="358648" y="89789"/>
                  </a:lnTo>
                  <a:close/>
                </a:path>
                <a:path w="4074159" h="658495">
                  <a:moveTo>
                    <a:pt x="416814" y="299212"/>
                  </a:moveTo>
                  <a:lnTo>
                    <a:pt x="406400" y="299212"/>
                  </a:lnTo>
                  <a:lnTo>
                    <a:pt x="406400" y="658114"/>
                  </a:lnTo>
                  <a:lnTo>
                    <a:pt x="416814" y="658114"/>
                  </a:lnTo>
                  <a:lnTo>
                    <a:pt x="416814" y="299212"/>
                  </a:lnTo>
                  <a:close/>
                </a:path>
                <a:path w="4074159" h="658495">
                  <a:moveTo>
                    <a:pt x="474853" y="119634"/>
                  </a:moveTo>
                  <a:lnTo>
                    <a:pt x="464439" y="119634"/>
                  </a:lnTo>
                  <a:lnTo>
                    <a:pt x="464439" y="658114"/>
                  </a:lnTo>
                  <a:lnTo>
                    <a:pt x="474853" y="658114"/>
                  </a:lnTo>
                  <a:lnTo>
                    <a:pt x="474853" y="119634"/>
                  </a:lnTo>
                  <a:close/>
                </a:path>
                <a:path w="4074159" h="658495">
                  <a:moveTo>
                    <a:pt x="532892" y="239268"/>
                  </a:moveTo>
                  <a:lnTo>
                    <a:pt x="522478" y="239268"/>
                  </a:lnTo>
                  <a:lnTo>
                    <a:pt x="522478" y="658114"/>
                  </a:lnTo>
                  <a:lnTo>
                    <a:pt x="532892" y="658114"/>
                  </a:lnTo>
                  <a:lnTo>
                    <a:pt x="532892" y="239268"/>
                  </a:lnTo>
                  <a:close/>
                </a:path>
                <a:path w="4074159" h="658495">
                  <a:moveTo>
                    <a:pt x="590931" y="119634"/>
                  </a:moveTo>
                  <a:lnTo>
                    <a:pt x="580517" y="119634"/>
                  </a:lnTo>
                  <a:lnTo>
                    <a:pt x="580517" y="658114"/>
                  </a:lnTo>
                  <a:lnTo>
                    <a:pt x="590931" y="658114"/>
                  </a:lnTo>
                  <a:lnTo>
                    <a:pt x="590931" y="119634"/>
                  </a:lnTo>
                  <a:close/>
                </a:path>
                <a:path w="4074159" h="658495">
                  <a:moveTo>
                    <a:pt x="648970" y="329057"/>
                  </a:moveTo>
                  <a:lnTo>
                    <a:pt x="638556" y="329057"/>
                  </a:lnTo>
                  <a:lnTo>
                    <a:pt x="638556" y="658114"/>
                  </a:lnTo>
                  <a:lnTo>
                    <a:pt x="648970" y="658114"/>
                  </a:lnTo>
                  <a:lnTo>
                    <a:pt x="648970" y="329057"/>
                  </a:lnTo>
                  <a:close/>
                </a:path>
                <a:path w="4074159" h="658495">
                  <a:moveTo>
                    <a:pt x="706996" y="359029"/>
                  </a:moveTo>
                  <a:lnTo>
                    <a:pt x="696595" y="359029"/>
                  </a:lnTo>
                  <a:lnTo>
                    <a:pt x="696595" y="658114"/>
                  </a:lnTo>
                  <a:lnTo>
                    <a:pt x="706996" y="658114"/>
                  </a:lnTo>
                  <a:lnTo>
                    <a:pt x="706996" y="359029"/>
                  </a:lnTo>
                  <a:close/>
                </a:path>
                <a:path w="4074159" h="658495">
                  <a:moveTo>
                    <a:pt x="765048" y="448691"/>
                  </a:moveTo>
                  <a:lnTo>
                    <a:pt x="754634" y="448691"/>
                  </a:lnTo>
                  <a:lnTo>
                    <a:pt x="754634" y="658114"/>
                  </a:lnTo>
                  <a:lnTo>
                    <a:pt x="765048" y="658114"/>
                  </a:lnTo>
                  <a:lnTo>
                    <a:pt x="765048" y="448691"/>
                  </a:lnTo>
                  <a:close/>
                </a:path>
                <a:path w="4074159" h="658495">
                  <a:moveTo>
                    <a:pt x="823087" y="329057"/>
                  </a:moveTo>
                  <a:lnTo>
                    <a:pt x="812673" y="329057"/>
                  </a:lnTo>
                  <a:lnTo>
                    <a:pt x="812673" y="658114"/>
                  </a:lnTo>
                  <a:lnTo>
                    <a:pt x="823087" y="658114"/>
                  </a:lnTo>
                  <a:lnTo>
                    <a:pt x="823087" y="329057"/>
                  </a:lnTo>
                  <a:close/>
                </a:path>
                <a:path w="4074159" h="658495">
                  <a:moveTo>
                    <a:pt x="881126" y="538480"/>
                  </a:moveTo>
                  <a:lnTo>
                    <a:pt x="870712" y="538480"/>
                  </a:lnTo>
                  <a:lnTo>
                    <a:pt x="870712" y="658114"/>
                  </a:lnTo>
                  <a:lnTo>
                    <a:pt x="881126" y="658114"/>
                  </a:lnTo>
                  <a:lnTo>
                    <a:pt x="881126" y="538480"/>
                  </a:lnTo>
                  <a:close/>
                </a:path>
                <a:path w="4074159" h="658495">
                  <a:moveTo>
                    <a:pt x="939292" y="478663"/>
                  </a:moveTo>
                  <a:lnTo>
                    <a:pt x="928878" y="478663"/>
                  </a:lnTo>
                  <a:lnTo>
                    <a:pt x="928878" y="658114"/>
                  </a:lnTo>
                  <a:lnTo>
                    <a:pt x="939292" y="658114"/>
                  </a:lnTo>
                  <a:lnTo>
                    <a:pt x="939292" y="478663"/>
                  </a:lnTo>
                  <a:close/>
                </a:path>
                <a:path w="4074159" h="658495">
                  <a:moveTo>
                    <a:pt x="997331" y="269240"/>
                  </a:moveTo>
                  <a:lnTo>
                    <a:pt x="986917" y="269240"/>
                  </a:lnTo>
                  <a:lnTo>
                    <a:pt x="986917" y="658114"/>
                  </a:lnTo>
                  <a:lnTo>
                    <a:pt x="997331" y="658114"/>
                  </a:lnTo>
                  <a:lnTo>
                    <a:pt x="997331" y="269240"/>
                  </a:lnTo>
                  <a:close/>
                </a:path>
                <a:path w="4074159" h="658495">
                  <a:moveTo>
                    <a:pt x="1055370" y="329057"/>
                  </a:moveTo>
                  <a:lnTo>
                    <a:pt x="1044956" y="329057"/>
                  </a:lnTo>
                  <a:lnTo>
                    <a:pt x="1044956" y="658114"/>
                  </a:lnTo>
                  <a:lnTo>
                    <a:pt x="1055370" y="658114"/>
                  </a:lnTo>
                  <a:lnTo>
                    <a:pt x="1055370" y="329057"/>
                  </a:lnTo>
                  <a:close/>
                </a:path>
                <a:path w="4074159" h="658495">
                  <a:moveTo>
                    <a:pt x="1113396" y="239268"/>
                  </a:moveTo>
                  <a:lnTo>
                    <a:pt x="1102995" y="239268"/>
                  </a:lnTo>
                  <a:lnTo>
                    <a:pt x="1102995" y="658114"/>
                  </a:lnTo>
                  <a:lnTo>
                    <a:pt x="1113396" y="658114"/>
                  </a:lnTo>
                  <a:lnTo>
                    <a:pt x="1113396" y="239268"/>
                  </a:lnTo>
                  <a:close/>
                </a:path>
                <a:path w="4074159" h="658495">
                  <a:moveTo>
                    <a:pt x="1171448" y="239268"/>
                  </a:moveTo>
                  <a:lnTo>
                    <a:pt x="1161034" y="239268"/>
                  </a:lnTo>
                  <a:lnTo>
                    <a:pt x="1161034" y="658114"/>
                  </a:lnTo>
                  <a:lnTo>
                    <a:pt x="1171448" y="658114"/>
                  </a:lnTo>
                  <a:lnTo>
                    <a:pt x="1171448" y="239268"/>
                  </a:lnTo>
                  <a:close/>
                </a:path>
                <a:path w="4074159" h="658495">
                  <a:moveTo>
                    <a:pt x="1229487" y="0"/>
                  </a:moveTo>
                  <a:lnTo>
                    <a:pt x="1219073" y="0"/>
                  </a:lnTo>
                  <a:lnTo>
                    <a:pt x="1219073" y="658114"/>
                  </a:lnTo>
                  <a:lnTo>
                    <a:pt x="1229487" y="658114"/>
                  </a:lnTo>
                  <a:lnTo>
                    <a:pt x="1229487" y="0"/>
                  </a:lnTo>
                  <a:close/>
                </a:path>
                <a:path w="4074159" h="658495">
                  <a:moveTo>
                    <a:pt x="1287526" y="418846"/>
                  </a:moveTo>
                  <a:lnTo>
                    <a:pt x="1277112" y="418846"/>
                  </a:lnTo>
                  <a:lnTo>
                    <a:pt x="1277112" y="658114"/>
                  </a:lnTo>
                  <a:lnTo>
                    <a:pt x="1287526" y="658114"/>
                  </a:lnTo>
                  <a:lnTo>
                    <a:pt x="1287526" y="418846"/>
                  </a:lnTo>
                  <a:close/>
                </a:path>
                <a:path w="4074159" h="658495">
                  <a:moveTo>
                    <a:pt x="1345565" y="239268"/>
                  </a:moveTo>
                  <a:lnTo>
                    <a:pt x="1335138" y="239268"/>
                  </a:lnTo>
                  <a:lnTo>
                    <a:pt x="1335138" y="658114"/>
                  </a:lnTo>
                  <a:lnTo>
                    <a:pt x="1345565" y="658114"/>
                  </a:lnTo>
                  <a:lnTo>
                    <a:pt x="1345565" y="239268"/>
                  </a:lnTo>
                  <a:close/>
                </a:path>
                <a:path w="4074159" h="658495">
                  <a:moveTo>
                    <a:pt x="1403604" y="388874"/>
                  </a:moveTo>
                  <a:lnTo>
                    <a:pt x="1393190" y="388874"/>
                  </a:lnTo>
                  <a:lnTo>
                    <a:pt x="1393190" y="658114"/>
                  </a:lnTo>
                  <a:lnTo>
                    <a:pt x="1403604" y="658114"/>
                  </a:lnTo>
                  <a:lnTo>
                    <a:pt x="1403604" y="388874"/>
                  </a:lnTo>
                  <a:close/>
                </a:path>
                <a:path w="4074159" h="658495">
                  <a:moveTo>
                    <a:pt x="1461770" y="418846"/>
                  </a:moveTo>
                  <a:lnTo>
                    <a:pt x="1451356" y="418846"/>
                  </a:lnTo>
                  <a:lnTo>
                    <a:pt x="1451356" y="658114"/>
                  </a:lnTo>
                  <a:lnTo>
                    <a:pt x="1461770" y="658114"/>
                  </a:lnTo>
                  <a:lnTo>
                    <a:pt x="1461770" y="418846"/>
                  </a:lnTo>
                  <a:close/>
                </a:path>
                <a:path w="4074159" h="658495">
                  <a:moveTo>
                    <a:pt x="1519809" y="359029"/>
                  </a:moveTo>
                  <a:lnTo>
                    <a:pt x="1509395" y="359029"/>
                  </a:lnTo>
                  <a:lnTo>
                    <a:pt x="1509395" y="658114"/>
                  </a:lnTo>
                  <a:lnTo>
                    <a:pt x="1519809" y="658114"/>
                  </a:lnTo>
                  <a:lnTo>
                    <a:pt x="1519809" y="359029"/>
                  </a:lnTo>
                  <a:close/>
                </a:path>
                <a:path w="4074159" h="658495">
                  <a:moveTo>
                    <a:pt x="1577848" y="209423"/>
                  </a:moveTo>
                  <a:lnTo>
                    <a:pt x="1567434" y="209423"/>
                  </a:lnTo>
                  <a:lnTo>
                    <a:pt x="1567434" y="658114"/>
                  </a:lnTo>
                  <a:lnTo>
                    <a:pt x="1577848" y="658114"/>
                  </a:lnTo>
                  <a:lnTo>
                    <a:pt x="1577848" y="209423"/>
                  </a:lnTo>
                  <a:close/>
                </a:path>
                <a:path w="4074159" h="658495">
                  <a:moveTo>
                    <a:pt x="1635887" y="239268"/>
                  </a:moveTo>
                  <a:lnTo>
                    <a:pt x="1625473" y="239268"/>
                  </a:lnTo>
                  <a:lnTo>
                    <a:pt x="1625473" y="658114"/>
                  </a:lnTo>
                  <a:lnTo>
                    <a:pt x="1635887" y="658114"/>
                  </a:lnTo>
                  <a:lnTo>
                    <a:pt x="1635887" y="239268"/>
                  </a:lnTo>
                  <a:close/>
                </a:path>
                <a:path w="4074159" h="658495">
                  <a:moveTo>
                    <a:pt x="1693926" y="478663"/>
                  </a:moveTo>
                  <a:lnTo>
                    <a:pt x="1683512" y="478663"/>
                  </a:lnTo>
                  <a:lnTo>
                    <a:pt x="1683512" y="658114"/>
                  </a:lnTo>
                  <a:lnTo>
                    <a:pt x="1693926" y="658114"/>
                  </a:lnTo>
                  <a:lnTo>
                    <a:pt x="1693926" y="478663"/>
                  </a:lnTo>
                  <a:close/>
                </a:path>
                <a:path w="4074159" h="658495">
                  <a:moveTo>
                    <a:pt x="1751965" y="359029"/>
                  </a:moveTo>
                  <a:lnTo>
                    <a:pt x="1741551" y="359029"/>
                  </a:lnTo>
                  <a:lnTo>
                    <a:pt x="1741551" y="658114"/>
                  </a:lnTo>
                  <a:lnTo>
                    <a:pt x="1751965" y="658114"/>
                  </a:lnTo>
                  <a:lnTo>
                    <a:pt x="1751965" y="359029"/>
                  </a:lnTo>
                  <a:close/>
                </a:path>
                <a:path w="4074159" h="658495">
                  <a:moveTo>
                    <a:pt x="1810004" y="329057"/>
                  </a:moveTo>
                  <a:lnTo>
                    <a:pt x="1799590" y="329057"/>
                  </a:lnTo>
                  <a:lnTo>
                    <a:pt x="1799590" y="658114"/>
                  </a:lnTo>
                  <a:lnTo>
                    <a:pt x="1810004" y="658114"/>
                  </a:lnTo>
                  <a:lnTo>
                    <a:pt x="1810004" y="329057"/>
                  </a:lnTo>
                  <a:close/>
                </a:path>
                <a:path w="4074159" h="658495">
                  <a:moveTo>
                    <a:pt x="1868043" y="418846"/>
                  </a:moveTo>
                  <a:lnTo>
                    <a:pt x="1857629" y="418846"/>
                  </a:lnTo>
                  <a:lnTo>
                    <a:pt x="1857629" y="658114"/>
                  </a:lnTo>
                  <a:lnTo>
                    <a:pt x="1868043" y="658114"/>
                  </a:lnTo>
                  <a:lnTo>
                    <a:pt x="1868043" y="418846"/>
                  </a:lnTo>
                  <a:close/>
                </a:path>
                <a:path w="4074159" h="658495">
                  <a:moveTo>
                    <a:pt x="1926082" y="299212"/>
                  </a:moveTo>
                  <a:lnTo>
                    <a:pt x="1915668" y="299212"/>
                  </a:lnTo>
                  <a:lnTo>
                    <a:pt x="1915668" y="658114"/>
                  </a:lnTo>
                  <a:lnTo>
                    <a:pt x="1926082" y="658114"/>
                  </a:lnTo>
                  <a:lnTo>
                    <a:pt x="1926082" y="299212"/>
                  </a:lnTo>
                  <a:close/>
                </a:path>
                <a:path w="4074159" h="658495">
                  <a:moveTo>
                    <a:pt x="1984121" y="299212"/>
                  </a:moveTo>
                  <a:lnTo>
                    <a:pt x="1973707" y="299212"/>
                  </a:lnTo>
                  <a:lnTo>
                    <a:pt x="1973707" y="658114"/>
                  </a:lnTo>
                  <a:lnTo>
                    <a:pt x="1984121" y="658114"/>
                  </a:lnTo>
                  <a:lnTo>
                    <a:pt x="1984121" y="299212"/>
                  </a:lnTo>
                  <a:close/>
                </a:path>
                <a:path w="4074159" h="658495">
                  <a:moveTo>
                    <a:pt x="2042287" y="448691"/>
                  </a:moveTo>
                  <a:lnTo>
                    <a:pt x="2031873" y="448691"/>
                  </a:lnTo>
                  <a:lnTo>
                    <a:pt x="2031873" y="658114"/>
                  </a:lnTo>
                  <a:lnTo>
                    <a:pt x="2042287" y="658114"/>
                  </a:lnTo>
                  <a:lnTo>
                    <a:pt x="2042287" y="448691"/>
                  </a:lnTo>
                  <a:close/>
                </a:path>
                <a:path w="4074159" h="658495">
                  <a:moveTo>
                    <a:pt x="2100326" y="568325"/>
                  </a:moveTo>
                  <a:lnTo>
                    <a:pt x="2089912" y="568325"/>
                  </a:lnTo>
                  <a:lnTo>
                    <a:pt x="2089912" y="658114"/>
                  </a:lnTo>
                  <a:lnTo>
                    <a:pt x="2100326" y="658114"/>
                  </a:lnTo>
                  <a:lnTo>
                    <a:pt x="2100326" y="568325"/>
                  </a:lnTo>
                  <a:close/>
                </a:path>
                <a:path w="4074159" h="658495">
                  <a:moveTo>
                    <a:pt x="2158365" y="359029"/>
                  </a:moveTo>
                  <a:lnTo>
                    <a:pt x="2147951" y="359029"/>
                  </a:lnTo>
                  <a:lnTo>
                    <a:pt x="2147951" y="658114"/>
                  </a:lnTo>
                  <a:lnTo>
                    <a:pt x="2158365" y="658114"/>
                  </a:lnTo>
                  <a:lnTo>
                    <a:pt x="2158365" y="359029"/>
                  </a:lnTo>
                  <a:close/>
                </a:path>
                <a:path w="4074159" h="658495">
                  <a:moveTo>
                    <a:pt x="2216404" y="329057"/>
                  </a:moveTo>
                  <a:lnTo>
                    <a:pt x="2205990" y="329057"/>
                  </a:lnTo>
                  <a:lnTo>
                    <a:pt x="2205990" y="658114"/>
                  </a:lnTo>
                  <a:lnTo>
                    <a:pt x="2216404" y="658114"/>
                  </a:lnTo>
                  <a:lnTo>
                    <a:pt x="2216404" y="329057"/>
                  </a:lnTo>
                  <a:close/>
                </a:path>
                <a:path w="4074159" h="658495">
                  <a:moveTo>
                    <a:pt x="2274443" y="359029"/>
                  </a:moveTo>
                  <a:lnTo>
                    <a:pt x="2264029" y="359029"/>
                  </a:lnTo>
                  <a:lnTo>
                    <a:pt x="2264029" y="658114"/>
                  </a:lnTo>
                  <a:lnTo>
                    <a:pt x="2274443" y="658114"/>
                  </a:lnTo>
                  <a:lnTo>
                    <a:pt x="2274443" y="359029"/>
                  </a:lnTo>
                  <a:close/>
                </a:path>
                <a:path w="4074159" h="658495">
                  <a:moveTo>
                    <a:pt x="2332482" y="209423"/>
                  </a:moveTo>
                  <a:lnTo>
                    <a:pt x="2322068" y="209423"/>
                  </a:lnTo>
                  <a:lnTo>
                    <a:pt x="2322068" y="658114"/>
                  </a:lnTo>
                  <a:lnTo>
                    <a:pt x="2332482" y="658114"/>
                  </a:lnTo>
                  <a:lnTo>
                    <a:pt x="2332482" y="209423"/>
                  </a:lnTo>
                  <a:close/>
                </a:path>
                <a:path w="4074159" h="658495">
                  <a:moveTo>
                    <a:pt x="2390521" y="329057"/>
                  </a:moveTo>
                  <a:lnTo>
                    <a:pt x="2380107" y="329057"/>
                  </a:lnTo>
                  <a:lnTo>
                    <a:pt x="2380107" y="658114"/>
                  </a:lnTo>
                  <a:lnTo>
                    <a:pt x="2390521" y="658114"/>
                  </a:lnTo>
                  <a:lnTo>
                    <a:pt x="2390521" y="329057"/>
                  </a:lnTo>
                  <a:close/>
                </a:path>
                <a:path w="4074159" h="658495">
                  <a:moveTo>
                    <a:pt x="2448560" y="359029"/>
                  </a:moveTo>
                  <a:lnTo>
                    <a:pt x="2438146" y="359029"/>
                  </a:lnTo>
                  <a:lnTo>
                    <a:pt x="2438146" y="658114"/>
                  </a:lnTo>
                  <a:lnTo>
                    <a:pt x="2448560" y="658114"/>
                  </a:lnTo>
                  <a:lnTo>
                    <a:pt x="2448560" y="359029"/>
                  </a:lnTo>
                  <a:close/>
                </a:path>
                <a:path w="4074159" h="658495">
                  <a:moveTo>
                    <a:pt x="2506599" y="359029"/>
                  </a:moveTo>
                  <a:lnTo>
                    <a:pt x="2496185" y="359029"/>
                  </a:lnTo>
                  <a:lnTo>
                    <a:pt x="2496185" y="658114"/>
                  </a:lnTo>
                  <a:lnTo>
                    <a:pt x="2506599" y="658114"/>
                  </a:lnTo>
                  <a:lnTo>
                    <a:pt x="2506599" y="359029"/>
                  </a:lnTo>
                  <a:close/>
                </a:path>
                <a:path w="4074159" h="658495">
                  <a:moveTo>
                    <a:pt x="2564765" y="359029"/>
                  </a:moveTo>
                  <a:lnTo>
                    <a:pt x="2554351" y="359029"/>
                  </a:lnTo>
                  <a:lnTo>
                    <a:pt x="2554351" y="658114"/>
                  </a:lnTo>
                  <a:lnTo>
                    <a:pt x="2564765" y="658114"/>
                  </a:lnTo>
                  <a:lnTo>
                    <a:pt x="2564765" y="359029"/>
                  </a:lnTo>
                  <a:close/>
                </a:path>
                <a:path w="4074159" h="658495">
                  <a:moveTo>
                    <a:pt x="2622804" y="269240"/>
                  </a:moveTo>
                  <a:lnTo>
                    <a:pt x="2612390" y="269240"/>
                  </a:lnTo>
                  <a:lnTo>
                    <a:pt x="2612390" y="658114"/>
                  </a:lnTo>
                  <a:lnTo>
                    <a:pt x="2622804" y="658114"/>
                  </a:lnTo>
                  <a:lnTo>
                    <a:pt x="2622804" y="269240"/>
                  </a:lnTo>
                  <a:close/>
                </a:path>
                <a:path w="4074159" h="658495">
                  <a:moveTo>
                    <a:pt x="2680843" y="359029"/>
                  </a:moveTo>
                  <a:lnTo>
                    <a:pt x="2670429" y="359029"/>
                  </a:lnTo>
                  <a:lnTo>
                    <a:pt x="2670429" y="658114"/>
                  </a:lnTo>
                  <a:lnTo>
                    <a:pt x="2680843" y="658114"/>
                  </a:lnTo>
                  <a:lnTo>
                    <a:pt x="2680843" y="359029"/>
                  </a:lnTo>
                  <a:close/>
                </a:path>
                <a:path w="4074159" h="658495">
                  <a:moveTo>
                    <a:pt x="2738882" y="418846"/>
                  </a:moveTo>
                  <a:lnTo>
                    <a:pt x="2728468" y="418846"/>
                  </a:lnTo>
                  <a:lnTo>
                    <a:pt x="2728468" y="658114"/>
                  </a:lnTo>
                  <a:lnTo>
                    <a:pt x="2738882" y="658114"/>
                  </a:lnTo>
                  <a:lnTo>
                    <a:pt x="2738882" y="418846"/>
                  </a:lnTo>
                  <a:close/>
                </a:path>
                <a:path w="4074159" h="658495">
                  <a:moveTo>
                    <a:pt x="2796921" y="179451"/>
                  </a:moveTo>
                  <a:lnTo>
                    <a:pt x="2786507" y="179451"/>
                  </a:lnTo>
                  <a:lnTo>
                    <a:pt x="2786507" y="658114"/>
                  </a:lnTo>
                  <a:lnTo>
                    <a:pt x="2796921" y="658114"/>
                  </a:lnTo>
                  <a:lnTo>
                    <a:pt x="2796921" y="179451"/>
                  </a:lnTo>
                  <a:close/>
                </a:path>
                <a:path w="4074159" h="658495">
                  <a:moveTo>
                    <a:pt x="2862834" y="418846"/>
                  </a:moveTo>
                  <a:lnTo>
                    <a:pt x="2849753" y="418846"/>
                  </a:lnTo>
                  <a:lnTo>
                    <a:pt x="2849753" y="658114"/>
                  </a:lnTo>
                  <a:lnTo>
                    <a:pt x="2862834" y="658114"/>
                  </a:lnTo>
                  <a:lnTo>
                    <a:pt x="2862834" y="418846"/>
                  </a:lnTo>
                  <a:close/>
                </a:path>
                <a:path w="4074159" h="658495">
                  <a:moveTo>
                    <a:pt x="2912999" y="418846"/>
                  </a:moveTo>
                  <a:lnTo>
                    <a:pt x="2902585" y="418846"/>
                  </a:lnTo>
                  <a:lnTo>
                    <a:pt x="2902585" y="658114"/>
                  </a:lnTo>
                  <a:lnTo>
                    <a:pt x="2912999" y="658114"/>
                  </a:lnTo>
                  <a:lnTo>
                    <a:pt x="2912999" y="418846"/>
                  </a:lnTo>
                  <a:close/>
                </a:path>
                <a:path w="4074159" h="658495">
                  <a:moveTo>
                    <a:pt x="2971038" y="269240"/>
                  </a:moveTo>
                  <a:lnTo>
                    <a:pt x="2960624" y="269240"/>
                  </a:lnTo>
                  <a:lnTo>
                    <a:pt x="2960624" y="658114"/>
                  </a:lnTo>
                  <a:lnTo>
                    <a:pt x="2971038" y="658114"/>
                  </a:lnTo>
                  <a:lnTo>
                    <a:pt x="2971038" y="269240"/>
                  </a:lnTo>
                  <a:close/>
                </a:path>
                <a:path w="4074159" h="658495">
                  <a:moveTo>
                    <a:pt x="3029077" y="59817"/>
                  </a:moveTo>
                  <a:lnTo>
                    <a:pt x="3018663" y="59817"/>
                  </a:lnTo>
                  <a:lnTo>
                    <a:pt x="3018663" y="658114"/>
                  </a:lnTo>
                  <a:lnTo>
                    <a:pt x="3029077" y="658114"/>
                  </a:lnTo>
                  <a:lnTo>
                    <a:pt x="3029077" y="59817"/>
                  </a:lnTo>
                  <a:close/>
                </a:path>
                <a:path w="4074159" h="658495">
                  <a:moveTo>
                    <a:pt x="3087243" y="388874"/>
                  </a:moveTo>
                  <a:lnTo>
                    <a:pt x="3076829" y="388874"/>
                  </a:lnTo>
                  <a:lnTo>
                    <a:pt x="3076829" y="658114"/>
                  </a:lnTo>
                  <a:lnTo>
                    <a:pt x="3087243" y="658114"/>
                  </a:lnTo>
                  <a:lnTo>
                    <a:pt x="3087243" y="388874"/>
                  </a:lnTo>
                  <a:close/>
                </a:path>
                <a:path w="4074159" h="658495">
                  <a:moveTo>
                    <a:pt x="3145282" y="359029"/>
                  </a:moveTo>
                  <a:lnTo>
                    <a:pt x="3134868" y="359029"/>
                  </a:lnTo>
                  <a:lnTo>
                    <a:pt x="3134868" y="658114"/>
                  </a:lnTo>
                  <a:lnTo>
                    <a:pt x="3145282" y="658114"/>
                  </a:lnTo>
                  <a:lnTo>
                    <a:pt x="3145282" y="359029"/>
                  </a:lnTo>
                  <a:close/>
                </a:path>
                <a:path w="4074159" h="658495">
                  <a:moveTo>
                    <a:pt x="3203321" y="448691"/>
                  </a:moveTo>
                  <a:lnTo>
                    <a:pt x="3192907" y="448691"/>
                  </a:lnTo>
                  <a:lnTo>
                    <a:pt x="3192907" y="658114"/>
                  </a:lnTo>
                  <a:lnTo>
                    <a:pt x="3203321" y="658114"/>
                  </a:lnTo>
                  <a:lnTo>
                    <a:pt x="3203321" y="448691"/>
                  </a:lnTo>
                  <a:close/>
                </a:path>
                <a:path w="4074159" h="658495">
                  <a:moveTo>
                    <a:pt x="3261360" y="508508"/>
                  </a:moveTo>
                  <a:lnTo>
                    <a:pt x="3250946" y="508508"/>
                  </a:lnTo>
                  <a:lnTo>
                    <a:pt x="3250946" y="658114"/>
                  </a:lnTo>
                  <a:lnTo>
                    <a:pt x="3261360" y="658114"/>
                  </a:lnTo>
                  <a:lnTo>
                    <a:pt x="3261360" y="508508"/>
                  </a:lnTo>
                  <a:close/>
                </a:path>
                <a:path w="4074159" h="658495">
                  <a:moveTo>
                    <a:pt x="3319399" y="478663"/>
                  </a:moveTo>
                  <a:lnTo>
                    <a:pt x="3308985" y="478663"/>
                  </a:lnTo>
                  <a:lnTo>
                    <a:pt x="3308985" y="658114"/>
                  </a:lnTo>
                  <a:lnTo>
                    <a:pt x="3319399" y="658114"/>
                  </a:lnTo>
                  <a:lnTo>
                    <a:pt x="3319399" y="478663"/>
                  </a:lnTo>
                  <a:close/>
                </a:path>
                <a:path w="4074159" h="658495">
                  <a:moveTo>
                    <a:pt x="3377438" y="209423"/>
                  </a:moveTo>
                  <a:lnTo>
                    <a:pt x="3367024" y="209423"/>
                  </a:lnTo>
                  <a:lnTo>
                    <a:pt x="3367024" y="658114"/>
                  </a:lnTo>
                  <a:lnTo>
                    <a:pt x="3377438" y="658114"/>
                  </a:lnTo>
                  <a:lnTo>
                    <a:pt x="3377438" y="209423"/>
                  </a:lnTo>
                  <a:close/>
                </a:path>
                <a:path w="4074159" h="658495">
                  <a:moveTo>
                    <a:pt x="3435477" y="388874"/>
                  </a:moveTo>
                  <a:lnTo>
                    <a:pt x="3425063" y="388874"/>
                  </a:lnTo>
                  <a:lnTo>
                    <a:pt x="3425063" y="658114"/>
                  </a:lnTo>
                  <a:lnTo>
                    <a:pt x="3435477" y="658114"/>
                  </a:lnTo>
                  <a:lnTo>
                    <a:pt x="3435477" y="388874"/>
                  </a:lnTo>
                  <a:close/>
                </a:path>
                <a:path w="4074159" h="658495">
                  <a:moveTo>
                    <a:pt x="3493516" y="149606"/>
                  </a:moveTo>
                  <a:lnTo>
                    <a:pt x="3483102" y="149606"/>
                  </a:lnTo>
                  <a:lnTo>
                    <a:pt x="3483102" y="658114"/>
                  </a:lnTo>
                  <a:lnTo>
                    <a:pt x="3493516" y="658114"/>
                  </a:lnTo>
                  <a:lnTo>
                    <a:pt x="3493516" y="149606"/>
                  </a:lnTo>
                  <a:close/>
                </a:path>
                <a:path w="4074159" h="658495">
                  <a:moveTo>
                    <a:pt x="3551555" y="388874"/>
                  </a:moveTo>
                  <a:lnTo>
                    <a:pt x="3541141" y="388874"/>
                  </a:lnTo>
                  <a:lnTo>
                    <a:pt x="3541141" y="658114"/>
                  </a:lnTo>
                  <a:lnTo>
                    <a:pt x="3551555" y="658114"/>
                  </a:lnTo>
                  <a:lnTo>
                    <a:pt x="3551555" y="388874"/>
                  </a:lnTo>
                  <a:close/>
                </a:path>
                <a:path w="4074159" h="658495">
                  <a:moveTo>
                    <a:pt x="3609594" y="329057"/>
                  </a:moveTo>
                  <a:lnTo>
                    <a:pt x="3599180" y="329057"/>
                  </a:lnTo>
                  <a:lnTo>
                    <a:pt x="3599180" y="658114"/>
                  </a:lnTo>
                  <a:lnTo>
                    <a:pt x="3609594" y="658114"/>
                  </a:lnTo>
                  <a:lnTo>
                    <a:pt x="3609594" y="329057"/>
                  </a:lnTo>
                  <a:close/>
                </a:path>
                <a:path w="4074159" h="658495">
                  <a:moveTo>
                    <a:pt x="3667760" y="418846"/>
                  </a:moveTo>
                  <a:lnTo>
                    <a:pt x="3657346" y="418846"/>
                  </a:lnTo>
                  <a:lnTo>
                    <a:pt x="3657346" y="658114"/>
                  </a:lnTo>
                  <a:lnTo>
                    <a:pt x="3667760" y="658114"/>
                  </a:lnTo>
                  <a:lnTo>
                    <a:pt x="3667760" y="418846"/>
                  </a:lnTo>
                  <a:close/>
                </a:path>
                <a:path w="4074159" h="658495">
                  <a:moveTo>
                    <a:pt x="3725799" y="478663"/>
                  </a:moveTo>
                  <a:lnTo>
                    <a:pt x="3715385" y="478663"/>
                  </a:lnTo>
                  <a:lnTo>
                    <a:pt x="3715385" y="658114"/>
                  </a:lnTo>
                  <a:lnTo>
                    <a:pt x="3725799" y="658114"/>
                  </a:lnTo>
                  <a:lnTo>
                    <a:pt x="3725799" y="478663"/>
                  </a:lnTo>
                  <a:close/>
                </a:path>
                <a:path w="4074159" h="658495">
                  <a:moveTo>
                    <a:pt x="3783838" y="448691"/>
                  </a:moveTo>
                  <a:lnTo>
                    <a:pt x="3773424" y="448691"/>
                  </a:lnTo>
                  <a:lnTo>
                    <a:pt x="3773424" y="658114"/>
                  </a:lnTo>
                  <a:lnTo>
                    <a:pt x="3783838" y="658114"/>
                  </a:lnTo>
                  <a:lnTo>
                    <a:pt x="3783838" y="448691"/>
                  </a:lnTo>
                  <a:close/>
                </a:path>
                <a:path w="4074159" h="658495">
                  <a:moveTo>
                    <a:pt x="3841877" y="269240"/>
                  </a:moveTo>
                  <a:lnTo>
                    <a:pt x="3831463" y="269240"/>
                  </a:lnTo>
                  <a:lnTo>
                    <a:pt x="3831463" y="658114"/>
                  </a:lnTo>
                  <a:lnTo>
                    <a:pt x="3841877" y="658114"/>
                  </a:lnTo>
                  <a:lnTo>
                    <a:pt x="3841877" y="269240"/>
                  </a:lnTo>
                  <a:close/>
                </a:path>
                <a:path w="4074159" h="658495">
                  <a:moveTo>
                    <a:pt x="3899916" y="329057"/>
                  </a:moveTo>
                  <a:lnTo>
                    <a:pt x="3889502" y="329057"/>
                  </a:lnTo>
                  <a:lnTo>
                    <a:pt x="3889502" y="658114"/>
                  </a:lnTo>
                  <a:lnTo>
                    <a:pt x="3899916" y="658114"/>
                  </a:lnTo>
                  <a:lnTo>
                    <a:pt x="3899916" y="329057"/>
                  </a:lnTo>
                  <a:close/>
                </a:path>
                <a:path w="4074159" h="658495">
                  <a:moveTo>
                    <a:pt x="3957955" y="538480"/>
                  </a:moveTo>
                  <a:lnTo>
                    <a:pt x="3947541" y="538480"/>
                  </a:lnTo>
                  <a:lnTo>
                    <a:pt x="3947541" y="658114"/>
                  </a:lnTo>
                  <a:lnTo>
                    <a:pt x="3957955" y="658114"/>
                  </a:lnTo>
                  <a:lnTo>
                    <a:pt x="3957955" y="538480"/>
                  </a:lnTo>
                  <a:close/>
                </a:path>
                <a:path w="4074159" h="658495">
                  <a:moveTo>
                    <a:pt x="4015994" y="329057"/>
                  </a:moveTo>
                  <a:lnTo>
                    <a:pt x="4005580" y="329057"/>
                  </a:lnTo>
                  <a:lnTo>
                    <a:pt x="4005580" y="658114"/>
                  </a:lnTo>
                  <a:lnTo>
                    <a:pt x="4015994" y="658114"/>
                  </a:lnTo>
                  <a:lnTo>
                    <a:pt x="4015994" y="329057"/>
                  </a:lnTo>
                  <a:close/>
                </a:path>
                <a:path w="4074159" h="658495">
                  <a:moveTo>
                    <a:pt x="4074033" y="478663"/>
                  </a:moveTo>
                  <a:lnTo>
                    <a:pt x="4063619" y="478663"/>
                  </a:lnTo>
                  <a:lnTo>
                    <a:pt x="4063619" y="658114"/>
                  </a:lnTo>
                  <a:lnTo>
                    <a:pt x="4074033" y="658114"/>
                  </a:lnTo>
                  <a:lnTo>
                    <a:pt x="4074033" y="478663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3" name="object 103" descr=""/>
            <p:cNvSpPr/>
            <p:nvPr/>
          </p:nvSpPr>
          <p:spPr>
            <a:xfrm>
              <a:off x="9272905" y="8243570"/>
              <a:ext cx="4132579" cy="419100"/>
            </a:xfrm>
            <a:custGeom>
              <a:avLst/>
              <a:gdLst/>
              <a:ahLst/>
              <a:cxnLst/>
              <a:rect l="l" t="t" r="r" b="b"/>
              <a:pathLst>
                <a:path w="4132580" h="419100">
                  <a:moveTo>
                    <a:pt x="10414" y="239395"/>
                  </a:moveTo>
                  <a:lnTo>
                    <a:pt x="0" y="239395"/>
                  </a:lnTo>
                  <a:lnTo>
                    <a:pt x="0" y="418846"/>
                  </a:lnTo>
                  <a:lnTo>
                    <a:pt x="10414" y="418846"/>
                  </a:lnTo>
                  <a:lnTo>
                    <a:pt x="10414" y="239395"/>
                  </a:lnTo>
                  <a:close/>
                </a:path>
                <a:path w="4132580" h="419100">
                  <a:moveTo>
                    <a:pt x="68453" y="209423"/>
                  </a:moveTo>
                  <a:lnTo>
                    <a:pt x="58039" y="209423"/>
                  </a:lnTo>
                  <a:lnTo>
                    <a:pt x="58039" y="418846"/>
                  </a:lnTo>
                  <a:lnTo>
                    <a:pt x="68453" y="418846"/>
                  </a:lnTo>
                  <a:lnTo>
                    <a:pt x="68453" y="209423"/>
                  </a:lnTo>
                  <a:close/>
                </a:path>
                <a:path w="4132580" h="419100">
                  <a:moveTo>
                    <a:pt x="126619" y="179578"/>
                  </a:moveTo>
                  <a:lnTo>
                    <a:pt x="116205" y="179578"/>
                  </a:lnTo>
                  <a:lnTo>
                    <a:pt x="116205" y="418846"/>
                  </a:lnTo>
                  <a:lnTo>
                    <a:pt x="126619" y="418846"/>
                  </a:lnTo>
                  <a:lnTo>
                    <a:pt x="126619" y="179578"/>
                  </a:lnTo>
                  <a:close/>
                </a:path>
                <a:path w="4132580" h="419100">
                  <a:moveTo>
                    <a:pt x="184658" y="299212"/>
                  </a:moveTo>
                  <a:lnTo>
                    <a:pt x="174244" y="299212"/>
                  </a:lnTo>
                  <a:lnTo>
                    <a:pt x="174244" y="418846"/>
                  </a:lnTo>
                  <a:lnTo>
                    <a:pt x="184658" y="418846"/>
                  </a:lnTo>
                  <a:lnTo>
                    <a:pt x="184658" y="299212"/>
                  </a:lnTo>
                  <a:close/>
                </a:path>
                <a:path w="4132580" h="419100">
                  <a:moveTo>
                    <a:pt x="242697" y="29972"/>
                  </a:moveTo>
                  <a:lnTo>
                    <a:pt x="232283" y="29972"/>
                  </a:lnTo>
                  <a:lnTo>
                    <a:pt x="232283" y="418846"/>
                  </a:lnTo>
                  <a:lnTo>
                    <a:pt x="242697" y="418846"/>
                  </a:lnTo>
                  <a:lnTo>
                    <a:pt x="242697" y="29972"/>
                  </a:lnTo>
                  <a:close/>
                </a:path>
                <a:path w="4132580" h="419100">
                  <a:moveTo>
                    <a:pt x="300736" y="299212"/>
                  </a:moveTo>
                  <a:lnTo>
                    <a:pt x="290322" y="299212"/>
                  </a:lnTo>
                  <a:lnTo>
                    <a:pt x="290322" y="418846"/>
                  </a:lnTo>
                  <a:lnTo>
                    <a:pt x="300736" y="418846"/>
                  </a:lnTo>
                  <a:lnTo>
                    <a:pt x="300736" y="299212"/>
                  </a:lnTo>
                  <a:close/>
                </a:path>
                <a:path w="4132580" h="419100">
                  <a:moveTo>
                    <a:pt x="358775" y="119761"/>
                  </a:moveTo>
                  <a:lnTo>
                    <a:pt x="348361" y="119761"/>
                  </a:lnTo>
                  <a:lnTo>
                    <a:pt x="348361" y="418846"/>
                  </a:lnTo>
                  <a:lnTo>
                    <a:pt x="358775" y="418846"/>
                  </a:lnTo>
                  <a:lnTo>
                    <a:pt x="358775" y="119761"/>
                  </a:lnTo>
                  <a:close/>
                </a:path>
                <a:path w="4132580" h="419100">
                  <a:moveTo>
                    <a:pt x="416814" y="329057"/>
                  </a:moveTo>
                  <a:lnTo>
                    <a:pt x="406400" y="329057"/>
                  </a:lnTo>
                  <a:lnTo>
                    <a:pt x="406400" y="418846"/>
                  </a:lnTo>
                  <a:lnTo>
                    <a:pt x="416814" y="418846"/>
                  </a:lnTo>
                  <a:lnTo>
                    <a:pt x="416814" y="329057"/>
                  </a:lnTo>
                  <a:close/>
                </a:path>
                <a:path w="4132580" h="419100">
                  <a:moveTo>
                    <a:pt x="474853" y="29972"/>
                  </a:moveTo>
                  <a:lnTo>
                    <a:pt x="464439" y="29972"/>
                  </a:lnTo>
                  <a:lnTo>
                    <a:pt x="464439" y="418846"/>
                  </a:lnTo>
                  <a:lnTo>
                    <a:pt x="474853" y="418846"/>
                  </a:lnTo>
                  <a:lnTo>
                    <a:pt x="474853" y="29972"/>
                  </a:lnTo>
                  <a:close/>
                </a:path>
                <a:path w="4132580" h="419100">
                  <a:moveTo>
                    <a:pt x="532892" y="269240"/>
                  </a:moveTo>
                  <a:lnTo>
                    <a:pt x="522478" y="269240"/>
                  </a:lnTo>
                  <a:lnTo>
                    <a:pt x="522478" y="418846"/>
                  </a:lnTo>
                  <a:lnTo>
                    <a:pt x="532892" y="418846"/>
                  </a:lnTo>
                  <a:lnTo>
                    <a:pt x="532892" y="269240"/>
                  </a:lnTo>
                  <a:close/>
                </a:path>
                <a:path w="4132580" h="419100">
                  <a:moveTo>
                    <a:pt x="590931" y="239395"/>
                  </a:moveTo>
                  <a:lnTo>
                    <a:pt x="580517" y="239395"/>
                  </a:lnTo>
                  <a:lnTo>
                    <a:pt x="580517" y="418846"/>
                  </a:lnTo>
                  <a:lnTo>
                    <a:pt x="590931" y="418846"/>
                  </a:lnTo>
                  <a:lnTo>
                    <a:pt x="590931" y="239395"/>
                  </a:lnTo>
                  <a:close/>
                </a:path>
                <a:path w="4132580" h="419100">
                  <a:moveTo>
                    <a:pt x="649097" y="149606"/>
                  </a:moveTo>
                  <a:lnTo>
                    <a:pt x="638683" y="149606"/>
                  </a:lnTo>
                  <a:lnTo>
                    <a:pt x="638683" y="418846"/>
                  </a:lnTo>
                  <a:lnTo>
                    <a:pt x="649097" y="418846"/>
                  </a:lnTo>
                  <a:lnTo>
                    <a:pt x="649097" y="149606"/>
                  </a:lnTo>
                  <a:close/>
                </a:path>
                <a:path w="4132580" h="419100">
                  <a:moveTo>
                    <a:pt x="707136" y="269240"/>
                  </a:moveTo>
                  <a:lnTo>
                    <a:pt x="696722" y="269240"/>
                  </a:lnTo>
                  <a:lnTo>
                    <a:pt x="696722" y="418846"/>
                  </a:lnTo>
                  <a:lnTo>
                    <a:pt x="707136" y="418846"/>
                  </a:lnTo>
                  <a:lnTo>
                    <a:pt x="707136" y="269240"/>
                  </a:lnTo>
                  <a:close/>
                </a:path>
                <a:path w="4132580" h="419100">
                  <a:moveTo>
                    <a:pt x="765175" y="239395"/>
                  </a:moveTo>
                  <a:lnTo>
                    <a:pt x="754761" y="239395"/>
                  </a:lnTo>
                  <a:lnTo>
                    <a:pt x="754761" y="418846"/>
                  </a:lnTo>
                  <a:lnTo>
                    <a:pt x="765175" y="418846"/>
                  </a:lnTo>
                  <a:lnTo>
                    <a:pt x="765175" y="239395"/>
                  </a:lnTo>
                  <a:close/>
                </a:path>
                <a:path w="4132580" h="419100">
                  <a:moveTo>
                    <a:pt x="831075" y="209423"/>
                  </a:moveTo>
                  <a:lnTo>
                    <a:pt x="818007" y="209423"/>
                  </a:lnTo>
                  <a:lnTo>
                    <a:pt x="818007" y="418846"/>
                  </a:lnTo>
                  <a:lnTo>
                    <a:pt x="831075" y="418846"/>
                  </a:lnTo>
                  <a:lnTo>
                    <a:pt x="831075" y="209423"/>
                  </a:lnTo>
                  <a:close/>
                </a:path>
                <a:path w="4132580" h="419100">
                  <a:moveTo>
                    <a:pt x="881253" y="179578"/>
                  </a:moveTo>
                  <a:lnTo>
                    <a:pt x="870839" y="179578"/>
                  </a:lnTo>
                  <a:lnTo>
                    <a:pt x="870839" y="418846"/>
                  </a:lnTo>
                  <a:lnTo>
                    <a:pt x="881253" y="418846"/>
                  </a:lnTo>
                  <a:lnTo>
                    <a:pt x="881253" y="179578"/>
                  </a:lnTo>
                  <a:close/>
                </a:path>
                <a:path w="4132580" h="419100">
                  <a:moveTo>
                    <a:pt x="939292" y="179578"/>
                  </a:moveTo>
                  <a:lnTo>
                    <a:pt x="928878" y="179578"/>
                  </a:lnTo>
                  <a:lnTo>
                    <a:pt x="928878" y="418846"/>
                  </a:lnTo>
                  <a:lnTo>
                    <a:pt x="939292" y="418846"/>
                  </a:lnTo>
                  <a:lnTo>
                    <a:pt x="939292" y="179578"/>
                  </a:lnTo>
                  <a:close/>
                </a:path>
                <a:path w="4132580" h="419100">
                  <a:moveTo>
                    <a:pt x="997331" y="29972"/>
                  </a:moveTo>
                  <a:lnTo>
                    <a:pt x="986917" y="29972"/>
                  </a:lnTo>
                  <a:lnTo>
                    <a:pt x="986917" y="418846"/>
                  </a:lnTo>
                  <a:lnTo>
                    <a:pt x="997331" y="418846"/>
                  </a:lnTo>
                  <a:lnTo>
                    <a:pt x="997331" y="29972"/>
                  </a:lnTo>
                  <a:close/>
                </a:path>
                <a:path w="4132580" h="419100">
                  <a:moveTo>
                    <a:pt x="1055370" y="299212"/>
                  </a:moveTo>
                  <a:lnTo>
                    <a:pt x="1044956" y="299212"/>
                  </a:lnTo>
                  <a:lnTo>
                    <a:pt x="1044956" y="418846"/>
                  </a:lnTo>
                  <a:lnTo>
                    <a:pt x="1055370" y="418846"/>
                  </a:lnTo>
                  <a:lnTo>
                    <a:pt x="1055370" y="299212"/>
                  </a:lnTo>
                  <a:close/>
                </a:path>
                <a:path w="4132580" h="419100">
                  <a:moveTo>
                    <a:pt x="1113409" y="329057"/>
                  </a:moveTo>
                  <a:lnTo>
                    <a:pt x="1102995" y="329057"/>
                  </a:lnTo>
                  <a:lnTo>
                    <a:pt x="1102995" y="418846"/>
                  </a:lnTo>
                  <a:lnTo>
                    <a:pt x="1113409" y="418846"/>
                  </a:lnTo>
                  <a:lnTo>
                    <a:pt x="1113409" y="329057"/>
                  </a:lnTo>
                  <a:close/>
                </a:path>
                <a:path w="4132580" h="419100">
                  <a:moveTo>
                    <a:pt x="1171448" y="179578"/>
                  </a:moveTo>
                  <a:lnTo>
                    <a:pt x="1161034" y="179578"/>
                  </a:lnTo>
                  <a:lnTo>
                    <a:pt x="1161034" y="418846"/>
                  </a:lnTo>
                  <a:lnTo>
                    <a:pt x="1171448" y="418846"/>
                  </a:lnTo>
                  <a:lnTo>
                    <a:pt x="1171448" y="179578"/>
                  </a:lnTo>
                  <a:close/>
                </a:path>
                <a:path w="4132580" h="419100">
                  <a:moveTo>
                    <a:pt x="1229614" y="149606"/>
                  </a:moveTo>
                  <a:lnTo>
                    <a:pt x="1219200" y="149606"/>
                  </a:lnTo>
                  <a:lnTo>
                    <a:pt x="1219200" y="418846"/>
                  </a:lnTo>
                  <a:lnTo>
                    <a:pt x="1229614" y="418846"/>
                  </a:lnTo>
                  <a:lnTo>
                    <a:pt x="1229614" y="149606"/>
                  </a:lnTo>
                  <a:close/>
                </a:path>
                <a:path w="4132580" h="419100">
                  <a:moveTo>
                    <a:pt x="1295527" y="149606"/>
                  </a:moveTo>
                  <a:lnTo>
                    <a:pt x="1282446" y="149606"/>
                  </a:lnTo>
                  <a:lnTo>
                    <a:pt x="1282446" y="418846"/>
                  </a:lnTo>
                  <a:lnTo>
                    <a:pt x="1295527" y="418846"/>
                  </a:lnTo>
                  <a:lnTo>
                    <a:pt x="1295527" y="149606"/>
                  </a:lnTo>
                  <a:close/>
                </a:path>
                <a:path w="4132580" h="419100">
                  <a:moveTo>
                    <a:pt x="1345692" y="179578"/>
                  </a:moveTo>
                  <a:lnTo>
                    <a:pt x="1335278" y="179578"/>
                  </a:lnTo>
                  <a:lnTo>
                    <a:pt x="1335278" y="418846"/>
                  </a:lnTo>
                  <a:lnTo>
                    <a:pt x="1345692" y="418846"/>
                  </a:lnTo>
                  <a:lnTo>
                    <a:pt x="1345692" y="179578"/>
                  </a:lnTo>
                  <a:close/>
                </a:path>
                <a:path w="4132580" h="419100">
                  <a:moveTo>
                    <a:pt x="1403731" y="329057"/>
                  </a:moveTo>
                  <a:lnTo>
                    <a:pt x="1393317" y="329057"/>
                  </a:lnTo>
                  <a:lnTo>
                    <a:pt x="1393317" y="418846"/>
                  </a:lnTo>
                  <a:lnTo>
                    <a:pt x="1403731" y="418846"/>
                  </a:lnTo>
                  <a:lnTo>
                    <a:pt x="1403731" y="329057"/>
                  </a:lnTo>
                  <a:close/>
                </a:path>
                <a:path w="4132580" h="419100">
                  <a:moveTo>
                    <a:pt x="1461770" y="179578"/>
                  </a:moveTo>
                  <a:lnTo>
                    <a:pt x="1451356" y="179578"/>
                  </a:lnTo>
                  <a:lnTo>
                    <a:pt x="1451356" y="418846"/>
                  </a:lnTo>
                  <a:lnTo>
                    <a:pt x="1461770" y="418846"/>
                  </a:lnTo>
                  <a:lnTo>
                    <a:pt x="1461770" y="179578"/>
                  </a:lnTo>
                  <a:close/>
                </a:path>
                <a:path w="4132580" h="419100">
                  <a:moveTo>
                    <a:pt x="1519809" y="299212"/>
                  </a:moveTo>
                  <a:lnTo>
                    <a:pt x="1509395" y="299212"/>
                  </a:lnTo>
                  <a:lnTo>
                    <a:pt x="1509395" y="418846"/>
                  </a:lnTo>
                  <a:lnTo>
                    <a:pt x="1519809" y="418846"/>
                  </a:lnTo>
                  <a:lnTo>
                    <a:pt x="1519809" y="299212"/>
                  </a:lnTo>
                  <a:close/>
                </a:path>
                <a:path w="4132580" h="419100">
                  <a:moveTo>
                    <a:pt x="1577848" y="0"/>
                  </a:moveTo>
                  <a:lnTo>
                    <a:pt x="1567434" y="0"/>
                  </a:lnTo>
                  <a:lnTo>
                    <a:pt x="1567434" y="418846"/>
                  </a:lnTo>
                  <a:lnTo>
                    <a:pt x="1577848" y="418846"/>
                  </a:lnTo>
                  <a:lnTo>
                    <a:pt x="1577848" y="0"/>
                  </a:lnTo>
                  <a:close/>
                </a:path>
                <a:path w="4132580" h="419100">
                  <a:moveTo>
                    <a:pt x="1635887" y="179578"/>
                  </a:moveTo>
                  <a:lnTo>
                    <a:pt x="1625473" y="179578"/>
                  </a:lnTo>
                  <a:lnTo>
                    <a:pt x="1625473" y="418846"/>
                  </a:lnTo>
                  <a:lnTo>
                    <a:pt x="1635887" y="418846"/>
                  </a:lnTo>
                  <a:lnTo>
                    <a:pt x="1635887" y="179578"/>
                  </a:lnTo>
                  <a:close/>
                </a:path>
                <a:path w="4132580" h="419100">
                  <a:moveTo>
                    <a:pt x="1693926" y="119761"/>
                  </a:moveTo>
                  <a:lnTo>
                    <a:pt x="1683512" y="119761"/>
                  </a:lnTo>
                  <a:lnTo>
                    <a:pt x="1683512" y="418846"/>
                  </a:lnTo>
                  <a:lnTo>
                    <a:pt x="1693926" y="418846"/>
                  </a:lnTo>
                  <a:lnTo>
                    <a:pt x="1693926" y="119761"/>
                  </a:lnTo>
                  <a:close/>
                </a:path>
                <a:path w="4132580" h="419100">
                  <a:moveTo>
                    <a:pt x="1752092" y="59944"/>
                  </a:moveTo>
                  <a:lnTo>
                    <a:pt x="1741678" y="59944"/>
                  </a:lnTo>
                  <a:lnTo>
                    <a:pt x="1741678" y="418846"/>
                  </a:lnTo>
                  <a:lnTo>
                    <a:pt x="1752092" y="418846"/>
                  </a:lnTo>
                  <a:lnTo>
                    <a:pt x="1752092" y="59944"/>
                  </a:lnTo>
                  <a:close/>
                </a:path>
                <a:path w="4132580" h="419100">
                  <a:moveTo>
                    <a:pt x="1810131" y="269240"/>
                  </a:moveTo>
                  <a:lnTo>
                    <a:pt x="1799717" y="269240"/>
                  </a:lnTo>
                  <a:lnTo>
                    <a:pt x="1799717" y="418846"/>
                  </a:lnTo>
                  <a:lnTo>
                    <a:pt x="1810131" y="418846"/>
                  </a:lnTo>
                  <a:lnTo>
                    <a:pt x="1810131" y="269240"/>
                  </a:lnTo>
                  <a:close/>
                </a:path>
                <a:path w="4132580" h="419100">
                  <a:moveTo>
                    <a:pt x="1876044" y="269240"/>
                  </a:moveTo>
                  <a:lnTo>
                    <a:pt x="1862963" y="269240"/>
                  </a:lnTo>
                  <a:lnTo>
                    <a:pt x="1862963" y="418846"/>
                  </a:lnTo>
                  <a:lnTo>
                    <a:pt x="1876044" y="418846"/>
                  </a:lnTo>
                  <a:lnTo>
                    <a:pt x="1876044" y="269240"/>
                  </a:lnTo>
                  <a:close/>
                </a:path>
                <a:path w="4132580" h="419100">
                  <a:moveTo>
                    <a:pt x="1926209" y="329057"/>
                  </a:moveTo>
                  <a:lnTo>
                    <a:pt x="1915795" y="329057"/>
                  </a:lnTo>
                  <a:lnTo>
                    <a:pt x="1915795" y="418846"/>
                  </a:lnTo>
                  <a:lnTo>
                    <a:pt x="1926209" y="418846"/>
                  </a:lnTo>
                  <a:lnTo>
                    <a:pt x="1926209" y="329057"/>
                  </a:lnTo>
                  <a:close/>
                </a:path>
                <a:path w="4132580" h="419100">
                  <a:moveTo>
                    <a:pt x="1984248" y="269240"/>
                  </a:moveTo>
                  <a:lnTo>
                    <a:pt x="1973834" y="269240"/>
                  </a:lnTo>
                  <a:lnTo>
                    <a:pt x="1973834" y="418846"/>
                  </a:lnTo>
                  <a:lnTo>
                    <a:pt x="1984248" y="418846"/>
                  </a:lnTo>
                  <a:lnTo>
                    <a:pt x="1984248" y="269240"/>
                  </a:lnTo>
                  <a:close/>
                </a:path>
                <a:path w="4132580" h="419100">
                  <a:moveTo>
                    <a:pt x="2042287" y="299212"/>
                  </a:moveTo>
                  <a:lnTo>
                    <a:pt x="2031873" y="299212"/>
                  </a:lnTo>
                  <a:lnTo>
                    <a:pt x="2031873" y="418846"/>
                  </a:lnTo>
                  <a:lnTo>
                    <a:pt x="2042287" y="418846"/>
                  </a:lnTo>
                  <a:lnTo>
                    <a:pt x="2042287" y="299212"/>
                  </a:lnTo>
                  <a:close/>
                </a:path>
                <a:path w="4132580" h="419100">
                  <a:moveTo>
                    <a:pt x="2100326" y="209423"/>
                  </a:moveTo>
                  <a:lnTo>
                    <a:pt x="2089912" y="209423"/>
                  </a:lnTo>
                  <a:lnTo>
                    <a:pt x="2089912" y="418846"/>
                  </a:lnTo>
                  <a:lnTo>
                    <a:pt x="2100326" y="418846"/>
                  </a:lnTo>
                  <a:lnTo>
                    <a:pt x="2100326" y="209423"/>
                  </a:lnTo>
                  <a:close/>
                </a:path>
                <a:path w="4132580" h="419100">
                  <a:moveTo>
                    <a:pt x="2158365" y="329057"/>
                  </a:moveTo>
                  <a:lnTo>
                    <a:pt x="2147951" y="329057"/>
                  </a:lnTo>
                  <a:lnTo>
                    <a:pt x="2147951" y="418846"/>
                  </a:lnTo>
                  <a:lnTo>
                    <a:pt x="2158365" y="418846"/>
                  </a:lnTo>
                  <a:lnTo>
                    <a:pt x="2158365" y="329057"/>
                  </a:lnTo>
                  <a:close/>
                </a:path>
                <a:path w="4132580" h="419100">
                  <a:moveTo>
                    <a:pt x="2216404" y="299212"/>
                  </a:moveTo>
                  <a:lnTo>
                    <a:pt x="2205990" y="299212"/>
                  </a:lnTo>
                  <a:lnTo>
                    <a:pt x="2205990" y="418846"/>
                  </a:lnTo>
                  <a:lnTo>
                    <a:pt x="2216404" y="418846"/>
                  </a:lnTo>
                  <a:lnTo>
                    <a:pt x="2216404" y="299212"/>
                  </a:lnTo>
                  <a:close/>
                </a:path>
                <a:path w="4132580" h="419100">
                  <a:moveTo>
                    <a:pt x="2274443" y="359029"/>
                  </a:moveTo>
                  <a:lnTo>
                    <a:pt x="2264029" y="359029"/>
                  </a:lnTo>
                  <a:lnTo>
                    <a:pt x="2264029" y="418846"/>
                  </a:lnTo>
                  <a:lnTo>
                    <a:pt x="2274443" y="418846"/>
                  </a:lnTo>
                  <a:lnTo>
                    <a:pt x="2274443" y="359029"/>
                  </a:lnTo>
                  <a:close/>
                </a:path>
                <a:path w="4132580" h="419100">
                  <a:moveTo>
                    <a:pt x="2332609" y="299212"/>
                  </a:moveTo>
                  <a:lnTo>
                    <a:pt x="2322195" y="299212"/>
                  </a:lnTo>
                  <a:lnTo>
                    <a:pt x="2322195" y="418846"/>
                  </a:lnTo>
                  <a:lnTo>
                    <a:pt x="2332609" y="418846"/>
                  </a:lnTo>
                  <a:lnTo>
                    <a:pt x="2332609" y="299212"/>
                  </a:lnTo>
                  <a:close/>
                </a:path>
                <a:path w="4132580" h="419100">
                  <a:moveTo>
                    <a:pt x="2390648" y="269240"/>
                  </a:moveTo>
                  <a:lnTo>
                    <a:pt x="2380234" y="269240"/>
                  </a:lnTo>
                  <a:lnTo>
                    <a:pt x="2380234" y="418846"/>
                  </a:lnTo>
                  <a:lnTo>
                    <a:pt x="2390648" y="418846"/>
                  </a:lnTo>
                  <a:lnTo>
                    <a:pt x="2390648" y="269240"/>
                  </a:lnTo>
                  <a:close/>
                </a:path>
                <a:path w="4132580" h="419100">
                  <a:moveTo>
                    <a:pt x="2456548" y="299212"/>
                  </a:moveTo>
                  <a:lnTo>
                    <a:pt x="2443480" y="299212"/>
                  </a:lnTo>
                  <a:lnTo>
                    <a:pt x="2443480" y="418846"/>
                  </a:lnTo>
                  <a:lnTo>
                    <a:pt x="2456548" y="418846"/>
                  </a:lnTo>
                  <a:lnTo>
                    <a:pt x="2456548" y="299212"/>
                  </a:lnTo>
                  <a:close/>
                </a:path>
                <a:path w="4132580" h="419100">
                  <a:moveTo>
                    <a:pt x="2506726" y="209423"/>
                  </a:moveTo>
                  <a:lnTo>
                    <a:pt x="2496312" y="209423"/>
                  </a:lnTo>
                  <a:lnTo>
                    <a:pt x="2496312" y="418846"/>
                  </a:lnTo>
                  <a:lnTo>
                    <a:pt x="2506726" y="418846"/>
                  </a:lnTo>
                  <a:lnTo>
                    <a:pt x="2506726" y="209423"/>
                  </a:lnTo>
                  <a:close/>
                </a:path>
                <a:path w="4132580" h="419100">
                  <a:moveTo>
                    <a:pt x="2564765" y="179578"/>
                  </a:moveTo>
                  <a:lnTo>
                    <a:pt x="2554351" y="179578"/>
                  </a:lnTo>
                  <a:lnTo>
                    <a:pt x="2554351" y="418846"/>
                  </a:lnTo>
                  <a:lnTo>
                    <a:pt x="2564765" y="418846"/>
                  </a:lnTo>
                  <a:lnTo>
                    <a:pt x="2564765" y="179578"/>
                  </a:lnTo>
                  <a:close/>
                </a:path>
                <a:path w="4132580" h="419100">
                  <a:moveTo>
                    <a:pt x="2630678" y="299212"/>
                  </a:moveTo>
                  <a:lnTo>
                    <a:pt x="2617597" y="299212"/>
                  </a:lnTo>
                  <a:lnTo>
                    <a:pt x="2617597" y="418846"/>
                  </a:lnTo>
                  <a:lnTo>
                    <a:pt x="2630678" y="418846"/>
                  </a:lnTo>
                  <a:lnTo>
                    <a:pt x="2630678" y="299212"/>
                  </a:lnTo>
                  <a:close/>
                </a:path>
                <a:path w="4132580" h="419100">
                  <a:moveTo>
                    <a:pt x="2680843" y="239395"/>
                  </a:moveTo>
                  <a:lnTo>
                    <a:pt x="2670429" y="239395"/>
                  </a:lnTo>
                  <a:lnTo>
                    <a:pt x="2670429" y="418846"/>
                  </a:lnTo>
                  <a:lnTo>
                    <a:pt x="2680843" y="418846"/>
                  </a:lnTo>
                  <a:lnTo>
                    <a:pt x="2680843" y="239395"/>
                  </a:lnTo>
                  <a:close/>
                </a:path>
                <a:path w="4132580" h="419100">
                  <a:moveTo>
                    <a:pt x="2738882" y="209423"/>
                  </a:moveTo>
                  <a:lnTo>
                    <a:pt x="2728468" y="209423"/>
                  </a:lnTo>
                  <a:lnTo>
                    <a:pt x="2728468" y="418846"/>
                  </a:lnTo>
                  <a:lnTo>
                    <a:pt x="2738882" y="418846"/>
                  </a:lnTo>
                  <a:lnTo>
                    <a:pt x="2738882" y="209423"/>
                  </a:lnTo>
                  <a:close/>
                </a:path>
                <a:path w="4132580" h="419100">
                  <a:moveTo>
                    <a:pt x="2796921" y="359029"/>
                  </a:moveTo>
                  <a:lnTo>
                    <a:pt x="2786507" y="359029"/>
                  </a:lnTo>
                  <a:lnTo>
                    <a:pt x="2786507" y="418846"/>
                  </a:lnTo>
                  <a:lnTo>
                    <a:pt x="2796921" y="418846"/>
                  </a:lnTo>
                  <a:lnTo>
                    <a:pt x="2796921" y="359029"/>
                  </a:lnTo>
                  <a:close/>
                </a:path>
                <a:path w="4132580" h="419100">
                  <a:moveTo>
                    <a:pt x="2862948" y="388874"/>
                  </a:moveTo>
                  <a:lnTo>
                    <a:pt x="2849880" y="388874"/>
                  </a:lnTo>
                  <a:lnTo>
                    <a:pt x="2849880" y="418846"/>
                  </a:lnTo>
                  <a:lnTo>
                    <a:pt x="2862948" y="418846"/>
                  </a:lnTo>
                  <a:lnTo>
                    <a:pt x="2862948" y="388874"/>
                  </a:lnTo>
                  <a:close/>
                </a:path>
                <a:path w="4132580" h="419100">
                  <a:moveTo>
                    <a:pt x="2913126" y="269240"/>
                  </a:moveTo>
                  <a:lnTo>
                    <a:pt x="2902712" y="269240"/>
                  </a:lnTo>
                  <a:lnTo>
                    <a:pt x="2902712" y="418846"/>
                  </a:lnTo>
                  <a:lnTo>
                    <a:pt x="2913126" y="418846"/>
                  </a:lnTo>
                  <a:lnTo>
                    <a:pt x="2913126" y="269240"/>
                  </a:lnTo>
                  <a:close/>
                </a:path>
                <a:path w="4132580" h="419100">
                  <a:moveTo>
                    <a:pt x="2971165" y="119761"/>
                  </a:moveTo>
                  <a:lnTo>
                    <a:pt x="2960751" y="119761"/>
                  </a:lnTo>
                  <a:lnTo>
                    <a:pt x="2960751" y="418846"/>
                  </a:lnTo>
                  <a:lnTo>
                    <a:pt x="2971165" y="418846"/>
                  </a:lnTo>
                  <a:lnTo>
                    <a:pt x="2971165" y="119761"/>
                  </a:lnTo>
                  <a:close/>
                </a:path>
                <a:path w="4132580" h="419100">
                  <a:moveTo>
                    <a:pt x="3029204" y="388874"/>
                  </a:moveTo>
                  <a:lnTo>
                    <a:pt x="3018790" y="388874"/>
                  </a:lnTo>
                  <a:lnTo>
                    <a:pt x="3018790" y="418846"/>
                  </a:lnTo>
                  <a:lnTo>
                    <a:pt x="3029204" y="418846"/>
                  </a:lnTo>
                  <a:lnTo>
                    <a:pt x="3029204" y="388874"/>
                  </a:lnTo>
                  <a:close/>
                </a:path>
                <a:path w="4132580" h="419100">
                  <a:moveTo>
                    <a:pt x="3087243" y="239395"/>
                  </a:moveTo>
                  <a:lnTo>
                    <a:pt x="3076829" y="239395"/>
                  </a:lnTo>
                  <a:lnTo>
                    <a:pt x="3076829" y="418846"/>
                  </a:lnTo>
                  <a:lnTo>
                    <a:pt x="3087243" y="418846"/>
                  </a:lnTo>
                  <a:lnTo>
                    <a:pt x="3087243" y="239395"/>
                  </a:lnTo>
                  <a:close/>
                </a:path>
                <a:path w="4132580" h="419100">
                  <a:moveTo>
                    <a:pt x="3145282" y="359029"/>
                  </a:moveTo>
                  <a:lnTo>
                    <a:pt x="3134868" y="359029"/>
                  </a:lnTo>
                  <a:lnTo>
                    <a:pt x="3134868" y="418846"/>
                  </a:lnTo>
                  <a:lnTo>
                    <a:pt x="3145282" y="418846"/>
                  </a:lnTo>
                  <a:lnTo>
                    <a:pt x="3145282" y="359029"/>
                  </a:lnTo>
                  <a:close/>
                </a:path>
                <a:path w="4132580" h="419100">
                  <a:moveTo>
                    <a:pt x="3203321" y="209423"/>
                  </a:moveTo>
                  <a:lnTo>
                    <a:pt x="3192907" y="209423"/>
                  </a:lnTo>
                  <a:lnTo>
                    <a:pt x="3192907" y="418846"/>
                  </a:lnTo>
                  <a:lnTo>
                    <a:pt x="3203321" y="418846"/>
                  </a:lnTo>
                  <a:lnTo>
                    <a:pt x="3203321" y="209423"/>
                  </a:lnTo>
                  <a:close/>
                </a:path>
                <a:path w="4132580" h="419100">
                  <a:moveTo>
                    <a:pt x="3261360" y="359029"/>
                  </a:moveTo>
                  <a:lnTo>
                    <a:pt x="3250946" y="359029"/>
                  </a:lnTo>
                  <a:lnTo>
                    <a:pt x="3250946" y="418846"/>
                  </a:lnTo>
                  <a:lnTo>
                    <a:pt x="3261360" y="418846"/>
                  </a:lnTo>
                  <a:lnTo>
                    <a:pt x="3261360" y="359029"/>
                  </a:lnTo>
                  <a:close/>
                </a:path>
                <a:path w="4132580" h="419100">
                  <a:moveTo>
                    <a:pt x="3327400" y="149606"/>
                  </a:moveTo>
                  <a:lnTo>
                    <a:pt x="3314319" y="149606"/>
                  </a:lnTo>
                  <a:lnTo>
                    <a:pt x="3314319" y="418846"/>
                  </a:lnTo>
                  <a:lnTo>
                    <a:pt x="3327400" y="418846"/>
                  </a:lnTo>
                  <a:lnTo>
                    <a:pt x="3327400" y="149606"/>
                  </a:lnTo>
                  <a:close/>
                </a:path>
                <a:path w="4132580" h="419100">
                  <a:moveTo>
                    <a:pt x="3385439" y="269240"/>
                  </a:moveTo>
                  <a:lnTo>
                    <a:pt x="3372358" y="269240"/>
                  </a:lnTo>
                  <a:lnTo>
                    <a:pt x="3372358" y="418846"/>
                  </a:lnTo>
                  <a:lnTo>
                    <a:pt x="3385439" y="418846"/>
                  </a:lnTo>
                  <a:lnTo>
                    <a:pt x="3385439" y="269240"/>
                  </a:lnTo>
                  <a:close/>
                </a:path>
                <a:path w="4132580" h="419100">
                  <a:moveTo>
                    <a:pt x="3435604" y="179578"/>
                  </a:moveTo>
                  <a:lnTo>
                    <a:pt x="3425190" y="179578"/>
                  </a:lnTo>
                  <a:lnTo>
                    <a:pt x="3425190" y="418846"/>
                  </a:lnTo>
                  <a:lnTo>
                    <a:pt x="3435604" y="418846"/>
                  </a:lnTo>
                  <a:lnTo>
                    <a:pt x="3435604" y="179578"/>
                  </a:lnTo>
                  <a:close/>
                </a:path>
                <a:path w="4132580" h="419100">
                  <a:moveTo>
                    <a:pt x="3493643" y="299212"/>
                  </a:moveTo>
                  <a:lnTo>
                    <a:pt x="3483229" y="299212"/>
                  </a:lnTo>
                  <a:lnTo>
                    <a:pt x="3483229" y="418846"/>
                  </a:lnTo>
                  <a:lnTo>
                    <a:pt x="3493643" y="418846"/>
                  </a:lnTo>
                  <a:lnTo>
                    <a:pt x="3493643" y="299212"/>
                  </a:lnTo>
                  <a:close/>
                </a:path>
                <a:path w="4132580" h="419100">
                  <a:moveTo>
                    <a:pt x="3551682" y="359029"/>
                  </a:moveTo>
                  <a:lnTo>
                    <a:pt x="3541268" y="359029"/>
                  </a:lnTo>
                  <a:lnTo>
                    <a:pt x="3541268" y="418846"/>
                  </a:lnTo>
                  <a:lnTo>
                    <a:pt x="3551682" y="418846"/>
                  </a:lnTo>
                  <a:lnTo>
                    <a:pt x="3551682" y="359029"/>
                  </a:lnTo>
                  <a:close/>
                </a:path>
                <a:path w="4132580" h="419100">
                  <a:moveTo>
                    <a:pt x="3609721" y="299212"/>
                  </a:moveTo>
                  <a:lnTo>
                    <a:pt x="3599307" y="299212"/>
                  </a:lnTo>
                  <a:lnTo>
                    <a:pt x="3599307" y="418846"/>
                  </a:lnTo>
                  <a:lnTo>
                    <a:pt x="3609721" y="418846"/>
                  </a:lnTo>
                  <a:lnTo>
                    <a:pt x="3609721" y="299212"/>
                  </a:lnTo>
                  <a:close/>
                </a:path>
                <a:path w="4132580" h="419100">
                  <a:moveTo>
                    <a:pt x="3667760" y="209423"/>
                  </a:moveTo>
                  <a:lnTo>
                    <a:pt x="3657346" y="209423"/>
                  </a:lnTo>
                  <a:lnTo>
                    <a:pt x="3657346" y="418846"/>
                  </a:lnTo>
                  <a:lnTo>
                    <a:pt x="3667760" y="418846"/>
                  </a:lnTo>
                  <a:lnTo>
                    <a:pt x="3667760" y="209423"/>
                  </a:lnTo>
                  <a:close/>
                </a:path>
                <a:path w="4132580" h="419100">
                  <a:moveTo>
                    <a:pt x="3725799" y="299212"/>
                  </a:moveTo>
                  <a:lnTo>
                    <a:pt x="3715385" y="299212"/>
                  </a:lnTo>
                  <a:lnTo>
                    <a:pt x="3715385" y="418846"/>
                  </a:lnTo>
                  <a:lnTo>
                    <a:pt x="3725799" y="418846"/>
                  </a:lnTo>
                  <a:lnTo>
                    <a:pt x="3725799" y="299212"/>
                  </a:lnTo>
                  <a:close/>
                </a:path>
                <a:path w="4132580" h="419100">
                  <a:moveTo>
                    <a:pt x="3783825" y="329057"/>
                  </a:moveTo>
                  <a:lnTo>
                    <a:pt x="3773424" y="329057"/>
                  </a:lnTo>
                  <a:lnTo>
                    <a:pt x="3773424" y="418846"/>
                  </a:lnTo>
                  <a:lnTo>
                    <a:pt x="3783825" y="418846"/>
                  </a:lnTo>
                  <a:lnTo>
                    <a:pt x="3783825" y="329057"/>
                  </a:lnTo>
                  <a:close/>
                </a:path>
                <a:path w="4132580" h="419100">
                  <a:moveTo>
                    <a:pt x="3849878" y="269240"/>
                  </a:moveTo>
                  <a:lnTo>
                    <a:pt x="3836797" y="269240"/>
                  </a:lnTo>
                  <a:lnTo>
                    <a:pt x="3836797" y="418846"/>
                  </a:lnTo>
                  <a:lnTo>
                    <a:pt x="3849878" y="418846"/>
                  </a:lnTo>
                  <a:lnTo>
                    <a:pt x="3849878" y="269240"/>
                  </a:lnTo>
                  <a:close/>
                </a:path>
                <a:path w="4132580" h="419100">
                  <a:moveTo>
                    <a:pt x="3899916" y="359029"/>
                  </a:moveTo>
                  <a:lnTo>
                    <a:pt x="3889502" y="359029"/>
                  </a:lnTo>
                  <a:lnTo>
                    <a:pt x="3889502" y="418846"/>
                  </a:lnTo>
                  <a:lnTo>
                    <a:pt x="3899916" y="418846"/>
                  </a:lnTo>
                  <a:lnTo>
                    <a:pt x="3899916" y="359029"/>
                  </a:lnTo>
                  <a:close/>
                </a:path>
                <a:path w="4132580" h="419100">
                  <a:moveTo>
                    <a:pt x="3965956" y="329057"/>
                  </a:moveTo>
                  <a:lnTo>
                    <a:pt x="3952875" y="329057"/>
                  </a:lnTo>
                  <a:lnTo>
                    <a:pt x="3952875" y="418846"/>
                  </a:lnTo>
                  <a:lnTo>
                    <a:pt x="3965956" y="418846"/>
                  </a:lnTo>
                  <a:lnTo>
                    <a:pt x="3965956" y="329057"/>
                  </a:lnTo>
                  <a:close/>
                </a:path>
                <a:path w="4132580" h="419100">
                  <a:moveTo>
                    <a:pt x="4082034" y="329057"/>
                  </a:moveTo>
                  <a:lnTo>
                    <a:pt x="4068953" y="329057"/>
                  </a:lnTo>
                  <a:lnTo>
                    <a:pt x="4068953" y="418846"/>
                  </a:lnTo>
                  <a:lnTo>
                    <a:pt x="4082034" y="418846"/>
                  </a:lnTo>
                  <a:lnTo>
                    <a:pt x="4082034" y="329057"/>
                  </a:lnTo>
                  <a:close/>
                </a:path>
                <a:path w="4132580" h="419100">
                  <a:moveTo>
                    <a:pt x="4132199" y="119761"/>
                  </a:moveTo>
                  <a:lnTo>
                    <a:pt x="4121785" y="119761"/>
                  </a:lnTo>
                  <a:lnTo>
                    <a:pt x="4121785" y="418846"/>
                  </a:lnTo>
                  <a:lnTo>
                    <a:pt x="4132199" y="418846"/>
                  </a:lnTo>
                  <a:lnTo>
                    <a:pt x="4132199" y="119761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4" name="object 104" descr=""/>
            <p:cNvSpPr/>
            <p:nvPr/>
          </p:nvSpPr>
          <p:spPr>
            <a:xfrm>
              <a:off x="13394690" y="8363331"/>
              <a:ext cx="2237740" cy="299085"/>
            </a:xfrm>
            <a:custGeom>
              <a:avLst/>
              <a:gdLst/>
              <a:ahLst/>
              <a:cxnLst/>
              <a:rect l="l" t="t" r="r" b="b"/>
              <a:pathLst>
                <a:path w="2237740" h="299084">
                  <a:moveTo>
                    <a:pt x="10414" y="0"/>
                  </a:moveTo>
                  <a:lnTo>
                    <a:pt x="0" y="0"/>
                  </a:lnTo>
                  <a:lnTo>
                    <a:pt x="0" y="299085"/>
                  </a:lnTo>
                  <a:lnTo>
                    <a:pt x="10414" y="299085"/>
                  </a:lnTo>
                  <a:lnTo>
                    <a:pt x="10414" y="0"/>
                  </a:lnTo>
                  <a:close/>
                </a:path>
                <a:path w="2237740" h="299084">
                  <a:moveTo>
                    <a:pt x="68453" y="179451"/>
                  </a:moveTo>
                  <a:lnTo>
                    <a:pt x="58039" y="179451"/>
                  </a:lnTo>
                  <a:lnTo>
                    <a:pt x="58039" y="299085"/>
                  </a:lnTo>
                  <a:lnTo>
                    <a:pt x="68453" y="299085"/>
                  </a:lnTo>
                  <a:lnTo>
                    <a:pt x="68453" y="179451"/>
                  </a:lnTo>
                  <a:close/>
                </a:path>
                <a:path w="2237740" h="299084">
                  <a:moveTo>
                    <a:pt x="134366" y="149479"/>
                  </a:moveTo>
                  <a:lnTo>
                    <a:pt x="121285" y="149479"/>
                  </a:lnTo>
                  <a:lnTo>
                    <a:pt x="121285" y="299085"/>
                  </a:lnTo>
                  <a:lnTo>
                    <a:pt x="134366" y="299085"/>
                  </a:lnTo>
                  <a:lnTo>
                    <a:pt x="134366" y="149479"/>
                  </a:lnTo>
                  <a:close/>
                </a:path>
                <a:path w="2237740" h="299084">
                  <a:moveTo>
                    <a:pt x="192405" y="179451"/>
                  </a:moveTo>
                  <a:lnTo>
                    <a:pt x="179324" y="179451"/>
                  </a:lnTo>
                  <a:lnTo>
                    <a:pt x="179324" y="299085"/>
                  </a:lnTo>
                  <a:lnTo>
                    <a:pt x="192405" y="299085"/>
                  </a:lnTo>
                  <a:lnTo>
                    <a:pt x="192405" y="179451"/>
                  </a:lnTo>
                  <a:close/>
                </a:path>
                <a:path w="2237740" h="299084">
                  <a:moveTo>
                    <a:pt x="250444" y="239268"/>
                  </a:moveTo>
                  <a:lnTo>
                    <a:pt x="237363" y="239268"/>
                  </a:lnTo>
                  <a:lnTo>
                    <a:pt x="237363" y="299085"/>
                  </a:lnTo>
                  <a:lnTo>
                    <a:pt x="250444" y="299085"/>
                  </a:lnTo>
                  <a:lnTo>
                    <a:pt x="250444" y="239268"/>
                  </a:lnTo>
                  <a:close/>
                </a:path>
                <a:path w="2237740" h="299084">
                  <a:moveTo>
                    <a:pt x="366649" y="149479"/>
                  </a:moveTo>
                  <a:lnTo>
                    <a:pt x="353568" y="149479"/>
                  </a:lnTo>
                  <a:lnTo>
                    <a:pt x="353568" y="299085"/>
                  </a:lnTo>
                  <a:lnTo>
                    <a:pt x="366649" y="299085"/>
                  </a:lnTo>
                  <a:lnTo>
                    <a:pt x="366649" y="149479"/>
                  </a:lnTo>
                  <a:close/>
                </a:path>
                <a:path w="2237740" h="299084">
                  <a:moveTo>
                    <a:pt x="424675" y="149479"/>
                  </a:moveTo>
                  <a:lnTo>
                    <a:pt x="411607" y="149479"/>
                  </a:lnTo>
                  <a:lnTo>
                    <a:pt x="411607" y="299085"/>
                  </a:lnTo>
                  <a:lnTo>
                    <a:pt x="424675" y="299085"/>
                  </a:lnTo>
                  <a:lnTo>
                    <a:pt x="424675" y="149479"/>
                  </a:lnTo>
                  <a:close/>
                </a:path>
                <a:path w="2237740" h="299084">
                  <a:moveTo>
                    <a:pt x="474853" y="209296"/>
                  </a:moveTo>
                  <a:lnTo>
                    <a:pt x="464439" y="209296"/>
                  </a:lnTo>
                  <a:lnTo>
                    <a:pt x="464439" y="299085"/>
                  </a:lnTo>
                  <a:lnTo>
                    <a:pt x="474853" y="299085"/>
                  </a:lnTo>
                  <a:lnTo>
                    <a:pt x="474853" y="209296"/>
                  </a:lnTo>
                  <a:close/>
                </a:path>
                <a:path w="2237740" h="299084">
                  <a:moveTo>
                    <a:pt x="532879" y="119634"/>
                  </a:moveTo>
                  <a:lnTo>
                    <a:pt x="522478" y="119634"/>
                  </a:lnTo>
                  <a:lnTo>
                    <a:pt x="522478" y="299085"/>
                  </a:lnTo>
                  <a:lnTo>
                    <a:pt x="532879" y="299085"/>
                  </a:lnTo>
                  <a:lnTo>
                    <a:pt x="532879" y="119634"/>
                  </a:lnTo>
                  <a:close/>
                </a:path>
                <a:path w="2237740" h="299084">
                  <a:moveTo>
                    <a:pt x="590931" y="239268"/>
                  </a:moveTo>
                  <a:lnTo>
                    <a:pt x="580517" y="239268"/>
                  </a:lnTo>
                  <a:lnTo>
                    <a:pt x="580517" y="299085"/>
                  </a:lnTo>
                  <a:lnTo>
                    <a:pt x="590931" y="299085"/>
                  </a:lnTo>
                  <a:lnTo>
                    <a:pt x="590931" y="239268"/>
                  </a:lnTo>
                  <a:close/>
                </a:path>
                <a:path w="2237740" h="299084">
                  <a:moveTo>
                    <a:pt x="648970" y="239268"/>
                  </a:moveTo>
                  <a:lnTo>
                    <a:pt x="638556" y="239268"/>
                  </a:lnTo>
                  <a:lnTo>
                    <a:pt x="638556" y="299085"/>
                  </a:lnTo>
                  <a:lnTo>
                    <a:pt x="648970" y="299085"/>
                  </a:lnTo>
                  <a:lnTo>
                    <a:pt x="648970" y="239268"/>
                  </a:lnTo>
                  <a:close/>
                </a:path>
                <a:path w="2237740" h="299084">
                  <a:moveTo>
                    <a:pt x="707009" y="149479"/>
                  </a:moveTo>
                  <a:lnTo>
                    <a:pt x="696595" y="149479"/>
                  </a:lnTo>
                  <a:lnTo>
                    <a:pt x="696595" y="299085"/>
                  </a:lnTo>
                  <a:lnTo>
                    <a:pt x="707009" y="299085"/>
                  </a:lnTo>
                  <a:lnTo>
                    <a:pt x="707009" y="149479"/>
                  </a:lnTo>
                  <a:close/>
                </a:path>
                <a:path w="2237740" h="299084">
                  <a:moveTo>
                    <a:pt x="765035" y="269113"/>
                  </a:moveTo>
                  <a:lnTo>
                    <a:pt x="754634" y="269113"/>
                  </a:lnTo>
                  <a:lnTo>
                    <a:pt x="754634" y="299085"/>
                  </a:lnTo>
                  <a:lnTo>
                    <a:pt x="765035" y="299085"/>
                  </a:lnTo>
                  <a:lnTo>
                    <a:pt x="765035" y="269113"/>
                  </a:lnTo>
                  <a:close/>
                </a:path>
                <a:path w="2237740" h="299084">
                  <a:moveTo>
                    <a:pt x="823087" y="149479"/>
                  </a:moveTo>
                  <a:lnTo>
                    <a:pt x="812673" y="149479"/>
                  </a:lnTo>
                  <a:lnTo>
                    <a:pt x="812673" y="299085"/>
                  </a:lnTo>
                  <a:lnTo>
                    <a:pt x="823087" y="299085"/>
                  </a:lnTo>
                  <a:lnTo>
                    <a:pt x="823087" y="149479"/>
                  </a:lnTo>
                  <a:close/>
                </a:path>
                <a:path w="2237740" h="299084">
                  <a:moveTo>
                    <a:pt x="881253" y="119634"/>
                  </a:moveTo>
                  <a:lnTo>
                    <a:pt x="870839" y="119634"/>
                  </a:lnTo>
                  <a:lnTo>
                    <a:pt x="870839" y="299085"/>
                  </a:lnTo>
                  <a:lnTo>
                    <a:pt x="881253" y="299085"/>
                  </a:lnTo>
                  <a:lnTo>
                    <a:pt x="881253" y="119634"/>
                  </a:lnTo>
                  <a:close/>
                </a:path>
                <a:path w="2237740" h="299084">
                  <a:moveTo>
                    <a:pt x="947166" y="209296"/>
                  </a:moveTo>
                  <a:lnTo>
                    <a:pt x="934085" y="209296"/>
                  </a:lnTo>
                  <a:lnTo>
                    <a:pt x="934085" y="299085"/>
                  </a:lnTo>
                  <a:lnTo>
                    <a:pt x="947166" y="299085"/>
                  </a:lnTo>
                  <a:lnTo>
                    <a:pt x="947166" y="209296"/>
                  </a:lnTo>
                  <a:close/>
                </a:path>
                <a:path w="2237740" h="299084">
                  <a:moveTo>
                    <a:pt x="1063244" y="269113"/>
                  </a:moveTo>
                  <a:lnTo>
                    <a:pt x="1050163" y="269113"/>
                  </a:lnTo>
                  <a:lnTo>
                    <a:pt x="1050163" y="299085"/>
                  </a:lnTo>
                  <a:lnTo>
                    <a:pt x="1063244" y="299085"/>
                  </a:lnTo>
                  <a:lnTo>
                    <a:pt x="1063244" y="269113"/>
                  </a:lnTo>
                  <a:close/>
                </a:path>
                <a:path w="2237740" h="299084">
                  <a:moveTo>
                    <a:pt x="1113409" y="269113"/>
                  </a:moveTo>
                  <a:lnTo>
                    <a:pt x="1102995" y="269113"/>
                  </a:lnTo>
                  <a:lnTo>
                    <a:pt x="1102995" y="299085"/>
                  </a:lnTo>
                  <a:lnTo>
                    <a:pt x="1113409" y="299085"/>
                  </a:lnTo>
                  <a:lnTo>
                    <a:pt x="1113409" y="269113"/>
                  </a:lnTo>
                  <a:close/>
                </a:path>
                <a:path w="2237740" h="299084">
                  <a:moveTo>
                    <a:pt x="1171435" y="269113"/>
                  </a:moveTo>
                  <a:lnTo>
                    <a:pt x="1161034" y="269113"/>
                  </a:lnTo>
                  <a:lnTo>
                    <a:pt x="1161034" y="299085"/>
                  </a:lnTo>
                  <a:lnTo>
                    <a:pt x="1171435" y="299085"/>
                  </a:lnTo>
                  <a:lnTo>
                    <a:pt x="1171435" y="269113"/>
                  </a:lnTo>
                  <a:close/>
                </a:path>
                <a:path w="2237740" h="299084">
                  <a:moveTo>
                    <a:pt x="1250429" y="239268"/>
                  </a:moveTo>
                  <a:lnTo>
                    <a:pt x="1233043" y="239268"/>
                  </a:lnTo>
                  <a:lnTo>
                    <a:pt x="1233043" y="299085"/>
                  </a:lnTo>
                  <a:lnTo>
                    <a:pt x="1250429" y="299085"/>
                  </a:lnTo>
                  <a:lnTo>
                    <a:pt x="1250429" y="239268"/>
                  </a:lnTo>
                  <a:close/>
                </a:path>
                <a:path w="2237740" h="299084">
                  <a:moveTo>
                    <a:pt x="1295400" y="269113"/>
                  </a:moveTo>
                  <a:lnTo>
                    <a:pt x="1282319" y="269113"/>
                  </a:lnTo>
                  <a:lnTo>
                    <a:pt x="1282319" y="299085"/>
                  </a:lnTo>
                  <a:lnTo>
                    <a:pt x="1295400" y="299085"/>
                  </a:lnTo>
                  <a:lnTo>
                    <a:pt x="1295400" y="269113"/>
                  </a:lnTo>
                  <a:close/>
                </a:path>
                <a:path w="2237740" h="299084">
                  <a:moveTo>
                    <a:pt x="1345552" y="239268"/>
                  </a:moveTo>
                  <a:lnTo>
                    <a:pt x="1335151" y="239268"/>
                  </a:lnTo>
                  <a:lnTo>
                    <a:pt x="1335151" y="299085"/>
                  </a:lnTo>
                  <a:lnTo>
                    <a:pt x="1345552" y="299085"/>
                  </a:lnTo>
                  <a:lnTo>
                    <a:pt x="1345552" y="239268"/>
                  </a:lnTo>
                  <a:close/>
                </a:path>
                <a:path w="2237740" h="299084">
                  <a:moveTo>
                    <a:pt x="1411605" y="209296"/>
                  </a:moveTo>
                  <a:lnTo>
                    <a:pt x="1398524" y="209296"/>
                  </a:lnTo>
                  <a:lnTo>
                    <a:pt x="1398524" y="299085"/>
                  </a:lnTo>
                  <a:lnTo>
                    <a:pt x="1411605" y="299085"/>
                  </a:lnTo>
                  <a:lnTo>
                    <a:pt x="1411605" y="209296"/>
                  </a:lnTo>
                  <a:close/>
                </a:path>
                <a:path w="2237740" h="299084">
                  <a:moveTo>
                    <a:pt x="1461770" y="269113"/>
                  </a:moveTo>
                  <a:lnTo>
                    <a:pt x="1451356" y="269113"/>
                  </a:lnTo>
                  <a:lnTo>
                    <a:pt x="1451356" y="299085"/>
                  </a:lnTo>
                  <a:lnTo>
                    <a:pt x="1461770" y="299085"/>
                  </a:lnTo>
                  <a:lnTo>
                    <a:pt x="1461770" y="269113"/>
                  </a:lnTo>
                  <a:close/>
                </a:path>
                <a:path w="2237740" h="299084">
                  <a:moveTo>
                    <a:pt x="1540637" y="209296"/>
                  </a:moveTo>
                  <a:lnTo>
                    <a:pt x="1523238" y="209296"/>
                  </a:lnTo>
                  <a:lnTo>
                    <a:pt x="1523238" y="299085"/>
                  </a:lnTo>
                  <a:lnTo>
                    <a:pt x="1540637" y="299085"/>
                  </a:lnTo>
                  <a:lnTo>
                    <a:pt x="1540637" y="209296"/>
                  </a:lnTo>
                  <a:close/>
                </a:path>
                <a:path w="2237740" h="299084">
                  <a:moveTo>
                    <a:pt x="1585722" y="239268"/>
                  </a:moveTo>
                  <a:lnTo>
                    <a:pt x="1572641" y="239268"/>
                  </a:lnTo>
                  <a:lnTo>
                    <a:pt x="1572641" y="299085"/>
                  </a:lnTo>
                  <a:lnTo>
                    <a:pt x="1585722" y="299085"/>
                  </a:lnTo>
                  <a:lnTo>
                    <a:pt x="1585722" y="239268"/>
                  </a:lnTo>
                  <a:close/>
                </a:path>
                <a:path w="2237740" h="299084">
                  <a:moveTo>
                    <a:pt x="1643748" y="269113"/>
                  </a:moveTo>
                  <a:lnTo>
                    <a:pt x="1630680" y="269113"/>
                  </a:lnTo>
                  <a:lnTo>
                    <a:pt x="1630680" y="299085"/>
                  </a:lnTo>
                  <a:lnTo>
                    <a:pt x="1643748" y="299085"/>
                  </a:lnTo>
                  <a:lnTo>
                    <a:pt x="1643748" y="269113"/>
                  </a:lnTo>
                  <a:close/>
                </a:path>
                <a:path w="2237740" h="299084">
                  <a:moveTo>
                    <a:pt x="1759839" y="239268"/>
                  </a:moveTo>
                  <a:lnTo>
                    <a:pt x="1746758" y="239268"/>
                  </a:lnTo>
                  <a:lnTo>
                    <a:pt x="1746758" y="299085"/>
                  </a:lnTo>
                  <a:lnTo>
                    <a:pt x="1759839" y="299085"/>
                  </a:lnTo>
                  <a:lnTo>
                    <a:pt x="1759839" y="239268"/>
                  </a:lnTo>
                  <a:close/>
                </a:path>
                <a:path w="2237740" h="299084">
                  <a:moveTo>
                    <a:pt x="1817878" y="239268"/>
                  </a:moveTo>
                  <a:lnTo>
                    <a:pt x="1804797" y="239268"/>
                  </a:lnTo>
                  <a:lnTo>
                    <a:pt x="1804797" y="299085"/>
                  </a:lnTo>
                  <a:lnTo>
                    <a:pt x="1817878" y="299085"/>
                  </a:lnTo>
                  <a:lnTo>
                    <a:pt x="1817878" y="239268"/>
                  </a:lnTo>
                  <a:close/>
                </a:path>
                <a:path w="2237740" h="299084">
                  <a:moveTo>
                    <a:pt x="1934083" y="209296"/>
                  </a:moveTo>
                  <a:lnTo>
                    <a:pt x="1921002" y="209296"/>
                  </a:lnTo>
                  <a:lnTo>
                    <a:pt x="1921002" y="299085"/>
                  </a:lnTo>
                  <a:lnTo>
                    <a:pt x="1934083" y="299085"/>
                  </a:lnTo>
                  <a:lnTo>
                    <a:pt x="1934083" y="209296"/>
                  </a:lnTo>
                  <a:close/>
                </a:path>
                <a:path w="2237740" h="299084">
                  <a:moveTo>
                    <a:pt x="1992122" y="209296"/>
                  </a:moveTo>
                  <a:lnTo>
                    <a:pt x="1979041" y="209296"/>
                  </a:lnTo>
                  <a:lnTo>
                    <a:pt x="1979041" y="299085"/>
                  </a:lnTo>
                  <a:lnTo>
                    <a:pt x="1992122" y="299085"/>
                  </a:lnTo>
                  <a:lnTo>
                    <a:pt x="1992122" y="209296"/>
                  </a:lnTo>
                  <a:close/>
                </a:path>
                <a:path w="2237740" h="299084">
                  <a:moveTo>
                    <a:pt x="2063102" y="179451"/>
                  </a:moveTo>
                  <a:lnTo>
                    <a:pt x="2045716" y="179451"/>
                  </a:lnTo>
                  <a:lnTo>
                    <a:pt x="2045716" y="299085"/>
                  </a:lnTo>
                  <a:lnTo>
                    <a:pt x="2063102" y="299085"/>
                  </a:lnTo>
                  <a:lnTo>
                    <a:pt x="2063102" y="179451"/>
                  </a:lnTo>
                  <a:close/>
                </a:path>
                <a:path w="2237740" h="299084">
                  <a:moveTo>
                    <a:pt x="2237359" y="269113"/>
                  </a:moveTo>
                  <a:lnTo>
                    <a:pt x="2211197" y="269113"/>
                  </a:lnTo>
                  <a:lnTo>
                    <a:pt x="2211197" y="299085"/>
                  </a:lnTo>
                  <a:lnTo>
                    <a:pt x="2237359" y="299085"/>
                  </a:lnTo>
                  <a:lnTo>
                    <a:pt x="2237359" y="269113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5" name="object 105" descr=""/>
            <p:cNvSpPr/>
            <p:nvPr/>
          </p:nvSpPr>
          <p:spPr>
            <a:xfrm>
              <a:off x="1150874" y="8243570"/>
              <a:ext cx="4079240" cy="419100"/>
            </a:xfrm>
            <a:custGeom>
              <a:avLst/>
              <a:gdLst/>
              <a:ahLst/>
              <a:cxnLst/>
              <a:rect l="l" t="t" r="r" b="b"/>
              <a:pathLst>
                <a:path w="4079240" h="419100">
                  <a:moveTo>
                    <a:pt x="13081" y="359029"/>
                  </a:moveTo>
                  <a:lnTo>
                    <a:pt x="0" y="359029"/>
                  </a:lnTo>
                  <a:lnTo>
                    <a:pt x="0" y="418846"/>
                  </a:lnTo>
                  <a:lnTo>
                    <a:pt x="13081" y="418846"/>
                  </a:lnTo>
                  <a:lnTo>
                    <a:pt x="13081" y="359029"/>
                  </a:lnTo>
                  <a:close/>
                </a:path>
                <a:path w="4079240" h="419100">
                  <a:moveTo>
                    <a:pt x="71120" y="388874"/>
                  </a:moveTo>
                  <a:lnTo>
                    <a:pt x="58039" y="388874"/>
                  </a:lnTo>
                  <a:lnTo>
                    <a:pt x="58039" y="418846"/>
                  </a:lnTo>
                  <a:lnTo>
                    <a:pt x="71120" y="418846"/>
                  </a:lnTo>
                  <a:lnTo>
                    <a:pt x="71120" y="388874"/>
                  </a:lnTo>
                  <a:close/>
                </a:path>
                <a:path w="4079240" h="419100">
                  <a:moveTo>
                    <a:pt x="129159" y="388874"/>
                  </a:moveTo>
                  <a:lnTo>
                    <a:pt x="116078" y="388874"/>
                  </a:lnTo>
                  <a:lnTo>
                    <a:pt x="116078" y="418846"/>
                  </a:lnTo>
                  <a:lnTo>
                    <a:pt x="129159" y="418846"/>
                  </a:lnTo>
                  <a:lnTo>
                    <a:pt x="129159" y="388874"/>
                  </a:lnTo>
                  <a:close/>
                </a:path>
                <a:path w="4079240" h="419100">
                  <a:moveTo>
                    <a:pt x="187198" y="299212"/>
                  </a:moveTo>
                  <a:lnTo>
                    <a:pt x="174117" y="299212"/>
                  </a:lnTo>
                  <a:lnTo>
                    <a:pt x="174117" y="418846"/>
                  </a:lnTo>
                  <a:lnTo>
                    <a:pt x="187198" y="418846"/>
                  </a:lnTo>
                  <a:lnTo>
                    <a:pt x="187198" y="299212"/>
                  </a:lnTo>
                  <a:close/>
                </a:path>
                <a:path w="4079240" h="419100">
                  <a:moveTo>
                    <a:pt x="245237" y="329057"/>
                  </a:moveTo>
                  <a:lnTo>
                    <a:pt x="232156" y="329057"/>
                  </a:lnTo>
                  <a:lnTo>
                    <a:pt x="232156" y="418846"/>
                  </a:lnTo>
                  <a:lnTo>
                    <a:pt x="245237" y="418846"/>
                  </a:lnTo>
                  <a:lnTo>
                    <a:pt x="245237" y="329057"/>
                  </a:lnTo>
                  <a:close/>
                </a:path>
                <a:path w="4079240" h="419100">
                  <a:moveTo>
                    <a:pt x="303276" y="359029"/>
                  </a:moveTo>
                  <a:lnTo>
                    <a:pt x="290195" y="359029"/>
                  </a:lnTo>
                  <a:lnTo>
                    <a:pt x="290195" y="418846"/>
                  </a:lnTo>
                  <a:lnTo>
                    <a:pt x="303276" y="418846"/>
                  </a:lnTo>
                  <a:lnTo>
                    <a:pt x="303276" y="359029"/>
                  </a:lnTo>
                  <a:close/>
                </a:path>
                <a:path w="4079240" h="419100">
                  <a:moveTo>
                    <a:pt x="361315" y="388874"/>
                  </a:moveTo>
                  <a:lnTo>
                    <a:pt x="348234" y="388874"/>
                  </a:lnTo>
                  <a:lnTo>
                    <a:pt x="348234" y="418846"/>
                  </a:lnTo>
                  <a:lnTo>
                    <a:pt x="361315" y="418846"/>
                  </a:lnTo>
                  <a:lnTo>
                    <a:pt x="361315" y="388874"/>
                  </a:lnTo>
                  <a:close/>
                </a:path>
                <a:path w="4079240" h="419100">
                  <a:moveTo>
                    <a:pt x="421881" y="299212"/>
                  </a:moveTo>
                  <a:lnTo>
                    <a:pt x="411480" y="299212"/>
                  </a:lnTo>
                  <a:lnTo>
                    <a:pt x="411480" y="418846"/>
                  </a:lnTo>
                  <a:lnTo>
                    <a:pt x="421881" y="418846"/>
                  </a:lnTo>
                  <a:lnTo>
                    <a:pt x="421881" y="299212"/>
                  </a:lnTo>
                  <a:close/>
                </a:path>
                <a:path w="4079240" h="419100">
                  <a:moveTo>
                    <a:pt x="477393" y="359029"/>
                  </a:moveTo>
                  <a:lnTo>
                    <a:pt x="464312" y="359029"/>
                  </a:lnTo>
                  <a:lnTo>
                    <a:pt x="464312" y="418846"/>
                  </a:lnTo>
                  <a:lnTo>
                    <a:pt x="477393" y="418846"/>
                  </a:lnTo>
                  <a:lnTo>
                    <a:pt x="477393" y="359029"/>
                  </a:lnTo>
                  <a:close/>
                </a:path>
                <a:path w="4079240" h="419100">
                  <a:moveTo>
                    <a:pt x="538086" y="179578"/>
                  </a:moveTo>
                  <a:lnTo>
                    <a:pt x="527685" y="179578"/>
                  </a:lnTo>
                  <a:lnTo>
                    <a:pt x="527685" y="418846"/>
                  </a:lnTo>
                  <a:lnTo>
                    <a:pt x="538086" y="418846"/>
                  </a:lnTo>
                  <a:lnTo>
                    <a:pt x="538086" y="179578"/>
                  </a:lnTo>
                  <a:close/>
                </a:path>
                <a:path w="4079240" h="419100">
                  <a:moveTo>
                    <a:pt x="596138" y="359029"/>
                  </a:moveTo>
                  <a:lnTo>
                    <a:pt x="585724" y="359029"/>
                  </a:lnTo>
                  <a:lnTo>
                    <a:pt x="585724" y="418846"/>
                  </a:lnTo>
                  <a:lnTo>
                    <a:pt x="596138" y="418846"/>
                  </a:lnTo>
                  <a:lnTo>
                    <a:pt x="596138" y="359029"/>
                  </a:lnTo>
                  <a:close/>
                </a:path>
                <a:path w="4079240" h="419100">
                  <a:moveTo>
                    <a:pt x="654177" y="299212"/>
                  </a:moveTo>
                  <a:lnTo>
                    <a:pt x="643763" y="299212"/>
                  </a:lnTo>
                  <a:lnTo>
                    <a:pt x="643763" y="418846"/>
                  </a:lnTo>
                  <a:lnTo>
                    <a:pt x="654177" y="418846"/>
                  </a:lnTo>
                  <a:lnTo>
                    <a:pt x="654177" y="299212"/>
                  </a:lnTo>
                  <a:close/>
                </a:path>
                <a:path w="4079240" h="419100">
                  <a:moveTo>
                    <a:pt x="712216" y="239395"/>
                  </a:moveTo>
                  <a:lnTo>
                    <a:pt x="701802" y="239395"/>
                  </a:lnTo>
                  <a:lnTo>
                    <a:pt x="701802" y="418846"/>
                  </a:lnTo>
                  <a:lnTo>
                    <a:pt x="712216" y="418846"/>
                  </a:lnTo>
                  <a:lnTo>
                    <a:pt x="712216" y="239395"/>
                  </a:lnTo>
                  <a:close/>
                </a:path>
                <a:path w="4079240" h="419100">
                  <a:moveTo>
                    <a:pt x="770242" y="179578"/>
                  </a:moveTo>
                  <a:lnTo>
                    <a:pt x="759841" y="179578"/>
                  </a:lnTo>
                  <a:lnTo>
                    <a:pt x="759841" y="418846"/>
                  </a:lnTo>
                  <a:lnTo>
                    <a:pt x="770242" y="418846"/>
                  </a:lnTo>
                  <a:lnTo>
                    <a:pt x="770242" y="179578"/>
                  </a:lnTo>
                  <a:close/>
                </a:path>
                <a:path w="4079240" h="419100">
                  <a:moveTo>
                    <a:pt x="828294" y="149606"/>
                  </a:moveTo>
                  <a:lnTo>
                    <a:pt x="817880" y="149606"/>
                  </a:lnTo>
                  <a:lnTo>
                    <a:pt x="817880" y="418846"/>
                  </a:lnTo>
                  <a:lnTo>
                    <a:pt x="828294" y="418846"/>
                  </a:lnTo>
                  <a:lnTo>
                    <a:pt x="828294" y="149606"/>
                  </a:lnTo>
                  <a:close/>
                </a:path>
                <a:path w="4079240" h="419100">
                  <a:moveTo>
                    <a:pt x="886333" y="329057"/>
                  </a:moveTo>
                  <a:lnTo>
                    <a:pt x="875919" y="329057"/>
                  </a:lnTo>
                  <a:lnTo>
                    <a:pt x="875919" y="418846"/>
                  </a:lnTo>
                  <a:lnTo>
                    <a:pt x="886333" y="418846"/>
                  </a:lnTo>
                  <a:lnTo>
                    <a:pt x="886333" y="329057"/>
                  </a:lnTo>
                  <a:close/>
                </a:path>
                <a:path w="4079240" h="419100">
                  <a:moveTo>
                    <a:pt x="944372" y="179578"/>
                  </a:moveTo>
                  <a:lnTo>
                    <a:pt x="933958" y="179578"/>
                  </a:lnTo>
                  <a:lnTo>
                    <a:pt x="933958" y="418846"/>
                  </a:lnTo>
                  <a:lnTo>
                    <a:pt x="944372" y="418846"/>
                  </a:lnTo>
                  <a:lnTo>
                    <a:pt x="944372" y="179578"/>
                  </a:lnTo>
                  <a:close/>
                </a:path>
                <a:path w="4079240" h="419100">
                  <a:moveTo>
                    <a:pt x="1002398" y="89789"/>
                  </a:moveTo>
                  <a:lnTo>
                    <a:pt x="991997" y="89789"/>
                  </a:lnTo>
                  <a:lnTo>
                    <a:pt x="991997" y="418846"/>
                  </a:lnTo>
                  <a:lnTo>
                    <a:pt x="1002398" y="418846"/>
                  </a:lnTo>
                  <a:lnTo>
                    <a:pt x="1002398" y="89789"/>
                  </a:lnTo>
                  <a:close/>
                </a:path>
                <a:path w="4079240" h="419100">
                  <a:moveTo>
                    <a:pt x="1060577" y="149606"/>
                  </a:moveTo>
                  <a:lnTo>
                    <a:pt x="1050163" y="149606"/>
                  </a:lnTo>
                  <a:lnTo>
                    <a:pt x="1050163" y="418846"/>
                  </a:lnTo>
                  <a:lnTo>
                    <a:pt x="1060577" y="418846"/>
                  </a:lnTo>
                  <a:lnTo>
                    <a:pt x="1060577" y="149606"/>
                  </a:lnTo>
                  <a:close/>
                </a:path>
                <a:path w="4079240" h="419100">
                  <a:moveTo>
                    <a:pt x="1118616" y="59944"/>
                  </a:moveTo>
                  <a:lnTo>
                    <a:pt x="1108202" y="59944"/>
                  </a:lnTo>
                  <a:lnTo>
                    <a:pt x="1108202" y="418846"/>
                  </a:lnTo>
                  <a:lnTo>
                    <a:pt x="1118616" y="418846"/>
                  </a:lnTo>
                  <a:lnTo>
                    <a:pt x="1118616" y="59944"/>
                  </a:lnTo>
                  <a:close/>
                </a:path>
                <a:path w="4079240" h="419100">
                  <a:moveTo>
                    <a:pt x="1176642" y="89789"/>
                  </a:moveTo>
                  <a:lnTo>
                    <a:pt x="1166241" y="89789"/>
                  </a:lnTo>
                  <a:lnTo>
                    <a:pt x="1166241" y="418846"/>
                  </a:lnTo>
                  <a:lnTo>
                    <a:pt x="1176642" y="418846"/>
                  </a:lnTo>
                  <a:lnTo>
                    <a:pt x="1176642" y="89789"/>
                  </a:lnTo>
                  <a:close/>
                </a:path>
                <a:path w="4079240" h="419100">
                  <a:moveTo>
                    <a:pt x="1234694" y="329057"/>
                  </a:moveTo>
                  <a:lnTo>
                    <a:pt x="1224280" y="329057"/>
                  </a:lnTo>
                  <a:lnTo>
                    <a:pt x="1224280" y="418846"/>
                  </a:lnTo>
                  <a:lnTo>
                    <a:pt x="1234694" y="418846"/>
                  </a:lnTo>
                  <a:lnTo>
                    <a:pt x="1234694" y="329057"/>
                  </a:lnTo>
                  <a:close/>
                </a:path>
                <a:path w="4079240" h="419100">
                  <a:moveTo>
                    <a:pt x="1292733" y="179578"/>
                  </a:moveTo>
                  <a:lnTo>
                    <a:pt x="1282319" y="179578"/>
                  </a:lnTo>
                  <a:lnTo>
                    <a:pt x="1282319" y="418846"/>
                  </a:lnTo>
                  <a:lnTo>
                    <a:pt x="1292733" y="418846"/>
                  </a:lnTo>
                  <a:lnTo>
                    <a:pt x="1292733" y="179578"/>
                  </a:lnTo>
                  <a:close/>
                </a:path>
                <a:path w="4079240" h="419100">
                  <a:moveTo>
                    <a:pt x="1350772" y="89789"/>
                  </a:moveTo>
                  <a:lnTo>
                    <a:pt x="1340358" y="89789"/>
                  </a:lnTo>
                  <a:lnTo>
                    <a:pt x="1340358" y="418846"/>
                  </a:lnTo>
                  <a:lnTo>
                    <a:pt x="1350772" y="418846"/>
                  </a:lnTo>
                  <a:lnTo>
                    <a:pt x="1350772" y="89789"/>
                  </a:lnTo>
                  <a:close/>
                </a:path>
                <a:path w="4079240" h="419100">
                  <a:moveTo>
                    <a:pt x="1408798" y="29972"/>
                  </a:moveTo>
                  <a:lnTo>
                    <a:pt x="1398397" y="29972"/>
                  </a:lnTo>
                  <a:lnTo>
                    <a:pt x="1398397" y="418846"/>
                  </a:lnTo>
                  <a:lnTo>
                    <a:pt x="1408798" y="418846"/>
                  </a:lnTo>
                  <a:lnTo>
                    <a:pt x="1408798" y="29972"/>
                  </a:lnTo>
                  <a:close/>
                </a:path>
                <a:path w="4079240" h="419100">
                  <a:moveTo>
                    <a:pt x="1466850" y="179578"/>
                  </a:moveTo>
                  <a:lnTo>
                    <a:pt x="1456436" y="179578"/>
                  </a:lnTo>
                  <a:lnTo>
                    <a:pt x="1456436" y="418846"/>
                  </a:lnTo>
                  <a:lnTo>
                    <a:pt x="1466850" y="418846"/>
                  </a:lnTo>
                  <a:lnTo>
                    <a:pt x="1466850" y="179578"/>
                  </a:lnTo>
                  <a:close/>
                </a:path>
                <a:path w="4079240" h="419100">
                  <a:moveTo>
                    <a:pt x="1524889" y="59944"/>
                  </a:moveTo>
                  <a:lnTo>
                    <a:pt x="1514475" y="59944"/>
                  </a:lnTo>
                  <a:lnTo>
                    <a:pt x="1514475" y="418846"/>
                  </a:lnTo>
                  <a:lnTo>
                    <a:pt x="1524889" y="418846"/>
                  </a:lnTo>
                  <a:lnTo>
                    <a:pt x="1524889" y="59944"/>
                  </a:lnTo>
                  <a:close/>
                </a:path>
                <a:path w="4079240" h="419100">
                  <a:moveTo>
                    <a:pt x="1583042" y="149606"/>
                  </a:moveTo>
                  <a:lnTo>
                    <a:pt x="1572641" y="149606"/>
                  </a:lnTo>
                  <a:lnTo>
                    <a:pt x="1572641" y="418846"/>
                  </a:lnTo>
                  <a:lnTo>
                    <a:pt x="1583042" y="418846"/>
                  </a:lnTo>
                  <a:lnTo>
                    <a:pt x="1583042" y="149606"/>
                  </a:lnTo>
                  <a:close/>
                </a:path>
                <a:path w="4079240" h="419100">
                  <a:moveTo>
                    <a:pt x="1641094" y="119761"/>
                  </a:moveTo>
                  <a:lnTo>
                    <a:pt x="1630680" y="119761"/>
                  </a:lnTo>
                  <a:lnTo>
                    <a:pt x="1630680" y="418846"/>
                  </a:lnTo>
                  <a:lnTo>
                    <a:pt x="1641094" y="418846"/>
                  </a:lnTo>
                  <a:lnTo>
                    <a:pt x="1641094" y="119761"/>
                  </a:lnTo>
                  <a:close/>
                </a:path>
                <a:path w="4079240" h="419100">
                  <a:moveTo>
                    <a:pt x="1699133" y="209423"/>
                  </a:moveTo>
                  <a:lnTo>
                    <a:pt x="1688719" y="209423"/>
                  </a:lnTo>
                  <a:lnTo>
                    <a:pt x="1688719" y="418846"/>
                  </a:lnTo>
                  <a:lnTo>
                    <a:pt x="1699133" y="418846"/>
                  </a:lnTo>
                  <a:lnTo>
                    <a:pt x="1699133" y="209423"/>
                  </a:lnTo>
                  <a:close/>
                </a:path>
                <a:path w="4079240" h="419100">
                  <a:moveTo>
                    <a:pt x="1757172" y="269240"/>
                  </a:moveTo>
                  <a:lnTo>
                    <a:pt x="1746758" y="269240"/>
                  </a:lnTo>
                  <a:lnTo>
                    <a:pt x="1746758" y="418846"/>
                  </a:lnTo>
                  <a:lnTo>
                    <a:pt x="1757172" y="418846"/>
                  </a:lnTo>
                  <a:lnTo>
                    <a:pt x="1757172" y="269240"/>
                  </a:lnTo>
                  <a:close/>
                </a:path>
                <a:path w="4079240" h="419100">
                  <a:moveTo>
                    <a:pt x="1815198" y="119761"/>
                  </a:moveTo>
                  <a:lnTo>
                    <a:pt x="1804797" y="119761"/>
                  </a:lnTo>
                  <a:lnTo>
                    <a:pt x="1804797" y="418846"/>
                  </a:lnTo>
                  <a:lnTo>
                    <a:pt x="1815198" y="418846"/>
                  </a:lnTo>
                  <a:lnTo>
                    <a:pt x="1815198" y="119761"/>
                  </a:lnTo>
                  <a:close/>
                </a:path>
                <a:path w="4079240" h="419100">
                  <a:moveTo>
                    <a:pt x="1873250" y="59944"/>
                  </a:moveTo>
                  <a:lnTo>
                    <a:pt x="1862836" y="59944"/>
                  </a:lnTo>
                  <a:lnTo>
                    <a:pt x="1862836" y="418846"/>
                  </a:lnTo>
                  <a:lnTo>
                    <a:pt x="1873250" y="418846"/>
                  </a:lnTo>
                  <a:lnTo>
                    <a:pt x="1873250" y="59944"/>
                  </a:lnTo>
                  <a:close/>
                </a:path>
                <a:path w="4079240" h="419100">
                  <a:moveTo>
                    <a:pt x="1931289" y="179578"/>
                  </a:moveTo>
                  <a:lnTo>
                    <a:pt x="1920875" y="179578"/>
                  </a:lnTo>
                  <a:lnTo>
                    <a:pt x="1920875" y="418846"/>
                  </a:lnTo>
                  <a:lnTo>
                    <a:pt x="1931289" y="418846"/>
                  </a:lnTo>
                  <a:lnTo>
                    <a:pt x="1931289" y="179578"/>
                  </a:lnTo>
                  <a:close/>
                </a:path>
                <a:path w="4079240" h="419100">
                  <a:moveTo>
                    <a:pt x="1989328" y="119761"/>
                  </a:moveTo>
                  <a:lnTo>
                    <a:pt x="1978914" y="119761"/>
                  </a:lnTo>
                  <a:lnTo>
                    <a:pt x="1978914" y="418846"/>
                  </a:lnTo>
                  <a:lnTo>
                    <a:pt x="1989328" y="418846"/>
                  </a:lnTo>
                  <a:lnTo>
                    <a:pt x="1989328" y="119761"/>
                  </a:lnTo>
                  <a:close/>
                </a:path>
                <a:path w="4079240" h="419100">
                  <a:moveTo>
                    <a:pt x="2047354" y="269240"/>
                  </a:moveTo>
                  <a:lnTo>
                    <a:pt x="2036953" y="269240"/>
                  </a:lnTo>
                  <a:lnTo>
                    <a:pt x="2036953" y="418846"/>
                  </a:lnTo>
                  <a:lnTo>
                    <a:pt x="2047354" y="418846"/>
                  </a:lnTo>
                  <a:lnTo>
                    <a:pt x="2047354" y="269240"/>
                  </a:lnTo>
                  <a:close/>
                </a:path>
                <a:path w="4079240" h="419100">
                  <a:moveTo>
                    <a:pt x="2105406" y="239395"/>
                  </a:moveTo>
                  <a:lnTo>
                    <a:pt x="2094992" y="239395"/>
                  </a:lnTo>
                  <a:lnTo>
                    <a:pt x="2094992" y="418846"/>
                  </a:lnTo>
                  <a:lnTo>
                    <a:pt x="2105406" y="418846"/>
                  </a:lnTo>
                  <a:lnTo>
                    <a:pt x="2105406" y="239395"/>
                  </a:lnTo>
                  <a:close/>
                </a:path>
                <a:path w="4079240" h="419100">
                  <a:moveTo>
                    <a:pt x="2163572" y="209423"/>
                  </a:moveTo>
                  <a:lnTo>
                    <a:pt x="2153158" y="209423"/>
                  </a:lnTo>
                  <a:lnTo>
                    <a:pt x="2153158" y="418846"/>
                  </a:lnTo>
                  <a:lnTo>
                    <a:pt x="2163572" y="418846"/>
                  </a:lnTo>
                  <a:lnTo>
                    <a:pt x="2163572" y="209423"/>
                  </a:lnTo>
                  <a:close/>
                </a:path>
                <a:path w="4079240" h="419100">
                  <a:moveTo>
                    <a:pt x="2221611" y="299212"/>
                  </a:moveTo>
                  <a:lnTo>
                    <a:pt x="2211197" y="299212"/>
                  </a:lnTo>
                  <a:lnTo>
                    <a:pt x="2211197" y="418846"/>
                  </a:lnTo>
                  <a:lnTo>
                    <a:pt x="2221611" y="418846"/>
                  </a:lnTo>
                  <a:lnTo>
                    <a:pt x="2221611" y="299212"/>
                  </a:lnTo>
                  <a:close/>
                </a:path>
                <a:path w="4079240" h="419100">
                  <a:moveTo>
                    <a:pt x="2279650" y="179578"/>
                  </a:moveTo>
                  <a:lnTo>
                    <a:pt x="2269236" y="179578"/>
                  </a:lnTo>
                  <a:lnTo>
                    <a:pt x="2269236" y="418846"/>
                  </a:lnTo>
                  <a:lnTo>
                    <a:pt x="2279650" y="418846"/>
                  </a:lnTo>
                  <a:lnTo>
                    <a:pt x="2279650" y="179578"/>
                  </a:lnTo>
                  <a:close/>
                </a:path>
                <a:path w="4079240" h="419100">
                  <a:moveTo>
                    <a:pt x="2337689" y="59944"/>
                  </a:moveTo>
                  <a:lnTo>
                    <a:pt x="2327275" y="59944"/>
                  </a:lnTo>
                  <a:lnTo>
                    <a:pt x="2327275" y="418846"/>
                  </a:lnTo>
                  <a:lnTo>
                    <a:pt x="2337689" y="418846"/>
                  </a:lnTo>
                  <a:lnTo>
                    <a:pt x="2337689" y="59944"/>
                  </a:lnTo>
                  <a:close/>
                </a:path>
                <a:path w="4079240" h="419100">
                  <a:moveTo>
                    <a:pt x="2395728" y="269240"/>
                  </a:moveTo>
                  <a:lnTo>
                    <a:pt x="2385314" y="269240"/>
                  </a:lnTo>
                  <a:lnTo>
                    <a:pt x="2385314" y="418846"/>
                  </a:lnTo>
                  <a:lnTo>
                    <a:pt x="2395728" y="418846"/>
                  </a:lnTo>
                  <a:lnTo>
                    <a:pt x="2395728" y="269240"/>
                  </a:lnTo>
                  <a:close/>
                </a:path>
                <a:path w="4079240" h="419100">
                  <a:moveTo>
                    <a:pt x="2453767" y="239395"/>
                  </a:moveTo>
                  <a:lnTo>
                    <a:pt x="2443353" y="239395"/>
                  </a:lnTo>
                  <a:lnTo>
                    <a:pt x="2443353" y="418846"/>
                  </a:lnTo>
                  <a:lnTo>
                    <a:pt x="2453767" y="418846"/>
                  </a:lnTo>
                  <a:lnTo>
                    <a:pt x="2453767" y="239395"/>
                  </a:lnTo>
                  <a:close/>
                </a:path>
                <a:path w="4079240" h="419100">
                  <a:moveTo>
                    <a:pt x="2511806" y="179578"/>
                  </a:moveTo>
                  <a:lnTo>
                    <a:pt x="2501392" y="179578"/>
                  </a:lnTo>
                  <a:lnTo>
                    <a:pt x="2501392" y="418846"/>
                  </a:lnTo>
                  <a:lnTo>
                    <a:pt x="2511806" y="418846"/>
                  </a:lnTo>
                  <a:lnTo>
                    <a:pt x="2511806" y="179578"/>
                  </a:lnTo>
                  <a:close/>
                </a:path>
                <a:path w="4079240" h="419100">
                  <a:moveTo>
                    <a:pt x="2569832" y="119761"/>
                  </a:moveTo>
                  <a:lnTo>
                    <a:pt x="2559431" y="119761"/>
                  </a:lnTo>
                  <a:lnTo>
                    <a:pt x="2559431" y="418846"/>
                  </a:lnTo>
                  <a:lnTo>
                    <a:pt x="2569832" y="418846"/>
                  </a:lnTo>
                  <a:lnTo>
                    <a:pt x="2569832" y="119761"/>
                  </a:lnTo>
                  <a:close/>
                </a:path>
                <a:path w="4079240" h="419100">
                  <a:moveTo>
                    <a:pt x="2627884" y="119761"/>
                  </a:moveTo>
                  <a:lnTo>
                    <a:pt x="2617470" y="119761"/>
                  </a:lnTo>
                  <a:lnTo>
                    <a:pt x="2617470" y="418846"/>
                  </a:lnTo>
                  <a:lnTo>
                    <a:pt x="2627884" y="418846"/>
                  </a:lnTo>
                  <a:lnTo>
                    <a:pt x="2627884" y="119761"/>
                  </a:lnTo>
                  <a:close/>
                </a:path>
                <a:path w="4079240" h="419100">
                  <a:moveTo>
                    <a:pt x="2686050" y="209423"/>
                  </a:moveTo>
                  <a:lnTo>
                    <a:pt x="2675636" y="209423"/>
                  </a:lnTo>
                  <a:lnTo>
                    <a:pt x="2675636" y="418846"/>
                  </a:lnTo>
                  <a:lnTo>
                    <a:pt x="2686050" y="418846"/>
                  </a:lnTo>
                  <a:lnTo>
                    <a:pt x="2686050" y="209423"/>
                  </a:lnTo>
                  <a:close/>
                </a:path>
                <a:path w="4079240" h="419100">
                  <a:moveTo>
                    <a:pt x="2744089" y="239395"/>
                  </a:moveTo>
                  <a:lnTo>
                    <a:pt x="2733675" y="239395"/>
                  </a:lnTo>
                  <a:lnTo>
                    <a:pt x="2733675" y="418846"/>
                  </a:lnTo>
                  <a:lnTo>
                    <a:pt x="2744089" y="418846"/>
                  </a:lnTo>
                  <a:lnTo>
                    <a:pt x="2744089" y="239395"/>
                  </a:lnTo>
                  <a:close/>
                </a:path>
                <a:path w="4079240" h="419100">
                  <a:moveTo>
                    <a:pt x="2802128" y="179578"/>
                  </a:moveTo>
                  <a:lnTo>
                    <a:pt x="2791714" y="179578"/>
                  </a:lnTo>
                  <a:lnTo>
                    <a:pt x="2791714" y="418846"/>
                  </a:lnTo>
                  <a:lnTo>
                    <a:pt x="2802128" y="418846"/>
                  </a:lnTo>
                  <a:lnTo>
                    <a:pt x="2802128" y="179578"/>
                  </a:lnTo>
                  <a:close/>
                </a:path>
                <a:path w="4079240" h="419100">
                  <a:moveTo>
                    <a:pt x="2860167" y="89789"/>
                  </a:moveTo>
                  <a:lnTo>
                    <a:pt x="2849753" y="89789"/>
                  </a:lnTo>
                  <a:lnTo>
                    <a:pt x="2849753" y="418846"/>
                  </a:lnTo>
                  <a:lnTo>
                    <a:pt x="2860167" y="418846"/>
                  </a:lnTo>
                  <a:lnTo>
                    <a:pt x="2860167" y="89789"/>
                  </a:lnTo>
                  <a:close/>
                </a:path>
                <a:path w="4079240" h="419100">
                  <a:moveTo>
                    <a:pt x="2918206" y="209423"/>
                  </a:moveTo>
                  <a:lnTo>
                    <a:pt x="2907792" y="209423"/>
                  </a:lnTo>
                  <a:lnTo>
                    <a:pt x="2907792" y="418846"/>
                  </a:lnTo>
                  <a:lnTo>
                    <a:pt x="2918206" y="418846"/>
                  </a:lnTo>
                  <a:lnTo>
                    <a:pt x="2918206" y="209423"/>
                  </a:lnTo>
                  <a:close/>
                </a:path>
                <a:path w="4079240" h="419100">
                  <a:moveTo>
                    <a:pt x="2976232" y="149606"/>
                  </a:moveTo>
                  <a:lnTo>
                    <a:pt x="2965831" y="149606"/>
                  </a:lnTo>
                  <a:lnTo>
                    <a:pt x="2965831" y="418846"/>
                  </a:lnTo>
                  <a:lnTo>
                    <a:pt x="2976232" y="418846"/>
                  </a:lnTo>
                  <a:lnTo>
                    <a:pt x="2976232" y="149606"/>
                  </a:lnTo>
                  <a:close/>
                </a:path>
                <a:path w="4079240" h="419100">
                  <a:moveTo>
                    <a:pt x="3034284" y="239395"/>
                  </a:moveTo>
                  <a:lnTo>
                    <a:pt x="3023870" y="239395"/>
                  </a:lnTo>
                  <a:lnTo>
                    <a:pt x="3023870" y="418846"/>
                  </a:lnTo>
                  <a:lnTo>
                    <a:pt x="3034284" y="418846"/>
                  </a:lnTo>
                  <a:lnTo>
                    <a:pt x="3034284" y="239395"/>
                  </a:lnTo>
                  <a:close/>
                </a:path>
                <a:path w="4079240" h="419100">
                  <a:moveTo>
                    <a:pt x="3092323" y="299212"/>
                  </a:moveTo>
                  <a:lnTo>
                    <a:pt x="3081909" y="299212"/>
                  </a:lnTo>
                  <a:lnTo>
                    <a:pt x="3081909" y="418846"/>
                  </a:lnTo>
                  <a:lnTo>
                    <a:pt x="3092323" y="418846"/>
                  </a:lnTo>
                  <a:lnTo>
                    <a:pt x="3092323" y="299212"/>
                  </a:lnTo>
                  <a:close/>
                </a:path>
                <a:path w="4079240" h="419100">
                  <a:moveTo>
                    <a:pt x="3150362" y="179578"/>
                  </a:moveTo>
                  <a:lnTo>
                    <a:pt x="3139948" y="179578"/>
                  </a:lnTo>
                  <a:lnTo>
                    <a:pt x="3139948" y="418846"/>
                  </a:lnTo>
                  <a:lnTo>
                    <a:pt x="3150362" y="418846"/>
                  </a:lnTo>
                  <a:lnTo>
                    <a:pt x="3150362" y="179578"/>
                  </a:lnTo>
                  <a:close/>
                </a:path>
                <a:path w="4079240" h="419100">
                  <a:moveTo>
                    <a:pt x="3208528" y="299212"/>
                  </a:moveTo>
                  <a:lnTo>
                    <a:pt x="3198114" y="299212"/>
                  </a:lnTo>
                  <a:lnTo>
                    <a:pt x="3198114" y="418846"/>
                  </a:lnTo>
                  <a:lnTo>
                    <a:pt x="3208528" y="418846"/>
                  </a:lnTo>
                  <a:lnTo>
                    <a:pt x="3208528" y="299212"/>
                  </a:lnTo>
                  <a:close/>
                </a:path>
                <a:path w="4079240" h="419100">
                  <a:moveTo>
                    <a:pt x="3266567" y="269240"/>
                  </a:moveTo>
                  <a:lnTo>
                    <a:pt x="3256153" y="269240"/>
                  </a:lnTo>
                  <a:lnTo>
                    <a:pt x="3256153" y="418846"/>
                  </a:lnTo>
                  <a:lnTo>
                    <a:pt x="3266567" y="418846"/>
                  </a:lnTo>
                  <a:lnTo>
                    <a:pt x="3266567" y="269240"/>
                  </a:lnTo>
                  <a:close/>
                </a:path>
                <a:path w="4079240" h="419100">
                  <a:moveTo>
                    <a:pt x="3324606" y="359029"/>
                  </a:moveTo>
                  <a:lnTo>
                    <a:pt x="3314192" y="359029"/>
                  </a:lnTo>
                  <a:lnTo>
                    <a:pt x="3314192" y="418846"/>
                  </a:lnTo>
                  <a:lnTo>
                    <a:pt x="3324606" y="418846"/>
                  </a:lnTo>
                  <a:lnTo>
                    <a:pt x="3324606" y="359029"/>
                  </a:lnTo>
                  <a:close/>
                </a:path>
                <a:path w="4079240" h="419100">
                  <a:moveTo>
                    <a:pt x="3382632" y="0"/>
                  </a:moveTo>
                  <a:lnTo>
                    <a:pt x="3372231" y="0"/>
                  </a:lnTo>
                  <a:lnTo>
                    <a:pt x="3372231" y="418846"/>
                  </a:lnTo>
                  <a:lnTo>
                    <a:pt x="3382632" y="418846"/>
                  </a:lnTo>
                  <a:lnTo>
                    <a:pt x="3382632" y="0"/>
                  </a:lnTo>
                  <a:close/>
                </a:path>
                <a:path w="4079240" h="419100">
                  <a:moveTo>
                    <a:pt x="3440684" y="299212"/>
                  </a:moveTo>
                  <a:lnTo>
                    <a:pt x="3430270" y="299212"/>
                  </a:lnTo>
                  <a:lnTo>
                    <a:pt x="3430270" y="418846"/>
                  </a:lnTo>
                  <a:lnTo>
                    <a:pt x="3440684" y="418846"/>
                  </a:lnTo>
                  <a:lnTo>
                    <a:pt x="3440684" y="299212"/>
                  </a:lnTo>
                  <a:close/>
                </a:path>
                <a:path w="4079240" h="419100">
                  <a:moveTo>
                    <a:pt x="3498723" y="299212"/>
                  </a:moveTo>
                  <a:lnTo>
                    <a:pt x="3488309" y="299212"/>
                  </a:lnTo>
                  <a:lnTo>
                    <a:pt x="3488309" y="418846"/>
                  </a:lnTo>
                  <a:lnTo>
                    <a:pt x="3498723" y="418846"/>
                  </a:lnTo>
                  <a:lnTo>
                    <a:pt x="3498723" y="299212"/>
                  </a:lnTo>
                  <a:close/>
                </a:path>
                <a:path w="4079240" h="419100">
                  <a:moveTo>
                    <a:pt x="3556762" y="119761"/>
                  </a:moveTo>
                  <a:lnTo>
                    <a:pt x="3546348" y="119761"/>
                  </a:lnTo>
                  <a:lnTo>
                    <a:pt x="3546348" y="418846"/>
                  </a:lnTo>
                  <a:lnTo>
                    <a:pt x="3556762" y="418846"/>
                  </a:lnTo>
                  <a:lnTo>
                    <a:pt x="3556762" y="119761"/>
                  </a:lnTo>
                  <a:close/>
                </a:path>
                <a:path w="4079240" h="419100">
                  <a:moveTo>
                    <a:pt x="3614801" y="239395"/>
                  </a:moveTo>
                  <a:lnTo>
                    <a:pt x="3604387" y="239395"/>
                  </a:lnTo>
                  <a:lnTo>
                    <a:pt x="3604387" y="418846"/>
                  </a:lnTo>
                  <a:lnTo>
                    <a:pt x="3614801" y="418846"/>
                  </a:lnTo>
                  <a:lnTo>
                    <a:pt x="3614801" y="239395"/>
                  </a:lnTo>
                  <a:close/>
                </a:path>
                <a:path w="4079240" h="419100">
                  <a:moveTo>
                    <a:pt x="3672840" y="149606"/>
                  </a:moveTo>
                  <a:lnTo>
                    <a:pt x="3662426" y="149606"/>
                  </a:lnTo>
                  <a:lnTo>
                    <a:pt x="3662426" y="418846"/>
                  </a:lnTo>
                  <a:lnTo>
                    <a:pt x="3672840" y="418846"/>
                  </a:lnTo>
                  <a:lnTo>
                    <a:pt x="3672840" y="149606"/>
                  </a:lnTo>
                  <a:close/>
                </a:path>
                <a:path w="4079240" h="419100">
                  <a:moveTo>
                    <a:pt x="3730879" y="209423"/>
                  </a:moveTo>
                  <a:lnTo>
                    <a:pt x="3720465" y="209423"/>
                  </a:lnTo>
                  <a:lnTo>
                    <a:pt x="3720465" y="418846"/>
                  </a:lnTo>
                  <a:lnTo>
                    <a:pt x="3730879" y="418846"/>
                  </a:lnTo>
                  <a:lnTo>
                    <a:pt x="3730879" y="209423"/>
                  </a:lnTo>
                  <a:close/>
                </a:path>
                <a:path w="4079240" h="419100">
                  <a:moveTo>
                    <a:pt x="3789032" y="269240"/>
                  </a:moveTo>
                  <a:lnTo>
                    <a:pt x="3778631" y="269240"/>
                  </a:lnTo>
                  <a:lnTo>
                    <a:pt x="3778631" y="418846"/>
                  </a:lnTo>
                  <a:lnTo>
                    <a:pt x="3789032" y="418846"/>
                  </a:lnTo>
                  <a:lnTo>
                    <a:pt x="3789032" y="269240"/>
                  </a:lnTo>
                  <a:close/>
                </a:path>
                <a:path w="4079240" h="419100">
                  <a:moveTo>
                    <a:pt x="3847084" y="239395"/>
                  </a:moveTo>
                  <a:lnTo>
                    <a:pt x="3836670" y="239395"/>
                  </a:lnTo>
                  <a:lnTo>
                    <a:pt x="3836670" y="418846"/>
                  </a:lnTo>
                  <a:lnTo>
                    <a:pt x="3847084" y="418846"/>
                  </a:lnTo>
                  <a:lnTo>
                    <a:pt x="3847084" y="239395"/>
                  </a:lnTo>
                  <a:close/>
                </a:path>
                <a:path w="4079240" h="419100">
                  <a:moveTo>
                    <a:pt x="3905123" y="89789"/>
                  </a:moveTo>
                  <a:lnTo>
                    <a:pt x="3894709" y="89789"/>
                  </a:lnTo>
                  <a:lnTo>
                    <a:pt x="3894709" y="418846"/>
                  </a:lnTo>
                  <a:lnTo>
                    <a:pt x="3905123" y="418846"/>
                  </a:lnTo>
                  <a:lnTo>
                    <a:pt x="3905123" y="89789"/>
                  </a:lnTo>
                  <a:close/>
                </a:path>
                <a:path w="4079240" h="419100">
                  <a:moveTo>
                    <a:pt x="3963162" y="29972"/>
                  </a:moveTo>
                  <a:lnTo>
                    <a:pt x="3952748" y="29972"/>
                  </a:lnTo>
                  <a:lnTo>
                    <a:pt x="3952748" y="418846"/>
                  </a:lnTo>
                  <a:lnTo>
                    <a:pt x="3963162" y="418846"/>
                  </a:lnTo>
                  <a:lnTo>
                    <a:pt x="3963162" y="29972"/>
                  </a:lnTo>
                  <a:close/>
                </a:path>
                <a:path w="4079240" h="419100">
                  <a:moveTo>
                    <a:pt x="4021201" y="89789"/>
                  </a:moveTo>
                  <a:lnTo>
                    <a:pt x="4010787" y="89789"/>
                  </a:lnTo>
                  <a:lnTo>
                    <a:pt x="4010787" y="418846"/>
                  </a:lnTo>
                  <a:lnTo>
                    <a:pt x="4021201" y="418846"/>
                  </a:lnTo>
                  <a:lnTo>
                    <a:pt x="4021201" y="89789"/>
                  </a:lnTo>
                  <a:close/>
                </a:path>
                <a:path w="4079240" h="419100">
                  <a:moveTo>
                    <a:pt x="4079240" y="209423"/>
                  </a:moveTo>
                  <a:lnTo>
                    <a:pt x="4068826" y="209423"/>
                  </a:lnTo>
                  <a:lnTo>
                    <a:pt x="4068826" y="418846"/>
                  </a:lnTo>
                  <a:lnTo>
                    <a:pt x="4079240" y="418846"/>
                  </a:lnTo>
                  <a:lnTo>
                    <a:pt x="4079240" y="209423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6" name="object 106" descr=""/>
            <p:cNvSpPr/>
            <p:nvPr/>
          </p:nvSpPr>
          <p:spPr>
            <a:xfrm>
              <a:off x="5219700" y="8303514"/>
              <a:ext cx="4132579" cy="359410"/>
            </a:xfrm>
            <a:custGeom>
              <a:avLst/>
              <a:gdLst/>
              <a:ahLst/>
              <a:cxnLst/>
              <a:rect l="l" t="t" r="r" b="b"/>
              <a:pathLst>
                <a:path w="4132579" h="359409">
                  <a:moveTo>
                    <a:pt x="10414" y="149479"/>
                  </a:moveTo>
                  <a:lnTo>
                    <a:pt x="0" y="149479"/>
                  </a:lnTo>
                  <a:lnTo>
                    <a:pt x="0" y="358902"/>
                  </a:lnTo>
                  <a:lnTo>
                    <a:pt x="10414" y="358902"/>
                  </a:lnTo>
                  <a:lnTo>
                    <a:pt x="10414" y="149479"/>
                  </a:lnTo>
                  <a:close/>
                </a:path>
                <a:path w="4132579" h="359409">
                  <a:moveTo>
                    <a:pt x="68453" y="0"/>
                  </a:moveTo>
                  <a:lnTo>
                    <a:pt x="58039" y="0"/>
                  </a:lnTo>
                  <a:lnTo>
                    <a:pt x="58039" y="358902"/>
                  </a:lnTo>
                  <a:lnTo>
                    <a:pt x="68453" y="358902"/>
                  </a:lnTo>
                  <a:lnTo>
                    <a:pt x="68453" y="0"/>
                  </a:lnTo>
                  <a:close/>
                </a:path>
                <a:path w="4132579" h="359409">
                  <a:moveTo>
                    <a:pt x="126492" y="239268"/>
                  </a:moveTo>
                  <a:lnTo>
                    <a:pt x="116078" y="239268"/>
                  </a:lnTo>
                  <a:lnTo>
                    <a:pt x="116078" y="358902"/>
                  </a:lnTo>
                  <a:lnTo>
                    <a:pt x="126492" y="358902"/>
                  </a:lnTo>
                  <a:lnTo>
                    <a:pt x="126492" y="239268"/>
                  </a:lnTo>
                  <a:close/>
                </a:path>
                <a:path w="4132579" h="359409">
                  <a:moveTo>
                    <a:pt x="184531" y="269113"/>
                  </a:moveTo>
                  <a:lnTo>
                    <a:pt x="174117" y="269113"/>
                  </a:lnTo>
                  <a:lnTo>
                    <a:pt x="174117" y="358902"/>
                  </a:lnTo>
                  <a:lnTo>
                    <a:pt x="184531" y="358902"/>
                  </a:lnTo>
                  <a:lnTo>
                    <a:pt x="184531" y="269113"/>
                  </a:lnTo>
                  <a:close/>
                </a:path>
                <a:path w="4132579" h="359409">
                  <a:moveTo>
                    <a:pt x="242697" y="239268"/>
                  </a:moveTo>
                  <a:lnTo>
                    <a:pt x="232283" y="239268"/>
                  </a:lnTo>
                  <a:lnTo>
                    <a:pt x="232283" y="358902"/>
                  </a:lnTo>
                  <a:lnTo>
                    <a:pt x="242697" y="358902"/>
                  </a:lnTo>
                  <a:lnTo>
                    <a:pt x="242697" y="239268"/>
                  </a:lnTo>
                  <a:close/>
                </a:path>
                <a:path w="4132579" h="359409">
                  <a:moveTo>
                    <a:pt x="300736" y="209296"/>
                  </a:moveTo>
                  <a:lnTo>
                    <a:pt x="290322" y="209296"/>
                  </a:lnTo>
                  <a:lnTo>
                    <a:pt x="290322" y="358902"/>
                  </a:lnTo>
                  <a:lnTo>
                    <a:pt x="300736" y="358902"/>
                  </a:lnTo>
                  <a:lnTo>
                    <a:pt x="300736" y="209296"/>
                  </a:lnTo>
                  <a:close/>
                </a:path>
                <a:path w="4132579" h="359409">
                  <a:moveTo>
                    <a:pt x="358775" y="89662"/>
                  </a:moveTo>
                  <a:lnTo>
                    <a:pt x="348361" y="89662"/>
                  </a:lnTo>
                  <a:lnTo>
                    <a:pt x="348361" y="358902"/>
                  </a:lnTo>
                  <a:lnTo>
                    <a:pt x="358775" y="358902"/>
                  </a:lnTo>
                  <a:lnTo>
                    <a:pt x="358775" y="89662"/>
                  </a:lnTo>
                  <a:close/>
                </a:path>
                <a:path w="4132579" h="359409">
                  <a:moveTo>
                    <a:pt x="416814" y="149479"/>
                  </a:moveTo>
                  <a:lnTo>
                    <a:pt x="406400" y="149479"/>
                  </a:lnTo>
                  <a:lnTo>
                    <a:pt x="406400" y="358902"/>
                  </a:lnTo>
                  <a:lnTo>
                    <a:pt x="416814" y="358902"/>
                  </a:lnTo>
                  <a:lnTo>
                    <a:pt x="416814" y="149479"/>
                  </a:lnTo>
                  <a:close/>
                </a:path>
                <a:path w="4132579" h="359409">
                  <a:moveTo>
                    <a:pt x="474853" y="209296"/>
                  </a:moveTo>
                  <a:lnTo>
                    <a:pt x="464439" y="209296"/>
                  </a:lnTo>
                  <a:lnTo>
                    <a:pt x="464439" y="358902"/>
                  </a:lnTo>
                  <a:lnTo>
                    <a:pt x="474853" y="358902"/>
                  </a:lnTo>
                  <a:lnTo>
                    <a:pt x="474853" y="209296"/>
                  </a:lnTo>
                  <a:close/>
                </a:path>
                <a:path w="4132579" h="359409">
                  <a:moveTo>
                    <a:pt x="532892" y="209296"/>
                  </a:moveTo>
                  <a:lnTo>
                    <a:pt x="522478" y="209296"/>
                  </a:lnTo>
                  <a:lnTo>
                    <a:pt x="522478" y="358902"/>
                  </a:lnTo>
                  <a:lnTo>
                    <a:pt x="532892" y="358902"/>
                  </a:lnTo>
                  <a:lnTo>
                    <a:pt x="532892" y="209296"/>
                  </a:lnTo>
                  <a:close/>
                </a:path>
                <a:path w="4132579" h="359409">
                  <a:moveTo>
                    <a:pt x="590931" y="179451"/>
                  </a:moveTo>
                  <a:lnTo>
                    <a:pt x="580517" y="179451"/>
                  </a:lnTo>
                  <a:lnTo>
                    <a:pt x="580517" y="358902"/>
                  </a:lnTo>
                  <a:lnTo>
                    <a:pt x="590931" y="358902"/>
                  </a:lnTo>
                  <a:lnTo>
                    <a:pt x="590931" y="179451"/>
                  </a:lnTo>
                  <a:close/>
                </a:path>
                <a:path w="4132579" h="359409">
                  <a:moveTo>
                    <a:pt x="648957" y="209296"/>
                  </a:moveTo>
                  <a:lnTo>
                    <a:pt x="638556" y="209296"/>
                  </a:lnTo>
                  <a:lnTo>
                    <a:pt x="638556" y="358902"/>
                  </a:lnTo>
                  <a:lnTo>
                    <a:pt x="648957" y="358902"/>
                  </a:lnTo>
                  <a:lnTo>
                    <a:pt x="648957" y="209296"/>
                  </a:lnTo>
                  <a:close/>
                </a:path>
                <a:path w="4132579" h="359409">
                  <a:moveTo>
                    <a:pt x="707009" y="299085"/>
                  </a:moveTo>
                  <a:lnTo>
                    <a:pt x="696595" y="299085"/>
                  </a:lnTo>
                  <a:lnTo>
                    <a:pt x="696595" y="358902"/>
                  </a:lnTo>
                  <a:lnTo>
                    <a:pt x="707009" y="358902"/>
                  </a:lnTo>
                  <a:lnTo>
                    <a:pt x="707009" y="299085"/>
                  </a:lnTo>
                  <a:close/>
                </a:path>
                <a:path w="4132579" h="359409">
                  <a:moveTo>
                    <a:pt x="765175" y="299085"/>
                  </a:moveTo>
                  <a:lnTo>
                    <a:pt x="754761" y="299085"/>
                  </a:lnTo>
                  <a:lnTo>
                    <a:pt x="754761" y="358902"/>
                  </a:lnTo>
                  <a:lnTo>
                    <a:pt x="765175" y="358902"/>
                  </a:lnTo>
                  <a:lnTo>
                    <a:pt x="765175" y="299085"/>
                  </a:lnTo>
                  <a:close/>
                </a:path>
                <a:path w="4132579" h="359409">
                  <a:moveTo>
                    <a:pt x="823214" y="89662"/>
                  </a:moveTo>
                  <a:lnTo>
                    <a:pt x="812800" y="89662"/>
                  </a:lnTo>
                  <a:lnTo>
                    <a:pt x="812800" y="358902"/>
                  </a:lnTo>
                  <a:lnTo>
                    <a:pt x="823214" y="358902"/>
                  </a:lnTo>
                  <a:lnTo>
                    <a:pt x="823214" y="89662"/>
                  </a:lnTo>
                  <a:close/>
                </a:path>
                <a:path w="4132579" h="359409">
                  <a:moveTo>
                    <a:pt x="881253" y="209296"/>
                  </a:moveTo>
                  <a:lnTo>
                    <a:pt x="870839" y="209296"/>
                  </a:lnTo>
                  <a:lnTo>
                    <a:pt x="870839" y="358902"/>
                  </a:lnTo>
                  <a:lnTo>
                    <a:pt x="881253" y="358902"/>
                  </a:lnTo>
                  <a:lnTo>
                    <a:pt x="881253" y="209296"/>
                  </a:lnTo>
                  <a:close/>
                </a:path>
                <a:path w="4132579" h="359409">
                  <a:moveTo>
                    <a:pt x="939292" y="239268"/>
                  </a:moveTo>
                  <a:lnTo>
                    <a:pt x="928878" y="239268"/>
                  </a:lnTo>
                  <a:lnTo>
                    <a:pt x="928878" y="358902"/>
                  </a:lnTo>
                  <a:lnTo>
                    <a:pt x="939292" y="358902"/>
                  </a:lnTo>
                  <a:lnTo>
                    <a:pt x="939292" y="239268"/>
                  </a:lnTo>
                  <a:close/>
                </a:path>
                <a:path w="4132579" h="359409">
                  <a:moveTo>
                    <a:pt x="997331" y="209296"/>
                  </a:moveTo>
                  <a:lnTo>
                    <a:pt x="986917" y="209296"/>
                  </a:lnTo>
                  <a:lnTo>
                    <a:pt x="986917" y="358902"/>
                  </a:lnTo>
                  <a:lnTo>
                    <a:pt x="997331" y="358902"/>
                  </a:lnTo>
                  <a:lnTo>
                    <a:pt x="997331" y="209296"/>
                  </a:lnTo>
                  <a:close/>
                </a:path>
                <a:path w="4132579" h="359409">
                  <a:moveTo>
                    <a:pt x="1055357" y="269113"/>
                  </a:moveTo>
                  <a:lnTo>
                    <a:pt x="1044956" y="269113"/>
                  </a:lnTo>
                  <a:lnTo>
                    <a:pt x="1044956" y="358902"/>
                  </a:lnTo>
                  <a:lnTo>
                    <a:pt x="1055357" y="358902"/>
                  </a:lnTo>
                  <a:lnTo>
                    <a:pt x="1055357" y="269113"/>
                  </a:lnTo>
                  <a:close/>
                </a:path>
                <a:path w="4132579" h="359409">
                  <a:moveTo>
                    <a:pt x="1113409" y="239268"/>
                  </a:moveTo>
                  <a:lnTo>
                    <a:pt x="1102995" y="239268"/>
                  </a:lnTo>
                  <a:lnTo>
                    <a:pt x="1102995" y="358902"/>
                  </a:lnTo>
                  <a:lnTo>
                    <a:pt x="1113409" y="358902"/>
                  </a:lnTo>
                  <a:lnTo>
                    <a:pt x="1113409" y="239268"/>
                  </a:lnTo>
                  <a:close/>
                </a:path>
                <a:path w="4132579" h="359409">
                  <a:moveTo>
                    <a:pt x="1171448" y="209296"/>
                  </a:moveTo>
                  <a:lnTo>
                    <a:pt x="1161034" y="209296"/>
                  </a:lnTo>
                  <a:lnTo>
                    <a:pt x="1161034" y="358902"/>
                  </a:lnTo>
                  <a:lnTo>
                    <a:pt x="1171448" y="358902"/>
                  </a:lnTo>
                  <a:lnTo>
                    <a:pt x="1171448" y="209296"/>
                  </a:lnTo>
                  <a:close/>
                </a:path>
                <a:path w="4132579" h="359409">
                  <a:moveTo>
                    <a:pt x="1229487" y="0"/>
                  </a:moveTo>
                  <a:lnTo>
                    <a:pt x="1219073" y="0"/>
                  </a:lnTo>
                  <a:lnTo>
                    <a:pt x="1219073" y="358902"/>
                  </a:lnTo>
                  <a:lnTo>
                    <a:pt x="1229487" y="358902"/>
                  </a:lnTo>
                  <a:lnTo>
                    <a:pt x="1229487" y="0"/>
                  </a:lnTo>
                  <a:close/>
                </a:path>
                <a:path w="4132579" h="359409">
                  <a:moveTo>
                    <a:pt x="1287526" y="149479"/>
                  </a:moveTo>
                  <a:lnTo>
                    <a:pt x="1277112" y="149479"/>
                  </a:lnTo>
                  <a:lnTo>
                    <a:pt x="1277112" y="358902"/>
                  </a:lnTo>
                  <a:lnTo>
                    <a:pt x="1287526" y="358902"/>
                  </a:lnTo>
                  <a:lnTo>
                    <a:pt x="1287526" y="149479"/>
                  </a:lnTo>
                  <a:close/>
                </a:path>
                <a:path w="4132579" h="359409">
                  <a:moveTo>
                    <a:pt x="1345692" y="239268"/>
                  </a:moveTo>
                  <a:lnTo>
                    <a:pt x="1335278" y="239268"/>
                  </a:lnTo>
                  <a:lnTo>
                    <a:pt x="1335278" y="358902"/>
                  </a:lnTo>
                  <a:lnTo>
                    <a:pt x="1345692" y="358902"/>
                  </a:lnTo>
                  <a:lnTo>
                    <a:pt x="1345692" y="239268"/>
                  </a:lnTo>
                  <a:close/>
                </a:path>
                <a:path w="4132579" h="359409">
                  <a:moveTo>
                    <a:pt x="1403731" y="209296"/>
                  </a:moveTo>
                  <a:lnTo>
                    <a:pt x="1393317" y="209296"/>
                  </a:lnTo>
                  <a:lnTo>
                    <a:pt x="1393317" y="358902"/>
                  </a:lnTo>
                  <a:lnTo>
                    <a:pt x="1403731" y="358902"/>
                  </a:lnTo>
                  <a:lnTo>
                    <a:pt x="1403731" y="209296"/>
                  </a:lnTo>
                  <a:close/>
                </a:path>
                <a:path w="4132579" h="359409">
                  <a:moveTo>
                    <a:pt x="1461770" y="149479"/>
                  </a:moveTo>
                  <a:lnTo>
                    <a:pt x="1451356" y="149479"/>
                  </a:lnTo>
                  <a:lnTo>
                    <a:pt x="1451356" y="358902"/>
                  </a:lnTo>
                  <a:lnTo>
                    <a:pt x="1461770" y="358902"/>
                  </a:lnTo>
                  <a:lnTo>
                    <a:pt x="1461770" y="149479"/>
                  </a:lnTo>
                  <a:close/>
                </a:path>
                <a:path w="4132579" h="359409">
                  <a:moveTo>
                    <a:pt x="1519809" y="149479"/>
                  </a:moveTo>
                  <a:lnTo>
                    <a:pt x="1509395" y="149479"/>
                  </a:lnTo>
                  <a:lnTo>
                    <a:pt x="1509395" y="358902"/>
                  </a:lnTo>
                  <a:lnTo>
                    <a:pt x="1519809" y="358902"/>
                  </a:lnTo>
                  <a:lnTo>
                    <a:pt x="1519809" y="149479"/>
                  </a:lnTo>
                  <a:close/>
                </a:path>
                <a:path w="4132579" h="359409">
                  <a:moveTo>
                    <a:pt x="1577848" y="209296"/>
                  </a:moveTo>
                  <a:lnTo>
                    <a:pt x="1567434" y="209296"/>
                  </a:lnTo>
                  <a:lnTo>
                    <a:pt x="1567434" y="358902"/>
                  </a:lnTo>
                  <a:lnTo>
                    <a:pt x="1577848" y="358902"/>
                  </a:lnTo>
                  <a:lnTo>
                    <a:pt x="1577848" y="209296"/>
                  </a:lnTo>
                  <a:close/>
                </a:path>
                <a:path w="4132579" h="359409">
                  <a:moveTo>
                    <a:pt x="1635887" y="209296"/>
                  </a:moveTo>
                  <a:lnTo>
                    <a:pt x="1625473" y="209296"/>
                  </a:lnTo>
                  <a:lnTo>
                    <a:pt x="1625473" y="358902"/>
                  </a:lnTo>
                  <a:lnTo>
                    <a:pt x="1635887" y="358902"/>
                  </a:lnTo>
                  <a:lnTo>
                    <a:pt x="1635887" y="209296"/>
                  </a:lnTo>
                  <a:close/>
                </a:path>
                <a:path w="4132579" h="359409">
                  <a:moveTo>
                    <a:pt x="1693926" y="149479"/>
                  </a:moveTo>
                  <a:lnTo>
                    <a:pt x="1683512" y="149479"/>
                  </a:lnTo>
                  <a:lnTo>
                    <a:pt x="1683512" y="358902"/>
                  </a:lnTo>
                  <a:lnTo>
                    <a:pt x="1693926" y="358902"/>
                  </a:lnTo>
                  <a:lnTo>
                    <a:pt x="1693926" y="149479"/>
                  </a:lnTo>
                  <a:close/>
                </a:path>
                <a:path w="4132579" h="359409">
                  <a:moveTo>
                    <a:pt x="1751965" y="239268"/>
                  </a:moveTo>
                  <a:lnTo>
                    <a:pt x="1741551" y="239268"/>
                  </a:lnTo>
                  <a:lnTo>
                    <a:pt x="1741551" y="358902"/>
                  </a:lnTo>
                  <a:lnTo>
                    <a:pt x="1751965" y="358902"/>
                  </a:lnTo>
                  <a:lnTo>
                    <a:pt x="1751965" y="239268"/>
                  </a:lnTo>
                  <a:close/>
                </a:path>
                <a:path w="4132579" h="359409">
                  <a:moveTo>
                    <a:pt x="1810004" y="179451"/>
                  </a:moveTo>
                  <a:lnTo>
                    <a:pt x="1799590" y="179451"/>
                  </a:lnTo>
                  <a:lnTo>
                    <a:pt x="1799590" y="358902"/>
                  </a:lnTo>
                  <a:lnTo>
                    <a:pt x="1810004" y="358902"/>
                  </a:lnTo>
                  <a:lnTo>
                    <a:pt x="1810004" y="179451"/>
                  </a:lnTo>
                  <a:close/>
                </a:path>
                <a:path w="4132579" h="359409">
                  <a:moveTo>
                    <a:pt x="1868170" y="179451"/>
                  </a:moveTo>
                  <a:lnTo>
                    <a:pt x="1857756" y="179451"/>
                  </a:lnTo>
                  <a:lnTo>
                    <a:pt x="1857756" y="358902"/>
                  </a:lnTo>
                  <a:lnTo>
                    <a:pt x="1868170" y="358902"/>
                  </a:lnTo>
                  <a:lnTo>
                    <a:pt x="1868170" y="179451"/>
                  </a:lnTo>
                  <a:close/>
                </a:path>
                <a:path w="4132579" h="359409">
                  <a:moveTo>
                    <a:pt x="1926209" y="119634"/>
                  </a:moveTo>
                  <a:lnTo>
                    <a:pt x="1915795" y="119634"/>
                  </a:lnTo>
                  <a:lnTo>
                    <a:pt x="1915795" y="358902"/>
                  </a:lnTo>
                  <a:lnTo>
                    <a:pt x="1926209" y="358902"/>
                  </a:lnTo>
                  <a:lnTo>
                    <a:pt x="1926209" y="119634"/>
                  </a:lnTo>
                  <a:close/>
                </a:path>
                <a:path w="4132579" h="359409">
                  <a:moveTo>
                    <a:pt x="1984248" y="179451"/>
                  </a:moveTo>
                  <a:lnTo>
                    <a:pt x="1973834" y="179451"/>
                  </a:lnTo>
                  <a:lnTo>
                    <a:pt x="1973834" y="358902"/>
                  </a:lnTo>
                  <a:lnTo>
                    <a:pt x="1984248" y="358902"/>
                  </a:lnTo>
                  <a:lnTo>
                    <a:pt x="1984248" y="179451"/>
                  </a:lnTo>
                  <a:close/>
                </a:path>
                <a:path w="4132579" h="359409">
                  <a:moveTo>
                    <a:pt x="2042287" y="209296"/>
                  </a:moveTo>
                  <a:lnTo>
                    <a:pt x="2031873" y="209296"/>
                  </a:lnTo>
                  <a:lnTo>
                    <a:pt x="2031873" y="358902"/>
                  </a:lnTo>
                  <a:lnTo>
                    <a:pt x="2042287" y="358902"/>
                  </a:lnTo>
                  <a:lnTo>
                    <a:pt x="2042287" y="209296"/>
                  </a:lnTo>
                  <a:close/>
                </a:path>
                <a:path w="4132579" h="359409">
                  <a:moveTo>
                    <a:pt x="2100326" y="299085"/>
                  </a:moveTo>
                  <a:lnTo>
                    <a:pt x="2089912" y="299085"/>
                  </a:lnTo>
                  <a:lnTo>
                    <a:pt x="2089912" y="358902"/>
                  </a:lnTo>
                  <a:lnTo>
                    <a:pt x="2100326" y="358902"/>
                  </a:lnTo>
                  <a:lnTo>
                    <a:pt x="2100326" y="299085"/>
                  </a:lnTo>
                  <a:close/>
                </a:path>
                <a:path w="4132579" h="359409">
                  <a:moveTo>
                    <a:pt x="2158365" y="89662"/>
                  </a:moveTo>
                  <a:lnTo>
                    <a:pt x="2147951" y="89662"/>
                  </a:lnTo>
                  <a:lnTo>
                    <a:pt x="2147951" y="358902"/>
                  </a:lnTo>
                  <a:lnTo>
                    <a:pt x="2158365" y="358902"/>
                  </a:lnTo>
                  <a:lnTo>
                    <a:pt x="2158365" y="89662"/>
                  </a:lnTo>
                  <a:close/>
                </a:path>
                <a:path w="4132579" h="359409">
                  <a:moveTo>
                    <a:pt x="2216404" y="299085"/>
                  </a:moveTo>
                  <a:lnTo>
                    <a:pt x="2205990" y="299085"/>
                  </a:lnTo>
                  <a:lnTo>
                    <a:pt x="2205990" y="358902"/>
                  </a:lnTo>
                  <a:lnTo>
                    <a:pt x="2216404" y="358902"/>
                  </a:lnTo>
                  <a:lnTo>
                    <a:pt x="2216404" y="299085"/>
                  </a:lnTo>
                  <a:close/>
                </a:path>
                <a:path w="4132579" h="359409">
                  <a:moveTo>
                    <a:pt x="2274443" y="209296"/>
                  </a:moveTo>
                  <a:lnTo>
                    <a:pt x="2264029" y="209296"/>
                  </a:lnTo>
                  <a:lnTo>
                    <a:pt x="2264029" y="358902"/>
                  </a:lnTo>
                  <a:lnTo>
                    <a:pt x="2274443" y="358902"/>
                  </a:lnTo>
                  <a:lnTo>
                    <a:pt x="2274443" y="209296"/>
                  </a:lnTo>
                  <a:close/>
                </a:path>
                <a:path w="4132579" h="359409">
                  <a:moveTo>
                    <a:pt x="2332482" y="239268"/>
                  </a:moveTo>
                  <a:lnTo>
                    <a:pt x="2322068" y="239268"/>
                  </a:lnTo>
                  <a:lnTo>
                    <a:pt x="2322068" y="358902"/>
                  </a:lnTo>
                  <a:lnTo>
                    <a:pt x="2332482" y="358902"/>
                  </a:lnTo>
                  <a:lnTo>
                    <a:pt x="2332482" y="239268"/>
                  </a:lnTo>
                  <a:close/>
                </a:path>
                <a:path w="4132579" h="359409">
                  <a:moveTo>
                    <a:pt x="2390648" y="179451"/>
                  </a:moveTo>
                  <a:lnTo>
                    <a:pt x="2380234" y="179451"/>
                  </a:lnTo>
                  <a:lnTo>
                    <a:pt x="2380234" y="358902"/>
                  </a:lnTo>
                  <a:lnTo>
                    <a:pt x="2390648" y="358902"/>
                  </a:lnTo>
                  <a:lnTo>
                    <a:pt x="2390648" y="179451"/>
                  </a:lnTo>
                  <a:close/>
                </a:path>
                <a:path w="4132579" h="359409">
                  <a:moveTo>
                    <a:pt x="2448687" y="59817"/>
                  </a:moveTo>
                  <a:lnTo>
                    <a:pt x="2438273" y="59817"/>
                  </a:lnTo>
                  <a:lnTo>
                    <a:pt x="2438273" y="358902"/>
                  </a:lnTo>
                  <a:lnTo>
                    <a:pt x="2448687" y="358902"/>
                  </a:lnTo>
                  <a:lnTo>
                    <a:pt x="2448687" y="59817"/>
                  </a:lnTo>
                  <a:close/>
                </a:path>
                <a:path w="4132579" h="359409">
                  <a:moveTo>
                    <a:pt x="2506726" y="209296"/>
                  </a:moveTo>
                  <a:lnTo>
                    <a:pt x="2496312" y="209296"/>
                  </a:lnTo>
                  <a:lnTo>
                    <a:pt x="2496312" y="358902"/>
                  </a:lnTo>
                  <a:lnTo>
                    <a:pt x="2506726" y="358902"/>
                  </a:lnTo>
                  <a:lnTo>
                    <a:pt x="2506726" y="209296"/>
                  </a:lnTo>
                  <a:close/>
                </a:path>
                <a:path w="4132579" h="359409">
                  <a:moveTo>
                    <a:pt x="2564765" y="269113"/>
                  </a:moveTo>
                  <a:lnTo>
                    <a:pt x="2554351" y="269113"/>
                  </a:lnTo>
                  <a:lnTo>
                    <a:pt x="2554351" y="358902"/>
                  </a:lnTo>
                  <a:lnTo>
                    <a:pt x="2564765" y="358902"/>
                  </a:lnTo>
                  <a:lnTo>
                    <a:pt x="2564765" y="269113"/>
                  </a:lnTo>
                  <a:close/>
                </a:path>
                <a:path w="4132579" h="359409">
                  <a:moveTo>
                    <a:pt x="2622804" y="269113"/>
                  </a:moveTo>
                  <a:lnTo>
                    <a:pt x="2612390" y="269113"/>
                  </a:lnTo>
                  <a:lnTo>
                    <a:pt x="2612390" y="358902"/>
                  </a:lnTo>
                  <a:lnTo>
                    <a:pt x="2622804" y="358902"/>
                  </a:lnTo>
                  <a:lnTo>
                    <a:pt x="2622804" y="269113"/>
                  </a:lnTo>
                  <a:close/>
                </a:path>
                <a:path w="4132579" h="359409">
                  <a:moveTo>
                    <a:pt x="2680843" y="209296"/>
                  </a:moveTo>
                  <a:lnTo>
                    <a:pt x="2670429" y="209296"/>
                  </a:lnTo>
                  <a:lnTo>
                    <a:pt x="2670429" y="358902"/>
                  </a:lnTo>
                  <a:lnTo>
                    <a:pt x="2680843" y="358902"/>
                  </a:lnTo>
                  <a:lnTo>
                    <a:pt x="2680843" y="209296"/>
                  </a:lnTo>
                  <a:close/>
                </a:path>
                <a:path w="4132579" h="359409">
                  <a:moveTo>
                    <a:pt x="2738882" y="209296"/>
                  </a:moveTo>
                  <a:lnTo>
                    <a:pt x="2728468" y="209296"/>
                  </a:lnTo>
                  <a:lnTo>
                    <a:pt x="2728468" y="358902"/>
                  </a:lnTo>
                  <a:lnTo>
                    <a:pt x="2738882" y="358902"/>
                  </a:lnTo>
                  <a:lnTo>
                    <a:pt x="2738882" y="209296"/>
                  </a:lnTo>
                  <a:close/>
                </a:path>
                <a:path w="4132579" h="359409">
                  <a:moveTo>
                    <a:pt x="2796921" y="179451"/>
                  </a:moveTo>
                  <a:lnTo>
                    <a:pt x="2786507" y="179451"/>
                  </a:lnTo>
                  <a:lnTo>
                    <a:pt x="2786507" y="358902"/>
                  </a:lnTo>
                  <a:lnTo>
                    <a:pt x="2796921" y="358902"/>
                  </a:lnTo>
                  <a:lnTo>
                    <a:pt x="2796921" y="179451"/>
                  </a:lnTo>
                  <a:close/>
                </a:path>
                <a:path w="4132579" h="359409">
                  <a:moveTo>
                    <a:pt x="2912999" y="239268"/>
                  </a:moveTo>
                  <a:lnTo>
                    <a:pt x="2902585" y="239268"/>
                  </a:lnTo>
                  <a:lnTo>
                    <a:pt x="2902585" y="358902"/>
                  </a:lnTo>
                  <a:lnTo>
                    <a:pt x="2912999" y="358902"/>
                  </a:lnTo>
                  <a:lnTo>
                    <a:pt x="2912999" y="239268"/>
                  </a:lnTo>
                  <a:close/>
                </a:path>
                <a:path w="4132579" h="359409">
                  <a:moveTo>
                    <a:pt x="2971165" y="209296"/>
                  </a:moveTo>
                  <a:lnTo>
                    <a:pt x="2960751" y="209296"/>
                  </a:lnTo>
                  <a:lnTo>
                    <a:pt x="2960751" y="358902"/>
                  </a:lnTo>
                  <a:lnTo>
                    <a:pt x="2971165" y="358902"/>
                  </a:lnTo>
                  <a:lnTo>
                    <a:pt x="2971165" y="209296"/>
                  </a:lnTo>
                  <a:close/>
                </a:path>
                <a:path w="4132579" h="359409">
                  <a:moveTo>
                    <a:pt x="3029204" y="149479"/>
                  </a:moveTo>
                  <a:lnTo>
                    <a:pt x="3018790" y="149479"/>
                  </a:lnTo>
                  <a:lnTo>
                    <a:pt x="3018790" y="358902"/>
                  </a:lnTo>
                  <a:lnTo>
                    <a:pt x="3029204" y="358902"/>
                  </a:lnTo>
                  <a:lnTo>
                    <a:pt x="3029204" y="149479"/>
                  </a:lnTo>
                  <a:close/>
                </a:path>
                <a:path w="4132579" h="359409">
                  <a:moveTo>
                    <a:pt x="3087243" y="179451"/>
                  </a:moveTo>
                  <a:lnTo>
                    <a:pt x="3076829" y="179451"/>
                  </a:lnTo>
                  <a:lnTo>
                    <a:pt x="3076829" y="358902"/>
                  </a:lnTo>
                  <a:lnTo>
                    <a:pt x="3087243" y="358902"/>
                  </a:lnTo>
                  <a:lnTo>
                    <a:pt x="3087243" y="179451"/>
                  </a:lnTo>
                  <a:close/>
                </a:path>
                <a:path w="4132579" h="359409">
                  <a:moveTo>
                    <a:pt x="3145282" y="299085"/>
                  </a:moveTo>
                  <a:lnTo>
                    <a:pt x="3134868" y="299085"/>
                  </a:lnTo>
                  <a:lnTo>
                    <a:pt x="3134868" y="358902"/>
                  </a:lnTo>
                  <a:lnTo>
                    <a:pt x="3145282" y="358902"/>
                  </a:lnTo>
                  <a:lnTo>
                    <a:pt x="3145282" y="299085"/>
                  </a:lnTo>
                  <a:close/>
                </a:path>
                <a:path w="4132579" h="359409">
                  <a:moveTo>
                    <a:pt x="3203321" y="328930"/>
                  </a:moveTo>
                  <a:lnTo>
                    <a:pt x="3192907" y="328930"/>
                  </a:lnTo>
                  <a:lnTo>
                    <a:pt x="3192907" y="358902"/>
                  </a:lnTo>
                  <a:lnTo>
                    <a:pt x="3203321" y="358902"/>
                  </a:lnTo>
                  <a:lnTo>
                    <a:pt x="3203321" y="328930"/>
                  </a:lnTo>
                  <a:close/>
                </a:path>
                <a:path w="4132579" h="359409">
                  <a:moveTo>
                    <a:pt x="3261360" y="299085"/>
                  </a:moveTo>
                  <a:lnTo>
                    <a:pt x="3250946" y="299085"/>
                  </a:lnTo>
                  <a:lnTo>
                    <a:pt x="3250946" y="358902"/>
                  </a:lnTo>
                  <a:lnTo>
                    <a:pt x="3261360" y="358902"/>
                  </a:lnTo>
                  <a:lnTo>
                    <a:pt x="3261360" y="299085"/>
                  </a:lnTo>
                  <a:close/>
                </a:path>
                <a:path w="4132579" h="359409">
                  <a:moveTo>
                    <a:pt x="3319399" y="328930"/>
                  </a:moveTo>
                  <a:lnTo>
                    <a:pt x="3308985" y="328930"/>
                  </a:lnTo>
                  <a:lnTo>
                    <a:pt x="3308985" y="358902"/>
                  </a:lnTo>
                  <a:lnTo>
                    <a:pt x="3319399" y="358902"/>
                  </a:lnTo>
                  <a:lnTo>
                    <a:pt x="3319399" y="328930"/>
                  </a:lnTo>
                  <a:close/>
                </a:path>
                <a:path w="4132579" h="359409">
                  <a:moveTo>
                    <a:pt x="3377438" y="29845"/>
                  </a:moveTo>
                  <a:lnTo>
                    <a:pt x="3367024" y="29845"/>
                  </a:lnTo>
                  <a:lnTo>
                    <a:pt x="3367024" y="358902"/>
                  </a:lnTo>
                  <a:lnTo>
                    <a:pt x="3377438" y="358902"/>
                  </a:lnTo>
                  <a:lnTo>
                    <a:pt x="3377438" y="29845"/>
                  </a:lnTo>
                  <a:close/>
                </a:path>
                <a:path w="4132579" h="359409">
                  <a:moveTo>
                    <a:pt x="3435477" y="239268"/>
                  </a:moveTo>
                  <a:lnTo>
                    <a:pt x="3425063" y="239268"/>
                  </a:lnTo>
                  <a:lnTo>
                    <a:pt x="3425063" y="358902"/>
                  </a:lnTo>
                  <a:lnTo>
                    <a:pt x="3435477" y="358902"/>
                  </a:lnTo>
                  <a:lnTo>
                    <a:pt x="3435477" y="239268"/>
                  </a:lnTo>
                  <a:close/>
                </a:path>
                <a:path w="4132579" h="359409">
                  <a:moveTo>
                    <a:pt x="3493643" y="209296"/>
                  </a:moveTo>
                  <a:lnTo>
                    <a:pt x="3483229" y="209296"/>
                  </a:lnTo>
                  <a:lnTo>
                    <a:pt x="3483229" y="358902"/>
                  </a:lnTo>
                  <a:lnTo>
                    <a:pt x="3493643" y="358902"/>
                  </a:lnTo>
                  <a:lnTo>
                    <a:pt x="3493643" y="209296"/>
                  </a:lnTo>
                  <a:close/>
                </a:path>
                <a:path w="4132579" h="359409">
                  <a:moveTo>
                    <a:pt x="3551682" y="179451"/>
                  </a:moveTo>
                  <a:lnTo>
                    <a:pt x="3541268" y="179451"/>
                  </a:lnTo>
                  <a:lnTo>
                    <a:pt x="3541268" y="358902"/>
                  </a:lnTo>
                  <a:lnTo>
                    <a:pt x="3551682" y="358902"/>
                  </a:lnTo>
                  <a:lnTo>
                    <a:pt x="3551682" y="179451"/>
                  </a:lnTo>
                  <a:close/>
                </a:path>
                <a:path w="4132579" h="359409">
                  <a:moveTo>
                    <a:pt x="3609721" y="269113"/>
                  </a:moveTo>
                  <a:lnTo>
                    <a:pt x="3599307" y="269113"/>
                  </a:lnTo>
                  <a:lnTo>
                    <a:pt x="3599307" y="358902"/>
                  </a:lnTo>
                  <a:lnTo>
                    <a:pt x="3609721" y="358902"/>
                  </a:lnTo>
                  <a:lnTo>
                    <a:pt x="3609721" y="269113"/>
                  </a:lnTo>
                  <a:close/>
                </a:path>
                <a:path w="4132579" h="359409">
                  <a:moveTo>
                    <a:pt x="3667760" y="209296"/>
                  </a:moveTo>
                  <a:lnTo>
                    <a:pt x="3657346" y="209296"/>
                  </a:lnTo>
                  <a:lnTo>
                    <a:pt x="3657346" y="358902"/>
                  </a:lnTo>
                  <a:lnTo>
                    <a:pt x="3667760" y="358902"/>
                  </a:lnTo>
                  <a:lnTo>
                    <a:pt x="3667760" y="209296"/>
                  </a:lnTo>
                  <a:close/>
                </a:path>
                <a:path w="4132579" h="359409">
                  <a:moveTo>
                    <a:pt x="3725799" y="119634"/>
                  </a:moveTo>
                  <a:lnTo>
                    <a:pt x="3715385" y="119634"/>
                  </a:lnTo>
                  <a:lnTo>
                    <a:pt x="3715385" y="358902"/>
                  </a:lnTo>
                  <a:lnTo>
                    <a:pt x="3725799" y="358902"/>
                  </a:lnTo>
                  <a:lnTo>
                    <a:pt x="3725799" y="119634"/>
                  </a:lnTo>
                  <a:close/>
                </a:path>
                <a:path w="4132579" h="359409">
                  <a:moveTo>
                    <a:pt x="3783838" y="299085"/>
                  </a:moveTo>
                  <a:lnTo>
                    <a:pt x="3773424" y="299085"/>
                  </a:lnTo>
                  <a:lnTo>
                    <a:pt x="3773424" y="358902"/>
                  </a:lnTo>
                  <a:lnTo>
                    <a:pt x="3783838" y="358902"/>
                  </a:lnTo>
                  <a:lnTo>
                    <a:pt x="3783838" y="299085"/>
                  </a:lnTo>
                  <a:close/>
                </a:path>
                <a:path w="4132579" h="359409">
                  <a:moveTo>
                    <a:pt x="3841877" y="299085"/>
                  </a:moveTo>
                  <a:lnTo>
                    <a:pt x="3831463" y="299085"/>
                  </a:lnTo>
                  <a:lnTo>
                    <a:pt x="3831463" y="358902"/>
                  </a:lnTo>
                  <a:lnTo>
                    <a:pt x="3841877" y="358902"/>
                  </a:lnTo>
                  <a:lnTo>
                    <a:pt x="3841877" y="299085"/>
                  </a:lnTo>
                  <a:close/>
                </a:path>
                <a:path w="4132579" h="359409">
                  <a:moveTo>
                    <a:pt x="3899916" y="328930"/>
                  </a:moveTo>
                  <a:lnTo>
                    <a:pt x="3889502" y="328930"/>
                  </a:lnTo>
                  <a:lnTo>
                    <a:pt x="3889502" y="358902"/>
                  </a:lnTo>
                  <a:lnTo>
                    <a:pt x="3899916" y="358902"/>
                  </a:lnTo>
                  <a:lnTo>
                    <a:pt x="3899916" y="328930"/>
                  </a:lnTo>
                  <a:close/>
                </a:path>
                <a:path w="4132579" h="359409">
                  <a:moveTo>
                    <a:pt x="3957955" y="179451"/>
                  </a:moveTo>
                  <a:lnTo>
                    <a:pt x="3947541" y="179451"/>
                  </a:lnTo>
                  <a:lnTo>
                    <a:pt x="3947541" y="358902"/>
                  </a:lnTo>
                  <a:lnTo>
                    <a:pt x="3957955" y="358902"/>
                  </a:lnTo>
                  <a:lnTo>
                    <a:pt x="3957955" y="179451"/>
                  </a:lnTo>
                  <a:close/>
                </a:path>
                <a:path w="4132579" h="359409">
                  <a:moveTo>
                    <a:pt x="4015994" y="299085"/>
                  </a:moveTo>
                  <a:lnTo>
                    <a:pt x="4005580" y="299085"/>
                  </a:lnTo>
                  <a:lnTo>
                    <a:pt x="4005580" y="358902"/>
                  </a:lnTo>
                  <a:lnTo>
                    <a:pt x="4015994" y="358902"/>
                  </a:lnTo>
                  <a:lnTo>
                    <a:pt x="4015994" y="299085"/>
                  </a:lnTo>
                  <a:close/>
                </a:path>
                <a:path w="4132579" h="359409">
                  <a:moveTo>
                    <a:pt x="4074160" y="328930"/>
                  </a:moveTo>
                  <a:lnTo>
                    <a:pt x="4063746" y="328930"/>
                  </a:lnTo>
                  <a:lnTo>
                    <a:pt x="4063746" y="358902"/>
                  </a:lnTo>
                  <a:lnTo>
                    <a:pt x="4074160" y="358902"/>
                  </a:lnTo>
                  <a:lnTo>
                    <a:pt x="4074160" y="328930"/>
                  </a:lnTo>
                  <a:close/>
                </a:path>
                <a:path w="4132579" h="359409">
                  <a:moveTo>
                    <a:pt x="4132199" y="269113"/>
                  </a:moveTo>
                  <a:lnTo>
                    <a:pt x="4121785" y="269113"/>
                  </a:lnTo>
                  <a:lnTo>
                    <a:pt x="4121785" y="358902"/>
                  </a:lnTo>
                  <a:lnTo>
                    <a:pt x="4132199" y="358902"/>
                  </a:lnTo>
                  <a:lnTo>
                    <a:pt x="4132199" y="269113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7" name="object 107" descr=""/>
            <p:cNvSpPr/>
            <p:nvPr/>
          </p:nvSpPr>
          <p:spPr>
            <a:xfrm>
              <a:off x="9341485" y="8452993"/>
              <a:ext cx="4712970" cy="209550"/>
            </a:xfrm>
            <a:custGeom>
              <a:avLst/>
              <a:gdLst/>
              <a:ahLst/>
              <a:cxnLst/>
              <a:rect l="l" t="t" r="r" b="b"/>
              <a:pathLst>
                <a:path w="4712969" h="209550">
                  <a:moveTo>
                    <a:pt x="10414" y="119634"/>
                  </a:moveTo>
                  <a:lnTo>
                    <a:pt x="0" y="119634"/>
                  </a:lnTo>
                  <a:lnTo>
                    <a:pt x="0" y="209423"/>
                  </a:lnTo>
                  <a:lnTo>
                    <a:pt x="10414" y="209423"/>
                  </a:lnTo>
                  <a:lnTo>
                    <a:pt x="10414" y="119634"/>
                  </a:lnTo>
                  <a:close/>
                </a:path>
                <a:path w="4712969" h="209550">
                  <a:moveTo>
                    <a:pt x="68453" y="149606"/>
                  </a:moveTo>
                  <a:lnTo>
                    <a:pt x="58039" y="149606"/>
                  </a:lnTo>
                  <a:lnTo>
                    <a:pt x="58039" y="209423"/>
                  </a:lnTo>
                  <a:lnTo>
                    <a:pt x="68453" y="209423"/>
                  </a:lnTo>
                  <a:lnTo>
                    <a:pt x="68453" y="149606"/>
                  </a:lnTo>
                  <a:close/>
                </a:path>
                <a:path w="4712969" h="209550">
                  <a:moveTo>
                    <a:pt x="126492" y="149606"/>
                  </a:moveTo>
                  <a:lnTo>
                    <a:pt x="116078" y="149606"/>
                  </a:lnTo>
                  <a:lnTo>
                    <a:pt x="116078" y="209423"/>
                  </a:lnTo>
                  <a:lnTo>
                    <a:pt x="126492" y="209423"/>
                  </a:lnTo>
                  <a:lnTo>
                    <a:pt x="126492" y="149606"/>
                  </a:lnTo>
                  <a:close/>
                </a:path>
                <a:path w="4712969" h="209550">
                  <a:moveTo>
                    <a:pt x="184531" y="89789"/>
                  </a:moveTo>
                  <a:lnTo>
                    <a:pt x="174117" y="89789"/>
                  </a:lnTo>
                  <a:lnTo>
                    <a:pt x="174117" y="209423"/>
                  </a:lnTo>
                  <a:lnTo>
                    <a:pt x="184531" y="209423"/>
                  </a:lnTo>
                  <a:lnTo>
                    <a:pt x="184531" y="89789"/>
                  </a:lnTo>
                  <a:close/>
                </a:path>
                <a:path w="4712969" h="209550">
                  <a:moveTo>
                    <a:pt x="242570" y="119634"/>
                  </a:moveTo>
                  <a:lnTo>
                    <a:pt x="232156" y="119634"/>
                  </a:lnTo>
                  <a:lnTo>
                    <a:pt x="232156" y="209423"/>
                  </a:lnTo>
                  <a:lnTo>
                    <a:pt x="242570" y="209423"/>
                  </a:lnTo>
                  <a:lnTo>
                    <a:pt x="242570" y="119634"/>
                  </a:lnTo>
                  <a:close/>
                </a:path>
                <a:path w="4712969" h="209550">
                  <a:moveTo>
                    <a:pt x="300609" y="119634"/>
                  </a:moveTo>
                  <a:lnTo>
                    <a:pt x="290195" y="119634"/>
                  </a:lnTo>
                  <a:lnTo>
                    <a:pt x="290195" y="209423"/>
                  </a:lnTo>
                  <a:lnTo>
                    <a:pt x="300609" y="209423"/>
                  </a:lnTo>
                  <a:lnTo>
                    <a:pt x="300609" y="119634"/>
                  </a:lnTo>
                  <a:close/>
                </a:path>
                <a:path w="4712969" h="209550">
                  <a:moveTo>
                    <a:pt x="358648" y="0"/>
                  </a:moveTo>
                  <a:lnTo>
                    <a:pt x="348234" y="0"/>
                  </a:lnTo>
                  <a:lnTo>
                    <a:pt x="348234" y="209423"/>
                  </a:lnTo>
                  <a:lnTo>
                    <a:pt x="358648" y="209423"/>
                  </a:lnTo>
                  <a:lnTo>
                    <a:pt x="358648" y="0"/>
                  </a:lnTo>
                  <a:close/>
                </a:path>
                <a:path w="4712969" h="209550">
                  <a:moveTo>
                    <a:pt x="416687" y="29972"/>
                  </a:moveTo>
                  <a:lnTo>
                    <a:pt x="406273" y="29972"/>
                  </a:lnTo>
                  <a:lnTo>
                    <a:pt x="406273" y="209423"/>
                  </a:lnTo>
                  <a:lnTo>
                    <a:pt x="416687" y="209423"/>
                  </a:lnTo>
                  <a:lnTo>
                    <a:pt x="416687" y="29972"/>
                  </a:lnTo>
                  <a:close/>
                </a:path>
                <a:path w="4712969" h="209550">
                  <a:moveTo>
                    <a:pt x="474853" y="59817"/>
                  </a:moveTo>
                  <a:lnTo>
                    <a:pt x="464439" y="59817"/>
                  </a:lnTo>
                  <a:lnTo>
                    <a:pt x="464439" y="209423"/>
                  </a:lnTo>
                  <a:lnTo>
                    <a:pt x="474853" y="209423"/>
                  </a:lnTo>
                  <a:lnTo>
                    <a:pt x="474853" y="59817"/>
                  </a:lnTo>
                  <a:close/>
                </a:path>
                <a:path w="4712969" h="209550">
                  <a:moveTo>
                    <a:pt x="532892" y="149606"/>
                  </a:moveTo>
                  <a:lnTo>
                    <a:pt x="522478" y="149606"/>
                  </a:lnTo>
                  <a:lnTo>
                    <a:pt x="522478" y="209423"/>
                  </a:lnTo>
                  <a:lnTo>
                    <a:pt x="532892" y="209423"/>
                  </a:lnTo>
                  <a:lnTo>
                    <a:pt x="532892" y="149606"/>
                  </a:lnTo>
                  <a:close/>
                </a:path>
                <a:path w="4712969" h="209550">
                  <a:moveTo>
                    <a:pt x="590931" y="89789"/>
                  </a:moveTo>
                  <a:lnTo>
                    <a:pt x="580517" y="89789"/>
                  </a:lnTo>
                  <a:lnTo>
                    <a:pt x="580517" y="209423"/>
                  </a:lnTo>
                  <a:lnTo>
                    <a:pt x="590931" y="209423"/>
                  </a:lnTo>
                  <a:lnTo>
                    <a:pt x="590931" y="89789"/>
                  </a:lnTo>
                  <a:close/>
                </a:path>
                <a:path w="4712969" h="209550">
                  <a:moveTo>
                    <a:pt x="648970" y="149606"/>
                  </a:moveTo>
                  <a:lnTo>
                    <a:pt x="638556" y="149606"/>
                  </a:lnTo>
                  <a:lnTo>
                    <a:pt x="638556" y="209423"/>
                  </a:lnTo>
                  <a:lnTo>
                    <a:pt x="648970" y="209423"/>
                  </a:lnTo>
                  <a:lnTo>
                    <a:pt x="648970" y="149606"/>
                  </a:lnTo>
                  <a:close/>
                </a:path>
                <a:path w="4712969" h="209550">
                  <a:moveTo>
                    <a:pt x="707009" y="149606"/>
                  </a:moveTo>
                  <a:lnTo>
                    <a:pt x="696595" y="149606"/>
                  </a:lnTo>
                  <a:lnTo>
                    <a:pt x="696595" y="209423"/>
                  </a:lnTo>
                  <a:lnTo>
                    <a:pt x="707009" y="209423"/>
                  </a:lnTo>
                  <a:lnTo>
                    <a:pt x="707009" y="149606"/>
                  </a:lnTo>
                  <a:close/>
                </a:path>
                <a:path w="4712969" h="209550">
                  <a:moveTo>
                    <a:pt x="775589" y="119634"/>
                  </a:moveTo>
                  <a:lnTo>
                    <a:pt x="762508" y="119634"/>
                  </a:lnTo>
                  <a:lnTo>
                    <a:pt x="762508" y="209423"/>
                  </a:lnTo>
                  <a:lnTo>
                    <a:pt x="775589" y="209423"/>
                  </a:lnTo>
                  <a:lnTo>
                    <a:pt x="775589" y="119634"/>
                  </a:lnTo>
                  <a:close/>
                </a:path>
                <a:path w="4712969" h="209550">
                  <a:moveTo>
                    <a:pt x="823087" y="179451"/>
                  </a:moveTo>
                  <a:lnTo>
                    <a:pt x="812673" y="179451"/>
                  </a:lnTo>
                  <a:lnTo>
                    <a:pt x="812673" y="209423"/>
                  </a:lnTo>
                  <a:lnTo>
                    <a:pt x="823087" y="209423"/>
                  </a:lnTo>
                  <a:lnTo>
                    <a:pt x="823087" y="179451"/>
                  </a:lnTo>
                  <a:close/>
                </a:path>
                <a:path w="4712969" h="209550">
                  <a:moveTo>
                    <a:pt x="881126" y="29972"/>
                  </a:moveTo>
                  <a:lnTo>
                    <a:pt x="870712" y="29972"/>
                  </a:lnTo>
                  <a:lnTo>
                    <a:pt x="870712" y="209423"/>
                  </a:lnTo>
                  <a:lnTo>
                    <a:pt x="881126" y="209423"/>
                  </a:lnTo>
                  <a:lnTo>
                    <a:pt x="881126" y="29972"/>
                  </a:lnTo>
                  <a:close/>
                </a:path>
                <a:path w="4712969" h="209550">
                  <a:moveTo>
                    <a:pt x="939165" y="89789"/>
                  </a:moveTo>
                  <a:lnTo>
                    <a:pt x="928751" y="89789"/>
                  </a:lnTo>
                  <a:lnTo>
                    <a:pt x="928751" y="209423"/>
                  </a:lnTo>
                  <a:lnTo>
                    <a:pt x="939165" y="209423"/>
                  </a:lnTo>
                  <a:lnTo>
                    <a:pt x="939165" y="89789"/>
                  </a:lnTo>
                  <a:close/>
                </a:path>
                <a:path w="4712969" h="209550">
                  <a:moveTo>
                    <a:pt x="997331" y="0"/>
                  </a:moveTo>
                  <a:lnTo>
                    <a:pt x="986917" y="0"/>
                  </a:lnTo>
                  <a:lnTo>
                    <a:pt x="986917" y="209423"/>
                  </a:lnTo>
                  <a:lnTo>
                    <a:pt x="997331" y="209423"/>
                  </a:lnTo>
                  <a:lnTo>
                    <a:pt x="997331" y="0"/>
                  </a:lnTo>
                  <a:close/>
                </a:path>
                <a:path w="4712969" h="209550">
                  <a:moveTo>
                    <a:pt x="1055370" y="149606"/>
                  </a:moveTo>
                  <a:lnTo>
                    <a:pt x="1044956" y="149606"/>
                  </a:lnTo>
                  <a:lnTo>
                    <a:pt x="1044956" y="209423"/>
                  </a:lnTo>
                  <a:lnTo>
                    <a:pt x="1055370" y="209423"/>
                  </a:lnTo>
                  <a:lnTo>
                    <a:pt x="1055370" y="149606"/>
                  </a:lnTo>
                  <a:close/>
                </a:path>
                <a:path w="4712969" h="209550">
                  <a:moveTo>
                    <a:pt x="1113409" y="179451"/>
                  </a:moveTo>
                  <a:lnTo>
                    <a:pt x="1102995" y="179451"/>
                  </a:lnTo>
                  <a:lnTo>
                    <a:pt x="1102995" y="209423"/>
                  </a:lnTo>
                  <a:lnTo>
                    <a:pt x="1113409" y="209423"/>
                  </a:lnTo>
                  <a:lnTo>
                    <a:pt x="1113409" y="179451"/>
                  </a:lnTo>
                  <a:close/>
                </a:path>
                <a:path w="4712969" h="209550">
                  <a:moveTo>
                    <a:pt x="1171448" y="29972"/>
                  </a:moveTo>
                  <a:lnTo>
                    <a:pt x="1161034" y="29972"/>
                  </a:lnTo>
                  <a:lnTo>
                    <a:pt x="1161034" y="209423"/>
                  </a:lnTo>
                  <a:lnTo>
                    <a:pt x="1171448" y="209423"/>
                  </a:lnTo>
                  <a:lnTo>
                    <a:pt x="1171448" y="29972"/>
                  </a:lnTo>
                  <a:close/>
                </a:path>
                <a:path w="4712969" h="209550">
                  <a:moveTo>
                    <a:pt x="1287526" y="179451"/>
                  </a:moveTo>
                  <a:lnTo>
                    <a:pt x="1277112" y="179451"/>
                  </a:lnTo>
                  <a:lnTo>
                    <a:pt x="1277112" y="209423"/>
                  </a:lnTo>
                  <a:lnTo>
                    <a:pt x="1287526" y="209423"/>
                  </a:lnTo>
                  <a:lnTo>
                    <a:pt x="1287526" y="179451"/>
                  </a:lnTo>
                  <a:close/>
                </a:path>
                <a:path w="4712969" h="209550">
                  <a:moveTo>
                    <a:pt x="1345565" y="119634"/>
                  </a:moveTo>
                  <a:lnTo>
                    <a:pt x="1335151" y="119634"/>
                  </a:lnTo>
                  <a:lnTo>
                    <a:pt x="1335151" y="209423"/>
                  </a:lnTo>
                  <a:lnTo>
                    <a:pt x="1345565" y="209423"/>
                  </a:lnTo>
                  <a:lnTo>
                    <a:pt x="1345565" y="119634"/>
                  </a:lnTo>
                  <a:close/>
                </a:path>
                <a:path w="4712969" h="209550">
                  <a:moveTo>
                    <a:pt x="1403604" y="119634"/>
                  </a:moveTo>
                  <a:lnTo>
                    <a:pt x="1393190" y="119634"/>
                  </a:lnTo>
                  <a:lnTo>
                    <a:pt x="1393190" y="209423"/>
                  </a:lnTo>
                  <a:lnTo>
                    <a:pt x="1403604" y="209423"/>
                  </a:lnTo>
                  <a:lnTo>
                    <a:pt x="1403604" y="119634"/>
                  </a:lnTo>
                  <a:close/>
                </a:path>
                <a:path w="4712969" h="209550">
                  <a:moveTo>
                    <a:pt x="1461643" y="89789"/>
                  </a:moveTo>
                  <a:lnTo>
                    <a:pt x="1451229" y="89789"/>
                  </a:lnTo>
                  <a:lnTo>
                    <a:pt x="1451229" y="209423"/>
                  </a:lnTo>
                  <a:lnTo>
                    <a:pt x="1461643" y="209423"/>
                  </a:lnTo>
                  <a:lnTo>
                    <a:pt x="1461643" y="89789"/>
                  </a:lnTo>
                  <a:close/>
                </a:path>
                <a:path w="4712969" h="209550">
                  <a:moveTo>
                    <a:pt x="1519682" y="179451"/>
                  </a:moveTo>
                  <a:lnTo>
                    <a:pt x="1509268" y="179451"/>
                  </a:lnTo>
                  <a:lnTo>
                    <a:pt x="1509268" y="209423"/>
                  </a:lnTo>
                  <a:lnTo>
                    <a:pt x="1519682" y="209423"/>
                  </a:lnTo>
                  <a:lnTo>
                    <a:pt x="1519682" y="179451"/>
                  </a:lnTo>
                  <a:close/>
                </a:path>
                <a:path w="4712969" h="209550">
                  <a:moveTo>
                    <a:pt x="1577848" y="179451"/>
                  </a:moveTo>
                  <a:lnTo>
                    <a:pt x="1567434" y="179451"/>
                  </a:lnTo>
                  <a:lnTo>
                    <a:pt x="1567434" y="209423"/>
                  </a:lnTo>
                  <a:lnTo>
                    <a:pt x="1577848" y="209423"/>
                  </a:lnTo>
                  <a:lnTo>
                    <a:pt x="1577848" y="179451"/>
                  </a:lnTo>
                  <a:close/>
                </a:path>
                <a:path w="4712969" h="209550">
                  <a:moveTo>
                    <a:pt x="1635887" y="149606"/>
                  </a:moveTo>
                  <a:lnTo>
                    <a:pt x="1625473" y="149606"/>
                  </a:lnTo>
                  <a:lnTo>
                    <a:pt x="1625473" y="209423"/>
                  </a:lnTo>
                  <a:lnTo>
                    <a:pt x="1635887" y="209423"/>
                  </a:lnTo>
                  <a:lnTo>
                    <a:pt x="1635887" y="149606"/>
                  </a:lnTo>
                  <a:close/>
                </a:path>
                <a:path w="4712969" h="209550">
                  <a:moveTo>
                    <a:pt x="1693926" y="149606"/>
                  </a:moveTo>
                  <a:lnTo>
                    <a:pt x="1683512" y="149606"/>
                  </a:lnTo>
                  <a:lnTo>
                    <a:pt x="1683512" y="209423"/>
                  </a:lnTo>
                  <a:lnTo>
                    <a:pt x="1693926" y="209423"/>
                  </a:lnTo>
                  <a:lnTo>
                    <a:pt x="1693926" y="149606"/>
                  </a:lnTo>
                  <a:close/>
                </a:path>
                <a:path w="4712969" h="209550">
                  <a:moveTo>
                    <a:pt x="1751965" y="119634"/>
                  </a:moveTo>
                  <a:lnTo>
                    <a:pt x="1741551" y="119634"/>
                  </a:lnTo>
                  <a:lnTo>
                    <a:pt x="1741551" y="209423"/>
                  </a:lnTo>
                  <a:lnTo>
                    <a:pt x="1751965" y="209423"/>
                  </a:lnTo>
                  <a:lnTo>
                    <a:pt x="1751965" y="119634"/>
                  </a:lnTo>
                  <a:close/>
                </a:path>
                <a:path w="4712969" h="209550">
                  <a:moveTo>
                    <a:pt x="1868043" y="89789"/>
                  </a:moveTo>
                  <a:lnTo>
                    <a:pt x="1857629" y="89789"/>
                  </a:lnTo>
                  <a:lnTo>
                    <a:pt x="1857629" y="209423"/>
                  </a:lnTo>
                  <a:lnTo>
                    <a:pt x="1868043" y="209423"/>
                  </a:lnTo>
                  <a:lnTo>
                    <a:pt x="1868043" y="89789"/>
                  </a:lnTo>
                  <a:close/>
                </a:path>
                <a:path w="4712969" h="209550">
                  <a:moveTo>
                    <a:pt x="1926082" y="59817"/>
                  </a:moveTo>
                  <a:lnTo>
                    <a:pt x="1915668" y="59817"/>
                  </a:lnTo>
                  <a:lnTo>
                    <a:pt x="1915668" y="209423"/>
                  </a:lnTo>
                  <a:lnTo>
                    <a:pt x="1926082" y="209423"/>
                  </a:lnTo>
                  <a:lnTo>
                    <a:pt x="1926082" y="59817"/>
                  </a:lnTo>
                  <a:close/>
                </a:path>
                <a:path w="4712969" h="209550">
                  <a:moveTo>
                    <a:pt x="1984121" y="89789"/>
                  </a:moveTo>
                  <a:lnTo>
                    <a:pt x="1973707" y="89789"/>
                  </a:lnTo>
                  <a:lnTo>
                    <a:pt x="1973707" y="209423"/>
                  </a:lnTo>
                  <a:lnTo>
                    <a:pt x="1984121" y="209423"/>
                  </a:lnTo>
                  <a:lnTo>
                    <a:pt x="1984121" y="89789"/>
                  </a:lnTo>
                  <a:close/>
                </a:path>
                <a:path w="4712969" h="209550">
                  <a:moveTo>
                    <a:pt x="2042160" y="59817"/>
                  </a:moveTo>
                  <a:lnTo>
                    <a:pt x="2031746" y="59817"/>
                  </a:lnTo>
                  <a:lnTo>
                    <a:pt x="2031746" y="209423"/>
                  </a:lnTo>
                  <a:lnTo>
                    <a:pt x="2042160" y="209423"/>
                  </a:lnTo>
                  <a:lnTo>
                    <a:pt x="2042160" y="59817"/>
                  </a:lnTo>
                  <a:close/>
                </a:path>
                <a:path w="4712969" h="209550">
                  <a:moveTo>
                    <a:pt x="2100326" y="59817"/>
                  </a:moveTo>
                  <a:lnTo>
                    <a:pt x="2089912" y="59817"/>
                  </a:lnTo>
                  <a:lnTo>
                    <a:pt x="2089912" y="209423"/>
                  </a:lnTo>
                  <a:lnTo>
                    <a:pt x="2100326" y="209423"/>
                  </a:lnTo>
                  <a:lnTo>
                    <a:pt x="2100326" y="59817"/>
                  </a:lnTo>
                  <a:close/>
                </a:path>
                <a:path w="4712969" h="209550">
                  <a:moveTo>
                    <a:pt x="2158365" y="149606"/>
                  </a:moveTo>
                  <a:lnTo>
                    <a:pt x="2147951" y="149606"/>
                  </a:lnTo>
                  <a:lnTo>
                    <a:pt x="2147951" y="209423"/>
                  </a:lnTo>
                  <a:lnTo>
                    <a:pt x="2158365" y="209423"/>
                  </a:lnTo>
                  <a:lnTo>
                    <a:pt x="2158365" y="149606"/>
                  </a:lnTo>
                  <a:close/>
                </a:path>
                <a:path w="4712969" h="209550">
                  <a:moveTo>
                    <a:pt x="2216404" y="119634"/>
                  </a:moveTo>
                  <a:lnTo>
                    <a:pt x="2205990" y="119634"/>
                  </a:lnTo>
                  <a:lnTo>
                    <a:pt x="2205990" y="209423"/>
                  </a:lnTo>
                  <a:lnTo>
                    <a:pt x="2216404" y="209423"/>
                  </a:lnTo>
                  <a:lnTo>
                    <a:pt x="2216404" y="119634"/>
                  </a:lnTo>
                  <a:close/>
                </a:path>
                <a:path w="4712969" h="209550">
                  <a:moveTo>
                    <a:pt x="2274443" y="149606"/>
                  </a:moveTo>
                  <a:lnTo>
                    <a:pt x="2264029" y="149606"/>
                  </a:lnTo>
                  <a:lnTo>
                    <a:pt x="2264029" y="209423"/>
                  </a:lnTo>
                  <a:lnTo>
                    <a:pt x="2274443" y="209423"/>
                  </a:lnTo>
                  <a:lnTo>
                    <a:pt x="2274443" y="149606"/>
                  </a:lnTo>
                  <a:close/>
                </a:path>
                <a:path w="4712969" h="209550">
                  <a:moveTo>
                    <a:pt x="2332482" y="119634"/>
                  </a:moveTo>
                  <a:lnTo>
                    <a:pt x="2322068" y="119634"/>
                  </a:lnTo>
                  <a:lnTo>
                    <a:pt x="2322068" y="209423"/>
                  </a:lnTo>
                  <a:lnTo>
                    <a:pt x="2332482" y="209423"/>
                  </a:lnTo>
                  <a:lnTo>
                    <a:pt x="2332482" y="119634"/>
                  </a:lnTo>
                  <a:close/>
                </a:path>
                <a:path w="4712969" h="209550">
                  <a:moveTo>
                    <a:pt x="2448560" y="149606"/>
                  </a:moveTo>
                  <a:lnTo>
                    <a:pt x="2438146" y="149606"/>
                  </a:lnTo>
                  <a:lnTo>
                    <a:pt x="2438146" y="209423"/>
                  </a:lnTo>
                  <a:lnTo>
                    <a:pt x="2448560" y="209423"/>
                  </a:lnTo>
                  <a:lnTo>
                    <a:pt x="2448560" y="149606"/>
                  </a:lnTo>
                  <a:close/>
                </a:path>
                <a:path w="4712969" h="209550">
                  <a:moveTo>
                    <a:pt x="2506599" y="179451"/>
                  </a:moveTo>
                  <a:lnTo>
                    <a:pt x="2496185" y="179451"/>
                  </a:lnTo>
                  <a:lnTo>
                    <a:pt x="2496185" y="209423"/>
                  </a:lnTo>
                  <a:lnTo>
                    <a:pt x="2506599" y="209423"/>
                  </a:lnTo>
                  <a:lnTo>
                    <a:pt x="2506599" y="179451"/>
                  </a:lnTo>
                  <a:close/>
                </a:path>
                <a:path w="4712969" h="209550">
                  <a:moveTo>
                    <a:pt x="2622804" y="119634"/>
                  </a:moveTo>
                  <a:lnTo>
                    <a:pt x="2612390" y="119634"/>
                  </a:lnTo>
                  <a:lnTo>
                    <a:pt x="2612390" y="209423"/>
                  </a:lnTo>
                  <a:lnTo>
                    <a:pt x="2622804" y="209423"/>
                  </a:lnTo>
                  <a:lnTo>
                    <a:pt x="2622804" y="119634"/>
                  </a:lnTo>
                  <a:close/>
                </a:path>
                <a:path w="4712969" h="209550">
                  <a:moveTo>
                    <a:pt x="2680843" y="149606"/>
                  </a:moveTo>
                  <a:lnTo>
                    <a:pt x="2670429" y="149606"/>
                  </a:lnTo>
                  <a:lnTo>
                    <a:pt x="2670429" y="209423"/>
                  </a:lnTo>
                  <a:lnTo>
                    <a:pt x="2680843" y="209423"/>
                  </a:lnTo>
                  <a:lnTo>
                    <a:pt x="2680843" y="149606"/>
                  </a:lnTo>
                  <a:close/>
                </a:path>
                <a:path w="4712969" h="209550">
                  <a:moveTo>
                    <a:pt x="2738882" y="119634"/>
                  </a:moveTo>
                  <a:lnTo>
                    <a:pt x="2728468" y="119634"/>
                  </a:lnTo>
                  <a:lnTo>
                    <a:pt x="2728468" y="209423"/>
                  </a:lnTo>
                  <a:lnTo>
                    <a:pt x="2738882" y="209423"/>
                  </a:lnTo>
                  <a:lnTo>
                    <a:pt x="2738882" y="119634"/>
                  </a:lnTo>
                  <a:close/>
                </a:path>
                <a:path w="4712969" h="209550">
                  <a:moveTo>
                    <a:pt x="2854960" y="149606"/>
                  </a:moveTo>
                  <a:lnTo>
                    <a:pt x="2844546" y="149606"/>
                  </a:lnTo>
                  <a:lnTo>
                    <a:pt x="2844546" y="209423"/>
                  </a:lnTo>
                  <a:lnTo>
                    <a:pt x="2854960" y="209423"/>
                  </a:lnTo>
                  <a:lnTo>
                    <a:pt x="2854960" y="149606"/>
                  </a:lnTo>
                  <a:close/>
                </a:path>
                <a:path w="4712969" h="209550">
                  <a:moveTo>
                    <a:pt x="2912999" y="149606"/>
                  </a:moveTo>
                  <a:lnTo>
                    <a:pt x="2902585" y="149606"/>
                  </a:lnTo>
                  <a:lnTo>
                    <a:pt x="2902585" y="209423"/>
                  </a:lnTo>
                  <a:lnTo>
                    <a:pt x="2912999" y="209423"/>
                  </a:lnTo>
                  <a:lnTo>
                    <a:pt x="2912999" y="149606"/>
                  </a:lnTo>
                  <a:close/>
                </a:path>
                <a:path w="4712969" h="209550">
                  <a:moveTo>
                    <a:pt x="2971038" y="149606"/>
                  </a:moveTo>
                  <a:lnTo>
                    <a:pt x="2960624" y="149606"/>
                  </a:lnTo>
                  <a:lnTo>
                    <a:pt x="2960624" y="209423"/>
                  </a:lnTo>
                  <a:lnTo>
                    <a:pt x="2971038" y="209423"/>
                  </a:lnTo>
                  <a:lnTo>
                    <a:pt x="2971038" y="149606"/>
                  </a:lnTo>
                  <a:close/>
                </a:path>
                <a:path w="4712969" h="209550">
                  <a:moveTo>
                    <a:pt x="3029077" y="179451"/>
                  </a:moveTo>
                  <a:lnTo>
                    <a:pt x="3018663" y="179451"/>
                  </a:lnTo>
                  <a:lnTo>
                    <a:pt x="3018663" y="209423"/>
                  </a:lnTo>
                  <a:lnTo>
                    <a:pt x="3029077" y="209423"/>
                  </a:lnTo>
                  <a:lnTo>
                    <a:pt x="3029077" y="179451"/>
                  </a:lnTo>
                  <a:close/>
                </a:path>
                <a:path w="4712969" h="209550">
                  <a:moveTo>
                    <a:pt x="3087116" y="179451"/>
                  </a:moveTo>
                  <a:lnTo>
                    <a:pt x="3076702" y="179451"/>
                  </a:lnTo>
                  <a:lnTo>
                    <a:pt x="3076702" y="209423"/>
                  </a:lnTo>
                  <a:lnTo>
                    <a:pt x="3087116" y="209423"/>
                  </a:lnTo>
                  <a:lnTo>
                    <a:pt x="3087116" y="179451"/>
                  </a:lnTo>
                  <a:close/>
                </a:path>
                <a:path w="4712969" h="209550">
                  <a:moveTo>
                    <a:pt x="3145155" y="59817"/>
                  </a:moveTo>
                  <a:lnTo>
                    <a:pt x="3134741" y="59817"/>
                  </a:lnTo>
                  <a:lnTo>
                    <a:pt x="3134741" y="209423"/>
                  </a:lnTo>
                  <a:lnTo>
                    <a:pt x="3145155" y="209423"/>
                  </a:lnTo>
                  <a:lnTo>
                    <a:pt x="3145155" y="59817"/>
                  </a:lnTo>
                  <a:close/>
                </a:path>
                <a:path w="4712969" h="209550">
                  <a:moveTo>
                    <a:pt x="3203321" y="119634"/>
                  </a:moveTo>
                  <a:lnTo>
                    <a:pt x="3192907" y="119634"/>
                  </a:lnTo>
                  <a:lnTo>
                    <a:pt x="3192907" y="209423"/>
                  </a:lnTo>
                  <a:lnTo>
                    <a:pt x="3203321" y="209423"/>
                  </a:lnTo>
                  <a:lnTo>
                    <a:pt x="3203321" y="119634"/>
                  </a:lnTo>
                  <a:close/>
                </a:path>
                <a:path w="4712969" h="209550">
                  <a:moveTo>
                    <a:pt x="3377438" y="89789"/>
                  </a:moveTo>
                  <a:lnTo>
                    <a:pt x="3367024" y="89789"/>
                  </a:lnTo>
                  <a:lnTo>
                    <a:pt x="3367024" y="209423"/>
                  </a:lnTo>
                  <a:lnTo>
                    <a:pt x="3377438" y="209423"/>
                  </a:lnTo>
                  <a:lnTo>
                    <a:pt x="3377438" y="89789"/>
                  </a:lnTo>
                  <a:close/>
                </a:path>
                <a:path w="4712969" h="209550">
                  <a:moveTo>
                    <a:pt x="3435477" y="179451"/>
                  </a:moveTo>
                  <a:lnTo>
                    <a:pt x="3425063" y="179451"/>
                  </a:lnTo>
                  <a:lnTo>
                    <a:pt x="3425063" y="209423"/>
                  </a:lnTo>
                  <a:lnTo>
                    <a:pt x="3435477" y="209423"/>
                  </a:lnTo>
                  <a:lnTo>
                    <a:pt x="3435477" y="179451"/>
                  </a:lnTo>
                  <a:close/>
                </a:path>
                <a:path w="4712969" h="209550">
                  <a:moveTo>
                    <a:pt x="3493516" y="149606"/>
                  </a:moveTo>
                  <a:lnTo>
                    <a:pt x="3483102" y="149606"/>
                  </a:lnTo>
                  <a:lnTo>
                    <a:pt x="3483102" y="209423"/>
                  </a:lnTo>
                  <a:lnTo>
                    <a:pt x="3493516" y="209423"/>
                  </a:lnTo>
                  <a:lnTo>
                    <a:pt x="3493516" y="149606"/>
                  </a:lnTo>
                  <a:close/>
                </a:path>
                <a:path w="4712969" h="209550">
                  <a:moveTo>
                    <a:pt x="3551555" y="179451"/>
                  </a:moveTo>
                  <a:lnTo>
                    <a:pt x="3541141" y="179451"/>
                  </a:lnTo>
                  <a:lnTo>
                    <a:pt x="3541141" y="209423"/>
                  </a:lnTo>
                  <a:lnTo>
                    <a:pt x="3551555" y="209423"/>
                  </a:lnTo>
                  <a:lnTo>
                    <a:pt x="3551555" y="179451"/>
                  </a:lnTo>
                  <a:close/>
                </a:path>
                <a:path w="4712969" h="209550">
                  <a:moveTo>
                    <a:pt x="3609594" y="179451"/>
                  </a:moveTo>
                  <a:lnTo>
                    <a:pt x="3599180" y="179451"/>
                  </a:lnTo>
                  <a:lnTo>
                    <a:pt x="3599180" y="209423"/>
                  </a:lnTo>
                  <a:lnTo>
                    <a:pt x="3609594" y="209423"/>
                  </a:lnTo>
                  <a:lnTo>
                    <a:pt x="3609594" y="179451"/>
                  </a:lnTo>
                  <a:close/>
                </a:path>
                <a:path w="4712969" h="209550">
                  <a:moveTo>
                    <a:pt x="3667620" y="149606"/>
                  </a:moveTo>
                  <a:lnTo>
                    <a:pt x="3657219" y="149606"/>
                  </a:lnTo>
                  <a:lnTo>
                    <a:pt x="3657219" y="209423"/>
                  </a:lnTo>
                  <a:lnTo>
                    <a:pt x="3667620" y="209423"/>
                  </a:lnTo>
                  <a:lnTo>
                    <a:pt x="3667620" y="149606"/>
                  </a:lnTo>
                  <a:close/>
                </a:path>
                <a:path w="4712969" h="209550">
                  <a:moveTo>
                    <a:pt x="3725786" y="149606"/>
                  </a:moveTo>
                  <a:lnTo>
                    <a:pt x="3715372" y="149606"/>
                  </a:lnTo>
                  <a:lnTo>
                    <a:pt x="3715372" y="209423"/>
                  </a:lnTo>
                  <a:lnTo>
                    <a:pt x="3725786" y="209423"/>
                  </a:lnTo>
                  <a:lnTo>
                    <a:pt x="3725786" y="149606"/>
                  </a:lnTo>
                  <a:close/>
                </a:path>
                <a:path w="4712969" h="209550">
                  <a:moveTo>
                    <a:pt x="3841877" y="179451"/>
                  </a:moveTo>
                  <a:lnTo>
                    <a:pt x="3831463" y="179451"/>
                  </a:lnTo>
                  <a:lnTo>
                    <a:pt x="3831463" y="209423"/>
                  </a:lnTo>
                  <a:lnTo>
                    <a:pt x="3841877" y="209423"/>
                  </a:lnTo>
                  <a:lnTo>
                    <a:pt x="3841877" y="179451"/>
                  </a:lnTo>
                  <a:close/>
                </a:path>
                <a:path w="4712969" h="209550">
                  <a:moveTo>
                    <a:pt x="3910457" y="179451"/>
                  </a:moveTo>
                  <a:lnTo>
                    <a:pt x="3897376" y="179451"/>
                  </a:lnTo>
                  <a:lnTo>
                    <a:pt x="3897376" y="209423"/>
                  </a:lnTo>
                  <a:lnTo>
                    <a:pt x="3910457" y="209423"/>
                  </a:lnTo>
                  <a:lnTo>
                    <a:pt x="3910457" y="179451"/>
                  </a:lnTo>
                  <a:close/>
                </a:path>
                <a:path w="4712969" h="209550">
                  <a:moveTo>
                    <a:pt x="3968369" y="179451"/>
                  </a:moveTo>
                  <a:lnTo>
                    <a:pt x="3950970" y="179451"/>
                  </a:lnTo>
                  <a:lnTo>
                    <a:pt x="3950970" y="209423"/>
                  </a:lnTo>
                  <a:lnTo>
                    <a:pt x="3968369" y="209423"/>
                  </a:lnTo>
                  <a:lnTo>
                    <a:pt x="3968369" y="179451"/>
                  </a:lnTo>
                  <a:close/>
                </a:path>
                <a:path w="4712969" h="209550">
                  <a:moveTo>
                    <a:pt x="4074033" y="179451"/>
                  </a:moveTo>
                  <a:lnTo>
                    <a:pt x="4063619" y="179451"/>
                  </a:lnTo>
                  <a:lnTo>
                    <a:pt x="4063619" y="209423"/>
                  </a:lnTo>
                  <a:lnTo>
                    <a:pt x="4074033" y="209423"/>
                  </a:lnTo>
                  <a:lnTo>
                    <a:pt x="4074033" y="179451"/>
                  </a:lnTo>
                  <a:close/>
                </a:path>
                <a:path w="4712969" h="209550">
                  <a:moveTo>
                    <a:pt x="4132059" y="179451"/>
                  </a:moveTo>
                  <a:lnTo>
                    <a:pt x="4121658" y="179451"/>
                  </a:lnTo>
                  <a:lnTo>
                    <a:pt x="4121658" y="209423"/>
                  </a:lnTo>
                  <a:lnTo>
                    <a:pt x="4132059" y="209423"/>
                  </a:lnTo>
                  <a:lnTo>
                    <a:pt x="4132059" y="179451"/>
                  </a:lnTo>
                  <a:close/>
                </a:path>
                <a:path w="4712969" h="209550">
                  <a:moveTo>
                    <a:pt x="4200652" y="179451"/>
                  </a:moveTo>
                  <a:lnTo>
                    <a:pt x="4187571" y="179451"/>
                  </a:lnTo>
                  <a:lnTo>
                    <a:pt x="4187571" y="209423"/>
                  </a:lnTo>
                  <a:lnTo>
                    <a:pt x="4200652" y="209423"/>
                  </a:lnTo>
                  <a:lnTo>
                    <a:pt x="4200652" y="179451"/>
                  </a:lnTo>
                  <a:close/>
                </a:path>
                <a:path w="4712969" h="209550">
                  <a:moveTo>
                    <a:pt x="4258678" y="179451"/>
                  </a:moveTo>
                  <a:lnTo>
                    <a:pt x="4245610" y="179451"/>
                  </a:lnTo>
                  <a:lnTo>
                    <a:pt x="4245610" y="209423"/>
                  </a:lnTo>
                  <a:lnTo>
                    <a:pt x="4258678" y="209423"/>
                  </a:lnTo>
                  <a:lnTo>
                    <a:pt x="4258678" y="179451"/>
                  </a:lnTo>
                  <a:close/>
                </a:path>
                <a:path w="4712969" h="209550">
                  <a:moveTo>
                    <a:pt x="4361815" y="179451"/>
                  </a:moveTo>
                  <a:lnTo>
                    <a:pt x="4348734" y="179451"/>
                  </a:lnTo>
                  <a:lnTo>
                    <a:pt x="4348734" y="209423"/>
                  </a:lnTo>
                  <a:lnTo>
                    <a:pt x="4361815" y="209423"/>
                  </a:lnTo>
                  <a:lnTo>
                    <a:pt x="4361815" y="179451"/>
                  </a:lnTo>
                  <a:close/>
                </a:path>
                <a:path w="4712969" h="209550">
                  <a:moveTo>
                    <a:pt x="4490974" y="119634"/>
                  </a:moveTo>
                  <a:lnTo>
                    <a:pt x="4477893" y="119634"/>
                  </a:lnTo>
                  <a:lnTo>
                    <a:pt x="4477893" y="209423"/>
                  </a:lnTo>
                  <a:lnTo>
                    <a:pt x="4490974" y="209423"/>
                  </a:lnTo>
                  <a:lnTo>
                    <a:pt x="4490974" y="119634"/>
                  </a:lnTo>
                  <a:close/>
                </a:path>
                <a:path w="4712969" h="209550">
                  <a:moveTo>
                    <a:pt x="4538459" y="179451"/>
                  </a:moveTo>
                  <a:lnTo>
                    <a:pt x="4528058" y="179451"/>
                  </a:lnTo>
                  <a:lnTo>
                    <a:pt x="4528058" y="209423"/>
                  </a:lnTo>
                  <a:lnTo>
                    <a:pt x="4538459" y="209423"/>
                  </a:lnTo>
                  <a:lnTo>
                    <a:pt x="4538459" y="179451"/>
                  </a:lnTo>
                  <a:close/>
                </a:path>
                <a:path w="4712969" h="209550">
                  <a:moveTo>
                    <a:pt x="4596511" y="179451"/>
                  </a:moveTo>
                  <a:lnTo>
                    <a:pt x="4586097" y="179451"/>
                  </a:lnTo>
                  <a:lnTo>
                    <a:pt x="4586097" y="209423"/>
                  </a:lnTo>
                  <a:lnTo>
                    <a:pt x="4596511" y="209423"/>
                  </a:lnTo>
                  <a:lnTo>
                    <a:pt x="4596511" y="179451"/>
                  </a:lnTo>
                  <a:close/>
                </a:path>
                <a:path w="4712969" h="209550">
                  <a:moveTo>
                    <a:pt x="4654550" y="179451"/>
                  </a:moveTo>
                  <a:lnTo>
                    <a:pt x="4644136" y="179451"/>
                  </a:lnTo>
                  <a:lnTo>
                    <a:pt x="4644136" y="209423"/>
                  </a:lnTo>
                  <a:lnTo>
                    <a:pt x="4654550" y="209423"/>
                  </a:lnTo>
                  <a:lnTo>
                    <a:pt x="4654550" y="179451"/>
                  </a:lnTo>
                  <a:close/>
                </a:path>
                <a:path w="4712969" h="209550">
                  <a:moveTo>
                    <a:pt x="4712589" y="179451"/>
                  </a:moveTo>
                  <a:lnTo>
                    <a:pt x="4702175" y="179451"/>
                  </a:lnTo>
                  <a:lnTo>
                    <a:pt x="4702175" y="209423"/>
                  </a:lnTo>
                  <a:lnTo>
                    <a:pt x="4712589" y="209423"/>
                  </a:lnTo>
                  <a:lnTo>
                    <a:pt x="4712589" y="179451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8" name="object 108" descr=""/>
            <p:cNvSpPr/>
            <p:nvPr/>
          </p:nvSpPr>
          <p:spPr>
            <a:xfrm>
              <a:off x="14043660" y="8602599"/>
              <a:ext cx="243204" cy="60325"/>
            </a:xfrm>
            <a:custGeom>
              <a:avLst/>
              <a:gdLst/>
              <a:ahLst/>
              <a:cxnLst/>
              <a:rect l="l" t="t" r="r" b="b"/>
              <a:pathLst>
                <a:path w="243205" h="60325">
                  <a:moveTo>
                    <a:pt x="10414" y="29845"/>
                  </a:moveTo>
                  <a:lnTo>
                    <a:pt x="0" y="29845"/>
                  </a:lnTo>
                  <a:lnTo>
                    <a:pt x="0" y="59817"/>
                  </a:lnTo>
                  <a:lnTo>
                    <a:pt x="10414" y="59817"/>
                  </a:lnTo>
                  <a:lnTo>
                    <a:pt x="10414" y="29845"/>
                  </a:lnTo>
                  <a:close/>
                </a:path>
                <a:path w="243205" h="60325">
                  <a:moveTo>
                    <a:pt x="68440" y="0"/>
                  </a:moveTo>
                  <a:lnTo>
                    <a:pt x="58039" y="0"/>
                  </a:lnTo>
                  <a:lnTo>
                    <a:pt x="58039" y="59817"/>
                  </a:lnTo>
                  <a:lnTo>
                    <a:pt x="68440" y="59817"/>
                  </a:lnTo>
                  <a:lnTo>
                    <a:pt x="68440" y="0"/>
                  </a:lnTo>
                  <a:close/>
                </a:path>
                <a:path w="243205" h="60325">
                  <a:moveTo>
                    <a:pt x="126619" y="29845"/>
                  </a:moveTo>
                  <a:lnTo>
                    <a:pt x="116205" y="29845"/>
                  </a:lnTo>
                  <a:lnTo>
                    <a:pt x="116205" y="59817"/>
                  </a:lnTo>
                  <a:lnTo>
                    <a:pt x="126619" y="59817"/>
                  </a:lnTo>
                  <a:lnTo>
                    <a:pt x="126619" y="29845"/>
                  </a:lnTo>
                  <a:close/>
                </a:path>
                <a:path w="243205" h="60325">
                  <a:moveTo>
                    <a:pt x="184658" y="29845"/>
                  </a:moveTo>
                  <a:lnTo>
                    <a:pt x="174244" y="29845"/>
                  </a:lnTo>
                  <a:lnTo>
                    <a:pt x="174244" y="59817"/>
                  </a:lnTo>
                  <a:lnTo>
                    <a:pt x="184658" y="59817"/>
                  </a:lnTo>
                  <a:lnTo>
                    <a:pt x="184658" y="29845"/>
                  </a:lnTo>
                  <a:close/>
                </a:path>
                <a:path w="243205" h="60325">
                  <a:moveTo>
                    <a:pt x="242684" y="29845"/>
                  </a:moveTo>
                  <a:lnTo>
                    <a:pt x="232283" y="29845"/>
                  </a:lnTo>
                  <a:lnTo>
                    <a:pt x="232283" y="59817"/>
                  </a:lnTo>
                  <a:lnTo>
                    <a:pt x="242684" y="59817"/>
                  </a:lnTo>
                  <a:lnTo>
                    <a:pt x="242684" y="29845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9" name="object 109" descr=""/>
            <p:cNvSpPr/>
            <p:nvPr/>
          </p:nvSpPr>
          <p:spPr>
            <a:xfrm>
              <a:off x="14341856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0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0" name="object 110" descr=""/>
            <p:cNvSpPr/>
            <p:nvPr/>
          </p:nvSpPr>
          <p:spPr>
            <a:xfrm>
              <a:off x="14457934" y="8572627"/>
              <a:ext cx="942340" cy="90170"/>
            </a:xfrm>
            <a:custGeom>
              <a:avLst/>
              <a:gdLst/>
              <a:ahLst/>
              <a:cxnLst/>
              <a:rect l="l" t="t" r="r" b="b"/>
              <a:pathLst>
                <a:path w="942340" h="90170">
                  <a:moveTo>
                    <a:pt x="13081" y="59817"/>
                  </a:moveTo>
                  <a:lnTo>
                    <a:pt x="0" y="59817"/>
                  </a:lnTo>
                  <a:lnTo>
                    <a:pt x="0" y="89789"/>
                  </a:lnTo>
                  <a:lnTo>
                    <a:pt x="13081" y="89789"/>
                  </a:lnTo>
                  <a:lnTo>
                    <a:pt x="13081" y="59817"/>
                  </a:lnTo>
                  <a:close/>
                </a:path>
                <a:path w="942340" h="90170">
                  <a:moveTo>
                    <a:pt x="60566" y="59817"/>
                  </a:moveTo>
                  <a:lnTo>
                    <a:pt x="50165" y="59817"/>
                  </a:lnTo>
                  <a:lnTo>
                    <a:pt x="50165" y="89789"/>
                  </a:lnTo>
                  <a:lnTo>
                    <a:pt x="60566" y="89789"/>
                  </a:lnTo>
                  <a:lnTo>
                    <a:pt x="60566" y="59817"/>
                  </a:lnTo>
                  <a:close/>
                </a:path>
                <a:path w="942340" h="90170">
                  <a:moveTo>
                    <a:pt x="118618" y="0"/>
                  </a:moveTo>
                  <a:lnTo>
                    <a:pt x="108204" y="0"/>
                  </a:lnTo>
                  <a:lnTo>
                    <a:pt x="108204" y="89789"/>
                  </a:lnTo>
                  <a:lnTo>
                    <a:pt x="118618" y="89789"/>
                  </a:lnTo>
                  <a:lnTo>
                    <a:pt x="118618" y="0"/>
                  </a:lnTo>
                  <a:close/>
                </a:path>
                <a:path w="942340" h="90170">
                  <a:moveTo>
                    <a:pt x="292862" y="59817"/>
                  </a:moveTo>
                  <a:lnTo>
                    <a:pt x="282448" y="59817"/>
                  </a:lnTo>
                  <a:lnTo>
                    <a:pt x="282448" y="89789"/>
                  </a:lnTo>
                  <a:lnTo>
                    <a:pt x="292862" y="89789"/>
                  </a:lnTo>
                  <a:lnTo>
                    <a:pt x="292862" y="59817"/>
                  </a:lnTo>
                  <a:close/>
                </a:path>
                <a:path w="942340" h="90170">
                  <a:moveTo>
                    <a:pt x="361315" y="59817"/>
                  </a:moveTo>
                  <a:lnTo>
                    <a:pt x="348234" y="59817"/>
                  </a:lnTo>
                  <a:lnTo>
                    <a:pt x="348234" y="89789"/>
                  </a:lnTo>
                  <a:lnTo>
                    <a:pt x="361315" y="89789"/>
                  </a:lnTo>
                  <a:lnTo>
                    <a:pt x="361315" y="59817"/>
                  </a:lnTo>
                  <a:close/>
                </a:path>
                <a:path w="942340" h="90170">
                  <a:moveTo>
                    <a:pt x="408940" y="0"/>
                  </a:moveTo>
                  <a:lnTo>
                    <a:pt x="398526" y="0"/>
                  </a:lnTo>
                  <a:lnTo>
                    <a:pt x="398526" y="89789"/>
                  </a:lnTo>
                  <a:lnTo>
                    <a:pt x="408940" y="89789"/>
                  </a:lnTo>
                  <a:lnTo>
                    <a:pt x="408940" y="0"/>
                  </a:lnTo>
                  <a:close/>
                </a:path>
                <a:path w="942340" h="90170">
                  <a:moveTo>
                    <a:pt x="535559" y="59817"/>
                  </a:moveTo>
                  <a:lnTo>
                    <a:pt x="522478" y="59817"/>
                  </a:lnTo>
                  <a:lnTo>
                    <a:pt x="522478" y="89789"/>
                  </a:lnTo>
                  <a:lnTo>
                    <a:pt x="535559" y="89789"/>
                  </a:lnTo>
                  <a:lnTo>
                    <a:pt x="535559" y="59817"/>
                  </a:lnTo>
                  <a:close/>
                </a:path>
                <a:path w="942340" h="90170">
                  <a:moveTo>
                    <a:pt x="593598" y="59817"/>
                  </a:moveTo>
                  <a:lnTo>
                    <a:pt x="580517" y="59817"/>
                  </a:lnTo>
                  <a:lnTo>
                    <a:pt x="580517" y="89789"/>
                  </a:lnTo>
                  <a:lnTo>
                    <a:pt x="593598" y="89789"/>
                  </a:lnTo>
                  <a:lnTo>
                    <a:pt x="593598" y="59817"/>
                  </a:lnTo>
                  <a:close/>
                </a:path>
                <a:path w="942340" h="90170">
                  <a:moveTo>
                    <a:pt x="651624" y="29972"/>
                  </a:moveTo>
                  <a:lnTo>
                    <a:pt x="634238" y="29972"/>
                  </a:lnTo>
                  <a:lnTo>
                    <a:pt x="634238" y="89789"/>
                  </a:lnTo>
                  <a:lnTo>
                    <a:pt x="651624" y="89789"/>
                  </a:lnTo>
                  <a:lnTo>
                    <a:pt x="651624" y="29972"/>
                  </a:lnTo>
                  <a:close/>
                </a:path>
                <a:path w="942340" h="90170">
                  <a:moveTo>
                    <a:pt x="709676" y="59817"/>
                  </a:moveTo>
                  <a:lnTo>
                    <a:pt x="696595" y="59817"/>
                  </a:lnTo>
                  <a:lnTo>
                    <a:pt x="696595" y="89789"/>
                  </a:lnTo>
                  <a:lnTo>
                    <a:pt x="709676" y="89789"/>
                  </a:lnTo>
                  <a:lnTo>
                    <a:pt x="709676" y="59817"/>
                  </a:lnTo>
                  <a:close/>
                </a:path>
                <a:path w="942340" h="90170">
                  <a:moveTo>
                    <a:pt x="767715" y="29972"/>
                  </a:moveTo>
                  <a:lnTo>
                    <a:pt x="754634" y="29972"/>
                  </a:lnTo>
                  <a:lnTo>
                    <a:pt x="754634" y="89789"/>
                  </a:lnTo>
                  <a:lnTo>
                    <a:pt x="767715" y="89789"/>
                  </a:lnTo>
                  <a:lnTo>
                    <a:pt x="767715" y="29972"/>
                  </a:lnTo>
                  <a:close/>
                </a:path>
                <a:path w="942340" h="90170">
                  <a:moveTo>
                    <a:pt x="883793" y="59817"/>
                  </a:moveTo>
                  <a:lnTo>
                    <a:pt x="870712" y="59817"/>
                  </a:lnTo>
                  <a:lnTo>
                    <a:pt x="870712" y="89789"/>
                  </a:lnTo>
                  <a:lnTo>
                    <a:pt x="883793" y="89789"/>
                  </a:lnTo>
                  <a:lnTo>
                    <a:pt x="883793" y="59817"/>
                  </a:lnTo>
                  <a:close/>
                </a:path>
                <a:path w="942340" h="90170">
                  <a:moveTo>
                    <a:pt x="941959" y="59817"/>
                  </a:moveTo>
                  <a:lnTo>
                    <a:pt x="928878" y="59817"/>
                  </a:lnTo>
                  <a:lnTo>
                    <a:pt x="928878" y="89789"/>
                  </a:lnTo>
                  <a:lnTo>
                    <a:pt x="941959" y="89789"/>
                  </a:lnTo>
                  <a:lnTo>
                    <a:pt x="941959" y="59817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1" name="object 111" descr=""/>
            <p:cNvSpPr/>
            <p:nvPr/>
          </p:nvSpPr>
          <p:spPr>
            <a:xfrm>
              <a:off x="1163828" y="7854696"/>
              <a:ext cx="4076700" cy="807720"/>
            </a:xfrm>
            <a:custGeom>
              <a:avLst/>
              <a:gdLst/>
              <a:ahLst/>
              <a:cxnLst/>
              <a:rect l="l" t="t" r="r" b="b"/>
              <a:pathLst>
                <a:path w="4076700" h="807720">
                  <a:moveTo>
                    <a:pt x="13081" y="777748"/>
                  </a:moveTo>
                  <a:lnTo>
                    <a:pt x="0" y="777748"/>
                  </a:lnTo>
                  <a:lnTo>
                    <a:pt x="0" y="807720"/>
                  </a:lnTo>
                  <a:lnTo>
                    <a:pt x="13081" y="807720"/>
                  </a:lnTo>
                  <a:lnTo>
                    <a:pt x="13081" y="777748"/>
                  </a:lnTo>
                  <a:close/>
                </a:path>
                <a:path w="4076700" h="807720">
                  <a:moveTo>
                    <a:pt x="71120" y="717931"/>
                  </a:moveTo>
                  <a:lnTo>
                    <a:pt x="58039" y="717931"/>
                  </a:lnTo>
                  <a:lnTo>
                    <a:pt x="58039" y="807720"/>
                  </a:lnTo>
                  <a:lnTo>
                    <a:pt x="71120" y="807720"/>
                  </a:lnTo>
                  <a:lnTo>
                    <a:pt x="71120" y="717931"/>
                  </a:lnTo>
                  <a:close/>
                </a:path>
                <a:path w="4076700" h="807720">
                  <a:moveTo>
                    <a:pt x="129286" y="717931"/>
                  </a:moveTo>
                  <a:lnTo>
                    <a:pt x="116205" y="717931"/>
                  </a:lnTo>
                  <a:lnTo>
                    <a:pt x="116205" y="807720"/>
                  </a:lnTo>
                  <a:lnTo>
                    <a:pt x="129286" y="807720"/>
                  </a:lnTo>
                  <a:lnTo>
                    <a:pt x="129286" y="717931"/>
                  </a:lnTo>
                  <a:close/>
                </a:path>
                <a:path w="4076700" h="807720">
                  <a:moveTo>
                    <a:pt x="187325" y="598297"/>
                  </a:moveTo>
                  <a:lnTo>
                    <a:pt x="174244" y="598297"/>
                  </a:lnTo>
                  <a:lnTo>
                    <a:pt x="174244" y="807720"/>
                  </a:lnTo>
                  <a:lnTo>
                    <a:pt x="187325" y="807720"/>
                  </a:lnTo>
                  <a:lnTo>
                    <a:pt x="187325" y="598297"/>
                  </a:lnTo>
                  <a:close/>
                </a:path>
                <a:path w="4076700" h="807720">
                  <a:moveTo>
                    <a:pt x="245364" y="628269"/>
                  </a:moveTo>
                  <a:lnTo>
                    <a:pt x="232283" y="628269"/>
                  </a:lnTo>
                  <a:lnTo>
                    <a:pt x="232283" y="807720"/>
                  </a:lnTo>
                  <a:lnTo>
                    <a:pt x="245364" y="807720"/>
                  </a:lnTo>
                  <a:lnTo>
                    <a:pt x="245364" y="628269"/>
                  </a:lnTo>
                  <a:close/>
                </a:path>
                <a:path w="4076700" h="807720">
                  <a:moveTo>
                    <a:pt x="303403" y="628269"/>
                  </a:moveTo>
                  <a:lnTo>
                    <a:pt x="290322" y="628269"/>
                  </a:lnTo>
                  <a:lnTo>
                    <a:pt x="290322" y="807720"/>
                  </a:lnTo>
                  <a:lnTo>
                    <a:pt x="303403" y="807720"/>
                  </a:lnTo>
                  <a:lnTo>
                    <a:pt x="303403" y="628269"/>
                  </a:lnTo>
                  <a:close/>
                </a:path>
                <a:path w="4076700" h="807720">
                  <a:moveTo>
                    <a:pt x="361442" y="448818"/>
                  </a:moveTo>
                  <a:lnTo>
                    <a:pt x="348361" y="448818"/>
                  </a:lnTo>
                  <a:lnTo>
                    <a:pt x="348361" y="807720"/>
                  </a:lnTo>
                  <a:lnTo>
                    <a:pt x="361442" y="807720"/>
                  </a:lnTo>
                  <a:lnTo>
                    <a:pt x="361442" y="448818"/>
                  </a:lnTo>
                  <a:close/>
                </a:path>
                <a:path w="4076700" h="807720">
                  <a:moveTo>
                    <a:pt x="419468" y="538480"/>
                  </a:moveTo>
                  <a:lnTo>
                    <a:pt x="409067" y="538480"/>
                  </a:lnTo>
                  <a:lnTo>
                    <a:pt x="409067" y="807720"/>
                  </a:lnTo>
                  <a:lnTo>
                    <a:pt x="419468" y="807720"/>
                  </a:lnTo>
                  <a:lnTo>
                    <a:pt x="419468" y="538480"/>
                  </a:lnTo>
                  <a:close/>
                </a:path>
                <a:path w="4076700" h="807720">
                  <a:moveTo>
                    <a:pt x="477520" y="329057"/>
                  </a:moveTo>
                  <a:lnTo>
                    <a:pt x="464439" y="329057"/>
                  </a:lnTo>
                  <a:lnTo>
                    <a:pt x="464439" y="807720"/>
                  </a:lnTo>
                  <a:lnTo>
                    <a:pt x="477520" y="807720"/>
                  </a:lnTo>
                  <a:lnTo>
                    <a:pt x="477520" y="329057"/>
                  </a:lnTo>
                  <a:close/>
                </a:path>
                <a:path w="4076700" h="807720">
                  <a:moveTo>
                    <a:pt x="535559" y="598297"/>
                  </a:moveTo>
                  <a:lnTo>
                    <a:pt x="525145" y="598297"/>
                  </a:lnTo>
                  <a:lnTo>
                    <a:pt x="525145" y="807720"/>
                  </a:lnTo>
                  <a:lnTo>
                    <a:pt x="535559" y="807720"/>
                  </a:lnTo>
                  <a:lnTo>
                    <a:pt x="535559" y="598297"/>
                  </a:lnTo>
                  <a:close/>
                </a:path>
                <a:path w="4076700" h="807720">
                  <a:moveTo>
                    <a:pt x="593598" y="628269"/>
                  </a:moveTo>
                  <a:lnTo>
                    <a:pt x="583184" y="628269"/>
                  </a:lnTo>
                  <a:lnTo>
                    <a:pt x="583184" y="807720"/>
                  </a:lnTo>
                  <a:lnTo>
                    <a:pt x="593598" y="807720"/>
                  </a:lnTo>
                  <a:lnTo>
                    <a:pt x="593598" y="628269"/>
                  </a:lnTo>
                  <a:close/>
                </a:path>
                <a:path w="4076700" h="807720">
                  <a:moveTo>
                    <a:pt x="651637" y="508635"/>
                  </a:moveTo>
                  <a:lnTo>
                    <a:pt x="641223" y="508635"/>
                  </a:lnTo>
                  <a:lnTo>
                    <a:pt x="641223" y="807720"/>
                  </a:lnTo>
                  <a:lnTo>
                    <a:pt x="651637" y="807720"/>
                  </a:lnTo>
                  <a:lnTo>
                    <a:pt x="651637" y="508635"/>
                  </a:lnTo>
                  <a:close/>
                </a:path>
                <a:path w="4076700" h="807720">
                  <a:moveTo>
                    <a:pt x="709663" y="269240"/>
                  </a:moveTo>
                  <a:lnTo>
                    <a:pt x="699262" y="269240"/>
                  </a:lnTo>
                  <a:lnTo>
                    <a:pt x="699262" y="807720"/>
                  </a:lnTo>
                  <a:lnTo>
                    <a:pt x="709663" y="807720"/>
                  </a:lnTo>
                  <a:lnTo>
                    <a:pt x="709663" y="269240"/>
                  </a:lnTo>
                  <a:close/>
                </a:path>
                <a:path w="4076700" h="807720">
                  <a:moveTo>
                    <a:pt x="767715" y="508635"/>
                  </a:moveTo>
                  <a:lnTo>
                    <a:pt x="757301" y="508635"/>
                  </a:lnTo>
                  <a:lnTo>
                    <a:pt x="757301" y="807720"/>
                  </a:lnTo>
                  <a:lnTo>
                    <a:pt x="767715" y="807720"/>
                  </a:lnTo>
                  <a:lnTo>
                    <a:pt x="767715" y="508635"/>
                  </a:lnTo>
                  <a:close/>
                </a:path>
                <a:path w="4076700" h="807720">
                  <a:moveTo>
                    <a:pt x="825754" y="89789"/>
                  </a:moveTo>
                  <a:lnTo>
                    <a:pt x="815340" y="89789"/>
                  </a:lnTo>
                  <a:lnTo>
                    <a:pt x="815340" y="807720"/>
                  </a:lnTo>
                  <a:lnTo>
                    <a:pt x="825754" y="807720"/>
                  </a:lnTo>
                  <a:lnTo>
                    <a:pt x="825754" y="89789"/>
                  </a:lnTo>
                  <a:close/>
                </a:path>
                <a:path w="4076700" h="807720">
                  <a:moveTo>
                    <a:pt x="883907" y="269240"/>
                  </a:moveTo>
                  <a:lnTo>
                    <a:pt x="873506" y="269240"/>
                  </a:lnTo>
                  <a:lnTo>
                    <a:pt x="873506" y="807720"/>
                  </a:lnTo>
                  <a:lnTo>
                    <a:pt x="883907" y="807720"/>
                  </a:lnTo>
                  <a:lnTo>
                    <a:pt x="883907" y="269240"/>
                  </a:lnTo>
                  <a:close/>
                </a:path>
                <a:path w="4076700" h="807720">
                  <a:moveTo>
                    <a:pt x="941959" y="329057"/>
                  </a:moveTo>
                  <a:lnTo>
                    <a:pt x="931545" y="329057"/>
                  </a:lnTo>
                  <a:lnTo>
                    <a:pt x="931545" y="807720"/>
                  </a:lnTo>
                  <a:lnTo>
                    <a:pt x="941959" y="807720"/>
                  </a:lnTo>
                  <a:lnTo>
                    <a:pt x="941959" y="329057"/>
                  </a:lnTo>
                  <a:close/>
                </a:path>
                <a:path w="4076700" h="807720">
                  <a:moveTo>
                    <a:pt x="999998" y="448818"/>
                  </a:moveTo>
                  <a:lnTo>
                    <a:pt x="989584" y="448818"/>
                  </a:lnTo>
                  <a:lnTo>
                    <a:pt x="989584" y="807720"/>
                  </a:lnTo>
                  <a:lnTo>
                    <a:pt x="999998" y="807720"/>
                  </a:lnTo>
                  <a:lnTo>
                    <a:pt x="999998" y="448818"/>
                  </a:lnTo>
                  <a:close/>
                </a:path>
                <a:path w="4076700" h="807720">
                  <a:moveTo>
                    <a:pt x="1058037" y="209423"/>
                  </a:moveTo>
                  <a:lnTo>
                    <a:pt x="1047623" y="209423"/>
                  </a:lnTo>
                  <a:lnTo>
                    <a:pt x="1047623" y="807720"/>
                  </a:lnTo>
                  <a:lnTo>
                    <a:pt x="1058037" y="807720"/>
                  </a:lnTo>
                  <a:lnTo>
                    <a:pt x="1058037" y="209423"/>
                  </a:lnTo>
                  <a:close/>
                </a:path>
                <a:path w="4076700" h="807720">
                  <a:moveTo>
                    <a:pt x="1116063" y="149606"/>
                  </a:moveTo>
                  <a:lnTo>
                    <a:pt x="1105662" y="149606"/>
                  </a:lnTo>
                  <a:lnTo>
                    <a:pt x="1105662" y="807720"/>
                  </a:lnTo>
                  <a:lnTo>
                    <a:pt x="1116063" y="807720"/>
                  </a:lnTo>
                  <a:lnTo>
                    <a:pt x="1116063" y="149606"/>
                  </a:lnTo>
                  <a:close/>
                </a:path>
                <a:path w="4076700" h="807720">
                  <a:moveTo>
                    <a:pt x="1174115" y="299212"/>
                  </a:moveTo>
                  <a:lnTo>
                    <a:pt x="1163701" y="299212"/>
                  </a:lnTo>
                  <a:lnTo>
                    <a:pt x="1163701" y="807720"/>
                  </a:lnTo>
                  <a:lnTo>
                    <a:pt x="1174115" y="807720"/>
                  </a:lnTo>
                  <a:lnTo>
                    <a:pt x="1174115" y="299212"/>
                  </a:lnTo>
                  <a:close/>
                </a:path>
                <a:path w="4076700" h="807720">
                  <a:moveTo>
                    <a:pt x="1232154" y="359029"/>
                  </a:moveTo>
                  <a:lnTo>
                    <a:pt x="1221740" y="359029"/>
                  </a:lnTo>
                  <a:lnTo>
                    <a:pt x="1221740" y="807720"/>
                  </a:lnTo>
                  <a:lnTo>
                    <a:pt x="1232154" y="807720"/>
                  </a:lnTo>
                  <a:lnTo>
                    <a:pt x="1232154" y="359029"/>
                  </a:lnTo>
                  <a:close/>
                </a:path>
                <a:path w="4076700" h="807720">
                  <a:moveTo>
                    <a:pt x="1290193" y="329057"/>
                  </a:moveTo>
                  <a:lnTo>
                    <a:pt x="1279779" y="329057"/>
                  </a:lnTo>
                  <a:lnTo>
                    <a:pt x="1279779" y="807720"/>
                  </a:lnTo>
                  <a:lnTo>
                    <a:pt x="1290193" y="807720"/>
                  </a:lnTo>
                  <a:lnTo>
                    <a:pt x="1290193" y="329057"/>
                  </a:lnTo>
                  <a:close/>
                </a:path>
                <a:path w="4076700" h="807720">
                  <a:moveTo>
                    <a:pt x="1348219" y="299212"/>
                  </a:moveTo>
                  <a:lnTo>
                    <a:pt x="1337818" y="299212"/>
                  </a:lnTo>
                  <a:lnTo>
                    <a:pt x="1337818" y="807720"/>
                  </a:lnTo>
                  <a:lnTo>
                    <a:pt x="1348219" y="807720"/>
                  </a:lnTo>
                  <a:lnTo>
                    <a:pt x="1348219" y="299212"/>
                  </a:lnTo>
                  <a:close/>
                </a:path>
                <a:path w="4076700" h="807720">
                  <a:moveTo>
                    <a:pt x="1406271" y="329057"/>
                  </a:moveTo>
                  <a:lnTo>
                    <a:pt x="1395857" y="329057"/>
                  </a:lnTo>
                  <a:lnTo>
                    <a:pt x="1395857" y="807720"/>
                  </a:lnTo>
                  <a:lnTo>
                    <a:pt x="1406271" y="807720"/>
                  </a:lnTo>
                  <a:lnTo>
                    <a:pt x="1406271" y="329057"/>
                  </a:lnTo>
                  <a:close/>
                </a:path>
                <a:path w="4076700" h="807720">
                  <a:moveTo>
                    <a:pt x="1464437" y="0"/>
                  </a:moveTo>
                  <a:lnTo>
                    <a:pt x="1454023" y="0"/>
                  </a:lnTo>
                  <a:lnTo>
                    <a:pt x="1454023" y="807720"/>
                  </a:lnTo>
                  <a:lnTo>
                    <a:pt x="1464437" y="807720"/>
                  </a:lnTo>
                  <a:lnTo>
                    <a:pt x="1464437" y="0"/>
                  </a:lnTo>
                  <a:close/>
                </a:path>
                <a:path w="4076700" h="807720">
                  <a:moveTo>
                    <a:pt x="1522463" y="299212"/>
                  </a:moveTo>
                  <a:lnTo>
                    <a:pt x="1512062" y="299212"/>
                  </a:lnTo>
                  <a:lnTo>
                    <a:pt x="1512062" y="807720"/>
                  </a:lnTo>
                  <a:lnTo>
                    <a:pt x="1522463" y="807720"/>
                  </a:lnTo>
                  <a:lnTo>
                    <a:pt x="1522463" y="299212"/>
                  </a:lnTo>
                  <a:close/>
                </a:path>
                <a:path w="4076700" h="807720">
                  <a:moveTo>
                    <a:pt x="1580515" y="448818"/>
                  </a:moveTo>
                  <a:lnTo>
                    <a:pt x="1570101" y="448818"/>
                  </a:lnTo>
                  <a:lnTo>
                    <a:pt x="1570101" y="807720"/>
                  </a:lnTo>
                  <a:lnTo>
                    <a:pt x="1580515" y="807720"/>
                  </a:lnTo>
                  <a:lnTo>
                    <a:pt x="1580515" y="448818"/>
                  </a:lnTo>
                  <a:close/>
                </a:path>
                <a:path w="4076700" h="807720">
                  <a:moveTo>
                    <a:pt x="1638554" y="508635"/>
                  </a:moveTo>
                  <a:lnTo>
                    <a:pt x="1628140" y="508635"/>
                  </a:lnTo>
                  <a:lnTo>
                    <a:pt x="1628140" y="807720"/>
                  </a:lnTo>
                  <a:lnTo>
                    <a:pt x="1638554" y="807720"/>
                  </a:lnTo>
                  <a:lnTo>
                    <a:pt x="1638554" y="508635"/>
                  </a:lnTo>
                  <a:close/>
                </a:path>
                <a:path w="4076700" h="807720">
                  <a:moveTo>
                    <a:pt x="1696593" y="239395"/>
                  </a:moveTo>
                  <a:lnTo>
                    <a:pt x="1686179" y="239395"/>
                  </a:lnTo>
                  <a:lnTo>
                    <a:pt x="1686179" y="807720"/>
                  </a:lnTo>
                  <a:lnTo>
                    <a:pt x="1696593" y="807720"/>
                  </a:lnTo>
                  <a:lnTo>
                    <a:pt x="1696593" y="239395"/>
                  </a:lnTo>
                  <a:close/>
                </a:path>
                <a:path w="4076700" h="807720">
                  <a:moveTo>
                    <a:pt x="1754619" y="299212"/>
                  </a:moveTo>
                  <a:lnTo>
                    <a:pt x="1744218" y="299212"/>
                  </a:lnTo>
                  <a:lnTo>
                    <a:pt x="1744218" y="807720"/>
                  </a:lnTo>
                  <a:lnTo>
                    <a:pt x="1754619" y="807720"/>
                  </a:lnTo>
                  <a:lnTo>
                    <a:pt x="1754619" y="299212"/>
                  </a:lnTo>
                  <a:close/>
                </a:path>
                <a:path w="4076700" h="807720">
                  <a:moveTo>
                    <a:pt x="1812671" y="119761"/>
                  </a:moveTo>
                  <a:lnTo>
                    <a:pt x="1802257" y="119761"/>
                  </a:lnTo>
                  <a:lnTo>
                    <a:pt x="1802257" y="807720"/>
                  </a:lnTo>
                  <a:lnTo>
                    <a:pt x="1812671" y="807720"/>
                  </a:lnTo>
                  <a:lnTo>
                    <a:pt x="1812671" y="119761"/>
                  </a:lnTo>
                  <a:close/>
                </a:path>
                <a:path w="4076700" h="807720">
                  <a:moveTo>
                    <a:pt x="1870710" y="149606"/>
                  </a:moveTo>
                  <a:lnTo>
                    <a:pt x="1860296" y="149606"/>
                  </a:lnTo>
                  <a:lnTo>
                    <a:pt x="1860296" y="807720"/>
                  </a:lnTo>
                  <a:lnTo>
                    <a:pt x="1870710" y="807720"/>
                  </a:lnTo>
                  <a:lnTo>
                    <a:pt x="1870710" y="149606"/>
                  </a:lnTo>
                  <a:close/>
                </a:path>
                <a:path w="4076700" h="807720">
                  <a:moveTo>
                    <a:pt x="1928749" y="329057"/>
                  </a:moveTo>
                  <a:lnTo>
                    <a:pt x="1918335" y="329057"/>
                  </a:lnTo>
                  <a:lnTo>
                    <a:pt x="1918335" y="807720"/>
                  </a:lnTo>
                  <a:lnTo>
                    <a:pt x="1928749" y="807720"/>
                  </a:lnTo>
                  <a:lnTo>
                    <a:pt x="1928749" y="329057"/>
                  </a:lnTo>
                  <a:close/>
                </a:path>
                <a:path w="4076700" h="807720">
                  <a:moveTo>
                    <a:pt x="1986915" y="359029"/>
                  </a:moveTo>
                  <a:lnTo>
                    <a:pt x="1976501" y="359029"/>
                  </a:lnTo>
                  <a:lnTo>
                    <a:pt x="1976501" y="807720"/>
                  </a:lnTo>
                  <a:lnTo>
                    <a:pt x="1986915" y="807720"/>
                  </a:lnTo>
                  <a:lnTo>
                    <a:pt x="1986915" y="359029"/>
                  </a:lnTo>
                  <a:close/>
                </a:path>
                <a:path w="4076700" h="807720">
                  <a:moveTo>
                    <a:pt x="2044954" y="329057"/>
                  </a:moveTo>
                  <a:lnTo>
                    <a:pt x="2034540" y="329057"/>
                  </a:lnTo>
                  <a:lnTo>
                    <a:pt x="2034540" y="807720"/>
                  </a:lnTo>
                  <a:lnTo>
                    <a:pt x="2044954" y="807720"/>
                  </a:lnTo>
                  <a:lnTo>
                    <a:pt x="2044954" y="329057"/>
                  </a:lnTo>
                  <a:close/>
                </a:path>
                <a:path w="4076700" h="807720">
                  <a:moveTo>
                    <a:pt x="2102993" y="568452"/>
                  </a:moveTo>
                  <a:lnTo>
                    <a:pt x="2092579" y="568452"/>
                  </a:lnTo>
                  <a:lnTo>
                    <a:pt x="2092579" y="807720"/>
                  </a:lnTo>
                  <a:lnTo>
                    <a:pt x="2102993" y="807720"/>
                  </a:lnTo>
                  <a:lnTo>
                    <a:pt x="2102993" y="568452"/>
                  </a:lnTo>
                  <a:close/>
                </a:path>
                <a:path w="4076700" h="807720">
                  <a:moveTo>
                    <a:pt x="2161032" y="568452"/>
                  </a:moveTo>
                  <a:lnTo>
                    <a:pt x="2150618" y="568452"/>
                  </a:lnTo>
                  <a:lnTo>
                    <a:pt x="2150618" y="807720"/>
                  </a:lnTo>
                  <a:lnTo>
                    <a:pt x="2161032" y="807720"/>
                  </a:lnTo>
                  <a:lnTo>
                    <a:pt x="2161032" y="568452"/>
                  </a:lnTo>
                  <a:close/>
                </a:path>
                <a:path w="4076700" h="807720">
                  <a:moveTo>
                    <a:pt x="2219071" y="388874"/>
                  </a:moveTo>
                  <a:lnTo>
                    <a:pt x="2208657" y="388874"/>
                  </a:lnTo>
                  <a:lnTo>
                    <a:pt x="2208657" y="807720"/>
                  </a:lnTo>
                  <a:lnTo>
                    <a:pt x="2219071" y="807720"/>
                  </a:lnTo>
                  <a:lnTo>
                    <a:pt x="2219071" y="388874"/>
                  </a:lnTo>
                  <a:close/>
                </a:path>
                <a:path w="4076700" h="807720">
                  <a:moveTo>
                    <a:pt x="2277110" y="239395"/>
                  </a:moveTo>
                  <a:lnTo>
                    <a:pt x="2266696" y="239395"/>
                  </a:lnTo>
                  <a:lnTo>
                    <a:pt x="2266696" y="807720"/>
                  </a:lnTo>
                  <a:lnTo>
                    <a:pt x="2277110" y="807720"/>
                  </a:lnTo>
                  <a:lnTo>
                    <a:pt x="2277110" y="239395"/>
                  </a:lnTo>
                  <a:close/>
                </a:path>
                <a:path w="4076700" h="807720">
                  <a:moveTo>
                    <a:pt x="2335149" y="299212"/>
                  </a:moveTo>
                  <a:lnTo>
                    <a:pt x="2324735" y="299212"/>
                  </a:lnTo>
                  <a:lnTo>
                    <a:pt x="2324735" y="807720"/>
                  </a:lnTo>
                  <a:lnTo>
                    <a:pt x="2335149" y="807720"/>
                  </a:lnTo>
                  <a:lnTo>
                    <a:pt x="2335149" y="299212"/>
                  </a:lnTo>
                  <a:close/>
                </a:path>
                <a:path w="4076700" h="807720">
                  <a:moveTo>
                    <a:pt x="2393188" y="209423"/>
                  </a:moveTo>
                  <a:lnTo>
                    <a:pt x="2382774" y="209423"/>
                  </a:lnTo>
                  <a:lnTo>
                    <a:pt x="2382774" y="807720"/>
                  </a:lnTo>
                  <a:lnTo>
                    <a:pt x="2393188" y="807720"/>
                  </a:lnTo>
                  <a:lnTo>
                    <a:pt x="2393188" y="209423"/>
                  </a:lnTo>
                  <a:close/>
                </a:path>
                <a:path w="4076700" h="807720">
                  <a:moveTo>
                    <a:pt x="2451227" y="568452"/>
                  </a:moveTo>
                  <a:lnTo>
                    <a:pt x="2440813" y="568452"/>
                  </a:lnTo>
                  <a:lnTo>
                    <a:pt x="2440813" y="807720"/>
                  </a:lnTo>
                  <a:lnTo>
                    <a:pt x="2451227" y="807720"/>
                  </a:lnTo>
                  <a:lnTo>
                    <a:pt x="2451227" y="568452"/>
                  </a:lnTo>
                  <a:close/>
                </a:path>
                <a:path w="4076700" h="807720">
                  <a:moveTo>
                    <a:pt x="2509393" y="508635"/>
                  </a:moveTo>
                  <a:lnTo>
                    <a:pt x="2498979" y="508635"/>
                  </a:lnTo>
                  <a:lnTo>
                    <a:pt x="2498979" y="807720"/>
                  </a:lnTo>
                  <a:lnTo>
                    <a:pt x="2509393" y="807720"/>
                  </a:lnTo>
                  <a:lnTo>
                    <a:pt x="2509393" y="508635"/>
                  </a:lnTo>
                  <a:close/>
                </a:path>
                <a:path w="4076700" h="807720">
                  <a:moveTo>
                    <a:pt x="2567432" y="329057"/>
                  </a:moveTo>
                  <a:lnTo>
                    <a:pt x="2557018" y="329057"/>
                  </a:lnTo>
                  <a:lnTo>
                    <a:pt x="2557018" y="807720"/>
                  </a:lnTo>
                  <a:lnTo>
                    <a:pt x="2567432" y="807720"/>
                  </a:lnTo>
                  <a:lnTo>
                    <a:pt x="2567432" y="329057"/>
                  </a:lnTo>
                  <a:close/>
                </a:path>
                <a:path w="4076700" h="807720">
                  <a:moveTo>
                    <a:pt x="2625471" y="568452"/>
                  </a:moveTo>
                  <a:lnTo>
                    <a:pt x="2615057" y="568452"/>
                  </a:lnTo>
                  <a:lnTo>
                    <a:pt x="2615057" y="807720"/>
                  </a:lnTo>
                  <a:lnTo>
                    <a:pt x="2625471" y="807720"/>
                  </a:lnTo>
                  <a:lnTo>
                    <a:pt x="2625471" y="568452"/>
                  </a:lnTo>
                  <a:close/>
                </a:path>
                <a:path w="4076700" h="807720">
                  <a:moveTo>
                    <a:pt x="2683510" y="418846"/>
                  </a:moveTo>
                  <a:lnTo>
                    <a:pt x="2673096" y="418846"/>
                  </a:lnTo>
                  <a:lnTo>
                    <a:pt x="2673096" y="807720"/>
                  </a:lnTo>
                  <a:lnTo>
                    <a:pt x="2683510" y="807720"/>
                  </a:lnTo>
                  <a:lnTo>
                    <a:pt x="2683510" y="418846"/>
                  </a:lnTo>
                  <a:close/>
                </a:path>
                <a:path w="4076700" h="807720">
                  <a:moveTo>
                    <a:pt x="2741549" y="418846"/>
                  </a:moveTo>
                  <a:lnTo>
                    <a:pt x="2731135" y="418846"/>
                  </a:lnTo>
                  <a:lnTo>
                    <a:pt x="2731135" y="807720"/>
                  </a:lnTo>
                  <a:lnTo>
                    <a:pt x="2741549" y="807720"/>
                  </a:lnTo>
                  <a:lnTo>
                    <a:pt x="2741549" y="418846"/>
                  </a:lnTo>
                  <a:close/>
                </a:path>
                <a:path w="4076700" h="807720">
                  <a:moveTo>
                    <a:pt x="2799588" y="448818"/>
                  </a:moveTo>
                  <a:lnTo>
                    <a:pt x="2789174" y="448818"/>
                  </a:lnTo>
                  <a:lnTo>
                    <a:pt x="2789174" y="807720"/>
                  </a:lnTo>
                  <a:lnTo>
                    <a:pt x="2799588" y="807720"/>
                  </a:lnTo>
                  <a:lnTo>
                    <a:pt x="2799588" y="448818"/>
                  </a:lnTo>
                  <a:close/>
                </a:path>
                <a:path w="4076700" h="807720">
                  <a:moveTo>
                    <a:pt x="2857627" y="239395"/>
                  </a:moveTo>
                  <a:lnTo>
                    <a:pt x="2847213" y="239395"/>
                  </a:lnTo>
                  <a:lnTo>
                    <a:pt x="2847213" y="807720"/>
                  </a:lnTo>
                  <a:lnTo>
                    <a:pt x="2857627" y="807720"/>
                  </a:lnTo>
                  <a:lnTo>
                    <a:pt x="2857627" y="239395"/>
                  </a:lnTo>
                  <a:close/>
                </a:path>
                <a:path w="4076700" h="807720">
                  <a:moveTo>
                    <a:pt x="2915653" y="329057"/>
                  </a:moveTo>
                  <a:lnTo>
                    <a:pt x="2905252" y="329057"/>
                  </a:lnTo>
                  <a:lnTo>
                    <a:pt x="2905252" y="807720"/>
                  </a:lnTo>
                  <a:lnTo>
                    <a:pt x="2915653" y="807720"/>
                  </a:lnTo>
                  <a:lnTo>
                    <a:pt x="2915653" y="329057"/>
                  </a:lnTo>
                  <a:close/>
                </a:path>
                <a:path w="4076700" h="807720">
                  <a:moveTo>
                    <a:pt x="2973705" y="239395"/>
                  </a:moveTo>
                  <a:lnTo>
                    <a:pt x="2963291" y="239395"/>
                  </a:lnTo>
                  <a:lnTo>
                    <a:pt x="2963291" y="807720"/>
                  </a:lnTo>
                  <a:lnTo>
                    <a:pt x="2973705" y="807720"/>
                  </a:lnTo>
                  <a:lnTo>
                    <a:pt x="2973705" y="239395"/>
                  </a:lnTo>
                  <a:close/>
                </a:path>
                <a:path w="4076700" h="807720">
                  <a:moveTo>
                    <a:pt x="3031744" y="299212"/>
                  </a:moveTo>
                  <a:lnTo>
                    <a:pt x="3021330" y="299212"/>
                  </a:lnTo>
                  <a:lnTo>
                    <a:pt x="3021330" y="807720"/>
                  </a:lnTo>
                  <a:lnTo>
                    <a:pt x="3031744" y="807720"/>
                  </a:lnTo>
                  <a:lnTo>
                    <a:pt x="3031744" y="299212"/>
                  </a:lnTo>
                  <a:close/>
                </a:path>
                <a:path w="4076700" h="807720">
                  <a:moveTo>
                    <a:pt x="3089910" y="538480"/>
                  </a:moveTo>
                  <a:lnTo>
                    <a:pt x="3079496" y="538480"/>
                  </a:lnTo>
                  <a:lnTo>
                    <a:pt x="3079496" y="807720"/>
                  </a:lnTo>
                  <a:lnTo>
                    <a:pt x="3089910" y="807720"/>
                  </a:lnTo>
                  <a:lnTo>
                    <a:pt x="3089910" y="538480"/>
                  </a:lnTo>
                  <a:close/>
                </a:path>
                <a:path w="4076700" h="807720">
                  <a:moveTo>
                    <a:pt x="3147949" y="478663"/>
                  </a:moveTo>
                  <a:lnTo>
                    <a:pt x="3137535" y="478663"/>
                  </a:lnTo>
                  <a:lnTo>
                    <a:pt x="3137535" y="807720"/>
                  </a:lnTo>
                  <a:lnTo>
                    <a:pt x="3147949" y="807720"/>
                  </a:lnTo>
                  <a:lnTo>
                    <a:pt x="3147949" y="478663"/>
                  </a:lnTo>
                  <a:close/>
                </a:path>
                <a:path w="4076700" h="807720">
                  <a:moveTo>
                    <a:pt x="3205988" y="359029"/>
                  </a:moveTo>
                  <a:lnTo>
                    <a:pt x="3195574" y="359029"/>
                  </a:lnTo>
                  <a:lnTo>
                    <a:pt x="3195574" y="807720"/>
                  </a:lnTo>
                  <a:lnTo>
                    <a:pt x="3205988" y="807720"/>
                  </a:lnTo>
                  <a:lnTo>
                    <a:pt x="3205988" y="359029"/>
                  </a:lnTo>
                  <a:close/>
                </a:path>
                <a:path w="4076700" h="807720">
                  <a:moveTo>
                    <a:pt x="3264027" y="388874"/>
                  </a:moveTo>
                  <a:lnTo>
                    <a:pt x="3253613" y="388874"/>
                  </a:lnTo>
                  <a:lnTo>
                    <a:pt x="3253613" y="807720"/>
                  </a:lnTo>
                  <a:lnTo>
                    <a:pt x="3264027" y="807720"/>
                  </a:lnTo>
                  <a:lnTo>
                    <a:pt x="3264027" y="388874"/>
                  </a:lnTo>
                  <a:close/>
                </a:path>
                <a:path w="4076700" h="807720">
                  <a:moveTo>
                    <a:pt x="3322053" y="508635"/>
                  </a:moveTo>
                  <a:lnTo>
                    <a:pt x="3311652" y="508635"/>
                  </a:lnTo>
                  <a:lnTo>
                    <a:pt x="3311652" y="807720"/>
                  </a:lnTo>
                  <a:lnTo>
                    <a:pt x="3322053" y="807720"/>
                  </a:lnTo>
                  <a:lnTo>
                    <a:pt x="3322053" y="508635"/>
                  </a:lnTo>
                  <a:close/>
                </a:path>
                <a:path w="4076700" h="807720">
                  <a:moveTo>
                    <a:pt x="3380105" y="299212"/>
                  </a:moveTo>
                  <a:lnTo>
                    <a:pt x="3369691" y="299212"/>
                  </a:lnTo>
                  <a:lnTo>
                    <a:pt x="3369691" y="807720"/>
                  </a:lnTo>
                  <a:lnTo>
                    <a:pt x="3380105" y="807720"/>
                  </a:lnTo>
                  <a:lnTo>
                    <a:pt x="3380105" y="299212"/>
                  </a:lnTo>
                  <a:close/>
                </a:path>
                <a:path w="4076700" h="807720">
                  <a:moveTo>
                    <a:pt x="3438144" y="359029"/>
                  </a:moveTo>
                  <a:lnTo>
                    <a:pt x="3427730" y="359029"/>
                  </a:lnTo>
                  <a:lnTo>
                    <a:pt x="3427730" y="807720"/>
                  </a:lnTo>
                  <a:lnTo>
                    <a:pt x="3438144" y="807720"/>
                  </a:lnTo>
                  <a:lnTo>
                    <a:pt x="3438144" y="359029"/>
                  </a:lnTo>
                  <a:close/>
                </a:path>
                <a:path w="4076700" h="807720">
                  <a:moveTo>
                    <a:pt x="3496183" y="329057"/>
                  </a:moveTo>
                  <a:lnTo>
                    <a:pt x="3485769" y="329057"/>
                  </a:lnTo>
                  <a:lnTo>
                    <a:pt x="3485769" y="807720"/>
                  </a:lnTo>
                  <a:lnTo>
                    <a:pt x="3496183" y="807720"/>
                  </a:lnTo>
                  <a:lnTo>
                    <a:pt x="3496183" y="329057"/>
                  </a:lnTo>
                  <a:close/>
                </a:path>
                <a:path w="4076700" h="807720">
                  <a:moveTo>
                    <a:pt x="3554222" y="179578"/>
                  </a:moveTo>
                  <a:lnTo>
                    <a:pt x="3543808" y="179578"/>
                  </a:lnTo>
                  <a:lnTo>
                    <a:pt x="3543808" y="807720"/>
                  </a:lnTo>
                  <a:lnTo>
                    <a:pt x="3554222" y="807720"/>
                  </a:lnTo>
                  <a:lnTo>
                    <a:pt x="3554222" y="179578"/>
                  </a:lnTo>
                  <a:close/>
                </a:path>
                <a:path w="4076700" h="807720">
                  <a:moveTo>
                    <a:pt x="3612388" y="628269"/>
                  </a:moveTo>
                  <a:lnTo>
                    <a:pt x="3601974" y="628269"/>
                  </a:lnTo>
                  <a:lnTo>
                    <a:pt x="3601974" y="807720"/>
                  </a:lnTo>
                  <a:lnTo>
                    <a:pt x="3612388" y="807720"/>
                  </a:lnTo>
                  <a:lnTo>
                    <a:pt x="3612388" y="628269"/>
                  </a:lnTo>
                  <a:close/>
                </a:path>
                <a:path w="4076700" h="807720">
                  <a:moveTo>
                    <a:pt x="3670427" y="209423"/>
                  </a:moveTo>
                  <a:lnTo>
                    <a:pt x="3660013" y="209423"/>
                  </a:lnTo>
                  <a:lnTo>
                    <a:pt x="3660013" y="807720"/>
                  </a:lnTo>
                  <a:lnTo>
                    <a:pt x="3670427" y="807720"/>
                  </a:lnTo>
                  <a:lnTo>
                    <a:pt x="3670427" y="209423"/>
                  </a:lnTo>
                  <a:close/>
                </a:path>
                <a:path w="4076700" h="807720">
                  <a:moveTo>
                    <a:pt x="3728453" y="538480"/>
                  </a:moveTo>
                  <a:lnTo>
                    <a:pt x="3718052" y="538480"/>
                  </a:lnTo>
                  <a:lnTo>
                    <a:pt x="3718052" y="807720"/>
                  </a:lnTo>
                  <a:lnTo>
                    <a:pt x="3728453" y="807720"/>
                  </a:lnTo>
                  <a:lnTo>
                    <a:pt x="3728453" y="538480"/>
                  </a:lnTo>
                  <a:close/>
                </a:path>
                <a:path w="4076700" h="807720">
                  <a:moveTo>
                    <a:pt x="3786505" y="568452"/>
                  </a:moveTo>
                  <a:lnTo>
                    <a:pt x="3776091" y="568452"/>
                  </a:lnTo>
                  <a:lnTo>
                    <a:pt x="3776091" y="807720"/>
                  </a:lnTo>
                  <a:lnTo>
                    <a:pt x="3786505" y="807720"/>
                  </a:lnTo>
                  <a:lnTo>
                    <a:pt x="3786505" y="568452"/>
                  </a:lnTo>
                  <a:close/>
                </a:path>
                <a:path w="4076700" h="807720">
                  <a:moveTo>
                    <a:pt x="3844544" y="388874"/>
                  </a:moveTo>
                  <a:lnTo>
                    <a:pt x="3834130" y="388874"/>
                  </a:lnTo>
                  <a:lnTo>
                    <a:pt x="3834130" y="807720"/>
                  </a:lnTo>
                  <a:lnTo>
                    <a:pt x="3844544" y="807720"/>
                  </a:lnTo>
                  <a:lnTo>
                    <a:pt x="3844544" y="388874"/>
                  </a:lnTo>
                  <a:close/>
                </a:path>
                <a:path w="4076700" h="807720">
                  <a:moveTo>
                    <a:pt x="3902583" y="299212"/>
                  </a:moveTo>
                  <a:lnTo>
                    <a:pt x="3892169" y="299212"/>
                  </a:lnTo>
                  <a:lnTo>
                    <a:pt x="3892169" y="807720"/>
                  </a:lnTo>
                  <a:lnTo>
                    <a:pt x="3902583" y="807720"/>
                  </a:lnTo>
                  <a:lnTo>
                    <a:pt x="3902583" y="299212"/>
                  </a:lnTo>
                  <a:close/>
                </a:path>
                <a:path w="4076700" h="807720">
                  <a:moveTo>
                    <a:pt x="3960622" y="448818"/>
                  </a:moveTo>
                  <a:lnTo>
                    <a:pt x="3950208" y="448818"/>
                  </a:lnTo>
                  <a:lnTo>
                    <a:pt x="3950208" y="807720"/>
                  </a:lnTo>
                  <a:lnTo>
                    <a:pt x="3960622" y="807720"/>
                  </a:lnTo>
                  <a:lnTo>
                    <a:pt x="3960622" y="448818"/>
                  </a:lnTo>
                  <a:close/>
                </a:path>
                <a:path w="4076700" h="807720">
                  <a:moveTo>
                    <a:pt x="4018661" y="448818"/>
                  </a:moveTo>
                  <a:lnTo>
                    <a:pt x="4008247" y="448818"/>
                  </a:lnTo>
                  <a:lnTo>
                    <a:pt x="4008247" y="807720"/>
                  </a:lnTo>
                  <a:lnTo>
                    <a:pt x="4018661" y="807720"/>
                  </a:lnTo>
                  <a:lnTo>
                    <a:pt x="4018661" y="448818"/>
                  </a:lnTo>
                  <a:close/>
                </a:path>
                <a:path w="4076700" h="807720">
                  <a:moveTo>
                    <a:pt x="4076700" y="388874"/>
                  </a:moveTo>
                  <a:lnTo>
                    <a:pt x="4066286" y="388874"/>
                  </a:lnTo>
                  <a:lnTo>
                    <a:pt x="4066286" y="807720"/>
                  </a:lnTo>
                  <a:lnTo>
                    <a:pt x="4076700" y="807720"/>
                  </a:lnTo>
                  <a:lnTo>
                    <a:pt x="4076700" y="388874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2" name="object 112" descr=""/>
            <p:cNvSpPr/>
            <p:nvPr/>
          </p:nvSpPr>
          <p:spPr>
            <a:xfrm>
              <a:off x="5230114" y="7854696"/>
              <a:ext cx="4074160" cy="807720"/>
            </a:xfrm>
            <a:custGeom>
              <a:avLst/>
              <a:gdLst/>
              <a:ahLst/>
              <a:cxnLst/>
              <a:rect l="l" t="t" r="r" b="b"/>
              <a:pathLst>
                <a:path w="4074159" h="807720">
                  <a:moveTo>
                    <a:pt x="10414" y="388874"/>
                  </a:moveTo>
                  <a:lnTo>
                    <a:pt x="0" y="388874"/>
                  </a:lnTo>
                  <a:lnTo>
                    <a:pt x="0" y="807720"/>
                  </a:lnTo>
                  <a:lnTo>
                    <a:pt x="10414" y="807720"/>
                  </a:lnTo>
                  <a:lnTo>
                    <a:pt x="10414" y="388874"/>
                  </a:lnTo>
                  <a:close/>
                </a:path>
                <a:path w="4074159" h="807720">
                  <a:moveTo>
                    <a:pt x="68567" y="508635"/>
                  </a:moveTo>
                  <a:lnTo>
                    <a:pt x="58166" y="508635"/>
                  </a:lnTo>
                  <a:lnTo>
                    <a:pt x="58166" y="807720"/>
                  </a:lnTo>
                  <a:lnTo>
                    <a:pt x="68567" y="807720"/>
                  </a:lnTo>
                  <a:lnTo>
                    <a:pt x="68567" y="508635"/>
                  </a:lnTo>
                  <a:close/>
                </a:path>
                <a:path w="4074159" h="807720">
                  <a:moveTo>
                    <a:pt x="126619" y="598297"/>
                  </a:moveTo>
                  <a:lnTo>
                    <a:pt x="116205" y="598297"/>
                  </a:lnTo>
                  <a:lnTo>
                    <a:pt x="116205" y="807720"/>
                  </a:lnTo>
                  <a:lnTo>
                    <a:pt x="126619" y="807720"/>
                  </a:lnTo>
                  <a:lnTo>
                    <a:pt x="126619" y="598297"/>
                  </a:lnTo>
                  <a:close/>
                </a:path>
                <a:path w="4074159" h="807720">
                  <a:moveTo>
                    <a:pt x="184658" y="448818"/>
                  </a:moveTo>
                  <a:lnTo>
                    <a:pt x="174244" y="448818"/>
                  </a:lnTo>
                  <a:lnTo>
                    <a:pt x="174244" y="807720"/>
                  </a:lnTo>
                  <a:lnTo>
                    <a:pt x="184658" y="807720"/>
                  </a:lnTo>
                  <a:lnTo>
                    <a:pt x="184658" y="448818"/>
                  </a:lnTo>
                  <a:close/>
                </a:path>
                <a:path w="4074159" h="807720">
                  <a:moveTo>
                    <a:pt x="242697" y="508635"/>
                  </a:moveTo>
                  <a:lnTo>
                    <a:pt x="232283" y="508635"/>
                  </a:lnTo>
                  <a:lnTo>
                    <a:pt x="232283" y="807720"/>
                  </a:lnTo>
                  <a:lnTo>
                    <a:pt x="242697" y="807720"/>
                  </a:lnTo>
                  <a:lnTo>
                    <a:pt x="242697" y="508635"/>
                  </a:lnTo>
                  <a:close/>
                </a:path>
                <a:path w="4074159" h="807720">
                  <a:moveTo>
                    <a:pt x="300736" y="179578"/>
                  </a:moveTo>
                  <a:lnTo>
                    <a:pt x="290322" y="179578"/>
                  </a:lnTo>
                  <a:lnTo>
                    <a:pt x="290322" y="807720"/>
                  </a:lnTo>
                  <a:lnTo>
                    <a:pt x="300736" y="807720"/>
                  </a:lnTo>
                  <a:lnTo>
                    <a:pt x="300736" y="179578"/>
                  </a:lnTo>
                  <a:close/>
                </a:path>
                <a:path w="4074159" h="807720">
                  <a:moveTo>
                    <a:pt x="358775" y="448818"/>
                  </a:moveTo>
                  <a:lnTo>
                    <a:pt x="348361" y="448818"/>
                  </a:lnTo>
                  <a:lnTo>
                    <a:pt x="348361" y="807720"/>
                  </a:lnTo>
                  <a:lnTo>
                    <a:pt x="358775" y="807720"/>
                  </a:lnTo>
                  <a:lnTo>
                    <a:pt x="358775" y="448818"/>
                  </a:lnTo>
                  <a:close/>
                </a:path>
                <a:path w="4074159" h="807720">
                  <a:moveTo>
                    <a:pt x="416814" y="478663"/>
                  </a:moveTo>
                  <a:lnTo>
                    <a:pt x="406400" y="478663"/>
                  </a:lnTo>
                  <a:lnTo>
                    <a:pt x="406400" y="807720"/>
                  </a:lnTo>
                  <a:lnTo>
                    <a:pt x="416814" y="807720"/>
                  </a:lnTo>
                  <a:lnTo>
                    <a:pt x="416814" y="478663"/>
                  </a:lnTo>
                  <a:close/>
                </a:path>
                <a:path w="4074159" h="807720">
                  <a:moveTo>
                    <a:pt x="474853" y="359029"/>
                  </a:moveTo>
                  <a:lnTo>
                    <a:pt x="464439" y="359029"/>
                  </a:lnTo>
                  <a:lnTo>
                    <a:pt x="464439" y="807720"/>
                  </a:lnTo>
                  <a:lnTo>
                    <a:pt x="474853" y="807720"/>
                  </a:lnTo>
                  <a:lnTo>
                    <a:pt x="474853" y="359029"/>
                  </a:lnTo>
                  <a:close/>
                </a:path>
                <a:path w="4074159" h="807720">
                  <a:moveTo>
                    <a:pt x="532892" y="329057"/>
                  </a:moveTo>
                  <a:lnTo>
                    <a:pt x="522478" y="329057"/>
                  </a:lnTo>
                  <a:lnTo>
                    <a:pt x="522478" y="807720"/>
                  </a:lnTo>
                  <a:lnTo>
                    <a:pt x="532892" y="807720"/>
                  </a:lnTo>
                  <a:lnTo>
                    <a:pt x="532892" y="329057"/>
                  </a:lnTo>
                  <a:close/>
                </a:path>
                <a:path w="4074159" h="807720">
                  <a:moveTo>
                    <a:pt x="590918" y="418846"/>
                  </a:moveTo>
                  <a:lnTo>
                    <a:pt x="580517" y="418846"/>
                  </a:lnTo>
                  <a:lnTo>
                    <a:pt x="580517" y="807720"/>
                  </a:lnTo>
                  <a:lnTo>
                    <a:pt x="590918" y="807720"/>
                  </a:lnTo>
                  <a:lnTo>
                    <a:pt x="590918" y="418846"/>
                  </a:lnTo>
                  <a:close/>
                </a:path>
                <a:path w="4074159" h="807720">
                  <a:moveTo>
                    <a:pt x="649097" y="508635"/>
                  </a:moveTo>
                  <a:lnTo>
                    <a:pt x="638683" y="508635"/>
                  </a:lnTo>
                  <a:lnTo>
                    <a:pt x="638683" y="807720"/>
                  </a:lnTo>
                  <a:lnTo>
                    <a:pt x="649097" y="807720"/>
                  </a:lnTo>
                  <a:lnTo>
                    <a:pt x="649097" y="508635"/>
                  </a:lnTo>
                  <a:close/>
                </a:path>
                <a:path w="4074159" h="807720">
                  <a:moveTo>
                    <a:pt x="707136" y="299212"/>
                  </a:moveTo>
                  <a:lnTo>
                    <a:pt x="696722" y="299212"/>
                  </a:lnTo>
                  <a:lnTo>
                    <a:pt x="696722" y="807720"/>
                  </a:lnTo>
                  <a:lnTo>
                    <a:pt x="707136" y="807720"/>
                  </a:lnTo>
                  <a:lnTo>
                    <a:pt x="707136" y="299212"/>
                  </a:lnTo>
                  <a:close/>
                </a:path>
                <a:path w="4074159" h="807720">
                  <a:moveTo>
                    <a:pt x="765175" y="329057"/>
                  </a:moveTo>
                  <a:lnTo>
                    <a:pt x="754761" y="329057"/>
                  </a:lnTo>
                  <a:lnTo>
                    <a:pt x="754761" y="807720"/>
                  </a:lnTo>
                  <a:lnTo>
                    <a:pt x="765175" y="807720"/>
                  </a:lnTo>
                  <a:lnTo>
                    <a:pt x="765175" y="329057"/>
                  </a:lnTo>
                  <a:close/>
                </a:path>
                <a:path w="4074159" h="807720">
                  <a:moveTo>
                    <a:pt x="823214" y="418846"/>
                  </a:moveTo>
                  <a:lnTo>
                    <a:pt x="812800" y="418846"/>
                  </a:lnTo>
                  <a:lnTo>
                    <a:pt x="812800" y="807720"/>
                  </a:lnTo>
                  <a:lnTo>
                    <a:pt x="823214" y="807720"/>
                  </a:lnTo>
                  <a:lnTo>
                    <a:pt x="823214" y="418846"/>
                  </a:lnTo>
                  <a:close/>
                </a:path>
                <a:path w="4074159" h="807720">
                  <a:moveTo>
                    <a:pt x="881253" y="478663"/>
                  </a:moveTo>
                  <a:lnTo>
                    <a:pt x="870839" y="478663"/>
                  </a:lnTo>
                  <a:lnTo>
                    <a:pt x="870839" y="807720"/>
                  </a:lnTo>
                  <a:lnTo>
                    <a:pt x="881253" y="807720"/>
                  </a:lnTo>
                  <a:lnTo>
                    <a:pt x="881253" y="478663"/>
                  </a:lnTo>
                  <a:close/>
                </a:path>
                <a:path w="4074159" h="807720">
                  <a:moveTo>
                    <a:pt x="939292" y="448818"/>
                  </a:moveTo>
                  <a:lnTo>
                    <a:pt x="928878" y="448818"/>
                  </a:lnTo>
                  <a:lnTo>
                    <a:pt x="928878" y="807720"/>
                  </a:lnTo>
                  <a:lnTo>
                    <a:pt x="939292" y="807720"/>
                  </a:lnTo>
                  <a:lnTo>
                    <a:pt x="939292" y="448818"/>
                  </a:lnTo>
                  <a:close/>
                </a:path>
                <a:path w="4074159" h="807720">
                  <a:moveTo>
                    <a:pt x="997318" y="418846"/>
                  </a:moveTo>
                  <a:lnTo>
                    <a:pt x="986917" y="418846"/>
                  </a:lnTo>
                  <a:lnTo>
                    <a:pt x="986917" y="807720"/>
                  </a:lnTo>
                  <a:lnTo>
                    <a:pt x="997318" y="807720"/>
                  </a:lnTo>
                  <a:lnTo>
                    <a:pt x="997318" y="418846"/>
                  </a:lnTo>
                  <a:close/>
                </a:path>
                <a:path w="4074159" h="807720">
                  <a:moveTo>
                    <a:pt x="1055370" y="418846"/>
                  </a:moveTo>
                  <a:lnTo>
                    <a:pt x="1044956" y="418846"/>
                  </a:lnTo>
                  <a:lnTo>
                    <a:pt x="1044956" y="807720"/>
                  </a:lnTo>
                  <a:lnTo>
                    <a:pt x="1055370" y="807720"/>
                  </a:lnTo>
                  <a:lnTo>
                    <a:pt x="1055370" y="418846"/>
                  </a:lnTo>
                  <a:close/>
                </a:path>
                <a:path w="4074159" h="807720">
                  <a:moveTo>
                    <a:pt x="1113409" y="598297"/>
                  </a:moveTo>
                  <a:lnTo>
                    <a:pt x="1102995" y="598297"/>
                  </a:lnTo>
                  <a:lnTo>
                    <a:pt x="1102995" y="807720"/>
                  </a:lnTo>
                  <a:lnTo>
                    <a:pt x="1113409" y="807720"/>
                  </a:lnTo>
                  <a:lnTo>
                    <a:pt x="1113409" y="598297"/>
                  </a:lnTo>
                  <a:close/>
                </a:path>
                <a:path w="4074159" h="807720">
                  <a:moveTo>
                    <a:pt x="1171575" y="538480"/>
                  </a:moveTo>
                  <a:lnTo>
                    <a:pt x="1161161" y="538480"/>
                  </a:lnTo>
                  <a:lnTo>
                    <a:pt x="1161161" y="807720"/>
                  </a:lnTo>
                  <a:lnTo>
                    <a:pt x="1171575" y="807720"/>
                  </a:lnTo>
                  <a:lnTo>
                    <a:pt x="1171575" y="538480"/>
                  </a:lnTo>
                  <a:close/>
                </a:path>
                <a:path w="4074159" h="807720">
                  <a:moveTo>
                    <a:pt x="1229614" y="0"/>
                  </a:moveTo>
                  <a:lnTo>
                    <a:pt x="1219200" y="0"/>
                  </a:lnTo>
                  <a:lnTo>
                    <a:pt x="1219200" y="807720"/>
                  </a:lnTo>
                  <a:lnTo>
                    <a:pt x="1229614" y="807720"/>
                  </a:lnTo>
                  <a:lnTo>
                    <a:pt x="1229614" y="0"/>
                  </a:lnTo>
                  <a:close/>
                </a:path>
                <a:path w="4074159" h="807720">
                  <a:moveTo>
                    <a:pt x="1287653" y="538480"/>
                  </a:moveTo>
                  <a:lnTo>
                    <a:pt x="1277239" y="538480"/>
                  </a:lnTo>
                  <a:lnTo>
                    <a:pt x="1277239" y="807720"/>
                  </a:lnTo>
                  <a:lnTo>
                    <a:pt x="1287653" y="807720"/>
                  </a:lnTo>
                  <a:lnTo>
                    <a:pt x="1287653" y="538480"/>
                  </a:lnTo>
                  <a:close/>
                </a:path>
                <a:path w="4074159" h="807720">
                  <a:moveTo>
                    <a:pt x="1345692" y="508635"/>
                  </a:moveTo>
                  <a:lnTo>
                    <a:pt x="1335278" y="508635"/>
                  </a:lnTo>
                  <a:lnTo>
                    <a:pt x="1335278" y="807720"/>
                  </a:lnTo>
                  <a:lnTo>
                    <a:pt x="1345692" y="807720"/>
                  </a:lnTo>
                  <a:lnTo>
                    <a:pt x="1345692" y="508635"/>
                  </a:lnTo>
                  <a:close/>
                </a:path>
                <a:path w="4074159" h="807720">
                  <a:moveTo>
                    <a:pt x="1403731" y="478663"/>
                  </a:moveTo>
                  <a:lnTo>
                    <a:pt x="1393317" y="478663"/>
                  </a:lnTo>
                  <a:lnTo>
                    <a:pt x="1393317" y="807720"/>
                  </a:lnTo>
                  <a:lnTo>
                    <a:pt x="1403731" y="807720"/>
                  </a:lnTo>
                  <a:lnTo>
                    <a:pt x="1403731" y="478663"/>
                  </a:lnTo>
                  <a:close/>
                </a:path>
                <a:path w="4074159" h="807720">
                  <a:moveTo>
                    <a:pt x="1461770" y="538480"/>
                  </a:moveTo>
                  <a:lnTo>
                    <a:pt x="1451356" y="538480"/>
                  </a:lnTo>
                  <a:lnTo>
                    <a:pt x="1451356" y="807720"/>
                  </a:lnTo>
                  <a:lnTo>
                    <a:pt x="1461770" y="807720"/>
                  </a:lnTo>
                  <a:lnTo>
                    <a:pt x="1461770" y="538480"/>
                  </a:lnTo>
                  <a:close/>
                </a:path>
                <a:path w="4074159" h="807720">
                  <a:moveTo>
                    <a:pt x="1519809" y="538480"/>
                  </a:moveTo>
                  <a:lnTo>
                    <a:pt x="1509395" y="538480"/>
                  </a:lnTo>
                  <a:lnTo>
                    <a:pt x="1509395" y="807720"/>
                  </a:lnTo>
                  <a:lnTo>
                    <a:pt x="1519809" y="807720"/>
                  </a:lnTo>
                  <a:lnTo>
                    <a:pt x="1519809" y="538480"/>
                  </a:lnTo>
                  <a:close/>
                </a:path>
                <a:path w="4074159" h="807720">
                  <a:moveTo>
                    <a:pt x="1577848" y="508635"/>
                  </a:moveTo>
                  <a:lnTo>
                    <a:pt x="1567434" y="508635"/>
                  </a:lnTo>
                  <a:lnTo>
                    <a:pt x="1567434" y="807720"/>
                  </a:lnTo>
                  <a:lnTo>
                    <a:pt x="1577848" y="807720"/>
                  </a:lnTo>
                  <a:lnTo>
                    <a:pt x="1577848" y="508635"/>
                  </a:lnTo>
                  <a:close/>
                </a:path>
                <a:path w="4074159" h="807720">
                  <a:moveTo>
                    <a:pt x="1635887" y="598297"/>
                  </a:moveTo>
                  <a:lnTo>
                    <a:pt x="1625473" y="598297"/>
                  </a:lnTo>
                  <a:lnTo>
                    <a:pt x="1625473" y="807720"/>
                  </a:lnTo>
                  <a:lnTo>
                    <a:pt x="1635887" y="807720"/>
                  </a:lnTo>
                  <a:lnTo>
                    <a:pt x="1635887" y="598297"/>
                  </a:lnTo>
                  <a:close/>
                </a:path>
                <a:path w="4074159" h="807720">
                  <a:moveTo>
                    <a:pt x="1694053" y="329057"/>
                  </a:moveTo>
                  <a:lnTo>
                    <a:pt x="1683639" y="329057"/>
                  </a:lnTo>
                  <a:lnTo>
                    <a:pt x="1683639" y="807720"/>
                  </a:lnTo>
                  <a:lnTo>
                    <a:pt x="1694053" y="807720"/>
                  </a:lnTo>
                  <a:lnTo>
                    <a:pt x="1694053" y="329057"/>
                  </a:lnTo>
                  <a:close/>
                </a:path>
                <a:path w="4074159" h="807720">
                  <a:moveTo>
                    <a:pt x="1752092" y="448818"/>
                  </a:moveTo>
                  <a:lnTo>
                    <a:pt x="1741678" y="448818"/>
                  </a:lnTo>
                  <a:lnTo>
                    <a:pt x="1741678" y="807720"/>
                  </a:lnTo>
                  <a:lnTo>
                    <a:pt x="1752092" y="807720"/>
                  </a:lnTo>
                  <a:lnTo>
                    <a:pt x="1752092" y="448818"/>
                  </a:lnTo>
                  <a:close/>
                </a:path>
                <a:path w="4074159" h="807720">
                  <a:moveTo>
                    <a:pt x="1810131" y="598297"/>
                  </a:moveTo>
                  <a:lnTo>
                    <a:pt x="1799717" y="598297"/>
                  </a:lnTo>
                  <a:lnTo>
                    <a:pt x="1799717" y="807720"/>
                  </a:lnTo>
                  <a:lnTo>
                    <a:pt x="1810131" y="807720"/>
                  </a:lnTo>
                  <a:lnTo>
                    <a:pt x="1810131" y="598297"/>
                  </a:lnTo>
                  <a:close/>
                </a:path>
                <a:path w="4074159" h="807720">
                  <a:moveTo>
                    <a:pt x="1868170" y="448818"/>
                  </a:moveTo>
                  <a:lnTo>
                    <a:pt x="1857756" y="448818"/>
                  </a:lnTo>
                  <a:lnTo>
                    <a:pt x="1857756" y="807720"/>
                  </a:lnTo>
                  <a:lnTo>
                    <a:pt x="1868170" y="807720"/>
                  </a:lnTo>
                  <a:lnTo>
                    <a:pt x="1868170" y="448818"/>
                  </a:lnTo>
                  <a:close/>
                </a:path>
                <a:path w="4074159" h="807720">
                  <a:moveTo>
                    <a:pt x="1926209" y="508635"/>
                  </a:moveTo>
                  <a:lnTo>
                    <a:pt x="1915795" y="508635"/>
                  </a:lnTo>
                  <a:lnTo>
                    <a:pt x="1915795" y="807720"/>
                  </a:lnTo>
                  <a:lnTo>
                    <a:pt x="1926209" y="807720"/>
                  </a:lnTo>
                  <a:lnTo>
                    <a:pt x="1926209" y="508635"/>
                  </a:lnTo>
                  <a:close/>
                </a:path>
                <a:path w="4074159" h="807720">
                  <a:moveTo>
                    <a:pt x="1984248" y="209423"/>
                  </a:moveTo>
                  <a:lnTo>
                    <a:pt x="1973834" y="209423"/>
                  </a:lnTo>
                  <a:lnTo>
                    <a:pt x="1973834" y="807720"/>
                  </a:lnTo>
                  <a:lnTo>
                    <a:pt x="1984248" y="807720"/>
                  </a:lnTo>
                  <a:lnTo>
                    <a:pt x="1984248" y="209423"/>
                  </a:lnTo>
                  <a:close/>
                </a:path>
                <a:path w="4074159" h="807720">
                  <a:moveTo>
                    <a:pt x="2042287" y="568452"/>
                  </a:moveTo>
                  <a:lnTo>
                    <a:pt x="2031873" y="568452"/>
                  </a:lnTo>
                  <a:lnTo>
                    <a:pt x="2031873" y="807720"/>
                  </a:lnTo>
                  <a:lnTo>
                    <a:pt x="2042287" y="807720"/>
                  </a:lnTo>
                  <a:lnTo>
                    <a:pt x="2042287" y="568452"/>
                  </a:lnTo>
                  <a:close/>
                </a:path>
                <a:path w="4074159" h="807720">
                  <a:moveTo>
                    <a:pt x="2100326" y="448818"/>
                  </a:moveTo>
                  <a:lnTo>
                    <a:pt x="2089912" y="448818"/>
                  </a:lnTo>
                  <a:lnTo>
                    <a:pt x="2089912" y="807720"/>
                  </a:lnTo>
                  <a:lnTo>
                    <a:pt x="2100326" y="807720"/>
                  </a:lnTo>
                  <a:lnTo>
                    <a:pt x="2100326" y="448818"/>
                  </a:lnTo>
                  <a:close/>
                </a:path>
                <a:path w="4074159" h="807720">
                  <a:moveTo>
                    <a:pt x="2158365" y="658114"/>
                  </a:moveTo>
                  <a:lnTo>
                    <a:pt x="2147951" y="658114"/>
                  </a:lnTo>
                  <a:lnTo>
                    <a:pt x="2147951" y="807720"/>
                  </a:lnTo>
                  <a:lnTo>
                    <a:pt x="2158365" y="807720"/>
                  </a:lnTo>
                  <a:lnTo>
                    <a:pt x="2158365" y="658114"/>
                  </a:lnTo>
                  <a:close/>
                </a:path>
                <a:path w="4074159" h="807720">
                  <a:moveTo>
                    <a:pt x="2216404" y="658114"/>
                  </a:moveTo>
                  <a:lnTo>
                    <a:pt x="2205990" y="658114"/>
                  </a:lnTo>
                  <a:lnTo>
                    <a:pt x="2205990" y="807720"/>
                  </a:lnTo>
                  <a:lnTo>
                    <a:pt x="2216404" y="807720"/>
                  </a:lnTo>
                  <a:lnTo>
                    <a:pt x="2216404" y="658114"/>
                  </a:lnTo>
                  <a:close/>
                </a:path>
                <a:path w="4074159" h="807720">
                  <a:moveTo>
                    <a:pt x="2274570" y="538480"/>
                  </a:moveTo>
                  <a:lnTo>
                    <a:pt x="2264156" y="538480"/>
                  </a:lnTo>
                  <a:lnTo>
                    <a:pt x="2264156" y="807720"/>
                  </a:lnTo>
                  <a:lnTo>
                    <a:pt x="2274570" y="807720"/>
                  </a:lnTo>
                  <a:lnTo>
                    <a:pt x="2274570" y="538480"/>
                  </a:lnTo>
                  <a:close/>
                </a:path>
                <a:path w="4074159" h="807720">
                  <a:moveTo>
                    <a:pt x="2332609" y="568452"/>
                  </a:moveTo>
                  <a:lnTo>
                    <a:pt x="2322195" y="568452"/>
                  </a:lnTo>
                  <a:lnTo>
                    <a:pt x="2322195" y="807720"/>
                  </a:lnTo>
                  <a:lnTo>
                    <a:pt x="2332609" y="807720"/>
                  </a:lnTo>
                  <a:lnTo>
                    <a:pt x="2332609" y="568452"/>
                  </a:lnTo>
                  <a:close/>
                </a:path>
                <a:path w="4074159" h="807720">
                  <a:moveTo>
                    <a:pt x="2390648" y="658114"/>
                  </a:moveTo>
                  <a:lnTo>
                    <a:pt x="2380234" y="658114"/>
                  </a:lnTo>
                  <a:lnTo>
                    <a:pt x="2380234" y="807720"/>
                  </a:lnTo>
                  <a:lnTo>
                    <a:pt x="2390648" y="807720"/>
                  </a:lnTo>
                  <a:lnTo>
                    <a:pt x="2390648" y="658114"/>
                  </a:lnTo>
                  <a:close/>
                </a:path>
                <a:path w="4074159" h="807720">
                  <a:moveTo>
                    <a:pt x="2448687" y="658114"/>
                  </a:moveTo>
                  <a:lnTo>
                    <a:pt x="2438273" y="658114"/>
                  </a:lnTo>
                  <a:lnTo>
                    <a:pt x="2438273" y="807720"/>
                  </a:lnTo>
                  <a:lnTo>
                    <a:pt x="2448687" y="807720"/>
                  </a:lnTo>
                  <a:lnTo>
                    <a:pt x="2448687" y="658114"/>
                  </a:lnTo>
                  <a:close/>
                </a:path>
                <a:path w="4074159" h="807720">
                  <a:moveTo>
                    <a:pt x="2506726" y="568452"/>
                  </a:moveTo>
                  <a:lnTo>
                    <a:pt x="2496312" y="568452"/>
                  </a:lnTo>
                  <a:lnTo>
                    <a:pt x="2496312" y="807720"/>
                  </a:lnTo>
                  <a:lnTo>
                    <a:pt x="2506726" y="807720"/>
                  </a:lnTo>
                  <a:lnTo>
                    <a:pt x="2506726" y="568452"/>
                  </a:lnTo>
                  <a:close/>
                </a:path>
                <a:path w="4074159" h="807720">
                  <a:moveTo>
                    <a:pt x="2564765" y="598297"/>
                  </a:moveTo>
                  <a:lnTo>
                    <a:pt x="2554351" y="598297"/>
                  </a:lnTo>
                  <a:lnTo>
                    <a:pt x="2554351" y="807720"/>
                  </a:lnTo>
                  <a:lnTo>
                    <a:pt x="2564765" y="807720"/>
                  </a:lnTo>
                  <a:lnTo>
                    <a:pt x="2564765" y="598297"/>
                  </a:lnTo>
                  <a:close/>
                </a:path>
                <a:path w="4074159" h="807720">
                  <a:moveTo>
                    <a:pt x="2622804" y="628269"/>
                  </a:moveTo>
                  <a:lnTo>
                    <a:pt x="2612390" y="628269"/>
                  </a:lnTo>
                  <a:lnTo>
                    <a:pt x="2612390" y="807720"/>
                  </a:lnTo>
                  <a:lnTo>
                    <a:pt x="2622804" y="807720"/>
                  </a:lnTo>
                  <a:lnTo>
                    <a:pt x="2622804" y="628269"/>
                  </a:lnTo>
                  <a:close/>
                </a:path>
                <a:path w="4074159" h="807720">
                  <a:moveTo>
                    <a:pt x="2680843" y="628269"/>
                  </a:moveTo>
                  <a:lnTo>
                    <a:pt x="2670429" y="628269"/>
                  </a:lnTo>
                  <a:lnTo>
                    <a:pt x="2670429" y="807720"/>
                  </a:lnTo>
                  <a:lnTo>
                    <a:pt x="2680843" y="807720"/>
                  </a:lnTo>
                  <a:lnTo>
                    <a:pt x="2680843" y="628269"/>
                  </a:lnTo>
                  <a:close/>
                </a:path>
                <a:path w="4074159" h="807720">
                  <a:moveTo>
                    <a:pt x="2738882" y="628269"/>
                  </a:moveTo>
                  <a:lnTo>
                    <a:pt x="2728468" y="628269"/>
                  </a:lnTo>
                  <a:lnTo>
                    <a:pt x="2728468" y="807720"/>
                  </a:lnTo>
                  <a:lnTo>
                    <a:pt x="2738882" y="807720"/>
                  </a:lnTo>
                  <a:lnTo>
                    <a:pt x="2738882" y="628269"/>
                  </a:lnTo>
                  <a:close/>
                </a:path>
                <a:path w="4074159" h="807720">
                  <a:moveTo>
                    <a:pt x="2797048" y="658114"/>
                  </a:moveTo>
                  <a:lnTo>
                    <a:pt x="2786634" y="658114"/>
                  </a:lnTo>
                  <a:lnTo>
                    <a:pt x="2786634" y="807720"/>
                  </a:lnTo>
                  <a:lnTo>
                    <a:pt x="2797048" y="807720"/>
                  </a:lnTo>
                  <a:lnTo>
                    <a:pt x="2797048" y="658114"/>
                  </a:lnTo>
                  <a:close/>
                </a:path>
                <a:path w="4074159" h="807720">
                  <a:moveTo>
                    <a:pt x="2855087" y="598297"/>
                  </a:moveTo>
                  <a:lnTo>
                    <a:pt x="2842006" y="598297"/>
                  </a:lnTo>
                  <a:lnTo>
                    <a:pt x="2842006" y="807720"/>
                  </a:lnTo>
                  <a:lnTo>
                    <a:pt x="2855087" y="807720"/>
                  </a:lnTo>
                  <a:lnTo>
                    <a:pt x="2855087" y="598297"/>
                  </a:lnTo>
                  <a:close/>
                </a:path>
                <a:path w="4074159" h="807720">
                  <a:moveTo>
                    <a:pt x="2913126" y="508635"/>
                  </a:moveTo>
                  <a:lnTo>
                    <a:pt x="2902712" y="508635"/>
                  </a:lnTo>
                  <a:lnTo>
                    <a:pt x="2902712" y="807720"/>
                  </a:lnTo>
                  <a:lnTo>
                    <a:pt x="2913126" y="807720"/>
                  </a:lnTo>
                  <a:lnTo>
                    <a:pt x="2913126" y="508635"/>
                  </a:lnTo>
                  <a:close/>
                </a:path>
                <a:path w="4074159" h="807720">
                  <a:moveTo>
                    <a:pt x="2971165" y="448818"/>
                  </a:moveTo>
                  <a:lnTo>
                    <a:pt x="2960751" y="448818"/>
                  </a:lnTo>
                  <a:lnTo>
                    <a:pt x="2960751" y="807720"/>
                  </a:lnTo>
                  <a:lnTo>
                    <a:pt x="2971165" y="807720"/>
                  </a:lnTo>
                  <a:lnTo>
                    <a:pt x="2971165" y="448818"/>
                  </a:lnTo>
                  <a:close/>
                </a:path>
                <a:path w="4074159" h="807720">
                  <a:moveTo>
                    <a:pt x="3029204" y="448818"/>
                  </a:moveTo>
                  <a:lnTo>
                    <a:pt x="3018790" y="448818"/>
                  </a:lnTo>
                  <a:lnTo>
                    <a:pt x="3018790" y="807720"/>
                  </a:lnTo>
                  <a:lnTo>
                    <a:pt x="3029204" y="807720"/>
                  </a:lnTo>
                  <a:lnTo>
                    <a:pt x="3029204" y="448818"/>
                  </a:lnTo>
                  <a:close/>
                </a:path>
                <a:path w="4074159" h="807720">
                  <a:moveTo>
                    <a:pt x="3087243" y="508635"/>
                  </a:moveTo>
                  <a:lnTo>
                    <a:pt x="3076829" y="508635"/>
                  </a:lnTo>
                  <a:lnTo>
                    <a:pt x="3076829" y="807720"/>
                  </a:lnTo>
                  <a:lnTo>
                    <a:pt x="3087243" y="807720"/>
                  </a:lnTo>
                  <a:lnTo>
                    <a:pt x="3087243" y="508635"/>
                  </a:lnTo>
                  <a:close/>
                </a:path>
                <a:path w="4074159" h="807720">
                  <a:moveTo>
                    <a:pt x="3145282" y="538480"/>
                  </a:moveTo>
                  <a:lnTo>
                    <a:pt x="3134868" y="538480"/>
                  </a:lnTo>
                  <a:lnTo>
                    <a:pt x="3134868" y="807720"/>
                  </a:lnTo>
                  <a:lnTo>
                    <a:pt x="3145282" y="807720"/>
                  </a:lnTo>
                  <a:lnTo>
                    <a:pt x="3145282" y="538480"/>
                  </a:lnTo>
                  <a:close/>
                </a:path>
                <a:path w="4074159" h="807720">
                  <a:moveTo>
                    <a:pt x="3203321" y="628269"/>
                  </a:moveTo>
                  <a:lnTo>
                    <a:pt x="3192907" y="628269"/>
                  </a:lnTo>
                  <a:lnTo>
                    <a:pt x="3192907" y="807720"/>
                  </a:lnTo>
                  <a:lnTo>
                    <a:pt x="3203321" y="807720"/>
                  </a:lnTo>
                  <a:lnTo>
                    <a:pt x="3203321" y="628269"/>
                  </a:lnTo>
                  <a:close/>
                </a:path>
                <a:path w="4074159" h="807720">
                  <a:moveTo>
                    <a:pt x="3261360" y="598297"/>
                  </a:moveTo>
                  <a:lnTo>
                    <a:pt x="3250946" y="598297"/>
                  </a:lnTo>
                  <a:lnTo>
                    <a:pt x="3250946" y="807720"/>
                  </a:lnTo>
                  <a:lnTo>
                    <a:pt x="3261360" y="807720"/>
                  </a:lnTo>
                  <a:lnTo>
                    <a:pt x="3261360" y="598297"/>
                  </a:lnTo>
                  <a:close/>
                </a:path>
                <a:path w="4074159" h="807720">
                  <a:moveTo>
                    <a:pt x="3319399" y="508635"/>
                  </a:moveTo>
                  <a:lnTo>
                    <a:pt x="3308985" y="508635"/>
                  </a:lnTo>
                  <a:lnTo>
                    <a:pt x="3308985" y="807720"/>
                  </a:lnTo>
                  <a:lnTo>
                    <a:pt x="3319399" y="807720"/>
                  </a:lnTo>
                  <a:lnTo>
                    <a:pt x="3319399" y="508635"/>
                  </a:lnTo>
                  <a:close/>
                </a:path>
                <a:path w="4074159" h="807720">
                  <a:moveTo>
                    <a:pt x="3377565" y="598297"/>
                  </a:moveTo>
                  <a:lnTo>
                    <a:pt x="3367151" y="598297"/>
                  </a:lnTo>
                  <a:lnTo>
                    <a:pt x="3367151" y="807720"/>
                  </a:lnTo>
                  <a:lnTo>
                    <a:pt x="3377565" y="807720"/>
                  </a:lnTo>
                  <a:lnTo>
                    <a:pt x="3377565" y="598297"/>
                  </a:lnTo>
                  <a:close/>
                </a:path>
                <a:path w="4074159" h="807720">
                  <a:moveTo>
                    <a:pt x="3435604" y="538480"/>
                  </a:moveTo>
                  <a:lnTo>
                    <a:pt x="3425190" y="538480"/>
                  </a:lnTo>
                  <a:lnTo>
                    <a:pt x="3425190" y="807720"/>
                  </a:lnTo>
                  <a:lnTo>
                    <a:pt x="3435604" y="807720"/>
                  </a:lnTo>
                  <a:lnTo>
                    <a:pt x="3435604" y="538480"/>
                  </a:lnTo>
                  <a:close/>
                </a:path>
                <a:path w="4074159" h="807720">
                  <a:moveTo>
                    <a:pt x="3493643" y="598297"/>
                  </a:moveTo>
                  <a:lnTo>
                    <a:pt x="3483229" y="598297"/>
                  </a:lnTo>
                  <a:lnTo>
                    <a:pt x="3483229" y="807720"/>
                  </a:lnTo>
                  <a:lnTo>
                    <a:pt x="3493643" y="807720"/>
                  </a:lnTo>
                  <a:lnTo>
                    <a:pt x="3493643" y="598297"/>
                  </a:lnTo>
                  <a:close/>
                </a:path>
                <a:path w="4074159" h="807720">
                  <a:moveTo>
                    <a:pt x="3551682" y="688086"/>
                  </a:moveTo>
                  <a:lnTo>
                    <a:pt x="3541268" y="688086"/>
                  </a:lnTo>
                  <a:lnTo>
                    <a:pt x="3541268" y="807720"/>
                  </a:lnTo>
                  <a:lnTo>
                    <a:pt x="3551682" y="807720"/>
                  </a:lnTo>
                  <a:lnTo>
                    <a:pt x="3551682" y="688086"/>
                  </a:lnTo>
                  <a:close/>
                </a:path>
                <a:path w="4074159" h="807720">
                  <a:moveTo>
                    <a:pt x="3609721" y="688086"/>
                  </a:moveTo>
                  <a:lnTo>
                    <a:pt x="3599307" y="688086"/>
                  </a:lnTo>
                  <a:lnTo>
                    <a:pt x="3599307" y="807720"/>
                  </a:lnTo>
                  <a:lnTo>
                    <a:pt x="3609721" y="807720"/>
                  </a:lnTo>
                  <a:lnTo>
                    <a:pt x="3609721" y="688086"/>
                  </a:lnTo>
                  <a:close/>
                </a:path>
                <a:path w="4074159" h="807720">
                  <a:moveTo>
                    <a:pt x="3667760" y="508635"/>
                  </a:moveTo>
                  <a:lnTo>
                    <a:pt x="3657346" y="508635"/>
                  </a:lnTo>
                  <a:lnTo>
                    <a:pt x="3657346" y="807720"/>
                  </a:lnTo>
                  <a:lnTo>
                    <a:pt x="3667760" y="807720"/>
                  </a:lnTo>
                  <a:lnTo>
                    <a:pt x="3667760" y="508635"/>
                  </a:lnTo>
                  <a:close/>
                </a:path>
                <a:path w="4074159" h="807720">
                  <a:moveTo>
                    <a:pt x="3725799" y="508635"/>
                  </a:moveTo>
                  <a:lnTo>
                    <a:pt x="3715385" y="508635"/>
                  </a:lnTo>
                  <a:lnTo>
                    <a:pt x="3715385" y="807720"/>
                  </a:lnTo>
                  <a:lnTo>
                    <a:pt x="3725799" y="807720"/>
                  </a:lnTo>
                  <a:lnTo>
                    <a:pt x="3725799" y="508635"/>
                  </a:lnTo>
                  <a:close/>
                </a:path>
                <a:path w="4074159" h="807720">
                  <a:moveTo>
                    <a:pt x="3783838" y="568452"/>
                  </a:moveTo>
                  <a:lnTo>
                    <a:pt x="3773424" y="568452"/>
                  </a:lnTo>
                  <a:lnTo>
                    <a:pt x="3773424" y="807720"/>
                  </a:lnTo>
                  <a:lnTo>
                    <a:pt x="3783838" y="807720"/>
                  </a:lnTo>
                  <a:lnTo>
                    <a:pt x="3783838" y="568452"/>
                  </a:lnTo>
                  <a:close/>
                </a:path>
                <a:path w="4074159" h="807720">
                  <a:moveTo>
                    <a:pt x="3841877" y="538480"/>
                  </a:moveTo>
                  <a:lnTo>
                    <a:pt x="3831463" y="538480"/>
                  </a:lnTo>
                  <a:lnTo>
                    <a:pt x="3831463" y="807720"/>
                  </a:lnTo>
                  <a:lnTo>
                    <a:pt x="3841877" y="807720"/>
                  </a:lnTo>
                  <a:lnTo>
                    <a:pt x="3841877" y="538480"/>
                  </a:lnTo>
                  <a:close/>
                </a:path>
                <a:path w="4074159" h="807720">
                  <a:moveTo>
                    <a:pt x="3900043" y="568452"/>
                  </a:moveTo>
                  <a:lnTo>
                    <a:pt x="3889629" y="568452"/>
                  </a:lnTo>
                  <a:lnTo>
                    <a:pt x="3889629" y="807720"/>
                  </a:lnTo>
                  <a:lnTo>
                    <a:pt x="3900043" y="807720"/>
                  </a:lnTo>
                  <a:lnTo>
                    <a:pt x="3900043" y="568452"/>
                  </a:lnTo>
                  <a:close/>
                </a:path>
                <a:path w="4074159" h="807720">
                  <a:moveTo>
                    <a:pt x="3958082" y="598297"/>
                  </a:moveTo>
                  <a:lnTo>
                    <a:pt x="3947668" y="598297"/>
                  </a:lnTo>
                  <a:lnTo>
                    <a:pt x="3947668" y="807720"/>
                  </a:lnTo>
                  <a:lnTo>
                    <a:pt x="3958082" y="807720"/>
                  </a:lnTo>
                  <a:lnTo>
                    <a:pt x="3958082" y="598297"/>
                  </a:lnTo>
                  <a:close/>
                </a:path>
                <a:path w="4074159" h="807720">
                  <a:moveTo>
                    <a:pt x="4016121" y="448818"/>
                  </a:moveTo>
                  <a:lnTo>
                    <a:pt x="4005707" y="448818"/>
                  </a:lnTo>
                  <a:lnTo>
                    <a:pt x="4005707" y="807720"/>
                  </a:lnTo>
                  <a:lnTo>
                    <a:pt x="4016121" y="807720"/>
                  </a:lnTo>
                  <a:lnTo>
                    <a:pt x="4016121" y="448818"/>
                  </a:lnTo>
                  <a:close/>
                </a:path>
                <a:path w="4074159" h="807720">
                  <a:moveTo>
                    <a:pt x="4074160" y="478663"/>
                  </a:moveTo>
                  <a:lnTo>
                    <a:pt x="4063746" y="478663"/>
                  </a:lnTo>
                  <a:lnTo>
                    <a:pt x="4063746" y="807720"/>
                  </a:lnTo>
                  <a:lnTo>
                    <a:pt x="4074160" y="807720"/>
                  </a:lnTo>
                  <a:lnTo>
                    <a:pt x="4074160" y="478663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3" name="object 113" descr=""/>
            <p:cNvSpPr/>
            <p:nvPr/>
          </p:nvSpPr>
          <p:spPr>
            <a:xfrm>
              <a:off x="9293860" y="8333359"/>
              <a:ext cx="4364355" cy="329565"/>
            </a:xfrm>
            <a:custGeom>
              <a:avLst/>
              <a:gdLst/>
              <a:ahLst/>
              <a:cxnLst/>
              <a:rect l="l" t="t" r="r" b="b"/>
              <a:pathLst>
                <a:path w="4364355" h="329565">
                  <a:moveTo>
                    <a:pt x="10414" y="0"/>
                  </a:moveTo>
                  <a:lnTo>
                    <a:pt x="0" y="0"/>
                  </a:lnTo>
                  <a:lnTo>
                    <a:pt x="0" y="329057"/>
                  </a:lnTo>
                  <a:lnTo>
                    <a:pt x="10414" y="329057"/>
                  </a:lnTo>
                  <a:lnTo>
                    <a:pt x="10414" y="0"/>
                  </a:lnTo>
                  <a:close/>
                </a:path>
                <a:path w="4364355" h="329565">
                  <a:moveTo>
                    <a:pt x="68453" y="89789"/>
                  </a:moveTo>
                  <a:lnTo>
                    <a:pt x="58039" y="89789"/>
                  </a:lnTo>
                  <a:lnTo>
                    <a:pt x="58039" y="329057"/>
                  </a:lnTo>
                  <a:lnTo>
                    <a:pt x="68453" y="329057"/>
                  </a:lnTo>
                  <a:lnTo>
                    <a:pt x="68453" y="89789"/>
                  </a:lnTo>
                  <a:close/>
                </a:path>
                <a:path w="4364355" h="329565">
                  <a:moveTo>
                    <a:pt x="126492" y="209423"/>
                  </a:moveTo>
                  <a:lnTo>
                    <a:pt x="116078" y="209423"/>
                  </a:lnTo>
                  <a:lnTo>
                    <a:pt x="116078" y="329057"/>
                  </a:lnTo>
                  <a:lnTo>
                    <a:pt x="126492" y="329057"/>
                  </a:lnTo>
                  <a:lnTo>
                    <a:pt x="126492" y="209423"/>
                  </a:lnTo>
                  <a:close/>
                </a:path>
                <a:path w="4364355" h="329565">
                  <a:moveTo>
                    <a:pt x="184531" y="179451"/>
                  </a:moveTo>
                  <a:lnTo>
                    <a:pt x="174117" y="179451"/>
                  </a:lnTo>
                  <a:lnTo>
                    <a:pt x="174117" y="329057"/>
                  </a:lnTo>
                  <a:lnTo>
                    <a:pt x="184531" y="329057"/>
                  </a:lnTo>
                  <a:lnTo>
                    <a:pt x="184531" y="179451"/>
                  </a:lnTo>
                  <a:close/>
                </a:path>
                <a:path w="4364355" h="329565">
                  <a:moveTo>
                    <a:pt x="242570" y="209423"/>
                  </a:moveTo>
                  <a:lnTo>
                    <a:pt x="232156" y="209423"/>
                  </a:lnTo>
                  <a:lnTo>
                    <a:pt x="232156" y="329057"/>
                  </a:lnTo>
                  <a:lnTo>
                    <a:pt x="242570" y="329057"/>
                  </a:lnTo>
                  <a:lnTo>
                    <a:pt x="242570" y="209423"/>
                  </a:lnTo>
                  <a:close/>
                </a:path>
                <a:path w="4364355" h="329565">
                  <a:moveTo>
                    <a:pt x="300609" y="149606"/>
                  </a:moveTo>
                  <a:lnTo>
                    <a:pt x="290195" y="149606"/>
                  </a:lnTo>
                  <a:lnTo>
                    <a:pt x="290195" y="329057"/>
                  </a:lnTo>
                  <a:lnTo>
                    <a:pt x="300609" y="329057"/>
                  </a:lnTo>
                  <a:lnTo>
                    <a:pt x="300609" y="149606"/>
                  </a:lnTo>
                  <a:close/>
                </a:path>
                <a:path w="4364355" h="329565">
                  <a:moveTo>
                    <a:pt x="358775" y="149606"/>
                  </a:moveTo>
                  <a:lnTo>
                    <a:pt x="348361" y="149606"/>
                  </a:lnTo>
                  <a:lnTo>
                    <a:pt x="348361" y="329057"/>
                  </a:lnTo>
                  <a:lnTo>
                    <a:pt x="358775" y="329057"/>
                  </a:lnTo>
                  <a:lnTo>
                    <a:pt x="358775" y="149606"/>
                  </a:lnTo>
                  <a:close/>
                </a:path>
                <a:path w="4364355" h="329565">
                  <a:moveTo>
                    <a:pt x="416814" y="59817"/>
                  </a:moveTo>
                  <a:lnTo>
                    <a:pt x="406400" y="59817"/>
                  </a:lnTo>
                  <a:lnTo>
                    <a:pt x="406400" y="329057"/>
                  </a:lnTo>
                  <a:lnTo>
                    <a:pt x="416814" y="329057"/>
                  </a:lnTo>
                  <a:lnTo>
                    <a:pt x="416814" y="59817"/>
                  </a:lnTo>
                  <a:close/>
                </a:path>
                <a:path w="4364355" h="329565">
                  <a:moveTo>
                    <a:pt x="474853" y="89789"/>
                  </a:moveTo>
                  <a:lnTo>
                    <a:pt x="464439" y="89789"/>
                  </a:lnTo>
                  <a:lnTo>
                    <a:pt x="464439" y="329057"/>
                  </a:lnTo>
                  <a:lnTo>
                    <a:pt x="474853" y="329057"/>
                  </a:lnTo>
                  <a:lnTo>
                    <a:pt x="474853" y="89789"/>
                  </a:lnTo>
                  <a:close/>
                </a:path>
                <a:path w="4364355" h="329565">
                  <a:moveTo>
                    <a:pt x="532892" y="149606"/>
                  </a:moveTo>
                  <a:lnTo>
                    <a:pt x="522478" y="149606"/>
                  </a:lnTo>
                  <a:lnTo>
                    <a:pt x="522478" y="329057"/>
                  </a:lnTo>
                  <a:lnTo>
                    <a:pt x="532892" y="329057"/>
                  </a:lnTo>
                  <a:lnTo>
                    <a:pt x="532892" y="149606"/>
                  </a:lnTo>
                  <a:close/>
                </a:path>
                <a:path w="4364355" h="329565">
                  <a:moveTo>
                    <a:pt x="590931" y="239268"/>
                  </a:moveTo>
                  <a:lnTo>
                    <a:pt x="580517" y="239268"/>
                  </a:lnTo>
                  <a:lnTo>
                    <a:pt x="580517" y="329057"/>
                  </a:lnTo>
                  <a:lnTo>
                    <a:pt x="590931" y="329057"/>
                  </a:lnTo>
                  <a:lnTo>
                    <a:pt x="590931" y="239268"/>
                  </a:lnTo>
                  <a:close/>
                </a:path>
                <a:path w="4364355" h="329565">
                  <a:moveTo>
                    <a:pt x="648970" y="119634"/>
                  </a:moveTo>
                  <a:lnTo>
                    <a:pt x="638556" y="119634"/>
                  </a:lnTo>
                  <a:lnTo>
                    <a:pt x="638556" y="329057"/>
                  </a:lnTo>
                  <a:lnTo>
                    <a:pt x="648970" y="329057"/>
                  </a:lnTo>
                  <a:lnTo>
                    <a:pt x="648970" y="119634"/>
                  </a:lnTo>
                  <a:close/>
                </a:path>
                <a:path w="4364355" h="329565">
                  <a:moveTo>
                    <a:pt x="707009" y="179451"/>
                  </a:moveTo>
                  <a:lnTo>
                    <a:pt x="696595" y="179451"/>
                  </a:lnTo>
                  <a:lnTo>
                    <a:pt x="696595" y="329057"/>
                  </a:lnTo>
                  <a:lnTo>
                    <a:pt x="707009" y="329057"/>
                  </a:lnTo>
                  <a:lnTo>
                    <a:pt x="707009" y="179451"/>
                  </a:lnTo>
                  <a:close/>
                </a:path>
                <a:path w="4364355" h="329565">
                  <a:moveTo>
                    <a:pt x="765048" y="149606"/>
                  </a:moveTo>
                  <a:lnTo>
                    <a:pt x="754634" y="149606"/>
                  </a:lnTo>
                  <a:lnTo>
                    <a:pt x="754634" y="329057"/>
                  </a:lnTo>
                  <a:lnTo>
                    <a:pt x="765048" y="329057"/>
                  </a:lnTo>
                  <a:lnTo>
                    <a:pt x="765048" y="149606"/>
                  </a:lnTo>
                  <a:close/>
                </a:path>
                <a:path w="4364355" h="329565">
                  <a:moveTo>
                    <a:pt x="881126" y="209423"/>
                  </a:moveTo>
                  <a:lnTo>
                    <a:pt x="870712" y="209423"/>
                  </a:lnTo>
                  <a:lnTo>
                    <a:pt x="870712" y="329057"/>
                  </a:lnTo>
                  <a:lnTo>
                    <a:pt x="881126" y="329057"/>
                  </a:lnTo>
                  <a:lnTo>
                    <a:pt x="881126" y="209423"/>
                  </a:lnTo>
                  <a:close/>
                </a:path>
                <a:path w="4364355" h="329565">
                  <a:moveTo>
                    <a:pt x="939292" y="29972"/>
                  </a:moveTo>
                  <a:lnTo>
                    <a:pt x="928878" y="29972"/>
                  </a:lnTo>
                  <a:lnTo>
                    <a:pt x="928878" y="329057"/>
                  </a:lnTo>
                  <a:lnTo>
                    <a:pt x="939292" y="329057"/>
                  </a:lnTo>
                  <a:lnTo>
                    <a:pt x="939292" y="29972"/>
                  </a:lnTo>
                  <a:close/>
                </a:path>
                <a:path w="4364355" h="329565">
                  <a:moveTo>
                    <a:pt x="997331" y="299085"/>
                  </a:moveTo>
                  <a:lnTo>
                    <a:pt x="986917" y="299085"/>
                  </a:lnTo>
                  <a:lnTo>
                    <a:pt x="986917" y="329057"/>
                  </a:lnTo>
                  <a:lnTo>
                    <a:pt x="997331" y="329057"/>
                  </a:lnTo>
                  <a:lnTo>
                    <a:pt x="997331" y="299085"/>
                  </a:lnTo>
                  <a:close/>
                </a:path>
                <a:path w="4364355" h="329565">
                  <a:moveTo>
                    <a:pt x="1055370" y="149606"/>
                  </a:moveTo>
                  <a:lnTo>
                    <a:pt x="1044956" y="149606"/>
                  </a:lnTo>
                  <a:lnTo>
                    <a:pt x="1044956" y="329057"/>
                  </a:lnTo>
                  <a:lnTo>
                    <a:pt x="1055370" y="329057"/>
                  </a:lnTo>
                  <a:lnTo>
                    <a:pt x="1055370" y="149606"/>
                  </a:lnTo>
                  <a:close/>
                </a:path>
                <a:path w="4364355" h="329565">
                  <a:moveTo>
                    <a:pt x="1113409" y="59817"/>
                  </a:moveTo>
                  <a:lnTo>
                    <a:pt x="1102995" y="59817"/>
                  </a:lnTo>
                  <a:lnTo>
                    <a:pt x="1102995" y="329057"/>
                  </a:lnTo>
                  <a:lnTo>
                    <a:pt x="1113409" y="329057"/>
                  </a:lnTo>
                  <a:lnTo>
                    <a:pt x="1113409" y="59817"/>
                  </a:lnTo>
                  <a:close/>
                </a:path>
                <a:path w="4364355" h="329565">
                  <a:moveTo>
                    <a:pt x="1171448" y="149606"/>
                  </a:moveTo>
                  <a:lnTo>
                    <a:pt x="1161034" y="149606"/>
                  </a:lnTo>
                  <a:lnTo>
                    <a:pt x="1161034" y="329057"/>
                  </a:lnTo>
                  <a:lnTo>
                    <a:pt x="1171448" y="329057"/>
                  </a:lnTo>
                  <a:lnTo>
                    <a:pt x="1171448" y="149606"/>
                  </a:lnTo>
                  <a:close/>
                </a:path>
                <a:path w="4364355" h="329565">
                  <a:moveTo>
                    <a:pt x="1229487" y="179451"/>
                  </a:moveTo>
                  <a:lnTo>
                    <a:pt x="1219073" y="179451"/>
                  </a:lnTo>
                  <a:lnTo>
                    <a:pt x="1219073" y="329057"/>
                  </a:lnTo>
                  <a:lnTo>
                    <a:pt x="1229487" y="329057"/>
                  </a:lnTo>
                  <a:lnTo>
                    <a:pt x="1229487" y="179451"/>
                  </a:lnTo>
                  <a:close/>
                </a:path>
                <a:path w="4364355" h="329565">
                  <a:moveTo>
                    <a:pt x="1287640" y="179451"/>
                  </a:moveTo>
                  <a:lnTo>
                    <a:pt x="1274572" y="179451"/>
                  </a:lnTo>
                  <a:lnTo>
                    <a:pt x="1274572" y="329057"/>
                  </a:lnTo>
                  <a:lnTo>
                    <a:pt x="1287640" y="329057"/>
                  </a:lnTo>
                  <a:lnTo>
                    <a:pt x="1287640" y="179451"/>
                  </a:lnTo>
                  <a:close/>
                </a:path>
                <a:path w="4364355" h="329565">
                  <a:moveTo>
                    <a:pt x="1345565" y="239268"/>
                  </a:moveTo>
                  <a:lnTo>
                    <a:pt x="1335151" y="239268"/>
                  </a:lnTo>
                  <a:lnTo>
                    <a:pt x="1335151" y="329057"/>
                  </a:lnTo>
                  <a:lnTo>
                    <a:pt x="1345565" y="329057"/>
                  </a:lnTo>
                  <a:lnTo>
                    <a:pt x="1345565" y="239268"/>
                  </a:lnTo>
                  <a:close/>
                </a:path>
                <a:path w="4364355" h="329565">
                  <a:moveTo>
                    <a:pt x="1403604" y="239268"/>
                  </a:moveTo>
                  <a:lnTo>
                    <a:pt x="1393190" y="239268"/>
                  </a:lnTo>
                  <a:lnTo>
                    <a:pt x="1393190" y="329057"/>
                  </a:lnTo>
                  <a:lnTo>
                    <a:pt x="1403604" y="329057"/>
                  </a:lnTo>
                  <a:lnTo>
                    <a:pt x="1403604" y="239268"/>
                  </a:lnTo>
                  <a:close/>
                </a:path>
                <a:path w="4364355" h="329565">
                  <a:moveTo>
                    <a:pt x="1461770" y="119634"/>
                  </a:moveTo>
                  <a:lnTo>
                    <a:pt x="1451356" y="119634"/>
                  </a:lnTo>
                  <a:lnTo>
                    <a:pt x="1451356" y="329057"/>
                  </a:lnTo>
                  <a:lnTo>
                    <a:pt x="1461770" y="329057"/>
                  </a:lnTo>
                  <a:lnTo>
                    <a:pt x="1461770" y="119634"/>
                  </a:lnTo>
                  <a:close/>
                </a:path>
                <a:path w="4364355" h="329565">
                  <a:moveTo>
                    <a:pt x="1519809" y="239268"/>
                  </a:moveTo>
                  <a:lnTo>
                    <a:pt x="1509395" y="239268"/>
                  </a:lnTo>
                  <a:lnTo>
                    <a:pt x="1509395" y="329057"/>
                  </a:lnTo>
                  <a:lnTo>
                    <a:pt x="1519809" y="329057"/>
                  </a:lnTo>
                  <a:lnTo>
                    <a:pt x="1519809" y="239268"/>
                  </a:lnTo>
                  <a:close/>
                </a:path>
                <a:path w="4364355" h="329565">
                  <a:moveTo>
                    <a:pt x="1577848" y="269240"/>
                  </a:moveTo>
                  <a:lnTo>
                    <a:pt x="1567434" y="269240"/>
                  </a:lnTo>
                  <a:lnTo>
                    <a:pt x="1567434" y="329057"/>
                  </a:lnTo>
                  <a:lnTo>
                    <a:pt x="1577848" y="329057"/>
                  </a:lnTo>
                  <a:lnTo>
                    <a:pt x="1577848" y="269240"/>
                  </a:lnTo>
                  <a:close/>
                </a:path>
                <a:path w="4364355" h="329565">
                  <a:moveTo>
                    <a:pt x="1635887" y="269240"/>
                  </a:moveTo>
                  <a:lnTo>
                    <a:pt x="1625473" y="269240"/>
                  </a:lnTo>
                  <a:lnTo>
                    <a:pt x="1625473" y="329057"/>
                  </a:lnTo>
                  <a:lnTo>
                    <a:pt x="1635887" y="329057"/>
                  </a:lnTo>
                  <a:lnTo>
                    <a:pt x="1635887" y="269240"/>
                  </a:lnTo>
                  <a:close/>
                </a:path>
                <a:path w="4364355" h="329565">
                  <a:moveTo>
                    <a:pt x="1693926" y="119634"/>
                  </a:moveTo>
                  <a:lnTo>
                    <a:pt x="1683512" y="119634"/>
                  </a:lnTo>
                  <a:lnTo>
                    <a:pt x="1683512" y="329057"/>
                  </a:lnTo>
                  <a:lnTo>
                    <a:pt x="1693926" y="329057"/>
                  </a:lnTo>
                  <a:lnTo>
                    <a:pt x="1693926" y="119634"/>
                  </a:lnTo>
                  <a:close/>
                </a:path>
                <a:path w="4364355" h="329565">
                  <a:moveTo>
                    <a:pt x="1751965" y="179451"/>
                  </a:moveTo>
                  <a:lnTo>
                    <a:pt x="1741551" y="179451"/>
                  </a:lnTo>
                  <a:lnTo>
                    <a:pt x="1741551" y="329057"/>
                  </a:lnTo>
                  <a:lnTo>
                    <a:pt x="1751965" y="329057"/>
                  </a:lnTo>
                  <a:lnTo>
                    <a:pt x="1751965" y="179451"/>
                  </a:lnTo>
                  <a:close/>
                </a:path>
                <a:path w="4364355" h="329565">
                  <a:moveTo>
                    <a:pt x="1810004" y="239268"/>
                  </a:moveTo>
                  <a:lnTo>
                    <a:pt x="1799590" y="239268"/>
                  </a:lnTo>
                  <a:lnTo>
                    <a:pt x="1799590" y="329057"/>
                  </a:lnTo>
                  <a:lnTo>
                    <a:pt x="1810004" y="329057"/>
                  </a:lnTo>
                  <a:lnTo>
                    <a:pt x="1810004" y="239268"/>
                  </a:lnTo>
                  <a:close/>
                </a:path>
                <a:path w="4364355" h="329565">
                  <a:moveTo>
                    <a:pt x="1868170" y="209423"/>
                  </a:moveTo>
                  <a:lnTo>
                    <a:pt x="1855089" y="209423"/>
                  </a:lnTo>
                  <a:lnTo>
                    <a:pt x="1855089" y="329057"/>
                  </a:lnTo>
                  <a:lnTo>
                    <a:pt x="1868170" y="329057"/>
                  </a:lnTo>
                  <a:lnTo>
                    <a:pt x="1868170" y="209423"/>
                  </a:lnTo>
                  <a:close/>
                </a:path>
                <a:path w="4364355" h="329565">
                  <a:moveTo>
                    <a:pt x="1926082" y="299085"/>
                  </a:moveTo>
                  <a:lnTo>
                    <a:pt x="1915668" y="299085"/>
                  </a:lnTo>
                  <a:lnTo>
                    <a:pt x="1915668" y="329057"/>
                  </a:lnTo>
                  <a:lnTo>
                    <a:pt x="1926082" y="329057"/>
                  </a:lnTo>
                  <a:lnTo>
                    <a:pt x="1926082" y="299085"/>
                  </a:lnTo>
                  <a:close/>
                </a:path>
                <a:path w="4364355" h="329565">
                  <a:moveTo>
                    <a:pt x="1984248" y="209423"/>
                  </a:moveTo>
                  <a:lnTo>
                    <a:pt x="1973834" y="209423"/>
                  </a:lnTo>
                  <a:lnTo>
                    <a:pt x="1973834" y="329057"/>
                  </a:lnTo>
                  <a:lnTo>
                    <a:pt x="1984248" y="329057"/>
                  </a:lnTo>
                  <a:lnTo>
                    <a:pt x="1984248" y="209423"/>
                  </a:lnTo>
                  <a:close/>
                </a:path>
                <a:path w="4364355" h="329565">
                  <a:moveTo>
                    <a:pt x="2042287" y="179451"/>
                  </a:moveTo>
                  <a:lnTo>
                    <a:pt x="2031873" y="179451"/>
                  </a:lnTo>
                  <a:lnTo>
                    <a:pt x="2031873" y="329057"/>
                  </a:lnTo>
                  <a:lnTo>
                    <a:pt x="2042287" y="329057"/>
                  </a:lnTo>
                  <a:lnTo>
                    <a:pt x="2042287" y="179451"/>
                  </a:lnTo>
                  <a:close/>
                </a:path>
                <a:path w="4364355" h="329565">
                  <a:moveTo>
                    <a:pt x="2100326" y="149606"/>
                  </a:moveTo>
                  <a:lnTo>
                    <a:pt x="2089912" y="149606"/>
                  </a:lnTo>
                  <a:lnTo>
                    <a:pt x="2089912" y="329057"/>
                  </a:lnTo>
                  <a:lnTo>
                    <a:pt x="2100326" y="329057"/>
                  </a:lnTo>
                  <a:lnTo>
                    <a:pt x="2100326" y="149606"/>
                  </a:lnTo>
                  <a:close/>
                </a:path>
                <a:path w="4364355" h="329565">
                  <a:moveTo>
                    <a:pt x="2158365" y="179451"/>
                  </a:moveTo>
                  <a:lnTo>
                    <a:pt x="2147951" y="179451"/>
                  </a:lnTo>
                  <a:lnTo>
                    <a:pt x="2147951" y="329057"/>
                  </a:lnTo>
                  <a:lnTo>
                    <a:pt x="2158365" y="329057"/>
                  </a:lnTo>
                  <a:lnTo>
                    <a:pt x="2158365" y="179451"/>
                  </a:lnTo>
                  <a:close/>
                </a:path>
                <a:path w="4364355" h="329565">
                  <a:moveTo>
                    <a:pt x="2216404" y="239268"/>
                  </a:moveTo>
                  <a:lnTo>
                    <a:pt x="2205990" y="239268"/>
                  </a:lnTo>
                  <a:lnTo>
                    <a:pt x="2205990" y="329057"/>
                  </a:lnTo>
                  <a:lnTo>
                    <a:pt x="2216404" y="329057"/>
                  </a:lnTo>
                  <a:lnTo>
                    <a:pt x="2216404" y="239268"/>
                  </a:lnTo>
                  <a:close/>
                </a:path>
                <a:path w="4364355" h="329565">
                  <a:moveTo>
                    <a:pt x="2274443" y="209423"/>
                  </a:moveTo>
                  <a:lnTo>
                    <a:pt x="2264029" y="209423"/>
                  </a:lnTo>
                  <a:lnTo>
                    <a:pt x="2264029" y="329057"/>
                  </a:lnTo>
                  <a:lnTo>
                    <a:pt x="2274443" y="329057"/>
                  </a:lnTo>
                  <a:lnTo>
                    <a:pt x="2274443" y="209423"/>
                  </a:lnTo>
                  <a:close/>
                </a:path>
                <a:path w="4364355" h="329565">
                  <a:moveTo>
                    <a:pt x="2332482" y="179451"/>
                  </a:moveTo>
                  <a:lnTo>
                    <a:pt x="2322068" y="179451"/>
                  </a:lnTo>
                  <a:lnTo>
                    <a:pt x="2322068" y="329057"/>
                  </a:lnTo>
                  <a:lnTo>
                    <a:pt x="2332482" y="329057"/>
                  </a:lnTo>
                  <a:lnTo>
                    <a:pt x="2332482" y="179451"/>
                  </a:lnTo>
                  <a:close/>
                </a:path>
                <a:path w="4364355" h="329565">
                  <a:moveTo>
                    <a:pt x="2390521" y="239268"/>
                  </a:moveTo>
                  <a:lnTo>
                    <a:pt x="2380107" y="239268"/>
                  </a:lnTo>
                  <a:lnTo>
                    <a:pt x="2380107" y="329057"/>
                  </a:lnTo>
                  <a:lnTo>
                    <a:pt x="2390521" y="329057"/>
                  </a:lnTo>
                  <a:lnTo>
                    <a:pt x="2390521" y="239268"/>
                  </a:lnTo>
                  <a:close/>
                </a:path>
                <a:path w="4364355" h="329565">
                  <a:moveTo>
                    <a:pt x="2448687" y="239268"/>
                  </a:moveTo>
                  <a:lnTo>
                    <a:pt x="2435606" y="239268"/>
                  </a:lnTo>
                  <a:lnTo>
                    <a:pt x="2435606" y="329057"/>
                  </a:lnTo>
                  <a:lnTo>
                    <a:pt x="2448687" y="329057"/>
                  </a:lnTo>
                  <a:lnTo>
                    <a:pt x="2448687" y="239268"/>
                  </a:lnTo>
                  <a:close/>
                </a:path>
                <a:path w="4364355" h="329565">
                  <a:moveTo>
                    <a:pt x="2506599" y="299085"/>
                  </a:moveTo>
                  <a:lnTo>
                    <a:pt x="2496185" y="299085"/>
                  </a:lnTo>
                  <a:lnTo>
                    <a:pt x="2496185" y="329057"/>
                  </a:lnTo>
                  <a:lnTo>
                    <a:pt x="2506599" y="329057"/>
                  </a:lnTo>
                  <a:lnTo>
                    <a:pt x="2506599" y="299085"/>
                  </a:lnTo>
                  <a:close/>
                </a:path>
                <a:path w="4364355" h="329565">
                  <a:moveTo>
                    <a:pt x="2564765" y="269240"/>
                  </a:moveTo>
                  <a:lnTo>
                    <a:pt x="2554351" y="269240"/>
                  </a:lnTo>
                  <a:lnTo>
                    <a:pt x="2554351" y="329057"/>
                  </a:lnTo>
                  <a:lnTo>
                    <a:pt x="2564765" y="329057"/>
                  </a:lnTo>
                  <a:lnTo>
                    <a:pt x="2564765" y="269240"/>
                  </a:lnTo>
                  <a:close/>
                </a:path>
                <a:path w="4364355" h="329565">
                  <a:moveTo>
                    <a:pt x="2622791" y="239268"/>
                  </a:moveTo>
                  <a:lnTo>
                    <a:pt x="2609723" y="239268"/>
                  </a:lnTo>
                  <a:lnTo>
                    <a:pt x="2609723" y="329057"/>
                  </a:lnTo>
                  <a:lnTo>
                    <a:pt x="2622791" y="329057"/>
                  </a:lnTo>
                  <a:lnTo>
                    <a:pt x="2622791" y="239268"/>
                  </a:lnTo>
                  <a:close/>
                </a:path>
                <a:path w="4364355" h="329565">
                  <a:moveTo>
                    <a:pt x="2680843" y="269240"/>
                  </a:moveTo>
                  <a:lnTo>
                    <a:pt x="2670429" y="269240"/>
                  </a:lnTo>
                  <a:lnTo>
                    <a:pt x="2670429" y="329057"/>
                  </a:lnTo>
                  <a:lnTo>
                    <a:pt x="2680843" y="329057"/>
                  </a:lnTo>
                  <a:lnTo>
                    <a:pt x="2680843" y="269240"/>
                  </a:lnTo>
                  <a:close/>
                </a:path>
                <a:path w="4364355" h="329565">
                  <a:moveTo>
                    <a:pt x="2738882" y="149606"/>
                  </a:moveTo>
                  <a:lnTo>
                    <a:pt x="2728468" y="149606"/>
                  </a:lnTo>
                  <a:lnTo>
                    <a:pt x="2728468" y="329057"/>
                  </a:lnTo>
                  <a:lnTo>
                    <a:pt x="2738882" y="329057"/>
                  </a:lnTo>
                  <a:lnTo>
                    <a:pt x="2738882" y="149606"/>
                  </a:lnTo>
                  <a:close/>
                </a:path>
                <a:path w="4364355" h="329565">
                  <a:moveTo>
                    <a:pt x="2796921" y="179451"/>
                  </a:moveTo>
                  <a:lnTo>
                    <a:pt x="2786507" y="179451"/>
                  </a:lnTo>
                  <a:lnTo>
                    <a:pt x="2786507" y="329057"/>
                  </a:lnTo>
                  <a:lnTo>
                    <a:pt x="2796921" y="329057"/>
                  </a:lnTo>
                  <a:lnTo>
                    <a:pt x="2796921" y="179451"/>
                  </a:lnTo>
                  <a:close/>
                </a:path>
                <a:path w="4364355" h="329565">
                  <a:moveTo>
                    <a:pt x="2855087" y="299085"/>
                  </a:moveTo>
                  <a:lnTo>
                    <a:pt x="2842006" y="299085"/>
                  </a:lnTo>
                  <a:lnTo>
                    <a:pt x="2842006" y="329057"/>
                  </a:lnTo>
                  <a:lnTo>
                    <a:pt x="2855087" y="329057"/>
                  </a:lnTo>
                  <a:lnTo>
                    <a:pt x="2855087" y="299085"/>
                  </a:lnTo>
                  <a:close/>
                </a:path>
                <a:path w="4364355" h="329565">
                  <a:moveTo>
                    <a:pt x="2912999" y="209423"/>
                  </a:moveTo>
                  <a:lnTo>
                    <a:pt x="2902585" y="209423"/>
                  </a:lnTo>
                  <a:lnTo>
                    <a:pt x="2902585" y="329057"/>
                  </a:lnTo>
                  <a:lnTo>
                    <a:pt x="2912999" y="329057"/>
                  </a:lnTo>
                  <a:lnTo>
                    <a:pt x="2912999" y="209423"/>
                  </a:lnTo>
                  <a:close/>
                </a:path>
                <a:path w="4364355" h="329565">
                  <a:moveTo>
                    <a:pt x="2971038" y="209423"/>
                  </a:moveTo>
                  <a:lnTo>
                    <a:pt x="2960624" y="209423"/>
                  </a:lnTo>
                  <a:lnTo>
                    <a:pt x="2960624" y="329057"/>
                  </a:lnTo>
                  <a:lnTo>
                    <a:pt x="2971038" y="329057"/>
                  </a:lnTo>
                  <a:lnTo>
                    <a:pt x="2971038" y="209423"/>
                  </a:lnTo>
                  <a:close/>
                </a:path>
                <a:path w="4364355" h="329565">
                  <a:moveTo>
                    <a:pt x="3029077" y="239268"/>
                  </a:moveTo>
                  <a:lnTo>
                    <a:pt x="3018663" y="239268"/>
                  </a:lnTo>
                  <a:lnTo>
                    <a:pt x="3018663" y="329057"/>
                  </a:lnTo>
                  <a:lnTo>
                    <a:pt x="3029077" y="329057"/>
                  </a:lnTo>
                  <a:lnTo>
                    <a:pt x="3029077" y="239268"/>
                  </a:lnTo>
                  <a:close/>
                </a:path>
                <a:path w="4364355" h="329565">
                  <a:moveTo>
                    <a:pt x="3087243" y="269240"/>
                  </a:moveTo>
                  <a:lnTo>
                    <a:pt x="3076829" y="269240"/>
                  </a:lnTo>
                  <a:lnTo>
                    <a:pt x="3076829" y="329057"/>
                  </a:lnTo>
                  <a:lnTo>
                    <a:pt x="3087243" y="329057"/>
                  </a:lnTo>
                  <a:lnTo>
                    <a:pt x="3087243" y="269240"/>
                  </a:lnTo>
                  <a:close/>
                </a:path>
                <a:path w="4364355" h="329565">
                  <a:moveTo>
                    <a:pt x="3145282" y="209423"/>
                  </a:moveTo>
                  <a:lnTo>
                    <a:pt x="3134868" y="209423"/>
                  </a:lnTo>
                  <a:lnTo>
                    <a:pt x="3134868" y="329057"/>
                  </a:lnTo>
                  <a:lnTo>
                    <a:pt x="3145282" y="329057"/>
                  </a:lnTo>
                  <a:lnTo>
                    <a:pt x="3145282" y="209423"/>
                  </a:lnTo>
                  <a:close/>
                </a:path>
                <a:path w="4364355" h="329565">
                  <a:moveTo>
                    <a:pt x="3203321" y="119634"/>
                  </a:moveTo>
                  <a:lnTo>
                    <a:pt x="3192907" y="119634"/>
                  </a:lnTo>
                  <a:lnTo>
                    <a:pt x="3192907" y="329057"/>
                  </a:lnTo>
                  <a:lnTo>
                    <a:pt x="3203321" y="329057"/>
                  </a:lnTo>
                  <a:lnTo>
                    <a:pt x="3203321" y="119634"/>
                  </a:lnTo>
                  <a:close/>
                </a:path>
                <a:path w="4364355" h="329565">
                  <a:moveTo>
                    <a:pt x="3261360" y="179451"/>
                  </a:moveTo>
                  <a:lnTo>
                    <a:pt x="3250946" y="179451"/>
                  </a:lnTo>
                  <a:lnTo>
                    <a:pt x="3250946" y="329057"/>
                  </a:lnTo>
                  <a:lnTo>
                    <a:pt x="3261360" y="329057"/>
                  </a:lnTo>
                  <a:lnTo>
                    <a:pt x="3261360" y="179451"/>
                  </a:lnTo>
                  <a:close/>
                </a:path>
                <a:path w="4364355" h="329565">
                  <a:moveTo>
                    <a:pt x="3319399" y="239268"/>
                  </a:moveTo>
                  <a:lnTo>
                    <a:pt x="3306318" y="239268"/>
                  </a:lnTo>
                  <a:lnTo>
                    <a:pt x="3306318" y="329057"/>
                  </a:lnTo>
                  <a:lnTo>
                    <a:pt x="3319399" y="329057"/>
                  </a:lnTo>
                  <a:lnTo>
                    <a:pt x="3319399" y="239268"/>
                  </a:lnTo>
                  <a:close/>
                </a:path>
                <a:path w="4364355" h="329565">
                  <a:moveTo>
                    <a:pt x="3377565" y="209423"/>
                  </a:moveTo>
                  <a:lnTo>
                    <a:pt x="3364484" y="209423"/>
                  </a:lnTo>
                  <a:lnTo>
                    <a:pt x="3364484" y="329057"/>
                  </a:lnTo>
                  <a:lnTo>
                    <a:pt x="3377565" y="329057"/>
                  </a:lnTo>
                  <a:lnTo>
                    <a:pt x="3377565" y="209423"/>
                  </a:lnTo>
                  <a:close/>
                </a:path>
                <a:path w="4364355" h="329565">
                  <a:moveTo>
                    <a:pt x="3435477" y="209423"/>
                  </a:moveTo>
                  <a:lnTo>
                    <a:pt x="3425063" y="209423"/>
                  </a:lnTo>
                  <a:lnTo>
                    <a:pt x="3425063" y="329057"/>
                  </a:lnTo>
                  <a:lnTo>
                    <a:pt x="3435477" y="329057"/>
                  </a:lnTo>
                  <a:lnTo>
                    <a:pt x="3435477" y="209423"/>
                  </a:lnTo>
                  <a:close/>
                </a:path>
                <a:path w="4364355" h="329565">
                  <a:moveTo>
                    <a:pt x="3493516" y="239268"/>
                  </a:moveTo>
                  <a:lnTo>
                    <a:pt x="3483102" y="239268"/>
                  </a:lnTo>
                  <a:lnTo>
                    <a:pt x="3483102" y="329057"/>
                  </a:lnTo>
                  <a:lnTo>
                    <a:pt x="3493516" y="329057"/>
                  </a:lnTo>
                  <a:lnTo>
                    <a:pt x="3493516" y="239268"/>
                  </a:lnTo>
                  <a:close/>
                </a:path>
                <a:path w="4364355" h="329565">
                  <a:moveTo>
                    <a:pt x="3551555" y="239268"/>
                  </a:moveTo>
                  <a:lnTo>
                    <a:pt x="3541141" y="239268"/>
                  </a:lnTo>
                  <a:lnTo>
                    <a:pt x="3541141" y="329057"/>
                  </a:lnTo>
                  <a:lnTo>
                    <a:pt x="3551555" y="329057"/>
                  </a:lnTo>
                  <a:lnTo>
                    <a:pt x="3551555" y="239268"/>
                  </a:lnTo>
                  <a:close/>
                </a:path>
                <a:path w="4364355" h="329565">
                  <a:moveTo>
                    <a:pt x="3609721" y="209423"/>
                  </a:moveTo>
                  <a:lnTo>
                    <a:pt x="3599307" y="209423"/>
                  </a:lnTo>
                  <a:lnTo>
                    <a:pt x="3599307" y="329057"/>
                  </a:lnTo>
                  <a:lnTo>
                    <a:pt x="3609721" y="329057"/>
                  </a:lnTo>
                  <a:lnTo>
                    <a:pt x="3609721" y="209423"/>
                  </a:lnTo>
                  <a:close/>
                </a:path>
                <a:path w="4364355" h="329565">
                  <a:moveTo>
                    <a:pt x="3667760" y="179451"/>
                  </a:moveTo>
                  <a:lnTo>
                    <a:pt x="3657346" y="179451"/>
                  </a:lnTo>
                  <a:lnTo>
                    <a:pt x="3657346" y="329057"/>
                  </a:lnTo>
                  <a:lnTo>
                    <a:pt x="3667760" y="329057"/>
                  </a:lnTo>
                  <a:lnTo>
                    <a:pt x="3667760" y="179451"/>
                  </a:lnTo>
                  <a:close/>
                </a:path>
                <a:path w="4364355" h="329565">
                  <a:moveTo>
                    <a:pt x="3725786" y="179451"/>
                  </a:moveTo>
                  <a:lnTo>
                    <a:pt x="3715372" y="179451"/>
                  </a:lnTo>
                  <a:lnTo>
                    <a:pt x="3715372" y="329057"/>
                  </a:lnTo>
                  <a:lnTo>
                    <a:pt x="3725786" y="329057"/>
                  </a:lnTo>
                  <a:lnTo>
                    <a:pt x="3725786" y="179451"/>
                  </a:lnTo>
                  <a:close/>
                </a:path>
                <a:path w="4364355" h="329565">
                  <a:moveTo>
                    <a:pt x="3783838" y="299085"/>
                  </a:moveTo>
                  <a:lnTo>
                    <a:pt x="3773424" y="299085"/>
                  </a:lnTo>
                  <a:lnTo>
                    <a:pt x="3773424" y="329057"/>
                  </a:lnTo>
                  <a:lnTo>
                    <a:pt x="3783838" y="329057"/>
                  </a:lnTo>
                  <a:lnTo>
                    <a:pt x="3783838" y="299085"/>
                  </a:lnTo>
                  <a:close/>
                </a:path>
                <a:path w="4364355" h="329565">
                  <a:moveTo>
                    <a:pt x="3841877" y="209423"/>
                  </a:moveTo>
                  <a:lnTo>
                    <a:pt x="3828796" y="209423"/>
                  </a:lnTo>
                  <a:lnTo>
                    <a:pt x="3828796" y="329057"/>
                  </a:lnTo>
                  <a:lnTo>
                    <a:pt x="3841877" y="329057"/>
                  </a:lnTo>
                  <a:lnTo>
                    <a:pt x="3841877" y="209423"/>
                  </a:lnTo>
                  <a:close/>
                </a:path>
                <a:path w="4364355" h="329565">
                  <a:moveTo>
                    <a:pt x="3899903" y="239268"/>
                  </a:moveTo>
                  <a:lnTo>
                    <a:pt x="3889502" y="239268"/>
                  </a:lnTo>
                  <a:lnTo>
                    <a:pt x="3889502" y="329057"/>
                  </a:lnTo>
                  <a:lnTo>
                    <a:pt x="3899903" y="329057"/>
                  </a:lnTo>
                  <a:lnTo>
                    <a:pt x="3899903" y="239268"/>
                  </a:lnTo>
                  <a:close/>
                </a:path>
                <a:path w="4364355" h="329565">
                  <a:moveTo>
                    <a:pt x="4074160" y="209423"/>
                  </a:moveTo>
                  <a:lnTo>
                    <a:pt x="4061079" y="209423"/>
                  </a:lnTo>
                  <a:lnTo>
                    <a:pt x="4061079" y="329057"/>
                  </a:lnTo>
                  <a:lnTo>
                    <a:pt x="4074160" y="329057"/>
                  </a:lnTo>
                  <a:lnTo>
                    <a:pt x="4074160" y="209423"/>
                  </a:lnTo>
                  <a:close/>
                </a:path>
                <a:path w="4364355" h="329565">
                  <a:moveTo>
                    <a:pt x="4132059" y="269240"/>
                  </a:moveTo>
                  <a:lnTo>
                    <a:pt x="4121658" y="269240"/>
                  </a:lnTo>
                  <a:lnTo>
                    <a:pt x="4121658" y="329057"/>
                  </a:lnTo>
                  <a:lnTo>
                    <a:pt x="4132059" y="329057"/>
                  </a:lnTo>
                  <a:lnTo>
                    <a:pt x="4132059" y="269240"/>
                  </a:lnTo>
                  <a:close/>
                </a:path>
                <a:path w="4364355" h="329565">
                  <a:moveTo>
                    <a:pt x="4190238" y="239268"/>
                  </a:moveTo>
                  <a:lnTo>
                    <a:pt x="4179824" y="239268"/>
                  </a:lnTo>
                  <a:lnTo>
                    <a:pt x="4179824" y="329057"/>
                  </a:lnTo>
                  <a:lnTo>
                    <a:pt x="4190238" y="329057"/>
                  </a:lnTo>
                  <a:lnTo>
                    <a:pt x="4190238" y="239268"/>
                  </a:lnTo>
                  <a:close/>
                </a:path>
                <a:path w="4364355" h="329565">
                  <a:moveTo>
                    <a:pt x="4364355" y="239268"/>
                  </a:moveTo>
                  <a:lnTo>
                    <a:pt x="4351274" y="239268"/>
                  </a:lnTo>
                  <a:lnTo>
                    <a:pt x="4351274" y="329057"/>
                  </a:lnTo>
                  <a:lnTo>
                    <a:pt x="4364355" y="329057"/>
                  </a:lnTo>
                  <a:lnTo>
                    <a:pt x="4364355" y="239268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4" name="object 114" descr=""/>
            <p:cNvSpPr/>
            <p:nvPr/>
          </p:nvSpPr>
          <p:spPr>
            <a:xfrm>
              <a:off x="13645134" y="8542782"/>
              <a:ext cx="1929130" cy="120014"/>
            </a:xfrm>
            <a:custGeom>
              <a:avLst/>
              <a:gdLst/>
              <a:ahLst/>
              <a:cxnLst/>
              <a:rect l="l" t="t" r="r" b="b"/>
              <a:pathLst>
                <a:path w="1929130" h="120015">
                  <a:moveTo>
                    <a:pt x="13081" y="29845"/>
                  </a:moveTo>
                  <a:lnTo>
                    <a:pt x="0" y="29845"/>
                  </a:lnTo>
                  <a:lnTo>
                    <a:pt x="0" y="119634"/>
                  </a:lnTo>
                  <a:lnTo>
                    <a:pt x="13081" y="119634"/>
                  </a:lnTo>
                  <a:lnTo>
                    <a:pt x="13081" y="29845"/>
                  </a:lnTo>
                  <a:close/>
                </a:path>
                <a:path w="1929130" h="120015">
                  <a:moveTo>
                    <a:pt x="71120" y="29845"/>
                  </a:moveTo>
                  <a:lnTo>
                    <a:pt x="58039" y="29845"/>
                  </a:lnTo>
                  <a:lnTo>
                    <a:pt x="58039" y="119634"/>
                  </a:lnTo>
                  <a:lnTo>
                    <a:pt x="71120" y="119634"/>
                  </a:lnTo>
                  <a:lnTo>
                    <a:pt x="71120" y="29845"/>
                  </a:lnTo>
                  <a:close/>
                </a:path>
                <a:path w="1929130" h="120015">
                  <a:moveTo>
                    <a:pt x="129286" y="89662"/>
                  </a:moveTo>
                  <a:lnTo>
                    <a:pt x="116205" y="89662"/>
                  </a:lnTo>
                  <a:lnTo>
                    <a:pt x="116205" y="119634"/>
                  </a:lnTo>
                  <a:lnTo>
                    <a:pt x="129286" y="119634"/>
                  </a:lnTo>
                  <a:lnTo>
                    <a:pt x="129286" y="89662"/>
                  </a:lnTo>
                  <a:close/>
                </a:path>
                <a:path w="1929130" h="120015">
                  <a:moveTo>
                    <a:pt x="245237" y="0"/>
                  </a:moveTo>
                  <a:lnTo>
                    <a:pt x="234823" y="0"/>
                  </a:lnTo>
                  <a:lnTo>
                    <a:pt x="234823" y="119634"/>
                  </a:lnTo>
                  <a:lnTo>
                    <a:pt x="245237" y="119634"/>
                  </a:lnTo>
                  <a:lnTo>
                    <a:pt x="245237" y="0"/>
                  </a:lnTo>
                  <a:close/>
                </a:path>
                <a:path w="1929130" h="120015">
                  <a:moveTo>
                    <a:pt x="303276" y="89662"/>
                  </a:moveTo>
                  <a:lnTo>
                    <a:pt x="292862" y="89662"/>
                  </a:lnTo>
                  <a:lnTo>
                    <a:pt x="292862" y="119634"/>
                  </a:lnTo>
                  <a:lnTo>
                    <a:pt x="303276" y="119634"/>
                  </a:lnTo>
                  <a:lnTo>
                    <a:pt x="303276" y="89662"/>
                  </a:lnTo>
                  <a:close/>
                </a:path>
                <a:path w="1929130" h="120015">
                  <a:moveTo>
                    <a:pt x="361429" y="59817"/>
                  </a:moveTo>
                  <a:lnTo>
                    <a:pt x="351028" y="59817"/>
                  </a:lnTo>
                  <a:lnTo>
                    <a:pt x="351028" y="119634"/>
                  </a:lnTo>
                  <a:lnTo>
                    <a:pt x="361429" y="119634"/>
                  </a:lnTo>
                  <a:lnTo>
                    <a:pt x="361429" y="59817"/>
                  </a:lnTo>
                  <a:close/>
                </a:path>
                <a:path w="1929130" h="120015">
                  <a:moveTo>
                    <a:pt x="419481" y="29845"/>
                  </a:moveTo>
                  <a:lnTo>
                    <a:pt x="409067" y="29845"/>
                  </a:lnTo>
                  <a:lnTo>
                    <a:pt x="409067" y="119634"/>
                  </a:lnTo>
                  <a:lnTo>
                    <a:pt x="419481" y="119634"/>
                  </a:lnTo>
                  <a:lnTo>
                    <a:pt x="419481" y="29845"/>
                  </a:lnTo>
                  <a:close/>
                </a:path>
                <a:path w="1929130" h="120015">
                  <a:moveTo>
                    <a:pt x="477520" y="0"/>
                  </a:moveTo>
                  <a:lnTo>
                    <a:pt x="467106" y="0"/>
                  </a:lnTo>
                  <a:lnTo>
                    <a:pt x="467106" y="119634"/>
                  </a:lnTo>
                  <a:lnTo>
                    <a:pt x="477520" y="119634"/>
                  </a:lnTo>
                  <a:lnTo>
                    <a:pt x="477520" y="0"/>
                  </a:lnTo>
                  <a:close/>
                </a:path>
                <a:path w="1929130" h="120015">
                  <a:moveTo>
                    <a:pt x="535559" y="59817"/>
                  </a:moveTo>
                  <a:lnTo>
                    <a:pt x="525145" y="59817"/>
                  </a:lnTo>
                  <a:lnTo>
                    <a:pt x="525145" y="119634"/>
                  </a:lnTo>
                  <a:lnTo>
                    <a:pt x="535559" y="119634"/>
                  </a:lnTo>
                  <a:lnTo>
                    <a:pt x="535559" y="59817"/>
                  </a:lnTo>
                  <a:close/>
                </a:path>
                <a:path w="1929130" h="120015">
                  <a:moveTo>
                    <a:pt x="593585" y="59817"/>
                  </a:moveTo>
                  <a:lnTo>
                    <a:pt x="583184" y="59817"/>
                  </a:lnTo>
                  <a:lnTo>
                    <a:pt x="583184" y="119634"/>
                  </a:lnTo>
                  <a:lnTo>
                    <a:pt x="593585" y="119634"/>
                  </a:lnTo>
                  <a:lnTo>
                    <a:pt x="593585" y="59817"/>
                  </a:lnTo>
                  <a:close/>
                </a:path>
                <a:path w="1929130" h="120015">
                  <a:moveTo>
                    <a:pt x="651637" y="0"/>
                  </a:moveTo>
                  <a:lnTo>
                    <a:pt x="641223" y="0"/>
                  </a:lnTo>
                  <a:lnTo>
                    <a:pt x="641223" y="119634"/>
                  </a:lnTo>
                  <a:lnTo>
                    <a:pt x="651637" y="119634"/>
                  </a:lnTo>
                  <a:lnTo>
                    <a:pt x="651637" y="0"/>
                  </a:lnTo>
                  <a:close/>
                </a:path>
                <a:path w="1929130" h="120015">
                  <a:moveTo>
                    <a:pt x="767715" y="89662"/>
                  </a:moveTo>
                  <a:lnTo>
                    <a:pt x="750316" y="89662"/>
                  </a:lnTo>
                  <a:lnTo>
                    <a:pt x="750316" y="119634"/>
                  </a:lnTo>
                  <a:lnTo>
                    <a:pt x="767715" y="119634"/>
                  </a:lnTo>
                  <a:lnTo>
                    <a:pt x="767715" y="89662"/>
                  </a:lnTo>
                  <a:close/>
                </a:path>
                <a:path w="1929130" h="120015">
                  <a:moveTo>
                    <a:pt x="883920" y="59817"/>
                  </a:moveTo>
                  <a:lnTo>
                    <a:pt x="873506" y="59817"/>
                  </a:lnTo>
                  <a:lnTo>
                    <a:pt x="873506" y="119634"/>
                  </a:lnTo>
                  <a:lnTo>
                    <a:pt x="883920" y="119634"/>
                  </a:lnTo>
                  <a:lnTo>
                    <a:pt x="883920" y="59817"/>
                  </a:lnTo>
                  <a:close/>
                </a:path>
                <a:path w="1929130" h="120015">
                  <a:moveTo>
                    <a:pt x="941959" y="89662"/>
                  </a:moveTo>
                  <a:lnTo>
                    <a:pt x="931545" y="89662"/>
                  </a:lnTo>
                  <a:lnTo>
                    <a:pt x="931545" y="119634"/>
                  </a:lnTo>
                  <a:lnTo>
                    <a:pt x="941959" y="119634"/>
                  </a:lnTo>
                  <a:lnTo>
                    <a:pt x="941959" y="89662"/>
                  </a:lnTo>
                  <a:close/>
                </a:path>
                <a:path w="1929130" h="120015">
                  <a:moveTo>
                    <a:pt x="1058037" y="89662"/>
                  </a:moveTo>
                  <a:lnTo>
                    <a:pt x="1044956" y="89662"/>
                  </a:lnTo>
                  <a:lnTo>
                    <a:pt x="1044956" y="119634"/>
                  </a:lnTo>
                  <a:lnTo>
                    <a:pt x="1058037" y="119634"/>
                  </a:lnTo>
                  <a:lnTo>
                    <a:pt x="1058037" y="89662"/>
                  </a:lnTo>
                  <a:close/>
                </a:path>
                <a:path w="1929130" h="120015">
                  <a:moveTo>
                    <a:pt x="1116076" y="89662"/>
                  </a:moveTo>
                  <a:lnTo>
                    <a:pt x="1105662" y="89662"/>
                  </a:lnTo>
                  <a:lnTo>
                    <a:pt x="1105662" y="119634"/>
                  </a:lnTo>
                  <a:lnTo>
                    <a:pt x="1116076" y="119634"/>
                  </a:lnTo>
                  <a:lnTo>
                    <a:pt x="1116076" y="89662"/>
                  </a:lnTo>
                  <a:close/>
                </a:path>
                <a:path w="1929130" h="120015">
                  <a:moveTo>
                    <a:pt x="1232141" y="59817"/>
                  </a:moveTo>
                  <a:lnTo>
                    <a:pt x="1221740" y="59817"/>
                  </a:lnTo>
                  <a:lnTo>
                    <a:pt x="1221740" y="119634"/>
                  </a:lnTo>
                  <a:lnTo>
                    <a:pt x="1232141" y="119634"/>
                  </a:lnTo>
                  <a:lnTo>
                    <a:pt x="1232141" y="59817"/>
                  </a:lnTo>
                  <a:close/>
                </a:path>
                <a:path w="1929130" h="120015">
                  <a:moveTo>
                    <a:pt x="1870697" y="89662"/>
                  </a:moveTo>
                  <a:lnTo>
                    <a:pt x="1853311" y="89662"/>
                  </a:lnTo>
                  <a:lnTo>
                    <a:pt x="1853311" y="119634"/>
                  </a:lnTo>
                  <a:lnTo>
                    <a:pt x="1870697" y="119634"/>
                  </a:lnTo>
                  <a:lnTo>
                    <a:pt x="1870697" y="89662"/>
                  </a:lnTo>
                  <a:close/>
                </a:path>
                <a:path w="1929130" h="120015">
                  <a:moveTo>
                    <a:pt x="1928876" y="89662"/>
                  </a:moveTo>
                  <a:lnTo>
                    <a:pt x="1911477" y="89662"/>
                  </a:lnTo>
                  <a:lnTo>
                    <a:pt x="1911477" y="119634"/>
                  </a:lnTo>
                  <a:lnTo>
                    <a:pt x="1928876" y="119634"/>
                  </a:lnTo>
                  <a:lnTo>
                    <a:pt x="1928876" y="89662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15" name="object 115" descr=""/>
          <p:cNvSpPr txBox="1"/>
          <p:nvPr/>
        </p:nvSpPr>
        <p:spPr>
          <a:xfrm>
            <a:off x="286258" y="8576436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16" name="object 116" descr=""/>
          <p:cNvSpPr txBox="1"/>
          <p:nvPr/>
        </p:nvSpPr>
        <p:spPr>
          <a:xfrm>
            <a:off x="260858" y="8486775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27777" sz="1350" spc="-82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27777" sz="1350">
              <a:latin typeface="Arial"/>
              <a:cs typeface="Arial"/>
            </a:endParaRPr>
          </a:p>
        </p:txBody>
      </p:sp>
      <p:sp>
        <p:nvSpPr>
          <p:cNvPr id="117" name="object 117" descr=""/>
          <p:cNvSpPr txBox="1"/>
          <p:nvPr/>
        </p:nvSpPr>
        <p:spPr>
          <a:xfrm>
            <a:off x="260858" y="8396985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27777" sz="1350" spc="-82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27777" sz="1350">
              <a:latin typeface="Arial"/>
              <a:cs typeface="Arial"/>
            </a:endParaRPr>
          </a:p>
        </p:txBody>
      </p:sp>
      <p:sp>
        <p:nvSpPr>
          <p:cNvPr id="118" name="object 118" descr=""/>
          <p:cNvSpPr txBox="1"/>
          <p:nvPr/>
        </p:nvSpPr>
        <p:spPr>
          <a:xfrm>
            <a:off x="260858" y="8307323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27777" sz="1350" spc="-82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27777" sz="1350">
              <a:latin typeface="Arial"/>
              <a:cs typeface="Arial"/>
            </a:endParaRPr>
          </a:p>
        </p:txBody>
      </p:sp>
      <p:sp>
        <p:nvSpPr>
          <p:cNvPr id="119" name="object 119" descr=""/>
          <p:cNvSpPr txBox="1"/>
          <p:nvPr/>
        </p:nvSpPr>
        <p:spPr>
          <a:xfrm>
            <a:off x="197357" y="8217534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0" name="object 120" descr=""/>
          <p:cNvSpPr txBox="1"/>
          <p:nvPr/>
        </p:nvSpPr>
        <p:spPr>
          <a:xfrm>
            <a:off x="197357" y="8127745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1" name="object 121" descr=""/>
          <p:cNvSpPr txBox="1"/>
          <p:nvPr/>
        </p:nvSpPr>
        <p:spPr>
          <a:xfrm>
            <a:off x="197357" y="8038083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2" name="object 122" descr=""/>
          <p:cNvSpPr txBox="1"/>
          <p:nvPr/>
        </p:nvSpPr>
        <p:spPr>
          <a:xfrm>
            <a:off x="197357" y="7948294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27777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3" name="object 123" descr=""/>
          <p:cNvSpPr txBox="1"/>
          <p:nvPr/>
        </p:nvSpPr>
        <p:spPr>
          <a:xfrm>
            <a:off x="197357" y="7858632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3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4" name="object 124" descr=""/>
          <p:cNvSpPr txBox="1"/>
          <p:nvPr/>
        </p:nvSpPr>
        <p:spPr>
          <a:xfrm>
            <a:off x="197357" y="7768843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6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5" name="object 125" descr=""/>
          <p:cNvSpPr txBox="1"/>
          <p:nvPr/>
        </p:nvSpPr>
        <p:spPr>
          <a:xfrm>
            <a:off x="197357" y="7679055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9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6" name="object 126" descr=""/>
          <p:cNvSpPr txBox="1"/>
          <p:nvPr/>
        </p:nvSpPr>
        <p:spPr>
          <a:xfrm>
            <a:off x="197357" y="7589392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7" name="object 127" descr=""/>
          <p:cNvSpPr txBox="1"/>
          <p:nvPr/>
        </p:nvSpPr>
        <p:spPr>
          <a:xfrm>
            <a:off x="197357" y="7499604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5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8" name="object 128" descr=""/>
          <p:cNvSpPr txBox="1"/>
          <p:nvPr/>
        </p:nvSpPr>
        <p:spPr>
          <a:xfrm>
            <a:off x="197357" y="7409815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8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29" name="object 129" descr=""/>
          <p:cNvSpPr txBox="1"/>
          <p:nvPr/>
        </p:nvSpPr>
        <p:spPr>
          <a:xfrm>
            <a:off x="1106297" y="875639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0" name="object 130" descr=""/>
          <p:cNvSpPr txBox="1"/>
          <p:nvPr/>
        </p:nvSpPr>
        <p:spPr>
          <a:xfrm>
            <a:off x="3977132" y="875639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1" name="object 131" descr=""/>
          <p:cNvSpPr txBox="1"/>
          <p:nvPr/>
        </p:nvSpPr>
        <p:spPr>
          <a:xfrm>
            <a:off x="6848093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2" name="object 132" descr=""/>
          <p:cNvSpPr txBox="1"/>
          <p:nvPr/>
        </p:nvSpPr>
        <p:spPr>
          <a:xfrm>
            <a:off x="9750679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3" name="object 133" descr=""/>
          <p:cNvSpPr txBox="1"/>
          <p:nvPr/>
        </p:nvSpPr>
        <p:spPr>
          <a:xfrm>
            <a:off x="12653264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4" name="object 134" descr=""/>
          <p:cNvSpPr txBox="1"/>
          <p:nvPr/>
        </p:nvSpPr>
        <p:spPr>
          <a:xfrm>
            <a:off x="15555976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5" name="object 135" descr=""/>
          <p:cNvSpPr txBox="1"/>
          <p:nvPr/>
        </p:nvSpPr>
        <p:spPr>
          <a:xfrm>
            <a:off x="8239506" y="8891269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36" name="object 136" descr=""/>
          <p:cNvSpPr txBox="1"/>
          <p:nvPr/>
        </p:nvSpPr>
        <p:spPr>
          <a:xfrm>
            <a:off x="30759" y="7618984"/>
            <a:ext cx="181610" cy="56134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10">
                <a:latin typeface="Arial"/>
                <a:cs typeface="Arial"/>
              </a:rPr>
              <a:t>n.censor</a:t>
            </a:r>
            <a:endParaRPr sz="1100">
              <a:latin typeface="Arial"/>
              <a:cs typeface="Arial"/>
            </a:endParaRPr>
          </a:p>
        </p:txBody>
      </p:sp>
      <p:sp>
        <p:nvSpPr>
          <p:cNvPr id="137" name="object 137" descr=""/>
          <p:cNvSpPr txBox="1"/>
          <p:nvPr/>
        </p:nvSpPr>
        <p:spPr>
          <a:xfrm>
            <a:off x="184657" y="6667147"/>
            <a:ext cx="1801495" cy="756285"/>
          </a:xfrm>
          <a:prstGeom prst="rect">
            <a:avLst/>
          </a:prstGeom>
        </p:spPr>
        <p:txBody>
          <a:bodyPr wrap="square" lIns="0" tIns="121920" rIns="0" bIns="0" rtlCol="0" vert="horz">
            <a:spAutoFit/>
          </a:bodyPr>
          <a:lstStyle/>
          <a:p>
            <a:pPr marL="240029">
              <a:lnSpc>
                <a:spcPct val="100000"/>
              </a:lnSpc>
              <a:spcBef>
                <a:spcPts val="960"/>
              </a:spcBef>
            </a:pPr>
            <a:r>
              <a:rPr dirty="0" sz="1300">
                <a:latin typeface="Arial"/>
                <a:cs typeface="Arial"/>
              </a:rPr>
              <a:t>Number of </a:t>
            </a:r>
            <a:r>
              <a:rPr dirty="0" sz="1300" spc="-10">
                <a:latin typeface="Arial"/>
                <a:cs typeface="Arial"/>
              </a:rPr>
              <a:t>censoring</a:t>
            </a:r>
            <a:endParaRPr sz="1300">
              <a:latin typeface="Arial"/>
              <a:cs typeface="Arial"/>
            </a:endParaRPr>
          </a:p>
          <a:p>
            <a:pPr marL="50800">
              <a:lnSpc>
                <a:spcPct val="100000"/>
              </a:lnSpc>
              <a:spcBef>
                <a:spcPts val="6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1</a:t>
            </a:r>
            <a:endParaRPr sz="900">
              <a:latin typeface="Arial"/>
              <a:cs typeface="Arial"/>
            </a:endParaRPr>
          </a:p>
          <a:p>
            <a:pPr marL="50800">
              <a:lnSpc>
                <a:spcPct val="100000"/>
              </a:lnSpc>
              <a:spcBef>
                <a:spcPts val="57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27777" sz="1350" spc="-802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3</a:t>
            </a:r>
            <a:endParaRPr baseline="-15432" sz="135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Graphics Output</dc:title>
  <dcterms:created xsi:type="dcterms:W3CDTF">2025-11-12T03:35:20Z</dcterms:created>
  <dcterms:modified xsi:type="dcterms:W3CDTF">2025-11-12T03:35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8-12T00:00:00Z</vt:filetime>
  </property>
  <property fmtid="{D5CDD505-2E9C-101B-9397-08002B2CF9AE}" pid="3" name="Creator">
    <vt:lpwstr>R</vt:lpwstr>
  </property>
  <property fmtid="{D5CDD505-2E9C-101B-9397-08002B2CF9AE}" pid="4" name="LastSaved">
    <vt:filetime>2025-11-12T00:00:00Z</vt:filetime>
  </property>
  <property fmtid="{D5CDD505-2E9C-101B-9397-08002B2CF9AE}" pid="5" name="Producer">
    <vt:lpwstr>R 4.5.0</vt:lpwstr>
  </property>
</Properties>
</file>